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3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200" d="100"/>
          <a:sy n="200" d="100"/>
        </p:scale>
        <p:origin x="-730" y="-87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Rectangle 366">
            <a:extLst>
              <a:ext uri="{FF2B5EF4-FFF2-40B4-BE49-F238E27FC236}">
                <a16:creationId xmlns:a16="http://schemas.microsoft.com/office/drawing/2014/main" id="{904299F5-B1EE-4618-8B51-570A0B17F10E}"/>
              </a:ext>
            </a:extLst>
          </p:cNvPr>
          <p:cNvSpPr/>
          <p:nvPr/>
        </p:nvSpPr>
        <p:spPr>
          <a:xfrm>
            <a:off x="315600" y="416560"/>
            <a:ext cx="6261133" cy="55485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2" name="Rectangle 641">
            <a:extLst>
              <a:ext uri="{FF2B5EF4-FFF2-40B4-BE49-F238E27FC236}">
                <a16:creationId xmlns:a16="http://schemas.microsoft.com/office/drawing/2014/main" id="{F532EBCB-551D-4737-91D6-A56E3F808E5D}"/>
              </a:ext>
            </a:extLst>
          </p:cNvPr>
          <p:cNvSpPr/>
          <p:nvPr/>
        </p:nvSpPr>
        <p:spPr>
          <a:xfrm>
            <a:off x="315600" y="6027420"/>
            <a:ext cx="6261133" cy="32696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A85733E-DFC9-4A0B-BE67-F1E27A0056DC}"/>
              </a:ext>
            </a:extLst>
          </p:cNvPr>
          <p:cNvSpPr txBox="1"/>
          <p:nvPr/>
        </p:nvSpPr>
        <p:spPr>
          <a:xfrm>
            <a:off x="658858" y="9359948"/>
            <a:ext cx="5516390" cy="461665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justLow"/>
            <a:r>
              <a:rPr lang="en-US" sz="1200" b="1" dirty="0"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cs typeface="Times New Roman" panose="02020603050405020304" pitchFamily="18" charset="0"/>
              </a:rPr>
              <a:t>Figure 18 </a:t>
            </a:r>
            <a:r>
              <a:rPr lang="en-US" sz="1200" dirty="0">
                <a:cs typeface="Times New Roman" panose="02020603050405020304" pitchFamily="18" charset="0"/>
              </a:rPr>
              <a:t>|</a:t>
            </a:r>
            <a:r>
              <a:rPr lang="en-US" sz="1200" b="1" dirty="0">
                <a:cs typeface="Times New Roman" panose="02020603050405020304" pitchFamily="18" charset="0"/>
              </a:rPr>
              <a:t> </a:t>
            </a:r>
            <a:r>
              <a:rPr lang="en-US" sz="1200" dirty="0">
                <a:cs typeface="Times New Roman" panose="02020603050405020304" pitchFamily="18" charset="0"/>
              </a:rPr>
              <a:t>Schematic constructions of DDP and pDDP fragments, primers and oligos.</a:t>
            </a:r>
          </a:p>
        </p:txBody>
      </p:sp>
      <p:grpSp>
        <p:nvGrpSpPr>
          <p:cNvPr id="459" name="Group 458">
            <a:extLst>
              <a:ext uri="{FF2B5EF4-FFF2-40B4-BE49-F238E27FC236}">
                <a16:creationId xmlns:a16="http://schemas.microsoft.com/office/drawing/2014/main" id="{D919CA9B-4276-48B4-9754-9A3E5FF59A5C}"/>
              </a:ext>
            </a:extLst>
          </p:cNvPr>
          <p:cNvGrpSpPr/>
          <p:nvPr/>
        </p:nvGrpSpPr>
        <p:grpSpPr>
          <a:xfrm>
            <a:off x="315600" y="1573367"/>
            <a:ext cx="6062587" cy="940451"/>
            <a:chOff x="315600" y="2243927"/>
            <a:chExt cx="6062587" cy="940451"/>
          </a:xfrm>
        </p:grpSpPr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2920A850-ECB7-4EAC-98CF-885210B9453D}"/>
                </a:ext>
              </a:extLst>
            </p:cNvPr>
            <p:cNvSpPr txBox="1"/>
            <p:nvPr/>
          </p:nvSpPr>
          <p:spPr>
            <a:xfrm>
              <a:off x="315600" y="2431815"/>
              <a:ext cx="911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agment 2</a:t>
              </a:r>
            </a:p>
          </p:txBody>
        </p:sp>
        <p:grpSp>
          <p:nvGrpSpPr>
            <p:cNvPr id="235" name="Group 234">
              <a:extLst>
                <a:ext uri="{FF2B5EF4-FFF2-40B4-BE49-F238E27FC236}">
                  <a16:creationId xmlns:a16="http://schemas.microsoft.com/office/drawing/2014/main" id="{79054D04-3D49-49B5-A506-2290277D1BB3}"/>
                </a:ext>
              </a:extLst>
            </p:cNvPr>
            <p:cNvGrpSpPr/>
            <p:nvPr/>
          </p:nvGrpSpPr>
          <p:grpSpPr>
            <a:xfrm>
              <a:off x="1183569" y="2243927"/>
              <a:ext cx="5194618" cy="940451"/>
              <a:chOff x="1215666" y="2235413"/>
              <a:chExt cx="5194618" cy="940451"/>
            </a:xfrm>
          </p:grpSpPr>
          <p:grpSp>
            <p:nvGrpSpPr>
              <p:cNvPr id="221" name="Group 220">
                <a:extLst>
                  <a:ext uri="{FF2B5EF4-FFF2-40B4-BE49-F238E27FC236}">
                    <a16:creationId xmlns:a16="http://schemas.microsoft.com/office/drawing/2014/main" id="{ED58F5D0-72F0-4799-9AFA-F438E0C51954}"/>
                  </a:ext>
                </a:extLst>
              </p:cNvPr>
              <p:cNvGrpSpPr/>
              <p:nvPr/>
            </p:nvGrpSpPr>
            <p:grpSpPr>
              <a:xfrm>
                <a:off x="1215666" y="2235413"/>
                <a:ext cx="4791379" cy="940451"/>
                <a:chOff x="1268544" y="2252078"/>
                <a:chExt cx="4791379" cy="940451"/>
              </a:xfrm>
            </p:grpSpPr>
            <p:grpSp>
              <p:nvGrpSpPr>
                <p:cNvPr id="217" name="Group 216">
                  <a:extLst>
                    <a:ext uri="{FF2B5EF4-FFF2-40B4-BE49-F238E27FC236}">
                      <a16:creationId xmlns:a16="http://schemas.microsoft.com/office/drawing/2014/main" id="{5EF7DEB6-D6FC-4E11-809A-8663644EA55C}"/>
                    </a:ext>
                  </a:extLst>
                </p:cNvPr>
                <p:cNvGrpSpPr/>
                <p:nvPr/>
              </p:nvGrpSpPr>
              <p:grpSpPr>
                <a:xfrm>
                  <a:off x="1268544" y="2270525"/>
                  <a:ext cx="1900801" cy="922004"/>
                  <a:chOff x="1497270" y="2252078"/>
                  <a:chExt cx="1900801" cy="922004"/>
                </a:xfrm>
              </p:grpSpPr>
              <p:sp>
                <p:nvSpPr>
                  <p:cNvPr id="169" name="Rectangle: Rounded Corners 168">
                    <a:extLst>
                      <a:ext uri="{FF2B5EF4-FFF2-40B4-BE49-F238E27FC236}">
                        <a16:creationId xmlns:a16="http://schemas.microsoft.com/office/drawing/2014/main" id="{03AAE5CE-E8E7-4DEA-A21D-CE6962545694}"/>
                      </a:ext>
                    </a:extLst>
                  </p:cNvPr>
                  <p:cNvSpPr/>
                  <p:nvPr/>
                </p:nvSpPr>
                <p:spPr>
                  <a:xfrm>
                    <a:off x="1913569" y="2521118"/>
                    <a:ext cx="1255776" cy="115824"/>
                  </a:xfrm>
                  <a:prstGeom prst="round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0" name="TextBox 169">
                    <a:extLst>
                      <a:ext uri="{FF2B5EF4-FFF2-40B4-BE49-F238E27FC236}">
                        <a16:creationId xmlns:a16="http://schemas.microsoft.com/office/drawing/2014/main" id="{6D95415C-CB23-472D-B799-8174B5C1191E}"/>
                      </a:ext>
                    </a:extLst>
                  </p:cNvPr>
                  <p:cNvSpPr txBox="1"/>
                  <p:nvPr/>
                </p:nvSpPr>
                <p:spPr>
                  <a:xfrm>
                    <a:off x="2043489" y="2452134"/>
                    <a:ext cx="1070203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' homology arm</a:t>
                    </a:r>
                  </a:p>
                </p:txBody>
              </p:sp>
              <p:cxnSp>
                <p:nvCxnSpPr>
                  <p:cNvPr id="172" name="Straight Arrow Connector 171">
                    <a:extLst>
                      <a:ext uri="{FF2B5EF4-FFF2-40B4-BE49-F238E27FC236}">
                        <a16:creationId xmlns:a16="http://schemas.microsoft.com/office/drawing/2014/main" id="{CBAFCA58-2075-459F-A847-5F312015EC9C}"/>
                      </a:ext>
                    </a:extLst>
                  </p:cNvPr>
                  <p:cNvCxnSpPr/>
                  <p:nvPr/>
                </p:nvCxnSpPr>
                <p:spPr>
                  <a:xfrm>
                    <a:off x="1913569" y="2452134"/>
                    <a:ext cx="35278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3" name="TextBox 172">
                    <a:extLst>
                      <a:ext uri="{FF2B5EF4-FFF2-40B4-BE49-F238E27FC236}">
                        <a16:creationId xmlns:a16="http://schemas.microsoft.com/office/drawing/2014/main" id="{DD2EB38C-5608-4374-8EC1-5219DBD79E93}"/>
                      </a:ext>
                    </a:extLst>
                  </p:cNvPr>
                  <p:cNvSpPr txBox="1"/>
                  <p:nvPr/>
                </p:nvSpPr>
                <p:spPr>
                  <a:xfrm>
                    <a:off x="1710762" y="2252078"/>
                    <a:ext cx="75839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' Ho-F-1</a:t>
                    </a:r>
                  </a:p>
                </p:txBody>
              </p:sp>
              <p:cxnSp>
                <p:nvCxnSpPr>
                  <p:cNvPr id="175" name="Straight Arrow Connector 174">
                    <a:extLst>
                      <a:ext uri="{FF2B5EF4-FFF2-40B4-BE49-F238E27FC236}">
                        <a16:creationId xmlns:a16="http://schemas.microsoft.com/office/drawing/2014/main" id="{9E1E59D0-869D-4407-873E-60BE76ED046F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797489" y="2702141"/>
                    <a:ext cx="371856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6" name="TextBox 175">
                    <a:extLst>
                      <a:ext uri="{FF2B5EF4-FFF2-40B4-BE49-F238E27FC236}">
                        <a16:creationId xmlns:a16="http://schemas.microsoft.com/office/drawing/2014/main" id="{7D0443B0-70D2-4CB9-81C8-9FDA1AC72CD0}"/>
                      </a:ext>
                    </a:extLst>
                  </p:cNvPr>
                  <p:cNvSpPr txBox="1"/>
                  <p:nvPr/>
                </p:nvSpPr>
                <p:spPr>
                  <a:xfrm>
                    <a:off x="2604220" y="2739408"/>
                    <a:ext cx="75839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' Ho-R-1</a:t>
                    </a:r>
                  </a:p>
                </p:txBody>
              </p:sp>
              <p:cxnSp>
                <p:nvCxnSpPr>
                  <p:cNvPr id="177" name="Straight Arrow Connector 176">
                    <a:extLst>
                      <a:ext uri="{FF2B5EF4-FFF2-40B4-BE49-F238E27FC236}">
                        <a16:creationId xmlns:a16="http://schemas.microsoft.com/office/drawing/2014/main" id="{89468876-387B-4D69-8ECD-18DCC0C8C16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17377" y="2587882"/>
                    <a:ext cx="180694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1" name="TextBox 200">
                    <a:extLst>
                      <a:ext uri="{FF2B5EF4-FFF2-40B4-BE49-F238E27FC236}">
                        <a16:creationId xmlns:a16="http://schemas.microsoft.com/office/drawing/2014/main" id="{80D2E51B-A9AF-4119-BBA3-618F2D924E77}"/>
                      </a:ext>
                    </a:extLst>
                  </p:cNvPr>
                  <p:cNvSpPr txBox="1"/>
                  <p:nvPr/>
                </p:nvSpPr>
                <p:spPr>
                  <a:xfrm>
                    <a:off x="1497270" y="2958638"/>
                    <a:ext cx="1070203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b="1" dirty="0">
                        <a:solidFill>
                          <a:srgbClr val="00206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pecial target: St</a:t>
                    </a:r>
                  </a:p>
                </p:txBody>
              </p:sp>
            </p:grpSp>
            <p:grpSp>
              <p:nvGrpSpPr>
                <p:cNvPr id="216" name="Group 215">
                  <a:extLst>
                    <a:ext uri="{FF2B5EF4-FFF2-40B4-BE49-F238E27FC236}">
                      <a16:creationId xmlns:a16="http://schemas.microsoft.com/office/drawing/2014/main" id="{B67E1601-089E-4D0F-BD33-C43A4056BB03}"/>
                    </a:ext>
                  </a:extLst>
                </p:cNvPr>
                <p:cNvGrpSpPr/>
                <p:nvPr/>
              </p:nvGrpSpPr>
              <p:grpSpPr>
                <a:xfrm>
                  <a:off x="3564341" y="2252078"/>
                  <a:ext cx="2495582" cy="823245"/>
                  <a:chOff x="3069536" y="2246240"/>
                  <a:chExt cx="2495582" cy="823245"/>
                </a:xfrm>
              </p:grpSpPr>
              <p:grpSp>
                <p:nvGrpSpPr>
                  <p:cNvPr id="195" name="Group 194">
                    <a:extLst>
                      <a:ext uri="{FF2B5EF4-FFF2-40B4-BE49-F238E27FC236}">
                        <a16:creationId xmlns:a16="http://schemas.microsoft.com/office/drawing/2014/main" id="{793A1B17-4D7E-4BA7-899F-BB07E2F430DC}"/>
                      </a:ext>
                    </a:extLst>
                  </p:cNvPr>
                  <p:cNvGrpSpPr/>
                  <p:nvPr/>
                </p:nvGrpSpPr>
                <p:grpSpPr>
                  <a:xfrm>
                    <a:off x="3330605" y="2421704"/>
                    <a:ext cx="497138" cy="41910"/>
                    <a:chOff x="5558790" y="222885"/>
                    <a:chExt cx="497138" cy="41910"/>
                  </a:xfrm>
                </p:grpSpPr>
                <p:cxnSp>
                  <p:nvCxnSpPr>
                    <p:cNvPr id="196" name="Straight Arrow Connector 195">
                      <a:extLst>
                        <a:ext uri="{FF2B5EF4-FFF2-40B4-BE49-F238E27FC236}">
                          <a16:creationId xmlns:a16="http://schemas.microsoft.com/office/drawing/2014/main" id="{A5F95851-5206-47F0-B24F-8DE4D939CAE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7" name="Straight Connector 196">
                      <a:extLst>
                        <a:ext uri="{FF2B5EF4-FFF2-40B4-BE49-F238E27FC236}">
                          <a16:creationId xmlns:a16="http://schemas.microsoft.com/office/drawing/2014/main" id="{DB674B05-46D2-4834-9F35-07B852424CF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8" name="Straight Connector 197">
                      <a:extLst>
                        <a:ext uri="{FF2B5EF4-FFF2-40B4-BE49-F238E27FC236}">
                          <a16:creationId xmlns:a16="http://schemas.microsoft.com/office/drawing/2014/main" id="{FB1D9FED-896E-4504-8A2D-4A390407167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15" name="Group 214">
                    <a:extLst>
                      <a:ext uri="{FF2B5EF4-FFF2-40B4-BE49-F238E27FC236}">
                        <a16:creationId xmlns:a16="http://schemas.microsoft.com/office/drawing/2014/main" id="{5CCBEC3C-2EA7-41AA-A100-2D97E3154EBA}"/>
                      </a:ext>
                    </a:extLst>
                  </p:cNvPr>
                  <p:cNvGrpSpPr/>
                  <p:nvPr/>
                </p:nvGrpSpPr>
                <p:grpSpPr>
                  <a:xfrm>
                    <a:off x="3069536" y="2246240"/>
                    <a:ext cx="2495582" cy="823245"/>
                    <a:chOff x="3069536" y="2246240"/>
                    <a:chExt cx="2495582" cy="823245"/>
                  </a:xfrm>
                </p:grpSpPr>
                <p:sp>
                  <p:nvSpPr>
                    <p:cNvPr id="178" name="Rectangle: Rounded Corners 177">
                      <a:extLst>
                        <a:ext uri="{FF2B5EF4-FFF2-40B4-BE49-F238E27FC236}">
                          <a16:creationId xmlns:a16="http://schemas.microsoft.com/office/drawing/2014/main" id="{E4A143FF-E026-426F-A779-0BB852D5ADA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562994" y="2514730"/>
                      <a:ext cx="1255776" cy="115824"/>
                    </a:xfrm>
                    <a:prstGeom prst="round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79" name="TextBox 178">
                      <a:extLst>
                        <a:ext uri="{FF2B5EF4-FFF2-40B4-BE49-F238E27FC236}">
                          <a16:creationId xmlns:a16="http://schemas.microsoft.com/office/drawing/2014/main" id="{BC683801-7C95-40F1-A94F-D225FBB18B8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46278" y="2452203"/>
                      <a:ext cx="1070203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homology arm</a:t>
                      </a:r>
                    </a:p>
                  </p:txBody>
                </p:sp>
                <p:sp>
                  <p:nvSpPr>
                    <p:cNvPr id="200" name="TextBox 199">
                      <a:extLst>
                        <a:ext uri="{FF2B5EF4-FFF2-40B4-BE49-F238E27FC236}">
                          <a16:creationId xmlns:a16="http://schemas.microsoft.com/office/drawing/2014/main" id="{B5E4C953-6876-45EC-8B72-A8D7DD7357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9536" y="2246240"/>
                      <a:ext cx="107020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b="1" i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H</a:t>
                      </a:r>
                      <a:r>
                        <a:rPr lang="en-US" sz="700" b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-St1-</a:t>
                      </a:r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Ho-F-2</a:t>
                      </a:r>
                    </a:p>
                  </p:txBody>
                </p:sp>
                <p:grpSp>
                  <p:nvGrpSpPr>
                    <p:cNvPr id="202" name="Group 201">
                      <a:extLst>
                        <a:ext uri="{FF2B5EF4-FFF2-40B4-BE49-F238E27FC236}">
                          <a16:creationId xmlns:a16="http://schemas.microsoft.com/office/drawing/2014/main" id="{641E6DC5-1EB8-4B2F-B570-B2A63D74764E}"/>
                        </a:ext>
                      </a:extLst>
                    </p:cNvPr>
                    <p:cNvGrpSpPr/>
                    <p:nvPr/>
                  </p:nvGrpSpPr>
                  <p:grpSpPr>
                    <a:xfrm flipH="1" flipV="1">
                      <a:off x="4573057" y="2708219"/>
                      <a:ext cx="462915" cy="51864"/>
                      <a:chOff x="5558790" y="222885"/>
                      <a:chExt cx="497138" cy="41910"/>
                    </a:xfrm>
                  </p:grpSpPr>
                  <p:cxnSp>
                    <p:nvCxnSpPr>
                      <p:cNvPr id="203" name="Straight Arrow Connector 202">
                        <a:extLst>
                          <a:ext uri="{FF2B5EF4-FFF2-40B4-BE49-F238E27FC236}">
                            <a16:creationId xmlns:a16="http://schemas.microsoft.com/office/drawing/2014/main" id="{B756A784-0FD0-4D2B-9040-7BA3242665E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4" name="Straight Connector 203">
                        <a:extLst>
                          <a:ext uri="{FF2B5EF4-FFF2-40B4-BE49-F238E27FC236}">
                            <a16:creationId xmlns:a16="http://schemas.microsoft.com/office/drawing/2014/main" id="{395C5C75-8EEB-4871-8792-353B4E90354F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5" name="Straight Connector 204">
                        <a:extLst>
                          <a:ext uri="{FF2B5EF4-FFF2-40B4-BE49-F238E27FC236}">
                            <a16:creationId xmlns:a16="http://schemas.microsoft.com/office/drawing/2014/main" id="{17BE2389-AAE9-41E4-A5F6-F7DCB08B29C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06" name="TextBox 205">
                      <a:extLst>
                        <a:ext uri="{FF2B5EF4-FFF2-40B4-BE49-F238E27FC236}">
                          <a16:creationId xmlns:a16="http://schemas.microsoft.com/office/drawing/2014/main" id="{59CF8F41-014D-4ADD-B5C9-567F1664E78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75531" y="2761708"/>
                      <a:ext cx="138958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Ho-R-2</a:t>
                      </a:r>
                      <a:r>
                        <a:rPr lang="en-US" sz="700" b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9 bp complemented with 5’ of fragment 3</a:t>
                      </a:r>
                    </a:p>
                  </p:txBody>
                </p:sp>
                <p:sp>
                  <p:nvSpPr>
                    <p:cNvPr id="208" name="TextBox 207">
                      <a:extLst>
                        <a:ext uri="{FF2B5EF4-FFF2-40B4-BE49-F238E27FC236}">
                          <a16:creationId xmlns:a16="http://schemas.microsoft.com/office/drawing/2014/main" id="{5DBC0B23-9DD2-498B-A607-260683B76E5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60222" y="2336035"/>
                      <a:ext cx="43095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R </a:t>
                      </a:r>
                    </a:p>
                  </p:txBody>
                </p:sp>
                <p:cxnSp>
                  <p:nvCxnSpPr>
                    <p:cNvPr id="209" name="Straight Arrow Connector 208">
                      <a:extLst>
                        <a:ext uri="{FF2B5EF4-FFF2-40B4-BE49-F238E27FC236}">
                          <a16:creationId xmlns:a16="http://schemas.microsoft.com/office/drawing/2014/main" id="{6BC33355-B71F-48E4-933D-FF0094BB448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884861" y="2584182"/>
                      <a:ext cx="24940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cxnSp>
              <p:nvCxnSpPr>
                <p:cNvPr id="219" name="Straight Arrow Connector 218">
                  <a:extLst>
                    <a:ext uri="{FF2B5EF4-FFF2-40B4-BE49-F238E27FC236}">
                      <a16:creationId xmlns:a16="http://schemas.microsoft.com/office/drawing/2014/main" id="{B47FE914-E3EB-44B3-94E5-B267DD27951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06244" y="2586286"/>
                  <a:ext cx="180694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0" name="TextBox 219">
                  <a:extLst>
                    <a:ext uri="{FF2B5EF4-FFF2-40B4-BE49-F238E27FC236}">
                      <a16:creationId xmlns:a16="http://schemas.microsoft.com/office/drawing/2014/main" id="{95473352-1C36-43DB-B677-A6C2E4E28B40}"/>
                    </a:ext>
                  </a:extLst>
                </p:cNvPr>
                <p:cNvSpPr txBox="1"/>
                <p:nvPr/>
              </p:nvSpPr>
              <p:spPr>
                <a:xfrm>
                  <a:off x="2864384" y="2378248"/>
                  <a:ext cx="43095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</p:grpSp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7C37FA59-E73C-4EBB-B596-53EC941BCC87}"/>
                  </a:ext>
                </a:extLst>
              </p:cNvPr>
              <p:cNvSpPr txBox="1"/>
              <p:nvPr/>
            </p:nvSpPr>
            <p:spPr>
              <a:xfrm>
                <a:off x="3009001" y="2423301"/>
                <a:ext cx="9119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ASY T3 ligation, screen and sequence</a:t>
                </a:r>
              </a:p>
            </p:txBody>
          </p: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99773DAF-98C5-47AC-9870-C70059E1EDED}"/>
                  </a:ext>
                </a:extLst>
              </p:cNvPr>
              <p:cNvSpPr txBox="1"/>
              <p:nvPr/>
            </p:nvSpPr>
            <p:spPr>
              <a:xfrm>
                <a:off x="5498355" y="2335440"/>
                <a:ext cx="9119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ASY T3 ligation, screen and sequence</a:t>
                </a:r>
              </a:p>
            </p:txBody>
          </p:sp>
        </p:grpSp>
      </p:grpSp>
      <p:grpSp>
        <p:nvGrpSpPr>
          <p:cNvPr id="460" name="Group 459">
            <a:extLst>
              <a:ext uri="{FF2B5EF4-FFF2-40B4-BE49-F238E27FC236}">
                <a16:creationId xmlns:a16="http://schemas.microsoft.com/office/drawing/2014/main" id="{F706376A-50A2-402D-A63D-1DFD6E3E3A31}"/>
              </a:ext>
            </a:extLst>
          </p:cNvPr>
          <p:cNvGrpSpPr/>
          <p:nvPr/>
        </p:nvGrpSpPr>
        <p:grpSpPr>
          <a:xfrm>
            <a:off x="321457" y="2478507"/>
            <a:ext cx="6330541" cy="1395978"/>
            <a:chOff x="321457" y="3291307"/>
            <a:chExt cx="6330541" cy="1395978"/>
          </a:xfrm>
        </p:grpSpPr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B05C372A-05F8-4005-9CB7-EF7468902D5C}"/>
                </a:ext>
              </a:extLst>
            </p:cNvPr>
            <p:cNvSpPr txBox="1"/>
            <p:nvPr/>
          </p:nvSpPr>
          <p:spPr>
            <a:xfrm>
              <a:off x="321457" y="3745513"/>
              <a:ext cx="911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agment 3</a:t>
              </a:r>
            </a:p>
          </p:txBody>
        </p:sp>
        <p:grpSp>
          <p:nvGrpSpPr>
            <p:cNvPr id="292" name="Group 291">
              <a:extLst>
                <a:ext uri="{FF2B5EF4-FFF2-40B4-BE49-F238E27FC236}">
                  <a16:creationId xmlns:a16="http://schemas.microsoft.com/office/drawing/2014/main" id="{645D4D3C-73E0-4D96-B3B7-881FF9C38E94}"/>
                </a:ext>
              </a:extLst>
            </p:cNvPr>
            <p:cNvGrpSpPr/>
            <p:nvPr/>
          </p:nvGrpSpPr>
          <p:grpSpPr>
            <a:xfrm>
              <a:off x="1151927" y="3291307"/>
              <a:ext cx="5500071" cy="1395978"/>
              <a:chOff x="1151927" y="3291307"/>
              <a:chExt cx="5500071" cy="1395978"/>
            </a:xfrm>
          </p:grpSpPr>
          <p:grpSp>
            <p:nvGrpSpPr>
              <p:cNvPr id="286" name="Group 285">
                <a:extLst>
                  <a:ext uri="{FF2B5EF4-FFF2-40B4-BE49-F238E27FC236}">
                    <a16:creationId xmlns:a16="http://schemas.microsoft.com/office/drawing/2014/main" id="{47B9F5A5-21B5-4F14-A788-968639D9A2D6}"/>
                  </a:ext>
                </a:extLst>
              </p:cNvPr>
              <p:cNvGrpSpPr/>
              <p:nvPr/>
            </p:nvGrpSpPr>
            <p:grpSpPr>
              <a:xfrm>
                <a:off x="1151927" y="3291307"/>
                <a:ext cx="5500071" cy="1236192"/>
                <a:chOff x="1339419" y="3272664"/>
                <a:chExt cx="5500071" cy="1236192"/>
              </a:xfrm>
            </p:grpSpPr>
            <p:sp>
              <p:nvSpPr>
                <p:cNvPr id="212" name="Rectangle: Rounded Corners 211">
                  <a:extLst>
                    <a:ext uri="{FF2B5EF4-FFF2-40B4-BE49-F238E27FC236}">
                      <a16:creationId xmlns:a16="http://schemas.microsoft.com/office/drawing/2014/main" id="{D5838BE9-C43E-4000-83A7-FA82766CDE82}"/>
                    </a:ext>
                  </a:extLst>
                </p:cNvPr>
                <p:cNvSpPr/>
                <p:nvPr/>
              </p:nvSpPr>
              <p:spPr>
                <a:xfrm>
                  <a:off x="1577393" y="3816714"/>
                  <a:ext cx="1255776" cy="115824"/>
                </a:xfrm>
                <a:prstGeom prst="round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3" name="TextBox 212">
                  <a:extLst>
                    <a:ext uri="{FF2B5EF4-FFF2-40B4-BE49-F238E27FC236}">
                      <a16:creationId xmlns:a16="http://schemas.microsoft.com/office/drawing/2014/main" id="{2C68FAB3-35B3-4CF3-8DA1-AA56195993A9}"/>
                    </a:ext>
                  </a:extLst>
                </p:cNvPr>
                <p:cNvSpPr txBox="1"/>
                <p:nvPr/>
              </p:nvSpPr>
              <p:spPr>
                <a:xfrm>
                  <a:off x="1652449" y="3747730"/>
                  <a:ext cx="10702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 err="1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leoR</a:t>
                  </a:r>
                  <a:endParaRPr lang="en-US" sz="9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22" name="Straight Arrow Connector 221">
                  <a:extLst>
                    <a:ext uri="{FF2B5EF4-FFF2-40B4-BE49-F238E27FC236}">
                      <a16:creationId xmlns:a16="http://schemas.microsoft.com/office/drawing/2014/main" id="{A797CF4B-629A-46DE-B49C-7579A5C9730C}"/>
                    </a:ext>
                  </a:extLst>
                </p:cNvPr>
                <p:cNvCxnSpPr/>
                <p:nvPr/>
              </p:nvCxnSpPr>
              <p:spPr>
                <a:xfrm>
                  <a:off x="1583157" y="3747730"/>
                  <a:ext cx="36936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Straight Arrow Connector 225">
                  <a:extLst>
                    <a:ext uri="{FF2B5EF4-FFF2-40B4-BE49-F238E27FC236}">
                      <a16:creationId xmlns:a16="http://schemas.microsoft.com/office/drawing/2014/main" id="{A3046B81-9549-4D9E-8B15-3CC6AD17A5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475981" y="4003348"/>
                  <a:ext cx="35610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7" name="TextBox 226">
                  <a:extLst>
                    <a:ext uri="{FF2B5EF4-FFF2-40B4-BE49-F238E27FC236}">
                      <a16:creationId xmlns:a16="http://schemas.microsoft.com/office/drawing/2014/main" id="{AE265F87-8AA6-48B1-B7F7-08EFEDDB6E3E}"/>
                    </a:ext>
                  </a:extLst>
                </p:cNvPr>
                <p:cNvSpPr txBox="1"/>
                <p:nvPr/>
              </p:nvSpPr>
              <p:spPr>
                <a:xfrm>
                  <a:off x="1371061" y="4293412"/>
                  <a:ext cx="104528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solidFill>
                        <a:srgbClr val="00206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leoR-overlap: BP</a:t>
                  </a:r>
                </a:p>
              </p:txBody>
            </p:sp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90662916-F11F-4EF2-A3C0-89ABB7A81C4E}"/>
                    </a:ext>
                  </a:extLst>
                </p:cNvPr>
                <p:cNvSpPr txBox="1"/>
                <p:nvPr/>
              </p:nvSpPr>
              <p:spPr>
                <a:xfrm>
                  <a:off x="1339419" y="3545849"/>
                  <a:ext cx="75839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leoR-1,092F</a:t>
                  </a:r>
                </a:p>
              </p:txBody>
            </p:sp>
            <p:sp>
              <p:nvSpPr>
                <p:cNvPr id="230" name="TextBox 229">
                  <a:extLst>
                    <a:ext uri="{FF2B5EF4-FFF2-40B4-BE49-F238E27FC236}">
                      <a16:creationId xmlns:a16="http://schemas.microsoft.com/office/drawing/2014/main" id="{CA372F54-2270-465A-93A3-19ABEC69BAC2}"/>
                    </a:ext>
                  </a:extLst>
                </p:cNvPr>
                <p:cNvSpPr txBox="1"/>
                <p:nvPr/>
              </p:nvSpPr>
              <p:spPr>
                <a:xfrm>
                  <a:off x="2281927" y="4028135"/>
                  <a:ext cx="75839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leoR-2,276R</a:t>
                  </a:r>
                </a:p>
              </p:txBody>
            </p:sp>
            <p:cxnSp>
              <p:nvCxnSpPr>
                <p:cNvPr id="231" name="Straight Arrow Connector 230">
                  <a:extLst>
                    <a:ext uri="{FF2B5EF4-FFF2-40B4-BE49-F238E27FC236}">
                      <a16:creationId xmlns:a16="http://schemas.microsoft.com/office/drawing/2014/main" id="{01F7484C-C92B-4458-8185-C41C00AA08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11540" y="3882651"/>
                  <a:ext cx="180694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A6220881-53A6-4358-950A-2666ED5BD8A1}"/>
                    </a:ext>
                  </a:extLst>
                </p:cNvPr>
                <p:cNvSpPr txBox="1"/>
                <p:nvPr/>
              </p:nvSpPr>
              <p:spPr>
                <a:xfrm>
                  <a:off x="2787273" y="3654570"/>
                  <a:ext cx="43095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sp>
              <p:nvSpPr>
                <p:cNvPr id="236" name="TextBox 235">
                  <a:extLst>
                    <a:ext uri="{FF2B5EF4-FFF2-40B4-BE49-F238E27FC236}">
                      <a16:creationId xmlns:a16="http://schemas.microsoft.com/office/drawing/2014/main" id="{16239AED-F952-4298-BB05-CFEE8CB5721B}"/>
                    </a:ext>
                  </a:extLst>
                </p:cNvPr>
                <p:cNvSpPr txBox="1"/>
                <p:nvPr/>
              </p:nvSpPr>
              <p:spPr>
                <a:xfrm>
                  <a:off x="3007552" y="3651301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cxnSp>
              <p:nvCxnSpPr>
                <p:cNvPr id="237" name="Straight Arrow Connector 236">
                  <a:extLst>
                    <a:ext uri="{FF2B5EF4-FFF2-40B4-BE49-F238E27FC236}">
                      <a16:creationId xmlns:a16="http://schemas.microsoft.com/office/drawing/2014/main" id="{B9081AC1-5AFE-4B95-AFBE-8709583589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19425" y="3859597"/>
                  <a:ext cx="180694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8" name="Rectangle: Rounded Corners 237">
                  <a:extLst>
                    <a:ext uri="{FF2B5EF4-FFF2-40B4-BE49-F238E27FC236}">
                      <a16:creationId xmlns:a16="http://schemas.microsoft.com/office/drawing/2014/main" id="{E8B1EF50-38AF-48F6-A789-47142ADCD161}"/>
                    </a:ext>
                  </a:extLst>
                </p:cNvPr>
                <p:cNvSpPr/>
                <p:nvPr/>
              </p:nvSpPr>
              <p:spPr>
                <a:xfrm>
                  <a:off x="4258636" y="3811339"/>
                  <a:ext cx="1255776" cy="115824"/>
                </a:xfrm>
                <a:prstGeom prst="round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ED27A8BA-64DE-4392-ADCB-69C7BAE2808B}"/>
                    </a:ext>
                  </a:extLst>
                </p:cNvPr>
                <p:cNvSpPr txBox="1"/>
                <p:nvPr/>
              </p:nvSpPr>
              <p:spPr>
                <a:xfrm>
                  <a:off x="4333692" y="3742355"/>
                  <a:ext cx="10702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 err="1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leoR</a:t>
                  </a:r>
                  <a:endParaRPr lang="en-US" sz="9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48" name="Straight Arrow Connector 247">
                  <a:extLst>
                    <a:ext uri="{FF2B5EF4-FFF2-40B4-BE49-F238E27FC236}">
                      <a16:creationId xmlns:a16="http://schemas.microsoft.com/office/drawing/2014/main" id="{B933D826-749C-45D0-8ED5-A4C2FE105B9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08481" y="3740791"/>
                  <a:ext cx="21109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3" name="Straight Arrow Connector 252">
                  <a:extLst>
                    <a:ext uri="{FF2B5EF4-FFF2-40B4-BE49-F238E27FC236}">
                      <a16:creationId xmlns:a16="http://schemas.microsoft.com/office/drawing/2014/main" id="{9CC8E07D-5405-4C19-8E2A-28B62D7B06A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112211" y="3667131"/>
                  <a:ext cx="21109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4" name="Straight Arrow Connector 253">
                  <a:extLst>
                    <a:ext uri="{FF2B5EF4-FFF2-40B4-BE49-F238E27FC236}">
                      <a16:creationId xmlns:a16="http://schemas.microsoft.com/office/drawing/2014/main" id="{91DB7EA4-09AD-41BE-A7E9-B2559721317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25324" y="3588391"/>
                  <a:ext cx="21109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Straight Arrow Connector 261">
                  <a:extLst>
                    <a:ext uri="{FF2B5EF4-FFF2-40B4-BE49-F238E27FC236}">
                      <a16:creationId xmlns:a16="http://schemas.microsoft.com/office/drawing/2014/main" id="{231B53EB-9682-4AD7-8BF0-37BC615C05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361734" y="3997252"/>
                  <a:ext cx="210236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4" name="Straight Arrow Connector 263">
                  <a:extLst>
                    <a:ext uri="{FF2B5EF4-FFF2-40B4-BE49-F238E27FC236}">
                      <a16:creationId xmlns:a16="http://schemas.microsoft.com/office/drawing/2014/main" id="{119B3C21-DF16-46ED-839A-5A64EBD228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438087" y="4078532"/>
                  <a:ext cx="210236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5" name="Straight Arrow Connector 264">
                  <a:extLst>
                    <a:ext uri="{FF2B5EF4-FFF2-40B4-BE49-F238E27FC236}">
                      <a16:creationId xmlns:a16="http://schemas.microsoft.com/office/drawing/2014/main" id="{575E19E7-7779-4C04-BDD6-2EF6E49D8D0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18577" y="4161182"/>
                  <a:ext cx="210236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7" name="Straight Connector 266">
                  <a:extLst>
                    <a:ext uri="{FF2B5EF4-FFF2-40B4-BE49-F238E27FC236}">
                      <a16:creationId xmlns:a16="http://schemas.microsoft.com/office/drawing/2014/main" id="{9B94387E-FEB0-4E1A-BEAE-52BAF04BEBBF}"/>
                    </a:ext>
                  </a:extLst>
                </p:cNvPr>
                <p:cNvCxnSpPr>
                  <a:cxnSpLocks/>
                  <a:stCxn id="238" idx="1"/>
                </p:cNvCxnSpPr>
                <p:nvPr/>
              </p:nvCxnSpPr>
              <p:spPr>
                <a:xfrm>
                  <a:off x="4258636" y="3869251"/>
                  <a:ext cx="0" cy="194041"/>
                </a:xfrm>
                <a:prstGeom prst="line">
                  <a:avLst/>
                </a:prstGeom>
                <a:ln w="9525">
                  <a:prstDash val="sysDot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68" name="Straight Connector 267">
                  <a:extLst>
                    <a:ext uri="{FF2B5EF4-FFF2-40B4-BE49-F238E27FC236}">
                      <a16:creationId xmlns:a16="http://schemas.microsoft.com/office/drawing/2014/main" id="{61AFD6A4-EF65-4062-804A-6501FF2A8E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25324" y="3493770"/>
                  <a:ext cx="0" cy="569522"/>
                </a:xfrm>
                <a:prstGeom prst="line">
                  <a:avLst/>
                </a:prstGeom>
                <a:ln w="9525">
                  <a:prstDash val="sysDot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69" name="Straight Connector 268">
                  <a:extLst>
                    <a:ext uri="{FF2B5EF4-FFF2-40B4-BE49-F238E27FC236}">
                      <a16:creationId xmlns:a16="http://schemas.microsoft.com/office/drawing/2014/main" id="{30358049-9016-4CBA-AE17-E540FB74788E}"/>
                    </a:ext>
                  </a:extLst>
                </p:cNvPr>
                <p:cNvCxnSpPr>
                  <a:cxnSpLocks/>
                  <a:endCxn id="238" idx="3"/>
                </p:cNvCxnSpPr>
                <p:nvPr/>
              </p:nvCxnSpPr>
              <p:spPr>
                <a:xfrm>
                  <a:off x="5513468" y="3584490"/>
                  <a:ext cx="944" cy="284761"/>
                </a:xfrm>
                <a:prstGeom prst="line">
                  <a:avLst/>
                </a:prstGeom>
                <a:ln w="9525">
                  <a:prstDash val="sysDot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70" name="Straight Connector 269">
                  <a:extLst>
                    <a:ext uri="{FF2B5EF4-FFF2-40B4-BE49-F238E27FC236}">
                      <a16:creationId xmlns:a16="http://schemas.microsoft.com/office/drawing/2014/main" id="{40B868DE-472B-4C88-B867-0F5A7C3E4CC2}"/>
                    </a:ext>
                  </a:extLst>
                </p:cNvPr>
                <p:cNvCxnSpPr/>
                <p:nvPr/>
              </p:nvCxnSpPr>
              <p:spPr>
                <a:xfrm>
                  <a:off x="5728813" y="3573010"/>
                  <a:ext cx="0" cy="569522"/>
                </a:xfrm>
                <a:prstGeom prst="line">
                  <a:avLst/>
                </a:prstGeom>
                <a:ln w="9525">
                  <a:prstDash val="sysDot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74" name="TextBox 273">
                  <a:extLst>
                    <a:ext uri="{FF2B5EF4-FFF2-40B4-BE49-F238E27FC236}">
                      <a16:creationId xmlns:a16="http://schemas.microsoft.com/office/drawing/2014/main" id="{FC332242-ADF5-44ED-9607-620A6B72EC0E}"/>
                    </a:ext>
                  </a:extLst>
                </p:cNvPr>
                <p:cNvSpPr txBox="1"/>
                <p:nvPr/>
              </p:nvSpPr>
              <p:spPr>
                <a:xfrm>
                  <a:off x="3740435" y="4028135"/>
                  <a:ext cx="830030" cy="4154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9 bp from remained exon8 and exon9</a:t>
                  </a:r>
                </a:p>
              </p:txBody>
            </p:sp>
            <p:sp>
              <p:nvSpPr>
                <p:cNvPr id="275" name="TextBox 274">
                  <a:extLst>
                    <a:ext uri="{FF2B5EF4-FFF2-40B4-BE49-F238E27FC236}">
                      <a16:creationId xmlns:a16="http://schemas.microsoft.com/office/drawing/2014/main" id="{287E5FB1-3166-45C6-9F55-6C5E57D30247}"/>
                    </a:ext>
                  </a:extLst>
                </p:cNvPr>
                <p:cNvSpPr txBox="1"/>
                <p:nvPr/>
              </p:nvSpPr>
              <p:spPr>
                <a:xfrm>
                  <a:off x="5249767" y="3272664"/>
                  <a:ext cx="74785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XHis and Poly-A</a:t>
                  </a:r>
                </a:p>
              </p:txBody>
            </p:sp>
            <p:sp>
              <p:nvSpPr>
                <p:cNvPr id="276" name="TextBox 275">
                  <a:extLst>
                    <a:ext uri="{FF2B5EF4-FFF2-40B4-BE49-F238E27FC236}">
                      <a16:creationId xmlns:a16="http://schemas.microsoft.com/office/drawing/2014/main" id="{8F2505D5-EA0E-4C71-B685-1FA60B266DEE}"/>
                    </a:ext>
                  </a:extLst>
                </p:cNvPr>
                <p:cNvSpPr txBox="1"/>
                <p:nvPr/>
              </p:nvSpPr>
              <p:spPr>
                <a:xfrm>
                  <a:off x="5648380" y="3644153"/>
                  <a:ext cx="43095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sp>
              <p:nvSpPr>
                <p:cNvPr id="277" name="TextBox 276">
                  <a:extLst>
                    <a:ext uri="{FF2B5EF4-FFF2-40B4-BE49-F238E27FC236}">
                      <a16:creationId xmlns:a16="http://schemas.microsoft.com/office/drawing/2014/main" id="{BEF3B168-840E-4FED-A92D-A227E56029B9}"/>
                    </a:ext>
                  </a:extLst>
                </p:cNvPr>
                <p:cNvSpPr txBox="1"/>
                <p:nvPr/>
              </p:nvSpPr>
              <p:spPr>
                <a:xfrm>
                  <a:off x="5927561" y="3658677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cxnSp>
              <p:nvCxnSpPr>
                <p:cNvPr id="278" name="Straight Arrow Connector 277">
                  <a:extLst>
                    <a:ext uri="{FF2B5EF4-FFF2-40B4-BE49-F238E27FC236}">
                      <a16:creationId xmlns:a16="http://schemas.microsoft.com/office/drawing/2014/main" id="{B090ABFB-D33E-4B87-A041-EDEF6ED9B3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72302" y="3859597"/>
                  <a:ext cx="24940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0" name="TextBox 279">
                  <a:extLst>
                    <a:ext uri="{FF2B5EF4-FFF2-40B4-BE49-F238E27FC236}">
                      <a16:creationId xmlns:a16="http://schemas.microsoft.com/office/drawing/2014/main" id="{C120FA6A-2B81-413A-BC80-63E0CCE9964F}"/>
                    </a:ext>
                  </a:extLst>
                </p:cNvPr>
                <p:cNvSpPr txBox="1"/>
                <p:nvPr/>
              </p:nvSpPr>
              <p:spPr>
                <a:xfrm>
                  <a:off x="4350243" y="3648458"/>
                  <a:ext cx="40184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P1-F</a:t>
                  </a:r>
                </a:p>
              </p:txBody>
            </p:sp>
            <p:sp>
              <p:nvSpPr>
                <p:cNvPr id="281" name="TextBox 280">
                  <a:extLst>
                    <a:ext uri="{FF2B5EF4-FFF2-40B4-BE49-F238E27FC236}">
                      <a16:creationId xmlns:a16="http://schemas.microsoft.com/office/drawing/2014/main" id="{6949BFC5-A960-4983-93FD-3238A3BCA380}"/>
                    </a:ext>
                  </a:extLst>
                </p:cNvPr>
                <p:cNvSpPr txBox="1"/>
                <p:nvPr/>
              </p:nvSpPr>
              <p:spPr>
                <a:xfrm>
                  <a:off x="4256520" y="3571725"/>
                  <a:ext cx="40184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P2-F</a:t>
                  </a:r>
                </a:p>
              </p:txBody>
            </p:sp>
            <p:sp>
              <p:nvSpPr>
                <p:cNvPr id="282" name="TextBox 281">
                  <a:extLst>
                    <a:ext uri="{FF2B5EF4-FFF2-40B4-BE49-F238E27FC236}">
                      <a16:creationId xmlns:a16="http://schemas.microsoft.com/office/drawing/2014/main" id="{B756AC2E-5F77-4D11-A809-2CFBCFBB318E}"/>
                    </a:ext>
                  </a:extLst>
                </p:cNvPr>
                <p:cNvSpPr txBox="1"/>
                <p:nvPr/>
              </p:nvSpPr>
              <p:spPr>
                <a:xfrm>
                  <a:off x="4180584" y="3486036"/>
                  <a:ext cx="40184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P3-F</a:t>
                  </a:r>
                </a:p>
              </p:txBody>
            </p:sp>
            <p:sp>
              <p:nvSpPr>
                <p:cNvPr id="283" name="TextBox 282">
                  <a:extLst>
                    <a:ext uri="{FF2B5EF4-FFF2-40B4-BE49-F238E27FC236}">
                      <a16:creationId xmlns:a16="http://schemas.microsoft.com/office/drawing/2014/main" id="{2BD9B3DA-9E4C-4BB9-A9D7-29DC61AAAC6B}"/>
                    </a:ext>
                  </a:extLst>
                </p:cNvPr>
                <p:cNvSpPr txBox="1"/>
                <p:nvPr/>
              </p:nvSpPr>
              <p:spPr>
                <a:xfrm>
                  <a:off x="5038416" y="3902750"/>
                  <a:ext cx="40184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P1-R</a:t>
                  </a:r>
                </a:p>
              </p:txBody>
            </p:sp>
            <p:sp>
              <p:nvSpPr>
                <p:cNvPr id="284" name="TextBox 283">
                  <a:extLst>
                    <a:ext uri="{FF2B5EF4-FFF2-40B4-BE49-F238E27FC236}">
                      <a16:creationId xmlns:a16="http://schemas.microsoft.com/office/drawing/2014/main" id="{F75F4D18-52FF-4005-9D91-9A297DD0B5F0}"/>
                    </a:ext>
                  </a:extLst>
                </p:cNvPr>
                <p:cNvSpPr txBox="1"/>
                <p:nvPr/>
              </p:nvSpPr>
              <p:spPr>
                <a:xfrm>
                  <a:off x="5110784" y="3988530"/>
                  <a:ext cx="40184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P2-R</a:t>
                  </a:r>
                </a:p>
              </p:txBody>
            </p:sp>
            <p:sp>
              <p:nvSpPr>
                <p:cNvPr id="285" name="TextBox 284">
                  <a:extLst>
                    <a:ext uri="{FF2B5EF4-FFF2-40B4-BE49-F238E27FC236}">
                      <a16:creationId xmlns:a16="http://schemas.microsoft.com/office/drawing/2014/main" id="{5C5681F0-9736-4879-AE7E-E90713E4471C}"/>
                    </a:ext>
                  </a:extLst>
                </p:cNvPr>
                <p:cNvSpPr txBox="1"/>
                <p:nvPr/>
              </p:nvSpPr>
              <p:spPr>
                <a:xfrm>
                  <a:off x="5179956" y="4068347"/>
                  <a:ext cx="40184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P3-R</a:t>
                  </a:r>
                </a:p>
              </p:txBody>
            </p:sp>
          </p:grpSp>
          <p:grpSp>
            <p:nvGrpSpPr>
              <p:cNvPr id="291" name="Group 290">
                <a:extLst>
                  <a:ext uri="{FF2B5EF4-FFF2-40B4-BE49-F238E27FC236}">
                    <a16:creationId xmlns:a16="http://schemas.microsoft.com/office/drawing/2014/main" id="{63CE72C0-1F80-4B49-83ED-390980B29C01}"/>
                  </a:ext>
                </a:extLst>
              </p:cNvPr>
              <p:cNvGrpSpPr/>
              <p:nvPr/>
            </p:nvGrpSpPr>
            <p:grpSpPr>
              <a:xfrm>
                <a:off x="3863168" y="4471841"/>
                <a:ext cx="1676725" cy="215444"/>
                <a:chOff x="3863168" y="4471841"/>
                <a:chExt cx="1676725" cy="215444"/>
              </a:xfrm>
            </p:grpSpPr>
            <p:cxnSp>
              <p:nvCxnSpPr>
                <p:cNvPr id="289" name="Straight Arrow Connector 288">
                  <a:extLst>
                    <a:ext uri="{FF2B5EF4-FFF2-40B4-BE49-F238E27FC236}">
                      <a16:creationId xmlns:a16="http://schemas.microsoft.com/office/drawing/2014/main" id="{53C49EA9-D0FE-4F03-8766-D9C5C37F0EF9}"/>
                    </a:ext>
                  </a:extLst>
                </p:cNvPr>
                <p:cNvCxnSpPr/>
                <p:nvPr/>
              </p:nvCxnSpPr>
              <p:spPr>
                <a:xfrm>
                  <a:off x="3863168" y="4484683"/>
                  <a:ext cx="1676725" cy="0"/>
                </a:xfrm>
                <a:prstGeom prst="straightConnector1">
                  <a:avLst/>
                </a:prstGeom>
                <a:ln w="12700">
                  <a:headEnd type="triangle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90" name="TextBox 289">
                  <a:extLst>
                    <a:ext uri="{FF2B5EF4-FFF2-40B4-BE49-F238E27FC236}">
                      <a16:creationId xmlns:a16="http://schemas.microsoft.com/office/drawing/2014/main" id="{F1F07EAC-1563-4DC6-BAEE-B1D90D14FF1C}"/>
                    </a:ext>
                  </a:extLst>
                </p:cNvPr>
                <p:cNvSpPr txBox="1"/>
                <p:nvPr/>
              </p:nvSpPr>
              <p:spPr>
                <a:xfrm>
                  <a:off x="4279839" y="4471841"/>
                  <a:ext cx="77938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verlap PCR</a:t>
                  </a:r>
                </a:p>
              </p:txBody>
            </p:sp>
          </p:grpSp>
        </p:grpSp>
      </p:grpSp>
      <p:grpSp>
        <p:nvGrpSpPr>
          <p:cNvPr id="331" name="Group 330">
            <a:extLst>
              <a:ext uri="{FF2B5EF4-FFF2-40B4-BE49-F238E27FC236}">
                <a16:creationId xmlns:a16="http://schemas.microsoft.com/office/drawing/2014/main" id="{F2080876-D9F9-43DC-8FD0-81AC2339D1A6}"/>
              </a:ext>
            </a:extLst>
          </p:cNvPr>
          <p:cNvGrpSpPr/>
          <p:nvPr/>
        </p:nvGrpSpPr>
        <p:grpSpPr>
          <a:xfrm>
            <a:off x="347057" y="4085140"/>
            <a:ext cx="6229676" cy="759148"/>
            <a:chOff x="316577" y="4897940"/>
            <a:chExt cx="6229676" cy="759148"/>
          </a:xfrm>
        </p:grpSpPr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D844E0C8-F66C-48EE-8192-959FA0532AC3}"/>
                </a:ext>
              </a:extLst>
            </p:cNvPr>
            <p:cNvSpPr txBox="1"/>
            <p:nvPr/>
          </p:nvSpPr>
          <p:spPr>
            <a:xfrm>
              <a:off x="316577" y="5147593"/>
              <a:ext cx="911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agment 4</a:t>
              </a:r>
            </a:p>
          </p:txBody>
        </p:sp>
        <p:grpSp>
          <p:nvGrpSpPr>
            <p:cNvPr id="330" name="Group 329">
              <a:extLst>
                <a:ext uri="{FF2B5EF4-FFF2-40B4-BE49-F238E27FC236}">
                  <a16:creationId xmlns:a16="http://schemas.microsoft.com/office/drawing/2014/main" id="{D542F2CD-D3BB-41CF-A2BC-DC6E03057A76}"/>
                </a:ext>
              </a:extLst>
            </p:cNvPr>
            <p:cNvGrpSpPr/>
            <p:nvPr/>
          </p:nvGrpSpPr>
          <p:grpSpPr>
            <a:xfrm>
              <a:off x="1192512" y="4897940"/>
              <a:ext cx="5353741" cy="759148"/>
              <a:chOff x="1192512" y="4897940"/>
              <a:chExt cx="5353741" cy="759148"/>
            </a:xfrm>
          </p:grpSpPr>
          <p:sp>
            <p:nvSpPr>
              <p:cNvPr id="293" name="Rectangle: Rounded Corners 292">
                <a:extLst>
                  <a:ext uri="{FF2B5EF4-FFF2-40B4-BE49-F238E27FC236}">
                    <a16:creationId xmlns:a16="http://schemas.microsoft.com/office/drawing/2014/main" id="{C0C35915-201D-49F3-9292-64CC144CEA7A}"/>
                  </a:ext>
                </a:extLst>
              </p:cNvPr>
              <p:cNvSpPr/>
              <p:nvPr/>
            </p:nvSpPr>
            <p:spPr>
              <a:xfrm>
                <a:off x="1399946" y="5226030"/>
                <a:ext cx="1255776" cy="115824"/>
              </a:xfrm>
              <a:prstGeom prst="round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id="{66F2D216-0338-4A52-95A6-B278EE98BDD6}"/>
                  </a:ext>
                </a:extLst>
              </p:cNvPr>
              <p:cNvSpPr txBox="1"/>
              <p:nvPr/>
            </p:nvSpPr>
            <p:spPr>
              <a:xfrm>
                <a:off x="1475002" y="5157046"/>
                <a:ext cx="10702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' homology arm</a:t>
                </a:r>
              </a:p>
            </p:txBody>
          </p:sp>
          <p:cxnSp>
            <p:nvCxnSpPr>
              <p:cNvPr id="295" name="Straight Arrow Connector 294">
                <a:extLst>
                  <a:ext uri="{FF2B5EF4-FFF2-40B4-BE49-F238E27FC236}">
                    <a16:creationId xmlns:a16="http://schemas.microsoft.com/office/drawing/2014/main" id="{EF0287F0-8096-4935-A0DB-CA96A67F4E1C}"/>
                  </a:ext>
                </a:extLst>
              </p:cNvPr>
              <p:cNvCxnSpPr/>
              <p:nvPr/>
            </p:nvCxnSpPr>
            <p:spPr>
              <a:xfrm>
                <a:off x="1395665" y="5147593"/>
                <a:ext cx="369367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Straight Arrow Connector 295">
                <a:extLst>
                  <a:ext uri="{FF2B5EF4-FFF2-40B4-BE49-F238E27FC236}">
                    <a16:creationId xmlns:a16="http://schemas.microsoft.com/office/drawing/2014/main" id="{E4F94A59-2D74-4F04-B385-E1C4C3E1918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327388" y="5433343"/>
                <a:ext cx="328334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8" name="TextBox 297">
                <a:extLst>
                  <a:ext uri="{FF2B5EF4-FFF2-40B4-BE49-F238E27FC236}">
                    <a16:creationId xmlns:a16="http://schemas.microsoft.com/office/drawing/2014/main" id="{450D9AF0-C8CC-4977-A41C-48FD2B9D4B7E}"/>
                  </a:ext>
                </a:extLst>
              </p:cNvPr>
              <p:cNvSpPr txBox="1"/>
              <p:nvPr/>
            </p:nvSpPr>
            <p:spPr>
              <a:xfrm>
                <a:off x="1192512" y="4942812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’ Ho-F-1</a:t>
                </a:r>
              </a:p>
            </p:txBody>
          </p:sp>
          <p:sp>
            <p:nvSpPr>
              <p:cNvPr id="299" name="TextBox 298">
                <a:extLst>
                  <a:ext uri="{FF2B5EF4-FFF2-40B4-BE49-F238E27FC236}">
                    <a16:creationId xmlns:a16="http://schemas.microsoft.com/office/drawing/2014/main" id="{A78C0C8B-07AE-42A9-9FB6-525EEDB70EFE}"/>
                  </a:ext>
                </a:extLst>
              </p:cNvPr>
              <p:cNvSpPr txBox="1"/>
              <p:nvPr/>
            </p:nvSpPr>
            <p:spPr>
              <a:xfrm>
                <a:off x="2117103" y="5446191"/>
                <a:ext cx="75839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’ Ho-R-1</a:t>
                </a:r>
              </a:p>
            </p:txBody>
          </p:sp>
          <p:cxnSp>
            <p:nvCxnSpPr>
              <p:cNvPr id="300" name="Straight Arrow Connector 299">
                <a:extLst>
                  <a:ext uri="{FF2B5EF4-FFF2-40B4-BE49-F238E27FC236}">
                    <a16:creationId xmlns:a16="http://schemas.microsoft.com/office/drawing/2014/main" id="{E05D89A2-0B79-4364-A0CC-C42EA468F9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30828" y="5285943"/>
                <a:ext cx="180694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1" name="TextBox 300">
                <a:extLst>
                  <a:ext uri="{FF2B5EF4-FFF2-40B4-BE49-F238E27FC236}">
                    <a16:creationId xmlns:a16="http://schemas.microsoft.com/office/drawing/2014/main" id="{69BB92C6-5ABB-4D57-A533-A87E4BDC116A}"/>
                  </a:ext>
                </a:extLst>
              </p:cNvPr>
              <p:cNvSpPr txBox="1"/>
              <p:nvPr/>
            </p:nvSpPr>
            <p:spPr>
              <a:xfrm>
                <a:off x="2606561" y="5057862"/>
                <a:ext cx="43095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R </a:t>
                </a:r>
              </a:p>
            </p:txBody>
          </p:sp>
          <p:sp>
            <p:nvSpPr>
              <p:cNvPr id="302" name="TextBox 301">
                <a:extLst>
                  <a:ext uri="{FF2B5EF4-FFF2-40B4-BE49-F238E27FC236}">
                    <a16:creationId xmlns:a16="http://schemas.microsoft.com/office/drawing/2014/main" id="{F2CF2DAE-C07B-47A7-BDC2-CF3C2E0D491B}"/>
                  </a:ext>
                </a:extLst>
              </p:cNvPr>
              <p:cNvSpPr txBox="1"/>
              <p:nvPr/>
            </p:nvSpPr>
            <p:spPr>
              <a:xfrm>
                <a:off x="2826840" y="5054593"/>
                <a:ext cx="9119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ASY T3 ligation, screen and sequence</a:t>
                </a:r>
              </a:p>
            </p:txBody>
          </p:sp>
          <p:cxnSp>
            <p:nvCxnSpPr>
              <p:cNvPr id="303" name="Straight Arrow Connector 302">
                <a:extLst>
                  <a:ext uri="{FF2B5EF4-FFF2-40B4-BE49-F238E27FC236}">
                    <a16:creationId xmlns:a16="http://schemas.microsoft.com/office/drawing/2014/main" id="{0A613260-AFD0-402F-823B-5DAF933237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38713" y="5262889"/>
                <a:ext cx="180694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4" name="Rectangle: Rounded Corners 303">
                <a:extLst>
                  <a:ext uri="{FF2B5EF4-FFF2-40B4-BE49-F238E27FC236}">
                    <a16:creationId xmlns:a16="http://schemas.microsoft.com/office/drawing/2014/main" id="{604FDD94-3B34-49D6-AB53-449F5B89C1B4}"/>
                  </a:ext>
                </a:extLst>
              </p:cNvPr>
              <p:cNvSpPr/>
              <p:nvPr/>
            </p:nvSpPr>
            <p:spPr>
              <a:xfrm>
                <a:off x="4105336" y="5201367"/>
                <a:ext cx="1255776" cy="115824"/>
              </a:xfrm>
              <a:prstGeom prst="round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6" name="TextBox 305">
                <a:extLst>
                  <a:ext uri="{FF2B5EF4-FFF2-40B4-BE49-F238E27FC236}">
                    <a16:creationId xmlns:a16="http://schemas.microsoft.com/office/drawing/2014/main" id="{A065F78A-2559-4434-B37F-59D0B091A733}"/>
                  </a:ext>
                </a:extLst>
              </p:cNvPr>
              <p:cNvSpPr txBox="1"/>
              <p:nvPr/>
            </p:nvSpPr>
            <p:spPr>
              <a:xfrm>
                <a:off x="4224488" y="5143863"/>
                <a:ext cx="10702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' homology arm</a:t>
                </a:r>
              </a:p>
            </p:txBody>
          </p:sp>
          <p:grpSp>
            <p:nvGrpSpPr>
              <p:cNvPr id="307" name="Group 306">
                <a:extLst>
                  <a:ext uri="{FF2B5EF4-FFF2-40B4-BE49-F238E27FC236}">
                    <a16:creationId xmlns:a16="http://schemas.microsoft.com/office/drawing/2014/main" id="{FCE01BA1-5DEE-4F51-81E2-F328071E9497}"/>
                  </a:ext>
                </a:extLst>
              </p:cNvPr>
              <p:cNvGrpSpPr/>
              <p:nvPr/>
            </p:nvGrpSpPr>
            <p:grpSpPr>
              <a:xfrm>
                <a:off x="3887624" y="5094775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308" name="Straight Arrow Connector 307">
                  <a:extLst>
                    <a:ext uri="{FF2B5EF4-FFF2-40B4-BE49-F238E27FC236}">
                      <a16:creationId xmlns:a16="http://schemas.microsoft.com/office/drawing/2014/main" id="{038BA352-626B-420F-9A3E-89B90B3F0BF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9" name="Straight Connector 308">
                  <a:extLst>
                    <a:ext uri="{FF2B5EF4-FFF2-40B4-BE49-F238E27FC236}">
                      <a16:creationId xmlns:a16="http://schemas.microsoft.com/office/drawing/2014/main" id="{3B5F4437-D50B-4F8E-83B4-8D6632EE07E4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0" name="Straight Connector 309">
                  <a:extLst>
                    <a:ext uri="{FF2B5EF4-FFF2-40B4-BE49-F238E27FC236}">
                      <a16:creationId xmlns:a16="http://schemas.microsoft.com/office/drawing/2014/main" id="{B2B1B62F-1123-42D0-99BD-9C4C848402C3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1" name="Group 310">
                <a:extLst>
                  <a:ext uri="{FF2B5EF4-FFF2-40B4-BE49-F238E27FC236}">
                    <a16:creationId xmlns:a16="http://schemas.microsoft.com/office/drawing/2014/main" id="{A0131305-DDE2-4D87-BAF8-C4FEE47F66D6}"/>
                  </a:ext>
                </a:extLst>
              </p:cNvPr>
              <p:cNvGrpSpPr/>
              <p:nvPr/>
            </p:nvGrpSpPr>
            <p:grpSpPr>
              <a:xfrm flipH="1" flipV="1">
                <a:off x="5127818" y="5381409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312" name="Straight Arrow Connector 311">
                  <a:extLst>
                    <a:ext uri="{FF2B5EF4-FFF2-40B4-BE49-F238E27FC236}">
                      <a16:creationId xmlns:a16="http://schemas.microsoft.com/office/drawing/2014/main" id="{6BA85187-946D-4BB9-BA8D-EB76DE232C7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3" name="Straight Connector 312">
                  <a:extLst>
                    <a:ext uri="{FF2B5EF4-FFF2-40B4-BE49-F238E27FC236}">
                      <a16:creationId xmlns:a16="http://schemas.microsoft.com/office/drawing/2014/main" id="{2CAEBEC6-80B0-4C5C-BE79-1C2CEED532BF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4" name="Straight Connector 313">
                  <a:extLst>
                    <a:ext uri="{FF2B5EF4-FFF2-40B4-BE49-F238E27FC236}">
                      <a16:creationId xmlns:a16="http://schemas.microsoft.com/office/drawing/2014/main" id="{4CF34741-93C9-406B-A1F6-4C337882F8DA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5" name="TextBox 324">
                <a:extLst>
                  <a:ext uri="{FF2B5EF4-FFF2-40B4-BE49-F238E27FC236}">
                    <a16:creationId xmlns:a16="http://schemas.microsoft.com/office/drawing/2014/main" id="{D0A03ED0-616D-401C-AE5B-31D6091C3D44}"/>
                  </a:ext>
                </a:extLst>
              </p:cNvPr>
              <p:cNvSpPr txBox="1"/>
              <p:nvPr/>
            </p:nvSpPr>
            <p:spPr>
              <a:xfrm>
                <a:off x="3496920" y="4897940"/>
                <a:ext cx="10702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 bp Poly-T-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' Ho-F-2</a:t>
                </a:r>
              </a:p>
            </p:txBody>
          </p:sp>
          <p:sp>
            <p:nvSpPr>
              <p:cNvPr id="326" name="TextBox 325">
                <a:extLst>
                  <a:ext uri="{FF2B5EF4-FFF2-40B4-BE49-F238E27FC236}">
                    <a16:creationId xmlns:a16="http://schemas.microsoft.com/office/drawing/2014/main" id="{ED320316-F57B-4797-AF28-B49898C6AD2C}"/>
                  </a:ext>
                </a:extLst>
              </p:cNvPr>
              <p:cNvSpPr txBox="1"/>
              <p:nvPr/>
            </p:nvSpPr>
            <p:spPr>
              <a:xfrm>
                <a:off x="4931744" y="5457033"/>
                <a:ext cx="97529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' Ho-R-2</a:t>
                </a:r>
                <a:r>
                  <a:rPr lang="en-US" sz="7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 St2-</a:t>
                </a:r>
                <a:r>
                  <a:rPr lang="en-US" sz="700" b="1" i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co</a:t>
                </a:r>
                <a:r>
                  <a:rPr lang="en-US" sz="7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</a:p>
            </p:txBody>
          </p:sp>
          <p:sp>
            <p:nvSpPr>
              <p:cNvPr id="327" name="TextBox 326">
                <a:extLst>
                  <a:ext uri="{FF2B5EF4-FFF2-40B4-BE49-F238E27FC236}">
                    <a16:creationId xmlns:a16="http://schemas.microsoft.com/office/drawing/2014/main" id="{D5EAF33F-7115-4FAE-A00E-23CE0FA246E5}"/>
                  </a:ext>
                </a:extLst>
              </p:cNvPr>
              <p:cNvSpPr txBox="1"/>
              <p:nvPr/>
            </p:nvSpPr>
            <p:spPr>
              <a:xfrm>
                <a:off x="5355143" y="5039006"/>
                <a:ext cx="43095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R </a:t>
                </a:r>
              </a:p>
            </p:txBody>
          </p:sp>
          <p:sp>
            <p:nvSpPr>
              <p:cNvPr id="328" name="TextBox 327">
                <a:extLst>
                  <a:ext uri="{FF2B5EF4-FFF2-40B4-BE49-F238E27FC236}">
                    <a16:creationId xmlns:a16="http://schemas.microsoft.com/office/drawing/2014/main" id="{A68521B8-BDEB-4279-B301-C04894FD1C72}"/>
                  </a:ext>
                </a:extLst>
              </p:cNvPr>
              <p:cNvSpPr txBox="1"/>
              <p:nvPr/>
            </p:nvSpPr>
            <p:spPr>
              <a:xfrm>
                <a:off x="5634324" y="5053530"/>
                <a:ext cx="9119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ASY T3 ligation, screen and sequence</a:t>
                </a:r>
              </a:p>
            </p:txBody>
          </p:sp>
          <p:cxnSp>
            <p:nvCxnSpPr>
              <p:cNvPr id="329" name="Straight Arrow Connector 328">
                <a:extLst>
                  <a:ext uri="{FF2B5EF4-FFF2-40B4-BE49-F238E27FC236}">
                    <a16:creationId xmlns:a16="http://schemas.microsoft.com/office/drawing/2014/main" id="{DC23724E-06C1-491D-8B04-78749133DF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79065" y="5254450"/>
                <a:ext cx="24940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66" name="Group 365">
            <a:extLst>
              <a:ext uri="{FF2B5EF4-FFF2-40B4-BE49-F238E27FC236}">
                <a16:creationId xmlns:a16="http://schemas.microsoft.com/office/drawing/2014/main" id="{69D74C37-E502-41F1-AE5D-86B6309367EF}"/>
              </a:ext>
            </a:extLst>
          </p:cNvPr>
          <p:cNvGrpSpPr/>
          <p:nvPr/>
        </p:nvGrpSpPr>
        <p:grpSpPr>
          <a:xfrm>
            <a:off x="411139" y="5010454"/>
            <a:ext cx="5721192" cy="754286"/>
            <a:chOff x="411139" y="5942634"/>
            <a:chExt cx="5721192" cy="754286"/>
          </a:xfrm>
        </p:grpSpPr>
        <p:grpSp>
          <p:nvGrpSpPr>
            <p:cNvPr id="316" name="Group 315">
              <a:extLst>
                <a:ext uri="{FF2B5EF4-FFF2-40B4-BE49-F238E27FC236}">
                  <a16:creationId xmlns:a16="http://schemas.microsoft.com/office/drawing/2014/main" id="{81B0B48D-B382-47AE-BDC9-2CDE4DEA3AB3}"/>
                </a:ext>
              </a:extLst>
            </p:cNvPr>
            <p:cNvGrpSpPr/>
            <p:nvPr/>
          </p:nvGrpSpPr>
          <p:grpSpPr>
            <a:xfrm flipH="1">
              <a:off x="4491217" y="6132271"/>
              <a:ext cx="449633" cy="60369"/>
              <a:chOff x="5558790" y="222885"/>
              <a:chExt cx="497138" cy="41910"/>
            </a:xfrm>
          </p:grpSpPr>
          <p:cxnSp>
            <p:nvCxnSpPr>
              <p:cNvPr id="317" name="Straight Arrow Connector 316">
                <a:extLst>
                  <a:ext uri="{FF2B5EF4-FFF2-40B4-BE49-F238E27FC236}">
                    <a16:creationId xmlns:a16="http://schemas.microsoft.com/office/drawing/2014/main" id="{4B76346F-DD6D-4DA4-A69E-7D4900E919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8" name="Straight Connector 317">
                <a:extLst>
                  <a:ext uri="{FF2B5EF4-FFF2-40B4-BE49-F238E27FC236}">
                    <a16:creationId xmlns:a16="http://schemas.microsoft.com/office/drawing/2014/main" id="{C5010D8C-594C-4879-B8F1-FE07D972EBA2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9" name="Straight Connector 318">
                <a:extLst>
                  <a:ext uri="{FF2B5EF4-FFF2-40B4-BE49-F238E27FC236}">
                    <a16:creationId xmlns:a16="http://schemas.microsoft.com/office/drawing/2014/main" id="{934A4DA7-6AD1-4BE4-A8DA-4910EAC27045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0" name="Group 319">
              <a:extLst>
                <a:ext uri="{FF2B5EF4-FFF2-40B4-BE49-F238E27FC236}">
                  <a16:creationId xmlns:a16="http://schemas.microsoft.com/office/drawing/2014/main" id="{2A8EB7F2-B43A-4AA6-A725-D601488F26DE}"/>
                </a:ext>
              </a:extLst>
            </p:cNvPr>
            <p:cNvGrpSpPr/>
            <p:nvPr/>
          </p:nvGrpSpPr>
          <p:grpSpPr>
            <a:xfrm flipV="1">
              <a:off x="1946647" y="6447497"/>
              <a:ext cx="479166" cy="58418"/>
              <a:chOff x="5558790" y="222885"/>
              <a:chExt cx="497138" cy="41910"/>
            </a:xfrm>
          </p:grpSpPr>
          <p:cxnSp>
            <p:nvCxnSpPr>
              <p:cNvPr id="321" name="Straight Arrow Connector 320">
                <a:extLst>
                  <a:ext uri="{FF2B5EF4-FFF2-40B4-BE49-F238E27FC236}">
                    <a16:creationId xmlns:a16="http://schemas.microsoft.com/office/drawing/2014/main" id="{E6935F16-DB07-49FA-9FF1-2096D48448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2" name="Straight Connector 321">
                <a:extLst>
                  <a:ext uri="{FF2B5EF4-FFF2-40B4-BE49-F238E27FC236}">
                    <a16:creationId xmlns:a16="http://schemas.microsoft.com/office/drawing/2014/main" id="{E4EF32E0-C20D-477B-8F48-559C13708E4F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Straight Connector 322">
                <a:extLst>
                  <a:ext uri="{FF2B5EF4-FFF2-40B4-BE49-F238E27FC236}">
                    <a16:creationId xmlns:a16="http://schemas.microsoft.com/office/drawing/2014/main" id="{91561938-E6D6-43D0-90AF-1919D6845450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2" name="Group 331">
              <a:extLst>
                <a:ext uri="{FF2B5EF4-FFF2-40B4-BE49-F238E27FC236}">
                  <a16:creationId xmlns:a16="http://schemas.microsoft.com/office/drawing/2014/main" id="{5B965F79-BFFA-4856-AE31-05B840D77012}"/>
                </a:ext>
              </a:extLst>
            </p:cNvPr>
            <p:cNvGrpSpPr/>
            <p:nvPr/>
          </p:nvGrpSpPr>
          <p:grpSpPr>
            <a:xfrm>
              <a:off x="411139" y="5942634"/>
              <a:ext cx="5721192" cy="754286"/>
              <a:chOff x="-97167" y="943823"/>
              <a:chExt cx="5721192" cy="754286"/>
            </a:xfrm>
          </p:grpSpPr>
          <p:grpSp>
            <p:nvGrpSpPr>
              <p:cNvPr id="333" name="Group 332">
                <a:extLst>
                  <a:ext uri="{FF2B5EF4-FFF2-40B4-BE49-F238E27FC236}">
                    <a16:creationId xmlns:a16="http://schemas.microsoft.com/office/drawing/2014/main" id="{73B403DE-FA76-41C8-ADAC-41403FA2BFF4}"/>
                  </a:ext>
                </a:extLst>
              </p:cNvPr>
              <p:cNvGrpSpPr/>
              <p:nvPr/>
            </p:nvGrpSpPr>
            <p:grpSpPr>
              <a:xfrm>
                <a:off x="-97167" y="943823"/>
                <a:ext cx="4701874" cy="754286"/>
                <a:chOff x="408801" y="949919"/>
                <a:chExt cx="4701874" cy="754286"/>
              </a:xfrm>
            </p:grpSpPr>
            <p:grpSp>
              <p:nvGrpSpPr>
                <p:cNvPr id="338" name="Group 337">
                  <a:extLst>
                    <a:ext uri="{FF2B5EF4-FFF2-40B4-BE49-F238E27FC236}">
                      <a16:creationId xmlns:a16="http://schemas.microsoft.com/office/drawing/2014/main" id="{8FDC8F07-E79D-40CD-89CA-AB7DD94686FB}"/>
                    </a:ext>
                  </a:extLst>
                </p:cNvPr>
                <p:cNvGrpSpPr/>
                <p:nvPr/>
              </p:nvGrpSpPr>
              <p:grpSpPr>
                <a:xfrm>
                  <a:off x="2183892" y="1212329"/>
                  <a:ext cx="2926783" cy="346116"/>
                  <a:chOff x="1536192" y="1225517"/>
                  <a:chExt cx="2926783" cy="346116"/>
                </a:xfrm>
              </p:grpSpPr>
              <p:sp>
                <p:nvSpPr>
                  <p:cNvPr id="348" name="TextBox 347">
                    <a:extLst>
                      <a:ext uri="{FF2B5EF4-FFF2-40B4-BE49-F238E27FC236}">
                        <a16:creationId xmlns:a16="http://schemas.microsoft.com/office/drawing/2014/main" id="{6DD1230E-3DCA-42D2-B5A9-FCF9DB945987}"/>
                      </a:ext>
                    </a:extLst>
                  </p:cNvPr>
                  <p:cNvSpPr txBox="1"/>
                  <p:nvPr/>
                </p:nvSpPr>
                <p:spPr>
                  <a:xfrm>
                    <a:off x="3576007" y="1386967"/>
                    <a:ext cx="88696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III</a:t>
                    </a:r>
                    <a:endPara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349" name="Group 348">
                    <a:extLst>
                      <a:ext uri="{FF2B5EF4-FFF2-40B4-BE49-F238E27FC236}">
                        <a16:creationId xmlns:a16="http://schemas.microsoft.com/office/drawing/2014/main" id="{7BE4BBDA-9BED-4794-9BD7-F9F42A3358CF}"/>
                      </a:ext>
                    </a:extLst>
                  </p:cNvPr>
                  <p:cNvGrpSpPr/>
                  <p:nvPr/>
                </p:nvGrpSpPr>
                <p:grpSpPr>
                  <a:xfrm>
                    <a:off x="1536192" y="1225517"/>
                    <a:ext cx="2537462" cy="230832"/>
                    <a:chOff x="1536192" y="1225517"/>
                    <a:chExt cx="2537462" cy="230832"/>
                  </a:xfrm>
                </p:grpSpPr>
                <p:sp>
                  <p:nvSpPr>
                    <p:cNvPr id="350" name="Rectangle: Rounded Corners 349">
                      <a:extLst>
                        <a:ext uri="{FF2B5EF4-FFF2-40B4-BE49-F238E27FC236}">
                          <a16:creationId xmlns:a16="http://schemas.microsoft.com/office/drawing/2014/main" id="{232FE381-9663-43FF-B915-DD68EE37E1E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536192" y="1286256"/>
                      <a:ext cx="1255776" cy="115824"/>
                    </a:xfrm>
                    <a:prstGeom prst="round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51" name="Arrow: Pentagon 350">
                      <a:extLst>
                        <a:ext uri="{FF2B5EF4-FFF2-40B4-BE49-F238E27FC236}">
                          <a16:creationId xmlns:a16="http://schemas.microsoft.com/office/drawing/2014/main" id="{18909499-339C-455D-8F80-96E60FC377E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833370" y="1286256"/>
                      <a:ext cx="455170" cy="115824"/>
                    </a:xfrm>
                    <a:prstGeom prst="homePlate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52" name="Arrow: Pentagon 351">
                      <a:extLst>
                        <a:ext uri="{FF2B5EF4-FFF2-40B4-BE49-F238E27FC236}">
                          <a16:creationId xmlns:a16="http://schemas.microsoft.com/office/drawing/2014/main" id="{666D10FE-D582-4443-B5F6-444B04475C2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326004" y="1286256"/>
                      <a:ext cx="660273" cy="115824"/>
                    </a:xfrm>
                    <a:prstGeom prst="homePlate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53" name="Rectangle 352">
                      <a:extLst>
                        <a:ext uri="{FF2B5EF4-FFF2-40B4-BE49-F238E27FC236}">
                          <a16:creationId xmlns:a16="http://schemas.microsoft.com/office/drawing/2014/main" id="{065C6766-BEA8-4F9D-8C4F-F8B1FE990DE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986278" y="1286256"/>
                      <a:ext cx="87376" cy="115824"/>
                    </a:xfrm>
                    <a:prstGeom prst="rect">
                      <a:avLst/>
                    </a:prstGeom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54" name="TextBox 353">
                      <a:extLst>
                        <a:ext uri="{FF2B5EF4-FFF2-40B4-BE49-F238E27FC236}">
                          <a16:creationId xmlns:a16="http://schemas.microsoft.com/office/drawing/2014/main" id="{ECBB8EEB-56D9-4A73-8C94-D18A62D48A6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80499" y="1225517"/>
                      <a:ext cx="99593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U3 promoter</a:t>
                      </a:r>
                    </a:p>
                  </p:txBody>
                </p:sp>
                <p:sp>
                  <p:nvSpPr>
                    <p:cNvPr id="355" name="TextBox 354">
                      <a:extLst>
                        <a:ext uri="{FF2B5EF4-FFF2-40B4-BE49-F238E27FC236}">
                          <a16:creationId xmlns:a16="http://schemas.microsoft.com/office/drawing/2014/main" id="{A2EE91BA-62F6-4689-9F9C-BD738D9BED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46573" y="1238037"/>
                      <a:ext cx="78339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NA scaffold</a:t>
                      </a:r>
                    </a:p>
                  </p:txBody>
                </p:sp>
                <p:sp>
                  <p:nvSpPr>
                    <p:cNvPr id="356" name="TextBox 355">
                      <a:extLst>
                        <a:ext uri="{FF2B5EF4-FFF2-40B4-BE49-F238E27FC236}">
                          <a16:creationId xmlns:a16="http://schemas.microsoft.com/office/drawing/2014/main" id="{75D2DED0-90F6-4A11-BB6F-27EBE726F21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866086" y="1238037"/>
                      <a:ext cx="357479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t2</a:t>
                      </a:r>
                    </a:p>
                  </p:txBody>
                </p:sp>
              </p:grpSp>
            </p:grpSp>
            <p:sp>
              <p:nvSpPr>
                <p:cNvPr id="339" name="TextBox 338">
                  <a:extLst>
                    <a:ext uri="{FF2B5EF4-FFF2-40B4-BE49-F238E27FC236}">
                      <a16:creationId xmlns:a16="http://schemas.microsoft.com/office/drawing/2014/main" id="{96721D52-8092-4F83-B6EB-720546ABA8C3}"/>
                    </a:ext>
                  </a:extLst>
                </p:cNvPr>
                <p:cNvSpPr txBox="1"/>
                <p:nvPr/>
              </p:nvSpPr>
              <p:spPr>
                <a:xfrm>
                  <a:off x="408801" y="1185041"/>
                  <a:ext cx="91192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ragment 5</a:t>
                  </a:r>
                </a:p>
              </p:txBody>
            </p:sp>
            <p:sp>
              <p:nvSpPr>
                <p:cNvPr id="341" name="TextBox 340">
                  <a:extLst>
                    <a:ext uri="{FF2B5EF4-FFF2-40B4-BE49-F238E27FC236}">
                      <a16:creationId xmlns:a16="http://schemas.microsoft.com/office/drawing/2014/main" id="{D5C66C71-5882-4ECA-AB5A-FA56AFC2A588}"/>
                    </a:ext>
                  </a:extLst>
                </p:cNvPr>
                <p:cNvSpPr txBox="1"/>
                <p:nvPr/>
              </p:nvSpPr>
              <p:spPr>
                <a:xfrm>
                  <a:off x="1788256" y="1504150"/>
                  <a:ext cx="75839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da</a:t>
                  </a:r>
                  <a:r>
                    <a: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Os2-R</a:t>
                  </a:r>
                </a:p>
              </p:txBody>
            </p:sp>
            <p:cxnSp>
              <p:nvCxnSpPr>
                <p:cNvPr id="342" name="Straight Arrow Connector 341">
                  <a:extLst>
                    <a:ext uri="{FF2B5EF4-FFF2-40B4-BE49-F238E27FC236}">
                      <a16:creationId xmlns:a16="http://schemas.microsoft.com/office/drawing/2014/main" id="{59898E68-56D5-4DEE-A495-403EB688903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80156" y="1474077"/>
                  <a:ext cx="435610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3" name="Straight Arrow Connector 342">
                  <a:extLst>
                    <a:ext uri="{FF2B5EF4-FFF2-40B4-BE49-F238E27FC236}">
                      <a16:creationId xmlns:a16="http://schemas.microsoft.com/office/drawing/2014/main" id="{C57997CA-B5A6-44B0-8364-6D78B402F7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477028" y="1194054"/>
                  <a:ext cx="397755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4" name="TextBox 343">
                  <a:extLst>
                    <a:ext uri="{FF2B5EF4-FFF2-40B4-BE49-F238E27FC236}">
                      <a16:creationId xmlns:a16="http://schemas.microsoft.com/office/drawing/2014/main" id="{653DDBD9-5ED0-49B6-8012-898B1C94485F}"/>
                    </a:ext>
                  </a:extLst>
                </p:cNvPr>
                <p:cNvSpPr txBox="1"/>
                <p:nvPr/>
              </p:nvSpPr>
              <p:spPr>
                <a:xfrm>
                  <a:off x="3472046" y="1005855"/>
                  <a:ext cx="46419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go2-F</a:t>
                  </a:r>
                </a:p>
              </p:txBody>
            </p:sp>
            <p:sp>
              <p:nvSpPr>
                <p:cNvPr id="345" name="TextBox 344">
                  <a:extLst>
                    <a:ext uri="{FF2B5EF4-FFF2-40B4-BE49-F238E27FC236}">
                      <a16:creationId xmlns:a16="http://schemas.microsoft.com/office/drawing/2014/main" id="{F0A91185-018F-45C4-9B01-736DDB2B95ED}"/>
                    </a:ext>
                  </a:extLst>
                </p:cNvPr>
                <p:cNvSpPr txBox="1"/>
                <p:nvPr/>
              </p:nvSpPr>
              <p:spPr>
                <a:xfrm>
                  <a:off x="3436573" y="1440465"/>
                  <a:ext cx="4630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go2-R</a:t>
                  </a:r>
                </a:p>
              </p:txBody>
            </p:sp>
            <p:sp>
              <p:nvSpPr>
                <p:cNvPr id="347" name="TextBox 346">
                  <a:extLst>
                    <a:ext uri="{FF2B5EF4-FFF2-40B4-BE49-F238E27FC236}">
                      <a16:creationId xmlns:a16="http://schemas.microsoft.com/office/drawing/2014/main" id="{A253EAF3-1EBF-497A-9307-5EF00A8E2BEE}"/>
                    </a:ext>
                  </a:extLst>
                </p:cNvPr>
                <p:cNvSpPr txBox="1"/>
                <p:nvPr/>
              </p:nvSpPr>
              <p:spPr>
                <a:xfrm>
                  <a:off x="4323198" y="949919"/>
                  <a:ext cx="75839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2-F-</a:t>
                  </a:r>
                  <a:r>
                    <a:rPr lang="en-US" sz="7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co</a:t>
                  </a:r>
                  <a:r>
                    <a: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</a:p>
              </p:txBody>
            </p:sp>
          </p:grpSp>
          <p:cxnSp>
            <p:nvCxnSpPr>
              <p:cNvPr id="334" name="Straight Arrow Connector 333">
                <a:extLst>
                  <a:ext uri="{FF2B5EF4-FFF2-40B4-BE49-F238E27FC236}">
                    <a16:creationId xmlns:a16="http://schemas.microsoft.com/office/drawing/2014/main" id="{5BFE5953-E8E3-4425-A1AD-2DCE40C2CE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13699" y="1321649"/>
                <a:ext cx="382016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5" name="TextBox 334">
                <a:extLst>
                  <a:ext uri="{FF2B5EF4-FFF2-40B4-BE49-F238E27FC236}">
                    <a16:creationId xmlns:a16="http://schemas.microsoft.com/office/drawing/2014/main" id="{033CA453-3C3D-4767-B2B5-8EC961E6A11E}"/>
                  </a:ext>
                </a:extLst>
              </p:cNvPr>
              <p:cNvSpPr txBox="1"/>
              <p:nvPr/>
            </p:nvSpPr>
            <p:spPr>
              <a:xfrm>
                <a:off x="4712096" y="1092567"/>
                <a:ext cx="9119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ASY T3 ligation, screen and sequence</a:t>
                </a:r>
              </a:p>
            </p:txBody>
          </p:sp>
          <p:sp>
            <p:nvSpPr>
              <p:cNvPr id="336" name="TextBox 335">
                <a:extLst>
                  <a:ext uri="{FF2B5EF4-FFF2-40B4-BE49-F238E27FC236}">
                    <a16:creationId xmlns:a16="http://schemas.microsoft.com/office/drawing/2014/main" id="{B6A2E3BE-D852-4904-9599-696454AAF4DF}"/>
                  </a:ext>
                </a:extLst>
              </p:cNvPr>
              <p:cNvSpPr txBox="1"/>
              <p:nvPr/>
            </p:nvSpPr>
            <p:spPr>
              <a:xfrm>
                <a:off x="4255398" y="1132294"/>
                <a:ext cx="67158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R </a:t>
                </a:r>
              </a:p>
            </p:txBody>
          </p:sp>
        </p:grpSp>
      </p:grpSp>
      <p:grpSp>
        <p:nvGrpSpPr>
          <p:cNvPr id="365" name="Group 364">
            <a:extLst>
              <a:ext uri="{FF2B5EF4-FFF2-40B4-BE49-F238E27FC236}">
                <a16:creationId xmlns:a16="http://schemas.microsoft.com/office/drawing/2014/main" id="{FEDA9DB5-C312-4F33-8D27-886BD27B0F6D}"/>
              </a:ext>
            </a:extLst>
          </p:cNvPr>
          <p:cNvGrpSpPr/>
          <p:nvPr/>
        </p:nvGrpSpPr>
        <p:grpSpPr>
          <a:xfrm>
            <a:off x="319554" y="565636"/>
            <a:ext cx="5676304" cy="917351"/>
            <a:chOff x="319554" y="972036"/>
            <a:chExt cx="5676304" cy="917351"/>
          </a:xfrm>
        </p:grpSpPr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97542E1E-B006-404D-A814-C0609C668355}"/>
                </a:ext>
              </a:extLst>
            </p:cNvPr>
            <p:cNvSpPr txBox="1"/>
            <p:nvPr/>
          </p:nvSpPr>
          <p:spPr>
            <a:xfrm>
              <a:off x="1139764" y="1550833"/>
              <a:ext cx="13516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al gRNA target: Sgt</a:t>
              </a:r>
            </a:p>
            <a:p>
              <a:r>
                <a:rPr lang="en-US" sz="800" b="1" dirty="0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al gRNA oligo: </a:t>
              </a:r>
              <a:r>
                <a:rPr lang="en-US" sz="800" b="1" dirty="0" err="1">
                  <a:solidFill>
                    <a:srgbClr val="00206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go</a:t>
              </a:r>
              <a:endParaRPr lang="en-US" sz="8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id="{567CA4CE-A625-4246-8B6A-911D96288AE3}"/>
                </a:ext>
              </a:extLst>
            </p:cNvPr>
            <p:cNvGrpSpPr/>
            <p:nvPr/>
          </p:nvGrpSpPr>
          <p:grpSpPr>
            <a:xfrm>
              <a:off x="2097812" y="1119996"/>
              <a:ext cx="2931033" cy="323165"/>
              <a:chOff x="1536192" y="1133184"/>
              <a:chExt cx="2931033" cy="323165"/>
            </a:xfrm>
          </p:grpSpPr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D13BAEF5-61EF-4F2A-AF62-568EFFCF5E0B}"/>
                  </a:ext>
                </a:extLst>
              </p:cNvPr>
              <p:cNvSpPr txBox="1"/>
              <p:nvPr/>
            </p:nvSpPr>
            <p:spPr>
              <a:xfrm>
                <a:off x="3580257" y="1133184"/>
                <a:ext cx="88696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III</a:t>
                </a:r>
                <a:endParaRPr 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0" name="Group 139">
                <a:extLst>
                  <a:ext uri="{FF2B5EF4-FFF2-40B4-BE49-F238E27FC236}">
                    <a16:creationId xmlns:a16="http://schemas.microsoft.com/office/drawing/2014/main" id="{A3AA615D-C95F-4259-9559-941A0BE88725}"/>
                  </a:ext>
                </a:extLst>
              </p:cNvPr>
              <p:cNvGrpSpPr/>
              <p:nvPr/>
            </p:nvGrpSpPr>
            <p:grpSpPr>
              <a:xfrm>
                <a:off x="1536192" y="1225517"/>
                <a:ext cx="2537462" cy="230832"/>
                <a:chOff x="1536192" y="1225517"/>
                <a:chExt cx="2537462" cy="230832"/>
              </a:xfrm>
            </p:grpSpPr>
            <p:sp>
              <p:nvSpPr>
                <p:cNvPr id="130" name="Rectangle: Rounded Corners 129">
                  <a:extLst>
                    <a:ext uri="{FF2B5EF4-FFF2-40B4-BE49-F238E27FC236}">
                      <a16:creationId xmlns:a16="http://schemas.microsoft.com/office/drawing/2014/main" id="{3A8B1B77-3098-42DA-AF35-C4BFDA2A2435}"/>
                    </a:ext>
                  </a:extLst>
                </p:cNvPr>
                <p:cNvSpPr/>
                <p:nvPr/>
              </p:nvSpPr>
              <p:spPr>
                <a:xfrm>
                  <a:off x="1536192" y="1286256"/>
                  <a:ext cx="1255776" cy="115824"/>
                </a:xfrm>
                <a:prstGeom prst="round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1" name="Arrow: Pentagon 130">
                  <a:extLst>
                    <a:ext uri="{FF2B5EF4-FFF2-40B4-BE49-F238E27FC236}">
                      <a16:creationId xmlns:a16="http://schemas.microsoft.com/office/drawing/2014/main" id="{50E3B9EC-7A54-4E07-B20A-F4828463296E}"/>
                    </a:ext>
                  </a:extLst>
                </p:cNvPr>
                <p:cNvSpPr/>
                <p:nvPr/>
              </p:nvSpPr>
              <p:spPr>
                <a:xfrm>
                  <a:off x="2833370" y="1286256"/>
                  <a:ext cx="455170" cy="115824"/>
                </a:xfrm>
                <a:prstGeom prst="homePlat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2" name="Arrow: Pentagon 131">
                  <a:extLst>
                    <a:ext uri="{FF2B5EF4-FFF2-40B4-BE49-F238E27FC236}">
                      <a16:creationId xmlns:a16="http://schemas.microsoft.com/office/drawing/2014/main" id="{57BCD896-E0D0-44F3-BB11-D04435AF7FE9}"/>
                    </a:ext>
                  </a:extLst>
                </p:cNvPr>
                <p:cNvSpPr/>
                <p:nvPr/>
              </p:nvSpPr>
              <p:spPr>
                <a:xfrm>
                  <a:off x="3326004" y="1286256"/>
                  <a:ext cx="660273" cy="115824"/>
                </a:xfrm>
                <a:prstGeom prst="homePlat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3" name="Rectangle 132">
                  <a:extLst>
                    <a:ext uri="{FF2B5EF4-FFF2-40B4-BE49-F238E27FC236}">
                      <a16:creationId xmlns:a16="http://schemas.microsoft.com/office/drawing/2014/main" id="{B529396F-D6C9-4491-9B4D-F7274DFB5CC8}"/>
                    </a:ext>
                  </a:extLst>
                </p:cNvPr>
                <p:cNvSpPr/>
                <p:nvPr/>
              </p:nvSpPr>
              <p:spPr>
                <a:xfrm>
                  <a:off x="3986278" y="1286256"/>
                  <a:ext cx="87376" cy="115824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4" name="TextBox 133">
                  <a:extLst>
                    <a:ext uri="{FF2B5EF4-FFF2-40B4-BE49-F238E27FC236}">
                      <a16:creationId xmlns:a16="http://schemas.microsoft.com/office/drawing/2014/main" id="{6ED6BF1B-7197-4FAD-981C-452DE53C893B}"/>
                    </a:ext>
                  </a:extLst>
                </p:cNvPr>
                <p:cNvSpPr txBox="1"/>
                <p:nvPr/>
              </p:nvSpPr>
              <p:spPr>
                <a:xfrm>
                  <a:off x="1680499" y="1225517"/>
                  <a:ext cx="99593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U3 promoter</a:t>
                  </a:r>
                </a:p>
              </p:txBody>
            </p:sp>
            <p:sp>
              <p:nvSpPr>
                <p:cNvPr id="136" name="TextBox 135">
                  <a:extLst>
                    <a:ext uri="{FF2B5EF4-FFF2-40B4-BE49-F238E27FC236}">
                      <a16:creationId xmlns:a16="http://schemas.microsoft.com/office/drawing/2014/main" id="{E568A896-565D-48B4-8424-30F02D4829AB}"/>
                    </a:ext>
                  </a:extLst>
                </p:cNvPr>
                <p:cNvSpPr txBox="1"/>
                <p:nvPr/>
              </p:nvSpPr>
              <p:spPr>
                <a:xfrm>
                  <a:off x="3246573" y="1238037"/>
                  <a:ext cx="78339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RNA scaffold</a:t>
                  </a:r>
                </a:p>
              </p:txBody>
            </p:sp>
            <p:sp>
              <p:nvSpPr>
                <p:cNvPr id="138" name="TextBox 137">
                  <a:extLst>
                    <a:ext uri="{FF2B5EF4-FFF2-40B4-BE49-F238E27FC236}">
                      <a16:creationId xmlns:a16="http://schemas.microsoft.com/office/drawing/2014/main" id="{03A02AB5-791B-4A93-BE4C-463D825E17CD}"/>
                    </a:ext>
                  </a:extLst>
                </p:cNvPr>
                <p:cNvSpPr txBox="1"/>
                <p:nvPr/>
              </p:nvSpPr>
              <p:spPr>
                <a:xfrm>
                  <a:off x="2866086" y="1238037"/>
                  <a:ext cx="35747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gt1</a:t>
                  </a:r>
                </a:p>
              </p:txBody>
            </p:sp>
          </p:grpSp>
        </p:grp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982818C6-3F1C-4E54-BC15-DB5770E6E40B}"/>
                </a:ext>
              </a:extLst>
            </p:cNvPr>
            <p:cNvSpPr txBox="1"/>
            <p:nvPr/>
          </p:nvSpPr>
          <p:spPr>
            <a:xfrm>
              <a:off x="319554" y="1196822"/>
              <a:ext cx="9119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agment 1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AC5AFBB0-7886-4101-9625-DDEA60A82880}"/>
                </a:ext>
              </a:extLst>
            </p:cNvPr>
            <p:cNvSpPr txBox="1"/>
            <p:nvPr/>
          </p:nvSpPr>
          <p:spPr>
            <a:xfrm>
              <a:off x="1702278" y="972036"/>
              <a:ext cx="7583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ind</a:t>
              </a:r>
              <a:r>
                <a: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II</a:t>
              </a:r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Os1-F</a:t>
              </a:r>
            </a:p>
          </p:txBody>
        </p:sp>
        <p:cxnSp>
          <p:nvCxnSpPr>
            <p:cNvPr id="146" name="Straight Arrow Connector 145">
              <a:extLst>
                <a:ext uri="{FF2B5EF4-FFF2-40B4-BE49-F238E27FC236}">
                  <a16:creationId xmlns:a16="http://schemas.microsoft.com/office/drawing/2014/main" id="{F444EEAE-319C-4C35-916F-BA582FF7315C}"/>
                </a:ext>
              </a:extLst>
            </p:cNvPr>
            <p:cNvCxnSpPr>
              <a:cxnSpLocks/>
            </p:cNvCxnSpPr>
            <p:nvPr/>
          </p:nvCxnSpPr>
          <p:spPr>
            <a:xfrm>
              <a:off x="3394990" y="1203960"/>
              <a:ext cx="43561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Arrow Connector 146">
              <a:extLst>
                <a:ext uri="{FF2B5EF4-FFF2-40B4-BE49-F238E27FC236}">
                  <a16:creationId xmlns:a16="http://schemas.microsoft.com/office/drawing/2014/main" id="{510CEFC1-81A2-4DA6-9023-A6134C17C3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10438" y="1469018"/>
              <a:ext cx="39775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9B9FCFD8-E963-46A2-B20A-28CE305AB41E}"/>
                </a:ext>
              </a:extLst>
            </p:cNvPr>
            <p:cNvSpPr txBox="1"/>
            <p:nvPr/>
          </p:nvSpPr>
          <p:spPr>
            <a:xfrm>
              <a:off x="3355417" y="1015332"/>
              <a:ext cx="46311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o1-F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68B75254-0D9E-472A-AC27-E0A240AB179B}"/>
                </a:ext>
              </a:extLst>
            </p:cNvPr>
            <p:cNvSpPr txBox="1"/>
            <p:nvPr/>
          </p:nvSpPr>
          <p:spPr>
            <a:xfrm>
              <a:off x="3360531" y="1471222"/>
              <a:ext cx="4825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o1-R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B5F625C4-DC94-4638-A3B5-FF15F1D7A3FB}"/>
                </a:ext>
              </a:extLst>
            </p:cNvPr>
            <p:cNvSpPr txBox="1"/>
            <p:nvPr/>
          </p:nvSpPr>
          <p:spPr>
            <a:xfrm>
              <a:off x="4306178" y="1554476"/>
              <a:ext cx="7583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1-R-</a:t>
              </a:r>
              <a:r>
                <a:rPr lang="en-US" sz="7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mH</a:t>
              </a:r>
              <a:r>
                <a: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</a:p>
          </p:txBody>
        </p:sp>
        <p:cxnSp>
          <p:nvCxnSpPr>
            <p:cNvPr id="160" name="Straight Arrow Connector 159">
              <a:extLst>
                <a:ext uri="{FF2B5EF4-FFF2-40B4-BE49-F238E27FC236}">
                  <a16:creationId xmlns:a16="http://schemas.microsoft.com/office/drawing/2014/main" id="{66173FE3-18C4-4ED4-9EC8-F278B1691357}"/>
                </a:ext>
              </a:extLst>
            </p:cNvPr>
            <p:cNvCxnSpPr>
              <a:cxnSpLocks/>
            </p:cNvCxnSpPr>
            <p:nvPr/>
          </p:nvCxnSpPr>
          <p:spPr>
            <a:xfrm>
              <a:off x="4767352" y="1324876"/>
              <a:ext cx="38201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1CB84604-FD73-4C76-AFA1-DCC2623F6188}"/>
                </a:ext>
              </a:extLst>
            </p:cNvPr>
            <p:cNvSpPr txBox="1"/>
            <p:nvPr/>
          </p:nvSpPr>
          <p:spPr>
            <a:xfrm>
              <a:off x="5083929" y="1104607"/>
              <a:ext cx="91192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ASY T3 ligation, screen and sequence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0C2DD42E-99B6-4F2F-B33B-72DA0E69A285}"/>
                </a:ext>
              </a:extLst>
            </p:cNvPr>
            <p:cNvSpPr txBox="1"/>
            <p:nvPr/>
          </p:nvSpPr>
          <p:spPr>
            <a:xfrm>
              <a:off x="4605058" y="1119996"/>
              <a:ext cx="6715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R </a:t>
              </a:r>
            </a:p>
          </p:txBody>
        </p:sp>
        <p:grpSp>
          <p:nvGrpSpPr>
            <p:cNvPr id="357" name="Group 356">
              <a:extLst>
                <a:ext uri="{FF2B5EF4-FFF2-40B4-BE49-F238E27FC236}">
                  <a16:creationId xmlns:a16="http://schemas.microsoft.com/office/drawing/2014/main" id="{3E82BC97-DEAA-4C15-8206-EAE555474B1A}"/>
                </a:ext>
              </a:extLst>
            </p:cNvPr>
            <p:cNvGrpSpPr/>
            <p:nvPr/>
          </p:nvGrpSpPr>
          <p:grpSpPr>
            <a:xfrm>
              <a:off x="1860161" y="1173917"/>
              <a:ext cx="497138" cy="41910"/>
              <a:chOff x="5558790" y="222885"/>
              <a:chExt cx="497138" cy="41910"/>
            </a:xfrm>
          </p:grpSpPr>
          <p:cxnSp>
            <p:nvCxnSpPr>
              <p:cNvPr id="358" name="Straight Arrow Connector 357">
                <a:extLst>
                  <a:ext uri="{FF2B5EF4-FFF2-40B4-BE49-F238E27FC236}">
                    <a16:creationId xmlns:a16="http://schemas.microsoft.com/office/drawing/2014/main" id="{17845B9C-D0AF-4568-938E-64900F6F48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9" name="Straight Connector 358">
                <a:extLst>
                  <a:ext uri="{FF2B5EF4-FFF2-40B4-BE49-F238E27FC236}">
                    <a16:creationId xmlns:a16="http://schemas.microsoft.com/office/drawing/2014/main" id="{7E6DA76C-97D9-48F5-8BC8-6F4D95556DF6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0" name="Straight Connector 359">
                <a:extLst>
                  <a:ext uri="{FF2B5EF4-FFF2-40B4-BE49-F238E27FC236}">
                    <a16:creationId xmlns:a16="http://schemas.microsoft.com/office/drawing/2014/main" id="{42B9C1A0-E3FE-4860-91B4-59F5A2FB6688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1" name="Group 360">
              <a:extLst>
                <a:ext uri="{FF2B5EF4-FFF2-40B4-BE49-F238E27FC236}">
                  <a16:creationId xmlns:a16="http://schemas.microsoft.com/office/drawing/2014/main" id="{5FA13978-6A94-48BE-A0CD-F523DDDE905F}"/>
                </a:ext>
              </a:extLst>
            </p:cNvPr>
            <p:cNvGrpSpPr/>
            <p:nvPr/>
          </p:nvGrpSpPr>
          <p:grpSpPr>
            <a:xfrm flipH="1" flipV="1">
              <a:off x="4403816" y="1470405"/>
              <a:ext cx="462915" cy="64787"/>
              <a:chOff x="5558790" y="222885"/>
              <a:chExt cx="497138" cy="41910"/>
            </a:xfrm>
          </p:grpSpPr>
          <p:cxnSp>
            <p:nvCxnSpPr>
              <p:cNvPr id="362" name="Straight Arrow Connector 361">
                <a:extLst>
                  <a:ext uri="{FF2B5EF4-FFF2-40B4-BE49-F238E27FC236}">
                    <a16:creationId xmlns:a16="http://schemas.microsoft.com/office/drawing/2014/main" id="{61AC6299-EB93-4C83-AD8D-A3ADB34F9AE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3" name="Straight Connector 362">
                <a:extLst>
                  <a:ext uri="{FF2B5EF4-FFF2-40B4-BE49-F238E27FC236}">
                    <a16:creationId xmlns:a16="http://schemas.microsoft.com/office/drawing/2014/main" id="{34CFFAAA-82DC-48C6-A8AA-CBC11A14B244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4" name="Straight Connector 363">
                <a:extLst>
                  <a:ext uri="{FF2B5EF4-FFF2-40B4-BE49-F238E27FC236}">
                    <a16:creationId xmlns:a16="http://schemas.microsoft.com/office/drawing/2014/main" id="{D8B0A18A-EBE6-4541-94B8-333D37508AE5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68" name="TextBox 367">
            <a:extLst>
              <a:ext uri="{FF2B5EF4-FFF2-40B4-BE49-F238E27FC236}">
                <a16:creationId xmlns:a16="http://schemas.microsoft.com/office/drawing/2014/main" id="{48497A21-D9FA-4596-92F1-7D63D76B27AC}"/>
              </a:ext>
            </a:extLst>
          </p:cNvPr>
          <p:cNvSpPr txBox="1"/>
          <p:nvPr/>
        </p:nvSpPr>
        <p:spPr>
          <a:xfrm>
            <a:off x="407972" y="421106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53" name="TextBox 452">
            <a:extLst>
              <a:ext uri="{FF2B5EF4-FFF2-40B4-BE49-F238E27FC236}">
                <a16:creationId xmlns:a16="http://schemas.microsoft.com/office/drawing/2014/main" id="{73581E0C-E3C3-4554-B86D-463BB9E3BC2D}"/>
              </a:ext>
            </a:extLst>
          </p:cNvPr>
          <p:cNvSpPr txBox="1"/>
          <p:nvPr/>
        </p:nvSpPr>
        <p:spPr>
          <a:xfrm>
            <a:off x="1195355" y="7626158"/>
            <a:ext cx="6202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riction cloning by </a:t>
            </a:r>
            <a:r>
              <a:rPr lang="en-US" sz="7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mH</a:t>
            </a:r>
            <a:r>
              <a:rPr lang="en-US" sz="7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7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o</a:t>
            </a:r>
            <a:r>
              <a:rPr lang="en-US" sz="7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6" name="Straight Arrow Connector 455">
            <a:extLst>
              <a:ext uri="{FF2B5EF4-FFF2-40B4-BE49-F238E27FC236}">
                <a16:creationId xmlns:a16="http://schemas.microsoft.com/office/drawing/2014/main" id="{8AA4F611-52D9-473A-84E7-92EABC5B6C7A}"/>
              </a:ext>
            </a:extLst>
          </p:cNvPr>
          <p:cNvCxnSpPr>
            <a:cxnSpLocks/>
          </p:cNvCxnSpPr>
          <p:nvPr/>
        </p:nvCxnSpPr>
        <p:spPr>
          <a:xfrm flipV="1">
            <a:off x="4417588" y="6613496"/>
            <a:ext cx="170987" cy="124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15" name="Group 414">
            <a:extLst>
              <a:ext uri="{FF2B5EF4-FFF2-40B4-BE49-F238E27FC236}">
                <a16:creationId xmlns:a16="http://schemas.microsoft.com/office/drawing/2014/main" id="{AB40D104-7538-4507-9855-4DB7DA8818E1}"/>
              </a:ext>
            </a:extLst>
          </p:cNvPr>
          <p:cNvGrpSpPr/>
          <p:nvPr/>
        </p:nvGrpSpPr>
        <p:grpSpPr>
          <a:xfrm>
            <a:off x="3390025" y="6404620"/>
            <a:ext cx="541293" cy="210119"/>
            <a:chOff x="1467068" y="7471122"/>
            <a:chExt cx="888991" cy="235892"/>
          </a:xfrm>
        </p:grpSpPr>
        <p:cxnSp>
          <p:nvCxnSpPr>
            <p:cNvPr id="416" name="Straight Arrow Connector 415">
              <a:extLst>
                <a:ext uri="{FF2B5EF4-FFF2-40B4-BE49-F238E27FC236}">
                  <a16:creationId xmlns:a16="http://schemas.microsoft.com/office/drawing/2014/main" id="{0FE96723-078D-467C-9AC7-9E7C1E2C61CC}"/>
                </a:ext>
              </a:extLst>
            </p:cNvPr>
            <p:cNvCxnSpPr/>
            <p:nvPr/>
          </p:nvCxnSpPr>
          <p:spPr>
            <a:xfrm>
              <a:off x="1662921" y="7707014"/>
              <a:ext cx="47519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7" name="TextBox 416">
              <a:extLst>
                <a:ext uri="{FF2B5EF4-FFF2-40B4-BE49-F238E27FC236}">
                  <a16:creationId xmlns:a16="http://schemas.microsoft.com/office/drawing/2014/main" id="{2DDA1808-8F7A-42D1-868A-12B10F6CC603}"/>
                </a:ext>
              </a:extLst>
            </p:cNvPr>
            <p:cNvSpPr txBox="1"/>
            <p:nvPr/>
          </p:nvSpPr>
          <p:spPr>
            <a:xfrm>
              <a:off x="1467068" y="7471122"/>
              <a:ext cx="888991" cy="224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gation</a:t>
              </a:r>
            </a:p>
          </p:txBody>
        </p:sp>
      </p:grpSp>
      <p:sp>
        <p:nvSpPr>
          <p:cNvPr id="370" name="Rectangle: Rounded Corners 369">
            <a:extLst>
              <a:ext uri="{FF2B5EF4-FFF2-40B4-BE49-F238E27FC236}">
                <a16:creationId xmlns:a16="http://schemas.microsoft.com/office/drawing/2014/main" id="{A3827FC9-F467-4636-844C-FEAE12FE2E1D}"/>
              </a:ext>
            </a:extLst>
          </p:cNvPr>
          <p:cNvSpPr/>
          <p:nvPr/>
        </p:nvSpPr>
        <p:spPr>
          <a:xfrm>
            <a:off x="658858" y="6533916"/>
            <a:ext cx="566168" cy="154358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gment 3</a:t>
            </a:r>
          </a:p>
        </p:txBody>
      </p:sp>
      <p:grpSp>
        <p:nvGrpSpPr>
          <p:cNvPr id="414" name="Group 413">
            <a:extLst>
              <a:ext uri="{FF2B5EF4-FFF2-40B4-BE49-F238E27FC236}">
                <a16:creationId xmlns:a16="http://schemas.microsoft.com/office/drawing/2014/main" id="{151E982C-781E-48A5-B279-0DC604645697}"/>
              </a:ext>
            </a:extLst>
          </p:cNvPr>
          <p:cNvGrpSpPr/>
          <p:nvPr/>
        </p:nvGrpSpPr>
        <p:grpSpPr>
          <a:xfrm>
            <a:off x="1152467" y="6379278"/>
            <a:ext cx="540463" cy="220615"/>
            <a:chOff x="1384611" y="7478840"/>
            <a:chExt cx="540463" cy="220615"/>
          </a:xfrm>
        </p:grpSpPr>
        <p:cxnSp>
          <p:nvCxnSpPr>
            <p:cNvPr id="373" name="Straight Arrow Connector 372">
              <a:extLst>
                <a:ext uri="{FF2B5EF4-FFF2-40B4-BE49-F238E27FC236}">
                  <a16:creationId xmlns:a16="http://schemas.microsoft.com/office/drawing/2014/main" id="{C8E4D1AF-EE36-4037-8B74-3C4AA379E312}"/>
                </a:ext>
              </a:extLst>
            </p:cNvPr>
            <p:cNvCxnSpPr>
              <a:cxnSpLocks/>
            </p:cNvCxnSpPr>
            <p:nvPr/>
          </p:nvCxnSpPr>
          <p:spPr>
            <a:xfrm>
              <a:off x="1509419" y="7699455"/>
              <a:ext cx="25492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4" name="TextBox 373">
              <a:extLst>
                <a:ext uri="{FF2B5EF4-FFF2-40B4-BE49-F238E27FC236}">
                  <a16:creationId xmlns:a16="http://schemas.microsoft.com/office/drawing/2014/main" id="{845FE112-70C1-4C97-B10F-365A2C0FDB0E}"/>
                </a:ext>
              </a:extLst>
            </p:cNvPr>
            <p:cNvSpPr txBox="1"/>
            <p:nvPr/>
          </p:nvSpPr>
          <p:spPr>
            <a:xfrm>
              <a:off x="1384611" y="7478840"/>
              <a:ext cx="5404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gation</a:t>
              </a:r>
            </a:p>
          </p:txBody>
        </p:sp>
      </p:grpSp>
      <p:sp>
        <p:nvSpPr>
          <p:cNvPr id="375" name="Rectangle: Rounded Corners 374">
            <a:extLst>
              <a:ext uri="{FF2B5EF4-FFF2-40B4-BE49-F238E27FC236}">
                <a16:creationId xmlns:a16="http://schemas.microsoft.com/office/drawing/2014/main" id="{72BB65F4-C88F-4F8F-8875-996478CB6C6D}"/>
              </a:ext>
            </a:extLst>
          </p:cNvPr>
          <p:cNvSpPr/>
          <p:nvPr/>
        </p:nvSpPr>
        <p:spPr>
          <a:xfrm>
            <a:off x="1582476" y="6529189"/>
            <a:ext cx="555029" cy="174049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gment 2</a:t>
            </a:r>
          </a:p>
        </p:txBody>
      </p:sp>
      <p:cxnSp>
        <p:nvCxnSpPr>
          <p:cNvPr id="376" name="Straight Arrow Connector 375">
            <a:extLst>
              <a:ext uri="{FF2B5EF4-FFF2-40B4-BE49-F238E27FC236}">
                <a16:creationId xmlns:a16="http://schemas.microsoft.com/office/drawing/2014/main" id="{B0C40179-47C4-4373-992C-C62FE398EA7F}"/>
              </a:ext>
            </a:extLst>
          </p:cNvPr>
          <p:cNvCxnSpPr>
            <a:cxnSpLocks/>
          </p:cNvCxnSpPr>
          <p:nvPr/>
        </p:nvCxnSpPr>
        <p:spPr>
          <a:xfrm>
            <a:off x="2171986" y="6608607"/>
            <a:ext cx="26485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1" name="Rectangle: Rounded Corners 420">
            <a:extLst>
              <a:ext uri="{FF2B5EF4-FFF2-40B4-BE49-F238E27FC236}">
                <a16:creationId xmlns:a16="http://schemas.microsoft.com/office/drawing/2014/main" id="{47E14571-6A22-4351-89F5-007D90AF687F}"/>
              </a:ext>
            </a:extLst>
          </p:cNvPr>
          <p:cNvSpPr/>
          <p:nvPr/>
        </p:nvSpPr>
        <p:spPr>
          <a:xfrm>
            <a:off x="3824657" y="6533962"/>
            <a:ext cx="554911" cy="169276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gment 4</a:t>
            </a:r>
          </a:p>
        </p:txBody>
      </p:sp>
      <p:grpSp>
        <p:nvGrpSpPr>
          <p:cNvPr id="490" name="Group 489">
            <a:extLst>
              <a:ext uri="{FF2B5EF4-FFF2-40B4-BE49-F238E27FC236}">
                <a16:creationId xmlns:a16="http://schemas.microsoft.com/office/drawing/2014/main" id="{11BEC7B0-4303-472E-9DAB-B071ADC525F1}"/>
              </a:ext>
            </a:extLst>
          </p:cNvPr>
          <p:cNvGrpSpPr/>
          <p:nvPr/>
        </p:nvGrpSpPr>
        <p:grpSpPr>
          <a:xfrm>
            <a:off x="1794713" y="7227335"/>
            <a:ext cx="894811" cy="314836"/>
            <a:chOff x="1625672" y="7546411"/>
            <a:chExt cx="894811" cy="314836"/>
          </a:xfrm>
        </p:grpSpPr>
        <p:sp>
          <p:nvSpPr>
            <p:cNvPr id="454" name="Rectangle: Rounded Corners 453">
              <a:extLst>
                <a:ext uri="{FF2B5EF4-FFF2-40B4-BE49-F238E27FC236}">
                  <a16:creationId xmlns:a16="http://schemas.microsoft.com/office/drawing/2014/main" id="{48DFEFFF-F72C-4C52-A699-BACA9973EF6A}"/>
                </a:ext>
              </a:extLst>
            </p:cNvPr>
            <p:cNvSpPr/>
            <p:nvPr/>
          </p:nvSpPr>
          <p:spPr>
            <a:xfrm>
              <a:off x="1732412" y="7696351"/>
              <a:ext cx="571097" cy="164896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agment 1</a:t>
              </a:r>
            </a:p>
          </p:txBody>
        </p:sp>
        <p:sp>
          <p:nvSpPr>
            <p:cNvPr id="486" name="TextBox 485">
              <a:extLst>
                <a:ext uri="{FF2B5EF4-FFF2-40B4-BE49-F238E27FC236}">
                  <a16:creationId xmlns:a16="http://schemas.microsoft.com/office/drawing/2014/main" id="{196FC39F-A8E0-451A-88D9-14AE51E822E6}"/>
                </a:ext>
              </a:extLst>
            </p:cNvPr>
            <p:cNvSpPr txBox="1"/>
            <p:nvPr/>
          </p:nvSpPr>
          <p:spPr>
            <a:xfrm>
              <a:off x="2085882" y="7548230"/>
              <a:ext cx="43460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amH</a:t>
              </a:r>
              <a:r>
                <a:rPr lang="en-US" sz="5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8" name="TextBox 487">
              <a:extLst>
                <a:ext uri="{FF2B5EF4-FFF2-40B4-BE49-F238E27FC236}">
                  <a16:creationId xmlns:a16="http://schemas.microsoft.com/office/drawing/2014/main" id="{B7027FCA-552E-4995-B1EC-7504D1EF2497}"/>
                </a:ext>
              </a:extLst>
            </p:cNvPr>
            <p:cNvSpPr txBox="1"/>
            <p:nvPr/>
          </p:nvSpPr>
          <p:spPr>
            <a:xfrm>
              <a:off x="1625672" y="7546411"/>
              <a:ext cx="43460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nd</a:t>
              </a:r>
              <a:r>
                <a:rPr 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II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1" name="Group 490">
            <a:extLst>
              <a:ext uri="{FF2B5EF4-FFF2-40B4-BE49-F238E27FC236}">
                <a16:creationId xmlns:a16="http://schemas.microsoft.com/office/drawing/2014/main" id="{D61A6DC0-EF1B-4F87-A51A-A95AF489D135}"/>
              </a:ext>
            </a:extLst>
          </p:cNvPr>
          <p:cNvGrpSpPr/>
          <p:nvPr/>
        </p:nvGrpSpPr>
        <p:grpSpPr>
          <a:xfrm>
            <a:off x="1781641" y="7599185"/>
            <a:ext cx="928775" cy="326562"/>
            <a:chOff x="1640052" y="8128557"/>
            <a:chExt cx="928775" cy="326562"/>
          </a:xfrm>
        </p:grpSpPr>
        <p:sp>
          <p:nvSpPr>
            <p:cNvPr id="473" name="Rectangle: Rounded Corners 472">
              <a:extLst>
                <a:ext uri="{FF2B5EF4-FFF2-40B4-BE49-F238E27FC236}">
                  <a16:creationId xmlns:a16="http://schemas.microsoft.com/office/drawing/2014/main" id="{6A90A2E9-7FA9-4039-A28F-4CCCCEBA99A8}"/>
                </a:ext>
              </a:extLst>
            </p:cNvPr>
            <p:cNvSpPr/>
            <p:nvPr/>
          </p:nvSpPr>
          <p:spPr>
            <a:xfrm>
              <a:off x="1745708" y="8272313"/>
              <a:ext cx="585898" cy="182806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agment 5</a:t>
              </a:r>
            </a:p>
          </p:txBody>
        </p:sp>
        <p:sp>
          <p:nvSpPr>
            <p:cNvPr id="487" name="TextBox 486">
              <a:extLst>
                <a:ext uri="{FF2B5EF4-FFF2-40B4-BE49-F238E27FC236}">
                  <a16:creationId xmlns:a16="http://schemas.microsoft.com/office/drawing/2014/main" id="{D567DECD-9760-4687-AE73-7A1CA3C65AE0}"/>
                </a:ext>
              </a:extLst>
            </p:cNvPr>
            <p:cNvSpPr txBox="1"/>
            <p:nvPr/>
          </p:nvSpPr>
          <p:spPr>
            <a:xfrm>
              <a:off x="2134226" y="8128557"/>
              <a:ext cx="43460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co</a:t>
              </a:r>
              <a:r>
                <a:rPr lang="en-US" sz="5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9" name="TextBox 488">
              <a:extLst>
                <a:ext uri="{FF2B5EF4-FFF2-40B4-BE49-F238E27FC236}">
                  <a16:creationId xmlns:a16="http://schemas.microsoft.com/office/drawing/2014/main" id="{4D0430B8-B0DE-4E6B-80A8-417CB5E482B0}"/>
                </a:ext>
              </a:extLst>
            </p:cNvPr>
            <p:cNvSpPr txBox="1"/>
            <p:nvPr/>
          </p:nvSpPr>
          <p:spPr>
            <a:xfrm>
              <a:off x="1640052" y="8128557"/>
              <a:ext cx="43460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da</a:t>
              </a:r>
              <a:r>
                <a:rPr lang="en-US" sz="5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47" name="Group 546">
            <a:extLst>
              <a:ext uri="{FF2B5EF4-FFF2-40B4-BE49-F238E27FC236}">
                <a16:creationId xmlns:a16="http://schemas.microsoft.com/office/drawing/2014/main" id="{00A2D7DE-17F0-4AA0-A90E-36BB6A20FCA7}"/>
              </a:ext>
            </a:extLst>
          </p:cNvPr>
          <p:cNvGrpSpPr/>
          <p:nvPr/>
        </p:nvGrpSpPr>
        <p:grpSpPr>
          <a:xfrm>
            <a:off x="2411194" y="6182329"/>
            <a:ext cx="1358055" cy="1001006"/>
            <a:chOff x="2886454" y="6161466"/>
            <a:chExt cx="1358055" cy="1001006"/>
          </a:xfrm>
        </p:grpSpPr>
        <p:grpSp>
          <p:nvGrpSpPr>
            <p:cNvPr id="501" name="Group 500">
              <a:extLst>
                <a:ext uri="{FF2B5EF4-FFF2-40B4-BE49-F238E27FC236}">
                  <a16:creationId xmlns:a16="http://schemas.microsoft.com/office/drawing/2014/main" id="{DBCE118A-FFCB-4628-A848-306A439DFE37}"/>
                </a:ext>
              </a:extLst>
            </p:cNvPr>
            <p:cNvGrpSpPr/>
            <p:nvPr/>
          </p:nvGrpSpPr>
          <p:grpSpPr>
            <a:xfrm>
              <a:off x="2886454" y="6161466"/>
              <a:ext cx="1358055" cy="1001006"/>
              <a:chOff x="3565380" y="6147807"/>
              <a:chExt cx="1358055" cy="1001006"/>
            </a:xfrm>
          </p:grpSpPr>
          <p:grpSp>
            <p:nvGrpSpPr>
              <p:cNvPr id="411" name="Group 410">
                <a:extLst>
                  <a:ext uri="{FF2B5EF4-FFF2-40B4-BE49-F238E27FC236}">
                    <a16:creationId xmlns:a16="http://schemas.microsoft.com/office/drawing/2014/main" id="{1AD7369F-66C0-421A-8DE9-801F9EC2B155}"/>
                  </a:ext>
                </a:extLst>
              </p:cNvPr>
              <p:cNvGrpSpPr/>
              <p:nvPr/>
            </p:nvGrpSpPr>
            <p:grpSpPr>
              <a:xfrm>
                <a:off x="3565380" y="6147807"/>
                <a:ext cx="1358055" cy="839092"/>
                <a:chOff x="4153639" y="7183682"/>
                <a:chExt cx="1358055" cy="839092"/>
              </a:xfrm>
            </p:grpSpPr>
            <p:sp>
              <p:nvSpPr>
                <p:cNvPr id="387" name="Arrow: Right 386">
                  <a:extLst>
                    <a:ext uri="{FF2B5EF4-FFF2-40B4-BE49-F238E27FC236}">
                      <a16:creationId xmlns:a16="http://schemas.microsoft.com/office/drawing/2014/main" id="{47CC964C-B1BA-45FB-8995-2A2F74F02B03}"/>
                    </a:ext>
                  </a:extLst>
                </p:cNvPr>
                <p:cNvSpPr/>
                <p:nvPr/>
              </p:nvSpPr>
              <p:spPr>
                <a:xfrm>
                  <a:off x="4207744" y="7506004"/>
                  <a:ext cx="448171" cy="225930"/>
                </a:xfrm>
                <a:prstGeom prst="rightArrow">
                  <a:avLst>
                    <a:gd name="adj1" fmla="val 50000"/>
                    <a:gd name="adj2" fmla="val 38654"/>
                  </a:avLst>
                </a:prstGeom>
                <a:solidFill>
                  <a:srgbClr val="A5BBE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0" tIns="0" rIns="0" bIns="0" rtlCol="0" anchor="ctr"/>
                <a:lstStyle/>
                <a:p>
                  <a:pPr algn="ctr"/>
                  <a:r>
                    <a:rPr lang="en-US" sz="4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’ homology arm</a:t>
                  </a:r>
                </a:p>
              </p:txBody>
            </p:sp>
            <p:sp>
              <p:nvSpPr>
                <p:cNvPr id="388" name="Arrow: Right 387">
                  <a:extLst>
                    <a:ext uri="{FF2B5EF4-FFF2-40B4-BE49-F238E27FC236}">
                      <a16:creationId xmlns:a16="http://schemas.microsoft.com/office/drawing/2014/main" id="{2DB54C4F-54A9-4550-87A4-9513007E04FA}"/>
                    </a:ext>
                  </a:extLst>
                </p:cNvPr>
                <p:cNvSpPr/>
                <p:nvPr/>
              </p:nvSpPr>
              <p:spPr>
                <a:xfrm>
                  <a:off x="4292631" y="7354147"/>
                  <a:ext cx="92333" cy="183698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89" name="Arrow: Right 388">
                  <a:extLst>
                    <a:ext uri="{FF2B5EF4-FFF2-40B4-BE49-F238E27FC236}">
                      <a16:creationId xmlns:a16="http://schemas.microsoft.com/office/drawing/2014/main" id="{43E79461-0EA0-41E3-8A12-ED24972B547D}"/>
                    </a:ext>
                  </a:extLst>
                </p:cNvPr>
                <p:cNvSpPr/>
                <p:nvPr/>
              </p:nvSpPr>
              <p:spPr>
                <a:xfrm>
                  <a:off x="4566993" y="7339691"/>
                  <a:ext cx="107436" cy="183698"/>
                </a:xfrm>
                <a:prstGeom prst="rightArrow">
                  <a:avLst>
                    <a:gd name="adj1" fmla="val 50000"/>
                    <a:gd name="adj2" fmla="val 32975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0" name="Arrow: Right 389">
                  <a:extLst>
                    <a:ext uri="{FF2B5EF4-FFF2-40B4-BE49-F238E27FC236}">
                      <a16:creationId xmlns:a16="http://schemas.microsoft.com/office/drawing/2014/main" id="{16BD8A41-27D3-4297-8F45-E97DCBC9D2A3}"/>
                    </a:ext>
                  </a:extLst>
                </p:cNvPr>
                <p:cNvSpPr/>
                <p:nvPr/>
              </p:nvSpPr>
              <p:spPr>
                <a:xfrm>
                  <a:off x="4664052" y="7517003"/>
                  <a:ext cx="48453" cy="183698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1" name="Arrow: Right 390">
                  <a:extLst>
                    <a:ext uri="{FF2B5EF4-FFF2-40B4-BE49-F238E27FC236}">
                      <a16:creationId xmlns:a16="http://schemas.microsoft.com/office/drawing/2014/main" id="{A4424EFB-77F2-4BCF-BA8E-74BC727051A4}"/>
                    </a:ext>
                  </a:extLst>
                </p:cNvPr>
                <p:cNvSpPr/>
                <p:nvPr/>
              </p:nvSpPr>
              <p:spPr>
                <a:xfrm>
                  <a:off x="4717869" y="7517994"/>
                  <a:ext cx="64771" cy="183698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2" name="Arrow: Right 391">
                  <a:extLst>
                    <a:ext uri="{FF2B5EF4-FFF2-40B4-BE49-F238E27FC236}">
                      <a16:creationId xmlns:a16="http://schemas.microsoft.com/office/drawing/2014/main" id="{D2F00A12-0961-4E96-854D-B6E0BC389C26}"/>
                    </a:ext>
                  </a:extLst>
                </p:cNvPr>
                <p:cNvSpPr/>
                <p:nvPr/>
              </p:nvSpPr>
              <p:spPr>
                <a:xfrm>
                  <a:off x="4789436" y="7508665"/>
                  <a:ext cx="292393" cy="200374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FF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3" name="Arrow: Right 392">
                  <a:extLst>
                    <a:ext uri="{FF2B5EF4-FFF2-40B4-BE49-F238E27FC236}">
                      <a16:creationId xmlns:a16="http://schemas.microsoft.com/office/drawing/2014/main" id="{F68C1A45-C2BB-4E7D-B90F-CCA36A1AE383}"/>
                    </a:ext>
                  </a:extLst>
                </p:cNvPr>
                <p:cNvSpPr/>
                <p:nvPr/>
              </p:nvSpPr>
              <p:spPr>
                <a:xfrm>
                  <a:off x="5093057" y="7525176"/>
                  <a:ext cx="45719" cy="183698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chemeClr val="bg2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4" name="Arrow: Right 393">
                  <a:extLst>
                    <a:ext uri="{FF2B5EF4-FFF2-40B4-BE49-F238E27FC236}">
                      <a16:creationId xmlns:a16="http://schemas.microsoft.com/office/drawing/2014/main" id="{E85C9D5D-A220-45C9-8CBD-EC27EEF5CDF4}"/>
                    </a:ext>
                  </a:extLst>
                </p:cNvPr>
                <p:cNvSpPr/>
                <p:nvPr/>
              </p:nvSpPr>
              <p:spPr>
                <a:xfrm>
                  <a:off x="5148684" y="7526725"/>
                  <a:ext cx="48453" cy="183698"/>
                </a:xfrm>
                <a:prstGeom prst="rightArrow">
                  <a:avLst>
                    <a:gd name="adj1" fmla="val 46494"/>
                    <a:gd name="adj2" fmla="val 39316"/>
                  </a:avLst>
                </a:prstGeom>
                <a:solidFill>
                  <a:schemeClr val="bg2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95" name="TextBox 394">
                  <a:extLst>
                    <a:ext uri="{FF2B5EF4-FFF2-40B4-BE49-F238E27FC236}">
                      <a16:creationId xmlns:a16="http://schemas.microsoft.com/office/drawing/2014/main" id="{CBE8E151-78F0-49B5-88D7-0BAA1F43C4C7}"/>
                    </a:ext>
                  </a:extLst>
                </p:cNvPr>
                <p:cNvSpPr txBox="1"/>
                <p:nvPr/>
              </p:nvSpPr>
              <p:spPr>
                <a:xfrm>
                  <a:off x="4153639" y="7199649"/>
                  <a:ext cx="50556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7</a:t>
                  </a:r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6" name="TextBox 395">
                  <a:extLst>
                    <a:ext uri="{FF2B5EF4-FFF2-40B4-BE49-F238E27FC236}">
                      <a16:creationId xmlns:a16="http://schemas.microsoft.com/office/drawing/2014/main" id="{FF58A85C-D7BE-4CAF-A80F-608A44655AF4}"/>
                    </a:ext>
                  </a:extLst>
                </p:cNvPr>
                <p:cNvSpPr txBox="1"/>
                <p:nvPr/>
              </p:nvSpPr>
              <p:spPr>
                <a:xfrm>
                  <a:off x="4449688" y="7183682"/>
                  <a:ext cx="50556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8</a:t>
                  </a:r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7" name="TextBox 396">
                  <a:extLst>
                    <a:ext uri="{FF2B5EF4-FFF2-40B4-BE49-F238E27FC236}">
                      <a16:creationId xmlns:a16="http://schemas.microsoft.com/office/drawing/2014/main" id="{702F9442-70EE-43EE-899D-E480DA7090ED}"/>
                    </a:ext>
                  </a:extLst>
                </p:cNvPr>
                <p:cNvSpPr txBox="1"/>
                <p:nvPr/>
              </p:nvSpPr>
              <p:spPr>
                <a:xfrm>
                  <a:off x="4561421" y="7838108"/>
                  <a:ext cx="50556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9</a:t>
                  </a:r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8" name="TextBox 397">
                  <a:extLst>
                    <a:ext uri="{FF2B5EF4-FFF2-40B4-BE49-F238E27FC236}">
                      <a16:creationId xmlns:a16="http://schemas.microsoft.com/office/drawing/2014/main" id="{6B8F479E-CB5B-440A-B89E-9A00BB20BC4B}"/>
                    </a:ext>
                  </a:extLst>
                </p:cNvPr>
                <p:cNvSpPr txBox="1"/>
                <p:nvPr/>
              </p:nvSpPr>
              <p:spPr>
                <a:xfrm>
                  <a:off x="4399509" y="7731909"/>
                  <a:ext cx="504017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8</a:t>
                  </a:r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9" name="TextBox 398">
                  <a:extLst>
                    <a:ext uri="{FF2B5EF4-FFF2-40B4-BE49-F238E27FC236}">
                      <a16:creationId xmlns:a16="http://schemas.microsoft.com/office/drawing/2014/main" id="{91CCE70A-1602-4F13-82E4-A9F7F2522841}"/>
                    </a:ext>
                  </a:extLst>
                </p:cNvPr>
                <p:cNvSpPr txBox="1"/>
                <p:nvPr/>
              </p:nvSpPr>
              <p:spPr>
                <a:xfrm>
                  <a:off x="4740964" y="7521219"/>
                  <a:ext cx="488642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leoR</a:t>
                  </a:r>
                  <a:endParaRPr lang="en-US" sz="5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0" name="TextBox 399">
                  <a:extLst>
                    <a:ext uri="{FF2B5EF4-FFF2-40B4-BE49-F238E27FC236}">
                      <a16:creationId xmlns:a16="http://schemas.microsoft.com/office/drawing/2014/main" id="{14320083-EBC3-4905-B2EC-948904C04416}"/>
                    </a:ext>
                  </a:extLst>
                </p:cNvPr>
                <p:cNvSpPr txBox="1"/>
                <p:nvPr/>
              </p:nvSpPr>
              <p:spPr>
                <a:xfrm>
                  <a:off x="4837972" y="7726882"/>
                  <a:ext cx="38601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xHis</a:t>
                  </a:r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1" name="TextBox 400">
                  <a:extLst>
                    <a:ext uri="{FF2B5EF4-FFF2-40B4-BE49-F238E27FC236}">
                      <a16:creationId xmlns:a16="http://schemas.microsoft.com/office/drawing/2014/main" id="{53E18611-02CB-4B8F-BFEE-DE884F941063}"/>
                    </a:ext>
                  </a:extLst>
                </p:cNvPr>
                <p:cNvSpPr txBox="1"/>
                <p:nvPr/>
              </p:nvSpPr>
              <p:spPr>
                <a:xfrm>
                  <a:off x="5006132" y="7836391"/>
                  <a:ext cx="50556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lyA</a:t>
                  </a:r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07" name="Straight Connector 406">
                  <a:extLst>
                    <a:ext uri="{FF2B5EF4-FFF2-40B4-BE49-F238E27FC236}">
                      <a16:creationId xmlns:a16="http://schemas.microsoft.com/office/drawing/2014/main" id="{7D74ADCE-4A8B-4242-8D70-99F42AF0F6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49519" y="7700701"/>
                  <a:ext cx="6" cy="189675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9" name="Straight Connector 408">
                  <a:extLst>
                    <a:ext uri="{FF2B5EF4-FFF2-40B4-BE49-F238E27FC236}">
                      <a16:creationId xmlns:a16="http://schemas.microsoft.com/office/drawing/2014/main" id="{44069297-CD10-4A23-B64C-A2B01093DD1F}"/>
                    </a:ext>
                  </a:extLst>
                </p:cNvPr>
                <p:cNvCxnSpPr/>
                <p:nvPr/>
              </p:nvCxnSpPr>
              <p:spPr>
                <a:xfrm>
                  <a:off x="5107550" y="7693704"/>
                  <a:ext cx="1293" cy="92654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0" name="Straight Connector 409">
                  <a:extLst>
                    <a:ext uri="{FF2B5EF4-FFF2-40B4-BE49-F238E27FC236}">
                      <a16:creationId xmlns:a16="http://schemas.microsoft.com/office/drawing/2014/main" id="{F0283CE8-87F8-44AC-AD93-7A9ADC509C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66085" y="7693704"/>
                  <a:ext cx="250" cy="186512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66" name="Group 465">
                <a:extLst>
                  <a:ext uri="{FF2B5EF4-FFF2-40B4-BE49-F238E27FC236}">
                    <a16:creationId xmlns:a16="http://schemas.microsoft.com/office/drawing/2014/main" id="{8219A446-9161-4989-BD8B-B9F1D296C979}"/>
                  </a:ext>
                </a:extLst>
              </p:cNvPr>
              <p:cNvGrpSpPr/>
              <p:nvPr/>
            </p:nvGrpSpPr>
            <p:grpSpPr>
              <a:xfrm>
                <a:off x="3632257" y="6964147"/>
                <a:ext cx="1014627" cy="184666"/>
                <a:chOff x="3632257" y="7012877"/>
                <a:chExt cx="1014627" cy="184666"/>
              </a:xfrm>
            </p:grpSpPr>
            <p:cxnSp>
              <p:nvCxnSpPr>
                <p:cNvPr id="464" name="Straight Arrow Connector 463">
                  <a:extLst>
                    <a:ext uri="{FF2B5EF4-FFF2-40B4-BE49-F238E27FC236}">
                      <a16:creationId xmlns:a16="http://schemas.microsoft.com/office/drawing/2014/main" id="{94C6B741-3C1B-407E-BD88-37C2297D584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32257" y="7035629"/>
                  <a:ext cx="101462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5" name="TextBox 464">
                  <a:extLst>
                    <a:ext uri="{FF2B5EF4-FFF2-40B4-BE49-F238E27FC236}">
                      <a16:creationId xmlns:a16="http://schemas.microsoft.com/office/drawing/2014/main" id="{339E17DE-0FAB-4E58-B45B-D262755CE905}"/>
                    </a:ext>
                  </a:extLst>
                </p:cNvPr>
                <p:cNvSpPr txBox="1"/>
                <p:nvPr/>
              </p:nvSpPr>
              <p:spPr>
                <a:xfrm>
                  <a:off x="3775765" y="7012877"/>
                  <a:ext cx="78802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eliminary DDP</a:t>
                  </a:r>
                </a:p>
              </p:txBody>
            </p:sp>
          </p:grpSp>
        </p:grpSp>
        <p:cxnSp>
          <p:nvCxnSpPr>
            <p:cNvPr id="544" name="Straight Connector 543">
              <a:extLst>
                <a:ext uri="{FF2B5EF4-FFF2-40B4-BE49-F238E27FC236}">
                  <a16:creationId xmlns:a16="http://schemas.microsoft.com/office/drawing/2014/main" id="{0E52F01C-23A8-4442-9488-B77DC607F2FF}"/>
                </a:ext>
              </a:extLst>
            </p:cNvPr>
            <p:cNvCxnSpPr/>
            <p:nvPr/>
          </p:nvCxnSpPr>
          <p:spPr>
            <a:xfrm>
              <a:off x="3404521" y="6674028"/>
              <a:ext cx="1293" cy="92654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4" name="Group 553">
            <a:extLst>
              <a:ext uri="{FF2B5EF4-FFF2-40B4-BE49-F238E27FC236}">
                <a16:creationId xmlns:a16="http://schemas.microsoft.com/office/drawing/2014/main" id="{033600C8-256D-40B0-8048-99ADB1688198}"/>
              </a:ext>
            </a:extLst>
          </p:cNvPr>
          <p:cNvGrpSpPr/>
          <p:nvPr/>
        </p:nvGrpSpPr>
        <p:grpSpPr>
          <a:xfrm>
            <a:off x="4440905" y="6120932"/>
            <a:ext cx="2229520" cy="1225950"/>
            <a:chOff x="637830" y="6885899"/>
            <a:chExt cx="2229520" cy="1225950"/>
          </a:xfrm>
        </p:grpSpPr>
        <p:grpSp>
          <p:nvGrpSpPr>
            <p:cNvPr id="553" name="Group 552">
              <a:extLst>
                <a:ext uri="{FF2B5EF4-FFF2-40B4-BE49-F238E27FC236}">
                  <a16:creationId xmlns:a16="http://schemas.microsoft.com/office/drawing/2014/main" id="{2E79B32B-67B2-4A1E-AA74-96804EDED6E3}"/>
                </a:ext>
              </a:extLst>
            </p:cNvPr>
            <p:cNvGrpSpPr/>
            <p:nvPr/>
          </p:nvGrpSpPr>
          <p:grpSpPr>
            <a:xfrm>
              <a:off x="637830" y="6885899"/>
              <a:ext cx="2229520" cy="1225950"/>
              <a:chOff x="637830" y="6885899"/>
              <a:chExt cx="2229520" cy="1225950"/>
            </a:xfrm>
          </p:grpSpPr>
          <p:grpSp>
            <p:nvGrpSpPr>
              <p:cNvPr id="471" name="Group 470">
                <a:extLst>
                  <a:ext uri="{FF2B5EF4-FFF2-40B4-BE49-F238E27FC236}">
                    <a16:creationId xmlns:a16="http://schemas.microsoft.com/office/drawing/2014/main" id="{1EAD52FE-274A-439A-BCC3-48072F5ED787}"/>
                  </a:ext>
                </a:extLst>
              </p:cNvPr>
              <p:cNvGrpSpPr/>
              <p:nvPr/>
            </p:nvGrpSpPr>
            <p:grpSpPr>
              <a:xfrm>
                <a:off x="782653" y="6885899"/>
                <a:ext cx="1810912" cy="1225950"/>
                <a:chOff x="4051089" y="7571372"/>
                <a:chExt cx="1810912" cy="1225950"/>
              </a:xfrm>
            </p:grpSpPr>
            <p:grpSp>
              <p:nvGrpSpPr>
                <p:cNvPr id="450" name="Group 449">
                  <a:extLst>
                    <a:ext uri="{FF2B5EF4-FFF2-40B4-BE49-F238E27FC236}">
                      <a16:creationId xmlns:a16="http://schemas.microsoft.com/office/drawing/2014/main" id="{A64D298A-D131-444B-8A45-456AAC468F1F}"/>
                    </a:ext>
                  </a:extLst>
                </p:cNvPr>
                <p:cNvGrpSpPr/>
                <p:nvPr/>
              </p:nvGrpSpPr>
              <p:grpSpPr>
                <a:xfrm>
                  <a:off x="4051089" y="7571372"/>
                  <a:ext cx="1760129" cy="928824"/>
                  <a:chOff x="867263" y="7954791"/>
                  <a:chExt cx="1760129" cy="928824"/>
                </a:xfrm>
              </p:grpSpPr>
              <p:grpSp>
                <p:nvGrpSpPr>
                  <p:cNvPr id="424" name="Group 423">
                    <a:extLst>
                      <a:ext uri="{FF2B5EF4-FFF2-40B4-BE49-F238E27FC236}">
                        <a16:creationId xmlns:a16="http://schemas.microsoft.com/office/drawing/2014/main" id="{5ACFB168-BA54-4DAA-8D2C-9B8AC9A921D7}"/>
                      </a:ext>
                    </a:extLst>
                  </p:cNvPr>
                  <p:cNvGrpSpPr/>
                  <p:nvPr/>
                </p:nvGrpSpPr>
                <p:grpSpPr>
                  <a:xfrm>
                    <a:off x="1961088" y="8286153"/>
                    <a:ext cx="666304" cy="227406"/>
                    <a:chOff x="5126876" y="8402356"/>
                    <a:chExt cx="666304" cy="227406"/>
                  </a:xfrm>
                </p:grpSpPr>
                <p:sp>
                  <p:nvSpPr>
                    <p:cNvPr id="422" name="Arrow: Right 421">
                      <a:extLst>
                        <a:ext uri="{FF2B5EF4-FFF2-40B4-BE49-F238E27FC236}">
                          <a16:creationId xmlns:a16="http://schemas.microsoft.com/office/drawing/2014/main" id="{C44E8279-93A3-43E7-A92F-B4329B7246F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126876" y="8402356"/>
                      <a:ext cx="592407" cy="227406"/>
                    </a:xfrm>
                    <a:prstGeom prst="rightArrow">
                      <a:avLst>
                        <a:gd name="adj1" fmla="val 50000"/>
                        <a:gd name="adj2" fmla="val 38654"/>
                      </a:avLst>
                    </a:prstGeom>
                    <a:solidFill>
                      <a:srgbClr val="A5BBE3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’homology arm</a:t>
                      </a:r>
                    </a:p>
                  </p:txBody>
                </p:sp>
                <p:sp>
                  <p:nvSpPr>
                    <p:cNvPr id="423" name="Arrow: Right 422">
                      <a:extLst>
                        <a:ext uri="{FF2B5EF4-FFF2-40B4-BE49-F238E27FC236}">
                          <a16:creationId xmlns:a16="http://schemas.microsoft.com/office/drawing/2014/main" id="{FFF8616C-ED1E-44B6-9096-8A8FFF3B702D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5727829" y="8424210"/>
                      <a:ext cx="65351" cy="177379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rgbClr val="C8A698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grpSp>
                <p:nvGrpSpPr>
                  <p:cNvPr id="430" name="Group 429">
                    <a:extLst>
                      <a:ext uri="{FF2B5EF4-FFF2-40B4-BE49-F238E27FC236}">
                        <a16:creationId xmlns:a16="http://schemas.microsoft.com/office/drawing/2014/main" id="{61C2844A-8C87-46B3-8E69-B6FD7565D7D8}"/>
                      </a:ext>
                    </a:extLst>
                  </p:cNvPr>
                  <p:cNvGrpSpPr/>
                  <p:nvPr/>
                </p:nvGrpSpPr>
                <p:grpSpPr>
                  <a:xfrm>
                    <a:off x="867263" y="7954791"/>
                    <a:ext cx="1495401" cy="928824"/>
                    <a:chOff x="4115199" y="7160177"/>
                    <a:chExt cx="1495401" cy="928824"/>
                  </a:xfrm>
                </p:grpSpPr>
                <p:sp>
                  <p:nvSpPr>
                    <p:cNvPr id="431" name="Arrow: Right 430">
                      <a:extLst>
                        <a:ext uri="{FF2B5EF4-FFF2-40B4-BE49-F238E27FC236}">
                          <a16:creationId xmlns:a16="http://schemas.microsoft.com/office/drawing/2014/main" id="{B1CB5976-2288-4F50-8180-7D9D0DC5E41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77534" y="7506004"/>
                      <a:ext cx="478381" cy="225930"/>
                    </a:xfrm>
                    <a:prstGeom prst="rightArrow">
                      <a:avLst>
                        <a:gd name="adj1" fmla="val 50000"/>
                        <a:gd name="adj2" fmla="val 38654"/>
                      </a:avLst>
                    </a:prstGeom>
                    <a:solidFill>
                      <a:srgbClr val="A5BBE3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lIns="0" tIns="0" rIns="0" bIns="0" rtlCol="0" anchor="ctr"/>
                    <a:lstStyle/>
                    <a:p>
                      <a:pPr algn="ctr"/>
                      <a:r>
                        <a:rPr lang="en-US" sz="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homology arm</a:t>
                      </a:r>
                    </a:p>
                  </p:txBody>
                </p:sp>
                <p:sp>
                  <p:nvSpPr>
                    <p:cNvPr id="432" name="Arrow: Right 431">
                      <a:extLst>
                        <a:ext uri="{FF2B5EF4-FFF2-40B4-BE49-F238E27FC236}">
                          <a16:creationId xmlns:a16="http://schemas.microsoft.com/office/drawing/2014/main" id="{2C2F6ED1-3120-4815-9379-A2FF1171FFA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262826" y="7338057"/>
                      <a:ext cx="92333" cy="183698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rgbClr val="FFFF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33" name="Arrow: Right 432">
                      <a:extLst>
                        <a:ext uri="{FF2B5EF4-FFF2-40B4-BE49-F238E27FC236}">
                          <a16:creationId xmlns:a16="http://schemas.microsoft.com/office/drawing/2014/main" id="{4EA89E42-06A0-4BA9-99B3-BBD8D8334C7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598994" y="7347863"/>
                      <a:ext cx="77182" cy="183698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rgbClr val="FFFF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34" name="Arrow: Right 433">
                      <a:extLst>
                        <a:ext uri="{FF2B5EF4-FFF2-40B4-BE49-F238E27FC236}">
                          <a16:creationId xmlns:a16="http://schemas.microsoft.com/office/drawing/2014/main" id="{DFB7621D-1CF3-4D7B-BE0E-E9CA0E539FE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664052" y="7517003"/>
                      <a:ext cx="48453" cy="183698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rgbClr val="FFFF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35" name="Arrow: Right 434">
                      <a:extLst>
                        <a:ext uri="{FF2B5EF4-FFF2-40B4-BE49-F238E27FC236}">
                          <a16:creationId xmlns:a16="http://schemas.microsoft.com/office/drawing/2014/main" id="{B38EDA9F-DF25-47E2-B037-7A177E1FEF7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17869" y="7517994"/>
                      <a:ext cx="64771" cy="183698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rgbClr val="FFFF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36" name="Arrow: Right 435">
                      <a:extLst>
                        <a:ext uri="{FF2B5EF4-FFF2-40B4-BE49-F238E27FC236}">
                          <a16:creationId xmlns:a16="http://schemas.microsoft.com/office/drawing/2014/main" id="{F3E42784-30C1-4351-A1B5-A113C129D83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86896" y="7508665"/>
                      <a:ext cx="300947" cy="200374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rgbClr val="FFFF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37" name="Arrow: Right 436">
                      <a:extLst>
                        <a:ext uri="{FF2B5EF4-FFF2-40B4-BE49-F238E27FC236}">
                          <a16:creationId xmlns:a16="http://schemas.microsoft.com/office/drawing/2014/main" id="{CEB24C79-0B52-4021-B416-EBBA0CE5040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099476" y="7513393"/>
                      <a:ext cx="45719" cy="183698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chemeClr val="bg2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38" name="Arrow: Right 437">
                      <a:extLst>
                        <a:ext uri="{FF2B5EF4-FFF2-40B4-BE49-F238E27FC236}">
                          <a16:creationId xmlns:a16="http://schemas.microsoft.com/office/drawing/2014/main" id="{94BC11F0-23C2-449C-9FD4-4EE059DD857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155103" y="7514942"/>
                      <a:ext cx="48453" cy="183698"/>
                    </a:xfrm>
                    <a:prstGeom prst="rightArrow">
                      <a:avLst>
                        <a:gd name="adj1" fmla="val 46494"/>
                        <a:gd name="adj2" fmla="val 39316"/>
                      </a:avLst>
                    </a:prstGeom>
                    <a:solidFill>
                      <a:schemeClr val="bg2">
                        <a:lumMod val="75000"/>
                      </a:schemeClr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439" name="TextBox 438">
                      <a:extLst>
                        <a:ext uri="{FF2B5EF4-FFF2-40B4-BE49-F238E27FC236}">
                          <a16:creationId xmlns:a16="http://schemas.microsoft.com/office/drawing/2014/main" id="{6C296740-C0BF-4A9F-BCFF-35E688EDA9B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15199" y="7160177"/>
                      <a:ext cx="50556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7</a:t>
                      </a:r>
                    </a:p>
                  </p:txBody>
                </p:sp>
                <p:sp>
                  <p:nvSpPr>
                    <p:cNvPr id="440" name="TextBox 439">
                      <a:extLst>
                        <a:ext uri="{FF2B5EF4-FFF2-40B4-BE49-F238E27FC236}">
                          <a16:creationId xmlns:a16="http://schemas.microsoft.com/office/drawing/2014/main" id="{CD7D03DE-D6EC-4D32-B3C3-9751A015772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37461" y="7181696"/>
                      <a:ext cx="50556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8</a:t>
                      </a:r>
                    </a:p>
                  </p:txBody>
                </p:sp>
                <p:sp>
                  <p:nvSpPr>
                    <p:cNvPr id="441" name="TextBox 440">
                      <a:extLst>
                        <a:ext uri="{FF2B5EF4-FFF2-40B4-BE49-F238E27FC236}">
                          <a16:creationId xmlns:a16="http://schemas.microsoft.com/office/drawing/2014/main" id="{F8C037F2-565C-4B73-843C-1EA478E5655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47897" y="7904335"/>
                      <a:ext cx="50556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9</a:t>
                      </a:r>
                    </a:p>
                  </p:txBody>
                </p:sp>
                <p:sp>
                  <p:nvSpPr>
                    <p:cNvPr id="442" name="TextBox 441">
                      <a:extLst>
                        <a:ext uri="{FF2B5EF4-FFF2-40B4-BE49-F238E27FC236}">
                          <a16:creationId xmlns:a16="http://schemas.microsoft.com/office/drawing/2014/main" id="{99ABFCC8-92FA-440B-901E-381DF0FF215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383884" y="7750857"/>
                      <a:ext cx="504017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8</a:t>
                      </a:r>
                    </a:p>
                  </p:txBody>
                </p:sp>
                <p:sp>
                  <p:nvSpPr>
                    <p:cNvPr id="443" name="TextBox 442">
                      <a:extLst>
                        <a:ext uri="{FF2B5EF4-FFF2-40B4-BE49-F238E27FC236}">
                          <a16:creationId xmlns:a16="http://schemas.microsoft.com/office/drawing/2014/main" id="{E82F2184-C0C9-44DC-ADE4-706C933E44A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43805" y="7515136"/>
                      <a:ext cx="488642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eoR</a:t>
                      </a:r>
                      <a:endParaRPr lang="en-US" sz="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444" name="TextBox 443">
                      <a:extLst>
                        <a:ext uri="{FF2B5EF4-FFF2-40B4-BE49-F238E27FC236}">
                          <a16:creationId xmlns:a16="http://schemas.microsoft.com/office/drawing/2014/main" id="{E4BCE85E-6815-4B3C-BF13-D32B6A3A76E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44797" y="7721256"/>
                      <a:ext cx="50556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xHis</a:t>
                      </a:r>
                    </a:p>
                  </p:txBody>
                </p:sp>
                <p:sp>
                  <p:nvSpPr>
                    <p:cNvPr id="445" name="TextBox 444">
                      <a:extLst>
                        <a:ext uri="{FF2B5EF4-FFF2-40B4-BE49-F238E27FC236}">
                          <a16:creationId xmlns:a16="http://schemas.microsoft.com/office/drawing/2014/main" id="{16364903-C795-4E1C-AF91-B2BBACD00CA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05038" y="7834648"/>
                      <a:ext cx="50556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yA</a:t>
                      </a:r>
                      <a:endPara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447" name="Straight Connector 446">
                      <a:extLst>
                        <a:ext uri="{FF2B5EF4-FFF2-40B4-BE49-F238E27FC236}">
                          <a16:creationId xmlns:a16="http://schemas.microsoft.com/office/drawing/2014/main" id="{D76B8179-CDAF-4C60-8432-C9635D8C96D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749519" y="7700701"/>
                      <a:ext cx="1551" cy="266009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8" name="Straight Connector 447">
                      <a:extLst>
                        <a:ext uri="{FF2B5EF4-FFF2-40B4-BE49-F238E27FC236}">
                          <a16:creationId xmlns:a16="http://schemas.microsoft.com/office/drawing/2014/main" id="{BA01AAE3-9FD0-4A56-AACB-261DF9711E4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113969" y="7681921"/>
                      <a:ext cx="1293" cy="92654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9" name="Straight Connector 448">
                      <a:extLst>
                        <a:ext uri="{FF2B5EF4-FFF2-40B4-BE49-F238E27FC236}">
                          <a16:creationId xmlns:a16="http://schemas.microsoft.com/office/drawing/2014/main" id="{25B6C452-75A8-4A1C-B522-606248C29AF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172754" y="7681921"/>
                      <a:ext cx="1551" cy="266009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cxnSp>
              <p:nvCxnSpPr>
                <p:cNvPr id="469" name="Straight Arrow Connector 468">
                  <a:extLst>
                    <a:ext uri="{FF2B5EF4-FFF2-40B4-BE49-F238E27FC236}">
                      <a16:creationId xmlns:a16="http://schemas.microsoft.com/office/drawing/2014/main" id="{4C271AA8-C3E9-4B77-AA58-EEE1BF5364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67657" y="8613497"/>
                  <a:ext cx="1794344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0" name="TextBox 469">
                  <a:extLst>
                    <a:ext uri="{FF2B5EF4-FFF2-40B4-BE49-F238E27FC236}">
                      <a16:creationId xmlns:a16="http://schemas.microsoft.com/office/drawing/2014/main" id="{C98C633B-C197-4868-9BCB-A62F870746DE}"/>
                    </a:ext>
                  </a:extLst>
                </p:cNvPr>
                <p:cNvSpPr txBox="1"/>
                <p:nvPr/>
              </p:nvSpPr>
              <p:spPr>
                <a:xfrm>
                  <a:off x="4599943" y="8612656"/>
                  <a:ext cx="80293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econdary</a:t>
                  </a:r>
                  <a:r>
                    <a:rPr lang="fa-IR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DP</a:t>
                  </a:r>
                </a:p>
              </p:txBody>
            </p:sp>
          </p:grpSp>
          <p:sp>
            <p:nvSpPr>
              <p:cNvPr id="481" name="TextBox 480">
                <a:extLst>
                  <a:ext uri="{FF2B5EF4-FFF2-40B4-BE49-F238E27FC236}">
                    <a16:creationId xmlns:a16="http://schemas.microsoft.com/office/drawing/2014/main" id="{5537FA9B-174B-4794-8047-E269C2E0FA26}"/>
                  </a:ext>
                </a:extLst>
              </p:cNvPr>
              <p:cNvSpPr txBox="1"/>
              <p:nvPr/>
            </p:nvSpPr>
            <p:spPr>
              <a:xfrm>
                <a:off x="637830" y="7152639"/>
                <a:ext cx="39938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5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mH</a:t>
                </a:r>
                <a:r>
                  <a:rPr lang="en-US" sz="5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2" name="TextBox 481">
                <a:extLst>
                  <a:ext uri="{FF2B5EF4-FFF2-40B4-BE49-F238E27FC236}">
                    <a16:creationId xmlns:a16="http://schemas.microsoft.com/office/drawing/2014/main" id="{42CC9DDC-DFEE-40B8-AD16-E4D216A57CF3}"/>
                  </a:ext>
                </a:extLst>
              </p:cNvPr>
              <p:cNvSpPr txBox="1"/>
              <p:nvPr/>
            </p:nvSpPr>
            <p:spPr>
              <a:xfrm>
                <a:off x="2432749" y="7117726"/>
                <a:ext cx="434601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5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co</a:t>
                </a:r>
                <a:r>
                  <a:rPr lang="en-US" sz="5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549" name="Straight Connector 548">
              <a:extLst>
                <a:ext uri="{FF2B5EF4-FFF2-40B4-BE49-F238E27FC236}">
                  <a16:creationId xmlns:a16="http://schemas.microsoft.com/office/drawing/2014/main" id="{A54E6BCF-E3CD-4534-A801-FA2E0D515ED8}"/>
                </a:ext>
              </a:extLst>
            </p:cNvPr>
            <p:cNvCxnSpPr/>
            <p:nvPr/>
          </p:nvCxnSpPr>
          <p:spPr>
            <a:xfrm>
              <a:off x="1335002" y="7414730"/>
              <a:ext cx="1293" cy="92654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1" name="TextBox 550">
              <a:extLst>
                <a:ext uri="{FF2B5EF4-FFF2-40B4-BE49-F238E27FC236}">
                  <a16:creationId xmlns:a16="http://schemas.microsoft.com/office/drawing/2014/main" id="{7E108884-DBAF-47DC-AB44-22D7414EFA1B}"/>
                </a:ext>
              </a:extLst>
            </p:cNvPr>
            <p:cNvSpPr txBox="1"/>
            <p:nvPr/>
          </p:nvSpPr>
          <p:spPr>
            <a:xfrm>
              <a:off x="2165022" y="7541511"/>
              <a:ext cx="4410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al target 2</a:t>
              </a:r>
            </a:p>
          </p:txBody>
        </p:sp>
        <p:cxnSp>
          <p:nvCxnSpPr>
            <p:cNvPr id="552" name="Straight Connector 551">
              <a:extLst>
                <a:ext uri="{FF2B5EF4-FFF2-40B4-BE49-F238E27FC236}">
                  <a16:creationId xmlns:a16="http://schemas.microsoft.com/office/drawing/2014/main" id="{C3D19593-1838-4937-8A1B-79265E39D6D2}"/>
                </a:ext>
              </a:extLst>
            </p:cNvPr>
            <p:cNvCxnSpPr>
              <a:cxnSpLocks/>
            </p:cNvCxnSpPr>
            <p:nvPr/>
          </p:nvCxnSpPr>
          <p:spPr>
            <a:xfrm>
              <a:off x="2517325" y="7396790"/>
              <a:ext cx="1551" cy="266009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56" name="TextBox 555">
            <a:extLst>
              <a:ext uri="{FF2B5EF4-FFF2-40B4-BE49-F238E27FC236}">
                <a16:creationId xmlns:a16="http://schemas.microsoft.com/office/drawing/2014/main" id="{F86B747B-C5D3-4D4E-9607-E5C648EF6A2A}"/>
              </a:ext>
            </a:extLst>
          </p:cNvPr>
          <p:cNvSpPr txBox="1"/>
          <p:nvPr/>
        </p:nvSpPr>
        <p:spPr>
          <a:xfrm>
            <a:off x="472440" y="7482202"/>
            <a:ext cx="9537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ary DDP</a:t>
            </a:r>
          </a:p>
        </p:txBody>
      </p:sp>
      <p:cxnSp>
        <p:nvCxnSpPr>
          <p:cNvPr id="557" name="Straight Arrow Connector 556">
            <a:extLst>
              <a:ext uri="{FF2B5EF4-FFF2-40B4-BE49-F238E27FC236}">
                <a16:creationId xmlns:a16="http://schemas.microsoft.com/office/drawing/2014/main" id="{9636EB52-1A69-4355-B3A7-62C26C0D14E0}"/>
              </a:ext>
            </a:extLst>
          </p:cNvPr>
          <p:cNvCxnSpPr>
            <a:cxnSpLocks/>
          </p:cNvCxnSpPr>
          <p:nvPr/>
        </p:nvCxnSpPr>
        <p:spPr>
          <a:xfrm>
            <a:off x="1290725" y="7589924"/>
            <a:ext cx="43906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9" name="Straight Arrow Connector 558">
            <a:extLst>
              <a:ext uri="{FF2B5EF4-FFF2-40B4-BE49-F238E27FC236}">
                <a16:creationId xmlns:a16="http://schemas.microsoft.com/office/drawing/2014/main" id="{8BB722B1-ABD8-4374-961A-CC5131CC5020}"/>
              </a:ext>
            </a:extLst>
          </p:cNvPr>
          <p:cNvCxnSpPr>
            <a:cxnSpLocks/>
          </p:cNvCxnSpPr>
          <p:nvPr/>
        </p:nvCxnSpPr>
        <p:spPr>
          <a:xfrm flipV="1">
            <a:off x="2533210" y="7585849"/>
            <a:ext cx="170987" cy="124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11" name="Group 610">
            <a:extLst>
              <a:ext uri="{FF2B5EF4-FFF2-40B4-BE49-F238E27FC236}">
                <a16:creationId xmlns:a16="http://schemas.microsoft.com/office/drawing/2014/main" id="{F3F83EE6-90F9-460B-A31B-B2D8DF2CD12D}"/>
              </a:ext>
            </a:extLst>
          </p:cNvPr>
          <p:cNvGrpSpPr/>
          <p:nvPr/>
        </p:nvGrpSpPr>
        <p:grpSpPr>
          <a:xfrm>
            <a:off x="2644463" y="7176468"/>
            <a:ext cx="3339346" cy="1225950"/>
            <a:chOff x="2644463" y="7176468"/>
            <a:chExt cx="3339346" cy="1225950"/>
          </a:xfrm>
        </p:grpSpPr>
        <p:sp>
          <p:nvSpPr>
            <p:cNvPr id="594" name="TextBox 593">
              <a:extLst>
                <a:ext uri="{FF2B5EF4-FFF2-40B4-BE49-F238E27FC236}">
                  <a16:creationId xmlns:a16="http://schemas.microsoft.com/office/drawing/2014/main" id="{AC8CF412-22C7-4B23-8E4B-2B191BA3C3BF}"/>
                </a:ext>
              </a:extLst>
            </p:cNvPr>
            <p:cNvSpPr txBox="1"/>
            <p:nvPr/>
          </p:nvSpPr>
          <p:spPr>
            <a:xfrm>
              <a:off x="2971908" y="7914392"/>
              <a:ext cx="68896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ecial target 1</a:t>
              </a:r>
            </a:p>
          </p:txBody>
        </p:sp>
        <p:sp>
          <p:nvSpPr>
            <p:cNvPr id="606" name="TextBox 605">
              <a:extLst>
                <a:ext uri="{FF2B5EF4-FFF2-40B4-BE49-F238E27FC236}">
                  <a16:creationId xmlns:a16="http://schemas.microsoft.com/office/drawing/2014/main" id="{FB9546E3-3326-4EF2-8973-0ED092D3EC6D}"/>
                </a:ext>
              </a:extLst>
            </p:cNvPr>
            <p:cNvSpPr txBox="1"/>
            <p:nvPr/>
          </p:nvSpPr>
          <p:spPr>
            <a:xfrm>
              <a:off x="2644463" y="7425483"/>
              <a:ext cx="43460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nd</a:t>
              </a:r>
              <a:r>
                <a:rPr 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II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10" name="Group 609">
              <a:extLst>
                <a:ext uri="{FF2B5EF4-FFF2-40B4-BE49-F238E27FC236}">
                  <a16:creationId xmlns:a16="http://schemas.microsoft.com/office/drawing/2014/main" id="{039DA0CF-F65B-49A5-89F6-B3898E1C90CC}"/>
                </a:ext>
              </a:extLst>
            </p:cNvPr>
            <p:cNvGrpSpPr/>
            <p:nvPr/>
          </p:nvGrpSpPr>
          <p:grpSpPr>
            <a:xfrm>
              <a:off x="2787732" y="7176468"/>
              <a:ext cx="3196077" cy="1225950"/>
              <a:chOff x="2594237" y="7417594"/>
              <a:chExt cx="3196077" cy="1225950"/>
            </a:xfrm>
          </p:grpSpPr>
          <p:grpSp>
            <p:nvGrpSpPr>
              <p:cNvPr id="600" name="Group 599">
                <a:extLst>
                  <a:ext uri="{FF2B5EF4-FFF2-40B4-BE49-F238E27FC236}">
                    <a16:creationId xmlns:a16="http://schemas.microsoft.com/office/drawing/2014/main" id="{C4391FB5-D5CA-4CF4-9DD4-3F9CE9045D4D}"/>
                  </a:ext>
                </a:extLst>
              </p:cNvPr>
              <p:cNvGrpSpPr/>
              <p:nvPr/>
            </p:nvGrpSpPr>
            <p:grpSpPr>
              <a:xfrm>
                <a:off x="2594237" y="7762917"/>
                <a:ext cx="536235" cy="202411"/>
                <a:chOff x="2594237" y="7762917"/>
                <a:chExt cx="536235" cy="202411"/>
              </a:xfrm>
            </p:grpSpPr>
            <p:sp>
              <p:nvSpPr>
                <p:cNvPr id="596" name="Arrow: Right 595">
                  <a:extLst>
                    <a:ext uri="{FF2B5EF4-FFF2-40B4-BE49-F238E27FC236}">
                      <a16:creationId xmlns:a16="http://schemas.microsoft.com/office/drawing/2014/main" id="{88C44917-9438-4AD2-B62E-BF518C6DA838}"/>
                    </a:ext>
                  </a:extLst>
                </p:cNvPr>
                <p:cNvSpPr/>
                <p:nvPr/>
              </p:nvSpPr>
              <p:spPr>
                <a:xfrm>
                  <a:off x="2594237" y="7762917"/>
                  <a:ext cx="347370" cy="202411"/>
                </a:xfrm>
                <a:prstGeom prst="rightArrow">
                  <a:avLst>
                    <a:gd name="adj1" fmla="val 50000"/>
                    <a:gd name="adj2" fmla="val 32692"/>
                  </a:avLst>
                </a:prstGeom>
                <a:solidFill>
                  <a:srgbClr val="8DEF4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4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U3</a:t>
                  </a:r>
                </a:p>
              </p:txBody>
            </p:sp>
            <p:sp>
              <p:nvSpPr>
                <p:cNvPr id="597" name="Arrow: Right 596">
                  <a:extLst>
                    <a:ext uri="{FF2B5EF4-FFF2-40B4-BE49-F238E27FC236}">
                      <a16:creationId xmlns:a16="http://schemas.microsoft.com/office/drawing/2014/main" id="{6C7D9A64-E748-4754-A465-FA0421893C77}"/>
                    </a:ext>
                  </a:extLst>
                </p:cNvPr>
                <p:cNvSpPr/>
                <p:nvPr/>
              </p:nvSpPr>
              <p:spPr>
                <a:xfrm>
                  <a:off x="2949744" y="7780690"/>
                  <a:ext cx="51444" cy="177379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C8A698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8" name="Arrow: Right 597">
                  <a:extLst>
                    <a:ext uri="{FF2B5EF4-FFF2-40B4-BE49-F238E27FC236}">
                      <a16:creationId xmlns:a16="http://schemas.microsoft.com/office/drawing/2014/main" id="{DB246467-F6F6-4214-9813-30B949EF364C}"/>
                    </a:ext>
                  </a:extLst>
                </p:cNvPr>
                <p:cNvSpPr/>
                <p:nvPr/>
              </p:nvSpPr>
              <p:spPr>
                <a:xfrm>
                  <a:off x="3007074" y="7780691"/>
                  <a:ext cx="71964" cy="177379"/>
                </a:xfrm>
                <a:prstGeom prst="rightArrow">
                  <a:avLst>
                    <a:gd name="adj1" fmla="val 50000"/>
                    <a:gd name="adj2" fmla="val 31756"/>
                  </a:avLst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9" name="Rectangle 598">
                  <a:extLst>
                    <a:ext uri="{FF2B5EF4-FFF2-40B4-BE49-F238E27FC236}">
                      <a16:creationId xmlns:a16="http://schemas.microsoft.com/office/drawing/2014/main" id="{70886B49-5E8A-4A0D-9561-57DD23168244}"/>
                    </a:ext>
                  </a:extLst>
                </p:cNvPr>
                <p:cNvSpPr/>
                <p:nvPr/>
              </p:nvSpPr>
              <p:spPr>
                <a:xfrm flipH="1">
                  <a:off x="3084753" y="7800807"/>
                  <a:ext cx="45719" cy="1405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609" name="Group 608">
                <a:extLst>
                  <a:ext uri="{FF2B5EF4-FFF2-40B4-BE49-F238E27FC236}">
                    <a16:creationId xmlns:a16="http://schemas.microsoft.com/office/drawing/2014/main" id="{BA05CF8C-50D1-4423-9B36-14552F738CA4}"/>
                  </a:ext>
                </a:extLst>
              </p:cNvPr>
              <p:cNvGrpSpPr/>
              <p:nvPr/>
            </p:nvGrpSpPr>
            <p:grpSpPr>
              <a:xfrm>
                <a:off x="3138609" y="7417594"/>
                <a:ext cx="2651705" cy="1225950"/>
                <a:chOff x="3138609" y="7417594"/>
                <a:chExt cx="2651705" cy="1225950"/>
              </a:xfrm>
            </p:grpSpPr>
            <p:sp>
              <p:nvSpPr>
                <p:cNvPr id="581" name="TextBox 580">
                  <a:extLst>
                    <a:ext uri="{FF2B5EF4-FFF2-40B4-BE49-F238E27FC236}">
                      <a16:creationId xmlns:a16="http://schemas.microsoft.com/office/drawing/2014/main" id="{7F3B8976-87E1-4677-8DCE-7CBD52A27690}"/>
                    </a:ext>
                  </a:extLst>
                </p:cNvPr>
                <p:cNvSpPr txBox="1"/>
                <p:nvPr/>
              </p:nvSpPr>
              <p:spPr>
                <a:xfrm>
                  <a:off x="3143903" y="7417594"/>
                  <a:ext cx="50556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7</a:t>
                  </a:r>
                </a:p>
              </p:txBody>
            </p:sp>
            <p:sp>
              <p:nvSpPr>
                <p:cNvPr id="582" name="TextBox 581">
                  <a:extLst>
                    <a:ext uri="{FF2B5EF4-FFF2-40B4-BE49-F238E27FC236}">
                      <a16:creationId xmlns:a16="http://schemas.microsoft.com/office/drawing/2014/main" id="{063BC797-A16D-4E1A-B3B5-9A72B4150573}"/>
                    </a:ext>
                  </a:extLst>
                </p:cNvPr>
                <p:cNvSpPr txBox="1"/>
                <p:nvPr/>
              </p:nvSpPr>
              <p:spPr>
                <a:xfrm>
                  <a:off x="3466165" y="7439113"/>
                  <a:ext cx="50556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8</a:t>
                  </a:r>
                </a:p>
              </p:txBody>
            </p:sp>
            <p:sp>
              <p:nvSpPr>
                <p:cNvPr id="570" name="TextBox 569">
                  <a:extLst>
                    <a:ext uri="{FF2B5EF4-FFF2-40B4-BE49-F238E27FC236}">
                      <a16:creationId xmlns:a16="http://schemas.microsoft.com/office/drawing/2014/main" id="{55955AC9-65F1-4292-AACA-200884538118}"/>
                    </a:ext>
                  </a:extLst>
                </p:cNvPr>
                <p:cNvSpPr txBox="1"/>
                <p:nvPr/>
              </p:nvSpPr>
              <p:spPr>
                <a:xfrm>
                  <a:off x="3692757" y="8458878"/>
                  <a:ext cx="80293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DP</a:t>
                  </a:r>
                </a:p>
              </p:txBody>
            </p:sp>
            <p:grpSp>
              <p:nvGrpSpPr>
                <p:cNvPr id="608" name="Group 607">
                  <a:extLst>
                    <a:ext uri="{FF2B5EF4-FFF2-40B4-BE49-F238E27FC236}">
                      <a16:creationId xmlns:a16="http://schemas.microsoft.com/office/drawing/2014/main" id="{8817FA5F-804E-4151-B554-4CD53E5AC318}"/>
                    </a:ext>
                  </a:extLst>
                </p:cNvPr>
                <p:cNvGrpSpPr/>
                <p:nvPr/>
              </p:nvGrpSpPr>
              <p:grpSpPr>
                <a:xfrm>
                  <a:off x="3138609" y="7595474"/>
                  <a:ext cx="2651705" cy="864245"/>
                  <a:chOff x="3138609" y="7595474"/>
                  <a:chExt cx="2651705" cy="864245"/>
                </a:xfrm>
              </p:grpSpPr>
              <p:sp>
                <p:nvSpPr>
                  <p:cNvPr id="591" name="Arrow: Right 590">
                    <a:extLst>
                      <a:ext uri="{FF2B5EF4-FFF2-40B4-BE49-F238E27FC236}">
                        <a16:creationId xmlns:a16="http://schemas.microsoft.com/office/drawing/2014/main" id="{3598DFDF-CC7D-4A2C-877A-83D6EC1FB40E}"/>
                      </a:ext>
                    </a:extLst>
                  </p:cNvPr>
                  <p:cNvSpPr/>
                  <p:nvPr/>
                </p:nvSpPr>
                <p:spPr>
                  <a:xfrm>
                    <a:off x="4237728" y="7748956"/>
                    <a:ext cx="602561" cy="227406"/>
                  </a:xfrm>
                  <a:prstGeom prst="rightArrow">
                    <a:avLst>
                      <a:gd name="adj1" fmla="val 50000"/>
                      <a:gd name="adj2" fmla="val 38654"/>
                    </a:avLst>
                  </a:prstGeom>
                  <a:solidFill>
                    <a:srgbClr val="A5BBE3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’homology arm</a:t>
                    </a:r>
                  </a:p>
                </p:txBody>
              </p:sp>
              <p:sp>
                <p:nvSpPr>
                  <p:cNvPr id="592" name="Arrow: Right 591">
                    <a:extLst>
                      <a:ext uri="{FF2B5EF4-FFF2-40B4-BE49-F238E27FC236}">
                        <a16:creationId xmlns:a16="http://schemas.microsoft.com/office/drawing/2014/main" id="{82842082-BBFD-43F0-A258-778651A30030}"/>
                      </a:ext>
                    </a:extLst>
                  </p:cNvPr>
                  <p:cNvSpPr/>
                  <p:nvPr/>
                </p:nvSpPr>
                <p:spPr>
                  <a:xfrm flipH="1">
                    <a:off x="4855353" y="7768287"/>
                    <a:ext cx="65351" cy="177379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C8A698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73" name="Arrow: Right 572">
                    <a:extLst>
                      <a:ext uri="{FF2B5EF4-FFF2-40B4-BE49-F238E27FC236}">
                        <a16:creationId xmlns:a16="http://schemas.microsoft.com/office/drawing/2014/main" id="{BCA6596B-EE44-4F1D-BFCC-189B99FC592D}"/>
                      </a:ext>
                    </a:extLst>
                  </p:cNvPr>
                  <p:cNvSpPr/>
                  <p:nvPr/>
                </p:nvSpPr>
                <p:spPr>
                  <a:xfrm>
                    <a:off x="3206238" y="7763421"/>
                    <a:ext cx="478381" cy="225930"/>
                  </a:xfrm>
                  <a:prstGeom prst="rightArrow">
                    <a:avLst>
                      <a:gd name="adj1" fmla="val 50000"/>
                      <a:gd name="adj2" fmla="val 38654"/>
                    </a:avLst>
                  </a:prstGeom>
                  <a:solidFill>
                    <a:srgbClr val="A5BBE3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0" tIns="0" rIns="0" bIns="0" rtlCol="0" anchor="ctr"/>
                  <a:lstStyle/>
                  <a:p>
                    <a:pPr algn="ctr"/>
                    <a:r>
                      <a:rPr lang="en-US" sz="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’ homology arm</a:t>
                    </a:r>
                  </a:p>
                </p:txBody>
              </p:sp>
              <p:sp>
                <p:nvSpPr>
                  <p:cNvPr id="574" name="Arrow: Right 573">
                    <a:extLst>
                      <a:ext uri="{FF2B5EF4-FFF2-40B4-BE49-F238E27FC236}">
                        <a16:creationId xmlns:a16="http://schemas.microsoft.com/office/drawing/2014/main" id="{B05C2C38-63CF-414B-9FE0-FB71A8BAE858}"/>
                      </a:ext>
                    </a:extLst>
                  </p:cNvPr>
                  <p:cNvSpPr/>
                  <p:nvPr/>
                </p:nvSpPr>
                <p:spPr>
                  <a:xfrm>
                    <a:off x="3291530" y="7595474"/>
                    <a:ext cx="92333" cy="183698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FFFF00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75" name="Arrow: Right 574">
                    <a:extLst>
                      <a:ext uri="{FF2B5EF4-FFF2-40B4-BE49-F238E27FC236}">
                        <a16:creationId xmlns:a16="http://schemas.microsoft.com/office/drawing/2014/main" id="{C8CBBEA5-49D2-4DD0-9EE3-B02468B6414E}"/>
                      </a:ext>
                    </a:extLst>
                  </p:cNvPr>
                  <p:cNvSpPr/>
                  <p:nvPr/>
                </p:nvSpPr>
                <p:spPr>
                  <a:xfrm>
                    <a:off x="3627698" y="7605280"/>
                    <a:ext cx="77182" cy="183698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FFFF00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76" name="Arrow: Right 575">
                    <a:extLst>
                      <a:ext uri="{FF2B5EF4-FFF2-40B4-BE49-F238E27FC236}">
                        <a16:creationId xmlns:a16="http://schemas.microsoft.com/office/drawing/2014/main" id="{94341323-AED4-479F-B414-B154A700E727}"/>
                      </a:ext>
                    </a:extLst>
                  </p:cNvPr>
                  <p:cNvSpPr/>
                  <p:nvPr/>
                </p:nvSpPr>
                <p:spPr>
                  <a:xfrm>
                    <a:off x="3692756" y="7774420"/>
                    <a:ext cx="48453" cy="183698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FFFF00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77" name="Arrow: Right 576">
                    <a:extLst>
                      <a:ext uri="{FF2B5EF4-FFF2-40B4-BE49-F238E27FC236}">
                        <a16:creationId xmlns:a16="http://schemas.microsoft.com/office/drawing/2014/main" id="{263B037A-B3A6-4F97-ACC3-61EBD1F29666}"/>
                      </a:ext>
                    </a:extLst>
                  </p:cNvPr>
                  <p:cNvSpPr/>
                  <p:nvPr/>
                </p:nvSpPr>
                <p:spPr>
                  <a:xfrm>
                    <a:off x="3746573" y="7775411"/>
                    <a:ext cx="64771" cy="183698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FFFF00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78" name="Arrow: Right 577">
                    <a:extLst>
                      <a:ext uri="{FF2B5EF4-FFF2-40B4-BE49-F238E27FC236}">
                        <a16:creationId xmlns:a16="http://schemas.microsoft.com/office/drawing/2014/main" id="{7525C1F6-BD93-409B-B313-3B651CCD7440}"/>
                      </a:ext>
                    </a:extLst>
                  </p:cNvPr>
                  <p:cNvSpPr/>
                  <p:nvPr/>
                </p:nvSpPr>
                <p:spPr>
                  <a:xfrm>
                    <a:off x="3815600" y="7766082"/>
                    <a:ext cx="300947" cy="200374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FFFF00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79" name="Arrow: Right 578">
                    <a:extLst>
                      <a:ext uri="{FF2B5EF4-FFF2-40B4-BE49-F238E27FC236}">
                        <a16:creationId xmlns:a16="http://schemas.microsoft.com/office/drawing/2014/main" id="{46E4E0FA-4E3E-4743-ABE1-4F7788F0A338}"/>
                      </a:ext>
                    </a:extLst>
                  </p:cNvPr>
                  <p:cNvSpPr/>
                  <p:nvPr/>
                </p:nvSpPr>
                <p:spPr>
                  <a:xfrm>
                    <a:off x="4128180" y="7770810"/>
                    <a:ext cx="45719" cy="183698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chemeClr val="bg2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80" name="Arrow: Right 579">
                    <a:extLst>
                      <a:ext uri="{FF2B5EF4-FFF2-40B4-BE49-F238E27FC236}">
                        <a16:creationId xmlns:a16="http://schemas.microsoft.com/office/drawing/2014/main" id="{C17CDE43-6B81-4D81-9BF7-E4306783ABA3}"/>
                      </a:ext>
                    </a:extLst>
                  </p:cNvPr>
                  <p:cNvSpPr/>
                  <p:nvPr/>
                </p:nvSpPr>
                <p:spPr>
                  <a:xfrm>
                    <a:off x="4183807" y="7772359"/>
                    <a:ext cx="48453" cy="183698"/>
                  </a:xfrm>
                  <a:prstGeom prst="rightArrow">
                    <a:avLst>
                      <a:gd name="adj1" fmla="val 46494"/>
                      <a:gd name="adj2" fmla="val 39316"/>
                    </a:avLst>
                  </a:prstGeom>
                  <a:solidFill>
                    <a:schemeClr val="bg2">
                      <a:lumMod val="75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83" name="TextBox 582">
                    <a:extLst>
                      <a:ext uri="{FF2B5EF4-FFF2-40B4-BE49-F238E27FC236}">
                        <a16:creationId xmlns:a16="http://schemas.microsoft.com/office/drawing/2014/main" id="{AF646997-91F0-4595-BBA4-095CCBEF1685}"/>
                      </a:ext>
                    </a:extLst>
                  </p:cNvPr>
                  <p:cNvSpPr txBox="1"/>
                  <p:nvPr/>
                </p:nvSpPr>
                <p:spPr>
                  <a:xfrm>
                    <a:off x="3576601" y="8161752"/>
                    <a:ext cx="505562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xon9</a:t>
                    </a:r>
                  </a:p>
                </p:txBody>
              </p:sp>
              <p:sp>
                <p:nvSpPr>
                  <p:cNvPr id="584" name="TextBox 583">
                    <a:extLst>
                      <a:ext uri="{FF2B5EF4-FFF2-40B4-BE49-F238E27FC236}">
                        <a16:creationId xmlns:a16="http://schemas.microsoft.com/office/drawing/2014/main" id="{ACF8D081-1498-484E-9154-ED16DEDCA2AD}"/>
                      </a:ext>
                    </a:extLst>
                  </p:cNvPr>
                  <p:cNvSpPr txBox="1"/>
                  <p:nvPr/>
                </p:nvSpPr>
                <p:spPr>
                  <a:xfrm>
                    <a:off x="3412588" y="8008274"/>
                    <a:ext cx="504017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xon8</a:t>
                    </a:r>
                  </a:p>
                </p:txBody>
              </p:sp>
              <p:sp>
                <p:nvSpPr>
                  <p:cNvPr id="585" name="TextBox 584">
                    <a:extLst>
                      <a:ext uri="{FF2B5EF4-FFF2-40B4-BE49-F238E27FC236}">
                        <a16:creationId xmlns:a16="http://schemas.microsoft.com/office/drawing/2014/main" id="{D0079354-68B7-45A2-8C03-6AE0421DB40E}"/>
                      </a:ext>
                    </a:extLst>
                  </p:cNvPr>
                  <p:cNvSpPr txBox="1"/>
                  <p:nvPr/>
                </p:nvSpPr>
                <p:spPr>
                  <a:xfrm>
                    <a:off x="3772509" y="7772553"/>
                    <a:ext cx="488642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5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leoR</a:t>
                    </a:r>
                    <a:endParaRPr lang="en-US" sz="5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6" name="TextBox 585">
                    <a:extLst>
                      <a:ext uri="{FF2B5EF4-FFF2-40B4-BE49-F238E27FC236}">
                        <a16:creationId xmlns:a16="http://schemas.microsoft.com/office/drawing/2014/main" id="{E32DE538-989A-499A-BE0B-7FD588D3BC39}"/>
                      </a:ext>
                    </a:extLst>
                  </p:cNvPr>
                  <p:cNvSpPr txBox="1"/>
                  <p:nvPr/>
                </p:nvSpPr>
                <p:spPr>
                  <a:xfrm>
                    <a:off x="3873501" y="7978673"/>
                    <a:ext cx="505562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xHis</a:t>
                    </a:r>
                  </a:p>
                </p:txBody>
              </p:sp>
              <p:sp>
                <p:nvSpPr>
                  <p:cNvPr id="587" name="TextBox 586">
                    <a:extLst>
                      <a:ext uri="{FF2B5EF4-FFF2-40B4-BE49-F238E27FC236}">
                        <a16:creationId xmlns:a16="http://schemas.microsoft.com/office/drawing/2014/main" id="{F7BC9F55-6846-42EC-862D-0C8801BE8400}"/>
                      </a:ext>
                    </a:extLst>
                  </p:cNvPr>
                  <p:cNvSpPr txBox="1"/>
                  <p:nvPr/>
                </p:nvSpPr>
                <p:spPr>
                  <a:xfrm>
                    <a:off x="4114526" y="8083223"/>
                    <a:ext cx="505562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A</a:t>
                    </a:r>
                    <a:endParaRPr lang="en-US" sz="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588" name="Straight Connector 587">
                    <a:extLst>
                      <a:ext uri="{FF2B5EF4-FFF2-40B4-BE49-F238E27FC236}">
                        <a16:creationId xmlns:a16="http://schemas.microsoft.com/office/drawing/2014/main" id="{BBD76098-C1B8-4755-AF51-FB2F680D969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770607" y="7936805"/>
                    <a:ext cx="1551" cy="266009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9" name="Straight Connector 588">
                    <a:extLst>
                      <a:ext uri="{FF2B5EF4-FFF2-40B4-BE49-F238E27FC236}">
                        <a16:creationId xmlns:a16="http://schemas.microsoft.com/office/drawing/2014/main" id="{AA3C589D-8877-41A9-84C2-3323C5DD92DF}"/>
                      </a:ext>
                    </a:extLst>
                  </p:cNvPr>
                  <p:cNvCxnSpPr/>
                  <p:nvPr/>
                </p:nvCxnSpPr>
                <p:spPr>
                  <a:xfrm>
                    <a:off x="4138764" y="7943184"/>
                    <a:ext cx="1293" cy="92654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0" name="Straight Connector 589">
                    <a:extLst>
                      <a:ext uri="{FF2B5EF4-FFF2-40B4-BE49-F238E27FC236}">
                        <a16:creationId xmlns:a16="http://schemas.microsoft.com/office/drawing/2014/main" id="{F959A68D-0CDF-4BB7-85AC-557DFA144E7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190956" y="7931138"/>
                    <a:ext cx="1551" cy="266009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9" name="Straight Arrow Connector 568">
                    <a:extLst>
                      <a:ext uri="{FF2B5EF4-FFF2-40B4-BE49-F238E27FC236}">
                        <a16:creationId xmlns:a16="http://schemas.microsoft.com/office/drawing/2014/main" id="{8454F123-388B-4A95-9FBB-24DE4464A2A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60471" y="8459719"/>
                    <a:ext cx="1794344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headEnd type="triangl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2" name="Straight Connector 561">
                    <a:extLst>
                      <a:ext uri="{FF2B5EF4-FFF2-40B4-BE49-F238E27FC236}">
                        <a16:creationId xmlns:a16="http://schemas.microsoft.com/office/drawing/2014/main" id="{BBCCFC71-E3F8-4F88-B12B-5E2061E37968}"/>
                      </a:ext>
                    </a:extLst>
                  </p:cNvPr>
                  <p:cNvCxnSpPr/>
                  <p:nvPr/>
                </p:nvCxnSpPr>
                <p:spPr>
                  <a:xfrm>
                    <a:off x="3701623" y="7937495"/>
                    <a:ext cx="1293" cy="92654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63" name="TextBox 562">
                    <a:extLst>
                      <a:ext uri="{FF2B5EF4-FFF2-40B4-BE49-F238E27FC236}">
                        <a16:creationId xmlns:a16="http://schemas.microsoft.com/office/drawing/2014/main" id="{A223C078-37ED-4141-9915-3F2B3466E3E1}"/>
                      </a:ext>
                    </a:extLst>
                  </p:cNvPr>
                  <p:cNvSpPr txBox="1"/>
                  <p:nvPr/>
                </p:nvSpPr>
                <p:spPr>
                  <a:xfrm>
                    <a:off x="4524512" y="8153700"/>
                    <a:ext cx="72548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pecial target 2</a:t>
                    </a:r>
                  </a:p>
                </p:txBody>
              </p:sp>
              <p:cxnSp>
                <p:nvCxnSpPr>
                  <p:cNvPr id="564" name="Straight Connector 563">
                    <a:extLst>
                      <a:ext uri="{FF2B5EF4-FFF2-40B4-BE49-F238E27FC236}">
                        <a16:creationId xmlns:a16="http://schemas.microsoft.com/office/drawing/2014/main" id="{0C02B36F-56D2-47CE-A49E-B5F2AF79B90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04977" y="7936683"/>
                    <a:ext cx="1551" cy="266009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93" name="Arrow: Right 592">
                    <a:extLst>
                      <a:ext uri="{FF2B5EF4-FFF2-40B4-BE49-F238E27FC236}">
                        <a16:creationId xmlns:a16="http://schemas.microsoft.com/office/drawing/2014/main" id="{D7BDE568-B6D4-411D-9773-275FBC44E40B}"/>
                      </a:ext>
                    </a:extLst>
                  </p:cNvPr>
                  <p:cNvSpPr/>
                  <p:nvPr/>
                </p:nvSpPr>
                <p:spPr>
                  <a:xfrm>
                    <a:off x="3138609" y="7785236"/>
                    <a:ext cx="61062" cy="177379"/>
                  </a:xfrm>
                  <a:prstGeom prst="rightArrow">
                    <a:avLst>
                      <a:gd name="adj1" fmla="val 50000"/>
                      <a:gd name="adj2" fmla="val 31756"/>
                    </a:avLst>
                  </a:prstGeom>
                  <a:solidFill>
                    <a:srgbClr val="C8A698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cxnSp>
                <p:nvCxnSpPr>
                  <p:cNvPr id="595" name="Straight Connector 594">
                    <a:extLst>
                      <a:ext uri="{FF2B5EF4-FFF2-40B4-BE49-F238E27FC236}">
                        <a16:creationId xmlns:a16="http://schemas.microsoft.com/office/drawing/2014/main" id="{7C45334D-9489-46A8-8F67-4065C9822EA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65606" y="7946290"/>
                    <a:ext cx="1551" cy="266009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01" name="Group 600">
                    <a:extLst>
                      <a:ext uri="{FF2B5EF4-FFF2-40B4-BE49-F238E27FC236}">
                        <a16:creationId xmlns:a16="http://schemas.microsoft.com/office/drawing/2014/main" id="{A084AF9F-BFA8-46F4-99EC-5F7FB7BA1C66}"/>
                      </a:ext>
                    </a:extLst>
                  </p:cNvPr>
                  <p:cNvGrpSpPr/>
                  <p:nvPr/>
                </p:nvGrpSpPr>
                <p:grpSpPr>
                  <a:xfrm flipH="1">
                    <a:off x="4921532" y="7753405"/>
                    <a:ext cx="591435" cy="202411"/>
                    <a:chOff x="2594237" y="7762917"/>
                    <a:chExt cx="536235" cy="202411"/>
                  </a:xfrm>
                </p:grpSpPr>
                <p:sp>
                  <p:nvSpPr>
                    <p:cNvPr id="602" name="Arrow: Right 601">
                      <a:extLst>
                        <a:ext uri="{FF2B5EF4-FFF2-40B4-BE49-F238E27FC236}">
                          <a16:creationId xmlns:a16="http://schemas.microsoft.com/office/drawing/2014/main" id="{122976DD-1AB8-4DB6-90C8-9EB0FEB2E80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94237" y="7762917"/>
                      <a:ext cx="347370" cy="202411"/>
                    </a:xfrm>
                    <a:prstGeom prst="rightArrow">
                      <a:avLst>
                        <a:gd name="adj1" fmla="val 50000"/>
                        <a:gd name="adj2" fmla="val 32692"/>
                      </a:avLst>
                    </a:prstGeom>
                    <a:solidFill>
                      <a:srgbClr val="8DEF43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U3</a:t>
                      </a:r>
                    </a:p>
                  </p:txBody>
                </p:sp>
                <p:sp>
                  <p:nvSpPr>
                    <p:cNvPr id="603" name="Arrow: Right 602">
                      <a:extLst>
                        <a:ext uri="{FF2B5EF4-FFF2-40B4-BE49-F238E27FC236}">
                          <a16:creationId xmlns:a16="http://schemas.microsoft.com/office/drawing/2014/main" id="{58B0B69B-D7FB-4F21-BE7E-D253103A82D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49744" y="7780690"/>
                      <a:ext cx="51444" cy="177379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rgbClr val="C8A698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04" name="Arrow: Right 603">
                      <a:extLst>
                        <a:ext uri="{FF2B5EF4-FFF2-40B4-BE49-F238E27FC236}">
                          <a16:creationId xmlns:a16="http://schemas.microsoft.com/office/drawing/2014/main" id="{6ADB8AD4-7C9A-40CD-B812-D8A4642A1B6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007074" y="7780691"/>
                      <a:ext cx="71964" cy="177379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rgbClr val="FF0000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05" name="Rectangle 604">
                      <a:extLst>
                        <a:ext uri="{FF2B5EF4-FFF2-40B4-BE49-F238E27FC236}">
                          <a16:creationId xmlns:a16="http://schemas.microsoft.com/office/drawing/2014/main" id="{ABDEEF7E-3FEF-469E-A8B8-97CB09329579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3084753" y="7800807"/>
                      <a:ext cx="45719" cy="140511"/>
                    </a:xfrm>
                    <a:prstGeom prst="rect">
                      <a:avLst/>
                    </a:prstGeom>
                    <a:solidFill>
                      <a:srgbClr val="C00000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607" name="TextBox 606">
                    <a:extLst>
                      <a:ext uri="{FF2B5EF4-FFF2-40B4-BE49-F238E27FC236}">
                        <a16:creationId xmlns:a16="http://schemas.microsoft.com/office/drawing/2014/main" id="{DFBCBA90-78FA-45EA-B9AD-9138EB3C5B39}"/>
                      </a:ext>
                    </a:extLst>
                  </p:cNvPr>
                  <p:cNvSpPr txBox="1"/>
                  <p:nvPr/>
                </p:nvSpPr>
                <p:spPr>
                  <a:xfrm>
                    <a:off x="5355713" y="7661421"/>
                    <a:ext cx="434601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500" b="1" i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da</a:t>
                    </a:r>
                    <a:r>
                      <a:rPr lang="en-US" sz="5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endPara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</p:grpSp>
      <p:sp>
        <p:nvSpPr>
          <p:cNvPr id="612" name="TextBox 611">
            <a:extLst>
              <a:ext uri="{FF2B5EF4-FFF2-40B4-BE49-F238E27FC236}">
                <a16:creationId xmlns:a16="http://schemas.microsoft.com/office/drawing/2014/main" id="{E8237C3A-16BC-41AA-85FC-F61E33C024C5}"/>
              </a:ext>
            </a:extLst>
          </p:cNvPr>
          <p:cNvSpPr txBox="1"/>
          <p:nvPr/>
        </p:nvSpPr>
        <p:spPr>
          <a:xfrm>
            <a:off x="345333" y="8600971"/>
            <a:ext cx="8029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P</a:t>
            </a:r>
          </a:p>
        </p:txBody>
      </p:sp>
      <p:cxnSp>
        <p:nvCxnSpPr>
          <p:cNvPr id="613" name="Straight Arrow Connector 612">
            <a:extLst>
              <a:ext uri="{FF2B5EF4-FFF2-40B4-BE49-F238E27FC236}">
                <a16:creationId xmlns:a16="http://schemas.microsoft.com/office/drawing/2014/main" id="{668AEDE6-BD34-414E-A445-F3E816102BAE}"/>
              </a:ext>
            </a:extLst>
          </p:cNvPr>
          <p:cNvCxnSpPr>
            <a:cxnSpLocks/>
          </p:cNvCxnSpPr>
          <p:nvPr/>
        </p:nvCxnSpPr>
        <p:spPr>
          <a:xfrm>
            <a:off x="910469" y="8693304"/>
            <a:ext cx="43906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4" name="TextBox 613">
            <a:extLst>
              <a:ext uri="{FF2B5EF4-FFF2-40B4-BE49-F238E27FC236}">
                <a16:creationId xmlns:a16="http://schemas.microsoft.com/office/drawing/2014/main" id="{7185181C-A586-47F7-A180-7F4146A5F1FF}"/>
              </a:ext>
            </a:extLst>
          </p:cNvPr>
          <p:cNvSpPr txBox="1"/>
          <p:nvPr/>
        </p:nvSpPr>
        <p:spPr>
          <a:xfrm>
            <a:off x="819873" y="8687676"/>
            <a:ext cx="6202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riction cloning by </a:t>
            </a:r>
            <a:r>
              <a:rPr lang="en-US" sz="7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nd</a:t>
            </a: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 and </a:t>
            </a:r>
            <a:r>
              <a:rPr lang="en-US" sz="7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daI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5" name="TextBox 614">
            <a:extLst>
              <a:ext uri="{FF2B5EF4-FFF2-40B4-BE49-F238E27FC236}">
                <a16:creationId xmlns:a16="http://schemas.microsoft.com/office/drawing/2014/main" id="{83A37066-9476-4A74-9999-1DA7C24109A1}"/>
              </a:ext>
            </a:extLst>
          </p:cNvPr>
          <p:cNvSpPr txBox="1"/>
          <p:nvPr/>
        </p:nvSpPr>
        <p:spPr>
          <a:xfrm>
            <a:off x="1312684" y="8590815"/>
            <a:ext cx="6202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GEB31</a:t>
            </a:r>
          </a:p>
        </p:txBody>
      </p:sp>
      <p:cxnSp>
        <p:nvCxnSpPr>
          <p:cNvPr id="616" name="Straight Arrow Connector 615">
            <a:extLst>
              <a:ext uri="{FF2B5EF4-FFF2-40B4-BE49-F238E27FC236}">
                <a16:creationId xmlns:a16="http://schemas.microsoft.com/office/drawing/2014/main" id="{E4AD1C9F-9D6C-47A6-825F-BE08CEE793F2}"/>
              </a:ext>
            </a:extLst>
          </p:cNvPr>
          <p:cNvCxnSpPr>
            <a:cxnSpLocks/>
          </p:cNvCxnSpPr>
          <p:nvPr/>
        </p:nvCxnSpPr>
        <p:spPr>
          <a:xfrm>
            <a:off x="1866025" y="8687676"/>
            <a:ext cx="43906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3" name="TextBox 642">
            <a:extLst>
              <a:ext uri="{FF2B5EF4-FFF2-40B4-BE49-F238E27FC236}">
                <a16:creationId xmlns:a16="http://schemas.microsoft.com/office/drawing/2014/main" id="{E552B12B-5C0D-4182-A966-B3F42746E815}"/>
              </a:ext>
            </a:extLst>
          </p:cNvPr>
          <p:cNvSpPr txBox="1"/>
          <p:nvPr/>
        </p:nvSpPr>
        <p:spPr>
          <a:xfrm>
            <a:off x="399737" y="6042807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645" name="Group 644">
            <a:extLst>
              <a:ext uri="{FF2B5EF4-FFF2-40B4-BE49-F238E27FC236}">
                <a16:creationId xmlns:a16="http://schemas.microsoft.com/office/drawing/2014/main" id="{1D4D93B5-7645-4875-BF79-6CC90BA1E338}"/>
              </a:ext>
            </a:extLst>
          </p:cNvPr>
          <p:cNvGrpSpPr/>
          <p:nvPr/>
        </p:nvGrpSpPr>
        <p:grpSpPr>
          <a:xfrm>
            <a:off x="2229374" y="8118352"/>
            <a:ext cx="1472218" cy="1054646"/>
            <a:chOff x="2229374" y="8118352"/>
            <a:chExt cx="1472218" cy="1054646"/>
          </a:xfrm>
        </p:grpSpPr>
        <p:grpSp>
          <p:nvGrpSpPr>
            <p:cNvPr id="641" name="Group 640">
              <a:extLst>
                <a:ext uri="{FF2B5EF4-FFF2-40B4-BE49-F238E27FC236}">
                  <a16:creationId xmlns:a16="http://schemas.microsoft.com/office/drawing/2014/main" id="{E52F4D47-0A05-4971-AAEB-BCFD0633B26F}"/>
                </a:ext>
              </a:extLst>
            </p:cNvPr>
            <p:cNvGrpSpPr/>
            <p:nvPr/>
          </p:nvGrpSpPr>
          <p:grpSpPr>
            <a:xfrm>
              <a:off x="2229374" y="8118352"/>
              <a:ext cx="1472218" cy="1054646"/>
              <a:chOff x="2229374" y="8118352"/>
              <a:chExt cx="1472218" cy="1054646"/>
            </a:xfrm>
          </p:grpSpPr>
          <p:grpSp>
            <p:nvGrpSpPr>
              <p:cNvPr id="639" name="Group 638">
                <a:extLst>
                  <a:ext uri="{FF2B5EF4-FFF2-40B4-BE49-F238E27FC236}">
                    <a16:creationId xmlns:a16="http://schemas.microsoft.com/office/drawing/2014/main" id="{3E70AA0F-B87C-4963-A7C6-92C188A0E224}"/>
                  </a:ext>
                </a:extLst>
              </p:cNvPr>
              <p:cNvGrpSpPr/>
              <p:nvPr/>
            </p:nvGrpSpPr>
            <p:grpSpPr>
              <a:xfrm>
                <a:off x="2229374" y="8118352"/>
                <a:ext cx="1472218" cy="1054646"/>
                <a:chOff x="2229374" y="8118352"/>
                <a:chExt cx="1472218" cy="1054646"/>
              </a:xfrm>
            </p:grpSpPr>
            <p:grpSp>
              <p:nvGrpSpPr>
                <p:cNvPr id="633" name="Group 632">
                  <a:extLst>
                    <a:ext uri="{FF2B5EF4-FFF2-40B4-BE49-F238E27FC236}">
                      <a16:creationId xmlns:a16="http://schemas.microsoft.com/office/drawing/2014/main" id="{08CE87D2-249B-416E-ABED-D019F5FFC2E9}"/>
                    </a:ext>
                  </a:extLst>
                </p:cNvPr>
                <p:cNvGrpSpPr/>
                <p:nvPr/>
              </p:nvGrpSpPr>
              <p:grpSpPr>
                <a:xfrm>
                  <a:off x="2229374" y="8118352"/>
                  <a:ext cx="1472218" cy="1054646"/>
                  <a:chOff x="2229374" y="8118352"/>
                  <a:chExt cx="1472218" cy="1054646"/>
                </a:xfrm>
              </p:grpSpPr>
              <p:grpSp>
                <p:nvGrpSpPr>
                  <p:cNvPr id="627" name="Group 626">
                    <a:extLst>
                      <a:ext uri="{FF2B5EF4-FFF2-40B4-BE49-F238E27FC236}">
                        <a16:creationId xmlns:a16="http://schemas.microsoft.com/office/drawing/2014/main" id="{070900C1-1160-4B9C-BA1F-F597F2CDDC74}"/>
                      </a:ext>
                    </a:extLst>
                  </p:cNvPr>
                  <p:cNvGrpSpPr/>
                  <p:nvPr/>
                </p:nvGrpSpPr>
                <p:grpSpPr>
                  <a:xfrm>
                    <a:off x="2229374" y="8284849"/>
                    <a:ext cx="1472218" cy="888149"/>
                    <a:chOff x="2229374" y="8284849"/>
                    <a:chExt cx="1472218" cy="888149"/>
                  </a:xfrm>
                </p:grpSpPr>
                <p:grpSp>
                  <p:nvGrpSpPr>
                    <p:cNvPr id="619" name="Group 618">
                      <a:extLst>
                        <a:ext uri="{FF2B5EF4-FFF2-40B4-BE49-F238E27FC236}">
                          <a16:creationId xmlns:a16="http://schemas.microsoft.com/office/drawing/2014/main" id="{45ABB0CB-AE02-4980-A668-2F8717717AC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497608" y="8284849"/>
                      <a:ext cx="888779" cy="888149"/>
                      <a:chOff x="2851655" y="8564962"/>
                      <a:chExt cx="754428" cy="645934"/>
                    </a:xfrm>
                  </p:grpSpPr>
                  <p:sp>
                    <p:nvSpPr>
                      <p:cNvPr id="617" name="Flowchart: Connector 616">
                        <a:extLst>
                          <a:ext uri="{FF2B5EF4-FFF2-40B4-BE49-F238E27FC236}">
                            <a16:creationId xmlns:a16="http://schemas.microsoft.com/office/drawing/2014/main" id="{337402D2-4DE5-4BC8-9B0B-1881C1AC605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51655" y="8564962"/>
                        <a:ext cx="754428" cy="645934"/>
                      </a:xfrm>
                      <a:prstGeom prst="flowChartConnector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618" name="Flowchart: Connector 617">
                        <a:extLst>
                          <a:ext uri="{FF2B5EF4-FFF2-40B4-BE49-F238E27FC236}">
                            <a16:creationId xmlns:a16="http://schemas.microsoft.com/office/drawing/2014/main" id="{4462DD7A-5121-4EB3-AEE4-D7FF85B20CC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904244" y="8602914"/>
                        <a:ext cx="648699" cy="554100"/>
                      </a:xfrm>
                      <a:prstGeom prst="flowChartConnector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625" name="TextBox 624">
                      <a:extLst>
                        <a:ext uri="{FF2B5EF4-FFF2-40B4-BE49-F238E27FC236}">
                          <a16:creationId xmlns:a16="http://schemas.microsoft.com/office/drawing/2014/main" id="{0187BF5A-9135-43AF-8C20-42D8E8CF6C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29374" y="8368486"/>
                      <a:ext cx="434601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nd</a:t>
                      </a:r>
                      <a:r>
                        <a:rPr lang="en-US" sz="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I</a:t>
                      </a:r>
                      <a:endPara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26" name="TextBox 625">
                      <a:extLst>
                        <a:ext uri="{FF2B5EF4-FFF2-40B4-BE49-F238E27FC236}">
                          <a16:creationId xmlns:a16="http://schemas.microsoft.com/office/drawing/2014/main" id="{684D707B-7BC6-49B8-B63C-12CA5C18D4E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66991" y="8363362"/>
                      <a:ext cx="434601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b="1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a</a:t>
                      </a:r>
                      <a:r>
                        <a:rPr lang="en-US" sz="5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632" name="TextBox 631">
                    <a:extLst>
                      <a:ext uri="{FF2B5EF4-FFF2-40B4-BE49-F238E27FC236}">
                        <a16:creationId xmlns:a16="http://schemas.microsoft.com/office/drawing/2014/main" id="{B63FF293-4EE4-4E27-B945-BD4A15E52952}"/>
                      </a:ext>
                    </a:extLst>
                  </p:cNvPr>
                  <p:cNvSpPr txBox="1"/>
                  <p:nvPr/>
                </p:nvSpPr>
                <p:spPr>
                  <a:xfrm>
                    <a:off x="2527792" y="8118352"/>
                    <a:ext cx="80293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DP</a:t>
                    </a:r>
                  </a:p>
                </p:txBody>
              </p:sp>
            </p:grpSp>
            <p:cxnSp>
              <p:nvCxnSpPr>
                <p:cNvPr id="635" name="Straight Connector 634">
                  <a:extLst>
                    <a:ext uri="{FF2B5EF4-FFF2-40B4-BE49-F238E27FC236}">
                      <a16:creationId xmlns:a16="http://schemas.microsoft.com/office/drawing/2014/main" id="{EC1E8C7F-A4E9-4C6F-8901-82D9D8EC956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451664" y="8726149"/>
                  <a:ext cx="166367" cy="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6" name="Straight Connector 635">
                  <a:extLst>
                    <a:ext uri="{FF2B5EF4-FFF2-40B4-BE49-F238E27FC236}">
                      <a16:creationId xmlns:a16="http://schemas.microsoft.com/office/drawing/2014/main" id="{F6554BF5-6CFE-4297-B6BA-24F2DC591D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282567" y="8705397"/>
                  <a:ext cx="166367" cy="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7" name="TextBox 636">
                  <a:extLst>
                    <a:ext uri="{FF2B5EF4-FFF2-40B4-BE49-F238E27FC236}">
                      <a16:creationId xmlns:a16="http://schemas.microsoft.com/office/drawing/2014/main" id="{EE797A9B-57DA-4E60-B30B-EEA6096D75D4}"/>
                    </a:ext>
                  </a:extLst>
                </p:cNvPr>
                <p:cNvSpPr txBox="1"/>
                <p:nvPr/>
              </p:nvSpPr>
              <p:spPr>
                <a:xfrm>
                  <a:off x="2265288" y="8637308"/>
                  <a:ext cx="290294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B</a:t>
                  </a:r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8" name="TextBox 637">
                  <a:extLst>
                    <a:ext uri="{FF2B5EF4-FFF2-40B4-BE49-F238E27FC236}">
                      <a16:creationId xmlns:a16="http://schemas.microsoft.com/office/drawing/2014/main" id="{28F3D1E2-C0CB-4B2F-891A-A96EFA3CD20B}"/>
                    </a:ext>
                  </a:extLst>
                </p:cNvPr>
                <p:cNvSpPr txBox="1"/>
                <p:nvPr/>
              </p:nvSpPr>
              <p:spPr>
                <a:xfrm>
                  <a:off x="3370977" y="8620657"/>
                  <a:ext cx="290294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B</a:t>
                  </a:r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40" name="TextBox 639">
                <a:extLst>
                  <a:ext uri="{FF2B5EF4-FFF2-40B4-BE49-F238E27FC236}">
                    <a16:creationId xmlns:a16="http://schemas.microsoft.com/office/drawing/2014/main" id="{0AD197C4-0F2C-4A63-B0ED-CF98A60C5923}"/>
                  </a:ext>
                </a:extLst>
              </p:cNvPr>
              <p:cNvSpPr txBox="1"/>
              <p:nvPr/>
            </p:nvSpPr>
            <p:spPr>
              <a:xfrm>
                <a:off x="2548986" y="8646909"/>
                <a:ext cx="80293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DDP</a:t>
                </a:r>
              </a:p>
            </p:txBody>
          </p:sp>
        </p:grpSp>
        <p:sp>
          <p:nvSpPr>
            <p:cNvPr id="644" name="Freeform: Shape 643">
              <a:extLst>
                <a:ext uri="{FF2B5EF4-FFF2-40B4-BE49-F238E27FC236}">
                  <a16:creationId xmlns:a16="http://schemas.microsoft.com/office/drawing/2014/main" id="{79FC2CCF-0D60-4FBD-BD8F-02EC23FAEBBB}"/>
                </a:ext>
              </a:extLst>
            </p:cNvPr>
            <p:cNvSpPr/>
            <p:nvPr/>
          </p:nvSpPr>
          <p:spPr>
            <a:xfrm>
              <a:off x="2527791" y="8281047"/>
              <a:ext cx="817171" cy="293425"/>
            </a:xfrm>
            <a:custGeom>
              <a:avLst/>
              <a:gdLst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43971 w 777394"/>
                <a:gd name="connsiteY96" fmla="*/ 7726 h 285901"/>
                <a:gd name="connsiteX97" fmla="*/ 432541 w 777394"/>
                <a:gd name="connsiteY97" fmla="*/ 5821 h 285901"/>
                <a:gd name="connsiteX98" fmla="*/ 415396 w 777394"/>
                <a:gd name="connsiteY98" fmla="*/ 3916 h 285901"/>
                <a:gd name="connsiteX99" fmla="*/ 365866 w 777394"/>
                <a:gd name="connsiteY99" fmla="*/ 106 h 285901"/>
                <a:gd name="connsiteX100" fmla="*/ 306811 w 777394"/>
                <a:gd name="connsiteY100" fmla="*/ 2011 h 285901"/>
                <a:gd name="connsiteX101" fmla="*/ 297286 w 777394"/>
                <a:gd name="connsiteY101" fmla="*/ 3916 h 285901"/>
                <a:gd name="connsiteX102" fmla="*/ 282046 w 777394"/>
                <a:gd name="connsiteY102" fmla="*/ 5821 h 285901"/>
                <a:gd name="connsiteX103" fmla="*/ 274426 w 777394"/>
                <a:gd name="connsiteY103" fmla="*/ 9631 h 285901"/>
                <a:gd name="connsiteX104" fmla="*/ 268711 w 777394"/>
                <a:gd name="connsiteY104" fmla="*/ 11536 h 285901"/>
                <a:gd name="connsiteX105" fmla="*/ 247756 w 777394"/>
                <a:gd name="connsiteY105" fmla="*/ 17251 h 285901"/>
                <a:gd name="connsiteX106" fmla="*/ 232516 w 777394"/>
                <a:gd name="connsiteY106" fmla="*/ 26776 h 285901"/>
                <a:gd name="connsiteX107" fmla="*/ 224896 w 777394"/>
                <a:gd name="connsiteY107" fmla="*/ 30586 h 285901"/>
                <a:gd name="connsiteX108" fmla="*/ 219181 w 777394"/>
                <a:gd name="connsiteY108" fmla="*/ 34396 h 285901"/>
                <a:gd name="connsiteX109" fmla="*/ 213466 w 777394"/>
                <a:gd name="connsiteY109" fmla="*/ 36301 h 285901"/>
                <a:gd name="connsiteX110" fmla="*/ 203941 w 777394"/>
                <a:gd name="connsiteY110" fmla="*/ 40111 h 285901"/>
                <a:gd name="connsiteX111" fmla="*/ 202036 w 777394"/>
                <a:gd name="connsiteY111" fmla="*/ 45826 h 285901"/>
                <a:gd name="connsiteX112" fmla="*/ 188701 w 777394"/>
                <a:gd name="connsiteY112" fmla="*/ 53446 h 285901"/>
                <a:gd name="connsiteX113" fmla="*/ 169651 w 777394"/>
                <a:gd name="connsiteY113" fmla="*/ 70591 h 285901"/>
                <a:gd name="connsiteX114" fmla="*/ 163936 w 777394"/>
                <a:gd name="connsiteY114" fmla="*/ 72496 h 285901"/>
                <a:gd name="connsiteX115" fmla="*/ 148696 w 777394"/>
                <a:gd name="connsiteY115" fmla="*/ 83926 h 285901"/>
                <a:gd name="connsiteX116" fmla="*/ 141076 w 777394"/>
                <a:gd name="connsiteY116" fmla="*/ 85831 h 285901"/>
                <a:gd name="connsiteX117" fmla="*/ 129646 w 777394"/>
                <a:gd name="connsiteY117" fmla="*/ 95356 h 285901"/>
                <a:gd name="connsiteX118" fmla="*/ 114406 w 777394"/>
                <a:gd name="connsiteY118" fmla="*/ 102976 h 285901"/>
                <a:gd name="connsiteX119" fmla="*/ 110596 w 777394"/>
                <a:gd name="connsiteY119" fmla="*/ 108691 h 285901"/>
                <a:gd name="connsiteX120" fmla="*/ 93451 w 777394"/>
                <a:gd name="connsiteY120" fmla="*/ 125836 h 285901"/>
                <a:gd name="connsiteX121" fmla="*/ 61066 w 777394"/>
                <a:gd name="connsiteY121" fmla="*/ 158221 h 285901"/>
                <a:gd name="connsiteX122" fmla="*/ 49636 w 777394"/>
                <a:gd name="connsiteY122" fmla="*/ 169651 h 285901"/>
                <a:gd name="connsiteX123" fmla="*/ 42016 w 777394"/>
                <a:gd name="connsiteY123" fmla="*/ 177271 h 285901"/>
                <a:gd name="connsiteX124" fmla="*/ 36301 w 777394"/>
                <a:gd name="connsiteY124" fmla="*/ 184891 h 285901"/>
                <a:gd name="connsiteX125" fmla="*/ 34396 w 777394"/>
                <a:gd name="connsiteY125" fmla="*/ 190606 h 285901"/>
                <a:gd name="connsiteX126" fmla="*/ 26776 w 777394"/>
                <a:gd name="connsiteY126" fmla="*/ 203941 h 285901"/>
                <a:gd name="connsiteX127" fmla="*/ 19156 w 777394"/>
                <a:gd name="connsiteY127" fmla="*/ 217276 h 285901"/>
                <a:gd name="connsiteX128" fmla="*/ 15346 w 777394"/>
                <a:gd name="connsiteY128" fmla="*/ 226801 h 285901"/>
                <a:gd name="connsiteX129" fmla="*/ 11536 w 777394"/>
                <a:gd name="connsiteY129" fmla="*/ 232516 h 285901"/>
                <a:gd name="connsiteX130" fmla="*/ 7726 w 777394"/>
                <a:gd name="connsiteY130" fmla="*/ 245851 h 285901"/>
                <a:gd name="connsiteX131" fmla="*/ 5821 w 777394"/>
                <a:gd name="connsiteY131" fmla="*/ 251566 h 285901"/>
                <a:gd name="connsiteX132" fmla="*/ 106 w 777394"/>
                <a:gd name="connsiteY132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43971 w 777394"/>
                <a:gd name="connsiteY96" fmla="*/ 7726 h 285901"/>
                <a:gd name="connsiteX97" fmla="*/ 415396 w 777394"/>
                <a:gd name="connsiteY97" fmla="*/ 3916 h 285901"/>
                <a:gd name="connsiteX98" fmla="*/ 365866 w 777394"/>
                <a:gd name="connsiteY98" fmla="*/ 106 h 285901"/>
                <a:gd name="connsiteX99" fmla="*/ 306811 w 777394"/>
                <a:gd name="connsiteY99" fmla="*/ 2011 h 285901"/>
                <a:gd name="connsiteX100" fmla="*/ 297286 w 777394"/>
                <a:gd name="connsiteY100" fmla="*/ 3916 h 285901"/>
                <a:gd name="connsiteX101" fmla="*/ 282046 w 777394"/>
                <a:gd name="connsiteY101" fmla="*/ 5821 h 285901"/>
                <a:gd name="connsiteX102" fmla="*/ 274426 w 777394"/>
                <a:gd name="connsiteY102" fmla="*/ 9631 h 285901"/>
                <a:gd name="connsiteX103" fmla="*/ 268711 w 777394"/>
                <a:gd name="connsiteY103" fmla="*/ 11536 h 285901"/>
                <a:gd name="connsiteX104" fmla="*/ 247756 w 777394"/>
                <a:gd name="connsiteY104" fmla="*/ 17251 h 285901"/>
                <a:gd name="connsiteX105" fmla="*/ 232516 w 777394"/>
                <a:gd name="connsiteY105" fmla="*/ 26776 h 285901"/>
                <a:gd name="connsiteX106" fmla="*/ 224896 w 777394"/>
                <a:gd name="connsiteY106" fmla="*/ 30586 h 285901"/>
                <a:gd name="connsiteX107" fmla="*/ 219181 w 777394"/>
                <a:gd name="connsiteY107" fmla="*/ 34396 h 285901"/>
                <a:gd name="connsiteX108" fmla="*/ 213466 w 777394"/>
                <a:gd name="connsiteY108" fmla="*/ 36301 h 285901"/>
                <a:gd name="connsiteX109" fmla="*/ 203941 w 777394"/>
                <a:gd name="connsiteY109" fmla="*/ 40111 h 285901"/>
                <a:gd name="connsiteX110" fmla="*/ 202036 w 777394"/>
                <a:gd name="connsiteY110" fmla="*/ 45826 h 285901"/>
                <a:gd name="connsiteX111" fmla="*/ 188701 w 777394"/>
                <a:gd name="connsiteY111" fmla="*/ 53446 h 285901"/>
                <a:gd name="connsiteX112" fmla="*/ 169651 w 777394"/>
                <a:gd name="connsiteY112" fmla="*/ 70591 h 285901"/>
                <a:gd name="connsiteX113" fmla="*/ 163936 w 777394"/>
                <a:gd name="connsiteY113" fmla="*/ 72496 h 285901"/>
                <a:gd name="connsiteX114" fmla="*/ 148696 w 777394"/>
                <a:gd name="connsiteY114" fmla="*/ 83926 h 285901"/>
                <a:gd name="connsiteX115" fmla="*/ 141076 w 777394"/>
                <a:gd name="connsiteY115" fmla="*/ 85831 h 285901"/>
                <a:gd name="connsiteX116" fmla="*/ 129646 w 777394"/>
                <a:gd name="connsiteY116" fmla="*/ 95356 h 285901"/>
                <a:gd name="connsiteX117" fmla="*/ 114406 w 777394"/>
                <a:gd name="connsiteY117" fmla="*/ 102976 h 285901"/>
                <a:gd name="connsiteX118" fmla="*/ 110596 w 777394"/>
                <a:gd name="connsiteY118" fmla="*/ 108691 h 285901"/>
                <a:gd name="connsiteX119" fmla="*/ 93451 w 777394"/>
                <a:gd name="connsiteY119" fmla="*/ 125836 h 285901"/>
                <a:gd name="connsiteX120" fmla="*/ 61066 w 777394"/>
                <a:gd name="connsiteY120" fmla="*/ 158221 h 285901"/>
                <a:gd name="connsiteX121" fmla="*/ 49636 w 777394"/>
                <a:gd name="connsiteY121" fmla="*/ 169651 h 285901"/>
                <a:gd name="connsiteX122" fmla="*/ 42016 w 777394"/>
                <a:gd name="connsiteY122" fmla="*/ 177271 h 285901"/>
                <a:gd name="connsiteX123" fmla="*/ 36301 w 777394"/>
                <a:gd name="connsiteY123" fmla="*/ 184891 h 285901"/>
                <a:gd name="connsiteX124" fmla="*/ 34396 w 777394"/>
                <a:gd name="connsiteY124" fmla="*/ 190606 h 285901"/>
                <a:gd name="connsiteX125" fmla="*/ 26776 w 777394"/>
                <a:gd name="connsiteY125" fmla="*/ 203941 h 285901"/>
                <a:gd name="connsiteX126" fmla="*/ 19156 w 777394"/>
                <a:gd name="connsiteY126" fmla="*/ 217276 h 285901"/>
                <a:gd name="connsiteX127" fmla="*/ 15346 w 777394"/>
                <a:gd name="connsiteY127" fmla="*/ 226801 h 285901"/>
                <a:gd name="connsiteX128" fmla="*/ 11536 w 777394"/>
                <a:gd name="connsiteY128" fmla="*/ 232516 h 285901"/>
                <a:gd name="connsiteX129" fmla="*/ 7726 w 777394"/>
                <a:gd name="connsiteY129" fmla="*/ 245851 h 285901"/>
                <a:gd name="connsiteX130" fmla="*/ 5821 w 777394"/>
                <a:gd name="connsiteY130" fmla="*/ 251566 h 285901"/>
                <a:gd name="connsiteX131" fmla="*/ 106 w 777394"/>
                <a:gd name="connsiteY131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97286 w 777394"/>
                <a:gd name="connsiteY99" fmla="*/ 3916 h 285901"/>
                <a:gd name="connsiteX100" fmla="*/ 282046 w 777394"/>
                <a:gd name="connsiteY100" fmla="*/ 5821 h 285901"/>
                <a:gd name="connsiteX101" fmla="*/ 274426 w 777394"/>
                <a:gd name="connsiteY101" fmla="*/ 9631 h 285901"/>
                <a:gd name="connsiteX102" fmla="*/ 268711 w 777394"/>
                <a:gd name="connsiteY102" fmla="*/ 11536 h 285901"/>
                <a:gd name="connsiteX103" fmla="*/ 247756 w 777394"/>
                <a:gd name="connsiteY103" fmla="*/ 17251 h 285901"/>
                <a:gd name="connsiteX104" fmla="*/ 232516 w 777394"/>
                <a:gd name="connsiteY104" fmla="*/ 26776 h 285901"/>
                <a:gd name="connsiteX105" fmla="*/ 224896 w 777394"/>
                <a:gd name="connsiteY105" fmla="*/ 30586 h 285901"/>
                <a:gd name="connsiteX106" fmla="*/ 219181 w 777394"/>
                <a:gd name="connsiteY106" fmla="*/ 34396 h 285901"/>
                <a:gd name="connsiteX107" fmla="*/ 213466 w 777394"/>
                <a:gd name="connsiteY107" fmla="*/ 36301 h 285901"/>
                <a:gd name="connsiteX108" fmla="*/ 203941 w 777394"/>
                <a:gd name="connsiteY108" fmla="*/ 40111 h 285901"/>
                <a:gd name="connsiteX109" fmla="*/ 202036 w 777394"/>
                <a:gd name="connsiteY109" fmla="*/ 45826 h 285901"/>
                <a:gd name="connsiteX110" fmla="*/ 188701 w 777394"/>
                <a:gd name="connsiteY110" fmla="*/ 53446 h 285901"/>
                <a:gd name="connsiteX111" fmla="*/ 169651 w 777394"/>
                <a:gd name="connsiteY111" fmla="*/ 70591 h 285901"/>
                <a:gd name="connsiteX112" fmla="*/ 163936 w 777394"/>
                <a:gd name="connsiteY112" fmla="*/ 72496 h 285901"/>
                <a:gd name="connsiteX113" fmla="*/ 148696 w 777394"/>
                <a:gd name="connsiteY113" fmla="*/ 83926 h 285901"/>
                <a:gd name="connsiteX114" fmla="*/ 141076 w 777394"/>
                <a:gd name="connsiteY114" fmla="*/ 85831 h 285901"/>
                <a:gd name="connsiteX115" fmla="*/ 129646 w 777394"/>
                <a:gd name="connsiteY115" fmla="*/ 95356 h 285901"/>
                <a:gd name="connsiteX116" fmla="*/ 114406 w 777394"/>
                <a:gd name="connsiteY116" fmla="*/ 102976 h 285901"/>
                <a:gd name="connsiteX117" fmla="*/ 110596 w 777394"/>
                <a:gd name="connsiteY117" fmla="*/ 108691 h 285901"/>
                <a:gd name="connsiteX118" fmla="*/ 93451 w 777394"/>
                <a:gd name="connsiteY118" fmla="*/ 125836 h 285901"/>
                <a:gd name="connsiteX119" fmla="*/ 61066 w 777394"/>
                <a:gd name="connsiteY119" fmla="*/ 158221 h 285901"/>
                <a:gd name="connsiteX120" fmla="*/ 49636 w 777394"/>
                <a:gd name="connsiteY120" fmla="*/ 169651 h 285901"/>
                <a:gd name="connsiteX121" fmla="*/ 42016 w 777394"/>
                <a:gd name="connsiteY121" fmla="*/ 177271 h 285901"/>
                <a:gd name="connsiteX122" fmla="*/ 36301 w 777394"/>
                <a:gd name="connsiteY122" fmla="*/ 184891 h 285901"/>
                <a:gd name="connsiteX123" fmla="*/ 34396 w 777394"/>
                <a:gd name="connsiteY123" fmla="*/ 190606 h 285901"/>
                <a:gd name="connsiteX124" fmla="*/ 26776 w 777394"/>
                <a:gd name="connsiteY124" fmla="*/ 203941 h 285901"/>
                <a:gd name="connsiteX125" fmla="*/ 19156 w 777394"/>
                <a:gd name="connsiteY125" fmla="*/ 217276 h 285901"/>
                <a:gd name="connsiteX126" fmla="*/ 15346 w 777394"/>
                <a:gd name="connsiteY126" fmla="*/ 226801 h 285901"/>
                <a:gd name="connsiteX127" fmla="*/ 11536 w 777394"/>
                <a:gd name="connsiteY127" fmla="*/ 232516 h 285901"/>
                <a:gd name="connsiteX128" fmla="*/ 7726 w 777394"/>
                <a:gd name="connsiteY128" fmla="*/ 245851 h 285901"/>
                <a:gd name="connsiteX129" fmla="*/ 5821 w 777394"/>
                <a:gd name="connsiteY129" fmla="*/ 251566 h 285901"/>
                <a:gd name="connsiteX130" fmla="*/ 106 w 777394"/>
                <a:gd name="connsiteY130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97286 w 777394"/>
                <a:gd name="connsiteY99" fmla="*/ 3916 h 285901"/>
                <a:gd name="connsiteX100" fmla="*/ 274426 w 777394"/>
                <a:gd name="connsiteY100" fmla="*/ 9631 h 285901"/>
                <a:gd name="connsiteX101" fmla="*/ 268711 w 777394"/>
                <a:gd name="connsiteY101" fmla="*/ 11536 h 285901"/>
                <a:gd name="connsiteX102" fmla="*/ 247756 w 777394"/>
                <a:gd name="connsiteY102" fmla="*/ 17251 h 285901"/>
                <a:gd name="connsiteX103" fmla="*/ 232516 w 777394"/>
                <a:gd name="connsiteY103" fmla="*/ 26776 h 285901"/>
                <a:gd name="connsiteX104" fmla="*/ 224896 w 777394"/>
                <a:gd name="connsiteY104" fmla="*/ 30586 h 285901"/>
                <a:gd name="connsiteX105" fmla="*/ 219181 w 777394"/>
                <a:gd name="connsiteY105" fmla="*/ 34396 h 285901"/>
                <a:gd name="connsiteX106" fmla="*/ 213466 w 777394"/>
                <a:gd name="connsiteY106" fmla="*/ 36301 h 285901"/>
                <a:gd name="connsiteX107" fmla="*/ 203941 w 777394"/>
                <a:gd name="connsiteY107" fmla="*/ 40111 h 285901"/>
                <a:gd name="connsiteX108" fmla="*/ 202036 w 777394"/>
                <a:gd name="connsiteY108" fmla="*/ 45826 h 285901"/>
                <a:gd name="connsiteX109" fmla="*/ 188701 w 777394"/>
                <a:gd name="connsiteY109" fmla="*/ 53446 h 285901"/>
                <a:gd name="connsiteX110" fmla="*/ 169651 w 777394"/>
                <a:gd name="connsiteY110" fmla="*/ 70591 h 285901"/>
                <a:gd name="connsiteX111" fmla="*/ 163936 w 777394"/>
                <a:gd name="connsiteY111" fmla="*/ 72496 h 285901"/>
                <a:gd name="connsiteX112" fmla="*/ 148696 w 777394"/>
                <a:gd name="connsiteY112" fmla="*/ 83926 h 285901"/>
                <a:gd name="connsiteX113" fmla="*/ 141076 w 777394"/>
                <a:gd name="connsiteY113" fmla="*/ 85831 h 285901"/>
                <a:gd name="connsiteX114" fmla="*/ 129646 w 777394"/>
                <a:gd name="connsiteY114" fmla="*/ 95356 h 285901"/>
                <a:gd name="connsiteX115" fmla="*/ 114406 w 777394"/>
                <a:gd name="connsiteY115" fmla="*/ 102976 h 285901"/>
                <a:gd name="connsiteX116" fmla="*/ 110596 w 777394"/>
                <a:gd name="connsiteY116" fmla="*/ 108691 h 285901"/>
                <a:gd name="connsiteX117" fmla="*/ 93451 w 777394"/>
                <a:gd name="connsiteY117" fmla="*/ 125836 h 285901"/>
                <a:gd name="connsiteX118" fmla="*/ 61066 w 777394"/>
                <a:gd name="connsiteY118" fmla="*/ 158221 h 285901"/>
                <a:gd name="connsiteX119" fmla="*/ 49636 w 777394"/>
                <a:gd name="connsiteY119" fmla="*/ 169651 h 285901"/>
                <a:gd name="connsiteX120" fmla="*/ 42016 w 777394"/>
                <a:gd name="connsiteY120" fmla="*/ 177271 h 285901"/>
                <a:gd name="connsiteX121" fmla="*/ 36301 w 777394"/>
                <a:gd name="connsiteY121" fmla="*/ 184891 h 285901"/>
                <a:gd name="connsiteX122" fmla="*/ 34396 w 777394"/>
                <a:gd name="connsiteY122" fmla="*/ 190606 h 285901"/>
                <a:gd name="connsiteX123" fmla="*/ 26776 w 777394"/>
                <a:gd name="connsiteY123" fmla="*/ 203941 h 285901"/>
                <a:gd name="connsiteX124" fmla="*/ 19156 w 777394"/>
                <a:gd name="connsiteY124" fmla="*/ 217276 h 285901"/>
                <a:gd name="connsiteX125" fmla="*/ 15346 w 777394"/>
                <a:gd name="connsiteY125" fmla="*/ 226801 h 285901"/>
                <a:gd name="connsiteX126" fmla="*/ 11536 w 777394"/>
                <a:gd name="connsiteY126" fmla="*/ 232516 h 285901"/>
                <a:gd name="connsiteX127" fmla="*/ 7726 w 777394"/>
                <a:gd name="connsiteY127" fmla="*/ 245851 h 285901"/>
                <a:gd name="connsiteX128" fmla="*/ 5821 w 777394"/>
                <a:gd name="connsiteY128" fmla="*/ 251566 h 285901"/>
                <a:gd name="connsiteX129" fmla="*/ 106 w 777394"/>
                <a:gd name="connsiteY129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68711 w 777394"/>
                <a:gd name="connsiteY100" fmla="*/ 11536 h 285901"/>
                <a:gd name="connsiteX101" fmla="*/ 247756 w 777394"/>
                <a:gd name="connsiteY101" fmla="*/ 17251 h 285901"/>
                <a:gd name="connsiteX102" fmla="*/ 232516 w 777394"/>
                <a:gd name="connsiteY102" fmla="*/ 26776 h 285901"/>
                <a:gd name="connsiteX103" fmla="*/ 224896 w 777394"/>
                <a:gd name="connsiteY103" fmla="*/ 30586 h 285901"/>
                <a:gd name="connsiteX104" fmla="*/ 219181 w 777394"/>
                <a:gd name="connsiteY104" fmla="*/ 34396 h 285901"/>
                <a:gd name="connsiteX105" fmla="*/ 213466 w 777394"/>
                <a:gd name="connsiteY105" fmla="*/ 36301 h 285901"/>
                <a:gd name="connsiteX106" fmla="*/ 203941 w 777394"/>
                <a:gd name="connsiteY106" fmla="*/ 40111 h 285901"/>
                <a:gd name="connsiteX107" fmla="*/ 202036 w 777394"/>
                <a:gd name="connsiteY107" fmla="*/ 45826 h 285901"/>
                <a:gd name="connsiteX108" fmla="*/ 188701 w 777394"/>
                <a:gd name="connsiteY108" fmla="*/ 53446 h 285901"/>
                <a:gd name="connsiteX109" fmla="*/ 169651 w 777394"/>
                <a:gd name="connsiteY109" fmla="*/ 70591 h 285901"/>
                <a:gd name="connsiteX110" fmla="*/ 163936 w 777394"/>
                <a:gd name="connsiteY110" fmla="*/ 72496 h 285901"/>
                <a:gd name="connsiteX111" fmla="*/ 148696 w 777394"/>
                <a:gd name="connsiteY111" fmla="*/ 83926 h 285901"/>
                <a:gd name="connsiteX112" fmla="*/ 141076 w 777394"/>
                <a:gd name="connsiteY112" fmla="*/ 85831 h 285901"/>
                <a:gd name="connsiteX113" fmla="*/ 129646 w 777394"/>
                <a:gd name="connsiteY113" fmla="*/ 95356 h 285901"/>
                <a:gd name="connsiteX114" fmla="*/ 114406 w 777394"/>
                <a:gd name="connsiteY114" fmla="*/ 102976 h 285901"/>
                <a:gd name="connsiteX115" fmla="*/ 110596 w 777394"/>
                <a:gd name="connsiteY115" fmla="*/ 108691 h 285901"/>
                <a:gd name="connsiteX116" fmla="*/ 93451 w 777394"/>
                <a:gd name="connsiteY116" fmla="*/ 125836 h 285901"/>
                <a:gd name="connsiteX117" fmla="*/ 61066 w 777394"/>
                <a:gd name="connsiteY117" fmla="*/ 158221 h 285901"/>
                <a:gd name="connsiteX118" fmla="*/ 49636 w 777394"/>
                <a:gd name="connsiteY118" fmla="*/ 169651 h 285901"/>
                <a:gd name="connsiteX119" fmla="*/ 42016 w 777394"/>
                <a:gd name="connsiteY119" fmla="*/ 177271 h 285901"/>
                <a:gd name="connsiteX120" fmla="*/ 36301 w 777394"/>
                <a:gd name="connsiteY120" fmla="*/ 184891 h 285901"/>
                <a:gd name="connsiteX121" fmla="*/ 34396 w 777394"/>
                <a:gd name="connsiteY121" fmla="*/ 190606 h 285901"/>
                <a:gd name="connsiteX122" fmla="*/ 26776 w 777394"/>
                <a:gd name="connsiteY122" fmla="*/ 203941 h 285901"/>
                <a:gd name="connsiteX123" fmla="*/ 19156 w 777394"/>
                <a:gd name="connsiteY123" fmla="*/ 217276 h 285901"/>
                <a:gd name="connsiteX124" fmla="*/ 15346 w 777394"/>
                <a:gd name="connsiteY124" fmla="*/ 226801 h 285901"/>
                <a:gd name="connsiteX125" fmla="*/ 11536 w 777394"/>
                <a:gd name="connsiteY125" fmla="*/ 232516 h 285901"/>
                <a:gd name="connsiteX126" fmla="*/ 7726 w 777394"/>
                <a:gd name="connsiteY126" fmla="*/ 245851 h 285901"/>
                <a:gd name="connsiteX127" fmla="*/ 5821 w 777394"/>
                <a:gd name="connsiteY127" fmla="*/ 251566 h 285901"/>
                <a:gd name="connsiteX128" fmla="*/ 106 w 777394"/>
                <a:gd name="connsiteY128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47756 w 777394"/>
                <a:gd name="connsiteY100" fmla="*/ 17251 h 285901"/>
                <a:gd name="connsiteX101" fmla="*/ 232516 w 777394"/>
                <a:gd name="connsiteY101" fmla="*/ 26776 h 285901"/>
                <a:gd name="connsiteX102" fmla="*/ 224896 w 777394"/>
                <a:gd name="connsiteY102" fmla="*/ 30586 h 285901"/>
                <a:gd name="connsiteX103" fmla="*/ 219181 w 777394"/>
                <a:gd name="connsiteY103" fmla="*/ 34396 h 285901"/>
                <a:gd name="connsiteX104" fmla="*/ 213466 w 777394"/>
                <a:gd name="connsiteY104" fmla="*/ 36301 h 285901"/>
                <a:gd name="connsiteX105" fmla="*/ 203941 w 777394"/>
                <a:gd name="connsiteY105" fmla="*/ 40111 h 285901"/>
                <a:gd name="connsiteX106" fmla="*/ 202036 w 777394"/>
                <a:gd name="connsiteY106" fmla="*/ 45826 h 285901"/>
                <a:gd name="connsiteX107" fmla="*/ 188701 w 777394"/>
                <a:gd name="connsiteY107" fmla="*/ 53446 h 285901"/>
                <a:gd name="connsiteX108" fmla="*/ 169651 w 777394"/>
                <a:gd name="connsiteY108" fmla="*/ 70591 h 285901"/>
                <a:gd name="connsiteX109" fmla="*/ 163936 w 777394"/>
                <a:gd name="connsiteY109" fmla="*/ 72496 h 285901"/>
                <a:gd name="connsiteX110" fmla="*/ 148696 w 777394"/>
                <a:gd name="connsiteY110" fmla="*/ 83926 h 285901"/>
                <a:gd name="connsiteX111" fmla="*/ 141076 w 777394"/>
                <a:gd name="connsiteY111" fmla="*/ 85831 h 285901"/>
                <a:gd name="connsiteX112" fmla="*/ 129646 w 777394"/>
                <a:gd name="connsiteY112" fmla="*/ 95356 h 285901"/>
                <a:gd name="connsiteX113" fmla="*/ 114406 w 777394"/>
                <a:gd name="connsiteY113" fmla="*/ 102976 h 285901"/>
                <a:gd name="connsiteX114" fmla="*/ 110596 w 777394"/>
                <a:gd name="connsiteY114" fmla="*/ 108691 h 285901"/>
                <a:gd name="connsiteX115" fmla="*/ 93451 w 777394"/>
                <a:gd name="connsiteY115" fmla="*/ 125836 h 285901"/>
                <a:gd name="connsiteX116" fmla="*/ 61066 w 777394"/>
                <a:gd name="connsiteY116" fmla="*/ 158221 h 285901"/>
                <a:gd name="connsiteX117" fmla="*/ 49636 w 777394"/>
                <a:gd name="connsiteY117" fmla="*/ 169651 h 285901"/>
                <a:gd name="connsiteX118" fmla="*/ 42016 w 777394"/>
                <a:gd name="connsiteY118" fmla="*/ 177271 h 285901"/>
                <a:gd name="connsiteX119" fmla="*/ 36301 w 777394"/>
                <a:gd name="connsiteY119" fmla="*/ 184891 h 285901"/>
                <a:gd name="connsiteX120" fmla="*/ 34396 w 777394"/>
                <a:gd name="connsiteY120" fmla="*/ 190606 h 285901"/>
                <a:gd name="connsiteX121" fmla="*/ 26776 w 777394"/>
                <a:gd name="connsiteY121" fmla="*/ 203941 h 285901"/>
                <a:gd name="connsiteX122" fmla="*/ 19156 w 777394"/>
                <a:gd name="connsiteY122" fmla="*/ 217276 h 285901"/>
                <a:gd name="connsiteX123" fmla="*/ 15346 w 777394"/>
                <a:gd name="connsiteY123" fmla="*/ 226801 h 285901"/>
                <a:gd name="connsiteX124" fmla="*/ 11536 w 777394"/>
                <a:gd name="connsiteY124" fmla="*/ 232516 h 285901"/>
                <a:gd name="connsiteX125" fmla="*/ 7726 w 777394"/>
                <a:gd name="connsiteY125" fmla="*/ 245851 h 285901"/>
                <a:gd name="connsiteX126" fmla="*/ 5821 w 777394"/>
                <a:gd name="connsiteY126" fmla="*/ 251566 h 285901"/>
                <a:gd name="connsiteX127" fmla="*/ 106 w 777394"/>
                <a:gd name="connsiteY127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224896 w 777394"/>
                <a:gd name="connsiteY101" fmla="*/ 30586 h 285901"/>
                <a:gd name="connsiteX102" fmla="*/ 219181 w 777394"/>
                <a:gd name="connsiteY102" fmla="*/ 34396 h 285901"/>
                <a:gd name="connsiteX103" fmla="*/ 213466 w 777394"/>
                <a:gd name="connsiteY103" fmla="*/ 36301 h 285901"/>
                <a:gd name="connsiteX104" fmla="*/ 203941 w 777394"/>
                <a:gd name="connsiteY104" fmla="*/ 40111 h 285901"/>
                <a:gd name="connsiteX105" fmla="*/ 202036 w 777394"/>
                <a:gd name="connsiteY105" fmla="*/ 45826 h 285901"/>
                <a:gd name="connsiteX106" fmla="*/ 188701 w 777394"/>
                <a:gd name="connsiteY106" fmla="*/ 53446 h 285901"/>
                <a:gd name="connsiteX107" fmla="*/ 169651 w 777394"/>
                <a:gd name="connsiteY107" fmla="*/ 70591 h 285901"/>
                <a:gd name="connsiteX108" fmla="*/ 163936 w 777394"/>
                <a:gd name="connsiteY108" fmla="*/ 72496 h 285901"/>
                <a:gd name="connsiteX109" fmla="*/ 148696 w 777394"/>
                <a:gd name="connsiteY109" fmla="*/ 83926 h 285901"/>
                <a:gd name="connsiteX110" fmla="*/ 141076 w 777394"/>
                <a:gd name="connsiteY110" fmla="*/ 85831 h 285901"/>
                <a:gd name="connsiteX111" fmla="*/ 129646 w 777394"/>
                <a:gd name="connsiteY111" fmla="*/ 95356 h 285901"/>
                <a:gd name="connsiteX112" fmla="*/ 114406 w 777394"/>
                <a:gd name="connsiteY112" fmla="*/ 102976 h 285901"/>
                <a:gd name="connsiteX113" fmla="*/ 110596 w 777394"/>
                <a:gd name="connsiteY113" fmla="*/ 108691 h 285901"/>
                <a:gd name="connsiteX114" fmla="*/ 93451 w 777394"/>
                <a:gd name="connsiteY114" fmla="*/ 125836 h 285901"/>
                <a:gd name="connsiteX115" fmla="*/ 61066 w 777394"/>
                <a:gd name="connsiteY115" fmla="*/ 158221 h 285901"/>
                <a:gd name="connsiteX116" fmla="*/ 49636 w 777394"/>
                <a:gd name="connsiteY116" fmla="*/ 169651 h 285901"/>
                <a:gd name="connsiteX117" fmla="*/ 42016 w 777394"/>
                <a:gd name="connsiteY117" fmla="*/ 177271 h 285901"/>
                <a:gd name="connsiteX118" fmla="*/ 36301 w 777394"/>
                <a:gd name="connsiteY118" fmla="*/ 184891 h 285901"/>
                <a:gd name="connsiteX119" fmla="*/ 34396 w 777394"/>
                <a:gd name="connsiteY119" fmla="*/ 190606 h 285901"/>
                <a:gd name="connsiteX120" fmla="*/ 26776 w 777394"/>
                <a:gd name="connsiteY120" fmla="*/ 203941 h 285901"/>
                <a:gd name="connsiteX121" fmla="*/ 19156 w 777394"/>
                <a:gd name="connsiteY121" fmla="*/ 217276 h 285901"/>
                <a:gd name="connsiteX122" fmla="*/ 15346 w 777394"/>
                <a:gd name="connsiteY122" fmla="*/ 226801 h 285901"/>
                <a:gd name="connsiteX123" fmla="*/ 11536 w 777394"/>
                <a:gd name="connsiteY123" fmla="*/ 232516 h 285901"/>
                <a:gd name="connsiteX124" fmla="*/ 7726 w 777394"/>
                <a:gd name="connsiteY124" fmla="*/ 245851 h 285901"/>
                <a:gd name="connsiteX125" fmla="*/ 5821 w 777394"/>
                <a:gd name="connsiteY125" fmla="*/ 251566 h 285901"/>
                <a:gd name="connsiteX126" fmla="*/ 106 w 777394"/>
                <a:gd name="connsiteY126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224896 w 777394"/>
                <a:gd name="connsiteY101" fmla="*/ 30586 h 285901"/>
                <a:gd name="connsiteX102" fmla="*/ 219181 w 777394"/>
                <a:gd name="connsiteY102" fmla="*/ 34396 h 285901"/>
                <a:gd name="connsiteX103" fmla="*/ 203941 w 777394"/>
                <a:gd name="connsiteY103" fmla="*/ 40111 h 285901"/>
                <a:gd name="connsiteX104" fmla="*/ 202036 w 777394"/>
                <a:gd name="connsiteY104" fmla="*/ 45826 h 285901"/>
                <a:gd name="connsiteX105" fmla="*/ 188701 w 777394"/>
                <a:gd name="connsiteY105" fmla="*/ 53446 h 285901"/>
                <a:gd name="connsiteX106" fmla="*/ 169651 w 777394"/>
                <a:gd name="connsiteY106" fmla="*/ 70591 h 285901"/>
                <a:gd name="connsiteX107" fmla="*/ 163936 w 777394"/>
                <a:gd name="connsiteY107" fmla="*/ 72496 h 285901"/>
                <a:gd name="connsiteX108" fmla="*/ 148696 w 777394"/>
                <a:gd name="connsiteY108" fmla="*/ 83926 h 285901"/>
                <a:gd name="connsiteX109" fmla="*/ 141076 w 777394"/>
                <a:gd name="connsiteY109" fmla="*/ 85831 h 285901"/>
                <a:gd name="connsiteX110" fmla="*/ 129646 w 777394"/>
                <a:gd name="connsiteY110" fmla="*/ 95356 h 285901"/>
                <a:gd name="connsiteX111" fmla="*/ 114406 w 777394"/>
                <a:gd name="connsiteY111" fmla="*/ 102976 h 285901"/>
                <a:gd name="connsiteX112" fmla="*/ 110596 w 777394"/>
                <a:gd name="connsiteY112" fmla="*/ 108691 h 285901"/>
                <a:gd name="connsiteX113" fmla="*/ 93451 w 777394"/>
                <a:gd name="connsiteY113" fmla="*/ 125836 h 285901"/>
                <a:gd name="connsiteX114" fmla="*/ 61066 w 777394"/>
                <a:gd name="connsiteY114" fmla="*/ 158221 h 285901"/>
                <a:gd name="connsiteX115" fmla="*/ 49636 w 777394"/>
                <a:gd name="connsiteY115" fmla="*/ 169651 h 285901"/>
                <a:gd name="connsiteX116" fmla="*/ 42016 w 777394"/>
                <a:gd name="connsiteY116" fmla="*/ 177271 h 285901"/>
                <a:gd name="connsiteX117" fmla="*/ 36301 w 777394"/>
                <a:gd name="connsiteY117" fmla="*/ 184891 h 285901"/>
                <a:gd name="connsiteX118" fmla="*/ 34396 w 777394"/>
                <a:gd name="connsiteY118" fmla="*/ 190606 h 285901"/>
                <a:gd name="connsiteX119" fmla="*/ 26776 w 777394"/>
                <a:gd name="connsiteY119" fmla="*/ 203941 h 285901"/>
                <a:gd name="connsiteX120" fmla="*/ 19156 w 777394"/>
                <a:gd name="connsiteY120" fmla="*/ 217276 h 285901"/>
                <a:gd name="connsiteX121" fmla="*/ 15346 w 777394"/>
                <a:gd name="connsiteY121" fmla="*/ 226801 h 285901"/>
                <a:gd name="connsiteX122" fmla="*/ 11536 w 777394"/>
                <a:gd name="connsiteY122" fmla="*/ 232516 h 285901"/>
                <a:gd name="connsiteX123" fmla="*/ 7726 w 777394"/>
                <a:gd name="connsiteY123" fmla="*/ 245851 h 285901"/>
                <a:gd name="connsiteX124" fmla="*/ 5821 w 777394"/>
                <a:gd name="connsiteY124" fmla="*/ 251566 h 285901"/>
                <a:gd name="connsiteX125" fmla="*/ 106 w 777394"/>
                <a:gd name="connsiteY125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224896 w 777394"/>
                <a:gd name="connsiteY101" fmla="*/ 30586 h 285901"/>
                <a:gd name="connsiteX102" fmla="*/ 203941 w 777394"/>
                <a:gd name="connsiteY102" fmla="*/ 40111 h 285901"/>
                <a:gd name="connsiteX103" fmla="*/ 202036 w 777394"/>
                <a:gd name="connsiteY103" fmla="*/ 45826 h 285901"/>
                <a:gd name="connsiteX104" fmla="*/ 188701 w 777394"/>
                <a:gd name="connsiteY104" fmla="*/ 53446 h 285901"/>
                <a:gd name="connsiteX105" fmla="*/ 169651 w 777394"/>
                <a:gd name="connsiteY105" fmla="*/ 70591 h 285901"/>
                <a:gd name="connsiteX106" fmla="*/ 163936 w 777394"/>
                <a:gd name="connsiteY106" fmla="*/ 72496 h 285901"/>
                <a:gd name="connsiteX107" fmla="*/ 148696 w 777394"/>
                <a:gd name="connsiteY107" fmla="*/ 83926 h 285901"/>
                <a:gd name="connsiteX108" fmla="*/ 141076 w 777394"/>
                <a:gd name="connsiteY108" fmla="*/ 85831 h 285901"/>
                <a:gd name="connsiteX109" fmla="*/ 129646 w 777394"/>
                <a:gd name="connsiteY109" fmla="*/ 95356 h 285901"/>
                <a:gd name="connsiteX110" fmla="*/ 114406 w 777394"/>
                <a:gd name="connsiteY110" fmla="*/ 102976 h 285901"/>
                <a:gd name="connsiteX111" fmla="*/ 110596 w 777394"/>
                <a:gd name="connsiteY111" fmla="*/ 108691 h 285901"/>
                <a:gd name="connsiteX112" fmla="*/ 93451 w 777394"/>
                <a:gd name="connsiteY112" fmla="*/ 125836 h 285901"/>
                <a:gd name="connsiteX113" fmla="*/ 61066 w 777394"/>
                <a:gd name="connsiteY113" fmla="*/ 158221 h 285901"/>
                <a:gd name="connsiteX114" fmla="*/ 49636 w 777394"/>
                <a:gd name="connsiteY114" fmla="*/ 169651 h 285901"/>
                <a:gd name="connsiteX115" fmla="*/ 42016 w 777394"/>
                <a:gd name="connsiteY115" fmla="*/ 177271 h 285901"/>
                <a:gd name="connsiteX116" fmla="*/ 36301 w 777394"/>
                <a:gd name="connsiteY116" fmla="*/ 184891 h 285901"/>
                <a:gd name="connsiteX117" fmla="*/ 34396 w 777394"/>
                <a:gd name="connsiteY117" fmla="*/ 190606 h 285901"/>
                <a:gd name="connsiteX118" fmla="*/ 26776 w 777394"/>
                <a:gd name="connsiteY118" fmla="*/ 203941 h 285901"/>
                <a:gd name="connsiteX119" fmla="*/ 19156 w 777394"/>
                <a:gd name="connsiteY119" fmla="*/ 217276 h 285901"/>
                <a:gd name="connsiteX120" fmla="*/ 15346 w 777394"/>
                <a:gd name="connsiteY120" fmla="*/ 226801 h 285901"/>
                <a:gd name="connsiteX121" fmla="*/ 11536 w 777394"/>
                <a:gd name="connsiteY121" fmla="*/ 232516 h 285901"/>
                <a:gd name="connsiteX122" fmla="*/ 7726 w 777394"/>
                <a:gd name="connsiteY122" fmla="*/ 245851 h 285901"/>
                <a:gd name="connsiteX123" fmla="*/ 5821 w 777394"/>
                <a:gd name="connsiteY123" fmla="*/ 251566 h 285901"/>
                <a:gd name="connsiteX124" fmla="*/ 106 w 777394"/>
                <a:gd name="connsiteY124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224896 w 777394"/>
                <a:gd name="connsiteY101" fmla="*/ 30586 h 285901"/>
                <a:gd name="connsiteX102" fmla="*/ 203941 w 777394"/>
                <a:gd name="connsiteY102" fmla="*/ 40111 h 285901"/>
                <a:gd name="connsiteX103" fmla="*/ 188701 w 777394"/>
                <a:gd name="connsiteY103" fmla="*/ 53446 h 285901"/>
                <a:gd name="connsiteX104" fmla="*/ 169651 w 777394"/>
                <a:gd name="connsiteY104" fmla="*/ 70591 h 285901"/>
                <a:gd name="connsiteX105" fmla="*/ 163936 w 777394"/>
                <a:gd name="connsiteY105" fmla="*/ 72496 h 285901"/>
                <a:gd name="connsiteX106" fmla="*/ 148696 w 777394"/>
                <a:gd name="connsiteY106" fmla="*/ 83926 h 285901"/>
                <a:gd name="connsiteX107" fmla="*/ 141076 w 777394"/>
                <a:gd name="connsiteY107" fmla="*/ 85831 h 285901"/>
                <a:gd name="connsiteX108" fmla="*/ 129646 w 777394"/>
                <a:gd name="connsiteY108" fmla="*/ 95356 h 285901"/>
                <a:gd name="connsiteX109" fmla="*/ 114406 w 777394"/>
                <a:gd name="connsiteY109" fmla="*/ 102976 h 285901"/>
                <a:gd name="connsiteX110" fmla="*/ 110596 w 777394"/>
                <a:gd name="connsiteY110" fmla="*/ 108691 h 285901"/>
                <a:gd name="connsiteX111" fmla="*/ 93451 w 777394"/>
                <a:gd name="connsiteY111" fmla="*/ 125836 h 285901"/>
                <a:gd name="connsiteX112" fmla="*/ 61066 w 777394"/>
                <a:gd name="connsiteY112" fmla="*/ 158221 h 285901"/>
                <a:gd name="connsiteX113" fmla="*/ 49636 w 777394"/>
                <a:gd name="connsiteY113" fmla="*/ 169651 h 285901"/>
                <a:gd name="connsiteX114" fmla="*/ 42016 w 777394"/>
                <a:gd name="connsiteY114" fmla="*/ 177271 h 285901"/>
                <a:gd name="connsiteX115" fmla="*/ 36301 w 777394"/>
                <a:gd name="connsiteY115" fmla="*/ 184891 h 285901"/>
                <a:gd name="connsiteX116" fmla="*/ 34396 w 777394"/>
                <a:gd name="connsiteY116" fmla="*/ 190606 h 285901"/>
                <a:gd name="connsiteX117" fmla="*/ 26776 w 777394"/>
                <a:gd name="connsiteY117" fmla="*/ 203941 h 285901"/>
                <a:gd name="connsiteX118" fmla="*/ 19156 w 777394"/>
                <a:gd name="connsiteY118" fmla="*/ 217276 h 285901"/>
                <a:gd name="connsiteX119" fmla="*/ 15346 w 777394"/>
                <a:gd name="connsiteY119" fmla="*/ 226801 h 285901"/>
                <a:gd name="connsiteX120" fmla="*/ 11536 w 777394"/>
                <a:gd name="connsiteY120" fmla="*/ 232516 h 285901"/>
                <a:gd name="connsiteX121" fmla="*/ 7726 w 777394"/>
                <a:gd name="connsiteY121" fmla="*/ 245851 h 285901"/>
                <a:gd name="connsiteX122" fmla="*/ 5821 w 777394"/>
                <a:gd name="connsiteY122" fmla="*/ 251566 h 285901"/>
                <a:gd name="connsiteX123" fmla="*/ 106 w 777394"/>
                <a:gd name="connsiteY123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224896 w 777394"/>
                <a:gd name="connsiteY101" fmla="*/ 30586 h 285901"/>
                <a:gd name="connsiteX102" fmla="*/ 203941 w 777394"/>
                <a:gd name="connsiteY102" fmla="*/ 40111 h 285901"/>
                <a:gd name="connsiteX103" fmla="*/ 188701 w 777394"/>
                <a:gd name="connsiteY103" fmla="*/ 53446 h 285901"/>
                <a:gd name="connsiteX104" fmla="*/ 163936 w 777394"/>
                <a:gd name="connsiteY104" fmla="*/ 72496 h 285901"/>
                <a:gd name="connsiteX105" fmla="*/ 148696 w 777394"/>
                <a:gd name="connsiteY105" fmla="*/ 83926 h 285901"/>
                <a:gd name="connsiteX106" fmla="*/ 141076 w 777394"/>
                <a:gd name="connsiteY106" fmla="*/ 85831 h 285901"/>
                <a:gd name="connsiteX107" fmla="*/ 129646 w 777394"/>
                <a:gd name="connsiteY107" fmla="*/ 95356 h 285901"/>
                <a:gd name="connsiteX108" fmla="*/ 114406 w 777394"/>
                <a:gd name="connsiteY108" fmla="*/ 102976 h 285901"/>
                <a:gd name="connsiteX109" fmla="*/ 110596 w 777394"/>
                <a:gd name="connsiteY109" fmla="*/ 108691 h 285901"/>
                <a:gd name="connsiteX110" fmla="*/ 93451 w 777394"/>
                <a:gd name="connsiteY110" fmla="*/ 125836 h 285901"/>
                <a:gd name="connsiteX111" fmla="*/ 61066 w 777394"/>
                <a:gd name="connsiteY111" fmla="*/ 158221 h 285901"/>
                <a:gd name="connsiteX112" fmla="*/ 49636 w 777394"/>
                <a:gd name="connsiteY112" fmla="*/ 169651 h 285901"/>
                <a:gd name="connsiteX113" fmla="*/ 42016 w 777394"/>
                <a:gd name="connsiteY113" fmla="*/ 177271 h 285901"/>
                <a:gd name="connsiteX114" fmla="*/ 36301 w 777394"/>
                <a:gd name="connsiteY114" fmla="*/ 184891 h 285901"/>
                <a:gd name="connsiteX115" fmla="*/ 34396 w 777394"/>
                <a:gd name="connsiteY115" fmla="*/ 190606 h 285901"/>
                <a:gd name="connsiteX116" fmla="*/ 26776 w 777394"/>
                <a:gd name="connsiteY116" fmla="*/ 203941 h 285901"/>
                <a:gd name="connsiteX117" fmla="*/ 19156 w 777394"/>
                <a:gd name="connsiteY117" fmla="*/ 217276 h 285901"/>
                <a:gd name="connsiteX118" fmla="*/ 15346 w 777394"/>
                <a:gd name="connsiteY118" fmla="*/ 226801 h 285901"/>
                <a:gd name="connsiteX119" fmla="*/ 11536 w 777394"/>
                <a:gd name="connsiteY119" fmla="*/ 232516 h 285901"/>
                <a:gd name="connsiteX120" fmla="*/ 7726 w 777394"/>
                <a:gd name="connsiteY120" fmla="*/ 245851 h 285901"/>
                <a:gd name="connsiteX121" fmla="*/ 5821 w 777394"/>
                <a:gd name="connsiteY121" fmla="*/ 251566 h 285901"/>
                <a:gd name="connsiteX122" fmla="*/ 106 w 777394"/>
                <a:gd name="connsiteY122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224896 w 777394"/>
                <a:gd name="connsiteY101" fmla="*/ 30586 h 285901"/>
                <a:gd name="connsiteX102" fmla="*/ 188701 w 777394"/>
                <a:gd name="connsiteY102" fmla="*/ 53446 h 285901"/>
                <a:gd name="connsiteX103" fmla="*/ 163936 w 777394"/>
                <a:gd name="connsiteY103" fmla="*/ 72496 h 285901"/>
                <a:gd name="connsiteX104" fmla="*/ 148696 w 777394"/>
                <a:gd name="connsiteY104" fmla="*/ 83926 h 285901"/>
                <a:gd name="connsiteX105" fmla="*/ 141076 w 777394"/>
                <a:gd name="connsiteY105" fmla="*/ 85831 h 285901"/>
                <a:gd name="connsiteX106" fmla="*/ 129646 w 777394"/>
                <a:gd name="connsiteY106" fmla="*/ 95356 h 285901"/>
                <a:gd name="connsiteX107" fmla="*/ 114406 w 777394"/>
                <a:gd name="connsiteY107" fmla="*/ 102976 h 285901"/>
                <a:gd name="connsiteX108" fmla="*/ 110596 w 777394"/>
                <a:gd name="connsiteY108" fmla="*/ 108691 h 285901"/>
                <a:gd name="connsiteX109" fmla="*/ 93451 w 777394"/>
                <a:gd name="connsiteY109" fmla="*/ 125836 h 285901"/>
                <a:gd name="connsiteX110" fmla="*/ 61066 w 777394"/>
                <a:gd name="connsiteY110" fmla="*/ 158221 h 285901"/>
                <a:gd name="connsiteX111" fmla="*/ 49636 w 777394"/>
                <a:gd name="connsiteY111" fmla="*/ 169651 h 285901"/>
                <a:gd name="connsiteX112" fmla="*/ 42016 w 777394"/>
                <a:gd name="connsiteY112" fmla="*/ 177271 h 285901"/>
                <a:gd name="connsiteX113" fmla="*/ 36301 w 777394"/>
                <a:gd name="connsiteY113" fmla="*/ 184891 h 285901"/>
                <a:gd name="connsiteX114" fmla="*/ 34396 w 777394"/>
                <a:gd name="connsiteY114" fmla="*/ 190606 h 285901"/>
                <a:gd name="connsiteX115" fmla="*/ 26776 w 777394"/>
                <a:gd name="connsiteY115" fmla="*/ 203941 h 285901"/>
                <a:gd name="connsiteX116" fmla="*/ 19156 w 777394"/>
                <a:gd name="connsiteY116" fmla="*/ 217276 h 285901"/>
                <a:gd name="connsiteX117" fmla="*/ 15346 w 777394"/>
                <a:gd name="connsiteY117" fmla="*/ 226801 h 285901"/>
                <a:gd name="connsiteX118" fmla="*/ 11536 w 777394"/>
                <a:gd name="connsiteY118" fmla="*/ 232516 h 285901"/>
                <a:gd name="connsiteX119" fmla="*/ 7726 w 777394"/>
                <a:gd name="connsiteY119" fmla="*/ 245851 h 285901"/>
                <a:gd name="connsiteX120" fmla="*/ 5821 w 777394"/>
                <a:gd name="connsiteY120" fmla="*/ 251566 h 285901"/>
                <a:gd name="connsiteX121" fmla="*/ 106 w 777394"/>
                <a:gd name="connsiteY121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63936 w 777394"/>
                <a:gd name="connsiteY102" fmla="*/ 72496 h 285901"/>
                <a:gd name="connsiteX103" fmla="*/ 148696 w 777394"/>
                <a:gd name="connsiteY103" fmla="*/ 83926 h 285901"/>
                <a:gd name="connsiteX104" fmla="*/ 141076 w 777394"/>
                <a:gd name="connsiteY104" fmla="*/ 85831 h 285901"/>
                <a:gd name="connsiteX105" fmla="*/ 129646 w 777394"/>
                <a:gd name="connsiteY105" fmla="*/ 95356 h 285901"/>
                <a:gd name="connsiteX106" fmla="*/ 114406 w 777394"/>
                <a:gd name="connsiteY106" fmla="*/ 102976 h 285901"/>
                <a:gd name="connsiteX107" fmla="*/ 110596 w 777394"/>
                <a:gd name="connsiteY107" fmla="*/ 108691 h 285901"/>
                <a:gd name="connsiteX108" fmla="*/ 93451 w 777394"/>
                <a:gd name="connsiteY108" fmla="*/ 125836 h 285901"/>
                <a:gd name="connsiteX109" fmla="*/ 61066 w 777394"/>
                <a:gd name="connsiteY109" fmla="*/ 158221 h 285901"/>
                <a:gd name="connsiteX110" fmla="*/ 49636 w 777394"/>
                <a:gd name="connsiteY110" fmla="*/ 169651 h 285901"/>
                <a:gd name="connsiteX111" fmla="*/ 42016 w 777394"/>
                <a:gd name="connsiteY111" fmla="*/ 177271 h 285901"/>
                <a:gd name="connsiteX112" fmla="*/ 36301 w 777394"/>
                <a:gd name="connsiteY112" fmla="*/ 184891 h 285901"/>
                <a:gd name="connsiteX113" fmla="*/ 34396 w 777394"/>
                <a:gd name="connsiteY113" fmla="*/ 190606 h 285901"/>
                <a:gd name="connsiteX114" fmla="*/ 26776 w 777394"/>
                <a:gd name="connsiteY114" fmla="*/ 203941 h 285901"/>
                <a:gd name="connsiteX115" fmla="*/ 19156 w 777394"/>
                <a:gd name="connsiteY115" fmla="*/ 217276 h 285901"/>
                <a:gd name="connsiteX116" fmla="*/ 15346 w 777394"/>
                <a:gd name="connsiteY116" fmla="*/ 226801 h 285901"/>
                <a:gd name="connsiteX117" fmla="*/ 11536 w 777394"/>
                <a:gd name="connsiteY117" fmla="*/ 232516 h 285901"/>
                <a:gd name="connsiteX118" fmla="*/ 7726 w 777394"/>
                <a:gd name="connsiteY118" fmla="*/ 245851 h 285901"/>
                <a:gd name="connsiteX119" fmla="*/ 5821 w 777394"/>
                <a:gd name="connsiteY119" fmla="*/ 251566 h 285901"/>
                <a:gd name="connsiteX120" fmla="*/ 106 w 777394"/>
                <a:gd name="connsiteY120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63936 w 777394"/>
                <a:gd name="connsiteY102" fmla="*/ 72496 h 285901"/>
                <a:gd name="connsiteX103" fmla="*/ 148696 w 777394"/>
                <a:gd name="connsiteY103" fmla="*/ 83926 h 285901"/>
                <a:gd name="connsiteX104" fmla="*/ 129646 w 777394"/>
                <a:gd name="connsiteY104" fmla="*/ 95356 h 285901"/>
                <a:gd name="connsiteX105" fmla="*/ 114406 w 777394"/>
                <a:gd name="connsiteY105" fmla="*/ 102976 h 285901"/>
                <a:gd name="connsiteX106" fmla="*/ 110596 w 777394"/>
                <a:gd name="connsiteY106" fmla="*/ 108691 h 285901"/>
                <a:gd name="connsiteX107" fmla="*/ 93451 w 777394"/>
                <a:gd name="connsiteY107" fmla="*/ 125836 h 285901"/>
                <a:gd name="connsiteX108" fmla="*/ 61066 w 777394"/>
                <a:gd name="connsiteY108" fmla="*/ 158221 h 285901"/>
                <a:gd name="connsiteX109" fmla="*/ 49636 w 777394"/>
                <a:gd name="connsiteY109" fmla="*/ 169651 h 285901"/>
                <a:gd name="connsiteX110" fmla="*/ 42016 w 777394"/>
                <a:gd name="connsiteY110" fmla="*/ 177271 h 285901"/>
                <a:gd name="connsiteX111" fmla="*/ 36301 w 777394"/>
                <a:gd name="connsiteY111" fmla="*/ 184891 h 285901"/>
                <a:gd name="connsiteX112" fmla="*/ 34396 w 777394"/>
                <a:gd name="connsiteY112" fmla="*/ 190606 h 285901"/>
                <a:gd name="connsiteX113" fmla="*/ 26776 w 777394"/>
                <a:gd name="connsiteY113" fmla="*/ 203941 h 285901"/>
                <a:gd name="connsiteX114" fmla="*/ 19156 w 777394"/>
                <a:gd name="connsiteY114" fmla="*/ 217276 h 285901"/>
                <a:gd name="connsiteX115" fmla="*/ 15346 w 777394"/>
                <a:gd name="connsiteY115" fmla="*/ 226801 h 285901"/>
                <a:gd name="connsiteX116" fmla="*/ 11536 w 777394"/>
                <a:gd name="connsiteY116" fmla="*/ 232516 h 285901"/>
                <a:gd name="connsiteX117" fmla="*/ 7726 w 777394"/>
                <a:gd name="connsiteY117" fmla="*/ 245851 h 285901"/>
                <a:gd name="connsiteX118" fmla="*/ 5821 w 777394"/>
                <a:gd name="connsiteY118" fmla="*/ 251566 h 285901"/>
                <a:gd name="connsiteX119" fmla="*/ 106 w 777394"/>
                <a:gd name="connsiteY119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63936 w 777394"/>
                <a:gd name="connsiteY102" fmla="*/ 72496 h 285901"/>
                <a:gd name="connsiteX103" fmla="*/ 148696 w 777394"/>
                <a:gd name="connsiteY103" fmla="*/ 83926 h 285901"/>
                <a:gd name="connsiteX104" fmla="*/ 129646 w 777394"/>
                <a:gd name="connsiteY104" fmla="*/ 95356 h 285901"/>
                <a:gd name="connsiteX105" fmla="*/ 110596 w 777394"/>
                <a:gd name="connsiteY105" fmla="*/ 108691 h 285901"/>
                <a:gd name="connsiteX106" fmla="*/ 93451 w 777394"/>
                <a:gd name="connsiteY106" fmla="*/ 125836 h 285901"/>
                <a:gd name="connsiteX107" fmla="*/ 61066 w 777394"/>
                <a:gd name="connsiteY107" fmla="*/ 158221 h 285901"/>
                <a:gd name="connsiteX108" fmla="*/ 49636 w 777394"/>
                <a:gd name="connsiteY108" fmla="*/ 169651 h 285901"/>
                <a:gd name="connsiteX109" fmla="*/ 42016 w 777394"/>
                <a:gd name="connsiteY109" fmla="*/ 177271 h 285901"/>
                <a:gd name="connsiteX110" fmla="*/ 36301 w 777394"/>
                <a:gd name="connsiteY110" fmla="*/ 184891 h 285901"/>
                <a:gd name="connsiteX111" fmla="*/ 34396 w 777394"/>
                <a:gd name="connsiteY111" fmla="*/ 190606 h 285901"/>
                <a:gd name="connsiteX112" fmla="*/ 26776 w 777394"/>
                <a:gd name="connsiteY112" fmla="*/ 203941 h 285901"/>
                <a:gd name="connsiteX113" fmla="*/ 19156 w 777394"/>
                <a:gd name="connsiteY113" fmla="*/ 217276 h 285901"/>
                <a:gd name="connsiteX114" fmla="*/ 15346 w 777394"/>
                <a:gd name="connsiteY114" fmla="*/ 226801 h 285901"/>
                <a:gd name="connsiteX115" fmla="*/ 11536 w 777394"/>
                <a:gd name="connsiteY115" fmla="*/ 232516 h 285901"/>
                <a:gd name="connsiteX116" fmla="*/ 7726 w 777394"/>
                <a:gd name="connsiteY116" fmla="*/ 245851 h 285901"/>
                <a:gd name="connsiteX117" fmla="*/ 5821 w 777394"/>
                <a:gd name="connsiteY117" fmla="*/ 251566 h 285901"/>
                <a:gd name="connsiteX118" fmla="*/ 106 w 777394"/>
                <a:gd name="connsiteY118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63936 w 777394"/>
                <a:gd name="connsiteY102" fmla="*/ 72496 h 285901"/>
                <a:gd name="connsiteX103" fmla="*/ 148696 w 777394"/>
                <a:gd name="connsiteY103" fmla="*/ 83926 h 285901"/>
                <a:gd name="connsiteX104" fmla="*/ 129646 w 777394"/>
                <a:gd name="connsiteY104" fmla="*/ 95356 h 285901"/>
                <a:gd name="connsiteX105" fmla="*/ 93451 w 777394"/>
                <a:gd name="connsiteY105" fmla="*/ 125836 h 285901"/>
                <a:gd name="connsiteX106" fmla="*/ 61066 w 777394"/>
                <a:gd name="connsiteY106" fmla="*/ 158221 h 285901"/>
                <a:gd name="connsiteX107" fmla="*/ 49636 w 777394"/>
                <a:gd name="connsiteY107" fmla="*/ 169651 h 285901"/>
                <a:gd name="connsiteX108" fmla="*/ 42016 w 777394"/>
                <a:gd name="connsiteY108" fmla="*/ 177271 h 285901"/>
                <a:gd name="connsiteX109" fmla="*/ 36301 w 777394"/>
                <a:gd name="connsiteY109" fmla="*/ 184891 h 285901"/>
                <a:gd name="connsiteX110" fmla="*/ 34396 w 777394"/>
                <a:gd name="connsiteY110" fmla="*/ 190606 h 285901"/>
                <a:gd name="connsiteX111" fmla="*/ 26776 w 777394"/>
                <a:gd name="connsiteY111" fmla="*/ 203941 h 285901"/>
                <a:gd name="connsiteX112" fmla="*/ 19156 w 777394"/>
                <a:gd name="connsiteY112" fmla="*/ 217276 h 285901"/>
                <a:gd name="connsiteX113" fmla="*/ 15346 w 777394"/>
                <a:gd name="connsiteY113" fmla="*/ 226801 h 285901"/>
                <a:gd name="connsiteX114" fmla="*/ 11536 w 777394"/>
                <a:gd name="connsiteY114" fmla="*/ 232516 h 285901"/>
                <a:gd name="connsiteX115" fmla="*/ 7726 w 777394"/>
                <a:gd name="connsiteY115" fmla="*/ 245851 h 285901"/>
                <a:gd name="connsiteX116" fmla="*/ 5821 w 777394"/>
                <a:gd name="connsiteY116" fmla="*/ 251566 h 285901"/>
                <a:gd name="connsiteX117" fmla="*/ 106 w 777394"/>
                <a:gd name="connsiteY117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63936 w 777394"/>
                <a:gd name="connsiteY102" fmla="*/ 72496 h 285901"/>
                <a:gd name="connsiteX103" fmla="*/ 129646 w 777394"/>
                <a:gd name="connsiteY103" fmla="*/ 95356 h 285901"/>
                <a:gd name="connsiteX104" fmla="*/ 93451 w 777394"/>
                <a:gd name="connsiteY104" fmla="*/ 125836 h 285901"/>
                <a:gd name="connsiteX105" fmla="*/ 61066 w 777394"/>
                <a:gd name="connsiteY105" fmla="*/ 158221 h 285901"/>
                <a:gd name="connsiteX106" fmla="*/ 49636 w 777394"/>
                <a:gd name="connsiteY106" fmla="*/ 169651 h 285901"/>
                <a:gd name="connsiteX107" fmla="*/ 42016 w 777394"/>
                <a:gd name="connsiteY107" fmla="*/ 177271 h 285901"/>
                <a:gd name="connsiteX108" fmla="*/ 36301 w 777394"/>
                <a:gd name="connsiteY108" fmla="*/ 184891 h 285901"/>
                <a:gd name="connsiteX109" fmla="*/ 34396 w 777394"/>
                <a:gd name="connsiteY109" fmla="*/ 190606 h 285901"/>
                <a:gd name="connsiteX110" fmla="*/ 26776 w 777394"/>
                <a:gd name="connsiteY110" fmla="*/ 203941 h 285901"/>
                <a:gd name="connsiteX111" fmla="*/ 19156 w 777394"/>
                <a:gd name="connsiteY111" fmla="*/ 217276 h 285901"/>
                <a:gd name="connsiteX112" fmla="*/ 15346 w 777394"/>
                <a:gd name="connsiteY112" fmla="*/ 226801 h 285901"/>
                <a:gd name="connsiteX113" fmla="*/ 11536 w 777394"/>
                <a:gd name="connsiteY113" fmla="*/ 232516 h 285901"/>
                <a:gd name="connsiteX114" fmla="*/ 7726 w 777394"/>
                <a:gd name="connsiteY114" fmla="*/ 245851 h 285901"/>
                <a:gd name="connsiteX115" fmla="*/ 5821 w 777394"/>
                <a:gd name="connsiteY115" fmla="*/ 251566 h 285901"/>
                <a:gd name="connsiteX116" fmla="*/ 106 w 777394"/>
                <a:gd name="connsiteY116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29646 w 777394"/>
                <a:gd name="connsiteY102" fmla="*/ 95356 h 285901"/>
                <a:gd name="connsiteX103" fmla="*/ 93451 w 777394"/>
                <a:gd name="connsiteY103" fmla="*/ 125836 h 285901"/>
                <a:gd name="connsiteX104" fmla="*/ 61066 w 777394"/>
                <a:gd name="connsiteY104" fmla="*/ 158221 h 285901"/>
                <a:gd name="connsiteX105" fmla="*/ 49636 w 777394"/>
                <a:gd name="connsiteY105" fmla="*/ 169651 h 285901"/>
                <a:gd name="connsiteX106" fmla="*/ 42016 w 777394"/>
                <a:gd name="connsiteY106" fmla="*/ 177271 h 285901"/>
                <a:gd name="connsiteX107" fmla="*/ 36301 w 777394"/>
                <a:gd name="connsiteY107" fmla="*/ 184891 h 285901"/>
                <a:gd name="connsiteX108" fmla="*/ 34396 w 777394"/>
                <a:gd name="connsiteY108" fmla="*/ 190606 h 285901"/>
                <a:gd name="connsiteX109" fmla="*/ 26776 w 777394"/>
                <a:gd name="connsiteY109" fmla="*/ 203941 h 285901"/>
                <a:gd name="connsiteX110" fmla="*/ 19156 w 777394"/>
                <a:gd name="connsiteY110" fmla="*/ 217276 h 285901"/>
                <a:gd name="connsiteX111" fmla="*/ 15346 w 777394"/>
                <a:gd name="connsiteY111" fmla="*/ 226801 h 285901"/>
                <a:gd name="connsiteX112" fmla="*/ 11536 w 777394"/>
                <a:gd name="connsiteY112" fmla="*/ 232516 h 285901"/>
                <a:gd name="connsiteX113" fmla="*/ 7726 w 777394"/>
                <a:gd name="connsiteY113" fmla="*/ 245851 h 285901"/>
                <a:gd name="connsiteX114" fmla="*/ 5821 w 777394"/>
                <a:gd name="connsiteY114" fmla="*/ 251566 h 285901"/>
                <a:gd name="connsiteX115" fmla="*/ 106 w 777394"/>
                <a:gd name="connsiteY115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29646 w 777394"/>
                <a:gd name="connsiteY102" fmla="*/ 95356 h 285901"/>
                <a:gd name="connsiteX103" fmla="*/ 93451 w 777394"/>
                <a:gd name="connsiteY103" fmla="*/ 125836 h 285901"/>
                <a:gd name="connsiteX104" fmla="*/ 61066 w 777394"/>
                <a:gd name="connsiteY104" fmla="*/ 158221 h 285901"/>
                <a:gd name="connsiteX105" fmla="*/ 49636 w 777394"/>
                <a:gd name="connsiteY105" fmla="*/ 169651 h 285901"/>
                <a:gd name="connsiteX106" fmla="*/ 42016 w 777394"/>
                <a:gd name="connsiteY106" fmla="*/ 177271 h 285901"/>
                <a:gd name="connsiteX107" fmla="*/ 36301 w 777394"/>
                <a:gd name="connsiteY107" fmla="*/ 184891 h 285901"/>
                <a:gd name="connsiteX108" fmla="*/ 34396 w 777394"/>
                <a:gd name="connsiteY108" fmla="*/ 190606 h 285901"/>
                <a:gd name="connsiteX109" fmla="*/ 26776 w 777394"/>
                <a:gd name="connsiteY109" fmla="*/ 203941 h 285901"/>
                <a:gd name="connsiteX110" fmla="*/ 15346 w 777394"/>
                <a:gd name="connsiteY110" fmla="*/ 226801 h 285901"/>
                <a:gd name="connsiteX111" fmla="*/ 11536 w 777394"/>
                <a:gd name="connsiteY111" fmla="*/ 232516 h 285901"/>
                <a:gd name="connsiteX112" fmla="*/ 7726 w 777394"/>
                <a:gd name="connsiteY112" fmla="*/ 245851 h 285901"/>
                <a:gd name="connsiteX113" fmla="*/ 5821 w 777394"/>
                <a:gd name="connsiteY113" fmla="*/ 251566 h 285901"/>
                <a:gd name="connsiteX114" fmla="*/ 106 w 777394"/>
                <a:gd name="connsiteY114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29646 w 777394"/>
                <a:gd name="connsiteY102" fmla="*/ 95356 h 285901"/>
                <a:gd name="connsiteX103" fmla="*/ 93451 w 777394"/>
                <a:gd name="connsiteY103" fmla="*/ 125836 h 285901"/>
                <a:gd name="connsiteX104" fmla="*/ 61066 w 777394"/>
                <a:gd name="connsiteY104" fmla="*/ 158221 h 285901"/>
                <a:gd name="connsiteX105" fmla="*/ 49636 w 777394"/>
                <a:gd name="connsiteY105" fmla="*/ 169651 h 285901"/>
                <a:gd name="connsiteX106" fmla="*/ 42016 w 777394"/>
                <a:gd name="connsiteY106" fmla="*/ 177271 h 285901"/>
                <a:gd name="connsiteX107" fmla="*/ 36301 w 777394"/>
                <a:gd name="connsiteY107" fmla="*/ 184891 h 285901"/>
                <a:gd name="connsiteX108" fmla="*/ 26776 w 777394"/>
                <a:gd name="connsiteY108" fmla="*/ 203941 h 285901"/>
                <a:gd name="connsiteX109" fmla="*/ 15346 w 777394"/>
                <a:gd name="connsiteY109" fmla="*/ 226801 h 285901"/>
                <a:gd name="connsiteX110" fmla="*/ 11536 w 777394"/>
                <a:gd name="connsiteY110" fmla="*/ 232516 h 285901"/>
                <a:gd name="connsiteX111" fmla="*/ 7726 w 777394"/>
                <a:gd name="connsiteY111" fmla="*/ 245851 h 285901"/>
                <a:gd name="connsiteX112" fmla="*/ 5821 w 777394"/>
                <a:gd name="connsiteY112" fmla="*/ 251566 h 285901"/>
                <a:gd name="connsiteX113" fmla="*/ 106 w 777394"/>
                <a:gd name="connsiteY113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29646 w 777394"/>
                <a:gd name="connsiteY102" fmla="*/ 95356 h 285901"/>
                <a:gd name="connsiteX103" fmla="*/ 93451 w 777394"/>
                <a:gd name="connsiteY103" fmla="*/ 125836 h 285901"/>
                <a:gd name="connsiteX104" fmla="*/ 61066 w 777394"/>
                <a:gd name="connsiteY104" fmla="*/ 158221 h 285901"/>
                <a:gd name="connsiteX105" fmla="*/ 49636 w 777394"/>
                <a:gd name="connsiteY105" fmla="*/ 169651 h 285901"/>
                <a:gd name="connsiteX106" fmla="*/ 42016 w 777394"/>
                <a:gd name="connsiteY106" fmla="*/ 177271 h 285901"/>
                <a:gd name="connsiteX107" fmla="*/ 26776 w 777394"/>
                <a:gd name="connsiteY107" fmla="*/ 203941 h 285901"/>
                <a:gd name="connsiteX108" fmla="*/ 15346 w 777394"/>
                <a:gd name="connsiteY108" fmla="*/ 226801 h 285901"/>
                <a:gd name="connsiteX109" fmla="*/ 11536 w 777394"/>
                <a:gd name="connsiteY109" fmla="*/ 232516 h 285901"/>
                <a:gd name="connsiteX110" fmla="*/ 7726 w 777394"/>
                <a:gd name="connsiteY110" fmla="*/ 245851 h 285901"/>
                <a:gd name="connsiteX111" fmla="*/ 5821 w 777394"/>
                <a:gd name="connsiteY111" fmla="*/ 251566 h 285901"/>
                <a:gd name="connsiteX112" fmla="*/ 106 w 777394"/>
                <a:gd name="connsiteY112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29646 w 777394"/>
                <a:gd name="connsiteY102" fmla="*/ 95356 h 285901"/>
                <a:gd name="connsiteX103" fmla="*/ 93451 w 777394"/>
                <a:gd name="connsiteY103" fmla="*/ 125836 h 285901"/>
                <a:gd name="connsiteX104" fmla="*/ 61066 w 777394"/>
                <a:gd name="connsiteY104" fmla="*/ 158221 h 285901"/>
                <a:gd name="connsiteX105" fmla="*/ 49636 w 777394"/>
                <a:gd name="connsiteY105" fmla="*/ 169651 h 285901"/>
                <a:gd name="connsiteX106" fmla="*/ 26776 w 777394"/>
                <a:gd name="connsiteY106" fmla="*/ 203941 h 285901"/>
                <a:gd name="connsiteX107" fmla="*/ 15346 w 777394"/>
                <a:gd name="connsiteY107" fmla="*/ 226801 h 285901"/>
                <a:gd name="connsiteX108" fmla="*/ 11536 w 777394"/>
                <a:gd name="connsiteY108" fmla="*/ 232516 h 285901"/>
                <a:gd name="connsiteX109" fmla="*/ 7726 w 777394"/>
                <a:gd name="connsiteY109" fmla="*/ 245851 h 285901"/>
                <a:gd name="connsiteX110" fmla="*/ 5821 w 777394"/>
                <a:gd name="connsiteY110" fmla="*/ 251566 h 285901"/>
                <a:gd name="connsiteX111" fmla="*/ 106 w 777394"/>
                <a:gd name="connsiteY111" fmla="*/ 253471 h 285901"/>
                <a:gd name="connsiteX0" fmla="*/ 106 w 777394"/>
                <a:gd name="connsiteY0" fmla="*/ 253471 h 285901"/>
                <a:gd name="connsiteX1" fmla="*/ 11536 w 777394"/>
                <a:gd name="connsiteY1" fmla="*/ 259186 h 285901"/>
                <a:gd name="connsiteX2" fmla="*/ 24871 w 777394"/>
                <a:gd name="connsiteY2" fmla="*/ 268711 h 285901"/>
                <a:gd name="connsiteX3" fmla="*/ 26776 w 777394"/>
                <a:gd name="connsiteY3" fmla="*/ 274426 h 285901"/>
                <a:gd name="connsiteX4" fmla="*/ 32491 w 777394"/>
                <a:gd name="connsiteY4" fmla="*/ 276331 h 285901"/>
                <a:gd name="connsiteX5" fmla="*/ 45826 w 777394"/>
                <a:gd name="connsiteY5" fmla="*/ 282046 h 285901"/>
                <a:gd name="connsiteX6" fmla="*/ 51541 w 777394"/>
                <a:gd name="connsiteY6" fmla="*/ 285856 h 285901"/>
                <a:gd name="connsiteX7" fmla="*/ 55351 w 777394"/>
                <a:gd name="connsiteY7" fmla="*/ 280141 h 285901"/>
                <a:gd name="connsiteX8" fmla="*/ 61066 w 777394"/>
                <a:gd name="connsiteY8" fmla="*/ 272521 h 285901"/>
                <a:gd name="connsiteX9" fmla="*/ 66781 w 777394"/>
                <a:gd name="connsiteY9" fmla="*/ 257281 h 285901"/>
                <a:gd name="connsiteX10" fmla="*/ 68686 w 777394"/>
                <a:gd name="connsiteY10" fmla="*/ 251566 h 285901"/>
                <a:gd name="connsiteX11" fmla="*/ 78211 w 777394"/>
                <a:gd name="connsiteY11" fmla="*/ 238231 h 285901"/>
                <a:gd name="connsiteX12" fmla="*/ 83926 w 777394"/>
                <a:gd name="connsiteY12" fmla="*/ 226801 h 285901"/>
                <a:gd name="connsiteX13" fmla="*/ 93451 w 777394"/>
                <a:gd name="connsiteY13" fmla="*/ 209656 h 285901"/>
                <a:gd name="connsiteX14" fmla="*/ 104881 w 777394"/>
                <a:gd name="connsiteY14" fmla="*/ 200131 h 285901"/>
                <a:gd name="connsiteX15" fmla="*/ 106786 w 777394"/>
                <a:gd name="connsiteY15" fmla="*/ 194416 h 285901"/>
                <a:gd name="connsiteX16" fmla="*/ 118216 w 777394"/>
                <a:gd name="connsiteY16" fmla="*/ 188701 h 285901"/>
                <a:gd name="connsiteX17" fmla="*/ 133456 w 777394"/>
                <a:gd name="connsiteY17" fmla="*/ 182986 h 285901"/>
                <a:gd name="connsiteX18" fmla="*/ 146791 w 777394"/>
                <a:gd name="connsiteY18" fmla="*/ 175366 h 285901"/>
                <a:gd name="connsiteX19" fmla="*/ 163936 w 777394"/>
                <a:gd name="connsiteY19" fmla="*/ 163936 h 285901"/>
                <a:gd name="connsiteX20" fmla="*/ 171556 w 777394"/>
                <a:gd name="connsiteY20" fmla="*/ 162031 h 285901"/>
                <a:gd name="connsiteX21" fmla="*/ 177271 w 777394"/>
                <a:gd name="connsiteY21" fmla="*/ 158221 h 285901"/>
                <a:gd name="connsiteX22" fmla="*/ 181081 w 777394"/>
                <a:gd name="connsiteY22" fmla="*/ 152506 h 285901"/>
                <a:gd name="connsiteX23" fmla="*/ 186796 w 777394"/>
                <a:gd name="connsiteY23" fmla="*/ 150601 h 285901"/>
                <a:gd name="connsiteX24" fmla="*/ 203941 w 777394"/>
                <a:gd name="connsiteY24" fmla="*/ 137266 h 285901"/>
                <a:gd name="connsiteX25" fmla="*/ 205846 w 777394"/>
                <a:gd name="connsiteY25" fmla="*/ 131551 h 285901"/>
                <a:gd name="connsiteX26" fmla="*/ 232516 w 777394"/>
                <a:gd name="connsiteY26" fmla="*/ 112501 h 285901"/>
                <a:gd name="connsiteX27" fmla="*/ 243946 w 777394"/>
                <a:gd name="connsiteY27" fmla="*/ 108691 h 285901"/>
                <a:gd name="connsiteX28" fmla="*/ 257281 w 777394"/>
                <a:gd name="connsiteY28" fmla="*/ 101071 h 285901"/>
                <a:gd name="connsiteX29" fmla="*/ 264901 w 777394"/>
                <a:gd name="connsiteY29" fmla="*/ 99166 h 285901"/>
                <a:gd name="connsiteX30" fmla="*/ 282046 w 777394"/>
                <a:gd name="connsiteY30" fmla="*/ 93451 h 285901"/>
                <a:gd name="connsiteX31" fmla="*/ 289666 w 777394"/>
                <a:gd name="connsiteY31" fmla="*/ 91546 h 285901"/>
                <a:gd name="connsiteX32" fmla="*/ 323956 w 777394"/>
                <a:gd name="connsiteY32" fmla="*/ 89641 h 285901"/>
                <a:gd name="connsiteX33" fmla="*/ 375391 w 777394"/>
                <a:gd name="connsiteY33" fmla="*/ 85831 h 285901"/>
                <a:gd name="connsiteX34" fmla="*/ 476356 w 777394"/>
                <a:gd name="connsiteY34" fmla="*/ 83926 h 285901"/>
                <a:gd name="connsiteX35" fmla="*/ 527791 w 777394"/>
                <a:gd name="connsiteY35" fmla="*/ 85831 h 285901"/>
                <a:gd name="connsiteX36" fmla="*/ 543031 w 777394"/>
                <a:gd name="connsiteY36" fmla="*/ 89641 h 285901"/>
                <a:gd name="connsiteX37" fmla="*/ 548746 w 777394"/>
                <a:gd name="connsiteY37" fmla="*/ 93451 h 285901"/>
                <a:gd name="connsiteX38" fmla="*/ 556366 w 777394"/>
                <a:gd name="connsiteY38" fmla="*/ 97261 h 285901"/>
                <a:gd name="connsiteX39" fmla="*/ 571606 w 777394"/>
                <a:gd name="connsiteY39" fmla="*/ 104881 h 285901"/>
                <a:gd name="connsiteX40" fmla="*/ 581131 w 777394"/>
                <a:gd name="connsiteY40" fmla="*/ 114406 h 285901"/>
                <a:gd name="connsiteX41" fmla="*/ 586846 w 777394"/>
                <a:gd name="connsiteY41" fmla="*/ 118216 h 285901"/>
                <a:gd name="connsiteX42" fmla="*/ 605896 w 777394"/>
                <a:gd name="connsiteY42" fmla="*/ 133456 h 285901"/>
                <a:gd name="connsiteX43" fmla="*/ 613516 w 777394"/>
                <a:gd name="connsiteY43" fmla="*/ 142981 h 285901"/>
                <a:gd name="connsiteX44" fmla="*/ 626851 w 777394"/>
                <a:gd name="connsiteY44" fmla="*/ 156316 h 285901"/>
                <a:gd name="connsiteX45" fmla="*/ 634471 w 777394"/>
                <a:gd name="connsiteY45" fmla="*/ 167746 h 285901"/>
                <a:gd name="connsiteX46" fmla="*/ 643996 w 777394"/>
                <a:gd name="connsiteY46" fmla="*/ 182986 h 285901"/>
                <a:gd name="connsiteX47" fmla="*/ 653521 w 777394"/>
                <a:gd name="connsiteY47" fmla="*/ 200131 h 285901"/>
                <a:gd name="connsiteX48" fmla="*/ 663046 w 777394"/>
                <a:gd name="connsiteY48" fmla="*/ 211561 h 285901"/>
                <a:gd name="connsiteX49" fmla="*/ 674476 w 777394"/>
                <a:gd name="connsiteY49" fmla="*/ 219181 h 285901"/>
                <a:gd name="connsiteX50" fmla="*/ 678286 w 777394"/>
                <a:gd name="connsiteY50" fmla="*/ 224896 h 285901"/>
                <a:gd name="connsiteX51" fmla="*/ 684001 w 777394"/>
                <a:gd name="connsiteY51" fmla="*/ 226801 h 285901"/>
                <a:gd name="connsiteX52" fmla="*/ 687811 w 777394"/>
                <a:gd name="connsiteY52" fmla="*/ 234421 h 285901"/>
                <a:gd name="connsiteX53" fmla="*/ 703051 w 777394"/>
                <a:gd name="connsiteY53" fmla="*/ 251566 h 285901"/>
                <a:gd name="connsiteX54" fmla="*/ 706861 w 777394"/>
                <a:gd name="connsiteY54" fmla="*/ 266806 h 285901"/>
                <a:gd name="connsiteX55" fmla="*/ 716386 w 777394"/>
                <a:gd name="connsiteY55" fmla="*/ 276331 h 285901"/>
                <a:gd name="connsiteX56" fmla="*/ 729721 w 777394"/>
                <a:gd name="connsiteY56" fmla="*/ 274426 h 285901"/>
                <a:gd name="connsiteX57" fmla="*/ 733531 w 777394"/>
                <a:gd name="connsiteY57" fmla="*/ 268711 h 285901"/>
                <a:gd name="connsiteX58" fmla="*/ 746866 w 777394"/>
                <a:gd name="connsiteY58" fmla="*/ 255376 h 285901"/>
                <a:gd name="connsiteX59" fmla="*/ 752581 w 777394"/>
                <a:gd name="connsiteY59" fmla="*/ 249661 h 285901"/>
                <a:gd name="connsiteX60" fmla="*/ 760201 w 777394"/>
                <a:gd name="connsiteY60" fmla="*/ 243946 h 285901"/>
                <a:gd name="connsiteX61" fmla="*/ 767821 w 777394"/>
                <a:gd name="connsiteY61" fmla="*/ 240136 h 285901"/>
                <a:gd name="connsiteX62" fmla="*/ 773536 w 777394"/>
                <a:gd name="connsiteY62" fmla="*/ 236326 h 285901"/>
                <a:gd name="connsiteX63" fmla="*/ 777346 w 777394"/>
                <a:gd name="connsiteY63" fmla="*/ 230611 h 285901"/>
                <a:gd name="connsiteX64" fmla="*/ 771631 w 777394"/>
                <a:gd name="connsiteY64" fmla="*/ 200131 h 285901"/>
                <a:gd name="connsiteX65" fmla="*/ 767821 w 777394"/>
                <a:gd name="connsiteY65" fmla="*/ 194416 h 285901"/>
                <a:gd name="connsiteX66" fmla="*/ 762106 w 777394"/>
                <a:gd name="connsiteY66" fmla="*/ 181081 h 285901"/>
                <a:gd name="connsiteX67" fmla="*/ 754486 w 777394"/>
                <a:gd name="connsiteY67" fmla="*/ 165841 h 285901"/>
                <a:gd name="connsiteX68" fmla="*/ 744961 w 777394"/>
                <a:gd name="connsiteY68" fmla="*/ 152506 h 285901"/>
                <a:gd name="connsiteX69" fmla="*/ 743056 w 777394"/>
                <a:gd name="connsiteY69" fmla="*/ 146791 h 285901"/>
                <a:gd name="connsiteX70" fmla="*/ 733531 w 777394"/>
                <a:gd name="connsiteY70" fmla="*/ 135361 h 285901"/>
                <a:gd name="connsiteX71" fmla="*/ 725911 w 777394"/>
                <a:gd name="connsiteY71" fmla="*/ 129646 h 285901"/>
                <a:gd name="connsiteX72" fmla="*/ 720196 w 777394"/>
                <a:gd name="connsiteY72" fmla="*/ 127741 h 285901"/>
                <a:gd name="connsiteX73" fmla="*/ 708766 w 777394"/>
                <a:gd name="connsiteY73" fmla="*/ 118216 h 285901"/>
                <a:gd name="connsiteX74" fmla="*/ 703051 w 777394"/>
                <a:gd name="connsiteY74" fmla="*/ 112501 h 285901"/>
                <a:gd name="connsiteX75" fmla="*/ 697336 w 777394"/>
                <a:gd name="connsiteY75" fmla="*/ 108691 h 285901"/>
                <a:gd name="connsiteX76" fmla="*/ 689716 w 777394"/>
                <a:gd name="connsiteY76" fmla="*/ 102976 h 285901"/>
                <a:gd name="connsiteX77" fmla="*/ 682096 w 777394"/>
                <a:gd name="connsiteY77" fmla="*/ 99166 h 285901"/>
                <a:gd name="connsiteX78" fmla="*/ 670666 w 777394"/>
                <a:gd name="connsiteY78" fmla="*/ 95356 h 285901"/>
                <a:gd name="connsiteX79" fmla="*/ 661141 w 777394"/>
                <a:gd name="connsiteY79" fmla="*/ 89641 h 285901"/>
                <a:gd name="connsiteX80" fmla="*/ 645901 w 777394"/>
                <a:gd name="connsiteY80" fmla="*/ 83926 h 285901"/>
                <a:gd name="connsiteX81" fmla="*/ 632566 w 777394"/>
                <a:gd name="connsiteY81" fmla="*/ 74401 h 285901"/>
                <a:gd name="connsiteX82" fmla="*/ 626851 w 777394"/>
                <a:gd name="connsiteY82" fmla="*/ 72496 h 285901"/>
                <a:gd name="connsiteX83" fmla="*/ 615421 w 777394"/>
                <a:gd name="connsiteY83" fmla="*/ 64876 h 285901"/>
                <a:gd name="connsiteX84" fmla="*/ 603991 w 777394"/>
                <a:gd name="connsiteY84" fmla="*/ 59161 h 285901"/>
                <a:gd name="connsiteX85" fmla="*/ 598276 w 777394"/>
                <a:gd name="connsiteY85" fmla="*/ 55351 h 285901"/>
                <a:gd name="connsiteX86" fmla="*/ 590656 w 777394"/>
                <a:gd name="connsiteY86" fmla="*/ 49636 h 285901"/>
                <a:gd name="connsiteX87" fmla="*/ 579226 w 777394"/>
                <a:gd name="connsiteY87" fmla="*/ 45826 h 285901"/>
                <a:gd name="connsiteX88" fmla="*/ 573511 w 777394"/>
                <a:gd name="connsiteY88" fmla="*/ 42016 h 285901"/>
                <a:gd name="connsiteX89" fmla="*/ 562081 w 777394"/>
                <a:gd name="connsiteY89" fmla="*/ 38206 h 285901"/>
                <a:gd name="connsiteX90" fmla="*/ 554461 w 777394"/>
                <a:gd name="connsiteY90" fmla="*/ 34396 h 285901"/>
                <a:gd name="connsiteX91" fmla="*/ 543031 w 777394"/>
                <a:gd name="connsiteY91" fmla="*/ 26776 h 285901"/>
                <a:gd name="connsiteX92" fmla="*/ 527791 w 777394"/>
                <a:gd name="connsiteY92" fmla="*/ 22966 h 285901"/>
                <a:gd name="connsiteX93" fmla="*/ 499216 w 777394"/>
                <a:gd name="connsiteY93" fmla="*/ 17251 h 285901"/>
                <a:gd name="connsiteX94" fmla="*/ 491596 w 777394"/>
                <a:gd name="connsiteY94" fmla="*/ 15346 h 285901"/>
                <a:gd name="connsiteX95" fmla="*/ 478261 w 777394"/>
                <a:gd name="connsiteY95" fmla="*/ 11536 h 285901"/>
                <a:gd name="connsiteX96" fmla="*/ 415396 w 777394"/>
                <a:gd name="connsiteY96" fmla="*/ 3916 h 285901"/>
                <a:gd name="connsiteX97" fmla="*/ 365866 w 777394"/>
                <a:gd name="connsiteY97" fmla="*/ 106 h 285901"/>
                <a:gd name="connsiteX98" fmla="*/ 306811 w 777394"/>
                <a:gd name="connsiteY98" fmla="*/ 2011 h 285901"/>
                <a:gd name="connsiteX99" fmla="*/ 274426 w 777394"/>
                <a:gd name="connsiteY99" fmla="*/ 9631 h 285901"/>
                <a:gd name="connsiteX100" fmla="*/ 232516 w 777394"/>
                <a:gd name="connsiteY100" fmla="*/ 26776 h 285901"/>
                <a:gd name="connsiteX101" fmla="*/ 188701 w 777394"/>
                <a:gd name="connsiteY101" fmla="*/ 53446 h 285901"/>
                <a:gd name="connsiteX102" fmla="*/ 129646 w 777394"/>
                <a:gd name="connsiteY102" fmla="*/ 95356 h 285901"/>
                <a:gd name="connsiteX103" fmla="*/ 93451 w 777394"/>
                <a:gd name="connsiteY103" fmla="*/ 125836 h 285901"/>
                <a:gd name="connsiteX104" fmla="*/ 61066 w 777394"/>
                <a:gd name="connsiteY104" fmla="*/ 158221 h 285901"/>
                <a:gd name="connsiteX105" fmla="*/ 26776 w 777394"/>
                <a:gd name="connsiteY105" fmla="*/ 203941 h 285901"/>
                <a:gd name="connsiteX106" fmla="*/ 15346 w 777394"/>
                <a:gd name="connsiteY106" fmla="*/ 226801 h 285901"/>
                <a:gd name="connsiteX107" fmla="*/ 11536 w 777394"/>
                <a:gd name="connsiteY107" fmla="*/ 232516 h 285901"/>
                <a:gd name="connsiteX108" fmla="*/ 7726 w 777394"/>
                <a:gd name="connsiteY108" fmla="*/ 245851 h 285901"/>
                <a:gd name="connsiteX109" fmla="*/ 5821 w 777394"/>
                <a:gd name="connsiteY109" fmla="*/ 251566 h 285901"/>
                <a:gd name="connsiteX110" fmla="*/ 106 w 777394"/>
                <a:gd name="connsiteY110" fmla="*/ 253471 h 285901"/>
                <a:gd name="connsiteX0" fmla="*/ 124 w 777412"/>
                <a:gd name="connsiteY0" fmla="*/ 253471 h 285901"/>
                <a:gd name="connsiteX1" fmla="*/ 11554 w 777412"/>
                <a:gd name="connsiteY1" fmla="*/ 259186 h 285901"/>
                <a:gd name="connsiteX2" fmla="*/ 24889 w 777412"/>
                <a:gd name="connsiteY2" fmla="*/ 268711 h 285901"/>
                <a:gd name="connsiteX3" fmla="*/ 26794 w 777412"/>
                <a:gd name="connsiteY3" fmla="*/ 274426 h 285901"/>
                <a:gd name="connsiteX4" fmla="*/ 32509 w 777412"/>
                <a:gd name="connsiteY4" fmla="*/ 276331 h 285901"/>
                <a:gd name="connsiteX5" fmla="*/ 45844 w 777412"/>
                <a:gd name="connsiteY5" fmla="*/ 282046 h 285901"/>
                <a:gd name="connsiteX6" fmla="*/ 51559 w 777412"/>
                <a:gd name="connsiteY6" fmla="*/ 285856 h 285901"/>
                <a:gd name="connsiteX7" fmla="*/ 55369 w 777412"/>
                <a:gd name="connsiteY7" fmla="*/ 280141 h 285901"/>
                <a:gd name="connsiteX8" fmla="*/ 61084 w 777412"/>
                <a:gd name="connsiteY8" fmla="*/ 272521 h 285901"/>
                <a:gd name="connsiteX9" fmla="*/ 66799 w 777412"/>
                <a:gd name="connsiteY9" fmla="*/ 257281 h 285901"/>
                <a:gd name="connsiteX10" fmla="*/ 68704 w 777412"/>
                <a:gd name="connsiteY10" fmla="*/ 251566 h 285901"/>
                <a:gd name="connsiteX11" fmla="*/ 78229 w 777412"/>
                <a:gd name="connsiteY11" fmla="*/ 238231 h 285901"/>
                <a:gd name="connsiteX12" fmla="*/ 83944 w 777412"/>
                <a:gd name="connsiteY12" fmla="*/ 226801 h 285901"/>
                <a:gd name="connsiteX13" fmla="*/ 93469 w 777412"/>
                <a:gd name="connsiteY13" fmla="*/ 209656 h 285901"/>
                <a:gd name="connsiteX14" fmla="*/ 104899 w 777412"/>
                <a:gd name="connsiteY14" fmla="*/ 200131 h 285901"/>
                <a:gd name="connsiteX15" fmla="*/ 106804 w 777412"/>
                <a:gd name="connsiteY15" fmla="*/ 194416 h 285901"/>
                <a:gd name="connsiteX16" fmla="*/ 118234 w 777412"/>
                <a:gd name="connsiteY16" fmla="*/ 188701 h 285901"/>
                <a:gd name="connsiteX17" fmla="*/ 133474 w 777412"/>
                <a:gd name="connsiteY17" fmla="*/ 182986 h 285901"/>
                <a:gd name="connsiteX18" fmla="*/ 146809 w 777412"/>
                <a:gd name="connsiteY18" fmla="*/ 175366 h 285901"/>
                <a:gd name="connsiteX19" fmla="*/ 163954 w 777412"/>
                <a:gd name="connsiteY19" fmla="*/ 163936 h 285901"/>
                <a:gd name="connsiteX20" fmla="*/ 171574 w 777412"/>
                <a:gd name="connsiteY20" fmla="*/ 162031 h 285901"/>
                <a:gd name="connsiteX21" fmla="*/ 177289 w 777412"/>
                <a:gd name="connsiteY21" fmla="*/ 158221 h 285901"/>
                <a:gd name="connsiteX22" fmla="*/ 181099 w 777412"/>
                <a:gd name="connsiteY22" fmla="*/ 152506 h 285901"/>
                <a:gd name="connsiteX23" fmla="*/ 186814 w 777412"/>
                <a:gd name="connsiteY23" fmla="*/ 150601 h 285901"/>
                <a:gd name="connsiteX24" fmla="*/ 203959 w 777412"/>
                <a:gd name="connsiteY24" fmla="*/ 137266 h 285901"/>
                <a:gd name="connsiteX25" fmla="*/ 205864 w 777412"/>
                <a:gd name="connsiteY25" fmla="*/ 131551 h 285901"/>
                <a:gd name="connsiteX26" fmla="*/ 232534 w 777412"/>
                <a:gd name="connsiteY26" fmla="*/ 112501 h 285901"/>
                <a:gd name="connsiteX27" fmla="*/ 243964 w 777412"/>
                <a:gd name="connsiteY27" fmla="*/ 108691 h 285901"/>
                <a:gd name="connsiteX28" fmla="*/ 257299 w 777412"/>
                <a:gd name="connsiteY28" fmla="*/ 101071 h 285901"/>
                <a:gd name="connsiteX29" fmla="*/ 264919 w 777412"/>
                <a:gd name="connsiteY29" fmla="*/ 99166 h 285901"/>
                <a:gd name="connsiteX30" fmla="*/ 282064 w 777412"/>
                <a:gd name="connsiteY30" fmla="*/ 93451 h 285901"/>
                <a:gd name="connsiteX31" fmla="*/ 289684 w 777412"/>
                <a:gd name="connsiteY31" fmla="*/ 91546 h 285901"/>
                <a:gd name="connsiteX32" fmla="*/ 323974 w 777412"/>
                <a:gd name="connsiteY32" fmla="*/ 89641 h 285901"/>
                <a:gd name="connsiteX33" fmla="*/ 375409 w 777412"/>
                <a:gd name="connsiteY33" fmla="*/ 85831 h 285901"/>
                <a:gd name="connsiteX34" fmla="*/ 476374 w 777412"/>
                <a:gd name="connsiteY34" fmla="*/ 83926 h 285901"/>
                <a:gd name="connsiteX35" fmla="*/ 527809 w 777412"/>
                <a:gd name="connsiteY35" fmla="*/ 85831 h 285901"/>
                <a:gd name="connsiteX36" fmla="*/ 543049 w 777412"/>
                <a:gd name="connsiteY36" fmla="*/ 89641 h 285901"/>
                <a:gd name="connsiteX37" fmla="*/ 548764 w 777412"/>
                <a:gd name="connsiteY37" fmla="*/ 93451 h 285901"/>
                <a:gd name="connsiteX38" fmla="*/ 556384 w 777412"/>
                <a:gd name="connsiteY38" fmla="*/ 97261 h 285901"/>
                <a:gd name="connsiteX39" fmla="*/ 571624 w 777412"/>
                <a:gd name="connsiteY39" fmla="*/ 104881 h 285901"/>
                <a:gd name="connsiteX40" fmla="*/ 581149 w 777412"/>
                <a:gd name="connsiteY40" fmla="*/ 114406 h 285901"/>
                <a:gd name="connsiteX41" fmla="*/ 586864 w 777412"/>
                <a:gd name="connsiteY41" fmla="*/ 118216 h 285901"/>
                <a:gd name="connsiteX42" fmla="*/ 605914 w 777412"/>
                <a:gd name="connsiteY42" fmla="*/ 133456 h 285901"/>
                <a:gd name="connsiteX43" fmla="*/ 613534 w 777412"/>
                <a:gd name="connsiteY43" fmla="*/ 142981 h 285901"/>
                <a:gd name="connsiteX44" fmla="*/ 626869 w 777412"/>
                <a:gd name="connsiteY44" fmla="*/ 156316 h 285901"/>
                <a:gd name="connsiteX45" fmla="*/ 634489 w 777412"/>
                <a:gd name="connsiteY45" fmla="*/ 167746 h 285901"/>
                <a:gd name="connsiteX46" fmla="*/ 644014 w 777412"/>
                <a:gd name="connsiteY46" fmla="*/ 182986 h 285901"/>
                <a:gd name="connsiteX47" fmla="*/ 653539 w 777412"/>
                <a:gd name="connsiteY47" fmla="*/ 200131 h 285901"/>
                <a:gd name="connsiteX48" fmla="*/ 663064 w 777412"/>
                <a:gd name="connsiteY48" fmla="*/ 211561 h 285901"/>
                <a:gd name="connsiteX49" fmla="*/ 674494 w 777412"/>
                <a:gd name="connsiteY49" fmla="*/ 219181 h 285901"/>
                <a:gd name="connsiteX50" fmla="*/ 678304 w 777412"/>
                <a:gd name="connsiteY50" fmla="*/ 224896 h 285901"/>
                <a:gd name="connsiteX51" fmla="*/ 684019 w 777412"/>
                <a:gd name="connsiteY51" fmla="*/ 226801 h 285901"/>
                <a:gd name="connsiteX52" fmla="*/ 687829 w 777412"/>
                <a:gd name="connsiteY52" fmla="*/ 234421 h 285901"/>
                <a:gd name="connsiteX53" fmla="*/ 703069 w 777412"/>
                <a:gd name="connsiteY53" fmla="*/ 251566 h 285901"/>
                <a:gd name="connsiteX54" fmla="*/ 706879 w 777412"/>
                <a:gd name="connsiteY54" fmla="*/ 266806 h 285901"/>
                <a:gd name="connsiteX55" fmla="*/ 716404 w 777412"/>
                <a:gd name="connsiteY55" fmla="*/ 276331 h 285901"/>
                <a:gd name="connsiteX56" fmla="*/ 729739 w 777412"/>
                <a:gd name="connsiteY56" fmla="*/ 274426 h 285901"/>
                <a:gd name="connsiteX57" fmla="*/ 733549 w 777412"/>
                <a:gd name="connsiteY57" fmla="*/ 268711 h 285901"/>
                <a:gd name="connsiteX58" fmla="*/ 746884 w 777412"/>
                <a:gd name="connsiteY58" fmla="*/ 255376 h 285901"/>
                <a:gd name="connsiteX59" fmla="*/ 752599 w 777412"/>
                <a:gd name="connsiteY59" fmla="*/ 249661 h 285901"/>
                <a:gd name="connsiteX60" fmla="*/ 760219 w 777412"/>
                <a:gd name="connsiteY60" fmla="*/ 243946 h 285901"/>
                <a:gd name="connsiteX61" fmla="*/ 767839 w 777412"/>
                <a:gd name="connsiteY61" fmla="*/ 240136 h 285901"/>
                <a:gd name="connsiteX62" fmla="*/ 773554 w 777412"/>
                <a:gd name="connsiteY62" fmla="*/ 236326 h 285901"/>
                <a:gd name="connsiteX63" fmla="*/ 777364 w 777412"/>
                <a:gd name="connsiteY63" fmla="*/ 230611 h 285901"/>
                <a:gd name="connsiteX64" fmla="*/ 771649 w 777412"/>
                <a:gd name="connsiteY64" fmla="*/ 200131 h 285901"/>
                <a:gd name="connsiteX65" fmla="*/ 767839 w 777412"/>
                <a:gd name="connsiteY65" fmla="*/ 194416 h 285901"/>
                <a:gd name="connsiteX66" fmla="*/ 762124 w 777412"/>
                <a:gd name="connsiteY66" fmla="*/ 181081 h 285901"/>
                <a:gd name="connsiteX67" fmla="*/ 754504 w 777412"/>
                <a:gd name="connsiteY67" fmla="*/ 165841 h 285901"/>
                <a:gd name="connsiteX68" fmla="*/ 744979 w 777412"/>
                <a:gd name="connsiteY68" fmla="*/ 152506 h 285901"/>
                <a:gd name="connsiteX69" fmla="*/ 743074 w 777412"/>
                <a:gd name="connsiteY69" fmla="*/ 146791 h 285901"/>
                <a:gd name="connsiteX70" fmla="*/ 733549 w 777412"/>
                <a:gd name="connsiteY70" fmla="*/ 135361 h 285901"/>
                <a:gd name="connsiteX71" fmla="*/ 725929 w 777412"/>
                <a:gd name="connsiteY71" fmla="*/ 129646 h 285901"/>
                <a:gd name="connsiteX72" fmla="*/ 720214 w 777412"/>
                <a:gd name="connsiteY72" fmla="*/ 127741 h 285901"/>
                <a:gd name="connsiteX73" fmla="*/ 708784 w 777412"/>
                <a:gd name="connsiteY73" fmla="*/ 118216 h 285901"/>
                <a:gd name="connsiteX74" fmla="*/ 703069 w 777412"/>
                <a:gd name="connsiteY74" fmla="*/ 112501 h 285901"/>
                <a:gd name="connsiteX75" fmla="*/ 697354 w 777412"/>
                <a:gd name="connsiteY75" fmla="*/ 108691 h 285901"/>
                <a:gd name="connsiteX76" fmla="*/ 689734 w 777412"/>
                <a:gd name="connsiteY76" fmla="*/ 102976 h 285901"/>
                <a:gd name="connsiteX77" fmla="*/ 682114 w 777412"/>
                <a:gd name="connsiteY77" fmla="*/ 99166 h 285901"/>
                <a:gd name="connsiteX78" fmla="*/ 670684 w 777412"/>
                <a:gd name="connsiteY78" fmla="*/ 95356 h 285901"/>
                <a:gd name="connsiteX79" fmla="*/ 661159 w 777412"/>
                <a:gd name="connsiteY79" fmla="*/ 89641 h 285901"/>
                <a:gd name="connsiteX80" fmla="*/ 645919 w 777412"/>
                <a:gd name="connsiteY80" fmla="*/ 83926 h 285901"/>
                <a:gd name="connsiteX81" fmla="*/ 632584 w 777412"/>
                <a:gd name="connsiteY81" fmla="*/ 74401 h 285901"/>
                <a:gd name="connsiteX82" fmla="*/ 626869 w 777412"/>
                <a:gd name="connsiteY82" fmla="*/ 72496 h 285901"/>
                <a:gd name="connsiteX83" fmla="*/ 615439 w 777412"/>
                <a:gd name="connsiteY83" fmla="*/ 64876 h 285901"/>
                <a:gd name="connsiteX84" fmla="*/ 604009 w 777412"/>
                <a:gd name="connsiteY84" fmla="*/ 59161 h 285901"/>
                <a:gd name="connsiteX85" fmla="*/ 598294 w 777412"/>
                <a:gd name="connsiteY85" fmla="*/ 55351 h 285901"/>
                <a:gd name="connsiteX86" fmla="*/ 590674 w 777412"/>
                <a:gd name="connsiteY86" fmla="*/ 49636 h 285901"/>
                <a:gd name="connsiteX87" fmla="*/ 579244 w 777412"/>
                <a:gd name="connsiteY87" fmla="*/ 45826 h 285901"/>
                <a:gd name="connsiteX88" fmla="*/ 573529 w 777412"/>
                <a:gd name="connsiteY88" fmla="*/ 42016 h 285901"/>
                <a:gd name="connsiteX89" fmla="*/ 562099 w 777412"/>
                <a:gd name="connsiteY89" fmla="*/ 38206 h 285901"/>
                <a:gd name="connsiteX90" fmla="*/ 554479 w 777412"/>
                <a:gd name="connsiteY90" fmla="*/ 34396 h 285901"/>
                <a:gd name="connsiteX91" fmla="*/ 543049 w 777412"/>
                <a:gd name="connsiteY91" fmla="*/ 26776 h 285901"/>
                <a:gd name="connsiteX92" fmla="*/ 527809 w 777412"/>
                <a:gd name="connsiteY92" fmla="*/ 22966 h 285901"/>
                <a:gd name="connsiteX93" fmla="*/ 499234 w 777412"/>
                <a:gd name="connsiteY93" fmla="*/ 17251 h 285901"/>
                <a:gd name="connsiteX94" fmla="*/ 491614 w 777412"/>
                <a:gd name="connsiteY94" fmla="*/ 15346 h 285901"/>
                <a:gd name="connsiteX95" fmla="*/ 478279 w 777412"/>
                <a:gd name="connsiteY95" fmla="*/ 11536 h 285901"/>
                <a:gd name="connsiteX96" fmla="*/ 415414 w 777412"/>
                <a:gd name="connsiteY96" fmla="*/ 3916 h 285901"/>
                <a:gd name="connsiteX97" fmla="*/ 365884 w 777412"/>
                <a:gd name="connsiteY97" fmla="*/ 106 h 285901"/>
                <a:gd name="connsiteX98" fmla="*/ 306829 w 777412"/>
                <a:gd name="connsiteY98" fmla="*/ 2011 h 285901"/>
                <a:gd name="connsiteX99" fmla="*/ 274444 w 777412"/>
                <a:gd name="connsiteY99" fmla="*/ 9631 h 285901"/>
                <a:gd name="connsiteX100" fmla="*/ 232534 w 777412"/>
                <a:gd name="connsiteY100" fmla="*/ 26776 h 285901"/>
                <a:gd name="connsiteX101" fmla="*/ 188719 w 777412"/>
                <a:gd name="connsiteY101" fmla="*/ 53446 h 285901"/>
                <a:gd name="connsiteX102" fmla="*/ 129664 w 777412"/>
                <a:gd name="connsiteY102" fmla="*/ 95356 h 285901"/>
                <a:gd name="connsiteX103" fmla="*/ 93469 w 777412"/>
                <a:gd name="connsiteY103" fmla="*/ 125836 h 285901"/>
                <a:gd name="connsiteX104" fmla="*/ 61084 w 777412"/>
                <a:gd name="connsiteY104" fmla="*/ 158221 h 285901"/>
                <a:gd name="connsiteX105" fmla="*/ 26794 w 777412"/>
                <a:gd name="connsiteY105" fmla="*/ 203941 h 285901"/>
                <a:gd name="connsiteX106" fmla="*/ 15364 w 777412"/>
                <a:gd name="connsiteY106" fmla="*/ 226801 h 285901"/>
                <a:gd name="connsiteX107" fmla="*/ 11554 w 777412"/>
                <a:gd name="connsiteY107" fmla="*/ 232516 h 285901"/>
                <a:gd name="connsiteX108" fmla="*/ 5839 w 777412"/>
                <a:gd name="connsiteY108" fmla="*/ 251566 h 285901"/>
                <a:gd name="connsiteX109" fmla="*/ 124 w 777412"/>
                <a:gd name="connsiteY109" fmla="*/ 253471 h 285901"/>
                <a:gd name="connsiteX0" fmla="*/ 0 w 771573"/>
                <a:gd name="connsiteY0" fmla="*/ 251566 h 285901"/>
                <a:gd name="connsiteX1" fmla="*/ 5715 w 771573"/>
                <a:gd name="connsiteY1" fmla="*/ 259186 h 285901"/>
                <a:gd name="connsiteX2" fmla="*/ 19050 w 771573"/>
                <a:gd name="connsiteY2" fmla="*/ 268711 h 285901"/>
                <a:gd name="connsiteX3" fmla="*/ 20955 w 771573"/>
                <a:gd name="connsiteY3" fmla="*/ 274426 h 285901"/>
                <a:gd name="connsiteX4" fmla="*/ 26670 w 771573"/>
                <a:gd name="connsiteY4" fmla="*/ 276331 h 285901"/>
                <a:gd name="connsiteX5" fmla="*/ 40005 w 771573"/>
                <a:gd name="connsiteY5" fmla="*/ 282046 h 285901"/>
                <a:gd name="connsiteX6" fmla="*/ 45720 w 771573"/>
                <a:gd name="connsiteY6" fmla="*/ 285856 h 285901"/>
                <a:gd name="connsiteX7" fmla="*/ 49530 w 771573"/>
                <a:gd name="connsiteY7" fmla="*/ 280141 h 285901"/>
                <a:gd name="connsiteX8" fmla="*/ 55245 w 771573"/>
                <a:gd name="connsiteY8" fmla="*/ 272521 h 285901"/>
                <a:gd name="connsiteX9" fmla="*/ 60960 w 771573"/>
                <a:gd name="connsiteY9" fmla="*/ 257281 h 285901"/>
                <a:gd name="connsiteX10" fmla="*/ 62865 w 771573"/>
                <a:gd name="connsiteY10" fmla="*/ 251566 h 285901"/>
                <a:gd name="connsiteX11" fmla="*/ 72390 w 771573"/>
                <a:gd name="connsiteY11" fmla="*/ 238231 h 285901"/>
                <a:gd name="connsiteX12" fmla="*/ 78105 w 771573"/>
                <a:gd name="connsiteY12" fmla="*/ 226801 h 285901"/>
                <a:gd name="connsiteX13" fmla="*/ 87630 w 771573"/>
                <a:gd name="connsiteY13" fmla="*/ 209656 h 285901"/>
                <a:gd name="connsiteX14" fmla="*/ 99060 w 771573"/>
                <a:gd name="connsiteY14" fmla="*/ 200131 h 285901"/>
                <a:gd name="connsiteX15" fmla="*/ 100965 w 771573"/>
                <a:gd name="connsiteY15" fmla="*/ 194416 h 285901"/>
                <a:gd name="connsiteX16" fmla="*/ 112395 w 771573"/>
                <a:gd name="connsiteY16" fmla="*/ 188701 h 285901"/>
                <a:gd name="connsiteX17" fmla="*/ 127635 w 771573"/>
                <a:gd name="connsiteY17" fmla="*/ 182986 h 285901"/>
                <a:gd name="connsiteX18" fmla="*/ 140970 w 771573"/>
                <a:gd name="connsiteY18" fmla="*/ 175366 h 285901"/>
                <a:gd name="connsiteX19" fmla="*/ 158115 w 771573"/>
                <a:gd name="connsiteY19" fmla="*/ 163936 h 285901"/>
                <a:gd name="connsiteX20" fmla="*/ 165735 w 771573"/>
                <a:gd name="connsiteY20" fmla="*/ 162031 h 285901"/>
                <a:gd name="connsiteX21" fmla="*/ 171450 w 771573"/>
                <a:gd name="connsiteY21" fmla="*/ 158221 h 285901"/>
                <a:gd name="connsiteX22" fmla="*/ 175260 w 771573"/>
                <a:gd name="connsiteY22" fmla="*/ 152506 h 285901"/>
                <a:gd name="connsiteX23" fmla="*/ 180975 w 771573"/>
                <a:gd name="connsiteY23" fmla="*/ 150601 h 285901"/>
                <a:gd name="connsiteX24" fmla="*/ 198120 w 771573"/>
                <a:gd name="connsiteY24" fmla="*/ 137266 h 285901"/>
                <a:gd name="connsiteX25" fmla="*/ 200025 w 771573"/>
                <a:gd name="connsiteY25" fmla="*/ 131551 h 285901"/>
                <a:gd name="connsiteX26" fmla="*/ 226695 w 771573"/>
                <a:gd name="connsiteY26" fmla="*/ 112501 h 285901"/>
                <a:gd name="connsiteX27" fmla="*/ 238125 w 771573"/>
                <a:gd name="connsiteY27" fmla="*/ 108691 h 285901"/>
                <a:gd name="connsiteX28" fmla="*/ 251460 w 771573"/>
                <a:gd name="connsiteY28" fmla="*/ 101071 h 285901"/>
                <a:gd name="connsiteX29" fmla="*/ 259080 w 771573"/>
                <a:gd name="connsiteY29" fmla="*/ 99166 h 285901"/>
                <a:gd name="connsiteX30" fmla="*/ 276225 w 771573"/>
                <a:gd name="connsiteY30" fmla="*/ 93451 h 285901"/>
                <a:gd name="connsiteX31" fmla="*/ 283845 w 771573"/>
                <a:gd name="connsiteY31" fmla="*/ 91546 h 285901"/>
                <a:gd name="connsiteX32" fmla="*/ 318135 w 771573"/>
                <a:gd name="connsiteY32" fmla="*/ 89641 h 285901"/>
                <a:gd name="connsiteX33" fmla="*/ 369570 w 771573"/>
                <a:gd name="connsiteY33" fmla="*/ 85831 h 285901"/>
                <a:gd name="connsiteX34" fmla="*/ 470535 w 771573"/>
                <a:gd name="connsiteY34" fmla="*/ 83926 h 285901"/>
                <a:gd name="connsiteX35" fmla="*/ 521970 w 771573"/>
                <a:gd name="connsiteY35" fmla="*/ 85831 h 285901"/>
                <a:gd name="connsiteX36" fmla="*/ 537210 w 771573"/>
                <a:gd name="connsiteY36" fmla="*/ 89641 h 285901"/>
                <a:gd name="connsiteX37" fmla="*/ 542925 w 771573"/>
                <a:gd name="connsiteY37" fmla="*/ 93451 h 285901"/>
                <a:gd name="connsiteX38" fmla="*/ 550545 w 771573"/>
                <a:gd name="connsiteY38" fmla="*/ 97261 h 285901"/>
                <a:gd name="connsiteX39" fmla="*/ 565785 w 771573"/>
                <a:gd name="connsiteY39" fmla="*/ 104881 h 285901"/>
                <a:gd name="connsiteX40" fmla="*/ 575310 w 771573"/>
                <a:gd name="connsiteY40" fmla="*/ 114406 h 285901"/>
                <a:gd name="connsiteX41" fmla="*/ 581025 w 771573"/>
                <a:gd name="connsiteY41" fmla="*/ 118216 h 285901"/>
                <a:gd name="connsiteX42" fmla="*/ 600075 w 771573"/>
                <a:gd name="connsiteY42" fmla="*/ 133456 h 285901"/>
                <a:gd name="connsiteX43" fmla="*/ 607695 w 771573"/>
                <a:gd name="connsiteY43" fmla="*/ 142981 h 285901"/>
                <a:gd name="connsiteX44" fmla="*/ 621030 w 771573"/>
                <a:gd name="connsiteY44" fmla="*/ 156316 h 285901"/>
                <a:gd name="connsiteX45" fmla="*/ 628650 w 771573"/>
                <a:gd name="connsiteY45" fmla="*/ 167746 h 285901"/>
                <a:gd name="connsiteX46" fmla="*/ 638175 w 771573"/>
                <a:gd name="connsiteY46" fmla="*/ 182986 h 285901"/>
                <a:gd name="connsiteX47" fmla="*/ 647700 w 771573"/>
                <a:gd name="connsiteY47" fmla="*/ 200131 h 285901"/>
                <a:gd name="connsiteX48" fmla="*/ 657225 w 771573"/>
                <a:gd name="connsiteY48" fmla="*/ 211561 h 285901"/>
                <a:gd name="connsiteX49" fmla="*/ 668655 w 771573"/>
                <a:gd name="connsiteY49" fmla="*/ 219181 h 285901"/>
                <a:gd name="connsiteX50" fmla="*/ 672465 w 771573"/>
                <a:gd name="connsiteY50" fmla="*/ 224896 h 285901"/>
                <a:gd name="connsiteX51" fmla="*/ 678180 w 771573"/>
                <a:gd name="connsiteY51" fmla="*/ 226801 h 285901"/>
                <a:gd name="connsiteX52" fmla="*/ 681990 w 771573"/>
                <a:gd name="connsiteY52" fmla="*/ 234421 h 285901"/>
                <a:gd name="connsiteX53" fmla="*/ 697230 w 771573"/>
                <a:gd name="connsiteY53" fmla="*/ 251566 h 285901"/>
                <a:gd name="connsiteX54" fmla="*/ 701040 w 771573"/>
                <a:gd name="connsiteY54" fmla="*/ 266806 h 285901"/>
                <a:gd name="connsiteX55" fmla="*/ 710565 w 771573"/>
                <a:gd name="connsiteY55" fmla="*/ 276331 h 285901"/>
                <a:gd name="connsiteX56" fmla="*/ 723900 w 771573"/>
                <a:gd name="connsiteY56" fmla="*/ 274426 h 285901"/>
                <a:gd name="connsiteX57" fmla="*/ 727710 w 771573"/>
                <a:gd name="connsiteY57" fmla="*/ 268711 h 285901"/>
                <a:gd name="connsiteX58" fmla="*/ 741045 w 771573"/>
                <a:gd name="connsiteY58" fmla="*/ 255376 h 285901"/>
                <a:gd name="connsiteX59" fmla="*/ 746760 w 771573"/>
                <a:gd name="connsiteY59" fmla="*/ 249661 h 285901"/>
                <a:gd name="connsiteX60" fmla="*/ 754380 w 771573"/>
                <a:gd name="connsiteY60" fmla="*/ 243946 h 285901"/>
                <a:gd name="connsiteX61" fmla="*/ 762000 w 771573"/>
                <a:gd name="connsiteY61" fmla="*/ 240136 h 285901"/>
                <a:gd name="connsiteX62" fmla="*/ 767715 w 771573"/>
                <a:gd name="connsiteY62" fmla="*/ 236326 h 285901"/>
                <a:gd name="connsiteX63" fmla="*/ 771525 w 771573"/>
                <a:gd name="connsiteY63" fmla="*/ 230611 h 285901"/>
                <a:gd name="connsiteX64" fmla="*/ 765810 w 771573"/>
                <a:gd name="connsiteY64" fmla="*/ 200131 h 285901"/>
                <a:gd name="connsiteX65" fmla="*/ 762000 w 771573"/>
                <a:gd name="connsiteY65" fmla="*/ 194416 h 285901"/>
                <a:gd name="connsiteX66" fmla="*/ 756285 w 771573"/>
                <a:gd name="connsiteY66" fmla="*/ 181081 h 285901"/>
                <a:gd name="connsiteX67" fmla="*/ 748665 w 771573"/>
                <a:gd name="connsiteY67" fmla="*/ 165841 h 285901"/>
                <a:gd name="connsiteX68" fmla="*/ 739140 w 771573"/>
                <a:gd name="connsiteY68" fmla="*/ 152506 h 285901"/>
                <a:gd name="connsiteX69" fmla="*/ 737235 w 771573"/>
                <a:gd name="connsiteY69" fmla="*/ 146791 h 285901"/>
                <a:gd name="connsiteX70" fmla="*/ 727710 w 771573"/>
                <a:gd name="connsiteY70" fmla="*/ 135361 h 285901"/>
                <a:gd name="connsiteX71" fmla="*/ 720090 w 771573"/>
                <a:gd name="connsiteY71" fmla="*/ 129646 h 285901"/>
                <a:gd name="connsiteX72" fmla="*/ 714375 w 771573"/>
                <a:gd name="connsiteY72" fmla="*/ 127741 h 285901"/>
                <a:gd name="connsiteX73" fmla="*/ 702945 w 771573"/>
                <a:gd name="connsiteY73" fmla="*/ 118216 h 285901"/>
                <a:gd name="connsiteX74" fmla="*/ 697230 w 771573"/>
                <a:gd name="connsiteY74" fmla="*/ 112501 h 285901"/>
                <a:gd name="connsiteX75" fmla="*/ 691515 w 771573"/>
                <a:gd name="connsiteY75" fmla="*/ 108691 h 285901"/>
                <a:gd name="connsiteX76" fmla="*/ 683895 w 771573"/>
                <a:gd name="connsiteY76" fmla="*/ 102976 h 285901"/>
                <a:gd name="connsiteX77" fmla="*/ 676275 w 771573"/>
                <a:gd name="connsiteY77" fmla="*/ 99166 h 285901"/>
                <a:gd name="connsiteX78" fmla="*/ 664845 w 771573"/>
                <a:gd name="connsiteY78" fmla="*/ 95356 h 285901"/>
                <a:gd name="connsiteX79" fmla="*/ 655320 w 771573"/>
                <a:gd name="connsiteY79" fmla="*/ 89641 h 285901"/>
                <a:gd name="connsiteX80" fmla="*/ 640080 w 771573"/>
                <a:gd name="connsiteY80" fmla="*/ 83926 h 285901"/>
                <a:gd name="connsiteX81" fmla="*/ 626745 w 771573"/>
                <a:gd name="connsiteY81" fmla="*/ 74401 h 285901"/>
                <a:gd name="connsiteX82" fmla="*/ 621030 w 771573"/>
                <a:gd name="connsiteY82" fmla="*/ 72496 h 285901"/>
                <a:gd name="connsiteX83" fmla="*/ 609600 w 771573"/>
                <a:gd name="connsiteY83" fmla="*/ 64876 h 285901"/>
                <a:gd name="connsiteX84" fmla="*/ 598170 w 771573"/>
                <a:gd name="connsiteY84" fmla="*/ 59161 h 285901"/>
                <a:gd name="connsiteX85" fmla="*/ 592455 w 771573"/>
                <a:gd name="connsiteY85" fmla="*/ 55351 h 285901"/>
                <a:gd name="connsiteX86" fmla="*/ 584835 w 771573"/>
                <a:gd name="connsiteY86" fmla="*/ 49636 h 285901"/>
                <a:gd name="connsiteX87" fmla="*/ 573405 w 771573"/>
                <a:gd name="connsiteY87" fmla="*/ 45826 h 285901"/>
                <a:gd name="connsiteX88" fmla="*/ 567690 w 771573"/>
                <a:gd name="connsiteY88" fmla="*/ 42016 h 285901"/>
                <a:gd name="connsiteX89" fmla="*/ 556260 w 771573"/>
                <a:gd name="connsiteY89" fmla="*/ 38206 h 285901"/>
                <a:gd name="connsiteX90" fmla="*/ 548640 w 771573"/>
                <a:gd name="connsiteY90" fmla="*/ 34396 h 285901"/>
                <a:gd name="connsiteX91" fmla="*/ 537210 w 771573"/>
                <a:gd name="connsiteY91" fmla="*/ 26776 h 285901"/>
                <a:gd name="connsiteX92" fmla="*/ 521970 w 771573"/>
                <a:gd name="connsiteY92" fmla="*/ 22966 h 285901"/>
                <a:gd name="connsiteX93" fmla="*/ 493395 w 771573"/>
                <a:gd name="connsiteY93" fmla="*/ 17251 h 285901"/>
                <a:gd name="connsiteX94" fmla="*/ 485775 w 771573"/>
                <a:gd name="connsiteY94" fmla="*/ 15346 h 285901"/>
                <a:gd name="connsiteX95" fmla="*/ 472440 w 771573"/>
                <a:gd name="connsiteY95" fmla="*/ 11536 h 285901"/>
                <a:gd name="connsiteX96" fmla="*/ 409575 w 771573"/>
                <a:gd name="connsiteY96" fmla="*/ 3916 h 285901"/>
                <a:gd name="connsiteX97" fmla="*/ 360045 w 771573"/>
                <a:gd name="connsiteY97" fmla="*/ 106 h 285901"/>
                <a:gd name="connsiteX98" fmla="*/ 300990 w 771573"/>
                <a:gd name="connsiteY98" fmla="*/ 2011 h 285901"/>
                <a:gd name="connsiteX99" fmla="*/ 268605 w 771573"/>
                <a:gd name="connsiteY99" fmla="*/ 9631 h 285901"/>
                <a:gd name="connsiteX100" fmla="*/ 226695 w 771573"/>
                <a:gd name="connsiteY100" fmla="*/ 26776 h 285901"/>
                <a:gd name="connsiteX101" fmla="*/ 182880 w 771573"/>
                <a:gd name="connsiteY101" fmla="*/ 53446 h 285901"/>
                <a:gd name="connsiteX102" fmla="*/ 123825 w 771573"/>
                <a:gd name="connsiteY102" fmla="*/ 95356 h 285901"/>
                <a:gd name="connsiteX103" fmla="*/ 87630 w 771573"/>
                <a:gd name="connsiteY103" fmla="*/ 125836 h 285901"/>
                <a:gd name="connsiteX104" fmla="*/ 55245 w 771573"/>
                <a:gd name="connsiteY104" fmla="*/ 158221 h 285901"/>
                <a:gd name="connsiteX105" fmla="*/ 20955 w 771573"/>
                <a:gd name="connsiteY105" fmla="*/ 203941 h 285901"/>
                <a:gd name="connsiteX106" fmla="*/ 9525 w 771573"/>
                <a:gd name="connsiteY106" fmla="*/ 226801 h 285901"/>
                <a:gd name="connsiteX107" fmla="*/ 5715 w 771573"/>
                <a:gd name="connsiteY107" fmla="*/ 232516 h 285901"/>
                <a:gd name="connsiteX108" fmla="*/ 0 w 771573"/>
                <a:gd name="connsiteY108" fmla="*/ 251566 h 285901"/>
                <a:gd name="connsiteX0" fmla="*/ 0 w 771573"/>
                <a:gd name="connsiteY0" fmla="*/ 251566 h 285856"/>
                <a:gd name="connsiteX1" fmla="*/ 5715 w 771573"/>
                <a:gd name="connsiteY1" fmla="*/ 259186 h 285856"/>
                <a:gd name="connsiteX2" fmla="*/ 19050 w 771573"/>
                <a:gd name="connsiteY2" fmla="*/ 268711 h 285856"/>
                <a:gd name="connsiteX3" fmla="*/ 20955 w 771573"/>
                <a:gd name="connsiteY3" fmla="*/ 274426 h 285856"/>
                <a:gd name="connsiteX4" fmla="*/ 26670 w 771573"/>
                <a:gd name="connsiteY4" fmla="*/ 276331 h 285856"/>
                <a:gd name="connsiteX5" fmla="*/ 45720 w 771573"/>
                <a:gd name="connsiteY5" fmla="*/ 285856 h 285856"/>
                <a:gd name="connsiteX6" fmla="*/ 49530 w 771573"/>
                <a:gd name="connsiteY6" fmla="*/ 280141 h 285856"/>
                <a:gd name="connsiteX7" fmla="*/ 55245 w 771573"/>
                <a:gd name="connsiteY7" fmla="*/ 272521 h 285856"/>
                <a:gd name="connsiteX8" fmla="*/ 60960 w 771573"/>
                <a:gd name="connsiteY8" fmla="*/ 257281 h 285856"/>
                <a:gd name="connsiteX9" fmla="*/ 62865 w 771573"/>
                <a:gd name="connsiteY9" fmla="*/ 251566 h 285856"/>
                <a:gd name="connsiteX10" fmla="*/ 72390 w 771573"/>
                <a:gd name="connsiteY10" fmla="*/ 238231 h 285856"/>
                <a:gd name="connsiteX11" fmla="*/ 78105 w 771573"/>
                <a:gd name="connsiteY11" fmla="*/ 226801 h 285856"/>
                <a:gd name="connsiteX12" fmla="*/ 87630 w 771573"/>
                <a:gd name="connsiteY12" fmla="*/ 209656 h 285856"/>
                <a:gd name="connsiteX13" fmla="*/ 99060 w 771573"/>
                <a:gd name="connsiteY13" fmla="*/ 200131 h 285856"/>
                <a:gd name="connsiteX14" fmla="*/ 100965 w 771573"/>
                <a:gd name="connsiteY14" fmla="*/ 194416 h 285856"/>
                <a:gd name="connsiteX15" fmla="*/ 112395 w 771573"/>
                <a:gd name="connsiteY15" fmla="*/ 188701 h 285856"/>
                <a:gd name="connsiteX16" fmla="*/ 127635 w 771573"/>
                <a:gd name="connsiteY16" fmla="*/ 182986 h 285856"/>
                <a:gd name="connsiteX17" fmla="*/ 140970 w 771573"/>
                <a:gd name="connsiteY17" fmla="*/ 175366 h 285856"/>
                <a:gd name="connsiteX18" fmla="*/ 158115 w 771573"/>
                <a:gd name="connsiteY18" fmla="*/ 163936 h 285856"/>
                <a:gd name="connsiteX19" fmla="*/ 165735 w 771573"/>
                <a:gd name="connsiteY19" fmla="*/ 162031 h 285856"/>
                <a:gd name="connsiteX20" fmla="*/ 171450 w 771573"/>
                <a:gd name="connsiteY20" fmla="*/ 158221 h 285856"/>
                <a:gd name="connsiteX21" fmla="*/ 175260 w 771573"/>
                <a:gd name="connsiteY21" fmla="*/ 152506 h 285856"/>
                <a:gd name="connsiteX22" fmla="*/ 180975 w 771573"/>
                <a:gd name="connsiteY22" fmla="*/ 150601 h 285856"/>
                <a:gd name="connsiteX23" fmla="*/ 198120 w 771573"/>
                <a:gd name="connsiteY23" fmla="*/ 137266 h 285856"/>
                <a:gd name="connsiteX24" fmla="*/ 200025 w 771573"/>
                <a:gd name="connsiteY24" fmla="*/ 131551 h 285856"/>
                <a:gd name="connsiteX25" fmla="*/ 226695 w 771573"/>
                <a:gd name="connsiteY25" fmla="*/ 112501 h 285856"/>
                <a:gd name="connsiteX26" fmla="*/ 238125 w 771573"/>
                <a:gd name="connsiteY26" fmla="*/ 108691 h 285856"/>
                <a:gd name="connsiteX27" fmla="*/ 251460 w 771573"/>
                <a:gd name="connsiteY27" fmla="*/ 101071 h 285856"/>
                <a:gd name="connsiteX28" fmla="*/ 259080 w 771573"/>
                <a:gd name="connsiteY28" fmla="*/ 99166 h 285856"/>
                <a:gd name="connsiteX29" fmla="*/ 276225 w 771573"/>
                <a:gd name="connsiteY29" fmla="*/ 93451 h 285856"/>
                <a:gd name="connsiteX30" fmla="*/ 283845 w 771573"/>
                <a:gd name="connsiteY30" fmla="*/ 91546 h 285856"/>
                <a:gd name="connsiteX31" fmla="*/ 318135 w 771573"/>
                <a:gd name="connsiteY31" fmla="*/ 89641 h 285856"/>
                <a:gd name="connsiteX32" fmla="*/ 369570 w 771573"/>
                <a:gd name="connsiteY32" fmla="*/ 85831 h 285856"/>
                <a:gd name="connsiteX33" fmla="*/ 470535 w 771573"/>
                <a:gd name="connsiteY33" fmla="*/ 83926 h 285856"/>
                <a:gd name="connsiteX34" fmla="*/ 521970 w 771573"/>
                <a:gd name="connsiteY34" fmla="*/ 85831 h 285856"/>
                <a:gd name="connsiteX35" fmla="*/ 537210 w 771573"/>
                <a:gd name="connsiteY35" fmla="*/ 89641 h 285856"/>
                <a:gd name="connsiteX36" fmla="*/ 542925 w 771573"/>
                <a:gd name="connsiteY36" fmla="*/ 93451 h 285856"/>
                <a:gd name="connsiteX37" fmla="*/ 550545 w 771573"/>
                <a:gd name="connsiteY37" fmla="*/ 97261 h 285856"/>
                <a:gd name="connsiteX38" fmla="*/ 565785 w 771573"/>
                <a:gd name="connsiteY38" fmla="*/ 104881 h 285856"/>
                <a:gd name="connsiteX39" fmla="*/ 575310 w 771573"/>
                <a:gd name="connsiteY39" fmla="*/ 114406 h 285856"/>
                <a:gd name="connsiteX40" fmla="*/ 581025 w 771573"/>
                <a:gd name="connsiteY40" fmla="*/ 118216 h 285856"/>
                <a:gd name="connsiteX41" fmla="*/ 600075 w 771573"/>
                <a:gd name="connsiteY41" fmla="*/ 133456 h 285856"/>
                <a:gd name="connsiteX42" fmla="*/ 607695 w 771573"/>
                <a:gd name="connsiteY42" fmla="*/ 142981 h 285856"/>
                <a:gd name="connsiteX43" fmla="*/ 621030 w 771573"/>
                <a:gd name="connsiteY43" fmla="*/ 156316 h 285856"/>
                <a:gd name="connsiteX44" fmla="*/ 628650 w 771573"/>
                <a:gd name="connsiteY44" fmla="*/ 167746 h 285856"/>
                <a:gd name="connsiteX45" fmla="*/ 638175 w 771573"/>
                <a:gd name="connsiteY45" fmla="*/ 182986 h 285856"/>
                <a:gd name="connsiteX46" fmla="*/ 647700 w 771573"/>
                <a:gd name="connsiteY46" fmla="*/ 200131 h 285856"/>
                <a:gd name="connsiteX47" fmla="*/ 657225 w 771573"/>
                <a:gd name="connsiteY47" fmla="*/ 211561 h 285856"/>
                <a:gd name="connsiteX48" fmla="*/ 668655 w 771573"/>
                <a:gd name="connsiteY48" fmla="*/ 219181 h 285856"/>
                <a:gd name="connsiteX49" fmla="*/ 672465 w 771573"/>
                <a:gd name="connsiteY49" fmla="*/ 224896 h 285856"/>
                <a:gd name="connsiteX50" fmla="*/ 678180 w 771573"/>
                <a:gd name="connsiteY50" fmla="*/ 226801 h 285856"/>
                <a:gd name="connsiteX51" fmla="*/ 681990 w 771573"/>
                <a:gd name="connsiteY51" fmla="*/ 234421 h 285856"/>
                <a:gd name="connsiteX52" fmla="*/ 697230 w 771573"/>
                <a:gd name="connsiteY52" fmla="*/ 251566 h 285856"/>
                <a:gd name="connsiteX53" fmla="*/ 701040 w 771573"/>
                <a:gd name="connsiteY53" fmla="*/ 266806 h 285856"/>
                <a:gd name="connsiteX54" fmla="*/ 710565 w 771573"/>
                <a:gd name="connsiteY54" fmla="*/ 276331 h 285856"/>
                <a:gd name="connsiteX55" fmla="*/ 723900 w 771573"/>
                <a:gd name="connsiteY55" fmla="*/ 274426 h 285856"/>
                <a:gd name="connsiteX56" fmla="*/ 727710 w 771573"/>
                <a:gd name="connsiteY56" fmla="*/ 268711 h 285856"/>
                <a:gd name="connsiteX57" fmla="*/ 741045 w 771573"/>
                <a:gd name="connsiteY57" fmla="*/ 255376 h 285856"/>
                <a:gd name="connsiteX58" fmla="*/ 746760 w 771573"/>
                <a:gd name="connsiteY58" fmla="*/ 249661 h 285856"/>
                <a:gd name="connsiteX59" fmla="*/ 754380 w 771573"/>
                <a:gd name="connsiteY59" fmla="*/ 243946 h 285856"/>
                <a:gd name="connsiteX60" fmla="*/ 762000 w 771573"/>
                <a:gd name="connsiteY60" fmla="*/ 240136 h 285856"/>
                <a:gd name="connsiteX61" fmla="*/ 767715 w 771573"/>
                <a:gd name="connsiteY61" fmla="*/ 236326 h 285856"/>
                <a:gd name="connsiteX62" fmla="*/ 771525 w 771573"/>
                <a:gd name="connsiteY62" fmla="*/ 230611 h 285856"/>
                <a:gd name="connsiteX63" fmla="*/ 765810 w 771573"/>
                <a:gd name="connsiteY63" fmla="*/ 200131 h 285856"/>
                <a:gd name="connsiteX64" fmla="*/ 762000 w 771573"/>
                <a:gd name="connsiteY64" fmla="*/ 194416 h 285856"/>
                <a:gd name="connsiteX65" fmla="*/ 756285 w 771573"/>
                <a:gd name="connsiteY65" fmla="*/ 181081 h 285856"/>
                <a:gd name="connsiteX66" fmla="*/ 748665 w 771573"/>
                <a:gd name="connsiteY66" fmla="*/ 165841 h 285856"/>
                <a:gd name="connsiteX67" fmla="*/ 739140 w 771573"/>
                <a:gd name="connsiteY67" fmla="*/ 152506 h 285856"/>
                <a:gd name="connsiteX68" fmla="*/ 737235 w 771573"/>
                <a:gd name="connsiteY68" fmla="*/ 146791 h 285856"/>
                <a:gd name="connsiteX69" fmla="*/ 727710 w 771573"/>
                <a:gd name="connsiteY69" fmla="*/ 135361 h 285856"/>
                <a:gd name="connsiteX70" fmla="*/ 720090 w 771573"/>
                <a:gd name="connsiteY70" fmla="*/ 129646 h 285856"/>
                <a:gd name="connsiteX71" fmla="*/ 714375 w 771573"/>
                <a:gd name="connsiteY71" fmla="*/ 127741 h 285856"/>
                <a:gd name="connsiteX72" fmla="*/ 702945 w 771573"/>
                <a:gd name="connsiteY72" fmla="*/ 118216 h 285856"/>
                <a:gd name="connsiteX73" fmla="*/ 697230 w 771573"/>
                <a:gd name="connsiteY73" fmla="*/ 112501 h 285856"/>
                <a:gd name="connsiteX74" fmla="*/ 691515 w 771573"/>
                <a:gd name="connsiteY74" fmla="*/ 108691 h 285856"/>
                <a:gd name="connsiteX75" fmla="*/ 683895 w 771573"/>
                <a:gd name="connsiteY75" fmla="*/ 102976 h 285856"/>
                <a:gd name="connsiteX76" fmla="*/ 676275 w 771573"/>
                <a:gd name="connsiteY76" fmla="*/ 99166 h 285856"/>
                <a:gd name="connsiteX77" fmla="*/ 664845 w 771573"/>
                <a:gd name="connsiteY77" fmla="*/ 95356 h 285856"/>
                <a:gd name="connsiteX78" fmla="*/ 655320 w 771573"/>
                <a:gd name="connsiteY78" fmla="*/ 89641 h 285856"/>
                <a:gd name="connsiteX79" fmla="*/ 640080 w 771573"/>
                <a:gd name="connsiteY79" fmla="*/ 83926 h 285856"/>
                <a:gd name="connsiteX80" fmla="*/ 626745 w 771573"/>
                <a:gd name="connsiteY80" fmla="*/ 74401 h 285856"/>
                <a:gd name="connsiteX81" fmla="*/ 621030 w 771573"/>
                <a:gd name="connsiteY81" fmla="*/ 72496 h 285856"/>
                <a:gd name="connsiteX82" fmla="*/ 609600 w 771573"/>
                <a:gd name="connsiteY82" fmla="*/ 64876 h 285856"/>
                <a:gd name="connsiteX83" fmla="*/ 598170 w 771573"/>
                <a:gd name="connsiteY83" fmla="*/ 59161 h 285856"/>
                <a:gd name="connsiteX84" fmla="*/ 592455 w 771573"/>
                <a:gd name="connsiteY84" fmla="*/ 55351 h 285856"/>
                <a:gd name="connsiteX85" fmla="*/ 584835 w 771573"/>
                <a:gd name="connsiteY85" fmla="*/ 49636 h 285856"/>
                <a:gd name="connsiteX86" fmla="*/ 573405 w 771573"/>
                <a:gd name="connsiteY86" fmla="*/ 45826 h 285856"/>
                <a:gd name="connsiteX87" fmla="*/ 567690 w 771573"/>
                <a:gd name="connsiteY87" fmla="*/ 42016 h 285856"/>
                <a:gd name="connsiteX88" fmla="*/ 556260 w 771573"/>
                <a:gd name="connsiteY88" fmla="*/ 38206 h 285856"/>
                <a:gd name="connsiteX89" fmla="*/ 548640 w 771573"/>
                <a:gd name="connsiteY89" fmla="*/ 34396 h 285856"/>
                <a:gd name="connsiteX90" fmla="*/ 537210 w 771573"/>
                <a:gd name="connsiteY90" fmla="*/ 26776 h 285856"/>
                <a:gd name="connsiteX91" fmla="*/ 521970 w 771573"/>
                <a:gd name="connsiteY91" fmla="*/ 22966 h 285856"/>
                <a:gd name="connsiteX92" fmla="*/ 493395 w 771573"/>
                <a:gd name="connsiteY92" fmla="*/ 17251 h 285856"/>
                <a:gd name="connsiteX93" fmla="*/ 485775 w 771573"/>
                <a:gd name="connsiteY93" fmla="*/ 15346 h 285856"/>
                <a:gd name="connsiteX94" fmla="*/ 472440 w 771573"/>
                <a:gd name="connsiteY94" fmla="*/ 11536 h 285856"/>
                <a:gd name="connsiteX95" fmla="*/ 409575 w 771573"/>
                <a:gd name="connsiteY95" fmla="*/ 3916 h 285856"/>
                <a:gd name="connsiteX96" fmla="*/ 360045 w 771573"/>
                <a:gd name="connsiteY96" fmla="*/ 106 h 285856"/>
                <a:gd name="connsiteX97" fmla="*/ 300990 w 771573"/>
                <a:gd name="connsiteY97" fmla="*/ 2011 h 285856"/>
                <a:gd name="connsiteX98" fmla="*/ 268605 w 771573"/>
                <a:gd name="connsiteY98" fmla="*/ 9631 h 285856"/>
                <a:gd name="connsiteX99" fmla="*/ 226695 w 771573"/>
                <a:gd name="connsiteY99" fmla="*/ 26776 h 285856"/>
                <a:gd name="connsiteX100" fmla="*/ 182880 w 771573"/>
                <a:gd name="connsiteY100" fmla="*/ 53446 h 285856"/>
                <a:gd name="connsiteX101" fmla="*/ 123825 w 771573"/>
                <a:gd name="connsiteY101" fmla="*/ 95356 h 285856"/>
                <a:gd name="connsiteX102" fmla="*/ 87630 w 771573"/>
                <a:gd name="connsiteY102" fmla="*/ 125836 h 285856"/>
                <a:gd name="connsiteX103" fmla="*/ 55245 w 771573"/>
                <a:gd name="connsiteY103" fmla="*/ 158221 h 285856"/>
                <a:gd name="connsiteX104" fmla="*/ 20955 w 771573"/>
                <a:gd name="connsiteY104" fmla="*/ 203941 h 285856"/>
                <a:gd name="connsiteX105" fmla="*/ 9525 w 771573"/>
                <a:gd name="connsiteY105" fmla="*/ 226801 h 285856"/>
                <a:gd name="connsiteX106" fmla="*/ 5715 w 771573"/>
                <a:gd name="connsiteY106" fmla="*/ 232516 h 285856"/>
                <a:gd name="connsiteX107" fmla="*/ 0 w 771573"/>
                <a:gd name="connsiteY107" fmla="*/ 251566 h 285856"/>
                <a:gd name="connsiteX0" fmla="*/ 0 w 771573"/>
                <a:gd name="connsiteY0" fmla="*/ 251566 h 285856"/>
                <a:gd name="connsiteX1" fmla="*/ 5715 w 771573"/>
                <a:gd name="connsiteY1" fmla="*/ 259186 h 285856"/>
                <a:gd name="connsiteX2" fmla="*/ 19050 w 771573"/>
                <a:gd name="connsiteY2" fmla="*/ 268711 h 285856"/>
                <a:gd name="connsiteX3" fmla="*/ 26670 w 771573"/>
                <a:gd name="connsiteY3" fmla="*/ 276331 h 285856"/>
                <a:gd name="connsiteX4" fmla="*/ 45720 w 771573"/>
                <a:gd name="connsiteY4" fmla="*/ 285856 h 285856"/>
                <a:gd name="connsiteX5" fmla="*/ 49530 w 771573"/>
                <a:gd name="connsiteY5" fmla="*/ 280141 h 285856"/>
                <a:gd name="connsiteX6" fmla="*/ 55245 w 771573"/>
                <a:gd name="connsiteY6" fmla="*/ 272521 h 285856"/>
                <a:gd name="connsiteX7" fmla="*/ 60960 w 771573"/>
                <a:gd name="connsiteY7" fmla="*/ 257281 h 285856"/>
                <a:gd name="connsiteX8" fmla="*/ 62865 w 771573"/>
                <a:gd name="connsiteY8" fmla="*/ 251566 h 285856"/>
                <a:gd name="connsiteX9" fmla="*/ 72390 w 771573"/>
                <a:gd name="connsiteY9" fmla="*/ 238231 h 285856"/>
                <a:gd name="connsiteX10" fmla="*/ 78105 w 771573"/>
                <a:gd name="connsiteY10" fmla="*/ 226801 h 285856"/>
                <a:gd name="connsiteX11" fmla="*/ 87630 w 771573"/>
                <a:gd name="connsiteY11" fmla="*/ 209656 h 285856"/>
                <a:gd name="connsiteX12" fmla="*/ 99060 w 771573"/>
                <a:gd name="connsiteY12" fmla="*/ 200131 h 285856"/>
                <a:gd name="connsiteX13" fmla="*/ 100965 w 771573"/>
                <a:gd name="connsiteY13" fmla="*/ 194416 h 285856"/>
                <a:gd name="connsiteX14" fmla="*/ 112395 w 771573"/>
                <a:gd name="connsiteY14" fmla="*/ 188701 h 285856"/>
                <a:gd name="connsiteX15" fmla="*/ 127635 w 771573"/>
                <a:gd name="connsiteY15" fmla="*/ 182986 h 285856"/>
                <a:gd name="connsiteX16" fmla="*/ 140970 w 771573"/>
                <a:gd name="connsiteY16" fmla="*/ 175366 h 285856"/>
                <a:gd name="connsiteX17" fmla="*/ 158115 w 771573"/>
                <a:gd name="connsiteY17" fmla="*/ 163936 h 285856"/>
                <a:gd name="connsiteX18" fmla="*/ 165735 w 771573"/>
                <a:gd name="connsiteY18" fmla="*/ 162031 h 285856"/>
                <a:gd name="connsiteX19" fmla="*/ 171450 w 771573"/>
                <a:gd name="connsiteY19" fmla="*/ 158221 h 285856"/>
                <a:gd name="connsiteX20" fmla="*/ 175260 w 771573"/>
                <a:gd name="connsiteY20" fmla="*/ 152506 h 285856"/>
                <a:gd name="connsiteX21" fmla="*/ 180975 w 771573"/>
                <a:gd name="connsiteY21" fmla="*/ 150601 h 285856"/>
                <a:gd name="connsiteX22" fmla="*/ 198120 w 771573"/>
                <a:gd name="connsiteY22" fmla="*/ 137266 h 285856"/>
                <a:gd name="connsiteX23" fmla="*/ 200025 w 771573"/>
                <a:gd name="connsiteY23" fmla="*/ 131551 h 285856"/>
                <a:gd name="connsiteX24" fmla="*/ 226695 w 771573"/>
                <a:gd name="connsiteY24" fmla="*/ 112501 h 285856"/>
                <a:gd name="connsiteX25" fmla="*/ 238125 w 771573"/>
                <a:gd name="connsiteY25" fmla="*/ 108691 h 285856"/>
                <a:gd name="connsiteX26" fmla="*/ 251460 w 771573"/>
                <a:gd name="connsiteY26" fmla="*/ 101071 h 285856"/>
                <a:gd name="connsiteX27" fmla="*/ 259080 w 771573"/>
                <a:gd name="connsiteY27" fmla="*/ 99166 h 285856"/>
                <a:gd name="connsiteX28" fmla="*/ 276225 w 771573"/>
                <a:gd name="connsiteY28" fmla="*/ 93451 h 285856"/>
                <a:gd name="connsiteX29" fmla="*/ 283845 w 771573"/>
                <a:gd name="connsiteY29" fmla="*/ 91546 h 285856"/>
                <a:gd name="connsiteX30" fmla="*/ 318135 w 771573"/>
                <a:gd name="connsiteY30" fmla="*/ 89641 h 285856"/>
                <a:gd name="connsiteX31" fmla="*/ 369570 w 771573"/>
                <a:gd name="connsiteY31" fmla="*/ 85831 h 285856"/>
                <a:gd name="connsiteX32" fmla="*/ 470535 w 771573"/>
                <a:gd name="connsiteY32" fmla="*/ 83926 h 285856"/>
                <a:gd name="connsiteX33" fmla="*/ 521970 w 771573"/>
                <a:gd name="connsiteY33" fmla="*/ 85831 h 285856"/>
                <a:gd name="connsiteX34" fmla="*/ 537210 w 771573"/>
                <a:gd name="connsiteY34" fmla="*/ 89641 h 285856"/>
                <a:gd name="connsiteX35" fmla="*/ 542925 w 771573"/>
                <a:gd name="connsiteY35" fmla="*/ 93451 h 285856"/>
                <a:gd name="connsiteX36" fmla="*/ 550545 w 771573"/>
                <a:gd name="connsiteY36" fmla="*/ 97261 h 285856"/>
                <a:gd name="connsiteX37" fmla="*/ 565785 w 771573"/>
                <a:gd name="connsiteY37" fmla="*/ 104881 h 285856"/>
                <a:gd name="connsiteX38" fmla="*/ 575310 w 771573"/>
                <a:gd name="connsiteY38" fmla="*/ 114406 h 285856"/>
                <a:gd name="connsiteX39" fmla="*/ 581025 w 771573"/>
                <a:gd name="connsiteY39" fmla="*/ 118216 h 285856"/>
                <a:gd name="connsiteX40" fmla="*/ 600075 w 771573"/>
                <a:gd name="connsiteY40" fmla="*/ 133456 h 285856"/>
                <a:gd name="connsiteX41" fmla="*/ 607695 w 771573"/>
                <a:gd name="connsiteY41" fmla="*/ 142981 h 285856"/>
                <a:gd name="connsiteX42" fmla="*/ 621030 w 771573"/>
                <a:gd name="connsiteY42" fmla="*/ 156316 h 285856"/>
                <a:gd name="connsiteX43" fmla="*/ 628650 w 771573"/>
                <a:gd name="connsiteY43" fmla="*/ 167746 h 285856"/>
                <a:gd name="connsiteX44" fmla="*/ 638175 w 771573"/>
                <a:gd name="connsiteY44" fmla="*/ 182986 h 285856"/>
                <a:gd name="connsiteX45" fmla="*/ 647700 w 771573"/>
                <a:gd name="connsiteY45" fmla="*/ 200131 h 285856"/>
                <a:gd name="connsiteX46" fmla="*/ 657225 w 771573"/>
                <a:gd name="connsiteY46" fmla="*/ 211561 h 285856"/>
                <a:gd name="connsiteX47" fmla="*/ 668655 w 771573"/>
                <a:gd name="connsiteY47" fmla="*/ 219181 h 285856"/>
                <a:gd name="connsiteX48" fmla="*/ 672465 w 771573"/>
                <a:gd name="connsiteY48" fmla="*/ 224896 h 285856"/>
                <a:gd name="connsiteX49" fmla="*/ 678180 w 771573"/>
                <a:gd name="connsiteY49" fmla="*/ 226801 h 285856"/>
                <a:gd name="connsiteX50" fmla="*/ 681990 w 771573"/>
                <a:gd name="connsiteY50" fmla="*/ 234421 h 285856"/>
                <a:gd name="connsiteX51" fmla="*/ 697230 w 771573"/>
                <a:gd name="connsiteY51" fmla="*/ 251566 h 285856"/>
                <a:gd name="connsiteX52" fmla="*/ 701040 w 771573"/>
                <a:gd name="connsiteY52" fmla="*/ 266806 h 285856"/>
                <a:gd name="connsiteX53" fmla="*/ 710565 w 771573"/>
                <a:gd name="connsiteY53" fmla="*/ 276331 h 285856"/>
                <a:gd name="connsiteX54" fmla="*/ 723900 w 771573"/>
                <a:gd name="connsiteY54" fmla="*/ 274426 h 285856"/>
                <a:gd name="connsiteX55" fmla="*/ 727710 w 771573"/>
                <a:gd name="connsiteY55" fmla="*/ 268711 h 285856"/>
                <a:gd name="connsiteX56" fmla="*/ 741045 w 771573"/>
                <a:gd name="connsiteY56" fmla="*/ 255376 h 285856"/>
                <a:gd name="connsiteX57" fmla="*/ 746760 w 771573"/>
                <a:gd name="connsiteY57" fmla="*/ 249661 h 285856"/>
                <a:gd name="connsiteX58" fmla="*/ 754380 w 771573"/>
                <a:gd name="connsiteY58" fmla="*/ 243946 h 285856"/>
                <a:gd name="connsiteX59" fmla="*/ 762000 w 771573"/>
                <a:gd name="connsiteY59" fmla="*/ 240136 h 285856"/>
                <a:gd name="connsiteX60" fmla="*/ 767715 w 771573"/>
                <a:gd name="connsiteY60" fmla="*/ 236326 h 285856"/>
                <a:gd name="connsiteX61" fmla="*/ 771525 w 771573"/>
                <a:gd name="connsiteY61" fmla="*/ 230611 h 285856"/>
                <a:gd name="connsiteX62" fmla="*/ 765810 w 771573"/>
                <a:gd name="connsiteY62" fmla="*/ 200131 h 285856"/>
                <a:gd name="connsiteX63" fmla="*/ 762000 w 771573"/>
                <a:gd name="connsiteY63" fmla="*/ 194416 h 285856"/>
                <a:gd name="connsiteX64" fmla="*/ 756285 w 771573"/>
                <a:gd name="connsiteY64" fmla="*/ 181081 h 285856"/>
                <a:gd name="connsiteX65" fmla="*/ 748665 w 771573"/>
                <a:gd name="connsiteY65" fmla="*/ 165841 h 285856"/>
                <a:gd name="connsiteX66" fmla="*/ 739140 w 771573"/>
                <a:gd name="connsiteY66" fmla="*/ 152506 h 285856"/>
                <a:gd name="connsiteX67" fmla="*/ 737235 w 771573"/>
                <a:gd name="connsiteY67" fmla="*/ 146791 h 285856"/>
                <a:gd name="connsiteX68" fmla="*/ 727710 w 771573"/>
                <a:gd name="connsiteY68" fmla="*/ 135361 h 285856"/>
                <a:gd name="connsiteX69" fmla="*/ 720090 w 771573"/>
                <a:gd name="connsiteY69" fmla="*/ 129646 h 285856"/>
                <a:gd name="connsiteX70" fmla="*/ 714375 w 771573"/>
                <a:gd name="connsiteY70" fmla="*/ 127741 h 285856"/>
                <a:gd name="connsiteX71" fmla="*/ 702945 w 771573"/>
                <a:gd name="connsiteY71" fmla="*/ 118216 h 285856"/>
                <a:gd name="connsiteX72" fmla="*/ 697230 w 771573"/>
                <a:gd name="connsiteY72" fmla="*/ 112501 h 285856"/>
                <a:gd name="connsiteX73" fmla="*/ 691515 w 771573"/>
                <a:gd name="connsiteY73" fmla="*/ 108691 h 285856"/>
                <a:gd name="connsiteX74" fmla="*/ 683895 w 771573"/>
                <a:gd name="connsiteY74" fmla="*/ 102976 h 285856"/>
                <a:gd name="connsiteX75" fmla="*/ 676275 w 771573"/>
                <a:gd name="connsiteY75" fmla="*/ 99166 h 285856"/>
                <a:gd name="connsiteX76" fmla="*/ 664845 w 771573"/>
                <a:gd name="connsiteY76" fmla="*/ 95356 h 285856"/>
                <a:gd name="connsiteX77" fmla="*/ 655320 w 771573"/>
                <a:gd name="connsiteY77" fmla="*/ 89641 h 285856"/>
                <a:gd name="connsiteX78" fmla="*/ 640080 w 771573"/>
                <a:gd name="connsiteY78" fmla="*/ 83926 h 285856"/>
                <a:gd name="connsiteX79" fmla="*/ 626745 w 771573"/>
                <a:gd name="connsiteY79" fmla="*/ 74401 h 285856"/>
                <a:gd name="connsiteX80" fmla="*/ 621030 w 771573"/>
                <a:gd name="connsiteY80" fmla="*/ 72496 h 285856"/>
                <a:gd name="connsiteX81" fmla="*/ 609600 w 771573"/>
                <a:gd name="connsiteY81" fmla="*/ 64876 h 285856"/>
                <a:gd name="connsiteX82" fmla="*/ 598170 w 771573"/>
                <a:gd name="connsiteY82" fmla="*/ 59161 h 285856"/>
                <a:gd name="connsiteX83" fmla="*/ 592455 w 771573"/>
                <a:gd name="connsiteY83" fmla="*/ 55351 h 285856"/>
                <a:gd name="connsiteX84" fmla="*/ 584835 w 771573"/>
                <a:gd name="connsiteY84" fmla="*/ 49636 h 285856"/>
                <a:gd name="connsiteX85" fmla="*/ 573405 w 771573"/>
                <a:gd name="connsiteY85" fmla="*/ 45826 h 285856"/>
                <a:gd name="connsiteX86" fmla="*/ 567690 w 771573"/>
                <a:gd name="connsiteY86" fmla="*/ 42016 h 285856"/>
                <a:gd name="connsiteX87" fmla="*/ 556260 w 771573"/>
                <a:gd name="connsiteY87" fmla="*/ 38206 h 285856"/>
                <a:gd name="connsiteX88" fmla="*/ 548640 w 771573"/>
                <a:gd name="connsiteY88" fmla="*/ 34396 h 285856"/>
                <a:gd name="connsiteX89" fmla="*/ 537210 w 771573"/>
                <a:gd name="connsiteY89" fmla="*/ 26776 h 285856"/>
                <a:gd name="connsiteX90" fmla="*/ 521970 w 771573"/>
                <a:gd name="connsiteY90" fmla="*/ 22966 h 285856"/>
                <a:gd name="connsiteX91" fmla="*/ 493395 w 771573"/>
                <a:gd name="connsiteY91" fmla="*/ 17251 h 285856"/>
                <a:gd name="connsiteX92" fmla="*/ 485775 w 771573"/>
                <a:gd name="connsiteY92" fmla="*/ 15346 h 285856"/>
                <a:gd name="connsiteX93" fmla="*/ 472440 w 771573"/>
                <a:gd name="connsiteY93" fmla="*/ 11536 h 285856"/>
                <a:gd name="connsiteX94" fmla="*/ 409575 w 771573"/>
                <a:gd name="connsiteY94" fmla="*/ 3916 h 285856"/>
                <a:gd name="connsiteX95" fmla="*/ 360045 w 771573"/>
                <a:gd name="connsiteY95" fmla="*/ 106 h 285856"/>
                <a:gd name="connsiteX96" fmla="*/ 300990 w 771573"/>
                <a:gd name="connsiteY96" fmla="*/ 2011 h 285856"/>
                <a:gd name="connsiteX97" fmla="*/ 268605 w 771573"/>
                <a:gd name="connsiteY97" fmla="*/ 9631 h 285856"/>
                <a:gd name="connsiteX98" fmla="*/ 226695 w 771573"/>
                <a:gd name="connsiteY98" fmla="*/ 26776 h 285856"/>
                <a:gd name="connsiteX99" fmla="*/ 182880 w 771573"/>
                <a:gd name="connsiteY99" fmla="*/ 53446 h 285856"/>
                <a:gd name="connsiteX100" fmla="*/ 123825 w 771573"/>
                <a:gd name="connsiteY100" fmla="*/ 95356 h 285856"/>
                <a:gd name="connsiteX101" fmla="*/ 87630 w 771573"/>
                <a:gd name="connsiteY101" fmla="*/ 125836 h 285856"/>
                <a:gd name="connsiteX102" fmla="*/ 55245 w 771573"/>
                <a:gd name="connsiteY102" fmla="*/ 158221 h 285856"/>
                <a:gd name="connsiteX103" fmla="*/ 20955 w 771573"/>
                <a:gd name="connsiteY103" fmla="*/ 203941 h 285856"/>
                <a:gd name="connsiteX104" fmla="*/ 9525 w 771573"/>
                <a:gd name="connsiteY104" fmla="*/ 226801 h 285856"/>
                <a:gd name="connsiteX105" fmla="*/ 5715 w 771573"/>
                <a:gd name="connsiteY105" fmla="*/ 232516 h 285856"/>
                <a:gd name="connsiteX106" fmla="*/ 0 w 771573"/>
                <a:gd name="connsiteY106" fmla="*/ 251566 h 285856"/>
                <a:gd name="connsiteX0" fmla="*/ 0 w 771573"/>
                <a:gd name="connsiteY0" fmla="*/ 251566 h 285856"/>
                <a:gd name="connsiteX1" fmla="*/ 5715 w 771573"/>
                <a:gd name="connsiteY1" fmla="*/ 259186 h 285856"/>
                <a:gd name="connsiteX2" fmla="*/ 19050 w 771573"/>
                <a:gd name="connsiteY2" fmla="*/ 268711 h 285856"/>
                <a:gd name="connsiteX3" fmla="*/ 45720 w 771573"/>
                <a:gd name="connsiteY3" fmla="*/ 285856 h 285856"/>
                <a:gd name="connsiteX4" fmla="*/ 49530 w 771573"/>
                <a:gd name="connsiteY4" fmla="*/ 280141 h 285856"/>
                <a:gd name="connsiteX5" fmla="*/ 55245 w 771573"/>
                <a:gd name="connsiteY5" fmla="*/ 272521 h 285856"/>
                <a:gd name="connsiteX6" fmla="*/ 60960 w 771573"/>
                <a:gd name="connsiteY6" fmla="*/ 257281 h 285856"/>
                <a:gd name="connsiteX7" fmla="*/ 62865 w 771573"/>
                <a:gd name="connsiteY7" fmla="*/ 251566 h 285856"/>
                <a:gd name="connsiteX8" fmla="*/ 72390 w 771573"/>
                <a:gd name="connsiteY8" fmla="*/ 238231 h 285856"/>
                <a:gd name="connsiteX9" fmla="*/ 78105 w 771573"/>
                <a:gd name="connsiteY9" fmla="*/ 226801 h 285856"/>
                <a:gd name="connsiteX10" fmla="*/ 87630 w 771573"/>
                <a:gd name="connsiteY10" fmla="*/ 209656 h 285856"/>
                <a:gd name="connsiteX11" fmla="*/ 99060 w 771573"/>
                <a:gd name="connsiteY11" fmla="*/ 200131 h 285856"/>
                <a:gd name="connsiteX12" fmla="*/ 100965 w 771573"/>
                <a:gd name="connsiteY12" fmla="*/ 194416 h 285856"/>
                <a:gd name="connsiteX13" fmla="*/ 112395 w 771573"/>
                <a:gd name="connsiteY13" fmla="*/ 188701 h 285856"/>
                <a:gd name="connsiteX14" fmla="*/ 127635 w 771573"/>
                <a:gd name="connsiteY14" fmla="*/ 182986 h 285856"/>
                <a:gd name="connsiteX15" fmla="*/ 140970 w 771573"/>
                <a:gd name="connsiteY15" fmla="*/ 175366 h 285856"/>
                <a:gd name="connsiteX16" fmla="*/ 158115 w 771573"/>
                <a:gd name="connsiteY16" fmla="*/ 163936 h 285856"/>
                <a:gd name="connsiteX17" fmla="*/ 165735 w 771573"/>
                <a:gd name="connsiteY17" fmla="*/ 162031 h 285856"/>
                <a:gd name="connsiteX18" fmla="*/ 171450 w 771573"/>
                <a:gd name="connsiteY18" fmla="*/ 158221 h 285856"/>
                <a:gd name="connsiteX19" fmla="*/ 175260 w 771573"/>
                <a:gd name="connsiteY19" fmla="*/ 152506 h 285856"/>
                <a:gd name="connsiteX20" fmla="*/ 180975 w 771573"/>
                <a:gd name="connsiteY20" fmla="*/ 150601 h 285856"/>
                <a:gd name="connsiteX21" fmla="*/ 198120 w 771573"/>
                <a:gd name="connsiteY21" fmla="*/ 137266 h 285856"/>
                <a:gd name="connsiteX22" fmla="*/ 200025 w 771573"/>
                <a:gd name="connsiteY22" fmla="*/ 131551 h 285856"/>
                <a:gd name="connsiteX23" fmla="*/ 226695 w 771573"/>
                <a:gd name="connsiteY23" fmla="*/ 112501 h 285856"/>
                <a:gd name="connsiteX24" fmla="*/ 238125 w 771573"/>
                <a:gd name="connsiteY24" fmla="*/ 108691 h 285856"/>
                <a:gd name="connsiteX25" fmla="*/ 251460 w 771573"/>
                <a:gd name="connsiteY25" fmla="*/ 101071 h 285856"/>
                <a:gd name="connsiteX26" fmla="*/ 259080 w 771573"/>
                <a:gd name="connsiteY26" fmla="*/ 99166 h 285856"/>
                <a:gd name="connsiteX27" fmla="*/ 276225 w 771573"/>
                <a:gd name="connsiteY27" fmla="*/ 93451 h 285856"/>
                <a:gd name="connsiteX28" fmla="*/ 283845 w 771573"/>
                <a:gd name="connsiteY28" fmla="*/ 91546 h 285856"/>
                <a:gd name="connsiteX29" fmla="*/ 318135 w 771573"/>
                <a:gd name="connsiteY29" fmla="*/ 89641 h 285856"/>
                <a:gd name="connsiteX30" fmla="*/ 369570 w 771573"/>
                <a:gd name="connsiteY30" fmla="*/ 85831 h 285856"/>
                <a:gd name="connsiteX31" fmla="*/ 470535 w 771573"/>
                <a:gd name="connsiteY31" fmla="*/ 83926 h 285856"/>
                <a:gd name="connsiteX32" fmla="*/ 521970 w 771573"/>
                <a:gd name="connsiteY32" fmla="*/ 85831 h 285856"/>
                <a:gd name="connsiteX33" fmla="*/ 537210 w 771573"/>
                <a:gd name="connsiteY33" fmla="*/ 89641 h 285856"/>
                <a:gd name="connsiteX34" fmla="*/ 542925 w 771573"/>
                <a:gd name="connsiteY34" fmla="*/ 93451 h 285856"/>
                <a:gd name="connsiteX35" fmla="*/ 550545 w 771573"/>
                <a:gd name="connsiteY35" fmla="*/ 97261 h 285856"/>
                <a:gd name="connsiteX36" fmla="*/ 565785 w 771573"/>
                <a:gd name="connsiteY36" fmla="*/ 104881 h 285856"/>
                <a:gd name="connsiteX37" fmla="*/ 575310 w 771573"/>
                <a:gd name="connsiteY37" fmla="*/ 114406 h 285856"/>
                <a:gd name="connsiteX38" fmla="*/ 581025 w 771573"/>
                <a:gd name="connsiteY38" fmla="*/ 118216 h 285856"/>
                <a:gd name="connsiteX39" fmla="*/ 600075 w 771573"/>
                <a:gd name="connsiteY39" fmla="*/ 133456 h 285856"/>
                <a:gd name="connsiteX40" fmla="*/ 607695 w 771573"/>
                <a:gd name="connsiteY40" fmla="*/ 142981 h 285856"/>
                <a:gd name="connsiteX41" fmla="*/ 621030 w 771573"/>
                <a:gd name="connsiteY41" fmla="*/ 156316 h 285856"/>
                <a:gd name="connsiteX42" fmla="*/ 628650 w 771573"/>
                <a:gd name="connsiteY42" fmla="*/ 167746 h 285856"/>
                <a:gd name="connsiteX43" fmla="*/ 638175 w 771573"/>
                <a:gd name="connsiteY43" fmla="*/ 182986 h 285856"/>
                <a:gd name="connsiteX44" fmla="*/ 647700 w 771573"/>
                <a:gd name="connsiteY44" fmla="*/ 200131 h 285856"/>
                <a:gd name="connsiteX45" fmla="*/ 657225 w 771573"/>
                <a:gd name="connsiteY45" fmla="*/ 211561 h 285856"/>
                <a:gd name="connsiteX46" fmla="*/ 668655 w 771573"/>
                <a:gd name="connsiteY46" fmla="*/ 219181 h 285856"/>
                <a:gd name="connsiteX47" fmla="*/ 672465 w 771573"/>
                <a:gd name="connsiteY47" fmla="*/ 224896 h 285856"/>
                <a:gd name="connsiteX48" fmla="*/ 678180 w 771573"/>
                <a:gd name="connsiteY48" fmla="*/ 226801 h 285856"/>
                <a:gd name="connsiteX49" fmla="*/ 681990 w 771573"/>
                <a:gd name="connsiteY49" fmla="*/ 234421 h 285856"/>
                <a:gd name="connsiteX50" fmla="*/ 697230 w 771573"/>
                <a:gd name="connsiteY50" fmla="*/ 251566 h 285856"/>
                <a:gd name="connsiteX51" fmla="*/ 701040 w 771573"/>
                <a:gd name="connsiteY51" fmla="*/ 266806 h 285856"/>
                <a:gd name="connsiteX52" fmla="*/ 710565 w 771573"/>
                <a:gd name="connsiteY52" fmla="*/ 276331 h 285856"/>
                <a:gd name="connsiteX53" fmla="*/ 723900 w 771573"/>
                <a:gd name="connsiteY53" fmla="*/ 274426 h 285856"/>
                <a:gd name="connsiteX54" fmla="*/ 727710 w 771573"/>
                <a:gd name="connsiteY54" fmla="*/ 268711 h 285856"/>
                <a:gd name="connsiteX55" fmla="*/ 741045 w 771573"/>
                <a:gd name="connsiteY55" fmla="*/ 255376 h 285856"/>
                <a:gd name="connsiteX56" fmla="*/ 746760 w 771573"/>
                <a:gd name="connsiteY56" fmla="*/ 249661 h 285856"/>
                <a:gd name="connsiteX57" fmla="*/ 754380 w 771573"/>
                <a:gd name="connsiteY57" fmla="*/ 243946 h 285856"/>
                <a:gd name="connsiteX58" fmla="*/ 762000 w 771573"/>
                <a:gd name="connsiteY58" fmla="*/ 240136 h 285856"/>
                <a:gd name="connsiteX59" fmla="*/ 767715 w 771573"/>
                <a:gd name="connsiteY59" fmla="*/ 236326 h 285856"/>
                <a:gd name="connsiteX60" fmla="*/ 771525 w 771573"/>
                <a:gd name="connsiteY60" fmla="*/ 230611 h 285856"/>
                <a:gd name="connsiteX61" fmla="*/ 765810 w 771573"/>
                <a:gd name="connsiteY61" fmla="*/ 200131 h 285856"/>
                <a:gd name="connsiteX62" fmla="*/ 762000 w 771573"/>
                <a:gd name="connsiteY62" fmla="*/ 194416 h 285856"/>
                <a:gd name="connsiteX63" fmla="*/ 756285 w 771573"/>
                <a:gd name="connsiteY63" fmla="*/ 181081 h 285856"/>
                <a:gd name="connsiteX64" fmla="*/ 748665 w 771573"/>
                <a:gd name="connsiteY64" fmla="*/ 165841 h 285856"/>
                <a:gd name="connsiteX65" fmla="*/ 739140 w 771573"/>
                <a:gd name="connsiteY65" fmla="*/ 152506 h 285856"/>
                <a:gd name="connsiteX66" fmla="*/ 737235 w 771573"/>
                <a:gd name="connsiteY66" fmla="*/ 146791 h 285856"/>
                <a:gd name="connsiteX67" fmla="*/ 727710 w 771573"/>
                <a:gd name="connsiteY67" fmla="*/ 135361 h 285856"/>
                <a:gd name="connsiteX68" fmla="*/ 720090 w 771573"/>
                <a:gd name="connsiteY68" fmla="*/ 129646 h 285856"/>
                <a:gd name="connsiteX69" fmla="*/ 714375 w 771573"/>
                <a:gd name="connsiteY69" fmla="*/ 127741 h 285856"/>
                <a:gd name="connsiteX70" fmla="*/ 702945 w 771573"/>
                <a:gd name="connsiteY70" fmla="*/ 118216 h 285856"/>
                <a:gd name="connsiteX71" fmla="*/ 697230 w 771573"/>
                <a:gd name="connsiteY71" fmla="*/ 112501 h 285856"/>
                <a:gd name="connsiteX72" fmla="*/ 691515 w 771573"/>
                <a:gd name="connsiteY72" fmla="*/ 108691 h 285856"/>
                <a:gd name="connsiteX73" fmla="*/ 683895 w 771573"/>
                <a:gd name="connsiteY73" fmla="*/ 102976 h 285856"/>
                <a:gd name="connsiteX74" fmla="*/ 676275 w 771573"/>
                <a:gd name="connsiteY74" fmla="*/ 99166 h 285856"/>
                <a:gd name="connsiteX75" fmla="*/ 664845 w 771573"/>
                <a:gd name="connsiteY75" fmla="*/ 95356 h 285856"/>
                <a:gd name="connsiteX76" fmla="*/ 655320 w 771573"/>
                <a:gd name="connsiteY76" fmla="*/ 89641 h 285856"/>
                <a:gd name="connsiteX77" fmla="*/ 640080 w 771573"/>
                <a:gd name="connsiteY77" fmla="*/ 83926 h 285856"/>
                <a:gd name="connsiteX78" fmla="*/ 626745 w 771573"/>
                <a:gd name="connsiteY78" fmla="*/ 74401 h 285856"/>
                <a:gd name="connsiteX79" fmla="*/ 621030 w 771573"/>
                <a:gd name="connsiteY79" fmla="*/ 72496 h 285856"/>
                <a:gd name="connsiteX80" fmla="*/ 609600 w 771573"/>
                <a:gd name="connsiteY80" fmla="*/ 64876 h 285856"/>
                <a:gd name="connsiteX81" fmla="*/ 598170 w 771573"/>
                <a:gd name="connsiteY81" fmla="*/ 59161 h 285856"/>
                <a:gd name="connsiteX82" fmla="*/ 592455 w 771573"/>
                <a:gd name="connsiteY82" fmla="*/ 55351 h 285856"/>
                <a:gd name="connsiteX83" fmla="*/ 584835 w 771573"/>
                <a:gd name="connsiteY83" fmla="*/ 49636 h 285856"/>
                <a:gd name="connsiteX84" fmla="*/ 573405 w 771573"/>
                <a:gd name="connsiteY84" fmla="*/ 45826 h 285856"/>
                <a:gd name="connsiteX85" fmla="*/ 567690 w 771573"/>
                <a:gd name="connsiteY85" fmla="*/ 42016 h 285856"/>
                <a:gd name="connsiteX86" fmla="*/ 556260 w 771573"/>
                <a:gd name="connsiteY86" fmla="*/ 38206 h 285856"/>
                <a:gd name="connsiteX87" fmla="*/ 548640 w 771573"/>
                <a:gd name="connsiteY87" fmla="*/ 34396 h 285856"/>
                <a:gd name="connsiteX88" fmla="*/ 537210 w 771573"/>
                <a:gd name="connsiteY88" fmla="*/ 26776 h 285856"/>
                <a:gd name="connsiteX89" fmla="*/ 521970 w 771573"/>
                <a:gd name="connsiteY89" fmla="*/ 22966 h 285856"/>
                <a:gd name="connsiteX90" fmla="*/ 493395 w 771573"/>
                <a:gd name="connsiteY90" fmla="*/ 17251 h 285856"/>
                <a:gd name="connsiteX91" fmla="*/ 485775 w 771573"/>
                <a:gd name="connsiteY91" fmla="*/ 15346 h 285856"/>
                <a:gd name="connsiteX92" fmla="*/ 472440 w 771573"/>
                <a:gd name="connsiteY92" fmla="*/ 11536 h 285856"/>
                <a:gd name="connsiteX93" fmla="*/ 409575 w 771573"/>
                <a:gd name="connsiteY93" fmla="*/ 3916 h 285856"/>
                <a:gd name="connsiteX94" fmla="*/ 360045 w 771573"/>
                <a:gd name="connsiteY94" fmla="*/ 106 h 285856"/>
                <a:gd name="connsiteX95" fmla="*/ 300990 w 771573"/>
                <a:gd name="connsiteY95" fmla="*/ 2011 h 285856"/>
                <a:gd name="connsiteX96" fmla="*/ 268605 w 771573"/>
                <a:gd name="connsiteY96" fmla="*/ 9631 h 285856"/>
                <a:gd name="connsiteX97" fmla="*/ 226695 w 771573"/>
                <a:gd name="connsiteY97" fmla="*/ 26776 h 285856"/>
                <a:gd name="connsiteX98" fmla="*/ 182880 w 771573"/>
                <a:gd name="connsiteY98" fmla="*/ 53446 h 285856"/>
                <a:gd name="connsiteX99" fmla="*/ 123825 w 771573"/>
                <a:gd name="connsiteY99" fmla="*/ 95356 h 285856"/>
                <a:gd name="connsiteX100" fmla="*/ 87630 w 771573"/>
                <a:gd name="connsiteY100" fmla="*/ 125836 h 285856"/>
                <a:gd name="connsiteX101" fmla="*/ 55245 w 771573"/>
                <a:gd name="connsiteY101" fmla="*/ 158221 h 285856"/>
                <a:gd name="connsiteX102" fmla="*/ 20955 w 771573"/>
                <a:gd name="connsiteY102" fmla="*/ 203941 h 285856"/>
                <a:gd name="connsiteX103" fmla="*/ 9525 w 771573"/>
                <a:gd name="connsiteY103" fmla="*/ 226801 h 285856"/>
                <a:gd name="connsiteX104" fmla="*/ 5715 w 771573"/>
                <a:gd name="connsiteY104" fmla="*/ 232516 h 285856"/>
                <a:gd name="connsiteX105" fmla="*/ 0 w 771573"/>
                <a:gd name="connsiteY105" fmla="*/ 251566 h 285856"/>
                <a:gd name="connsiteX0" fmla="*/ 0 w 771573"/>
                <a:gd name="connsiteY0" fmla="*/ 251566 h 285887"/>
                <a:gd name="connsiteX1" fmla="*/ 5715 w 771573"/>
                <a:gd name="connsiteY1" fmla="*/ 259186 h 285887"/>
                <a:gd name="connsiteX2" fmla="*/ 19050 w 771573"/>
                <a:gd name="connsiteY2" fmla="*/ 268711 h 285887"/>
                <a:gd name="connsiteX3" fmla="*/ 45720 w 771573"/>
                <a:gd name="connsiteY3" fmla="*/ 285856 h 285887"/>
                <a:gd name="connsiteX4" fmla="*/ 55245 w 771573"/>
                <a:gd name="connsiteY4" fmla="*/ 272521 h 285887"/>
                <a:gd name="connsiteX5" fmla="*/ 60960 w 771573"/>
                <a:gd name="connsiteY5" fmla="*/ 257281 h 285887"/>
                <a:gd name="connsiteX6" fmla="*/ 62865 w 771573"/>
                <a:gd name="connsiteY6" fmla="*/ 251566 h 285887"/>
                <a:gd name="connsiteX7" fmla="*/ 72390 w 771573"/>
                <a:gd name="connsiteY7" fmla="*/ 238231 h 285887"/>
                <a:gd name="connsiteX8" fmla="*/ 78105 w 771573"/>
                <a:gd name="connsiteY8" fmla="*/ 226801 h 285887"/>
                <a:gd name="connsiteX9" fmla="*/ 87630 w 771573"/>
                <a:gd name="connsiteY9" fmla="*/ 209656 h 285887"/>
                <a:gd name="connsiteX10" fmla="*/ 99060 w 771573"/>
                <a:gd name="connsiteY10" fmla="*/ 200131 h 285887"/>
                <a:gd name="connsiteX11" fmla="*/ 100965 w 771573"/>
                <a:gd name="connsiteY11" fmla="*/ 194416 h 285887"/>
                <a:gd name="connsiteX12" fmla="*/ 112395 w 771573"/>
                <a:gd name="connsiteY12" fmla="*/ 188701 h 285887"/>
                <a:gd name="connsiteX13" fmla="*/ 127635 w 771573"/>
                <a:gd name="connsiteY13" fmla="*/ 182986 h 285887"/>
                <a:gd name="connsiteX14" fmla="*/ 140970 w 771573"/>
                <a:gd name="connsiteY14" fmla="*/ 175366 h 285887"/>
                <a:gd name="connsiteX15" fmla="*/ 158115 w 771573"/>
                <a:gd name="connsiteY15" fmla="*/ 163936 h 285887"/>
                <a:gd name="connsiteX16" fmla="*/ 165735 w 771573"/>
                <a:gd name="connsiteY16" fmla="*/ 162031 h 285887"/>
                <a:gd name="connsiteX17" fmla="*/ 171450 w 771573"/>
                <a:gd name="connsiteY17" fmla="*/ 158221 h 285887"/>
                <a:gd name="connsiteX18" fmla="*/ 175260 w 771573"/>
                <a:gd name="connsiteY18" fmla="*/ 152506 h 285887"/>
                <a:gd name="connsiteX19" fmla="*/ 180975 w 771573"/>
                <a:gd name="connsiteY19" fmla="*/ 150601 h 285887"/>
                <a:gd name="connsiteX20" fmla="*/ 198120 w 771573"/>
                <a:gd name="connsiteY20" fmla="*/ 137266 h 285887"/>
                <a:gd name="connsiteX21" fmla="*/ 200025 w 771573"/>
                <a:gd name="connsiteY21" fmla="*/ 131551 h 285887"/>
                <a:gd name="connsiteX22" fmla="*/ 226695 w 771573"/>
                <a:gd name="connsiteY22" fmla="*/ 112501 h 285887"/>
                <a:gd name="connsiteX23" fmla="*/ 238125 w 771573"/>
                <a:gd name="connsiteY23" fmla="*/ 108691 h 285887"/>
                <a:gd name="connsiteX24" fmla="*/ 251460 w 771573"/>
                <a:gd name="connsiteY24" fmla="*/ 101071 h 285887"/>
                <a:gd name="connsiteX25" fmla="*/ 259080 w 771573"/>
                <a:gd name="connsiteY25" fmla="*/ 99166 h 285887"/>
                <a:gd name="connsiteX26" fmla="*/ 276225 w 771573"/>
                <a:gd name="connsiteY26" fmla="*/ 93451 h 285887"/>
                <a:gd name="connsiteX27" fmla="*/ 283845 w 771573"/>
                <a:gd name="connsiteY27" fmla="*/ 91546 h 285887"/>
                <a:gd name="connsiteX28" fmla="*/ 318135 w 771573"/>
                <a:gd name="connsiteY28" fmla="*/ 89641 h 285887"/>
                <a:gd name="connsiteX29" fmla="*/ 369570 w 771573"/>
                <a:gd name="connsiteY29" fmla="*/ 85831 h 285887"/>
                <a:gd name="connsiteX30" fmla="*/ 470535 w 771573"/>
                <a:gd name="connsiteY30" fmla="*/ 83926 h 285887"/>
                <a:gd name="connsiteX31" fmla="*/ 521970 w 771573"/>
                <a:gd name="connsiteY31" fmla="*/ 85831 h 285887"/>
                <a:gd name="connsiteX32" fmla="*/ 537210 w 771573"/>
                <a:gd name="connsiteY32" fmla="*/ 89641 h 285887"/>
                <a:gd name="connsiteX33" fmla="*/ 542925 w 771573"/>
                <a:gd name="connsiteY33" fmla="*/ 93451 h 285887"/>
                <a:gd name="connsiteX34" fmla="*/ 550545 w 771573"/>
                <a:gd name="connsiteY34" fmla="*/ 97261 h 285887"/>
                <a:gd name="connsiteX35" fmla="*/ 565785 w 771573"/>
                <a:gd name="connsiteY35" fmla="*/ 104881 h 285887"/>
                <a:gd name="connsiteX36" fmla="*/ 575310 w 771573"/>
                <a:gd name="connsiteY36" fmla="*/ 114406 h 285887"/>
                <a:gd name="connsiteX37" fmla="*/ 581025 w 771573"/>
                <a:gd name="connsiteY37" fmla="*/ 118216 h 285887"/>
                <a:gd name="connsiteX38" fmla="*/ 600075 w 771573"/>
                <a:gd name="connsiteY38" fmla="*/ 133456 h 285887"/>
                <a:gd name="connsiteX39" fmla="*/ 607695 w 771573"/>
                <a:gd name="connsiteY39" fmla="*/ 142981 h 285887"/>
                <a:gd name="connsiteX40" fmla="*/ 621030 w 771573"/>
                <a:gd name="connsiteY40" fmla="*/ 156316 h 285887"/>
                <a:gd name="connsiteX41" fmla="*/ 628650 w 771573"/>
                <a:gd name="connsiteY41" fmla="*/ 167746 h 285887"/>
                <a:gd name="connsiteX42" fmla="*/ 638175 w 771573"/>
                <a:gd name="connsiteY42" fmla="*/ 182986 h 285887"/>
                <a:gd name="connsiteX43" fmla="*/ 647700 w 771573"/>
                <a:gd name="connsiteY43" fmla="*/ 200131 h 285887"/>
                <a:gd name="connsiteX44" fmla="*/ 657225 w 771573"/>
                <a:gd name="connsiteY44" fmla="*/ 211561 h 285887"/>
                <a:gd name="connsiteX45" fmla="*/ 668655 w 771573"/>
                <a:gd name="connsiteY45" fmla="*/ 219181 h 285887"/>
                <a:gd name="connsiteX46" fmla="*/ 672465 w 771573"/>
                <a:gd name="connsiteY46" fmla="*/ 224896 h 285887"/>
                <a:gd name="connsiteX47" fmla="*/ 678180 w 771573"/>
                <a:gd name="connsiteY47" fmla="*/ 226801 h 285887"/>
                <a:gd name="connsiteX48" fmla="*/ 681990 w 771573"/>
                <a:gd name="connsiteY48" fmla="*/ 234421 h 285887"/>
                <a:gd name="connsiteX49" fmla="*/ 697230 w 771573"/>
                <a:gd name="connsiteY49" fmla="*/ 251566 h 285887"/>
                <a:gd name="connsiteX50" fmla="*/ 701040 w 771573"/>
                <a:gd name="connsiteY50" fmla="*/ 266806 h 285887"/>
                <a:gd name="connsiteX51" fmla="*/ 710565 w 771573"/>
                <a:gd name="connsiteY51" fmla="*/ 276331 h 285887"/>
                <a:gd name="connsiteX52" fmla="*/ 723900 w 771573"/>
                <a:gd name="connsiteY52" fmla="*/ 274426 h 285887"/>
                <a:gd name="connsiteX53" fmla="*/ 727710 w 771573"/>
                <a:gd name="connsiteY53" fmla="*/ 268711 h 285887"/>
                <a:gd name="connsiteX54" fmla="*/ 741045 w 771573"/>
                <a:gd name="connsiteY54" fmla="*/ 255376 h 285887"/>
                <a:gd name="connsiteX55" fmla="*/ 746760 w 771573"/>
                <a:gd name="connsiteY55" fmla="*/ 249661 h 285887"/>
                <a:gd name="connsiteX56" fmla="*/ 754380 w 771573"/>
                <a:gd name="connsiteY56" fmla="*/ 243946 h 285887"/>
                <a:gd name="connsiteX57" fmla="*/ 762000 w 771573"/>
                <a:gd name="connsiteY57" fmla="*/ 240136 h 285887"/>
                <a:gd name="connsiteX58" fmla="*/ 767715 w 771573"/>
                <a:gd name="connsiteY58" fmla="*/ 236326 h 285887"/>
                <a:gd name="connsiteX59" fmla="*/ 771525 w 771573"/>
                <a:gd name="connsiteY59" fmla="*/ 230611 h 285887"/>
                <a:gd name="connsiteX60" fmla="*/ 765810 w 771573"/>
                <a:gd name="connsiteY60" fmla="*/ 200131 h 285887"/>
                <a:gd name="connsiteX61" fmla="*/ 762000 w 771573"/>
                <a:gd name="connsiteY61" fmla="*/ 194416 h 285887"/>
                <a:gd name="connsiteX62" fmla="*/ 756285 w 771573"/>
                <a:gd name="connsiteY62" fmla="*/ 181081 h 285887"/>
                <a:gd name="connsiteX63" fmla="*/ 748665 w 771573"/>
                <a:gd name="connsiteY63" fmla="*/ 165841 h 285887"/>
                <a:gd name="connsiteX64" fmla="*/ 739140 w 771573"/>
                <a:gd name="connsiteY64" fmla="*/ 152506 h 285887"/>
                <a:gd name="connsiteX65" fmla="*/ 737235 w 771573"/>
                <a:gd name="connsiteY65" fmla="*/ 146791 h 285887"/>
                <a:gd name="connsiteX66" fmla="*/ 727710 w 771573"/>
                <a:gd name="connsiteY66" fmla="*/ 135361 h 285887"/>
                <a:gd name="connsiteX67" fmla="*/ 720090 w 771573"/>
                <a:gd name="connsiteY67" fmla="*/ 129646 h 285887"/>
                <a:gd name="connsiteX68" fmla="*/ 714375 w 771573"/>
                <a:gd name="connsiteY68" fmla="*/ 127741 h 285887"/>
                <a:gd name="connsiteX69" fmla="*/ 702945 w 771573"/>
                <a:gd name="connsiteY69" fmla="*/ 118216 h 285887"/>
                <a:gd name="connsiteX70" fmla="*/ 697230 w 771573"/>
                <a:gd name="connsiteY70" fmla="*/ 112501 h 285887"/>
                <a:gd name="connsiteX71" fmla="*/ 691515 w 771573"/>
                <a:gd name="connsiteY71" fmla="*/ 108691 h 285887"/>
                <a:gd name="connsiteX72" fmla="*/ 683895 w 771573"/>
                <a:gd name="connsiteY72" fmla="*/ 102976 h 285887"/>
                <a:gd name="connsiteX73" fmla="*/ 676275 w 771573"/>
                <a:gd name="connsiteY73" fmla="*/ 99166 h 285887"/>
                <a:gd name="connsiteX74" fmla="*/ 664845 w 771573"/>
                <a:gd name="connsiteY74" fmla="*/ 95356 h 285887"/>
                <a:gd name="connsiteX75" fmla="*/ 655320 w 771573"/>
                <a:gd name="connsiteY75" fmla="*/ 89641 h 285887"/>
                <a:gd name="connsiteX76" fmla="*/ 640080 w 771573"/>
                <a:gd name="connsiteY76" fmla="*/ 83926 h 285887"/>
                <a:gd name="connsiteX77" fmla="*/ 626745 w 771573"/>
                <a:gd name="connsiteY77" fmla="*/ 74401 h 285887"/>
                <a:gd name="connsiteX78" fmla="*/ 621030 w 771573"/>
                <a:gd name="connsiteY78" fmla="*/ 72496 h 285887"/>
                <a:gd name="connsiteX79" fmla="*/ 609600 w 771573"/>
                <a:gd name="connsiteY79" fmla="*/ 64876 h 285887"/>
                <a:gd name="connsiteX80" fmla="*/ 598170 w 771573"/>
                <a:gd name="connsiteY80" fmla="*/ 59161 h 285887"/>
                <a:gd name="connsiteX81" fmla="*/ 592455 w 771573"/>
                <a:gd name="connsiteY81" fmla="*/ 55351 h 285887"/>
                <a:gd name="connsiteX82" fmla="*/ 584835 w 771573"/>
                <a:gd name="connsiteY82" fmla="*/ 49636 h 285887"/>
                <a:gd name="connsiteX83" fmla="*/ 573405 w 771573"/>
                <a:gd name="connsiteY83" fmla="*/ 45826 h 285887"/>
                <a:gd name="connsiteX84" fmla="*/ 567690 w 771573"/>
                <a:gd name="connsiteY84" fmla="*/ 42016 h 285887"/>
                <a:gd name="connsiteX85" fmla="*/ 556260 w 771573"/>
                <a:gd name="connsiteY85" fmla="*/ 38206 h 285887"/>
                <a:gd name="connsiteX86" fmla="*/ 548640 w 771573"/>
                <a:gd name="connsiteY86" fmla="*/ 34396 h 285887"/>
                <a:gd name="connsiteX87" fmla="*/ 537210 w 771573"/>
                <a:gd name="connsiteY87" fmla="*/ 26776 h 285887"/>
                <a:gd name="connsiteX88" fmla="*/ 521970 w 771573"/>
                <a:gd name="connsiteY88" fmla="*/ 22966 h 285887"/>
                <a:gd name="connsiteX89" fmla="*/ 493395 w 771573"/>
                <a:gd name="connsiteY89" fmla="*/ 17251 h 285887"/>
                <a:gd name="connsiteX90" fmla="*/ 485775 w 771573"/>
                <a:gd name="connsiteY90" fmla="*/ 15346 h 285887"/>
                <a:gd name="connsiteX91" fmla="*/ 472440 w 771573"/>
                <a:gd name="connsiteY91" fmla="*/ 11536 h 285887"/>
                <a:gd name="connsiteX92" fmla="*/ 409575 w 771573"/>
                <a:gd name="connsiteY92" fmla="*/ 3916 h 285887"/>
                <a:gd name="connsiteX93" fmla="*/ 360045 w 771573"/>
                <a:gd name="connsiteY93" fmla="*/ 106 h 285887"/>
                <a:gd name="connsiteX94" fmla="*/ 300990 w 771573"/>
                <a:gd name="connsiteY94" fmla="*/ 2011 h 285887"/>
                <a:gd name="connsiteX95" fmla="*/ 268605 w 771573"/>
                <a:gd name="connsiteY95" fmla="*/ 9631 h 285887"/>
                <a:gd name="connsiteX96" fmla="*/ 226695 w 771573"/>
                <a:gd name="connsiteY96" fmla="*/ 26776 h 285887"/>
                <a:gd name="connsiteX97" fmla="*/ 182880 w 771573"/>
                <a:gd name="connsiteY97" fmla="*/ 53446 h 285887"/>
                <a:gd name="connsiteX98" fmla="*/ 123825 w 771573"/>
                <a:gd name="connsiteY98" fmla="*/ 95356 h 285887"/>
                <a:gd name="connsiteX99" fmla="*/ 87630 w 771573"/>
                <a:gd name="connsiteY99" fmla="*/ 125836 h 285887"/>
                <a:gd name="connsiteX100" fmla="*/ 55245 w 771573"/>
                <a:gd name="connsiteY100" fmla="*/ 158221 h 285887"/>
                <a:gd name="connsiteX101" fmla="*/ 20955 w 771573"/>
                <a:gd name="connsiteY101" fmla="*/ 203941 h 285887"/>
                <a:gd name="connsiteX102" fmla="*/ 9525 w 771573"/>
                <a:gd name="connsiteY102" fmla="*/ 226801 h 285887"/>
                <a:gd name="connsiteX103" fmla="*/ 5715 w 771573"/>
                <a:gd name="connsiteY103" fmla="*/ 232516 h 285887"/>
                <a:gd name="connsiteX104" fmla="*/ 0 w 771573"/>
                <a:gd name="connsiteY104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65735 w 771573"/>
                <a:gd name="connsiteY15" fmla="*/ 162031 h 285887"/>
                <a:gd name="connsiteX16" fmla="*/ 171450 w 771573"/>
                <a:gd name="connsiteY16" fmla="*/ 158221 h 285887"/>
                <a:gd name="connsiteX17" fmla="*/ 175260 w 771573"/>
                <a:gd name="connsiteY17" fmla="*/ 152506 h 285887"/>
                <a:gd name="connsiteX18" fmla="*/ 180975 w 771573"/>
                <a:gd name="connsiteY18" fmla="*/ 150601 h 285887"/>
                <a:gd name="connsiteX19" fmla="*/ 198120 w 771573"/>
                <a:gd name="connsiteY19" fmla="*/ 137266 h 285887"/>
                <a:gd name="connsiteX20" fmla="*/ 200025 w 771573"/>
                <a:gd name="connsiteY20" fmla="*/ 131551 h 285887"/>
                <a:gd name="connsiteX21" fmla="*/ 226695 w 771573"/>
                <a:gd name="connsiteY21" fmla="*/ 112501 h 285887"/>
                <a:gd name="connsiteX22" fmla="*/ 238125 w 771573"/>
                <a:gd name="connsiteY22" fmla="*/ 108691 h 285887"/>
                <a:gd name="connsiteX23" fmla="*/ 251460 w 771573"/>
                <a:gd name="connsiteY23" fmla="*/ 101071 h 285887"/>
                <a:gd name="connsiteX24" fmla="*/ 259080 w 771573"/>
                <a:gd name="connsiteY24" fmla="*/ 99166 h 285887"/>
                <a:gd name="connsiteX25" fmla="*/ 276225 w 771573"/>
                <a:gd name="connsiteY25" fmla="*/ 93451 h 285887"/>
                <a:gd name="connsiteX26" fmla="*/ 283845 w 771573"/>
                <a:gd name="connsiteY26" fmla="*/ 91546 h 285887"/>
                <a:gd name="connsiteX27" fmla="*/ 318135 w 771573"/>
                <a:gd name="connsiteY27" fmla="*/ 89641 h 285887"/>
                <a:gd name="connsiteX28" fmla="*/ 369570 w 771573"/>
                <a:gd name="connsiteY28" fmla="*/ 85831 h 285887"/>
                <a:gd name="connsiteX29" fmla="*/ 470535 w 771573"/>
                <a:gd name="connsiteY29" fmla="*/ 83926 h 285887"/>
                <a:gd name="connsiteX30" fmla="*/ 521970 w 771573"/>
                <a:gd name="connsiteY30" fmla="*/ 85831 h 285887"/>
                <a:gd name="connsiteX31" fmla="*/ 537210 w 771573"/>
                <a:gd name="connsiteY31" fmla="*/ 89641 h 285887"/>
                <a:gd name="connsiteX32" fmla="*/ 542925 w 771573"/>
                <a:gd name="connsiteY32" fmla="*/ 93451 h 285887"/>
                <a:gd name="connsiteX33" fmla="*/ 550545 w 771573"/>
                <a:gd name="connsiteY33" fmla="*/ 97261 h 285887"/>
                <a:gd name="connsiteX34" fmla="*/ 565785 w 771573"/>
                <a:gd name="connsiteY34" fmla="*/ 104881 h 285887"/>
                <a:gd name="connsiteX35" fmla="*/ 575310 w 771573"/>
                <a:gd name="connsiteY35" fmla="*/ 114406 h 285887"/>
                <a:gd name="connsiteX36" fmla="*/ 581025 w 771573"/>
                <a:gd name="connsiteY36" fmla="*/ 118216 h 285887"/>
                <a:gd name="connsiteX37" fmla="*/ 600075 w 771573"/>
                <a:gd name="connsiteY37" fmla="*/ 133456 h 285887"/>
                <a:gd name="connsiteX38" fmla="*/ 607695 w 771573"/>
                <a:gd name="connsiteY38" fmla="*/ 142981 h 285887"/>
                <a:gd name="connsiteX39" fmla="*/ 621030 w 771573"/>
                <a:gd name="connsiteY39" fmla="*/ 156316 h 285887"/>
                <a:gd name="connsiteX40" fmla="*/ 628650 w 771573"/>
                <a:gd name="connsiteY40" fmla="*/ 167746 h 285887"/>
                <a:gd name="connsiteX41" fmla="*/ 638175 w 771573"/>
                <a:gd name="connsiteY41" fmla="*/ 182986 h 285887"/>
                <a:gd name="connsiteX42" fmla="*/ 647700 w 771573"/>
                <a:gd name="connsiteY42" fmla="*/ 200131 h 285887"/>
                <a:gd name="connsiteX43" fmla="*/ 657225 w 771573"/>
                <a:gd name="connsiteY43" fmla="*/ 211561 h 285887"/>
                <a:gd name="connsiteX44" fmla="*/ 668655 w 771573"/>
                <a:gd name="connsiteY44" fmla="*/ 219181 h 285887"/>
                <a:gd name="connsiteX45" fmla="*/ 672465 w 771573"/>
                <a:gd name="connsiteY45" fmla="*/ 224896 h 285887"/>
                <a:gd name="connsiteX46" fmla="*/ 678180 w 771573"/>
                <a:gd name="connsiteY46" fmla="*/ 226801 h 285887"/>
                <a:gd name="connsiteX47" fmla="*/ 681990 w 771573"/>
                <a:gd name="connsiteY47" fmla="*/ 234421 h 285887"/>
                <a:gd name="connsiteX48" fmla="*/ 697230 w 771573"/>
                <a:gd name="connsiteY48" fmla="*/ 251566 h 285887"/>
                <a:gd name="connsiteX49" fmla="*/ 701040 w 771573"/>
                <a:gd name="connsiteY49" fmla="*/ 266806 h 285887"/>
                <a:gd name="connsiteX50" fmla="*/ 710565 w 771573"/>
                <a:gd name="connsiteY50" fmla="*/ 276331 h 285887"/>
                <a:gd name="connsiteX51" fmla="*/ 723900 w 771573"/>
                <a:gd name="connsiteY51" fmla="*/ 274426 h 285887"/>
                <a:gd name="connsiteX52" fmla="*/ 727710 w 771573"/>
                <a:gd name="connsiteY52" fmla="*/ 268711 h 285887"/>
                <a:gd name="connsiteX53" fmla="*/ 741045 w 771573"/>
                <a:gd name="connsiteY53" fmla="*/ 255376 h 285887"/>
                <a:gd name="connsiteX54" fmla="*/ 746760 w 771573"/>
                <a:gd name="connsiteY54" fmla="*/ 249661 h 285887"/>
                <a:gd name="connsiteX55" fmla="*/ 754380 w 771573"/>
                <a:gd name="connsiteY55" fmla="*/ 243946 h 285887"/>
                <a:gd name="connsiteX56" fmla="*/ 762000 w 771573"/>
                <a:gd name="connsiteY56" fmla="*/ 240136 h 285887"/>
                <a:gd name="connsiteX57" fmla="*/ 767715 w 771573"/>
                <a:gd name="connsiteY57" fmla="*/ 236326 h 285887"/>
                <a:gd name="connsiteX58" fmla="*/ 771525 w 771573"/>
                <a:gd name="connsiteY58" fmla="*/ 230611 h 285887"/>
                <a:gd name="connsiteX59" fmla="*/ 765810 w 771573"/>
                <a:gd name="connsiteY59" fmla="*/ 200131 h 285887"/>
                <a:gd name="connsiteX60" fmla="*/ 762000 w 771573"/>
                <a:gd name="connsiteY60" fmla="*/ 194416 h 285887"/>
                <a:gd name="connsiteX61" fmla="*/ 756285 w 771573"/>
                <a:gd name="connsiteY61" fmla="*/ 181081 h 285887"/>
                <a:gd name="connsiteX62" fmla="*/ 748665 w 771573"/>
                <a:gd name="connsiteY62" fmla="*/ 165841 h 285887"/>
                <a:gd name="connsiteX63" fmla="*/ 739140 w 771573"/>
                <a:gd name="connsiteY63" fmla="*/ 152506 h 285887"/>
                <a:gd name="connsiteX64" fmla="*/ 737235 w 771573"/>
                <a:gd name="connsiteY64" fmla="*/ 146791 h 285887"/>
                <a:gd name="connsiteX65" fmla="*/ 727710 w 771573"/>
                <a:gd name="connsiteY65" fmla="*/ 135361 h 285887"/>
                <a:gd name="connsiteX66" fmla="*/ 720090 w 771573"/>
                <a:gd name="connsiteY66" fmla="*/ 129646 h 285887"/>
                <a:gd name="connsiteX67" fmla="*/ 714375 w 771573"/>
                <a:gd name="connsiteY67" fmla="*/ 127741 h 285887"/>
                <a:gd name="connsiteX68" fmla="*/ 702945 w 771573"/>
                <a:gd name="connsiteY68" fmla="*/ 118216 h 285887"/>
                <a:gd name="connsiteX69" fmla="*/ 697230 w 771573"/>
                <a:gd name="connsiteY69" fmla="*/ 112501 h 285887"/>
                <a:gd name="connsiteX70" fmla="*/ 691515 w 771573"/>
                <a:gd name="connsiteY70" fmla="*/ 108691 h 285887"/>
                <a:gd name="connsiteX71" fmla="*/ 683895 w 771573"/>
                <a:gd name="connsiteY71" fmla="*/ 102976 h 285887"/>
                <a:gd name="connsiteX72" fmla="*/ 676275 w 771573"/>
                <a:gd name="connsiteY72" fmla="*/ 99166 h 285887"/>
                <a:gd name="connsiteX73" fmla="*/ 664845 w 771573"/>
                <a:gd name="connsiteY73" fmla="*/ 95356 h 285887"/>
                <a:gd name="connsiteX74" fmla="*/ 655320 w 771573"/>
                <a:gd name="connsiteY74" fmla="*/ 89641 h 285887"/>
                <a:gd name="connsiteX75" fmla="*/ 640080 w 771573"/>
                <a:gd name="connsiteY75" fmla="*/ 83926 h 285887"/>
                <a:gd name="connsiteX76" fmla="*/ 626745 w 771573"/>
                <a:gd name="connsiteY76" fmla="*/ 74401 h 285887"/>
                <a:gd name="connsiteX77" fmla="*/ 621030 w 771573"/>
                <a:gd name="connsiteY77" fmla="*/ 72496 h 285887"/>
                <a:gd name="connsiteX78" fmla="*/ 609600 w 771573"/>
                <a:gd name="connsiteY78" fmla="*/ 64876 h 285887"/>
                <a:gd name="connsiteX79" fmla="*/ 598170 w 771573"/>
                <a:gd name="connsiteY79" fmla="*/ 59161 h 285887"/>
                <a:gd name="connsiteX80" fmla="*/ 592455 w 771573"/>
                <a:gd name="connsiteY80" fmla="*/ 55351 h 285887"/>
                <a:gd name="connsiteX81" fmla="*/ 584835 w 771573"/>
                <a:gd name="connsiteY81" fmla="*/ 49636 h 285887"/>
                <a:gd name="connsiteX82" fmla="*/ 573405 w 771573"/>
                <a:gd name="connsiteY82" fmla="*/ 45826 h 285887"/>
                <a:gd name="connsiteX83" fmla="*/ 567690 w 771573"/>
                <a:gd name="connsiteY83" fmla="*/ 42016 h 285887"/>
                <a:gd name="connsiteX84" fmla="*/ 556260 w 771573"/>
                <a:gd name="connsiteY84" fmla="*/ 38206 h 285887"/>
                <a:gd name="connsiteX85" fmla="*/ 548640 w 771573"/>
                <a:gd name="connsiteY85" fmla="*/ 34396 h 285887"/>
                <a:gd name="connsiteX86" fmla="*/ 537210 w 771573"/>
                <a:gd name="connsiteY86" fmla="*/ 26776 h 285887"/>
                <a:gd name="connsiteX87" fmla="*/ 521970 w 771573"/>
                <a:gd name="connsiteY87" fmla="*/ 22966 h 285887"/>
                <a:gd name="connsiteX88" fmla="*/ 493395 w 771573"/>
                <a:gd name="connsiteY88" fmla="*/ 17251 h 285887"/>
                <a:gd name="connsiteX89" fmla="*/ 485775 w 771573"/>
                <a:gd name="connsiteY89" fmla="*/ 15346 h 285887"/>
                <a:gd name="connsiteX90" fmla="*/ 472440 w 771573"/>
                <a:gd name="connsiteY90" fmla="*/ 11536 h 285887"/>
                <a:gd name="connsiteX91" fmla="*/ 409575 w 771573"/>
                <a:gd name="connsiteY91" fmla="*/ 3916 h 285887"/>
                <a:gd name="connsiteX92" fmla="*/ 360045 w 771573"/>
                <a:gd name="connsiteY92" fmla="*/ 106 h 285887"/>
                <a:gd name="connsiteX93" fmla="*/ 300990 w 771573"/>
                <a:gd name="connsiteY93" fmla="*/ 2011 h 285887"/>
                <a:gd name="connsiteX94" fmla="*/ 268605 w 771573"/>
                <a:gd name="connsiteY94" fmla="*/ 9631 h 285887"/>
                <a:gd name="connsiteX95" fmla="*/ 226695 w 771573"/>
                <a:gd name="connsiteY95" fmla="*/ 26776 h 285887"/>
                <a:gd name="connsiteX96" fmla="*/ 182880 w 771573"/>
                <a:gd name="connsiteY96" fmla="*/ 53446 h 285887"/>
                <a:gd name="connsiteX97" fmla="*/ 123825 w 771573"/>
                <a:gd name="connsiteY97" fmla="*/ 95356 h 285887"/>
                <a:gd name="connsiteX98" fmla="*/ 87630 w 771573"/>
                <a:gd name="connsiteY98" fmla="*/ 125836 h 285887"/>
                <a:gd name="connsiteX99" fmla="*/ 55245 w 771573"/>
                <a:gd name="connsiteY99" fmla="*/ 158221 h 285887"/>
                <a:gd name="connsiteX100" fmla="*/ 20955 w 771573"/>
                <a:gd name="connsiteY100" fmla="*/ 203941 h 285887"/>
                <a:gd name="connsiteX101" fmla="*/ 9525 w 771573"/>
                <a:gd name="connsiteY101" fmla="*/ 226801 h 285887"/>
                <a:gd name="connsiteX102" fmla="*/ 5715 w 771573"/>
                <a:gd name="connsiteY102" fmla="*/ 232516 h 285887"/>
                <a:gd name="connsiteX103" fmla="*/ 0 w 771573"/>
                <a:gd name="connsiteY103" fmla="*/ 251566 h 285887"/>
                <a:gd name="connsiteX0" fmla="*/ 214 w 771787"/>
                <a:gd name="connsiteY0" fmla="*/ 251566 h 285887"/>
                <a:gd name="connsiteX1" fmla="*/ 19264 w 771787"/>
                <a:gd name="connsiteY1" fmla="*/ 268711 h 285887"/>
                <a:gd name="connsiteX2" fmla="*/ 45934 w 771787"/>
                <a:gd name="connsiteY2" fmla="*/ 285856 h 285887"/>
                <a:gd name="connsiteX3" fmla="*/ 55459 w 771787"/>
                <a:gd name="connsiteY3" fmla="*/ 272521 h 285887"/>
                <a:gd name="connsiteX4" fmla="*/ 61174 w 771787"/>
                <a:gd name="connsiteY4" fmla="*/ 257281 h 285887"/>
                <a:gd name="connsiteX5" fmla="*/ 63079 w 771787"/>
                <a:gd name="connsiteY5" fmla="*/ 251566 h 285887"/>
                <a:gd name="connsiteX6" fmla="*/ 72604 w 771787"/>
                <a:gd name="connsiteY6" fmla="*/ 238231 h 285887"/>
                <a:gd name="connsiteX7" fmla="*/ 78319 w 771787"/>
                <a:gd name="connsiteY7" fmla="*/ 226801 h 285887"/>
                <a:gd name="connsiteX8" fmla="*/ 87844 w 771787"/>
                <a:gd name="connsiteY8" fmla="*/ 209656 h 285887"/>
                <a:gd name="connsiteX9" fmla="*/ 99274 w 771787"/>
                <a:gd name="connsiteY9" fmla="*/ 200131 h 285887"/>
                <a:gd name="connsiteX10" fmla="*/ 101179 w 771787"/>
                <a:gd name="connsiteY10" fmla="*/ 194416 h 285887"/>
                <a:gd name="connsiteX11" fmla="*/ 112609 w 771787"/>
                <a:gd name="connsiteY11" fmla="*/ 188701 h 285887"/>
                <a:gd name="connsiteX12" fmla="*/ 127849 w 771787"/>
                <a:gd name="connsiteY12" fmla="*/ 182986 h 285887"/>
                <a:gd name="connsiteX13" fmla="*/ 141184 w 771787"/>
                <a:gd name="connsiteY13" fmla="*/ 175366 h 285887"/>
                <a:gd name="connsiteX14" fmla="*/ 158329 w 771787"/>
                <a:gd name="connsiteY14" fmla="*/ 163936 h 285887"/>
                <a:gd name="connsiteX15" fmla="*/ 165949 w 771787"/>
                <a:gd name="connsiteY15" fmla="*/ 162031 h 285887"/>
                <a:gd name="connsiteX16" fmla="*/ 171664 w 771787"/>
                <a:gd name="connsiteY16" fmla="*/ 158221 h 285887"/>
                <a:gd name="connsiteX17" fmla="*/ 175474 w 771787"/>
                <a:gd name="connsiteY17" fmla="*/ 152506 h 285887"/>
                <a:gd name="connsiteX18" fmla="*/ 181189 w 771787"/>
                <a:gd name="connsiteY18" fmla="*/ 150601 h 285887"/>
                <a:gd name="connsiteX19" fmla="*/ 198334 w 771787"/>
                <a:gd name="connsiteY19" fmla="*/ 137266 h 285887"/>
                <a:gd name="connsiteX20" fmla="*/ 200239 w 771787"/>
                <a:gd name="connsiteY20" fmla="*/ 131551 h 285887"/>
                <a:gd name="connsiteX21" fmla="*/ 226909 w 771787"/>
                <a:gd name="connsiteY21" fmla="*/ 112501 h 285887"/>
                <a:gd name="connsiteX22" fmla="*/ 238339 w 771787"/>
                <a:gd name="connsiteY22" fmla="*/ 108691 h 285887"/>
                <a:gd name="connsiteX23" fmla="*/ 251674 w 771787"/>
                <a:gd name="connsiteY23" fmla="*/ 101071 h 285887"/>
                <a:gd name="connsiteX24" fmla="*/ 259294 w 771787"/>
                <a:gd name="connsiteY24" fmla="*/ 99166 h 285887"/>
                <a:gd name="connsiteX25" fmla="*/ 276439 w 771787"/>
                <a:gd name="connsiteY25" fmla="*/ 93451 h 285887"/>
                <a:gd name="connsiteX26" fmla="*/ 284059 w 771787"/>
                <a:gd name="connsiteY26" fmla="*/ 91546 h 285887"/>
                <a:gd name="connsiteX27" fmla="*/ 318349 w 771787"/>
                <a:gd name="connsiteY27" fmla="*/ 89641 h 285887"/>
                <a:gd name="connsiteX28" fmla="*/ 369784 w 771787"/>
                <a:gd name="connsiteY28" fmla="*/ 85831 h 285887"/>
                <a:gd name="connsiteX29" fmla="*/ 470749 w 771787"/>
                <a:gd name="connsiteY29" fmla="*/ 83926 h 285887"/>
                <a:gd name="connsiteX30" fmla="*/ 522184 w 771787"/>
                <a:gd name="connsiteY30" fmla="*/ 85831 h 285887"/>
                <a:gd name="connsiteX31" fmla="*/ 537424 w 771787"/>
                <a:gd name="connsiteY31" fmla="*/ 89641 h 285887"/>
                <a:gd name="connsiteX32" fmla="*/ 543139 w 771787"/>
                <a:gd name="connsiteY32" fmla="*/ 93451 h 285887"/>
                <a:gd name="connsiteX33" fmla="*/ 550759 w 771787"/>
                <a:gd name="connsiteY33" fmla="*/ 97261 h 285887"/>
                <a:gd name="connsiteX34" fmla="*/ 565999 w 771787"/>
                <a:gd name="connsiteY34" fmla="*/ 104881 h 285887"/>
                <a:gd name="connsiteX35" fmla="*/ 575524 w 771787"/>
                <a:gd name="connsiteY35" fmla="*/ 114406 h 285887"/>
                <a:gd name="connsiteX36" fmla="*/ 581239 w 771787"/>
                <a:gd name="connsiteY36" fmla="*/ 118216 h 285887"/>
                <a:gd name="connsiteX37" fmla="*/ 600289 w 771787"/>
                <a:gd name="connsiteY37" fmla="*/ 133456 h 285887"/>
                <a:gd name="connsiteX38" fmla="*/ 607909 w 771787"/>
                <a:gd name="connsiteY38" fmla="*/ 142981 h 285887"/>
                <a:gd name="connsiteX39" fmla="*/ 621244 w 771787"/>
                <a:gd name="connsiteY39" fmla="*/ 156316 h 285887"/>
                <a:gd name="connsiteX40" fmla="*/ 628864 w 771787"/>
                <a:gd name="connsiteY40" fmla="*/ 167746 h 285887"/>
                <a:gd name="connsiteX41" fmla="*/ 638389 w 771787"/>
                <a:gd name="connsiteY41" fmla="*/ 182986 h 285887"/>
                <a:gd name="connsiteX42" fmla="*/ 647914 w 771787"/>
                <a:gd name="connsiteY42" fmla="*/ 200131 h 285887"/>
                <a:gd name="connsiteX43" fmla="*/ 657439 w 771787"/>
                <a:gd name="connsiteY43" fmla="*/ 211561 h 285887"/>
                <a:gd name="connsiteX44" fmla="*/ 668869 w 771787"/>
                <a:gd name="connsiteY44" fmla="*/ 219181 h 285887"/>
                <a:gd name="connsiteX45" fmla="*/ 672679 w 771787"/>
                <a:gd name="connsiteY45" fmla="*/ 224896 h 285887"/>
                <a:gd name="connsiteX46" fmla="*/ 678394 w 771787"/>
                <a:gd name="connsiteY46" fmla="*/ 226801 h 285887"/>
                <a:gd name="connsiteX47" fmla="*/ 682204 w 771787"/>
                <a:gd name="connsiteY47" fmla="*/ 234421 h 285887"/>
                <a:gd name="connsiteX48" fmla="*/ 697444 w 771787"/>
                <a:gd name="connsiteY48" fmla="*/ 251566 h 285887"/>
                <a:gd name="connsiteX49" fmla="*/ 701254 w 771787"/>
                <a:gd name="connsiteY49" fmla="*/ 266806 h 285887"/>
                <a:gd name="connsiteX50" fmla="*/ 710779 w 771787"/>
                <a:gd name="connsiteY50" fmla="*/ 276331 h 285887"/>
                <a:gd name="connsiteX51" fmla="*/ 724114 w 771787"/>
                <a:gd name="connsiteY51" fmla="*/ 274426 h 285887"/>
                <a:gd name="connsiteX52" fmla="*/ 727924 w 771787"/>
                <a:gd name="connsiteY52" fmla="*/ 268711 h 285887"/>
                <a:gd name="connsiteX53" fmla="*/ 741259 w 771787"/>
                <a:gd name="connsiteY53" fmla="*/ 255376 h 285887"/>
                <a:gd name="connsiteX54" fmla="*/ 746974 w 771787"/>
                <a:gd name="connsiteY54" fmla="*/ 249661 h 285887"/>
                <a:gd name="connsiteX55" fmla="*/ 754594 w 771787"/>
                <a:gd name="connsiteY55" fmla="*/ 243946 h 285887"/>
                <a:gd name="connsiteX56" fmla="*/ 762214 w 771787"/>
                <a:gd name="connsiteY56" fmla="*/ 240136 h 285887"/>
                <a:gd name="connsiteX57" fmla="*/ 767929 w 771787"/>
                <a:gd name="connsiteY57" fmla="*/ 236326 h 285887"/>
                <a:gd name="connsiteX58" fmla="*/ 771739 w 771787"/>
                <a:gd name="connsiteY58" fmla="*/ 230611 h 285887"/>
                <a:gd name="connsiteX59" fmla="*/ 766024 w 771787"/>
                <a:gd name="connsiteY59" fmla="*/ 200131 h 285887"/>
                <a:gd name="connsiteX60" fmla="*/ 762214 w 771787"/>
                <a:gd name="connsiteY60" fmla="*/ 194416 h 285887"/>
                <a:gd name="connsiteX61" fmla="*/ 756499 w 771787"/>
                <a:gd name="connsiteY61" fmla="*/ 181081 h 285887"/>
                <a:gd name="connsiteX62" fmla="*/ 748879 w 771787"/>
                <a:gd name="connsiteY62" fmla="*/ 165841 h 285887"/>
                <a:gd name="connsiteX63" fmla="*/ 739354 w 771787"/>
                <a:gd name="connsiteY63" fmla="*/ 152506 h 285887"/>
                <a:gd name="connsiteX64" fmla="*/ 737449 w 771787"/>
                <a:gd name="connsiteY64" fmla="*/ 146791 h 285887"/>
                <a:gd name="connsiteX65" fmla="*/ 727924 w 771787"/>
                <a:gd name="connsiteY65" fmla="*/ 135361 h 285887"/>
                <a:gd name="connsiteX66" fmla="*/ 720304 w 771787"/>
                <a:gd name="connsiteY66" fmla="*/ 129646 h 285887"/>
                <a:gd name="connsiteX67" fmla="*/ 714589 w 771787"/>
                <a:gd name="connsiteY67" fmla="*/ 127741 h 285887"/>
                <a:gd name="connsiteX68" fmla="*/ 703159 w 771787"/>
                <a:gd name="connsiteY68" fmla="*/ 118216 h 285887"/>
                <a:gd name="connsiteX69" fmla="*/ 697444 w 771787"/>
                <a:gd name="connsiteY69" fmla="*/ 112501 h 285887"/>
                <a:gd name="connsiteX70" fmla="*/ 691729 w 771787"/>
                <a:gd name="connsiteY70" fmla="*/ 108691 h 285887"/>
                <a:gd name="connsiteX71" fmla="*/ 684109 w 771787"/>
                <a:gd name="connsiteY71" fmla="*/ 102976 h 285887"/>
                <a:gd name="connsiteX72" fmla="*/ 676489 w 771787"/>
                <a:gd name="connsiteY72" fmla="*/ 99166 h 285887"/>
                <a:gd name="connsiteX73" fmla="*/ 665059 w 771787"/>
                <a:gd name="connsiteY73" fmla="*/ 95356 h 285887"/>
                <a:gd name="connsiteX74" fmla="*/ 655534 w 771787"/>
                <a:gd name="connsiteY74" fmla="*/ 89641 h 285887"/>
                <a:gd name="connsiteX75" fmla="*/ 640294 w 771787"/>
                <a:gd name="connsiteY75" fmla="*/ 83926 h 285887"/>
                <a:gd name="connsiteX76" fmla="*/ 626959 w 771787"/>
                <a:gd name="connsiteY76" fmla="*/ 74401 h 285887"/>
                <a:gd name="connsiteX77" fmla="*/ 621244 w 771787"/>
                <a:gd name="connsiteY77" fmla="*/ 72496 h 285887"/>
                <a:gd name="connsiteX78" fmla="*/ 609814 w 771787"/>
                <a:gd name="connsiteY78" fmla="*/ 64876 h 285887"/>
                <a:gd name="connsiteX79" fmla="*/ 598384 w 771787"/>
                <a:gd name="connsiteY79" fmla="*/ 59161 h 285887"/>
                <a:gd name="connsiteX80" fmla="*/ 592669 w 771787"/>
                <a:gd name="connsiteY80" fmla="*/ 55351 h 285887"/>
                <a:gd name="connsiteX81" fmla="*/ 585049 w 771787"/>
                <a:gd name="connsiteY81" fmla="*/ 49636 h 285887"/>
                <a:gd name="connsiteX82" fmla="*/ 573619 w 771787"/>
                <a:gd name="connsiteY82" fmla="*/ 45826 h 285887"/>
                <a:gd name="connsiteX83" fmla="*/ 567904 w 771787"/>
                <a:gd name="connsiteY83" fmla="*/ 42016 h 285887"/>
                <a:gd name="connsiteX84" fmla="*/ 556474 w 771787"/>
                <a:gd name="connsiteY84" fmla="*/ 38206 h 285887"/>
                <a:gd name="connsiteX85" fmla="*/ 548854 w 771787"/>
                <a:gd name="connsiteY85" fmla="*/ 34396 h 285887"/>
                <a:gd name="connsiteX86" fmla="*/ 537424 w 771787"/>
                <a:gd name="connsiteY86" fmla="*/ 26776 h 285887"/>
                <a:gd name="connsiteX87" fmla="*/ 522184 w 771787"/>
                <a:gd name="connsiteY87" fmla="*/ 22966 h 285887"/>
                <a:gd name="connsiteX88" fmla="*/ 493609 w 771787"/>
                <a:gd name="connsiteY88" fmla="*/ 17251 h 285887"/>
                <a:gd name="connsiteX89" fmla="*/ 485989 w 771787"/>
                <a:gd name="connsiteY89" fmla="*/ 15346 h 285887"/>
                <a:gd name="connsiteX90" fmla="*/ 472654 w 771787"/>
                <a:gd name="connsiteY90" fmla="*/ 11536 h 285887"/>
                <a:gd name="connsiteX91" fmla="*/ 409789 w 771787"/>
                <a:gd name="connsiteY91" fmla="*/ 3916 h 285887"/>
                <a:gd name="connsiteX92" fmla="*/ 360259 w 771787"/>
                <a:gd name="connsiteY92" fmla="*/ 106 h 285887"/>
                <a:gd name="connsiteX93" fmla="*/ 301204 w 771787"/>
                <a:gd name="connsiteY93" fmla="*/ 2011 h 285887"/>
                <a:gd name="connsiteX94" fmla="*/ 268819 w 771787"/>
                <a:gd name="connsiteY94" fmla="*/ 9631 h 285887"/>
                <a:gd name="connsiteX95" fmla="*/ 226909 w 771787"/>
                <a:gd name="connsiteY95" fmla="*/ 26776 h 285887"/>
                <a:gd name="connsiteX96" fmla="*/ 183094 w 771787"/>
                <a:gd name="connsiteY96" fmla="*/ 53446 h 285887"/>
                <a:gd name="connsiteX97" fmla="*/ 124039 w 771787"/>
                <a:gd name="connsiteY97" fmla="*/ 95356 h 285887"/>
                <a:gd name="connsiteX98" fmla="*/ 87844 w 771787"/>
                <a:gd name="connsiteY98" fmla="*/ 125836 h 285887"/>
                <a:gd name="connsiteX99" fmla="*/ 55459 w 771787"/>
                <a:gd name="connsiteY99" fmla="*/ 158221 h 285887"/>
                <a:gd name="connsiteX100" fmla="*/ 21169 w 771787"/>
                <a:gd name="connsiteY100" fmla="*/ 203941 h 285887"/>
                <a:gd name="connsiteX101" fmla="*/ 9739 w 771787"/>
                <a:gd name="connsiteY101" fmla="*/ 226801 h 285887"/>
                <a:gd name="connsiteX102" fmla="*/ 214 w 771787"/>
                <a:gd name="connsiteY102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65735 w 771573"/>
                <a:gd name="connsiteY15" fmla="*/ 162031 h 285887"/>
                <a:gd name="connsiteX16" fmla="*/ 171450 w 771573"/>
                <a:gd name="connsiteY16" fmla="*/ 158221 h 285887"/>
                <a:gd name="connsiteX17" fmla="*/ 175260 w 771573"/>
                <a:gd name="connsiteY17" fmla="*/ 152506 h 285887"/>
                <a:gd name="connsiteX18" fmla="*/ 180975 w 771573"/>
                <a:gd name="connsiteY18" fmla="*/ 150601 h 285887"/>
                <a:gd name="connsiteX19" fmla="*/ 198120 w 771573"/>
                <a:gd name="connsiteY19" fmla="*/ 137266 h 285887"/>
                <a:gd name="connsiteX20" fmla="*/ 200025 w 771573"/>
                <a:gd name="connsiteY20" fmla="*/ 131551 h 285887"/>
                <a:gd name="connsiteX21" fmla="*/ 226695 w 771573"/>
                <a:gd name="connsiteY21" fmla="*/ 112501 h 285887"/>
                <a:gd name="connsiteX22" fmla="*/ 238125 w 771573"/>
                <a:gd name="connsiteY22" fmla="*/ 108691 h 285887"/>
                <a:gd name="connsiteX23" fmla="*/ 251460 w 771573"/>
                <a:gd name="connsiteY23" fmla="*/ 101071 h 285887"/>
                <a:gd name="connsiteX24" fmla="*/ 259080 w 771573"/>
                <a:gd name="connsiteY24" fmla="*/ 99166 h 285887"/>
                <a:gd name="connsiteX25" fmla="*/ 276225 w 771573"/>
                <a:gd name="connsiteY25" fmla="*/ 93451 h 285887"/>
                <a:gd name="connsiteX26" fmla="*/ 283845 w 771573"/>
                <a:gd name="connsiteY26" fmla="*/ 91546 h 285887"/>
                <a:gd name="connsiteX27" fmla="*/ 318135 w 771573"/>
                <a:gd name="connsiteY27" fmla="*/ 89641 h 285887"/>
                <a:gd name="connsiteX28" fmla="*/ 369570 w 771573"/>
                <a:gd name="connsiteY28" fmla="*/ 85831 h 285887"/>
                <a:gd name="connsiteX29" fmla="*/ 470535 w 771573"/>
                <a:gd name="connsiteY29" fmla="*/ 83926 h 285887"/>
                <a:gd name="connsiteX30" fmla="*/ 521970 w 771573"/>
                <a:gd name="connsiteY30" fmla="*/ 85831 h 285887"/>
                <a:gd name="connsiteX31" fmla="*/ 537210 w 771573"/>
                <a:gd name="connsiteY31" fmla="*/ 89641 h 285887"/>
                <a:gd name="connsiteX32" fmla="*/ 542925 w 771573"/>
                <a:gd name="connsiteY32" fmla="*/ 93451 h 285887"/>
                <a:gd name="connsiteX33" fmla="*/ 550545 w 771573"/>
                <a:gd name="connsiteY33" fmla="*/ 97261 h 285887"/>
                <a:gd name="connsiteX34" fmla="*/ 565785 w 771573"/>
                <a:gd name="connsiteY34" fmla="*/ 104881 h 285887"/>
                <a:gd name="connsiteX35" fmla="*/ 575310 w 771573"/>
                <a:gd name="connsiteY35" fmla="*/ 114406 h 285887"/>
                <a:gd name="connsiteX36" fmla="*/ 581025 w 771573"/>
                <a:gd name="connsiteY36" fmla="*/ 118216 h 285887"/>
                <a:gd name="connsiteX37" fmla="*/ 600075 w 771573"/>
                <a:gd name="connsiteY37" fmla="*/ 133456 h 285887"/>
                <a:gd name="connsiteX38" fmla="*/ 607695 w 771573"/>
                <a:gd name="connsiteY38" fmla="*/ 142981 h 285887"/>
                <a:gd name="connsiteX39" fmla="*/ 621030 w 771573"/>
                <a:gd name="connsiteY39" fmla="*/ 156316 h 285887"/>
                <a:gd name="connsiteX40" fmla="*/ 628650 w 771573"/>
                <a:gd name="connsiteY40" fmla="*/ 167746 h 285887"/>
                <a:gd name="connsiteX41" fmla="*/ 638175 w 771573"/>
                <a:gd name="connsiteY41" fmla="*/ 182986 h 285887"/>
                <a:gd name="connsiteX42" fmla="*/ 647700 w 771573"/>
                <a:gd name="connsiteY42" fmla="*/ 200131 h 285887"/>
                <a:gd name="connsiteX43" fmla="*/ 657225 w 771573"/>
                <a:gd name="connsiteY43" fmla="*/ 211561 h 285887"/>
                <a:gd name="connsiteX44" fmla="*/ 668655 w 771573"/>
                <a:gd name="connsiteY44" fmla="*/ 219181 h 285887"/>
                <a:gd name="connsiteX45" fmla="*/ 672465 w 771573"/>
                <a:gd name="connsiteY45" fmla="*/ 224896 h 285887"/>
                <a:gd name="connsiteX46" fmla="*/ 678180 w 771573"/>
                <a:gd name="connsiteY46" fmla="*/ 226801 h 285887"/>
                <a:gd name="connsiteX47" fmla="*/ 681990 w 771573"/>
                <a:gd name="connsiteY47" fmla="*/ 234421 h 285887"/>
                <a:gd name="connsiteX48" fmla="*/ 697230 w 771573"/>
                <a:gd name="connsiteY48" fmla="*/ 251566 h 285887"/>
                <a:gd name="connsiteX49" fmla="*/ 701040 w 771573"/>
                <a:gd name="connsiteY49" fmla="*/ 266806 h 285887"/>
                <a:gd name="connsiteX50" fmla="*/ 710565 w 771573"/>
                <a:gd name="connsiteY50" fmla="*/ 276331 h 285887"/>
                <a:gd name="connsiteX51" fmla="*/ 723900 w 771573"/>
                <a:gd name="connsiteY51" fmla="*/ 274426 h 285887"/>
                <a:gd name="connsiteX52" fmla="*/ 727710 w 771573"/>
                <a:gd name="connsiteY52" fmla="*/ 268711 h 285887"/>
                <a:gd name="connsiteX53" fmla="*/ 741045 w 771573"/>
                <a:gd name="connsiteY53" fmla="*/ 255376 h 285887"/>
                <a:gd name="connsiteX54" fmla="*/ 746760 w 771573"/>
                <a:gd name="connsiteY54" fmla="*/ 249661 h 285887"/>
                <a:gd name="connsiteX55" fmla="*/ 754380 w 771573"/>
                <a:gd name="connsiteY55" fmla="*/ 243946 h 285887"/>
                <a:gd name="connsiteX56" fmla="*/ 762000 w 771573"/>
                <a:gd name="connsiteY56" fmla="*/ 240136 h 285887"/>
                <a:gd name="connsiteX57" fmla="*/ 767715 w 771573"/>
                <a:gd name="connsiteY57" fmla="*/ 236326 h 285887"/>
                <a:gd name="connsiteX58" fmla="*/ 771525 w 771573"/>
                <a:gd name="connsiteY58" fmla="*/ 230611 h 285887"/>
                <a:gd name="connsiteX59" fmla="*/ 765810 w 771573"/>
                <a:gd name="connsiteY59" fmla="*/ 200131 h 285887"/>
                <a:gd name="connsiteX60" fmla="*/ 762000 w 771573"/>
                <a:gd name="connsiteY60" fmla="*/ 194416 h 285887"/>
                <a:gd name="connsiteX61" fmla="*/ 756285 w 771573"/>
                <a:gd name="connsiteY61" fmla="*/ 181081 h 285887"/>
                <a:gd name="connsiteX62" fmla="*/ 748665 w 771573"/>
                <a:gd name="connsiteY62" fmla="*/ 165841 h 285887"/>
                <a:gd name="connsiteX63" fmla="*/ 739140 w 771573"/>
                <a:gd name="connsiteY63" fmla="*/ 152506 h 285887"/>
                <a:gd name="connsiteX64" fmla="*/ 737235 w 771573"/>
                <a:gd name="connsiteY64" fmla="*/ 146791 h 285887"/>
                <a:gd name="connsiteX65" fmla="*/ 727710 w 771573"/>
                <a:gd name="connsiteY65" fmla="*/ 135361 h 285887"/>
                <a:gd name="connsiteX66" fmla="*/ 720090 w 771573"/>
                <a:gd name="connsiteY66" fmla="*/ 129646 h 285887"/>
                <a:gd name="connsiteX67" fmla="*/ 714375 w 771573"/>
                <a:gd name="connsiteY67" fmla="*/ 127741 h 285887"/>
                <a:gd name="connsiteX68" fmla="*/ 702945 w 771573"/>
                <a:gd name="connsiteY68" fmla="*/ 118216 h 285887"/>
                <a:gd name="connsiteX69" fmla="*/ 697230 w 771573"/>
                <a:gd name="connsiteY69" fmla="*/ 112501 h 285887"/>
                <a:gd name="connsiteX70" fmla="*/ 691515 w 771573"/>
                <a:gd name="connsiteY70" fmla="*/ 108691 h 285887"/>
                <a:gd name="connsiteX71" fmla="*/ 683895 w 771573"/>
                <a:gd name="connsiteY71" fmla="*/ 102976 h 285887"/>
                <a:gd name="connsiteX72" fmla="*/ 676275 w 771573"/>
                <a:gd name="connsiteY72" fmla="*/ 99166 h 285887"/>
                <a:gd name="connsiteX73" fmla="*/ 664845 w 771573"/>
                <a:gd name="connsiteY73" fmla="*/ 95356 h 285887"/>
                <a:gd name="connsiteX74" fmla="*/ 655320 w 771573"/>
                <a:gd name="connsiteY74" fmla="*/ 89641 h 285887"/>
                <a:gd name="connsiteX75" fmla="*/ 640080 w 771573"/>
                <a:gd name="connsiteY75" fmla="*/ 83926 h 285887"/>
                <a:gd name="connsiteX76" fmla="*/ 626745 w 771573"/>
                <a:gd name="connsiteY76" fmla="*/ 74401 h 285887"/>
                <a:gd name="connsiteX77" fmla="*/ 621030 w 771573"/>
                <a:gd name="connsiteY77" fmla="*/ 72496 h 285887"/>
                <a:gd name="connsiteX78" fmla="*/ 609600 w 771573"/>
                <a:gd name="connsiteY78" fmla="*/ 64876 h 285887"/>
                <a:gd name="connsiteX79" fmla="*/ 598170 w 771573"/>
                <a:gd name="connsiteY79" fmla="*/ 59161 h 285887"/>
                <a:gd name="connsiteX80" fmla="*/ 592455 w 771573"/>
                <a:gd name="connsiteY80" fmla="*/ 55351 h 285887"/>
                <a:gd name="connsiteX81" fmla="*/ 584835 w 771573"/>
                <a:gd name="connsiteY81" fmla="*/ 49636 h 285887"/>
                <a:gd name="connsiteX82" fmla="*/ 573405 w 771573"/>
                <a:gd name="connsiteY82" fmla="*/ 45826 h 285887"/>
                <a:gd name="connsiteX83" fmla="*/ 567690 w 771573"/>
                <a:gd name="connsiteY83" fmla="*/ 42016 h 285887"/>
                <a:gd name="connsiteX84" fmla="*/ 556260 w 771573"/>
                <a:gd name="connsiteY84" fmla="*/ 38206 h 285887"/>
                <a:gd name="connsiteX85" fmla="*/ 548640 w 771573"/>
                <a:gd name="connsiteY85" fmla="*/ 34396 h 285887"/>
                <a:gd name="connsiteX86" fmla="*/ 537210 w 771573"/>
                <a:gd name="connsiteY86" fmla="*/ 26776 h 285887"/>
                <a:gd name="connsiteX87" fmla="*/ 521970 w 771573"/>
                <a:gd name="connsiteY87" fmla="*/ 22966 h 285887"/>
                <a:gd name="connsiteX88" fmla="*/ 493395 w 771573"/>
                <a:gd name="connsiteY88" fmla="*/ 17251 h 285887"/>
                <a:gd name="connsiteX89" fmla="*/ 485775 w 771573"/>
                <a:gd name="connsiteY89" fmla="*/ 15346 h 285887"/>
                <a:gd name="connsiteX90" fmla="*/ 472440 w 771573"/>
                <a:gd name="connsiteY90" fmla="*/ 11536 h 285887"/>
                <a:gd name="connsiteX91" fmla="*/ 409575 w 771573"/>
                <a:gd name="connsiteY91" fmla="*/ 3916 h 285887"/>
                <a:gd name="connsiteX92" fmla="*/ 360045 w 771573"/>
                <a:gd name="connsiteY92" fmla="*/ 106 h 285887"/>
                <a:gd name="connsiteX93" fmla="*/ 300990 w 771573"/>
                <a:gd name="connsiteY93" fmla="*/ 2011 h 285887"/>
                <a:gd name="connsiteX94" fmla="*/ 268605 w 771573"/>
                <a:gd name="connsiteY94" fmla="*/ 9631 h 285887"/>
                <a:gd name="connsiteX95" fmla="*/ 226695 w 771573"/>
                <a:gd name="connsiteY95" fmla="*/ 26776 h 285887"/>
                <a:gd name="connsiteX96" fmla="*/ 182880 w 771573"/>
                <a:gd name="connsiteY96" fmla="*/ 53446 h 285887"/>
                <a:gd name="connsiteX97" fmla="*/ 123825 w 771573"/>
                <a:gd name="connsiteY97" fmla="*/ 95356 h 285887"/>
                <a:gd name="connsiteX98" fmla="*/ 87630 w 771573"/>
                <a:gd name="connsiteY98" fmla="*/ 125836 h 285887"/>
                <a:gd name="connsiteX99" fmla="*/ 55245 w 771573"/>
                <a:gd name="connsiteY99" fmla="*/ 158221 h 285887"/>
                <a:gd name="connsiteX100" fmla="*/ 20955 w 771573"/>
                <a:gd name="connsiteY100" fmla="*/ 203941 h 285887"/>
                <a:gd name="connsiteX101" fmla="*/ 0 w 771573"/>
                <a:gd name="connsiteY101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65735 w 771573"/>
                <a:gd name="connsiteY15" fmla="*/ 162031 h 285887"/>
                <a:gd name="connsiteX16" fmla="*/ 171450 w 771573"/>
                <a:gd name="connsiteY16" fmla="*/ 158221 h 285887"/>
                <a:gd name="connsiteX17" fmla="*/ 175260 w 771573"/>
                <a:gd name="connsiteY17" fmla="*/ 152506 h 285887"/>
                <a:gd name="connsiteX18" fmla="*/ 180975 w 771573"/>
                <a:gd name="connsiteY18" fmla="*/ 150601 h 285887"/>
                <a:gd name="connsiteX19" fmla="*/ 198120 w 771573"/>
                <a:gd name="connsiteY19" fmla="*/ 137266 h 285887"/>
                <a:gd name="connsiteX20" fmla="*/ 200025 w 771573"/>
                <a:gd name="connsiteY20" fmla="*/ 131551 h 285887"/>
                <a:gd name="connsiteX21" fmla="*/ 226695 w 771573"/>
                <a:gd name="connsiteY21" fmla="*/ 112501 h 285887"/>
                <a:gd name="connsiteX22" fmla="*/ 238125 w 771573"/>
                <a:gd name="connsiteY22" fmla="*/ 108691 h 285887"/>
                <a:gd name="connsiteX23" fmla="*/ 251460 w 771573"/>
                <a:gd name="connsiteY23" fmla="*/ 101071 h 285887"/>
                <a:gd name="connsiteX24" fmla="*/ 259080 w 771573"/>
                <a:gd name="connsiteY24" fmla="*/ 99166 h 285887"/>
                <a:gd name="connsiteX25" fmla="*/ 276225 w 771573"/>
                <a:gd name="connsiteY25" fmla="*/ 93451 h 285887"/>
                <a:gd name="connsiteX26" fmla="*/ 283845 w 771573"/>
                <a:gd name="connsiteY26" fmla="*/ 91546 h 285887"/>
                <a:gd name="connsiteX27" fmla="*/ 318135 w 771573"/>
                <a:gd name="connsiteY27" fmla="*/ 89641 h 285887"/>
                <a:gd name="connsiteX28" fmla="*/ 369570 w 771573"/>
                <a:gd name="connsiteY28" fmla="*/ 85831 h 285887"/>
                <a:gd name="connsiteX29" fmla="*/ 470535 w 771573"/>
                <a:gd name="connsiteY29" fmla="*/ 83926 h 285887"/>
                <a:gd name="connsiteX30" fmla="*/ 521970 w 771573"/>
                <a:gd name="connsiteY30" fmla="*/ 85831 h 285887"/>
                <a:gd name="connsiteX31" fmla="*/ 537210 w 771573"/>
                <a:gd name="connsiteY31" fmla="*/ 89641 h 285887"/>
                <a:gd name="connsiteX32" fmla="*/ 542925 w 771573"/>
                <a:gd name="connsiteY32" fmla="*/ 93451 h 285887"/>
                <a:gd name="connsiteX33" fmla="*/ 550545 w 771573"/>
                <a:gd name="connsiteY33" fmla="*/ 97261 h 285887"/>
                <a:gd name="connsiteX34" fmla="*/ 565785 w 771573"/>
                <a:gd name="connsiteY34" fmla="*/ 104881 h 285887"/>
                <a:gd name="connsiteX35" fmla="*/ 575310 w 771573"/>
                <a:gd name="connsiteY35" fmla="*/ 114406 h 285887"/>
                <a:gd name="connsiteX36" fmla="*/ 581025 w 771573"/>
                <a:gd name="connsiteY36" fmla="*/ 118216 h 285887"/>
                <a:gd name="connsiteX37" fmla="*/ 600075 w 771573"/>
                <a:gd name="connsiteY37" fmla="*/ 133456 h 285887"/>
                <a:gd name="connsiteX38" fmla="*/ 607695 w 771573"/>
                <a:gd name="connsiteY38" fmla="*/ 142981 h 285887"/>
                <a:gd name="connsiteX39" fmla="*/ 621030 w 771573"/>
                <a:gd name="connsiteY39" fmla="*/ 156316 h 285887"/>
                <a:gd name="connsiteX40" fmla="*/ 628650 w 771573"/>
                <a:gd name="connsiteY40" fmla="*/ 167746 h 285887"/>
                <a:gd name="connsiteX41" fmla="*/ 638175 w 771573"/>
                <a:gd name="connsiteY41" fmla="*/ 182986 h 285887"/>
                <a:gd name="connsiteX42" fmla="*/ 647700 w 771573"/>
                <a:gd name="connsiteY42" fmla="*/ 200131 h 285887"/>
                <a:gd name="connsiteX43" fmla="*/ 657225 w 771573"/>
                <a:gd name="connsiteY43" fmla="*/ 211561 h 285887"/>
                <a:gd name="connsiteX44" fmla="*/ 668655 w 771573"/>
                <a:gd name="connsiteY44" fmla="*/ 219181 h 285887"/>
                <a:gd name="connsiteX45" fmla="*/ 672465 w 771573"/>
                <a:gd name="connsiteY45" fmla="*/ 224896 h 285887"/>
                <a:gd name="connsiteX46" fmla="*/ 678180 w 771573"/>
                <a:gd name="connsiteY46" fmla="*/ 226801 h 285887"/>
                <a:gd name="connsiteX47" fmla="*/ 681990 w 771573"/>
                <a:gd name="connsiteY47" fmla="*/ 234421 h 285887"/>
                <a:gd name="connsiteX48" fmla="*/ 697230 w 771573"/>
                <a:gd name="connsiteY48" fmla="*/ 251566 h 285887"/>
                <a:gd name="connsiteX49" fmla="*/ 701040 w 771573"/>
                <a:gd name="connsiteY49" fmla="*/ 266806 h 285887"/>
                <a:gd name="connsiteX50" fmla="*/ 710565 w 771573"/>
                <a:gd name="connsiteY50" fmla="*/ 276331 h 285887"/>
                <a:gd name="connsiteX51" fmla="*/ 723900 w 771573"/>
                <a:gd name="connsiteY51" fmla="*/ 274426 h 285887"/>
                <a:gd name="connsiteX52" fmla="*/ 727710 w 771573"/>
                <a:gd name="connsiteY52" fmla="*/ 268711 h 285887"/>
                <a:gd name="connsiteX53" fmla="*/ 741045 w 771573"/>
                <a:gd name="connsiteY53" fmla="*/ 255376 h 285887"/>
                <a:gd name="connsiteX54" fmla="*/ 746760 w 771573"/>
                <a:gd name="connsiteY54" fmla="*/ 249661 h 285887"/>
                <a:gd name="connsiteX55" fmla="*/ 754380 w 771573"/>
                <a:gd name="connsiteY55" fmla="*/ 243946 h 285887"/>
                <a:gd name="connsiteX56" fmla="*/ 762000 w 771573"/>
                <a:gd name="connsiteY56" fmla="*/ 240136 h 285887"/>
                <a:gd name="connsiteX57" fmla="*/ 767715 w 771573"/>
                <a:gd name="connsiteY57" fmla="*/ 236326 h 285887"/>
                <a:gd name="connsiteX58" fmla="*/ 771525 w 771573"/>
                <a:gd name="connsiteY58" fmla="*/ 230611 h 285887"/>
                <a:gd name="connsiteX59" fmla="*/ 765810 w 771573"/>
                <a:gd name="connsiteY59" fmla="*/ 200131 h 285887"/>
                <a:gd name="connsiteX60" fmla="*/ 762000 w 771573"/>
                <a:gd name="connsiteY60" fmla="*/ 194416 h 285887"/>
                <a:gd name="connsiteX61" fmla="*/ 756285 w 771573"/>
                <a:gd name="connsiteY61" fmla="*/ 181081 h 285887"/>
                <a:gd name="connsiteX62" fmla="*/ 748665 w 771573"/>
                <a:gd name="connsiteY62" fmla="*/ 165841 h 285887"/>
                <a:gd name="connsiteX63" fmla="*/ 739140 w 771573"/>
                <a:gd name="connsiteY63" fmla="*/ 152506 h 285887"/>
                <a:gd name="connsiteX64" fmla="*/ 737235 w 771573"/>
                <a:gd name="connsiteY64" fmla="*/ 146791 h 285887"/>
                <a:gd name="connsiteX65" fmla="*/ 727710 w 771573"/>
                <a:gd name="connsiteY65" fmla="*/ 135361 h 285887"/>
                <a:gd name="connsiteX66" fmla="*/ 720090 w 771573"/>
                <a:gd name="connsiteY66" fmla="*/ 129646 h 285887"/>
                <a:gd name="connsiteX67" fmla="*/ 714375 w 771573"/>
                <a:gd name="connsiteY67" fmla="*/ 127741 h 285887"/>
                <a:gd name="connsiteX68" fmla="*/ 702945 w 771573"/>
                <a:gd name="connsiteY68" fmla="*/ 118216 h 285887"/>
                <a:gd name="connsiteX69" fmla="*/ 697230 w 771573"/>
                <a:gd name="connsiteY69" fmla="*/ 112501 h 285887"/>
                <a:gd name="connsiteX70" fmla="*/ 691515 w 771573"/>
                <a:gd name="connsiteY70" fmla="*/ 108691 h 285887"/>
                <a:gd name="connsiteX71" fmla="*/ 683895 w 771573"/>
                <a:gd name="connsiteY71" fmla="*/ 102976 h 285887"/>
                <a:gd name="connsiteX72" fmla="*/ 676275 w 771573"/>
                <a:gd name="connsiteY72" fmla="*/ 99166 h 285887"/>
                <a:gd name="connsiteX73" fmla="*/ 664845 w 771573"/>
                <a:gd name="connsiteY73" fmla="*/ 95356 h 285887"/>
                <a:gd name="connsiteX74" fmla="*/ 655320 w 771573"/>
                <a:gd name="connsiteY74" fmla="*/ 89641 h 285887"/>
                <a:gd name="connsiteX75" fmla="*/ 640080 w 771573"/>
                <a:gd name="connsiteY75" fmla="*/ 83926 h 285887"/>
                <a:gd name="connsiteX76" fmla="*/ 626745 w 771573"/>
                <a:gd name="connsiteY76" fmla="*/ 74401 h 285887"/>
                <a:gd name="connsiteX77" fmla="*/ 621030 w 771573"/>
                <a:gd name="connsiteY77" fmla="*/ 72496 h 285887"/>
                <a:gd name="connsiteX78" fmla="*/ 609600 w 771573"/>
                <a:gd name="connsiteY78" fmla="*/ 64876 h 285887"/>
                <a:gd name="connsiteX79" fmla="*/ 598170 w 771573"/>
                <a:gd name="connsiteY79" fmla="*/ 59161 h 285887"/>
                <a:gd name="connsiteX80" fmla="*/ 592455 w 771573"/>
                <a:gd name="connsiteY80" fmla="*/ 55351 h 285887"/>
                <a:gd name="connsiteX81" fmla="*/ 584835 w 771573"/>
                <a:gd name="connsiteY81" fmla="*/ 49636 h 285887"/>
                <a:gd name="connsiteX82" fmla="*/ 573405 w 771573"/>
                <a:gd name="connsiteY82" fmla="*/ 45826 h 285887"/>
                <a:gd name="connsiteX83" fmla="*/ 567690 w 771573"/>
                <a:gd name="connsiteY83" fmla="*/ 42016 h 285887"/>
                <a:gd name="connsiteX84" fmla="*/ 556260 w 771573"/>
                <a:gd name="connsiteY84" fmla="*/ 38206 h 285887"/>
                <a:gd name="connsiteX85" fmla="*/ 548640 w 771573"/>
                <a:gd name="connsiteY85" fmla="*/ 34396 h 285887"/>
                <a:gd name="connsiteX86" fmla="*/ 537210 w 771573"/>
                <a:gd name="connsiteY86" fmla="*/ 26776 h 285887"/>
                <a:gd name="connsiteX87" fmla="*/ 493395 w 771573"/>
                <a:gd name="connsiteY87" fmla="*/ 17251 h 285887"/>
                <a:gd name="connsiteX88" fmla="*/ 485775 w 771573"/>
                <a:gd name="connsiteY88" fmla="*/ 15346 h 285887"/>
                <a:gd name="connsiteX89" fmla="*/ 472440 w 771573"/>
                <a:gd name="connsiteY89" fmla="*/ 11536 h 285887"/>
                <a:gd name="connsiteX90" fmla="*/ 409575 w 771573"/>
                <a:gd name="connsiteY90" fmla="*/ 3916 h 285887"/>
                <a:gd name="connsiteX91" fmla="*/ 360045 w 771573"/>
                <a:gd name="connsiteY91" fmla="*/ 106 h 285887"/>
                <a:gd name="connsiteX92" fmla="*/ 300990 w 771573"/>
                <a:gd name="connsiteY92" fmla="*/ 2011 h 285887"/>
                <a:gd name="connsiteX93" fmla="*/ 268605 w 771573"/>
                <a:gd name="connsiteY93" fmla="*/ 9631 h 285887"/>
                <a:gd name="connsiteX94" fmla="*/ 226695 w 771573"/>
                <a:gd name="connsiteY94" fmla="*/ 26776 h 285887"/>
                <a:gd name="connsiteX95" fmla="*/ 182880 w 771573"/>
                <a:gd name="connsiteY95" fmla="*/ 53446 h 285887"/>
                <a:gd name="connsiteX96" fmla="*/ 123825 w 771573"/>
                <a:gd name="connsiteY96" fmla="*/ 95356 h 285887"/>
                <a:gd name="connsiteX97" fmla="*/ 87630 w 771573"/>
                <a:gd name="connsiteY97" fmla="*/ 125836 h 285887"/>
                <a:gd name="connsiteX98" fmla="*/ 55245 w 771573"/>
                <a:gd name="connsiteY98" fmla="*/ 158221 h 285887"/>
                <a:gd name="connsiteX99" fmla="*/ 20955 w 771573"/>
                <a:gd name="connsiteY99" fmla="*/ 203941 h 285887"/>
                <a:gd name="connsiteX100" fmla="*/ 0 w 771573"/>
                <a:gd name="connsiteY100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65735 w 771573"/>
                <a:gd name="connsiteY15" fmla="*/ 162031 h 285887"/>
                <a:gd name="connsiteX16" fmla="*/ 171450 w 771573"/>
                <a:gd name="connsiteY16" fmla="*/ 158221 h 285887"/>
                <a:gd name="connsiteX17" fmla="*/ 175260 w 771573"/>
                <a:gd name="connsiteY17" fmla="*/ 152506 h 285887"/>
                <a:gd name="connsiteX18" fmla="*/ 180975 w 771573"/>
                <a:gd name="connsiteY18" fmla="*/ 150601 h 285887"/>
                <a:gd name="connsiteX19" fmla="*/ 198120 w 771573"/>
                <a:gd name="connsiteY19" fmla="*/ 137266 h 285887"/>
                <a:gd name="connsiteX20" fmla="*/ 200025 w 771573"/>
                <a:gd name="connsiteY20" fmla="*/ 131551 h 285887"/>
                <a:gd name="connsiteX21" fmla="*/ 226695 w 771573"/>
                <a:gd name="connsiteY21" fmla="*/ 112501 h 285887"/>
                <a:gd name="connsiteX22" fmla="*/ 238125 w 771573"/>
                <a:gd name="connsiteY22" fmla="*/ 108691 h 285887"/>
                <a:gd name="connsiteX23" fmla="*/ 251460 w 771573"/>
                <a:gd name="connsiteY23" fmla="*/ 101071 h 285887"/>
                <a:gd name="connsiteX24" fmla="*/ 259080 w 771573"/>
                <a:gd name="connsiteY24" fmla="*/ 99166 h 285887"/>
                <a:gd name="connsiteX25" fmla="*/ 276225 w 771573"/>
                <a:gd name="connsiteY25" fmla="*/ 93451 h 285887"/>
                <a:gd name="connsiteX26" fmla="*/ 283845 w 771573"/>
                <a:gd name="connsiteY26" fmla="*/ 91546 h 285887"/>
                <a:gd name="connsiteX27" fmla="*/ 319563 w 771573"/>
                <a:gd name="connsiteY27" fmla="*/ 82846 h 285887"/>
                <a:gd name="connsiteX28" fmla="*/ 369570 w 771573"/>
                <a:gd name="connsiteY28" fmla="*/ 85831 h 285887"/>
                <a:gd name="connsiteX29" fmla="*/ 470535 w 771573"/>
                <a:gd name="connsiteY29" fmla="*/ 83926 h 285887"/>
                <a:gd name="connsiteX30" fmla="*/ 521970 w 771573"/>
                <a:gd name="connsiteY30" fmla="*/ 85831 h 285887"/>
                <a:gd name="connsiteX31" fmla="*/ 537210 w 771573"/>
                <a:gd name="connsiteY31" fmla="*/ 89641 h 285887"/>
                <a:gd name="connsiteX32" fmla="*/ 542925 w 771573"/>
                <a:gd name="connsiteY32" fmla="*/ 93451 h 285887"/>
                <a:gd name="connsiteX33" fmla="*/ 550545 w 771573"/>
                <a:gd name="connsiteY33" fmla="*/ 97261 h 285887"/>
                <a:gd name="connsiteX34" fmla="*/ 565785 w 771573"/>
                <a:gd name="connsiteY34" fmla="*/ 104881 h 285887"/>
                <a:gd name="connsiteX35" fmla="*/ 575310 w 771573"/>
                <a:gd name="connsiteY35" fmla="*/ 114406 h 285887"/>
                <a:gd name="connsiteX36" fmla="*/ 581025 w 771573"/>
                <a:gd name="connsiteY36" fmla="*/ 118216 h 285887"/>
                <a:gd name="connsiteX37" fmla="*/ 600075 w 771573"/>
                <a:gd name="connsiteY37" fmla="*/ 133456 h 285887"/>
                <a:gd name="connsiteX38" fmla="*/ 607695 w 771573"/>
                <a:gd name="connsiteY38" fmla="*/ 142981 h 285887"/>
                <a:gd name="connsiteX39" fmla="*/ 621030 w 771573"/>
                <a:gd name="connsiteY39" fmla="*/ 156316 h 285887"/>
                <a:gd name="connsiteX40" fmla="*/ 628650 w 771573"/>
                <a:gd name="connsiteY40" fmla="*/ 167746 h 285887"/>
                <a:gd name="connsiteX41" fmla="*/ 638175 w 771573"/>
                <a:gd name="connsiteY41" fmla="*/ 182986 h 285887"/>
                <a:gd name="connsiteX42" fmla="*/ 647700 w 771573"/>
                <a:gd name="connsiteY42" fmla="*/ 200131 h 285887"/>
                <a:gd name="connsiteX43" fmla="*/ 657225 w 771573"/>
                <a:gd name="connsiteY43" fmla="*/ 211561 h 285887"/>
                <a:gd name="connsiteX44" fmla="*/ 668655 w 771573"/>
                <a:gd name="connsiteY44" fmla="*/ 219181 h 285887"/>
                <a:gd name="connsiteX45" fmla="*/ 672465 w 771573"/>
                <a:gd name="connsiteY45" fmla="*/ 224896 h 285887"/>
                <a:gd name="connsiteX46" fmla="*/ 678180 w 771573"/>
                <a:gd name="connsiteY46" fmla="*/ 226801 h 285887"/>
                <a:gd name="connsiteX47" fmla="*/ 681990 w 771573"/>
                <a:gd name="connsiteY47" fmla="*/ 234421 h 285887"/>
                <a:gd name="connsiteX48" fmla="*/ 697230 w 771573"/>
                <a:gd name="connsiteY48" fmla="*/ 251566 h 285887"/>
                <a:gd name="connsiteX49" fmla="*/ 701040 w 771573"/>
                <a:gd name="connsiteY49" fmla="*/ 266806 h 285887"/>
                <a:gd name="connsiteX50" fmla="*/ 710565 w 771573"/>
                <a:gd name="connsiteY50" fmla="*/ 276331 h 285887"/>
                <a:gd name="connsiteX51" fmla="*/ 723900 w 771573"/>
                <a:gd name="connsiteY51" fmla="*/ 274426 h 285887"/>
                <a:gd name="connsiteX52" fmla="*/ 727710 w 771573"/>
                <a:gd name="connsiteY52" fmla="*/ 268711 h 285887"/>
                <a:gd name="connsiteX53" fmla="*/ 741045 w 771573"/>
                <a:gd name="connsiteY53" fmla="*/ 255376 h 285887"/>
                <a:gd name="connsiteX54" fmla="*/ 746760 w 771573"/>
                <a:gd name="connsiteY54" fmla="*/ 249661 h 285887"/>
                <a:gd name="connsiteX55" fmla="*/ 754380 w 771573"/>
                <a:gd name="connsiteY55" fmla="*/ 243946 h 285887"/>
                <a:gd name="connsiteX56" fmla="*/ 762000 w 771573"/>
                <a:gd name="connsiteY56" fmla="*/ 240136 h 285887"/>
                <a:gd name="connsiteX57" fmla="*/ 767715 w 771573"/>
                <a:gd name="connsiteY57" fmla="*/ 236326 h 285887"/>
                <a:gd name="connsiteX58" fmla="*/ 771525 w 771573"/>
                <a:gd name="connsiteY58" fmla="*/ 230611 h 285887"/>
                <a:gd name="connsiteX59" fmla="*/ 765810 w 771573"/>
                <a:gd name="connsiteY59" fmla="*/ 200131 h 285887"/>
                <a:gd name="connsiteX60" fmla="*/ 762000 w 771573"/>
                <a:gd name="connsiteY60" fmla="*/ 194416 h 285887"/>
                <a:gd name="connsiteX61" fmla="*/ 756285 w 771573"/>
                <a:gd name="connsiteY61" fmla="*/ 181081 h 285887"/>
                <a:gd name="connsiteX62" fmla="*/ 748665 w 771573"/>
                <a:gd name="connsiteY62" fmla="*/ 165841 h 285887"/>
                <a:gd name="connsiteX63" fmla="*/ 739140 w 771573"/>
                <a:gd name="connsiteY63" fmla="*/ 152506 h 285887"/>
                <a:gd name="connsiteX64" fmla="*/ 737235 w 771573"/>
                <a:gd name="connsiteY64" fmla="*/ 146791 h 285887"/>
                <a:gd name="connsiteX65" fmla="*/ 727710 w 771573"/>
                <a:gd name="connsiteY65" fmla="*/ 135361 h 285887"/>
                <a:gd name="connsiteX66" fmla="*/ 720090 w 771573"/>
                <a:gd name="connsiteY66" fmla="*/ 129646 h 285887"/>
                <a:gd name="connsiteX67" fmla="*/ 714375 w 771573"/>
                <a:gd name="connsiteY67" fmla="*/ 127741 h 285887"/>
                <a:gd name="connsiteX68" fmla="*/ 702945 w 771573"/>
                <a:gd name="connsiteY68" fmla="*/ 118216 h 285887"/>
                <a:gd name="connsiteX69" fmla="*/ 697230 w 771573"/>
                <a:gd name="connsiteY69" fmla="*/ 112501 h 285887"/>
                <a:gd name="connsiteX70" fmla="*/ 691515 w 771573"/>
                <a:gd name="connsiteY70" fmla="*/ 108691 h 285887"/>
                <a:gd name="connsiteX71" fmla="*/ 683895 w 771573"/>
                <a:gd name="connsiteY71" fmla="*/ 102976 h 285887"/>
                <a:gd name="connsiteX72" fmla="*/ 676275 w 771573"/>
                <a:gd name="connsiteY72" fmla="*/ 99166 h 285887"/>
                <a:gd name="connsiteX73" fmla="*/ 664845 w 771573"/>
                <a:gd name="connsiteY73" fmla="*/ 95356 h 285887"/>
                <a:gd name="connsiteX74" fmla="*/ 655320 w 771573"/>
                <a:gd name="connsiteY74" fmla="*/ 89641 h 285887"/>
                <a:gd name="connsiteX75" fmla="*/ 640080 w 771573"/>
                <a:gd name="connsiteY75" fmla="*/ 83926 h 285887"/>
                <a:gd name="connsiteX76" fmla="*/ 626745 w 771573"/>
                <a:gd name="connsiteY76" fmla="*/ 74401 h 285887"/>
                <a:gd name="connsiteX77" fmla="*/ 621030 w 771573"/>
                <a:gd name="connsiteY77" fmla="*/ 72496 h 285887"/>
                <a:gd name="connsiteX78" fmla="*/ 609600 w 771573"/>
                <a:gd name="connsiteY78" fmla="*/ 64876 h 285887"/>
                <a:gd name="connsiteX79" fmla="*/ 598170 w 771573"/>
                <a:gd name="connsiteY79" fmla="*/ 59161 h 285887"/>
                <a:gd name="connsiteX80" fmla="*/ 592455 w 771573"/>
                <a:gd name="connsiteY80" fmla="*/ 55351 h 285887"/>
                <a:gd name="connsiteX81" fmla="*/ 584835 w 771573"/>
                <a:gd name="connsiteY81" fmla="*/ 49636 h 285887"/>
                <a:gd name="connsiteX82" fmla="*/ 573405 w 771573"/>
                <a:gd name="connsiteY82" fmla="*/ 45826 h 285887"/>
                <a:gd name="connsiteX83" fmla="*/ 567690 w 771573"/>
                <a:gd name="connsiteY83" fmla="*/ 42016 h 285887"/>
                <a:gd name="connsiteX84" fmla="*/ 556260 w 771573"/>
                <a:gd name="connsiteY84" fmla="*/ 38206 h 285887"/>
                <a:gd name="connsiteX85" fmla="*/ 548640 w 771573"/>
                <a:gd name="connsiteY85" fmla="*/ 34396 h 285887"/>
                <a:gd name="connsiteX86" fmla="*/ 537210 w 771573"/>
                <a:gd name="connsiteY86" fmla="*/ 26776 h 285887"/>
                <a:gd name="connsiteX87" fmla="*/ 493395 w 771573"/>
                <a:gd name="connsiteY87" fmla="*/ 17251 h 285887"/>
                <a:gd name="connsiteX88" fmla="*/ 485775 w 771573"/>
                <a:gd name="connsiteY88" fmla="*/ 15346 h 285887"/>
                <a:gd name="connsiteX89" fmla="*/ 472440 w 771573"/>
                <a:gd name="connsiteY89" fmla="*/ 11536 h 285887"/>
                <a:gd name="connsiteX90" fmla="*/ 409575 w 771573"/>
                <a:gd name="connsiteY90" fmla="*/ 3916 h 285887"/>
                <a:gd name="connsiteX91" fmla="*/ 360045 w 771573"/>
                <a:gd name="connsiteY91" fmla="*/ 106 h 285887"/>
                <a:gd name="connsiteX92" fmla="*/ 300990 w 771573"/>
                <a:gd name="connsiteY92" fmla="*/ 2011 h 285887"/>
                <a:gd name="connsiteX93" fmla="*/ 268605 w 771573"/>
                <a:gd name="connsiteY93" fmla="*/ 9631 h 285887"/>
                <a:gd name="connsiteX94" fmla="*/ 226695 w 771573"/>
                <a:gd name="connsiteY94" fmla="*/ 26776 h 285887"/>
                <a:gd name="connsiteX95" fmla="*/ 182880 w 771573"/>
                <a:gd name="connsiteY95" fmla="*/ 53446 h 285887"/>
                <a:gd name="connsiteX96" fmla="*/ 123825 w 771573"/>
                <a:gd name="connsiteY96" fmla="*/ 95356 h 285887"/>
                <a:gd name="connsiteX97" fmla="*/ 87630 w 771573"/>
                <a:gd name="connsiteY97" fmla="*/ 125836 h 285887"/>
                <a:gd name="connsiteX98" fmla="*/ 55245 w 771573"/>
                <a:gd name="connsiteY98" fmla="*/ 158221 h 285887"/>
                <a:gd name="connsiteX99" fmla="*/ 20955 w 771573"/>
                <a:gd name="connsiteY99" fmla="*/ 203941 h 285887"/>
                <a:gd name="connsiteX100" fmla="*/ 0 w 771573"/>
                <a:gd name="connsiteY100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65735 w 771573"/>
                <a:gd name="connsiteY15" fmla="*/ 162031 h 285887"/>
                <a:gd name="connsiteX16" fmla="*/ 171450 w 771573"/>
                <a:gd name="connsiteY16" fmla="*/ 158221 h 285887"/>
                <a:gd name="connsiteX17" fmla="*/ 175260 w 771573"/>
                <a:gd name="connsiteY17" fmla="*/ 152506 h 285887"/>
                <a:gd name="connsiteX18" fmla="*/ 180975 w 771573"/>
                <a:gd name="connsiteY18" fmla="*/ 150601 h 285887"/>
                <a:gd name="connsiteX19" fmla="*/ 198120 w 771573"/>
                <a:gd name="connsiteY19" fmla="*/ 137266 h 285887"/>
                <a:gd name="connsiteX20" fmla="*/ 200025 w 771573"/>
                <a:gd name="connsiteY20" fmla="*/ 131551 h 285887"/>
                <a:gd name="connsiteX21" fmla="*/ 226695 w 771573"/>
                <a:gd name="connsiteY21" fmla="*/ 112501 h 285887"/>
                <a:gd name="connsiteX22" fmla="*/ 238125 w 771573"/>
                <a:gd name="connsiteY22" fmla="*/ 108691 h 285887"/>
                <a:gd name="connsiteX23" fmla="*/ 251460 w 771573"/>
                <a:gd name="connsiteY23" fmla="*/ 101071 h 285887"/>
                <a:gd name="connsiteX24" fmla="*/ 259080 w 771573"/>
                <a:gd name="connsiteY24" fmla="*/ 99166 h 285887"/>
                <a:gd name="connsiteX25" fmla="*/ 276225 w 771573"/>
                <a:gd name="connsiteY25" fmla="*/ 93451 h 285887"/>
                <a:gd name="connsiteX26" fmla="*/ 283845 w 771573"/>
                <a:gd name="connsiteY26" fmla="*/ 91546 h 285887"/>
                <a:gd name="connsiteX27" fmla="*/ 319563 w 771573"/>
                <a:gd name="connsiteY27" fmla="*/ 82846 h 285887"/>
                <a:gd name="connsiteX28" fmla="*/ 372425 w 771573"/>
                <a:gd name="connsiteY28" fmla="*/ 78470 h 285887"/>
                <a:gd name="connsiteX29" fmla="*/ 470535 w 771573"/>
                <a:gd name="connsiteY29" fmla="*/ 83926 h 285887"/>
                <a:gd name="connsiteX30" fmla="*/ 521970 w 771573"/>
                <a:gd name="connsiteY30" fmla="*/ 85831 h 285887"/>
                <a:gd name="connsiteX31" fmla="*/ 537210 w 771573"/>
                <a:gd name="connsiteY31" fmla="*/ 89641 h 285887"/>
                <a:gd name="connsiteX32" fmla="*/ 542925 w 771573"/>
                <a:gd name="connsiteY32" fmla="*/ 93451 h 285887"/>
                <a:gd name="connsiteX33" fmla="*/ 550545 w 771573"/>
                <a:gd name="connsiteY33" fmla="*/ 97261 h 285887"/>
                <a:gd name="connsiteX34" fmla="*/ 565785 w 771573"/>
                <a:gd name="connsiteY34" fmla="*/ 104881 h 285887"/>
                <a:gd name="connsiteX35" fmla="*/ 575310 w 771573"/>
                <a:gd name="connsiteY35" fmla="*/ 114406 h 285887"/>
                <a:gd name="connsiteX36" fmla="*/ 581025 w 771573"/>
                <a:gd name="connsiteY36" fmla="*/ 118216 h 285887"/>
                <a:gd name="connsiteX37" fmla="*/ 600075 w 771573"/>
                <a:gd name="connsiteY37" fmla="*/ 133456 h 285887"/>
                <a:gd name="connsiteX38" fmla="*/ 607695 w 771573"/>
                <a:gd name="connsiteY38" fmla="*/ 142981 h 285887"/>
                <a:gd name="connsiteX39" fmla="*/ 621030 w 771573"/>
                <a:gd name="connsiteY39" fmla="*/ 156316 h 285887"/>
                <a:gd name="connsiteX40" fmla="*/ 628650 w 771573"/>
                <a:gd name="connsiteY40" fmla="*/ 167746 h 285887"/>
                <a:gd name="connsiteX41" fmla="*/ 638175 w 771573"/>
                <a:gd name="connsiteY41" fmla="*/ 182986 h 285887"/>
                <a:gd name="connsiteX42" fmla="*/ 647700 w 771573"/>
                <a:gd name="connsiteY42" fmla="*/ 200131 h 285887"/>
                <a:gd name="connsiteX43" fmla="*/ 657225 w 771573"/>
                <a:gd name="connsiteY43" fmla="*/ 211561 h 285887"/>
                <a:gd name="connsiteX44" fmla="*/ 668655 w 771573"/>
                <a:gd name="connsiteY44" fmla="*/ 219181 h 285887"/>
                <a:gd name="connsiteX45" fmla="*/ 672465 w 771573"/>
                <a:gd name="connsiteY45" fmla="*/ 224896 h 285887"/>
                <a:gd name="connsiteX46" fmla="*/ 678180 w 771573"/>
                <a:gd name="connsiteY46" fmla="*/ 226801 h 285887"/>
                <a:gd name="connsiteX47" fmla="*/ 681990 w 771573"/>
                <a:gd name="connsiteY47" fmla="*/ 234421 h 285887"/>
                <a:gd name="connsiteX48" fmla="*/ 697230 w 771573"/>
                <a:gd name="connsiteY48" fmla="*/ 251566 h 285887"/>
                <a:gd name="connsiteX49" fmla="*/ 701040 w 771573"/>
                <a:gd name="connsiteY49" fmla="*/ 266806 h 285887"/>
                <a:gd name="connsiteX50" fmla="*/ 710565 w 771573"/>
                <a:gd name="connsiteY50" fmla="*/ 276331 h 285887"/>
                <a:gd name="connsiteX51" fmla="*/ 723900 w 771573"/>
                <a:gd name="connsiteY51" fmla="*/ 274426 h 285887"/>
                <a:gd name="connsiteX52" fmla="*/ 727710 w 771573"/>
                <a:gd name="connsiteY52" fmla="*/ 268711 h 285887"/>
                <a:gd name="connsiteX53" fmla="*/ 741045 w 771573"/>
                <a:gd name="connsiteY53" fmla="*/ 255376 h 285887"/>
                <a:gd name="connsiteX54" fmla="*/ 746760 w 771573"/>
                <a:gd name="connsiteY54" fmla="*/ 249661 h 285887"/>
                <a:gd name="connsiteX55" fmla="*/ 754380 w 771573"/>
                <a:gd name="connsiteY55" fmla="*/ 243946 h 285887"/>
                <a:gd name="connsiteX56" fmla="*/ 762000 w 771573"/>
                <a:gd name="connsiteY56" fmla="*/ 240136 h 285887"/>
                <a:gd name="connsiteX57" fmla="*/ 767715 w 771573"/>
                <a:gd name="connsiteY57" fmla="*/ 236326 h 285887"/>
                <a:gd name="connsiteX58" fmla="*/ 771525 w 771573"/>
                <a:gd name="connsiteY58" fmla="*/ 230611 h 285887"/>
                <a:gd name="connsiteX59" fmla="*/ 765810 w 771573"/>
                <a:gd name="connsiteY59" fmla="*/ 200131 h 285887"/>
                <a:gd name="connsiteX60" fmla="*/ 762000 w 771573"/>
                <a:gd name="connsiteY60" fmla="*/ 194416 h 285887"/>
                <a:gd name="connsiteX61" fmla="*/ 756285 w 771573"/>
                <a:gd name="connsiteY61" fmla="*/ 181081 h 285887"/>
                <a:gd name="connsiteX62" fmla="*/ 748665 w 771573"/>
                <a:gd name="connsiteY62" fmla="*/ 165841 h 285887"/>
                <a:gd name="connsiteX63" fmla="*/ 739140 w 771573"/>
                <a:gd name="connsiteY63" fmla="*/ 152506 h 285887"/>
                <a:gd name="connsiteX64" fmla="*/ 737235 w 771573"/>
                <a:gd name="connsiteY64" fmla="*/ 146791 h 285887"/>
                <a:gd name="connsiteX65" fmla="*/ 727710 w 771573"/>
                <a:gd name="connsiteY65" fmla="*/ 135361 h 285887"/>
                <a:gd name="connsiteX66" fmla="*/ 720090 w 771573"/>
                <a:gd name="connsiteY66" fmla="*/ 129646 h 285887"/>
                <a:gd name="connsiteX67" fmla="*/ 714375 w 771573"/>
                <a:gd name="connsiteY67" fmla="*/ 127741 h 285887"/>
                <a:gd name="connsiteX68" fmla="*/ 702945 w 771573"/>
                <a:gd name="connsiteY68" fmla="*/ 118216 h 285887"/>
                <a:gd name="connsiteX69" fmla="*/ 697230 w 771573"/>
                <a:gd name="connsiteY69" fmla="*/ 112501 h 285887"/>
                <a:gd name="connsiteX70" fmla="*/ 691515 w 771573"/>
                <a:gd name="connsiteY70" fmla="*/ 108691 h 285887"/>
                <a:gd name="connsiteX71" fmla="*/ 683895 w 771573"/>
                <a:gd name="connsiteY71" fmla="*/ 102976 h 285887"/>
                <a:gd name="connsiteX72" fmla="*/ 676275 w 771573"/>
                <a:gd name="connsiteY72" fmla="*/ 99166 h 285887"/>
                <a:gd name="connsiteX73" fmla="*/ 664845 w 771573"/>
                <a:gd name="connsiteY73" fmla="*/ 95356 h 285887"/>
                <a:gd name="connsiteX74" fmla="*/ 655320 w 771573"/>
                <a:gd name="connsiteY74" fmla="*/ 89641 h 285887"/>
                <a:gd name="connsiteX75" fmla="*/ 640080 w 771573"/>
                <a:gd name="connsiteY75" fmla="*/ 83926 h 285887"/>
                <a:gd name="connsiteX76" fmla="*/ 626745 w 771573"/>
                <a:gd name="connsiteY76" fmla="*/ 74401 h 285887"/>
                <a:gd name="connsiteX77" fmla="*/ 621030 w 771573"/>
                <a:gd name="connsiteY77" fmla="*/ 72496 h 285887"/>
                <a:gd name="connsiteX78" fmla="*/ 609600 w 771573"/>
                <a:gd name="connsiteY78" fmla="*/ 64876 h 285887"/>
                <a:gd name="connsiteX79" fmla="*/ 598170 w 771573"/>
                <a:gd name="connsiteY79" fmla="*/ 59161 h 285887"/>
                <a:gd name="connsiteX80" fmla="*/ 592455 w 771573"/>
                <a:gd name="connsiteY80" fmla="*/ 55351 h 285887"/>
                <a:gd name="connsiteX81" fmla="*/ 584835 w 771573"/>
                <a:gd name="connsiteY81" fmla="*/ 49636 h 285887"/>
                <a:gd name="connsiteX82" fmla="*/ 573405 w 771573"/>
                <a:gd name="connsiteY82" fmla="*/ 45826 h 285887"/>
                <a:gd name="connsiteX83" fmla="*/ 567690 w 771573"/>
                <a:gd name="connsiteY83" fmla="*/ 42016 h 285887"/>
                <a:gd name="connsiteX84" fmla="*/ 556260 w 771573"/>
                <a:gd name="connsiteY84" fmla="*/ 38206 h 285887"/>
                <a:gd name="connsiteX85" fmla="*/ 548640 w 771573"/>
                <a:gd name="connsiteY85" fmla="*/ 34396 h 285887"/>
                <a:gd name="connsiteX86" fmla="*/ 537210 w 771573"/>
                <a:gd name="connsiteY86" fmla="*/ 26776 h 285887"/>
                <a:gd name="connsiteX87" fmla="*/ 493395 w 771573"/>
                <a:gd name="connsiteY87" fmla="*/ 17251 h 285887"/>
                <a:gd name="connsiteX88" fmla="*/ 485775 w 771573"/>
                <a:gd name="connsiteY88" fmla="*/ 15346 h 285887"/>
                <a:gd name="connsiteX89" fmla="*/ 472440 w 771573"/>
                <a:gd name="connsiteY89" fmla="*/ 11536 h 285887"/>
                <a:gd name="connsiteX90" fmla="*/ 409575 w 771573"/>
                <a:gd name="connsiteY90" fmla="*/ 3916 h 285887"/>
                <a:gd name="connsiteX91" fmla="*/ 360045 w 771573"/>
                <a:gd name="connsiteY91" fmla="*/ 106 h 285887"/>
                <a:gd name="connsiteX92" fmla="*/ 300990 w 771573"/>
                <a:gd name="connsiteY92" fmla="*/ 2011 h 285887"/>
                <a:gd name="connsiteX93" fmla="*/ 268605 w 771573"/>
                <a:gd name="connsiteY93" fmla="*/ 9631 h 285887"/>
                <a:gd name="connsiteX94" fmla="*/ 226695 w 771573"/>
                <a:gd name="connsiteY94" fmla="*/ 26776 h 285887"/>
                <a:gd name="connsiteX95" fmla="*/ 182880 w 771573"/>
                <a:gd name="connsiteY95" fmla="*/ 53446 h 285887"/>
                <a:gd name="connsiteX96" fmla="*/ 123825 w 771573"/>
                <a:gd name="connsiteY96" fmla="*/ 95356 h 285887"/>
                <a:gd name="connsiteX97" fmla="*/ 87630 w 771573"/>
                <a:gd name="connsiteY97" fmla="*/ 125836 h 285887"/>
                <a:gd name="connsiteX98" fmla="*/ 55245 w 771573"/>
                <a:gd name="connsiteY98" fmla="*/ 158221 h 285887"/>
                <a:gd name="connsiteX99" fmla="*/ 20955 w 771573"/>
                <a:gd name="connsiteY99" fmla="*/ 203941 h 285887"/>
                <a:gd name="connsiteX100" fmla="*/ 0 w 771573"/>
                <a:gd name="connsiteY100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65735 w 771573"/>
                <a:gd name="connsiteY15" fmla="*/ 162031 h 285887"/>
                <a:gd name="connsiteX16" fmla="*/ 171450 w 771573"/>
                <a:gd name="connsiteY16" fmla="*/ 158221 h 285887"/>
                <a:gd name="connsiteX17" fmla="*/ 175260 w 771573"/>
                <a:gd name="connsiteY17" fmla="*/ 152506 h 285887"/>
                <a:gd name="connsiteX18" fmla="*/ 180975 w 771573"/>
                <a:gd name="connsiteY18" fmla="*/ 150601 h 285887"/>
                <a:gd name="connsiteX19" fmla="*/ 198120 w 771573"/>
                <a:gd name="connsiteY19" fmla="*/ 137266 h 285887"/>
                <a:gd name="connsiteX20" fmla="*/ 200025 w 771573"/>
                <a:gd name="connsiteY20" fmla="*/ 131551 h 285887"/>
                <a:gd name="connsiteX21" fmla="*/ 226695 w 771573"/>
                <a:gd name="connsiteY21" fmla="*/ 112501 h 285887"/>
                <a:gd name="connsiteX22" fmla="*/ 238125 w 771573"/>
                <a:gd name="connsiteY22" fmla="*/ 108691 h 285887"/>
                <a:gd name="connsiteX23" fmla="*/ 251460 w 771573"/>
                <a:gd name="connsiteY23" fmla="*/ 101071 h 285887"/>
                <a:gd name="connsiteX24" fmla="*/ 259080 w 771573"/>
                <a:gd name="connsiteY24" fmla="*/ 99166 h 285887"/>
                <a:gd name="connsiteX25" fmla="*/ 276225 w 771573"/>
                <a:gd name="connsiteY25" fmla="*/ 93451 h 285887"/>
                <a:gd name="connsiteX26" fmla="*/ 283845 w 771573"/>
                <a:gd name="connsiteY26" fmla="*/ 91546 h 285887"/>
                <a:gd name="connsiteX27" fmla="*/ 319563 w 771573"/>
                <a:gd name="connsiteY27" fmla="*/ 82846 h 285887"/>
                <a:gd name="connsiteX28" fmla="*/ 372425 w 771573"/>
                <a:gd name="connsiteY28" fmla="*/ 78470 h 285887"/>
                <a:gd name="connsiteX29" fmla="*/ 456259 w 771573"/>
                <a:gd name="connsiteY29" fmla="*/ 78263 h 285887"/>
                <a:gd name="connsiteX30" fmla="*/ 521970 w 771573"/>
                <a:gd name="connsiteY30" fmla="*/ 85831 h 285887"/>
                <a:gd name="connsiteX31" fmla="*/ 537210 w 771573"/>
                <a:gd name="connsiteY31" fmla="*/ 89641 h 285887"/>
                <a:gd name="connsiteX32" fmla="*/ 542925 w 771573"/>
                <a:gd name="connsiteY32" fmla="*/ 93451 h 285887"/>
                <a:gd name="connsiteX33" fmla="*/ 550545 w 771573"/>
                <a:gd name="connsiteY33" fmla="*/ 97261 h 285887"/>
                <a:gd name="connsiteX34" fmla="*/ 565785 w 771573"/>
                <a:gd name="connsiteY34" fmla="*/ 104881 h 285887"/>
                <a:gd name="connsiteX35" fmla="*/ 575310 w 771573"/>
                <a:gd name="connsiteY35" fmla="*/ 114406 h 285887"/>
                <a:gd name="connsiteX36" fmla="*/ 581025 w 771573"/>
                <a:gd name="connsiteY36" fmla="*/ 118216 h 285887"/>
                <a:gd name="connsiteX37" fmla="*/ 600075 w 771573"/>
                <a:gd name="connsiteY37" fmla="*/ 133456 h 285887"/>
                <a:gd name="connsiteX38" fmla="*/ 607695 w 771573"/>
                <a:gd name="connsiteY38" fmla="*/ 142981 h 285887"/>
                <a:gd name="connsiteX39" fmla="*/ 621030 w 771573"/>
                <a:gd name="connsiteY39" fmla="*/ 156316 h 285887"/>
                <a:gd name="connsiteX40" fmla="*/ 628650 w 771573"/>
                <a:gd name="connsiteY40" fmla="*/ 167746 h 285887"/>
                <a:gd name="connsiteX41" fmla="*/ 638175 w 771573"/>
                <a:gd name="connsiteY41" fmla="*/ 182986 h 285887"/>
                <a:gd name="connsiteX42" fmla="*/ 647700 w 771573"/>
                <a:gd name="connsiteY42" fmla="*/ 200131 h 285887"/>
                <a:gd name="connsiteX43" fmla="*/ 657225 w 771573"/>
                <a:gd name="connsiteY43" fmla="*/ 211561 h 285887"/>
                <a:gd name="connsiteX44" fmla="*/ 668655 w 771573"/>
                <a:gd name="connsiteY44" fmla="*/ 219181 h 285887"/>
                <a:gd name="connsiteX45" fmla="*/ 672465 w 771573"/>
                <a:gd name="connsiteY45" fmla="*/ 224896 h 285887"/>
                <a:gd name="connsiteX46" fmla="*/ 678180 w 771573"/>
                <a:gd name="connsiteY46" fmla="*/ 226801 h 285887"/>
                <a:gd name="connsiteX47" fmla="*/ 681990 w 771573"/>
                <a:gd name="connsiteY47" fmla="*/ 234421 h 285887"/>
                <a:gd name="connsiteX48" fmla="*/ 697230 w 771573"/>
                <a:gd name="connsiteY48" fmla="*/ 251566 h 285887"/>
                <a:gd name="connsiteX49" fmla="*/ 701040 w 771573"/>
                <a:gd name="connsiteY49" fmla="*/ 266806 h 285887"/>
                <a:gd name="connsiteX50" fmla="*/ 710565 w 771573"/>
                <a:gd name="connsiteY50" fmla="*/ 276331 h 285887"/>
                <a:gd name="connsiteX51" fmla="*/ 723900 w 771573"/>
                <a:gd name="connsiteY51" fmla="*/ 274426 h 285887"/>
                <a:gd name="connsiteX52" fmla="*/ 727710 w 771573"/>
                <a:gd name="connsiteY52" fmla="*/ 268711 h 285887"/>
                <a:gd name="connsiteX53" fmla="*/ 741045 w 771573"/>
                <a:gd name="connsiteY53" fmla="*/ 255376 h 285887"/>
                <a:gd name="connsiteX54" fmla="*/ 746760 w 771573"/>
                <a:gd name="connsiteY54" fmla="*/ 249661 h 285887"/>
                <a:gd name="connsiteX55" fmla="*/ 754380 w 771573"/>
                <a:gd name="connsiteY55" fmla="*/ 243946 h 285887"/>
                <a:gd name="connsiteX56" fmla="*/ 762000 w 771573"/>
                <a:gd name="connsiteY56" fmla="*/ 240136 h 285887"/>
                <a:gd name="connsiteX57" fmla="*/ 767715 w 771573"/>
                <a:gd name="connsiteY57" fmla="*/ 236326 h 285887"/>
                <a:gd name="connsiteX58" fmla="*/ 771525 w 771573"/>
                <a:gd name="connsiteY58" fmla="*/ 230611 h 285887"/>
                <a:gd name="connsiteX59" fmla="*/ 765810 w 771573"/>
                <a:gd name="connsiteY59" fmla="*/ 200131 h 285887"/>
                <a:gd name="connsiteX60" fmla="*/ 762000 w 771573"/>
                <a:gd name="connsiteY60" fmla="*/ 194416 h 285887"/>
                <a:gd name="connsiteX61" fmla="*/ 756285 w 771573"/>
                <a:gd name="connsiteY61" fmla="*/ 181081 h 285887"/>
                <a:gd name="connsiteX62" fmla="*/ 748665 w 771573"/>
                <a:gd name="connsiteY62" fmla="*/ 165841 h 285887"/>
                <a:gd name="connsiteX63" fmla="*/ 739140 w 771573"/>
                <a:gd name="connsiteY63" fmla="*/ 152506 h 285887"/>
                <a:gd name="connsiteX64" fmla="*/ 737235 w 771573"/>
                <a:gd name="connsiteY64" fmla="*/ 146791 h 285887"/>
                <a:gd name="connsiteX65" fmla="*/ 727710 w 771573"/>
                <a:gd name="connsiteY65" fmla="*/ 135361 h 285887"/>
                <a:gd name="connsiteX66" fmla="*/ 720090 w 771573"/>
                <a:gd name="connsiteY66" fmla="*/ 129646 h 285887"/>
                <a:gd name="connsiteX67" fmla="*/ 714375 w 771573"/>
                <a:gd name="connsiteY67" fmla="*/ 127741 h 285887"/>
                <a:gd name="connsiteX68" fmla="*/ 702945 w 771573"/>
                <a:gd name="connsiteY68" fmla="*/ 118216 h 285887"/>
                <a:gd name="connsiteX69" fmla="*/ 697230 w 771573"/>
                <a:gd name="connsiteY69" fmla="*/ 112501 h 285887"/>
                <a:gd name="connsiteX70" fmla="*/ 691515 w 771573"/>
                <a:gd name="connsiteY70" fmla="*/ 108691 h 285887"/>
                <a:gd name="connsiteX71" fmla="*/ 683895 w 771573"/>
                <a:gd name="connsiteY71" fmla="*/ 102976 h 285887"/>
                <a:gd name="connsiteX72" fmla="*/ 676275 w 771573"/>
                <a:gd name="connsiteY72" fmla="*/ 99166 h 285887"/>
                <a:gd name="connsiteX73" fmla="*/ 664845 w 771573"/>
                <a:gd name="connsiteY73" fmla="*/ 95356 h 285887"/>
                <a:gd name="connsiteX74" fmla="*/ 655320 w 771573"/>
                <a:gd name="connsiteY74" fmla="*/ 89641 h 285887"/>
                <a:gd name="connsiteX75" fmla="*/ 640080 w 771573"/>
                <a:gd name="connsiteY75" fmla="*/ 83926 h 285887"/>
                <a:gd name="connsiteX76" fmla="*/ 626745 w 771573"/>
                <a:gd name="connsiteY76" fmla="*/ 74401 h 285887"/>
                <a:gd name="connsiteX77" fmla="*/ 621030 w 771573"/>
                <a:gd name="connsiteY77" fmla="*/ 72496 h 285887"/>
                <a:gd name="connsiteX78" fmla="*/ 609600 w 771573"/>
                <a:gd name="connsiteY78" fmla="*/ 64876 h 285887"/>
                <a:gd name="connsiteX79" fmla="*/ 598170 w 771573"/>
                <a:gd name="connsiteY79" fmla="*/ 59161 h 285887"/>
                <a:gd name="connsiteX80" fmla="*/ 592455 w 771573"/>
                <a:gd name="connsiteY80" fmla="*/ 55351 h 285887"/>
                <a:gd name="connsiteX81" fmla="*/ 584835 w 771573"/>
                <a:gd name="connsiteY81" fmla="*/ 49636 h 285887"/>
                <a:gd name="connsiteX82" fmla="*/ 573405 w 771573"/>
                <a:gd name="connsiteY82" fmla="*/ 45826 h 285887"/>
                <a:gd name="connsiteX83" fmla="*/ 567690 w 771573"/>
                <a:gd name="connsiteY83" fmla="*/ 42016 h 285887"/>
                <a:gd name="connsiteX84" fmla="*/ 556260 w 771573"/>
                <a:gd name="connsiteY84" fmla="*/ 38206 h 285887"/>
                <a:gd name="connsiteX85" fmla="*/ 548640 w 771573"/>
                <a:gd name="connsiteY85" fmla="*/ 34396 h 285887"/>
                <a:gd name="connsiteX86" fmla="*/ 537210 w 771573"/>
                <a:gd name="connsiteY86" fmla="*/ 26776 h 285887"/>
                <a:gd name="connsiteX87" fmla="*/ 493395 w 771573"/>
                <a:gd name="connsiteY87" fmla="*/ 17251 h 285887"/>
                <a:gd name="connsiteX88" fmla="*/ 485775 w 771573"/>
                <a:gd name="connsiteY88" fmla="*/ 15346 h 285887"/>
                <a:gd name="connsiteX89" fmla="*/ 472440 w 771573"/>
                <a:gd name="connsiteY89" fmla="*/ 11536 h 285887"/>
                <a:gd name="connsiteX90" fmla="*/ 409575 w 771573"/>
                <a:gd name="connsiteY90" fmla="*/ 3916 h 285887"/>
                <a:gd name="connsiteX91" fmla="*/ 360045 w 771573"/>
                <a:gd name="connsiteY91" fmla="*/ 106 h 285887"/>
                <a:gd name="connsiteX92" fmla="*/ 300990 w 771573"/>
                <a:gd name="connsiteY92" fmla="*/ 2011 h 285887"/>
                <a:gd name="connsiteX93" fmla="*/ 268605 w 771573"/>
                <a:gd name="connsiteY93" fmla="*/ 9631 h 285887"/>
                <a:gd name="connsiteX94" fmla="*/ 226695 w 771573"/>
                <a:gd name="connsiteY94" fmla="*/ 26776 h 285887"/>
                <a:gd name="connsiteX95" fmla="*/ 182880 w 771573"/>
                <a:gd name="connsiteY95" fmla="*/ 53446 h 285887"/>
                <a:gd name="connsiteX96" fmla="*/ 123825 w 771573"/>
                <a:gd name="connsiteY96" fmla="*/ 95356 h 285887"/>
                <a:gd name="connsiteX97" fmla="*/ 87630 w 771573"/>
                <a:gd name="connsiteY97" fmla="*/ 125836 h 285887"/>
                <a:gd name="connsiteX98" fmla="*/ 55245 w 771573"/>
                <a:gd name="connsiteY98" fmla="*/ 158221 h 285887"/>
                <a:gd name="connsiteX99" fmla="*/ 20955 w 771573"/>
                <a:gd name="connsiteY99" fmla="*/ 203941 h 285887"/>
                <a:gd name="connsiteX100" fmla="*/ 0 w 771573"/>
                <a:gd name="connsiteY100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65735 w 771573"/>
                <a:gd name="connsiteY15" fmla="*/ 162031 h 285887"/>
                <a:gd name="connsiteX16" fmla="*/ 171450 w 771573"/>
                <a:gd name="connsiteY16" fmla="*/ 158221 h 285887"/>
                <a:gd name="connsiteX17" fmla="*/ 175260 w 771573"/>
                <a:gd name="connsiteY17" fmla="*/ 152506 h 285887"/>
                <a:gd name="connsiteX18" fmla="*/ 180975 w 771573"/>
                <a:gd name="connsiteY18" fmla="*/ 150601 h 285887"/>
                <a:gd name="connsiteX19" fmla="*/ 200025 w 771573"/>
                <a:gd name="connsiteY19" fmla="*/ 131551 h 285887"/>
                <a:gd name="connsiteX20" fmla="*/ 226695 w 771573"/>
                <a:gd name="connsiteY20" fmla="*/ 112501 h 285887"/>
                <a:gd name="connsiteX21" fmla="*/ 238125 w 771573"/>
                <a:gd name="connsiteY21" fmla="*/ 108691 h 285887"/>
                <a:gd name="connsiteX22" fmla="*/ 251460 w 771573"/>
                <a:gd name="connsiteY22" fmla="*/ 101071 h 285887"/>
                <a:gd name="connsiteX23" fmla="*/ 259080 w 771573"/>
                <a:gd name="connsiteY23" fmla="*/ 99166 h 285887"/>
                <a:gd name="connsiteX24" fmla="*/ 276225 w 771573"/>
                <a:gd name="connsiteY24" fmla="*/ 93451 h 285887"/>
                <a:gd name="connsiteX25" fmla="*/ 283845 w 771573"/>
                <a:gd name="connsiteY25" fmla="*/ 91546 h 285887"/>
                <a:gd name="connsiteX26" fmla="*/ 319563 w 771573"/>
                <a:gd name="connsiteY26" fmla="*/ 82846 h 285887"/>
                <a:gd name="connsiteX27" fmla="*/ 372425 w 771573"/>
                <a:gd name="connsiteY27" fmla="*/ 78470 h 285887"/>
                <a:gd name="connsiteX28" fmla="*/ 456259 w 771573"/>
                <a:gd name="connsiteY28" fmla="*/ 78263 h 285887"/>
                <a:gd name="connsiteX29" fmla="*/ 521970 w 771573"/>
                <a:gd name="connsiteY29" fmla="*/ 85831 h 285887"/>
                <a:gd name="connsiteX30" fmla="*/ 537210 w 771573"/>
                <a:gd name="connsiteY30" fmla="*/ 89641 h 285887"/>
                <a:gd name="connsiteX31" fmla="*/ 542925 w 771573"/>
                <a:gd name="connsiteY31" fmla="*/ 93451 h 285887"/>
                <a:gd name="connsiteX32" fmla="*/ 550545 w 771573"/>
                <a:gd name="connsiteY32" fmla="*/ 97261 h 285887"/>
                <a:gd name="connsiteX33" fmla="*/ 565785 w 771573"/>
                <a:gd name="connsiteY33" fmla="*/ 104881 h 285887"/>
                <a:gd name="connsiteX34" fmla="*/ 575310 w 771573"/>
                <a:gd name="connsiteY34" fmla="*/ 114406 h 285887"/>
                <a:gd name="connsiteX35" fmla="*/ 581025 w 771573"/>
                <a:gd name="connsiteY35" fmla="*/ 118216 h 285887"/>
                <a:gd name="connsiteX36" fmla="*/ 600075 w 771573"/>
                <a:gd name="connsiteY36" fmla="*/ 133456 h 285887"/>
                <a:gd name="connsiteX37" fmla="*/ 607695 w 771573"/>
                <a:gd name="connsiteY37" fmla="*/ 142981 h 285887"/>
                <a:gd name="connsiteX38" fmla="*/ 621030 w 771573"/>
                <a:gd name="connsiteY38" fmla="*/ 156316 h 285887"/>
                <a:gd name="connsiteX39" fmla="*/ 628650 w 771573"/>
                <a:gd name="connsiteY39" fmla="*/ 167746 h 285887"/>
                <a:gd name="connsiteX40" fmla="*/ 638175 w 771573"/>
                <a:gd name="connsiteY40" fmla="*/ 182986 h 285887"/>
                <a:gd name="connsiteX41" fmla="*/ 647700 w 771573"/>
                <a:gd name="connsiteY41" fmla="*/ 200131 h 285887"/>
                <a:gd name="connsiteX42" fmla="*/ 657225 w 771573"/>
                <a:gd name="connsiteY42" fmla="*/ 211561 h 285887"/>
                <a:gd name="connsiteX43" fmla="*/ 668655 w 771573"/>
                <a:gd name="connsiteY43" fmla="*/ 219181 h 285887"/>
                <a:gd name="connsiteX44" fmla="*/ 672465 w 771573"/>
                <a:gd name="connsiteY44" fmla="*/ 224896 h 285887"/>
                <a:gd name="connsiteX45" fmla="*/ 678180 w 771573"/>
                <a:gd name="connsiteY45" fmla="*/ 226801 h 285887"/>
                <a:gd name="connsiteX46" fmla="*/ 681990 w 771573"/>
                <a:gd name="connsiteY46" fmla="*/ 234421 h 285887"/>
                <a:gd name="connsiteX47" fmla="*/ 697230 w 771573"/>
                <a:gd name="connsiteY47" fmla="*/ 251566 h 285887"/>
                <a:gd name="connsiteX48" fmla="*/ 701040 w 771573"/>
                <a:gd name="connsiteY48" fmla="*/ 266806 h 285887"/>
                <a:gd name="connsiteX49" fmla="*/ 710565 w 771573"/>
                <a:gd name="connsiteY49" fmla="*/ 276331 h 285887"/>
                <a:gd name="connsiteX50" fmla="*/ 723900 w 771573"/>
                <a:gd name="connsiteY50" fmla="*/ 274426 h 285887"/>
                <a:gd name="connsiteX51" fmla="*/ 727710 w 771573"/>
                <a:gd name="connsiteY51" fmla="*/ 268711 h 285887"/>
                <a:gd name="connsiteX52" fmla="*/ 741045 w 771573"/>
                <a:gd name="connsiteY52" fmla="*/ 255376 h 285887"/>
                <a:gd name="connsiteX53" fmla="*/ 746760 w 771573"/>
                <a:gd name="connsiteY53" fmla="*/ 249661 h 285887"/>
                <a:gd name="connsiteX54" fmla="*/ 754380 w 771573"/>
                <a:gd name="connsiteY54" fmla="*/ 243946 h 285887"/>
                <a:gd name="connsiteX55" fmla="*/ 762000 w 771573"/>
                <a:gd name="connsiteY55" fmla="*/ 240136 h 285887"/>
                <a:gd name="connsiteX56" fmla="*/ 767715 w 771573"/>
                <a:gd name="connsiteY56" fmla="*/ 236326 h 285887"/>
                <a:gd name="connsiteX57" fmla="*/ 771525 w 771573"/>
                <a:gd name="connsiteY57" fmla="*/ 230611 h 285887"/>
                <a:gd name="connsiteX58" fmla="*/ 765810 w 771573"/>
                <a:gd name="connsiteY58" fmla="*/ 200131 h 285887"/>
                <a:gd name="connsiteX59" fmla="*/ 762000 w 771573"/>
                <a:gd name="connsiteY59" fmla="*/ 194416 h 285887"/>
                <a:gd name="connsiteX60" fmla="*/ 756285 w 771573"/>
                <a:gd name="connsiteY60" fmla="*/ 181081 h 285887"/>
                <a:gd name="connsiteX61" fmla="*/ 748665 w 771573"/>
                <a:gd name="connsiteY61" fmla="*/ 165841 h 285887"/>
                <a:gd name="connsiteX62" fmla="*/ 739140 w 771573"/>
                <a:gd name="connsiteY62" fmla="*/ 152506 h 285887"/>
                <a:gd name="connsiteX63" fmla="*/ 737235 w 771573"/>
                <a:gd name="connsiteY63" fmla="*/ 146791 h 285887"/>
                <a:gd name="connsiteX64" fmla="*/ 727710 w 771573"/>
                <a:gd name="connsiteY64" fmla="*/ 135361 h 285887"/>
                <a:gd name="connsiteX65" fmla="*/ 720090 w 771573"/>
                <a:gd name="connsiteY65" fmla="*/ 129646 h 285887"/>
                <a:gd name="connsiteX66" fmla="*/ 714375 w 771573"/>
                <a:gd name="connsiteY66" fmla="*/ 127741 h 285887"/>
                <a:gd name="connsiteX67" fmla="*/ 702945 w 771573"/>
                <a:gd name="connsiteY67" fmla="*/ 118216 h 285887"/>
                <a:gd name="connsiteX68" fmla="*/ 697230 w 771573"/>
                <a:gd name="connsiteY68" fmla="*/ 112501 h 285887"/>
                <a:gd name="connsiteX69" fmla="*/ 691515 w 771573"/>
                <a:gd name="connsiteY69" fmla="*/ 108691 h 285887"/>
                <a:gd name="connsiteX70" fmla="*/ 683895 w 771573"/>
                <a:gd name="connsiteY70" fmla="*/ 102976 h 285887"/>
                <a:gd name="connsiteX71" fmla="*/ 676275 w 771573"/>
                <a:gd name="connsiteY71" fmla="*/ 99166 h 285887"/>
                <a:gd name="connsiteX72" fmla="*/ 664845 w 771573"/>
                <a:gd name="connsiteY72" fmla="*/ 95356 h 285887"/>
                <a:gd name="connsiteX73" fmla="*/ 655320 w 771573"/>
                <a:gd name="connsiteY73" fmla="*/ 89641 h 285887"/>
                <a:gd name="connsiteX74" fmla="*/ 640080 w 771573"/>
                <a:gd name="connsiteY74" fmla="*/ 83926 h 285887"/>
                <a:gd name="connsiteX75" fmla="*/ 626745 w 771573"/>
                <a:gd name="connsiteY75" fmla="*/ 74401 h 285887"/>
                <a:gd name="connsiteX76" fmla="*/ 621030 w 771573"/>
                <a:gd name="connsiteY76" fmla="*/ 72496 h 285887"/>
                <a:gd name="connsiteX77" fmla="*/ 609600 w 771573"/>
                <a:gd name="connsiteY77" fmla="*/ 64876 h 285887"/>
                <a:gd name="connsiteX78" fmla="*/ 598170 w 771573"/>
                <a:gd name="connsiteY78" fmla="*/ 59161 h 285887"/>
                <a:gd name="connsiteX79" fmla="*/ 592455 w 771573"/>
                <a:gd name="connsiteY79" fmla="*/ 55351 h 285887"/>
                <a:gd name="connsiteX80" fmla="*/ 584835 w 771573"/>
                <a:gd name="connsiteY80" fmla="*/ 49636 h 285887"/>
                <a:gd name="connsiteX81" fmla="*/ 573405 w 771573"/>
                <a:gd name="connsiteY81" fmla="*/ 45826 h 285887"/>
                <a:gd name="connsiteX82" fmla="*/ 567690 w 771573"/>
                <a:gd name="connsiteY82" fmla="*/ 42016 h 285887"/>
                <a:gd name="connsiteX83" fmla="*/ 556260 w 771573"/>
                <a:gd name="connsiteY83" fmla="*/ 38206 h 285887"/>
                <a:gd name="connsiteX84" fmla="*/ 548640 w 771573"/>
                <a:gd name="connsiteY84" fmla="*/ 34396 h 285887"/>
                <a:gd name="connsiteX85" fmla="*/ 537210 w 771573"/>
                <a:gd name="connsiteY85" fmla="*/ 26776 h 285887"/>
                <a:gd name="connsiteX86" fmla="*/ 493395 w 771573"/>
                <a:gd name="connsiteY86" fmla="*/ 17251 h 285887"/>
                <a:gd name="connsiteX87" fmla="*/ 485775 w 771573"/>
                <a:gd name="connsiteY87" fmla="*/ 15346 h 285887"/>
                <a:gd name="connsiteX88" fmla="*/ 472440 w 771573"/>
                <a:gd name="connsiteY88" fmla="*/ 11536 h 285887"/>
                <a:gd name="connsiteX89" fmla="*/ 409575 w 771573"/>
                <a:gd name="connsiteY89" fmla="*/ 3916 h 285887"/>
                <a:gd name="connsiteX90" fmla="*/ 360045 w 771573"/>
                <a:gd name="connsiteY90" fmla="*/ 106 h 285887"/>
                <a:gd name="connsiteX91" fmla="*/ 300990 w 771573"/>
                <a:gd name="connsiteY91" fmla="*/ 2011 h 285887"/>
                <a:gd name="connsiteX92" fmla="*/ 268605 w 771573"/>
                <a:gd name="connsiteY92" fmla="*/ 9631 h 285887"/>
                <a:gd name="connsiteX93" fmla="*/ 226695 w 771573"/>
                <a:gd name="connsiteY93" fmla="*/ 26776 h 285887"/>
                <a:gd name="connsiteX94" fmla="*/ 182880 w 771573"/>
                <a:gd name="connsiteY94" fmla="*/ 53446 h 285887"/>
                <a:gd name="connsiteX95" fmla="*/ 123825 w 771573"/>
                <a:gd name="connsiteY95" fmla="*/ 95356 h 285887"/>
                <a:gd name="connsiteX96" fmla="*/ 87630 w 771573"/>
                <a:gd name="connsiteY96" fmla="*/ 125836 h 285887"/>
                <a:gd name="connsiteX97" fmla="*/ 55245 w 771573"/>
                <a:gd name="connsiteY97" fmla="*/ 158221 h 285887"/>
                <a:gd name="connsiteX98" fmla="*/ 20955 w 771573"/>
                <a:gd name="connsiteY98" fmla="*/ 203941 h 285887"/>
                <a:gd name="connsiteX99" fmla="*/ 0 w 771573"/>
                <a:gd name="connsiteY99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65735 w 771573"/>
                <a:gd name="connsiteY15" fmla="*/ 162031 h 285887"/>
                <a:gd name="connsiteX16" fmla="*/ 171450 w 771573"/>
                <a:gd name="connsiteY16" fmla="*/ 158221 h 285887"/>
                <a:gd name="connsiteX17" fmla="*/ 180975 w 771573"/>
                <a:gd name="connsiteY17" fmla="*/ 150601 h 285887"/>
                <a:gd name="connsiteX18" fmla="*/ 200025 w 771573"/>
                <a:gd name="connsiteY18" fmla="*/ 131551 h 285887"/>
                <a:gd name="connsiteX19" fmla="*/ 226695 w 771573"/>
                <a:gd name="connsiteY19" fmla="*/ 112501 h 285887"/>
                <a:gd name="connsiteX20" fmla="*/ 238125 w 771573"/>
                <a:gd name="connsiteY20" fmla="*/ 108691 h 285887"/>
                <a:gd name="connsiteX21" fmla="*/ 251460 w 771573"/>
                <a:gd name="connsiteY21" fmla="*/ 101071 h 285887"/>
                <a:gd name="connsiteX22" fmla="*/ 259080 w 771573"/>
                <a:gd name="connsiteY22" fmla="*/ 99166 h 285887"/>
                <a:gd name="connsiteX23" fmla="*/ 276225 w 771573"/>
                <a:gd name="connsiteY23" fmla="*/ 93451 h 285887"/>
                <a:gd name="connsiteX24" fmla="*/ 283845 w 771573"/>
                <a:gd name="connsiteY24" fmla="*/ 91546 h 285887"/>
                <a:gd name="connsiteX25" fmla="*/ 319563 w 771573"/>
                <a:gd name="connsiteY25" fmla="*/ 82846 h 285887"/>
                <a:gd name="connsiteX26" fmla="*/ 372425 w 771573"/>
                <a:gd name="connsiteY26" fmla="*/ 78470 h 285887"/>
                <a:gd name="connsiteX27" fmla="*/ 456259 w 771573"/>
                <a:gd name="connsiteY27" fmla="*/ 78263 h 285887"/>
                <a:gd name="connsiteX28" fmla="*/ 521970 w 771573"/>
                <a:gd name="connsiteY28" fmla="*/ 85831 h 285887"/>
                <a:gd name="connsiteX29" fmla="*/ 537210 w 771573"/>
                <a:gd name="connsiteY29" fmla="*/ 89641 h 285887"/>
                <a:gd name="connsiteX30" fmla="*/ 542925 w 771573"/>
                <a:gd name="connsiteY30" fmla="*/ 93451 h 285887"/>
                <a:gd name="connsiteX31" fmla="*/ 550545 w 771573"/>
                <a:gd name="connsiteY31" fmla="*/ 97261 h 285887"/>
                <a:gd name="connsiteX32" fmla="*/ 565785 w 771573"/>
                <a:gd name="connsiteY32" fmla="*/ 104881 h 285887"/>
                <a:gd name="connsiteX33" fmla="*/ 575310 w 771573"/>
                <a:gd name="connsiteY33" fmla="*/ 114406 h 285887"/>
                <a:gd name="connsiteX34" fmla="*/ 581025 w 771573"/>
                <a:gd name="connsiteY34" fmla="*/ 118216 h 285887"/>
                <a:gd name="connsiteX35" fmla="*/ 600075 w 771573"/>
                <a:gd name="connsiteY35" fmla="*/ 133456 h 285887"/>
                <a:gd name="connsiteX36" fmla="*/ 607695 w 771573"/>
                <a:gd name="connsiteY36" fmla="*/ 142981 h 285887"/>
                <a:gd name="connsiteX37" fmla="*/ 621030 w 771573"/>
                <a:gd name="connsiteY37" fmla="*/ 156316 h 285887"/>
                <a:gd name="connsiteX38" fmla="*/ 628650 w 771573"/>
                <a:gd name="connsiteY38" fmla="*/ 167746 h 285887"/>
                <a:gd name="connsiteX39" fmla="*/ 638175 w 771573"/>
                <a:gd name="connsiteY39" fmla="*/ 182986 h 285887"/>
                <a:gd name="connsiteX40" fmla="*/ 647700 w 771573"/>
                <a:gd name="connsiteY40" fmla="*/ 200131 h 285887"/>
                <a:gd name="connsiteX41" fmla="*/ 657225 w 771573"/>
                <a:gd name="connsiteY41" fmla="*/ 211561 h 285887"/>
                <a:gd name="connsiteX42" fmla="*/ 668655 w 771573"/>
                <a:gd name="connsiteY42" fmla="*/ 219181 h 285887"/>
                <a:gd name="connsiteX43" fmla="*/ 672465 w 771573"/>
                <a:gd name="connsiteY43" fmla="*/ 224896 h 285887"/>
                <a:gd name="connsiteX44" fmla="*/ 678180 w 771573"/>
                <a:gd name="connsiteY44" fmla="*/ 226801 h 285887"/>
                <a:gd name="connsiteX45" fmla="*/ 681990 w 771573"/>
                <a:gd name="connsiteY45" fmla="*/ 234421 h 285887"/>
                <a:gd name="connsiteX46" fmla="*/ 697230 w 771573"/>
                <a:gd name="connsiteY46" fmla="*/ 251566 h 285887"/>
                <a:gd name="connsiteX47" fmla="*/ 701040 w 771573"/>
                <a:gd name="connsiteY47" fmla="*/ 266806 h 285887"/>
                <a:gd name="connsiteX48" fmla="*/ 710565 w 771573"/>
                <a:gd name="connsiteY48" fmla="*/ 276331 h 285887"/>
                <a:gd name="connsiteX49" fmla="*/ 723900 w 771573"/>
                <a:gd name="connsiteY49" fmla="*/ 274426 h 285887"/>
                <a:gd name="connsiteX50" fmla="*/ 727710 w 771573"/>
                <a:gd name="connsiteY50" fmla="*/ 268711 h 285887"/>
                <a:gd name="connsiteX51" fmla="*/ 741045 w 771573"/>
                <a:gd name="connsiteY51" fmla="*/ 255376 h 285887"/>
                <a:gd name="connsiteX52" fmla="*/ 746760 w 771573"/>
                <a:gd name="connsiteY52" fmla="*/ 249661 h 285887"/>
                <a:gd name="connsiteX53" fmla="*/ 754380 w 771573"/>
                <a:gd name="connsiteY53" fmla="*/ 243946 h 285887"/>
                <a:gd name="connsiteX54" fmla="*/ 762000 w 771573"/>
                <a:gd name="connsiteY54" fmla="*/ 240136 h 285887"/>
                <a:gd name="connsiteX55" fmla="*/ 767715 w 771573"/>
                <a:gd name="connsiteY55" fmla="*/ 236326 h 285887"/>
                <a:gd name="connsiteX56" fmla="*/ 771525 w 771573"/>
                <a:gd name="connsiteY56" fmla="*/ 230611 h 285887"/>
                <a:gd name="connsiteX57" fmla="*/ 765810 w 771573"/>
                <a:gd name="connsiteY57" fmla="*/ 200131 h 285887"/>
                <a:gd name="connsiteX58" fmla="*/ 762000 w 771573"/>
                <a:gd name="connsiteY58" fmla="*/ 194416 h 285887"/>
                <a:gd name="connsiteX59" fmla="*/ 756285 w 771573"/>
                <a:gd name="connsiteY59" fmla="*/ 181081 h 285887"/>
                <a:gd name="connsiteX60" fmla="*/ 748665 w 771573"/>
                <a:gd name="connsiteY60" fmla="*/ 165841 h 285887"/>
                <a:gd name="connsiteX61" fmla="*/ 739140 w 771573"/>
                <a:gd name="connsiteY61" fmla="*/ 152506 h 285887"/>
                <a:gd name="connsiteX62" fmla="*/ 737235 w 771573"/>
                <a:gd name="connsiteY62" fmla="*/ 146791 h 285887"/>
                <a:gd name="connsiteX63" fmla="*/ 727710 w 771573"/>
                <a:gd name="connsiteY63" fmla="*/ 135361 h 285887"/>
                <a:gd name="connsiteX64" fmla="*/ 720090 w 771573"/>
                <a:gd name="connsiteY64" fmla="*/ 129646 h 285887"/>
                <a:gd name="connsiteX65" fmla="*/ 714375 w 771573"/>
                <a:gd name="connsiteY65" fmla="*/ 127741 h 285887"/>
                <a:gd name="connsiteX66" fmla="*/ 702945 w 771573"/>
                <a:gd name="connsiteY66" fmla="*/ 118216 h 285887"/>
                <a:gd name="connsiteX67" fmla="*/ 697230 w 771573"/>
                <a:gd name="connsiteY67" fmla="*/ 112501 h 285887"/>
                <a:gd name="connsiteX68" fmla="*/ 691515 w 771573"/>
                <a:gd name="connsiteY68" fmla="*/ 108691 h 285887"/>
                <a:gd name="connsiteX69" fmla="*/ 683895 w 771573"/>
                <a:gd name="connsiteY69" fmla="*/ 102976 h 285887"/>
                <a:gd name="connsiteX70" fmla="*/ 676275 w 771573"/>
                <a:gd name="connsiteY70" fmla="*/ 99166 h 285887"/>
                <a:gd name="connsiteX71" fmla="*/ 664845 w 771573"/>
                <a:gd name="connsiteY71" fmla="*/ 95356 h 285887"/>
                <a:gd name="connsiteX72" fmla="*/ 655320 w 771573"/>
                <a:gd name="connsiteY72" fmla="*/ 89641 h 285887"/>
                <a:gd name="connsiteX73" fmla="*/ 640080 w 771573"/>
                <a:gd name="connsiteY73" fmla="*/ 83926 h 285887"/>
                <a:gd name="connsiteX74" fmla="*/ 626745 w 771573"/>
                <a:gd name="connsiteY74" fmla="*/ 74401 h 285887"/>
                <a:gd name="connsiteX75" fmla="*/ 621030 w 771573"/>
                <a:gd name="connsiteY75" fmla="*/ 72496 h 285887"/>
                <a:gd name="connsiteX76" fmla="*/ 609600 w 771573"/>
                <a:gd name="connsiteY76" fmla="*/ 64876 h 285887"/>
                <a:gd name="connsiteX77" fmla="*/ 598170 w 771573"/>
                <a:gd name="connsiteY77" fmla="*/ 59161 h 285887"/>
                <a:gd name="connsiteX78" fmla="*/ 592455 w 771573"/>
                <a:gd name="connsiteY78" fmla="*/ 55351 h 285887"/>
                <a:gd name="connsiteX79" fmla="*/ 584835 w 771573"/>
                <a:gd name="connsiteY79" fmla="*/ 49636 h 285887"/>
                <a:gd name="connsiteX80" fmla="*/ 573405 w 771573"/>
                <a:gd name="connsiteY80" fmla="*/ 45826 h 285887"/>
                <a:gd name="connsiteX81" fmla="*/ 567690 w 771573"/>
                <a:gd name="connsiteY81" fmla="*/ 42016 h 285887"/>
                <a:gd name="connsiteX82" fmla="*/ 556260 w 771573"/>
                <a:gd name="connsiteY82" fmla="*/ 38206 h 285887"/>
                <a:gd name="connsiteX83" fmla="*/ 548640 w 771573"/>
                <a:gd name="connsiteY83" fmla="*/ 34396 h 285887"/>
                <a:gd name="connsiteX84" fmla="*/ 537210 w 771573"/>
                <a:gd name="connsiteY84" fmla="*/ 26776 h 285887"/>
                <a:gd name="connsiteX85" fmla="*/ 493395 w 771573"/>
                <a:gd name="connsiteY85" fmla="*/ 17251 h 285887"/>
                <a:gd name="connsiteX86" fmla="*/ 485775 w 771573"/>
                <a:gd name="connsiteY86" fmla="*/ 15346 h 285887"/>
                <a:gd name="connsiteX87" fmla="*/ 472440 w 771573"/>
                <a:gd name="connsiteY87" fmla="*/ 11536 h 285887"/>
                <a:gd name="connsiteX88" fmla="*/ 409575 w 771573"/>
                <a:gd name="connsiteY88" fmla="*/ 3916 h 285887"/>
                <a:gd name="connsiteX89" fmla="*/ 360045 w 771573"/>
                <a:gd name="connsiteY89" fmla="*/ 106 h 285887"/>
                <a:gd name="connsiteX90" fmla="*/ 300990 w 771573"/>
                <a:gd name="connsiteY90" fmla="*/ 2011 h 285887"/>
                <a:gd name="connsiteX91" fmla="*/ 268605 w 771573"/>
                <a:gd name="connsiteY91" fmla="*/ 9631 h 285887"/>
                <a:gd name="connsiteX92" fmla="*/ 226695 w 771573"/>
                <a:gd name="connsiteY92" fmla="*/ 26776 h 285887"/>
                <a:gd name="connsiteX93" fmla="*/ 182880 w 771573"/>
                <a:gd name="connsiteY93" fmla="*/ 53446 h 285887"/>
                <a:gd name="connsiteX94" fmla="*/ 123825 w 771573"/>
                <a:gd name="connsiteY94" fmla="*/ 95356 h 285887"/>
                <a:gd name="connsiteX95" fmla="*/ 87630 w 771573"/>
                <a:gd name="connsiteY95" fmla="*/ 125836 h 285887"/>
                <a:gd name="connsiteX96" fmla="*/ 55245 w 771573"/>
                <a:gd name="connsiteY96" fmla="*/ 158221 h 285887"/>
                <a:gd name="connsiteX97" fmla="*/ 20955 w 771573"/>
                <a:gd name="connsiteY97" fmla="*/ 203941 h 285887"/>
                <a:gd name="connsiteX98" fmla="*/ 0 w 771573"/>
                <a:gd name="connsiteY98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65735 w 771573"/>
                <a:gd name="connsiteY15" fmla="*/ 162031 h 285887"/>
                <a:gd name="connsiteX16" fmla="*/ 180975 w 771573"/>
                <a:gd name="connsiteY16" fmla="*/ 150601 h 285887"/>
                <a:gd name="connsiteX17" fmla="*/ 200025 w 771573"/>
                <a:gd name="connsiteY17" fmla="*/ 131551 h 285887"/>
                <a:gd name="connsiteX18" fmla="*/ 226695 w 771573"/>
                <a:gd name="connsiteY18" fmla="*/ 112501 h 285887"/>
                <a:gd name="connsiteX19" fmla="*/ 238125 w 771573"/>
                <a:gd name="connsiteY19" fmla="*/ 108691 h 285887"/>
                <a:gd name="connsiteX20" fmla="*/ 251460 w 771573"/>
                <a:gd name="connsiteY20" fmla="*/ 101071 h 285887"/>
                <a:gd name="connsiteX21" fmla="*/ 259080 w 771573"/>
                <a:gd name="connsiteY21" fmla="*/ 99166 h 285887"/>
                <a:gd name="connsiteX22" fmla="*/ 276225 w 771573"/>
                <a:gd name="connsiteY22" fmla="*/ 93451 h 285887"/>
                <a:gd name="connsiteX23" fmla="*/ 283845 w 771573"/>
                <a:gd name="connsiteY23" fmla="*/ 91546 h 285887"/>
                <a:gd name="connsiteX24" fmla="*/ 319563 w 771573"/>
                <a:gd name="connsiteY24" fmla="*/ 82846 h 285887"/>
                <a:gd name="connsiteX25" fmla="*/ 372425 w 771573"/>
                <a:gd name="connsiteY25" fmla="*/ 78470 h 285887"/>
                <a:gd name="connsiteX26" fmla="*/ 456259 w 771573"/>
                <a:gd name="connsiteY26" fmla="*/ 78263 h 285887"/>
                <a:gd name="connsiteX27" fmla="*/ 521970 w 771573"/>
                <a:gd name="connsiteY27" fmla="*/ 85831 h 285887"/>
                <a:gd name="connsiteX28" fmla="*/ 537210 w 771573"/>
                <a:gd name="connsiteY28" fmla="*/ 89641 h 285887"/>
                <a:gd name="connsiteX29" fmla="*/ 542925 w 771573"/>
                <a:gd name="connsiteY29" fmla="*/ 93451 h 285887"/>
                <a:gd name="connsiteX30" fmla="*/ 550545 w 771573"/>
                <a:gd name="connsiteY30" fmla="*/ 97261 h 285887"/>
                <a:gd name="connsiteX31" fmla="*/ 565785 w 771573"/>
                <a:gd name="connsiteY31" fmla="*/ 104881 h 285887"/>
                <a:gd name="connsiteX32" fmla="*/ 575310 w 771573"/>
                <a:gd name="connsiteY32" fmla="*/ 114406 h 285887"/>
                <a:gd name="connsiteX33" fmla="*/ 581025 w 771573"/>
                <a:gd name="connsiteY33" fmla="*/ 118216 h 285887"/>
                <a:gd name="connsiteX34" fmla="*/ 600075 w 771573"/>
                <a:gd name="connsiteY34" fmla="*/ 133456 h 285887"/>
                <a:gd name="connsiteX35" fmla="*/ 607695 w 771573"/>
                <a:gd name="connsiteY35" fmla="*/ 142981 h 285887"/>
                <a:gd name="connsiteX36" fmla="*/ 621030 w 771573"/>
                <a:gd name="connsiteY36" fmla="*/ 156316 h 285887"/>
                <a:gd name="connsiteX37" fmla="*/ 628650 w 771573"/>
                <a:gd name="connsiteY37" fmla="*/ 167746 h 285887"/>
                <a:gd name="connsiteX38" fmla="*/ 638175 w 771573"/>
                <a:gd name="connsiteY38" fmla="*/ 182986 h 285887"/>
                <a:gd name="connsiteX39" fmla="*/ 647700 w 771573"/>
                <a:gd name="connsiteY39" fmla="*/ 200131 h 285887"/>
                <a:gd name="connsiteX40" fmla="*/ 657225 w 771573"/>
                <a:gd name="connsiteY40" fmla="*/ 211561 h 285887"/>
                <a:gd name="connsiteX41" fmla="*/ 668655 w 771573"/>
                <a:gd name="connsiteY41" fmla="*/ 219181 h 285887"/>
                <a:gd name="connsiteX42" fmla="*/ 672465 w 771573"/>
                <a:gd name="connsiteY42" fmla="*/ 224896 h 285887"/>
                <a:gd name="connsiteX43" fmla="*/ 678180 w 771573"/>
                <a:gd name="connsiteY43" fmla="*/ 226801 h 285887"/>
                <a:gd name="connsiteX44" fmla="*/ 681990 w 771573"/>
                <a:gd name="connsiteY44" fmla="*/ 234421 h 285887"/>
                <a:gd name="connsiteX45" fmla="*/ 697230 w 771573"/>
                <a:gd name="connsiteY45" fmla="*/ 251566 h 285887"/>
                <a:gd name="connsiteX46" fmla="*/ 701040 w 771573"/>
                <a:gd name="connsiteY46" fmla="*/ 266806 h 285887"/>
                <a:gd name="connsiteX47" fmla="*/ 710565 w 771573"/>
                <a:gd name="connsiteY47" fmla="*/ 276331 h 285887"/>
                <a:gd name="connsiteX48" fmla="*/ 723900 w 771573"/>
                <a:gd name="connsiteY48" fmla="*/ 274426 h 285887"/>
                <a:gd name="connsiteX49" fmla="*/ 727710 w 771573"/>
                <a:gd name="connsiteY49" fmla="*/ 268711 h 285887"/>
                <a:gd name="connsiteX50" fmla="*/ 741045 w 771573"/>
                <a:gd name="connsiteY50" fmla="*/ 255376 h 285887"/>
                <a:gd name="connsiteX51" fmla="*/ 746760 w 771573"/>
                <a:gd name="connsiteY51" fmla="*/ 249661 h 285887"/>
                <a:gd name="connsiteX52" fmla="*/ 754380 w 771573"/>
                <a:gd name="connsiteY52" fmla="*/ 243946 h 285887"/>
                <a:gd name="connsiteX53" fmla="*/ 762000 w 771573"/>
                <a:gd name="connsiteY53" fmla="*/ 240136 h 285887"/>
                <a:gd name="connsiteX54" fmla="*/ 767715 w 771573"/>
                <a:gd name="connsiteY54" fmla="*/ 236326 h 285887"/>
                <a:gd name="connsiteX55" fmla="*/ 771525 w 771573"/>
                <a:gd name="connsiteY55" fmla="*/ 230611 h 285887"/>
                <a:gd name="connsiteX56" fmla="*/ 765810 w 771573"/>
                <a:gd name="connsiteY56" fmla="*/ 200131 h 285887"/>
                <a:gd name="connsiteX57" fmla="*/ 762000 w 771573"/>
                <a:gd name="connsiteY57" fmla="*/ 194416 h 285887"/>
                <a:gd name="connsiteX58" fmla="*/ 756285 w 771573"/>
                <a:gd name="connsiteY58" fmla="*/ 181081 h 285887"/>
                <a:gd name="connsiteX59" fmla="*/ 748665 w 771573"/>
                <a:gd name="connsiteY59" fmla="*/ 165841 h 285887"/>
                <a:gd name="connsiteX60" fmla="*/ 739140 w 771573"/>
                <a:gd name="connsiteY60" fmla="*/ 152506 h 285887"/>
                <a:gd name="connsiteX61" fmla="*/ 737235 w 771573"/>
                <a:gd name="connsiteY61" fmla="*/ 146791 h 285887"/>
                <a:gd name="connsiteX62" fmla="*/ 727710 w 771573"/>
                <a:gd name="connsiteY62" fmla="*/ 135361 h 285887"/>
                <a:gd name="connsiteX63" fmla="*/ 720090 w 771573"/>
                <a:gd name="connsiteY63" fmla="*/ 129646 h 285887"/>
                <a:gd name="connsiteX64" fmla="*/ 714375 w 771573"/>
                <a:gd name="connsiteY64" fmla="*/ 127741 h 285887"/>
                <a:gd name="connsiteX65" fmla="*/ 702945 w 771573"/>
                <a:gd name="connsiteY65" fmla="*/ 118216 h 285887"/>
                <a:gd name="connsiteX66" fmla="*/ 697230 w 771573"/>
                <a:gd name="connsiteY66" fmla="*/ 112501 h 285887"/>
                <a:gd name="connsiteX67" fmla="*/ 691515 w 771573"/>
                <a:gd name="connsiteY67" fmla="*/ 108691 h 285887"/>
                <a:gd name="connsiteX68" fmla="*/ 683895 w 771573"/>
                <a:gd name="connsiteY68" fmla="*/ 102976 h 285887"/>
                <a:gd name="connsiteX69" fmla="*/ 676275 w 771573"/>
                <a:gd name="connsiteY69" fmla="*/ 99166 h 285887"/>
                <a:gd name="connsiteX70" fmla="*/ 664845 w 771573"/>
                <a:gd name="connsiteY70" fmla="*/ 95356 h 285887"/>
                <a:gd name="connsiteX71" fmla="*/ 655320 w 771573"/>
                <a:gd name="connsiteY71" fmla="*/ 89641 h 285887"/>
                <a:gd name="connsiteX72" fmla="*/ 640080 w 771573"/>
                <a:gd name="connsiteY72" fmla="*/ 83926 h 285887"/>
                <a:gd name="connsiteX73" fmla="*/ 626745 w 771573"/>
                <a:gd name="connsiteY73" fmla="*/ 74401 h 285887"/>
                <a:gd name="connsiteX74" fmla="*/ 621030 w 771573"/>
                <a:gd name="connsiteY74" fmla="*/ 72496 h 285887"/>
                <a:gd name="connsiteX75" fmla="*/ 609600 w 771573"/>
                <a:gd name="connsiteY75" fmla="*/ 64876 h 285887"/>
                <a:gd name="connsiteX76" fmla="*/ 598170 w 771573"/>
                <a:gd name="connsiteY76" fmla="*/ 59161 h 285887"/>
                <a:gd name="connsiteX77" fmla="*/ 592455 w 771573"/>
                <a:gd name="connsiteY77" fmla="*/ 55351 h 285887"/>
                <a:gd name="connsiteX78" fmla="*/ 584835 w 771573"/>
                <a:gd name="connsiteY78" fmla="*/ 49636 h 285887"/>
                <a:gd name="connsiteX79" fmla="*/ 573405 w 771573"/>
                <a:gd name="connsiteY79" fmla="*/ 45826 h 285887"/>
                <a:gd name="connsiteX80" fmla="*/ 567690 w 771573"/>
                <a:gd name="connsiteY80" fmla="*/ 42016 h 285887"/>
                <a:gd name="connsiteX81" fmla="*/ 556260 w 771573"/>
                <a:gd name="connsiteY81" fmla="*/ 38206 h 285887"/>
                <a:gd name="connsiteX82" fmla="*/ 548640 w 771573"/>
                <a:gd name="connsiteY82" fmla="*/ 34396 h 285887"/>
                <a:gd name="connsiteX83" fmla="*/ 537210 w 771573"/>
                <a:gd name="connsiteY83" fmla="*/ 26776 h 285887"/>
                <a:gd name="connsiteX84" fmla="*/ 493395 w 771573"/>
                <a:gd name="connsiteY84" fmla="*/ 17251 h 285887"/>
                <a:gd name="connsiteX85" fmla="*/ 485775 w 771573"/>
                <a:gd name="connsiteY85" fmla="*/ 15346 h 285887"/>
                <a:gd name="connsiteX86" fmla="*/ 472440 w 771573"/>
                <a:gd name="connsiteY86" fmla="*/ 11536 h 285887"/>
                <a:gd name="connsiteX87" fmla="*/ 409575 w 771573"/>
                <a:gd name="connsiteY87" fmla="*/ 3916 h 285887"/>
                <a:gd name="connsiteX88" fmla="*/ 360045 w 771573"/>
                <a:gd name="connsiteY88" fmla="*/ 106 h 285887"/>
                <a:gd name="connsiteX89" fmla="*/ 300990 w 771573"/>
                <a:gd name="connsiteY89" fmla="*/ 2011 h 285887"/>
                <a:gd name="connsiteX90" fmla="*/ 268605 w 771573"/>
                <a:gd name="connsiteY90" fmla="*/ 9631 h 285887"/>
                <a:gd name="connsiteX91" fmla="*/ 226695 w 771573"/>
                <a:gd name="connsiteY91" fmla="*/ 26776 h 285887"/>
                <a:gd name="connsiteX92" fmla="*/ 182880 w 771573"/>
                <a:gd name="connsiteY92" fmla="*/ 53446 h 285887"/>
                <a:gd name="connsiteX93" fmla="*/ 123825 w 771573"/>
                <a:gd name="connsiteY93" fmla="*/ 95356 h 285887"/>
                <a:gd name="connsiteX94" fmla="*/ 87630 w 771573"/>
                <a:gd name="connsiteY94" fmla="*/ 125836 h 285887"/>
                <a:gd name="connsiteX95" fmla="*/ 55245 w 771573"/>
                <a:gd name="connsiteY95" fmla="*/ 158221 h 285887"/>
                <a:gd name="connsiteX96" fmla="*/ 20955 w 771573"/>
                <a:gd name="connsiteY96" fmla="*/ 203941 h 285887"/>
                <a:gd name="connsiteX97" fmla="*/ 0 w 771573"/>
                <a:gd name="connsiteY97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58115 w 771573"/>
                <a:gd name="connsiteY14" fmla="*/ 163936 h 285887"/>
                <a:gd name="connsiteX15" fmla="*/ 180975 w 771573"/>
                <a:gd name="connsiteY15" fmla="*/ 150601 h 285887"/>
                <a:gd name="connsiteX16" fmla="*/ 200025 w 771573"/>
                <a:gd name="connsiteY16" fmla="*/ 131551 h 285887"/>
                <a:gd name="connsiteX17" fmla="*/ 226695 w 771573"/>
                <a:gd name="connsiteY17" fmla="*/ 112501 h 285887"/>
                <a:gd name="connsiteX18" fmla="*/ 238125 w 771573"/>
                <a:gd name="connsiteY18" fmla="*/ 108691 h 285887"/>
                <a:gd name="connsiteX19" fmla="*/ 251460 w 771573"/>
                <a:gd name="connsiteY19" fmla="*/ 101071 h 285887"/>
                <a:gd name="connsiteX20" fmla="*/ 259080 w 771573"/>
                <a:gd name="connsiteY20" fmla="*/ 99166 h 285887"/>
                <a:gd name="connsiteX21" fmla="*/ 276225 w 771573"/>
                <a:gd name="connsiteY21" fmla="*/ 93451 h 285887"/>
                <a:gd name="connsiteX22" fmla="*/ 283845 w 771573"/>
                <a:gd name="connsiteY22" fmla="*/ 91546 h 285887"/>
                <a:gd name="connsiteX23" fmla="*/ 319563 w 771573"/>
                <a:gd name="connsiteY23" fmla="*/ 82846 h 285887"/>
                <a:gd name="connsiteX24" fmla="*/ 372425 w 771573"/>
                <a:gd name="connsiteY24" fmla="*/ 78470 h 285887"/>
                <a:gd name="connsiteX25" fmla="*/ 456259 w 771573"/>
                <a:gd name="connsiteY25" fmla="*/ 78263 h 285887"/>
                <a:gd name="connsiteX26" fmla="*/ 521970 w 771573"/>
                <a:gd name="connsiteY26" fmla="*/ 85831 h 285887"/>
                <a:gd name="connsiteX27" fmla="*/ 537210 w 771573"/>
                <a:gd name="connsiteY27" fmla="*/ 89641 h 285887"/>
                <a:gd name="connsiteX28" fmla="*/ 542925 w 771573"/>
                <a:gd name="connsiteY28" fmla="*/ 93451 h 285887"/>
                <a:gd name="connsiteX29" fmla="*/ 550545 w 771573"/>
                <a:gd name="connsiteY29" fmla="*/ 97261 h 285887"/>
                <a:gd name="connsiteX30" fmla="*/ 565785 w 771573"/>
                <a:gd name="connsiteY30" fmla="*/ 104881 h 285887"/>
                <a:gd name="connsiteX31" fmla="*/ 575310 w 771573"/>
                <a:gd name="connsiteY31" fmla="*/ 114406 h 285887"/>
                <a:gd name="connsiteX32" fmla="*/ 581025 w 771573"/>
                <a:gd name="connsiteY32" fmla="*/ 118216 h 285887"/>
                <a:gd name="connsiteX33" fmla="*/ 600075 w 771573"/>
                <a:gd name="connsiteY33" fmla="*/ 133456 h 285887"/>
                <a:gd name="connsiteX34" fmla="*/ 607695 w 771573"/>
                <a:gd name="connsiteY34" fmla="*/ 142981 h 285887"/>
                <a:gd name="connsiteX35" fmla="*/ 621030 w 771573"/>
                <a:gd name="connsiteY35" fmla="*/ 156316 h 285887"/>
                <a:gd name="connsiteX36" fmla="*/ 628650 w 771573"/>
                <a:gd name="connsiteY36" fmla="*/ 167746 h 285887"/>
                <a:gd name="connsiteX37" fmla="*/ 638175 w 771573"/>
                <a:gd name="connsiteY37" fmla="*/ 182986 h 285887"/>
                <a:gd name="connsiteX38" fmla="*/ 647700 w 771573"/>
                <a:gd name="connsiteY38" fmla="*/ 200131 h 285887"/>
                <a:gd name="connsiteX39" fmla="*/ 657225 w 771573"/>
                <a:gd name="connsiteY39" fmla="*/ 211561 h 285887"/>
                <a:gd name="connsiteX40" fmla="*/ 668655 w 771573"/>
                <a:gd name="connsiteY40" fmla="*/ 219181 h 285887"/>
                <a:gd name="connsiteX41" fmla="*/ 672465 w 771573"/>
                <a:gd name="connsiteY41" fmla="*/ 224896 h 285887"/>
                <a:gd name="connsiteX42" fmla="*/ 678180 w 771573"/>
                <a:gd name="connsiteY42" fmla="*/ 226801 h 285887"/>
                <a:gd name="connsiteX43" fmla="*/ 681990 w 771573"/>
                <a:gd name="connsiteY43" fmla="*/ 234421 h 285887"/>
                <a:gd name="connsiteX44" fmla="*/ 697230 w 771573"/>
                <a:gd name="connsiteY44" fmla="*/ 251566 h 285887"/>
                <a:gd name="connsiteX45" fmla="*/ 701040 w 771573"/>
                <a:gd name="connsiteY45" fmla="*/ 266806 h 285887"/>
                <a:gd name="connsiteX46" fmla="*/ 710565 w 771573"/>
                <a:gd name="connsiteY46" fmla="*/ 276331 h 285887"/>
                <a:gd name="connsiteX47" fmla="*/ 723900 w 771573"/>
                <a:gd name="connsiteY47" fmla="*/ 274426 h 285887"/>
                <a:gd name="connsiteX48" fmla="*/ 727710 w 771573"/>
                <a:gd name="connsiteY48" fmla="*/ 268711 h 285887"/>
                <a:gd name="connsiteX49" fmla="*/ 741045 w 771573"/>
                <a:gd name="connsiteY49" fmla="*/ 255376 h 285887"/>
                <a:gd name="connsiteX50" fmla="*/ 746760 w 771573"/>
                <a:gd name="connsiteY50" fmla="*/ 249661 h 285887"/>
                <a:gd name="connsiteX51" fmla="*/ 754380 w 771573"/>
                <a:gd name="connsiteY51" fmla="*/ 243946 h 285887"/>
                <a:gd name="connsiteX52" fmla="*/ 762000 w 771573"/>
                <a:gd name="connsiteY52" fmla="*/ 240136 h 285887"/>
                <a:gd name="connsiteX53" fmla="*/ 767715 w 771573"/>
                <a:gd name="connsiteY53" fmla="*/ 236326 h 285887"/>
                <a:gd name="connsiteX54" fmla="*/ 771525 w 771573"/>
                <a:gd name="connsiteY54" fmla="*/ 230611 h 285887"/>
                <a:gd name="connsiteX55" fmla="*/ 765810 w 771573"/>
                <a:gd name="connsiteY55" fmla="*/ 200131 h 285887"/>
                <a:gd name="connsiteX56" fmla="*/ 762000 w 771573"/>
                <a:gd name="connsiteY56" fmla="*/ 194416 h 285887"/>
                <a:gd name="connsiteX57" fmla="*/ 756285 w 771573"/>
                <a:gd name="connsiteY57" fmla="*/ 181081 h 285887"/>
                <a:gd name="connsiteX58" fmla="*/ 748665 w 771573"/>
                <a:gd name="connsiteY58" fmla="*/ 165841 h 285887"/>
                <a:gd name="connsiteX59" fmla="*/ 739140 w 771573"/>
                <a:gd name="connsiteY59" fmla="*/ 152506 h 285887"/>
                <a:gd name="connsiteX60" fmla="*/ 737235 w 771573"/>
                <a:gd name="connsiteY60" fmla="*/ 146791 h 285887"/>
                <a:gd name="connsiteX61" fmla="*/ 727710 w 771573"/>
                <a:gd name="connsiteY61" fmla="*/ 135361 h 285887"/>
                <a:gd name="connsiteX62" fmla="*/ 720090 w 771573"/>
                <a:gd name="connsiteY62" fmla="*/ 129646 h 285887"/>
                <a:gd name="connsiteX63" fmla="*/ 714375 w 771573"/>
                <a:gd name="connsiteY63" fmla="*/ 127741 h 285887"/>
                <a:gd name="connsiteX64" fmla="*/ 702945 w 771573"/>
                <a:gd name="connsiteY64" fmla="*/ 118216 h 285887"/>
                <a:gd name="connsiteX65" fmla="*/ 697230 w 771573"/>
                <a:gd name="connsiteY65" fmla="*/ 112501 h 285887"/>
                <a:gd name="connsiteX66" fmla="*/ 691515 w 771573"/>
                <a:gd name="connsiteY66" fmla="*/ 108691 h 285887"/>
                <a:gd name="connsiteX67" fmla="*/ 683895 w 771573"/>
                <a:gd name="connsiteY67" fmla="*/ 102976 h 285887"/>
                <a:gd name="connsiteX68" fmla="*/ 676275 w 771573"/>
                <a:gd name="connsiteY68" fmla="*/ 99166 h 285887"/>
                <a:gd name="connsiteX69" fmla="*/ 664845 w 771573"/>
                <a:gd name="connsiteY69" fmla="*/ 95356 h 285887"/>
                <a:gd name="connsiteX70" fmla="*/ 655320 w 771573"/>
                <a:gd name="connsiteY70" fmla="*/ 89641 h 285887"/>
                <a:gd name="connsiteX71" fmla="*/ 640080 w 771573"/>
                <a:gd name="connsiteY71" fmla="*/ 83926 h 285887"/>
                <a:gd name="connsiteX72" fmla="*/ 626745 w 771573"/>
                <a:gd name="connsiteY72" fmla="*/ 74401 h 285887"/>
                <a:gd name="connsiteX73" fmla="*/ 621030 w 771573"/>
                <a:gd name="connsiteY73" fmla="*/ 72496 h 285887"/>
                <a:gd name="connsiteX74" fmla="*/ 609600 w 771573"/>
                <a:gd name="connsiteY74" fmla="*/ 64876 h 285887"/>
                <a:gd name="connsiteX75" fmla="*/ 598170 w 771573"/>
                <a:gd name="connsiteY75" fmla="*/ 59161 h 285887"/>
                <a:gd name="connsiteX76" fmla="*/ 592455 w 771573"/>
                <a:gd name="connsiteY76" fmla="*/ 55351 h 285887"/>
                <a:gd name="connsiteX77" fmla="*/ 584835 w 771573"/>
                <a:gd name="connsiteY77" fmla="*/ 49636 h 285887"/>
                <a:gd name="connsiteX78" fmla="*/ 573405 w 771573"/>
                <a:gd name="connsiteY78" fmla="*/ 45826 h 285887"/>
                <a:gd name="connsiteX79" fmla="*/ 567690 w 771573"/>
                <a:gd name="connsiteY79" fmla="*/ 42016 h 285887"/>
                <a:gd name="connsiteX80" fmla="*/ 556260 w 771573"/>
                <a:gd name="connsiteY80" fmla="*/ 38206 h 285887"/>
                <a:gd name="connsiteX81" fmla="*/ 548640 w 771573"/>
                <a:gd name="connsiteY81" fmla="*/ 34396 h 285887"/>
                <a:gd name="connsiteX82" fmla="*/ 537210 w 771573"/>
                <a:gd name="connsiteY82" fmla="*/ 26776 h 285887"/>
                <a:gd name="connsiteX83" fmla="*/ 493395 w 771573"/>
                <a:gd name="connsiteY83" fmla="*/ 17251 h 285887"/>
                <a:gd name="connsiteX84" fmla="*/ 485775 w 771573"/>
                <a:gd name="connsiteY84" fmla="*/ 15346 h 285887"/>
                <a:gd name="connsiteX85" fmla="*/ 472440 w 771573"/>
                <a:gd name="connsiteY85" fmla="*/ 11536 h 285887"/>
                <a:gd name="connsiteX86" fmla="*/ 409575 w 771573"/>
                <a:gd name="connsiteY86" fmla="*/ 3916 h 285887"/>
                <a:gd name="connsiteX87" fmla="*/ 360045 w 771573"/>
                <a:gd name="connsiteY87" fmla="*/ 106 h 285887"/>
                <a:gd name="connsiteX88" fmla="*/ 300990 w 771573"/>
                <a:gd name="connsiteY88" fmla="*/ 2011 h 285887"/>
                <a:gd name="connsiteX89" fmla="*/ 268605 w 771573"/>
                <a:gd name="connsiteY89" fmla="*/ 9631 h 285887"/>
                <a:gd name="connsiteX90" fmla="*/ 226695 w 771573"/>
                <a:gd name="connsiteY90" fmla="*/ 26776 h 285887"/>
                <a:gd name="connsiteX91" fmla="*/ 182880 w 771573"/>
                <a:gd name="connsiteY91" fmla="*/ 53446 h 285887"/>
                <a:gd name="connsiteX92" fmla="*/ 123825 w 771573"/>
                <a:gd name="connsiteY92" fmla="*/ 95356 h 285887"/>
                <a:gd name="connsiteX93" fmla="*/ 87630 w 771573"/>
                <a:gd name="connsiteY93" fmla="*/ 125836 h 285887"/>
                <a:gd name="connsiteX94" fmla="*/ 55245 w 771573"/>
                <a:gd name="connsiteY94" fmla="*/ 158221 h 285887"/>
                <a:gd name="connsiteX95" fmla="*/ 20955 w 771573"/>
                <a:gd name="connsiteY95" fmla="*/ 203941 h 285887"/>
                <a:gd name="connsiteX96" fmla="*/ 0 w 771573"/>
                <a:gd name="connsiteY96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27635 w 771573"/>
                <a:gd name="connsiteY12" fmla="*/ 182986 h 285887"/>
                <a:gd name="connsiteX13" fmla="*/ 140970 w 771573"/>
                <a:gd name="connsiteY13" fmla="*/ 175366 h 285887"/>
                <a:gd name="connsiteX14" fmla="*/ 180975 w 771573"/>
                <a:gd name="connsiteY14" fmla="*/ 150601 h 285887"/>
                <a:gd name="connsiteX15" fmla="*/ 200025 w 771573"/>
                <a:gd name="connsiteY15" fmla="*/ 131551 h 285887"/>
                <a:gd name="connsiteX16" fmla="*/ 226695 w 771573"/>
                <a:gd name="connsiteY16" fmla="*/ 112501 h 285887"/>
                <a:gd name="connsiteX17" fmla="*/ 238125 w 771573"/>
                <a:gd name="connsiteY17" fmla="*/ 108691 h 285887"/>
                <a:gd name="connsiteX18" fmla="*/ 251460 w 771573"/>
                <a:gd name="connsiteY18" fmla="*/ 101071 h 285887"/>
                <a:gd name="connsiteX19" fmla="*/ 259080 w 771573"/>
                <a:gd name="connsiteY19" fmla="*/ 99166 h 285887"/>
                <a:gd name="connsiteX20" fmla="*/ 276225 w 771573"/>
                <a:gd name="connsiteY20" fmla="*/ 93451 h 285887"/>
                <a:gd name="connsiteX21" fmla="*/ 283845 w 771573"/>
                <a:gd name="connsiteY21" fmla="*/ 91546 h 285887"/>
                <a:gd name="connsiteX22" fmla="*/ 319563 w 771573"/>
                <a:gd name="connsiteY22" fmla="*/ 82846 h 285887"/>
                <a:gd name="connsiteX23" fmla="*/ 372425 w 771573"/>
                <a:gd name="connsiteY23" fmla="*/ 78470 h 285887"/>
                <a:gd name="connsiteX24" fmla="*/ 456259 w 771573"/>
                <a:gd name="connsiteY24" fmla="*/ 78263 h 285887"/>
                <a:gd name="connsiteX25" fmla="*/ 521970 w 771573"/>
                <a:gd name="connsiteY25" fmla="*/ 85831 h 285887"/>
                <a:gd name="connsiteX26" fmla="*/ 537210 w 771573"/>
                <a:gd name="connsiteY26" fmla="*/ 89641 h 285887"/>
                <a:gd name="connsiteX27" fmla="*/ 542925 w 771573"/>
                <a:gd name="connsiteY27" fmla="*/ 93451 h 285887"/>
                <a:gd name="connsiteX28" fmla="*/ 550545 w 771573"/>
                <a:gd name="connsiteY28" fmla="*/ 97261 h 285887"/>
                <a:gd name="connsiteX29" fmla="*/ 565785 w 771573"/>
                <a:gd name="connsiteY29" fmla="*/ 104881 h 285887"/>
                <a:gd name="connsiteX30" fmla="*/ 575310 w 771573"/>
                <a:gd name="connsiteY30" fmla="*/ 114406 h 285887"/>
                <a:gd name="connsiteX31" fmla="*/ 581025 w 771573"/>
                <a:gd name="connsiteY31" fmla="*/ 118216 h 285887"/>
                <a:gd name="connsiteX32" fmla="*/ 600075 w 771573"/>
                <a:gd name="connsiteY32" fmla="*/ 133456 h 285887"/>
                <a:gd name="connsiteX33" fmla="*/ 607695 w 771573"/>
                <a:gd name="connsiteY33" fmla="*/ 142981 h 285887"/>
                <a:gd name="connsiteX34" fmla="*/ 621030 w 771573"/>
                <a:gd name="connsiteY34" fmla="*/ 156316 h 285887"/>
                <a:gd name="connsiteX35" fmla="*/ 628650 w 771573"/>
                <a:gd name="connsiteY35" fmla="*/ 167746 h 285887"/>
                <a:gd name="connsiteX36" fmla="*/ 638175 w 771573"/>
                <a:gd name="connsiteY36" fmla="*/ 182986 h 285887"/>
                <a:gd name="connsiteX37" fmla="*/ 647700 w 771573"/>
                <a:gd name="connsiteY37" fmla="*/ 200131 h 285887"/>
                <a:gd name="connsiteX38" fmla="*/ 657225 w 771573"/>
                <a:gd name="connsiteY38" fmla="*/ 211561 h 285887"/>
                <a:gd name="connsiteX39" fmla="*/ 668655 w 771573"/>
                <a:gd name="connsiteY39" fmla="*/ 219181 h 285887"/>
                <a:gd name="connsiteX40" fmla="*/ 672465 w 771573"/>
                <a:gd name="connsiteY40" fmla="*/ 224896 h 285887"/>
                <a:gd name="connsiteX41" fmla="*/ 678180 w 771573"/>
                <a:gd name="connsiteY41" fmla="*/ 226801 h 285887"/>
                <a:gd name="connsiteX42" fmla="*/ 681990 w 771573"/>
                <a:gd name="connsiteY42" fmla="*/ 234421 h 285887"/>
                <a:gd name="connsiteX43" fmla="*/ 697230 w 771573"/>
                <a:gd name="connsiteY43" fmla="*/ 251566 h 285887"/>
                <a:gd name="connsiteX44" fmla="*/ 701040 w 771573"/>
                <a:gd name="connsiteY44" fmla="*/ 266806 h 285887"/>
                <a:gd name="connsiteX45" fmla="*/ 710565 w 771573"/>
                <a:gd name="connsiteY45" fmla="*/ 276331 h 285887"/>
                <a:gd name="connsiteX46" fmla="*/ 723900 w 771573"/>
                <a:gd name="connsiteY46" fmla="*/ 274426 h 285887"/>
                <a:gd name="connsiteX47" fmla="*/ 727710 w 771573"/>
                <a:gd name="connsiteY47" fmla="*/ 268711 h 285887"/>
                <a:gd name="connsiteX48" fmla="*/ 741045 w 771573"/>
                <a:gd name="connsiteY48" fmla="*/ 255376 h 285887"/>
                <a:gd name="connsiteX49" fmla="*/ 746760 w 771573"/>
                <a:gd name="connsiteY49" fmla="*/ 249661 h 285887"/>
                <a:gd name="connsiteX50" fmla="*/ 754380 w 771573"/>
                <a:gd name="connsiteY50" fmla="*/ 243946 h 285887"/>
                <a:gd name="connsiteX51" fmla="*/ 762000 w 771573"/>
                <a:gd name="connsiteY51" fmla="*/ 240136 h 285887"/>
                <a:gd name="connsiteX52" fmla="*/ 767715 w 771573"/>
                <a:gd name="connsiteY52" fmla="*/ 236326 h 285887"/>
                <a:gd name="connsiteX53" fmla="*/ 771525 w 771573"/>
                <a:gd name="connsiteY53" fmla="*/ 230611 h 285887"/>
                <a:gd name="connsiteX54" fmla="*/ 765810 w 771573"/>
                <a:gd name="connsiteY54" fmla="*/ 200131 h 285887"/>
                <a:gd name="connsiteX55" fmla="*/ 762000 w 771573"/>
                <a:gd name="connsiteY55" fmla="*/ 194416 h 285887"/>
                <a:gd name="connsiteX56" fmla="*/ 756285 w 771573"/>
                <a:gd name="connsiteY56" fmla="*/ 181081 h 285887"/>
                <a:gd name="connsiteX57" fmla="*/ 748665 w 771573"/>
                <a:gd name="connsiteY57" fmla="*/ 165841 h 285887"/>
                <a:gd name="connsiteX58" fmla="*/ 739140 w 771573"/>
                <a:gd name="connsiteY58" fmla="*/ 152506 h 285887"/>
                <a:gd name="connsiteX59" fmla="*/ 737235 w 771573"/>
                <a:gd name="connsiteY59" fmla="*/ 146791 h 285887"/>
                <a:gd name="connsiteX60" fmla="*/ 727710 w 771573"/>
                <a:gd name="connsiteY60" fmla="*/ 135361 h 285887"/>
                <a:gd name="connsiteX61" fmla="*/ 720090 w 771573"/>
                <a:gd name="connsiteY61" fmla="*/ 129646 h 285887"/>
                <a:gd name="connsiteX62" fmla="*/ 714375 w 771573"/>
                <a:gd name="connsiteY62" fmla="*/ 127741 h 285887"/>
                <a:gd name="connsiteX63" fmla="*/ 702945 w 771573"/>
                <a:gd name="connsiteY63" fmla="*/ 118216 h 285887"/>
                <a:gd name="connsiteX64" fmla="*/ 697230 w 771573"/>
                <a:gd name="connsiteY64" fmla="*/ 112501 h 285887"/>
                <a:gd name="connsiteX65" fmla="*/ 691515 w 771573"/>
                <a:gd name="connsiteY65" fmla="*/ 108691 h 285887"/>
                <a:gd name="connsiteX66" fmla="*/ 683895 w 771573"/>
                <a:gd name="connsiteY66" fmla="*/ 102976 h 285887"/>
                <a:gd name="connsiteX67" fmla="*/ 676275 w 771573"/>
                <a:gd name="connsiteY67" fmla="*/ 99166 h 285887"/>
                <a:gd name="connsiteX68" fmla="*/ 664845 w 771573"/>
                <a:gd name="connsiteY68" fmla="*/ 95356 h 285887"/>
                <a:gd name="connsiteX69" fmla="*/ 655320 w 771573"/>
                <a:gd name="connsiteY69" fmla="*/ 89641 h 285887"/>
                <a:gd name="connsiteX70" fmla="*/ 640080 w 771573"/>
                <a:gd name="connsiteY70" fmla="*/ 83926 h 285887"/>
                <a:gd name="connsiteX71" fmla="*/ 626745 w 771573"/>
                <a:gd name="connsiteY71" fmla="*/ 74401 h 285887"/>
                <a:gd name="connsiteX72" fmla="*/ 621030 w 771573"/>
                <a:gd name="connsiteY72" fmla="*/ 72496 h 285887"/>
                <a:gd name="connsiteX73" fmla="*/ 609600 w 771573"/>
                <a:gd name="connsiteY73" fmla="*/ 64876 h 285887"/>
                <a:gd name="connsiteX74" fmla="*/ 598170 w 771573"/>
                <a:gd name="connsiteY74" fmla="*/ 59161 h 285887"/>
                <a:gd name="connsiteX75" fmla="*/ 592455 w 771573"/>
                <a:gd name="connsiteY75" fmla="*/ 55351 h 285887"/>
                <a:gd name="connsiteX76" fmla="*/ 584835 w 771573"/>
                <a:gd name="connsiteY76" fmla="*/ 49636 h 285887"/>
                <a:gd name="connsiteX77" fmla="*/ 573405 w 771573"/>
                <a:gd name="connsiteY77" fmla="*/ 45826 h 285887"/>
                <a:gd name="connsiteX78" fmla="*/ 567690 w 771573"/>
                <a:gd name="connsiteY78" fmla="*/ 42016 h 285887"/>
                <a:gd name="connsiteX79" fmla="*/ 556260 w 771573"/>
                <a:gd name="connsiteY79" fmla="*/ 38206 h 285887"/>
                <a:gd name="connsiteX80" fmla="*/ 548640 w 771573"/>
                <a:gd name="connsiteY80" fmla="*/ 34396 h 285887"/>
                <a:gd name="connsiteX81" fmla="*/ 537210 w 771573"/>
                <a:gd name="connsiteY81" fmla="*/ 26776 h 285887"/>
                <a:gd name="connsiteX82" fmla="*/ 493395 w 771573"/>
                <a:gd name="connsiteY82" fmla="*/ 17251 h 285887"/>
                <a:gd name="connsiteX83" fmla="*/ 485775 w 771573"/>
                <a:gd name="connsiteY83" fmla="*/ 15346 h 285887"/>
                <a:gd name="connsiteX84" fmla="*/ 472440 w 771573"/>
                <a:gd name="connsiteY84" fmla="*/ 11536 h 285887"/>
                <a:gd name="connsiteX85" fmla="*/ 409575 w 771573"/>
                <a:gd name="connsiteY85" fmla="*/ 3916 h 285887"/>
                <a:gd name="connsiteX86" fmla="*/ 360045 w 771573"/>
                <a:gd name="connsiteY86" fmla="*/ 106 h 285887"/>
                <a:gd name="connsiteX87" fmla="*/ 300990 w 771573"/>
                <a:gd name="connsiteY87" fmla="*/ 2011 h 285887"/>
                <a:gd name="connsiteX88" fmla="*/ 268605 w 771573"/>
                <a:gd name="connsiteY88" fmla="*/ 9631 h 285887"/>
                <a:gd name="connsiteX89" fmla="*/ 226695 w 771573"/>
                <a:gd name="connsiteY89" fmla="*/ 26776 h 285887"/>
                <a:gd name="connsiteX90" fmla="*/ 182880 w 771573"/>
                <a:gd name="connsiteY90" fmla="*/ 53446 h 285887"/>
                <a:gd name="connsiteX91" fmla="*/ 123825 w 771573"/>
                <a:gd name="connsiteY91" fmla="*/ 95356 h 285887"/>
                <a:gd name="connsiteX92" fmla="*/ 87630 w 771573"/>
                <a:gd name="connsiteY92" fmla="*/ 125836 h 285887"/>
                <a:gd name="connsiteX93" fmla="*/ 55245 w 771573"/>
                <a:gd name="connsiteY93" fmla="*/ 158221 h 285887"/>
                <a:gd name="connsiteX94" fmla="*/ 20955 w 771573"/>
                <a:gd name="connsiteY94" fmla="*/ 203941 h 285887"/>
                <a:gd name="connsiteX95" fmla="*/ 0 w 771573"/>
                <a:gd name="connsiteY95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12395 w 771573"/>
                <a:gd name="connsiteY11" fmla="*/ 188701 h 285887"/>
                <a:gd name="connsiteX12" fmla="*/ 140970 w 771573"/>
                <a:gd name="connsiteY12" fmla="*/ 175366 h 285887"/>
                <a:gd name="connsiteX13" fmla="*/ 180975 w 771573"/>
                <a:gd name="connsiteY13" fmla="*/ 150601 h 285887"/>
                <a:gd name="connsiteX14" fmla="*/ 200025 w 771573"/>
                <a:gd name="connsiteY14" fmla="*/ 131551 h 285887"/>
                <a:gd name="connsiteX15" fmla="*/ 226695 w 771573"/>
                <a:gd name="connsiteY15" fmla="*/ 112501 h 285887"/>
                <a:gd name="connsiteX16" fmla="*/ 238125 w 771573"/>
                <a:gd name="connsiteY16" fmla="*/ 108691 h 285887"/>
                <a:gd name="connsiteX17" fmla="*/ 251460 w 771573"/>
                <a:gd name="connsiteY17" fmla="*/ 101071 h 285887"/>
                <a:gd name="connsiteX18" fmla="*/ 259080 w 771573"/>
                <a:gd name="connsiteY18" fmla="*/ 99166 h 285887"/>
                <a:gd name="connsiteX19" fmla="*/ 276225 w 771573"/>
                <a:gd name="connsiteY19" fmla="*/ 93451 h 285887"/>
                <a:gd name="connsiteX20" fmla="*/ 283845 w 771573"/>
                <a:gd name="connsiteY20" fmla="*/ 91546 h 285887"/>
                <a:gd name="connsiteX21" fmla="*/ 319563 w 771573"/>
                <a:gd name="connsiteY21" fmla="*/ 82846 h 285887"/>
                <a:gd name="connsiteX22" fmla="*/ 372425 w 771573"/>
                <a:gd name="connsiteY22" fmla="*/ 78470 h 285887"/>
                <a:gd name="connsiteX23" fmla="*/ 456259 w 771573"/>
                <a:gd name="connsiteY23" fmla="*/ 78263 h 285887"/>
                <a:gd name="connsiteX24" fmla="*/ 521970 w 771573"/>
                <a:gd name="connsiteY24" fmla="*/ 85831 h 285887"/>
                <a:gd name="connsiteX25" fmla="*/ 537210 w 771573"/>
                <a:gd name="connsiteY25" fmla="*/ 89641 h 285887"/>
                <a:gd name="connsiteX26" fmla="*/ 542925 w 771573"/>
                <a:gd name="connsiteY26" fmla="*/ 93451 h 285887"/>
                <a:gd name="connsiteX27" fmla="*/ 550545 w 771573"/>
                <a:gd name="connsiteY27" fmla="*/ 97261 h 285887"/>
                <a:gd name="connsiteX28" fmla="*/ 565785 w 771573"/>
                <a:gd name="connsiteY28" fmla="*/ 104881 h 285887"/>
                <a:gd name="connsiteX29" fmla="*/ 575310 w 771573"/>
                <a:gd name="connsiteY29" fmla="*/ 114406 h 285887"/>
                <a:gd name="connsiteX30" fmla="*/ 581025 w 771573"/>
                <a:gd name="connsiteY30" fmla="*/ 118216 h 285887"/>
                <a:gd name="connsiteX31" fmla="*/ 600075 w 771573"/>
                <a:gd name="connsiteY31" fmla="*/ 133456 h 285887"/>
                <a:gd name="connsiteX32" fmla="*/ 607695 w 771573"/>
                <a:gd name="connsiteY32" fmla="*/ 142981 h 285887"/>
                <a:gd name="connsiteX33" fmla="*/ 621030 w 771573"/>
                <a:gd name="connsiteY33" fmla="*/ 156316 h 285887"/>
                <a:gd name="connsiteX34" fmla="*/ 628650 w 771573"/>
                <a:gd name="connsiteY34" fmla="*/ 167746 h 285887"/>
                <a:gd name="connsiteX35" fmla="*/ 638175 w 771573"/>
                <a:gd name="connsiteY35" fmla="*/ 182986 h 285887"/>
                <a:gd name="connsiteX36" fmla="*/ 647700 w 771573"/>
                <a:gd name="connsiteY36" fmla="*/ 200131 h 285887"/>
                <a:gd name="connsiteX37" fmla="*/ 657225 w 771573"/>
                <a:gd name="connsiteY37" fmla="*/ 211561 h 285887"/>
                <a:gd name="connsiteX38" fmla="*/ 668655 w 771573"/>
                <a:gd name="connsiteY38" fmla="*/ 219181 h 285887"/>
                <a:gd name="connsiteX39" fmla="*/ 672465 w 771573"/>
                <a:gd name="connsiteY39" fmla="*/ 224896 h 285887"/>
                <a:gd name="connsiteX40" fmla="*/ 678180 w 771573"/>
                <a:gd name="connsiteY40" fmla="*/ 226801 h 285887"/>
                <a:gd name="connsiteX41" fmla="*/ 681990 w 771573"/>
                <a:gd name="connsiteY41" fmla="*/ 234421 h 285887"/>
                <a:gd name="connsiteX42" fmla="*/ 697230 w 771573"/>
                <a:gd name="connsiteY42" fmla="*/ 251566 h 285887"/>
                <a:gd name="connsiteX43" fmla="*/ 701040 w 771573"/>
                <a:gd name="connsiteY43" fmla="*/ 266806 h 285887"/>
                <a:gd name="connsiteX44" fmla="*/ 710565 w 771573"/>
                <a:gd name="connsiteY44" fmla="*/ 276331 h 285887"/>
                <a:gd name="connsiteX45" fmla="*/ 723900 w 771573"/>
                <a:gd name="connsiteY45" fmla="*/ 274426 h 285887"/>
                <a:gd name="connsiteX46" fmla="*/ 727710 w 771573"/>
                <a:gd name="connsiteY46" fmla="*/ 268711 h 285887"/>
                <a:gd name="connsiteX47" fmla="*/ 741045 w 771573"/>
                <a:gd name="connsiteY47" fmla="*/ 255376 h 285887"/>
                <a:gd name="connsiteX48" fmla="*/ 746760 w 771573"/>
                <a:gd name="connsiteY48" fmla="*/ 249661 h 285887"/>
                <a:gd name="connsiteX49" fmla="*/ 754380 w 771573"/>
                <a:gd name="connsiteY49" fmla="*/ 243946 h 285887"/>
                <a:gd name="connsiteX50" fmla="*/ 762000 w 771573"/>
                <a:gd name="connsiteY50" fmla="*/ 240136 h 285887"/>
                <a:gd name="connsiteX51" fmla="*/ 767715 w 771573"/>
                <a:gd name="connsiteY51" fmla="*/ 236326 h 285887"/>
                <a:gd name="connsiteX52" fmla="*/ 771525 w 771573"/>
                <a:gd name="connsiteY52" fmla="*/ 230611 h 285887"/>
                <a:gd name="connsiteX53" fmla="*/ 765810 w 771573"/>
                <a:gd name="connsiteY53" fmla="*/ 200131 h 285887"/>
                <a:gd name="connsiteX54" fmla="*/ 762000 w 771573"/>
                <a:gd name="connsiteY54" fmla="*/ 194416 h 285887"/>
                <a:gd name="connsiteX55" fmla="*/ 756285 w 771573"/>
                <a:gd name="connsiteY55" fmla="*/ 181081 h 285887"/>
                <a:gd name="connsiteX56" fmla="*/ 748665 w 771573"/>
                <a:gd name="connsiteY56" fmla="*/ 165841 h 285887"/>
                <a:gd name="connsiteX57" fmla="*/ 739140 w 771573"/>
                <a:gd name="connsiteY57" fmla="*/ 152506 h 285887"/>
                <a:gd name="connsiteX58" fmla="*/ 737235 w 771573"/>
                <a:gd name="connsiteY58" fmla="*/ 146791 h 285887"/>
                <a:gd name="connsiteX59" fmla="*/ 727710 w 771573"/>
                <a:gd name="connsiteY59" fmla="*/ 135361 h 285887"/>
                <a:gd name="connsiteX60" fmla="*/ 720090 w 771573"/>
                <a:gd name="connsiteY60" fmla="*/ 129646 h 285887"/>
                <a:gd name="connsiteX61" fmla="*/ 714375 w 771573"/>
                <a:gd name="connsiteY61" fmla="*/ 127741 h 285887"/>
                <a:gd name="connsiteX62" fmla="*/ 702945 w 771573"/>
                <a:gd name="connsiteY62" fmla="*/ 118216 h 285887"/>
                <a:gd name="connsiteX63" fmla="*/ 697230 w 771573"/>
                <a:gd name="connsiteY63" fmla="*/ 112501 h 285887"/>
                <a:gd name="connsiteX64" fmla="*/ 691515 w 771573"/>
                <a:gd name="connsiteY64" fmla="*/ 108691 h 285887"/>
                <a:gd name="connsiteX65" fmla="*/ 683895 w 771573"/>
                <a:gd name="connsiteY65" fmla="*/ 102976 h 285887"/>
                <a:gd name="connsiteX66" fmla="*/ 676275 w 771573"/>
                <a:gd name="connsiteY66" fmla="*/ 99166 h 285887"/>
                <a:gd name="connsiteX67" fmla="*/ 664845 w 771573"/>
                <a:gd name="connsiteY67" fmla="*/ 95356 h 285887"/>
                <a:gd name="connsiteX68" fmla="*/ 655320 w 771573"/>
                <a:gd name="connsiteY68" fmla="*/ 89641 h 285887"/>
                <a:gd name="connsiteX69" fmla="*/ 640080 w 771573"/>
                <a:gd name="connsiteY69" fmla="*/ 83926 h 285887"/>
                <a:gd name="connsiteX70" fmla="*/ 626745 w 771573"/>
                <a:gd name="connsiteY70" fmla="*/ 74401 h 285887"/>
                <a:gd name="connsiteX71" fmla="*/ 621030 w 771573"/>
                <a:gd name="connsiteY71" fmla="*/ 72496 h 285887"/>
                <a:gd name="connsiteX72" fmla="*/ 609600 w 771573"/>
                <a:gd name="connsiteY72" fmla="*/ 64876 h 285887"/>
                <a:gd name="connsiteX73" fmla="*/ 598170 w 771573"/>
                <a:gd name="connsiteY73" fmla="*/ 59161 h 285887"/>
                <a:gd name="connsiteX74" fmla="*/ 592455 w 771573"/>
                <a:gd name="connsiteY74" fmla="*/ 55351 h 285887"/>
                <a:gd name="connsiteX75" fmla="*/ 584835 w 771573"/>
                <a:gd name="connsiteY75" fmla="*/ 49636 h 285887"/>
                <a:gd name="connsiteX76" fmla="*/ 573405 w 771573"/>
                <a:gd name="connsiteY76" fmla="*/ 45826 h 285887"/>
                <a:gd name="connsiteX77" fmla="*/ 567690 w 771573"/>
                <a:gd name="connsiteY77" fmla="*/ 42016 h 285887"/>
                <a:gd name="connsiteX78" fmla="*/ 556260 w 771573"/>
                <a:gd name="connsiteY78" fmla="*/ 38206 h 285887"/>
                <a:gd name="connsiteX79" fmla="*/ 548640 w 771573"/>
                <a:gd name="connsiteY79" fmla="*/ 34396 h 285887"/>
                <a:gd name="connsiteX80" fmla="*/ 537210 w 771573"/>
                <a:gd name="connsiteY80" fmla="*/ 26776 h 285887"/>
                <a:gd name="connsiteX81" fmla="*/ 493395 w 771573"/>
                <a:gd name="connsiteY81" fmla="*/ 17251 h 285887"/>
                <a:gd name="connsiteX82" fmla="*/ 485775 w 771573"/>
                <a:gd name="connsiteY82" fmla="*/ 15346 h 285887"/>
                <a:gd name="connsiteX83" fmla="*/ 472440 w 771573"/>
                <a:gd name="connsiteY83" fmla="*/ 11536 h 285887"/>
                <a:gd name="connsiteX84" fmla="*/ 409575 w 771573"/>
                <a:gd name="connsiteY84" fmla="*/ 3916 h 285887"/>
                <a:gd name="connsiteX85" fmla="*/ 360045 w 771573"/>
                <a:gd name="connsiteY85" fmla="*/ 106 h 285887"/>
                <a:gd name="connsiteX86" fmla="*/ 300990 w 771573"/>
                <a:gd name="connsiteY86" fmla="*/ 2011 h 285887"/>
                <a:gd name="connsiteX87" fmla="*/ 268605 w 771573"/>
                <a:gd name="connsiteY87" fmla="*/ 9631 h 285887"/>
                <a:gd name="connsiteX88" fmla="*/ 226695 w 771573"/>
                <a:gd name="connsiteY88" fmla="*/ 26776 h 285887"/>
                <a:gd name="connsiteX89" fmla="*/ 182880 w 771573"/>
                <a:gd name="connsiteY89" fmla="*/ 53446 h 285887"/>
                <a:gd name="connsiteX90" fmla="*/ 123825 w 771573"/>
                <a:gd name="connsiteY90" fmla="*/ 95356 h 285887"/>
                <a:gd name="connsiteX91" fmla="*/ 87630 w 771573"/>
                <a:gd name="connsiteY91" fmla="*/ 125836 h 285887"/>
                <a:gd name="connsiteX92" fmla="*/ 55245 w 771573"/>
                <a:gd name="connsiteY92" fmla="*/ 158221 h 285887"/>
                <a:gd name="connsiteX93" fmla="*/ 20955 w 771573"/>
                <a:gd name="connsiteY93" fmla="*/ 203941 h 285887"/>
                <a:gd name="connsiteX94" fmla="*/ 0 w 771573"/>
                <a:gd name="connsiteY94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00965 w 771573"/>
                <a:gd name="connsiteY10" fmla="*/ 194416 h 285887"/>
                <a:gd name="connsiteX11" fmla="*/ 140970 w 771573"/>
                <a:gd name="connsiteY11" fmla="*/ 175366 h 285887"/>
                <a:gd name="connsiteX12" fmla="*/ 180975 w 771573"/>
                <a:gd name="connsiteY12" fmla="*/ 150601 h 285887"/>
                <a:gd name="connsiteX13" fmla="*/ 200025 w 771573"/>
                <a:gd name="connsiteY13" fmla="*/ 131551 h 285887"/>
                <a:gd name="connsiteX14" fmla="*/ 226695 w 771573"/>
                <a:gd name="connsiteY14" fmla="*/ 112501 h 285887"/>
                <a:gd name="connsiteX15" fmla="*/ 238125 w 771573"/>
                <a:gd name="connsiteY15" fmla="*/ 108691 h 285887"/>
                <a:gd name="connsiteX16" fmla="*/ 251460 w 771573"/>
                <a:gd name="connsiteY16" fmla="*/ 101071 h 285887"/>
                <a:gd name="connsiteX17" fmla="*/ 259080 w 771573"/>
                <a:gd name="connsiteY17" fmla="*/ 99166 h 285887"/>
                <a:gd name="connsiteX18" fmla="*/ 276225 w 771573"/>
                <a:gd name="connsiteY18" fmla="*/ 93451 h 285887"/>
                <a:gd name="connsiteX19" fmla="*/ 283845 w 771573"/>
                <a:gd name="connsiteY19" fmla="*/ 91546 h 285887"/>
                <a:gd name="connsiteX20" fmla="*/ 319563 w 771573"/>
                <a:gd name="connsiteY20" fmla="*/ 82846 h 285887"/>
                <a:gd name="connsiteX21" fmla="*/ 372425 w 771573"/>
                <a:gd name="connsiteY21" fmla="*/ 78470 h 285887"/>
                <a:gd name="connsiteX22" fmla="*/ 456259 w 771573"/>
                <a:gd name="connsiteY22" fmla="*/ 78263 h 285887"/>
                <a:gd name="connsiteX23" fmla="*/ 521970 w 771573"/>
                <a:gd name="connsiteY23" fmla="*/ 85831 h 285887"/>
                <a:gd name="connsiteX24" fmla="*/ 537210 w 771573"/>
                <a:gd name="connsiteY24" fmla="*/ 89641 h 285887"/>
                <a:gd name="connsiteX25" fmla="*/ 542925 w 771573"/>
                <a:gd name="connsiteY25" fmla="*/ 93451 h 285887"/>
                <a:gd name="connsiteX26" fmla="*/ 550545 w 771573"/>
                <a:gd name="connsiteY26" fmla="*/ 97261 h 285887"/>
                <a:gd name="connsiteX27" fmla="*/ 565785 w 771573"/>
                <a:gd name="connsiteY27" fmla="*/ 104881 h 285887"/>
                <a:gd name="connsiteX28" fmla="*/ 575310 w 771573"/>
                <a:gd name="connsiteY28" fmla="*/ 114406 h 285887"/>
                <a:gd name="connsiteX29" fmla="*/ 581025 w 771573"/>
                <a:gd name="connsiteY29" fmla="*/ 118216 h 285887"/>
                <a:gd name="connsiteX30" fmla="*/ 600075 w 771573"/>
                <a:gd name="connsiteY30" fmla="*/ 133456 h 285887"/>
                <a:gd name="connsiteX31" fmla="*/ 607695 w 771573"/>
                <a:gd name="connsiteY31" fmla="*/ 142981 h 285887"/>
                <a:gd name="connsiteX32" fmla="*/ 621030 w 771573"/>
                <a:gd name="connsiteY32" fmla="*/ 156316 h 285887"/>
                <a:gd name="connsiteX33" fmla="*/ 628650 w 771573"/>
                <a:gd name="connsiteY33" fmla="*/ 167746 h 285887"/>
                <a:gd name="connsiteX34" fmla="*/ 638175 w 771573"/>
                <a:gd name="connsiteY34" fmla="*/ 182986 h 285887"/>
                <a:gd name="connsiteX35" fmla="*/ 647700 w 771573"/>
                <a:gd name="connsiteY35" fmla="*/ 200131 h 285887"/>
                <a:gd name="connsiteX36" fmla="*/ 657225 w 771573"/>
                <a:gd name="connsiteY36" fmla="*/ 211561 h 285887"/>
                <a:gd name="connsiteX37" fmla="*/ 668655 w 771573"/>
                <a:gd name="connsiteY37" fmla="*/ 219181 h 285887"/>
                <a:gd name="connsiteX38" fmla="*/ 672465 w 771573"/>
                <a:gd name="connsiteY38" fmla="*/ 224896 h 285887"/>
                <a:gd name="connsiteX39" fmla="*/ 678180 w 771573"/>
                <a:gd name="connsiteY39" fmla="*/ 226801 h 285887"/>
                <a:gd name="connsiteX40" fmla="*/ 681990 w 771573"/>
                <a:gd name="connsiteY40" fmla="*/ 234421 h 285887"/>
                <a:gd name="connsiteX41" fmla="*/ 697230 w 771573"/>
                <a:gd name="connsiteY41" fmla="*/ 251566 h 285887"/>
                <a:gd name="connsiteX42" fmla="*/ 701040 w 771573"/>
                <a:gd name="connsiteY42" fmla="*/ 266806 h 285887"/>
                <a:gd name="connsiteX43" fmla="*/ 710565 w 771573"/>
                <a:gd name="connsiteY43" fmla="*/ 276331 h 285887"/>
                <a:gd name="connsiteX44" fmla="*/ 723900 w 771573"/>
                <a:gd name="connsiteY44" fmla="*/ 274426 h 285887"/>
                <a:gd name="connsiteX45" fmla="*/ 727710 w 771573"/>
                <a:gd name="connsiteY45" fmla="*/ 268711 h 285887"/>
                <a:gd name="connsiteX46" fmla="*/ 741045 w 771573"/>
                <a:gd name="connsiteY46" fmla="*/ 255376 h 285887"/>
                <a:gd name="connsiteX47" fmla="*/ 746760 w 771573"/>
                <a:gd name="connsiteY47" fmla="*/ 249661 h 285887"/>
                <a:gd name="connsiteX48" fmla="*/ 754380 w 771573"/>
                <a:gd name="connsiteY48" fmla="*/ 243946 h 285887"/>
                <a:gd name="connsiteX49" fmla="*/ 762000 w 771573"/>
                <a:gd name="connsiteY49" fmla="*/ 240136 h 285887"/>
                <a:gd name="connsiteX50" fmla="*/ 767715 w 771573"/>
                <a:gd name="connsiteY50" fmla="*/ 236326 h 285887"/>
                <a:gd name="connsiteX51" fmla="*/ 771525 w 771573"/>
                <a:gd name="connsiteY51" fmla="*/ 230611 h 285887"/>
                <a:gd name="connsiteX52" fmla="*/ 765810 w 771573"/>
                <a:gd name="connsiteY52" fmla="*/ 200131 h 285887"/>
                <a:gd name="connsiteX53" fmla="*/ 762000 w 771573"/>
                <a:gd name="connsiteY53" fmla="*/ 194416 h 285887"/>
                <a:gd name="connsiteX54" fmla="*/ 756285 w 771573"/>
                <a:gd name="connsiteY54" fmla="*/ 181081 h 285887"/>
                <a:gd name="connsiteX55" fmla="*/ 748665 w 771573"/>
                <a:gd name="connsiteY55" fmla="*/ 165841 h 285887"/>
                <a:gd name="connsiteX56" fmla="*/ 739140 w 771573"/>
                <a:gd name="connsiteY56" fmla="*/ 152506 h 285887"/>
                <a:gd name="connsiteX57" fmla="*/ 737235 w 771573"/>
                <a:gd name="connsiteY57" fmla="*/ 146791 h 285887"/>
                <a:gd name="connsiteX58" fmla="*/ 727710 w 771573"/>
                <a:gd name="connsiteY58" fmla="*/ 135361 h 285887"/>
                <a:gd name="connsiteX59" fmla="*/ 720090 w 771573"/>
                <a:gd name="connsiteY59" fmla="*/ 129646 h 285887"/>
                <a:gd name="connsiteX60" fmla="*/ 714375 w 771573"/>
                <a:gd name="connsiteY60" fmla="*/ 127741 h 285887"/>
                <a:gd name="connsiteX61" fmla="*/ 702945 w 771573"/>
                <a:gd name="connsiteY61" fmla="*/ 118216 h 285887"/>
                <a:gd name="connsiteX62" fmla="*/ 697230 w 771573"/>
                <a:gd name="connsiteY62" fmla="*/ 112501 h 285887"/>
                <a:gd name="connsiteX63" fmla="*/ 691515 w 771573"/>
                <a:gd name="connsiteY63" fmla="*/ 108691 h 285887"/>
                <a:gd name="connsiteX64" fmla="*/ 683895 w 771573"/>
                <a:gd name="connsiteY64" fmla="*/ 102976 h 285887"/>
                <a:gd name="connsiteX65" fmla="*/ 676275 w 771573"/>
                <a:gd name="connsiteY65" fmla="*/ 99166 h 285887"/>
                <a:gd name="connsiteX66" fmla="*/ 664845 w 771573"/>
                <a:gd name="connsiteY66" fmla="*/ 95356 h 285887"/>
                <a:gd name="connsiteX67" fmla="*/ 655320 w 771573"/>
                <a:gd name="connsiteY67" fmla="*/ 89641 h 285887"/>
                <a:gd name="connsiteX68" fmla="*/ 640080 w 771573"/>
                <a:gd name="connsiteY68" fmla="*/ 83926 h 285887"/>
                <a:gd name="connsiteX69" fmla="*/ 626745 w 771573"/>
                <a:gd name="connsiteY69" fmla="*/ 74401 h 285887"/>
                <a:gd name="connsiteX70" fmla="*/ 621030 w 771573"/>
                <a:gd name="connsiteY70" fmla="*/ 72496 h 285887"/>
                <a:gd name="connsiteX71" fmla="*/ 609600 w 771573"/>
                <a:gd name="connsiteY71" fmla="*/ 64876 h 285887"/>
                <a:gd name="connsiteX72" fmla="*/ 598170 w 771573"/>
                <a:gd name="connsiteY72" fmla="*/ 59161 h 285887"/>
                <a:gd name="connsiteX73" fmla="*/ 592455 w 771573"/>
                <a:gd name="connsiteY73" fmla="*/ 55351 h 285887"/>
                <a:gd name="connsiteX74" fmla="*/ 584835 w 771573"/>
                <a:gd name="connsiteY74" fmla="*/ 49636 h 285887"/>
                <a:gd name="connsiteX75" fmla="*/ 573405 w 771573"/>
                <a:gd name="connsiteY75" fmla="*/ 45826 h 285887"/>
                <a:gd name="connsiteX76" fmla="*/ 567690 w 771573"/>
                <a:gd name="connsiteY76" fmla="*/ 42016 h 285887"/>
                <a:gd name="connsiteX77" fmla="*/ 556260 w 771573"/>
                <a:gd name="connsiteY77" fmla="*/ 38206 h 285887"/>
                <a:gd name="connsiteX78" fmla="*/ 548640 w 771573"/>
                <a:gd name="connsiteY78" fmla="*/ 34396 h 285887"/>
                <a:gd name="connsiteX79" fmla="*/ 537210 w 771573"/>
                <a:gd name="connsiteY79" fmla="*/ 26776 h 285887"/>
                <a:gd name="connsiteX80" fmla="*/ 493395 w 771573"/>
                <a:gd name="connsiteY80" fmla="*/ 17251 h 285887"/>
                <a:gd name="connsiteX81" fmla="*/ 485775 w 771573"/>
                <a:gd name="connsiteY81" fmla="*/ 15346 h 285887"/>
                <a:gd name="connsiteX82" fmla="*/ 472440 w 771573"/>
                <a:gd name="connsiteY82" fmla="*/ 11536 h 285887"/>
                <a:gd name="connsiteX83" fmla="*/ 409575 w 771573"/>
                <a:gd name="connsiteY83" fmla="*/ 3916 h 285887"/>
                <a:gd name="connsiteX84" fmla="*/ 360045 w 771573"/>
                <a:gd name="connsiteY84" fmla="*/ 106 h 285887"/>
                <a:gd name="connsiteX85" fmla="*/ 300990 w 771573"/>
                <a:gd name="connsiteY85" fmla="*/ 2011 h 285887"/>
                <a:gd name="connsiteX86" fmla="*/ 268605 w 771573"/>
                <a:gd name="connsiteY86" fmla="*/ 9631 h 285887"/>
                <a:gd name="connsiteX87" fmla="*/ 226695 w 771573"/>
                <a:gd name="connsiteY87" fmla="*/ 26776 h 285887"/>
                <a:gd name="connsiteX88" fmla="*/ 182880 w 771573"/>
                <a:gd name="connsiteY88" fmla="*/ 53446 h 285887"/>
                <a:gd name="connsiteX89" fmla="*/ 123825 w 771573"/>
                <a:gd name="connsiteY89" fmla="*/ 95356 h 285887"/>
                <a:gd name="connsiteX90" fmla="*/ 87630 w 771573"/>
                <a:gd name="connsiteY90" fmla="*/ 125836 h 285887"/>
                <a:gd name="connsiteX91" fmla="*/ 55245 w 771573"/>
                <a:gd name="connsiteY91" fmla="*/ 158221 h 285887"/>
                <a:gd name="connsiteX92" fmla="*/ 20955 w 771573"/>
                <a:gd name="connsiteY92" fmla="*/ 203941 h 285887"/>
                <a:gd name="connsiteX93" fmla="*/ 0 w 771573"/>
                <a:gd name="connsiteY93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99060 w 771573"/>
                <a:gd name="connsiteY9" fmla="*/ 200131 h 285887"/>
                <a:gd name="connsiteX10" fmla="*/ 112386 w 771573"/>
                <a:gd name="connsiteY10" fmla="*/ 198946 h 285887"/>
                <a:gd name="connsiteX11" fmla="*/ 140970 w 771573"/>
                <a:gd name="connsiteY11" fmla="*/ 175366 h 285887"/>
                <a:gd name="connsiteX12" fmla="*/ 180975 w 771573"/>
                <a:gd name="connsiteY12" fmla="*/ 150601 h 285887"/>
                <a:gd name="connsiteX13" fmla="*/ 200025 w 771573"/>
                <a:gd name="connsiteY13" fmla="*/ 131551 h 285887"/>
                <a:gd name="connsiteX14" fmla="*/ 226695 w 771573"/>
                <a:gd name="connsiteY14" fmla="*/ 112501 h 285887"/>
                <a:gd name="connsiteX15" fmla="*/ 238125 w 771573"/>
                <a:gd name="connsiteY15" fmla="*/ 108691 h 285887"/>
                <a:gd name="connsiteX16" fmla="*/ 251460 w 771573"/>
                <a:gd name="connsiteY16" fmla="*/ 101071 h 285887"/>
                <a:gd name="connsiteX17" fmla="*/ 259080 w 771573"/>
                <a:gd name="connsiteY17" fmla="*/ 99166 h 285887"/>
                <a:gd name="connsiteX18" fmla="*/ 276225 w 771573"/>
                <a:gd name="connsiteY18" fmla="*/ 93451 h 285887"/>
                <a:gd name="connsiteX19" fmla="*/ 283845 w 771573"/>
                <a:gd name="connsiteY19" fmla="*/ 91546 h 285887"/>
                <a:gd name="connsiteX20" fmla="*/ 319563 w 771573"/>
                <a:gd name="connsiteY20" fmla="*/ 82846 h 285887"/>
                <a:gd name="connsiteX21" fmla="*/ 372425 w 771573"/>
                <a:gd name="connsiteY21" fmla="*/ 78470 h 285887"/>
                <a:gd name="connsiteX22" fmla="*/ 456259 w 771573"/>
                <a:gd name="connsiteY22" fmla="*/ 78263 h 285887"/>
                <a:gd name="connsiteX23" fmla="*/ 521970 w 771573"/>
                <a:gd name="connsiteY23" fmla="*/ 85831 h 285887"/>
                <a:gd name="connsiteX24" fmla="*/ 537210 w 771573"/>
                <a:gd name="connsiteY24" fmla="*/ 89641 h 285887"/>
                <a:gd name="connsiteX25" fmla="*/ 542925 w 771573"/>
                <a:gd name="connsiteY25" fmla="*/ 93451 h 285887"/>
                <a:gd name="connsiteX26" fmla="*/ 550545 w 771573"/>
                <a:gd name="connsiteY26" fmla="*/ 97261 h 285887"/>
                <a:gd name="connsiteX27" fmla="*/ 565785 w 771573"/>
                <a:gd name="connsiteY27" fmla="*/ 104881 h 285887"/>
                <a:gd name="connsiteX28" fmla="*/ 575310 w 771573"/>
                <a:gd name="connsiteY28" fmla="*/ 114406 h 285887"/>
                <a:gd name="connsiteX29" fmla="*/ 581025 w 771573"/>
                <a:gd name="connsiteY29" fmla="*/ 118216 h 285887"/>
                <a:gd name="connsiteX30" fmla="*/ 600075 w 771573"/>
                <a:gd name="connsiteY30" fmla="*/ 133456 h 285887"/>
                <a:gd name="connsiteX31" fmla="*/ 607695 w 771573"/>
                <a:gd name="connsiteY31" fmla="*/ 142981 h 285887"/>
                <a:gd name="connsiteX32" fmla="*/ 621030 w 771573"/>
                <a:gd name="connsiteY32" fmla="*/ 156316 h 285887"/>
                <a:gd name="connsiteX33" fmla="*/ 628650 w 771573"/>
                <a:gd name="connsiteY33" fmla="*/ 167746 h 285887"/>
                <a:gd name="connsiteX34" fmla="*/ 638175 w 771573"/>
                <a:gd name="connsiteY34" fmla="*/ 182986 h 285887"/>
                <a:gd name="connsiteX35" fmla="*/ 647700 w 771573"/>
                <a:gd name="connsiteY35" fmla="*/ 200131 h 285887"/>
                <a:gd name="connsiteX36" fmla="*/ 657225 w 771573"/>
                <a:gd name="connsiteY36" fmla="*/ 211561 h 285887"/>
                <a:gd name="connsiteX37" fmla="*/ 668655 w 771573"/>
                <a:gd name="connsiteY37" fmla="*/ 219181 h 285887"/>
                <a:gd name="connsiteX38" fmla="*/ 672465 w 771573"/>
                <a:gd name="connsiteY38" fmla="*/ 224896 h 285887"/>
                <a:gd name="connsiteX39" fmla="*/ 678180 w 771573"/>
                <a:gd name="connsiteY39" fmla="*/ 226801 h 285887"/>
                <a:gd name="connsiteX40" fmla="*/ 681990 w 771573"/>
                <a:gd name="connsiteY40" fmla="*/ 234421 h 285887"/>
                <a:gd name="connsiteX41" fmla="*/ 697230 w 771573"/>
                <a:gd name="connsiteY41" fmla="*/ 251566 h 285887"/>
                <a:gd name="connsiteX42" fmla="*/ 701040 w 771573"/>
                <a:gd name="connsiteY42" fmla="*/ 266806 h 285887"/>
                <a:gd name="connsiteX43" fmla="*/ 710565 w 771573"/>
                <a:gd name="connsiteY43" fmla="*/ 276331 h 285887"/>
                <a:gd name="connsiteX44" fmla="*/ 723900 w 771573"/>
                <a:gd name="connsiteY44" fmla="*/ 274426 h 285887"/>
                <a:gd name="connsiteX45" fmla="*/ 727710 w 771573"/>
                <a:gd name="connsiteY45" fmla="*/ 268711 h 285887"/>
                <a:gd name="connsiteX46" fmla="*/ 741045 w 771573"/>
                <a:gd name="connsiteY46" fmla="*/ 255376 h 285887"/>
                <a:gd name="connsiteX47" fmla="*/ 746760 w 771573"/>
                <a:gd name="connsiteY47" fmla="*/ 249661 h 285887"/>
                <a:gd name="connsiteX48" fmla="*/ 754380 w 771573"/>
                <a:gd name="connsiteY48" fmla="*/ 243946 h 285887"/>
                <a:gd name="connsiteX49" fmla="*/ 762000 w 771573"/>
                <a:gd name="connsiteY49" fmla="*/ 240136 h 285887"/>
                <a:gd name="connsiteX50" fmla="*/ 767715 w 771573"/>
                <a:gd name="connsiteY50" fmla="*/ 236326 h 285887"/>
                <a:gd name="connsiteX51" fmla="*/ 771525 w 771573"/>
                <a:gd name="connsiteY51" fmla="*/ 230611 h 285887"/>
                <a:gd name="connsiteX52" fmla="*/ 765810 w 771573"/>
                <a:gd name="connsiteY52" fmla="*/ 200131 h 285887"/>
                <a:gd name="connsiteX53" fmla="*/ 762000 w 771573"/>
                <a:gd name="connsiteY53" fmla="*/ 194416 h 285887"/>
                <a:gd name="connsiteX54" fmla="*/ 756285 w 771573"/>
                <a:gd name="connsiteY54" fmla="*/ 181081 h 285887"/>
                <a:gd name="connsiteX55" fmla="*/ 748665 w 771573"/>
                <a:gd name="connsiteY55" fmla="*/ 165841 h 285887"/>
                <a:gd name="connsiteX56" fmla="*/ 739140 w 771573"/>
                <a:gd name="connsiteY56" fmla="*/ 152506 h 285887"/>
                <a:gd name="connsiteX57" fmla="*/ 737235 w 771573"/>
                <a:gd name="connsiteY57" fmla="*/ 146791 h 285887"/>
                <a:gd name="connsiteX58" fmla="*/ 727710 w 771573"/>
                <a:gd name="connsiteY58" fmla="*/ 135361 h 285887"/>
                <a:gd name="connsiteX59" fmla="*/ 720090 w 771573"/>
                <a:gd name="connsiteY59" fmla="*/ 129646 h 285887"/>
                <a:gd name="connsiteX60" fmla="*/ 714375 w 771573"/>
                <a:gd name="connsiteY60" fmla="*/ 127741 h 285887"/>
                <a:gd name="connsiteX61" fmla="*/ 702945 w 771573"/>
                <a:gd name="connsiteY61" fmla="*/ 118216 h 285887"/>
                <a:gd name="connsiteX62" fmla="*/ 697230 w 771573"/>
                <a:gd name="connsiteY62" fmla="*/ 112501 h 285887"/>
                <a:gd name="connsiteX63" fmla="*/ 691515 w 771573"/>
                <a:gd name="connsiteY63" fmla="*/ 108691 h 285887"/>
                <a:gd name="connsiteX64" fmla="*/ 683895 w 771573"/>
                <a:gd name="connsiteY64" fmla="*/ 102976 h 285887"/>
                <a:gd name="connsiteX65" fmla="*/ 676275 w 771573"/>
                <a:gd name="connsiteY65" fmla="*/ 99166 h 285887"/>
                <a:gd name="connsiteX66" fmla="*/ 664845 w 771573"/>
                <a:gd name="connsiteY66" fmla="*/ 95356 h 285887"/>
                <a:gd name="connsiteX67" fmla="*/ 655320 w 771573"/>
                <a:gd name="connsiteY67" fmla="*/ 89641 h 285887"/>
                <a:gd name="connsiteX68" fmla="*/ 640080 w 771573"/>
                <a:gd name="connsiteY68" fmla="*/ 83926 h 285887"/>
                <a:gd name="connsiteX69" fmla="*/ 626745 w 771573"/>
                <a:gd name="connsiteY69" fmla="*/ 74401 h 285887"/>
                <a:gd name="connsiteX70" fmla="*/ 621030 w 771573"/>
                <a:gd name="connsiteY70" fmla="*/ 72496 h 285887"/>
                <a:gd name="connsiteX71" fmla="*/ 609600 w 771573"/>
                <a:gd name="connsiteY71" fmla="*/ 64876 h 285887"/>
                <a:gd name="connsiteX72" fmla="*/ 598170 w 771573"/>
                <a:gd name="connsiteY72" fmla="*/ 59161 h 285887"/>
                <a:gd name="connsiteX73" fmla="*/ 592455 w 771573"/>
                <a:gd name="connsiteY73" fmla="*/ 55351 h 285887"/>
                <a:gd name="connsiteX74" fmla="*/ 584835 w 771573"/>
                <a:gd name="connsiteY74" fmla="*/ 49636 h 285887"/>
                <a:gd name="connsiteX75" fmla="*/ 573405 w 771573"/>
                <a:gd name="connsiteY75" fmla="*/ 45826 h 285887"/>
                <a:gd name="connsiteX76" fmla="*/ 567690 w 771573"/>
                <a:gd name="connsiteY76" fmla="*/ 42016 h 285887"/>
                <a:gd name="connsiteX77" fmla="*/ 556260 w 771573"/>
                <a:gd name="connsiteY77" fmla="*/ 38206 h 285887"/>
                <a:gd name="connsiteX78" fmla="*/ 548640 w 771573"/>
                <a:gd name="connsiteY78" fmla="*/ 34396 h 285887"/>
                <a:gd name="connsiteX79" fmla="*/ 537210 w 771573"/>
                <a:gd name="connsiteY79" fmla="*/ 26776 h 285887"/>
                <a:gd name="connsiteX80" fmla="*/ 493395 w 771573"/>
                <a:gd name="connsiteY80" fmla="*/ 17251 h 285887"/>
                <a:gd name="connsiteX81" fmla="*/ 485775 w 771573"/>
                <a:gd name="connsiteY81" fmla="*/ 15346 h 285887"/>
                <a:gd name="connsiteX82" fmla="*/ 472440 w 771573"/>
                <a:gd name="connsiteY82" fmla="*/ 11536 h 285887"/>
                <a:gd name="connsiteX83" fmla="*/ 409575 w 771573"/>
                <a:gd name="connsiteY83" fmla="*/ 3916 h 285887"/>
                <a:gd name="connsiteX84" fmla="*/ 360045 w 771573"/>
                <a:gd name="connsiteY84" fmla="*/ 106 h 285887"/>
                <a:gd name="connsiteX85" fmla="*/ 300990 w 771573"/>
                <a:gd name="connsiteY85" fmla="*/ 2011 h 285887"/>
                <a:gd name="connsiteX86" fmla="*/ 268605 w 771573"/>
                <a:gd name="connsiteY86" fmla="*/ 9631 h 285887"/>
                <a:gd name="connsiteX87" fmla="*/ 226695 w 771573"/>
                <a:gd name="connsiteY87" fmla="*/ 26776 h 285887"/>
                <a:gd name="connsiteX88" fmla="*/ 182880 w 771573"/>
                <a:gd name="connsiteY88" fmla="*/ 53446 h 285887"/>
                <a:gd name="connsiteX89" fmla="*/ 123825 w 771573"/>
                <a:gd name="connsiteY89" fmla="*/ 95356 h 285887"/>
                <a:gd name="connsiteX90" fmla="*/ 87630 w 771573"/>
                <a:gd name="connsiteY90" fmla="*/ 125836 h 285887"/>
                <a:gd name="connsiteX91" fmla="*/ 55245 w 771573"/>
                <a:gd name="connsiteY91" fmla="*/ 158221 h 285887"/>
                <a:gd name="connsiteX92" fmla="*/ 20955 w 771573"/>
                <a:gd name="connsiteY92" fmla="*/ 203941 h 285887"/>
                <a:gd name="connsiteX93" fmla="*/ 0 w 771573"/>
                <a:gd name="connsiteY93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87630 w 771573"/>
                <a:gd name="connsiteY8" fmla="*/ 209656 h 285887"/>
                <a:gd name="connsiteX9" fmla="*/ 112386 w 771573"/>
                <a:gd name="connsiteY9" fmla="*/ 198946 h 285887"/>
                <a:gd name="connsiteX10" fmla="*/ 140970 w 771573"/>
                <a:gd name="connsiteY10" fmla="*/ 175366 h 285887"/>
                <a:gd name="connsiteX11" fmla="*/ 180975 w 771573"/>
                <a:gd name="connsiteY11" fmla="*/ 150601 h 285887"/>
                <a:gd name="connsiteX12" fmla="*/ 200025 w 771573"/>
                <a:gd name="connsiteY12" fmla="*/ 131551 h 285887"/>
                <a:gd name="connsiteX13" fmla="*/ 226695 w 771573"/>
                <a:gd name="connsiteY13" fmla="*/ 112501 h 285887"/>
                <a:gd name="connsiteX14" fmla="*/ 238125 w 771573"/>
                <a:gd name="connsiteY14" fmla="*/ 108691 h 285887"/>
                <a:gd name="connsiteX15" fmla="*/ 251460 w 771573"/>
                <a:gd name="connsiteY15" fmla="*/ 101071 h 285887"/>
                <a:gd name="connsiteX16" fmla="*/ 259080 w 771573"/>
                <a:gd name="connsiteY16" fmla="*/ 99166 h 285887"/>
                <a:gd name="connsiteX17" fmla="*/ 276225 w 771573"/>
                <a:gd name="connsiteY17" fmla="*/ 93451 h 285887"/>
                <a:gd name="connsiteX18" fmla="*/ 283845 w 771573"/>
                <a:gd name="connsiteY18" fmla="*/ 91546 h 285887"/>
                <a:gd name="connsiteX19" fmla="*/ 319563 w 771573"/>
                <a:gd name="connsiteY19" fmla="*/ 82846 h 285887"/>
                <a:gd name="connsiteX20" fmla="*/ 372425 w 771573"/>
                <a:gd name="connsiteY20" fmla="*/ 78470 h 285887"/>
                <a:gd name="connsiteX21" fmla="*/ 456259 w 771573"/>
                <a:gd name="connsiteY21" fmla="*/ 78263 h 285887"/>
                <a:gd name="connsiteX22" fmla="*/ 521970 w 771573"/>
                <a:gd name="connsiteY22" fmla="*/ 85831 h 285887"/>
                <a:gd name="connsiteX23" fmla="*/ 537210 w 771573"/>
                <a:gd name="connsiteY23" fmla="*/ 89641 h 285887"/>
                <a:gd name="connsiteX24" fmla="*/ 542925 w 771573"/>
                <a:gd name="connsiteY24" fmla="*/ 93451 h 285887"/>
                <a:gd name="connsiteX25" fmla="*/ 550545 w 771573"/>
                <a:gd name="connsiteY25" fmla="*/ 97261 h 285887"/>
                <a:gd name="connsiteX26" fmla="*/ 565785 w 771573"/>
                <a:gd name="connsiteY26" fmla="*/ 104881 h 285887"/>
                <a:gd name="connsiteX27" fmla="*/ 575310 w 771573"/>
                <a:gd name="connsiteY27" fmla="*/ 114406 h 285887"/>
                <a:gd name="connsiteX28" fmla="*/ 581025 w 771573"/>
                <a:gd name="connsiteY28" fmla="*/ 118216 h 285887"/>
                <a:gd name="connsiteX29" fmla="*/ 600075 w 771573"/>
                <a:gd name="connsiteY29" fmla="*/ 133456 h 285887"/>
                <a:gd name="connsiteX30" fmla="*/ 607695 w 771573"/>
                <a:gd name="connsiteY30" fmla="*/ 142981 h 285887"/>
                <a:gd name="connsiteX31" fmla="*/ 621030 w 771573"/>
                <a:gd name="connsiteY31" fmla="*/ 156316 h 285887"/>
                <a:gd name="connsiteX32" fmla="*/ 628650 w 771573"/>
                <a:gd name="connsiteY32" fmla="*/ 167746 h 285887"/>
                <a:gd name="connsiteX33" fmla="*/ 638175 w 771573"/>
                <a:gd name="connsiteY33" fmla="*/ 182986 h 285887"/>
                <a:gd name="connsiteX34" fmla="*/ 647700 w 771573"/>
                <a:gd name="connsiteY34" fmla="*/ 200131 h 285887"/>
                <a:gd name="connsiteX35" fmla="*/ 657225 w 771573"/>
                <a:gd name="connsiteY35" fmla="*/ 211561 h 285887"/>
                <a:gd name="connsiteX36" fmla="*/ 668655 w 771573"/>
                <a:gd name="connsiteY36" fmla="*/ 219181 h 285887"/>
                <a:gd name="connsiteX37" fmla="*/ 672465 w 771573"/>
                <a:gd name="connsiteY37" fmla="*/ 224896 h 285887"/>
                <a:gd name="connsiteX38" fmla="*/ 678180 w 771573"/>
                <a:gd name="connsiteY38" fmla="*/ 226801 h 285887"/>
                <a:gd name="connsiteX39" fmla="*/ 681990 w 771573"/>
                <a:gd name="connsiteY39" fmla="*/ 234421 h 285887"/>
                <a:gd name="connsiteX40" fmla="*/ 697230 w 771573"/>
                <a:gd name="connsiteY40" fmla="*/ 251566 h 285887"/>
                <a:gd name="connsiteX41" fmla="*/ 701040 w 771573"/>
                <a:gd name="connsiteY41" fmla="*/ 266806 h 285887"/>
                <a:gd name="connsiteX42" fmla="*/ 710565 w 771573"/>
                <a:gd name="connsiteY42" fmla="*/ 276331 h 285887"/>
                <a:gd name="connsiteX43" fmla="*/ 723900 w 771573"/>
                <a:gd name="connsiteY43" fmla="*/ 274426 h 285887"/>
                <a:gd name="connsiteX44" fmla="*/ 727710 w 771573"/>
                <a:gd name="connsiteY44" fmla="*/ 268711 h 285887"/>
                <a:gd name="connsiteX45" fmla="*/ 741045 w 771573"/>
                <a:gd name="connsiteY45" fmla="*/ 255376 h 285887"/>
                <a:gd name="connsiteX46" fmla="*/ 746760 w 771573"/>
                <a:gd name="connsiteY46" fmla="*/ 249661 h 285887"/>
                <a:gd name="connsiteX47" fmla="*/ 754380 w 771573"/>
                <a:gd name="connsiteY47" fmla="*/ 243946 h 285887"/>
                <a:gd name="connsiteX48" fmla="*/ 762000 w 771573"/>
                <a:gd name="connsiteY48" fmla="*/ 240136 h 285887"/>
                <a:gd name="connsiteX49" fmla="*/ 767715 w 771573"/>
                <a:gd name="connsiteY49" fmla="*/ 236326 h 285887"/>
                <a:gd name="connsiteX50" fmla="*/ 771525 w 771573"/>
                <a:gd name="connsiteY50" fmla="*/ 230611 h 285887"/>
                <a:gd name="connsiteX51" fmla="*/ 765810 w 771573"/>
                <a:gd name="connsiteY51" fmla="*/ 200131 h 285887"/>
                <a:gd name="connsiteX52" fmla="*/ 762000 w 771573"/>
                <a:gd name="connsiteY52" fmla="*/ 194416 h 285887"/>
                <a:gd name="connsiteX53" fmla="*/ 756285 w 771573"/>
                <a:gd name="connsiteY53" fmla="*/ 181081 h 285887"/>
                <a:gd name="connsiteX54" fmla="*/ 748665 w 771573"/>
                <a:gd name="connsiteY54" fmla="*/ 165841 h 285887"/>
                <a:gd name="connsiteX55" fmla="*/ 739140 w 771573"/>
                <a:gd name="connsiteY55" fmla="*/ 152506 h 285887"/>
                <a:gd name="connsiteX56" fmla="*/ 737235 w 771573"/>
                <a:gd name="connsiteY56" fmla="*/ 146791 h 285887"/>
                <a:gd name="connsiteX57" fmla="*/ 727710 w 771573"/>
                <a:gd name="connsiteY57" fmla="*/ 135361 h 285887"/>
                <a:gd name="connsiteX58" fmla="*/ 720090 w 771573"/>
                <a:gd name="connsiteY58" fmla="*/ 129646 h 285887"/>
                <a:gd name="connsiteX59" fmla="*/ 714375 w 771573"/>
                <a:gd name="connsiteY59" fmla="*/ 127741 h 285887"/>
                <a:gd name="connsiteX60" fmla="*/ 702945 w 771573"/>
                <a:gd name="connsiteY60" fmla="*/ 118216 h 285887"/>
                <a:gd name="connsiteX61" fmla="*/ 697230 w 771573"/>
                <a:gd name="connsiteY61" fmla="*/ 112501 h 285887"/>
                <a:gd name="connsiteX62" fmla="*/ 691515 w 771573"/>
                <a:gd name="connsiteY62" fmla="*/ 108691 h 285887"/>
                <a:gd name="connsiteX63" fmla="*/ 683895 w 771573"/>
                <a:gd name="connsiteY63" fmla="*/ 102976 h 285887"/>
                <a:gd name="connsiteX64" fmla="*/ 676275 w 771573"/>
                <a:gd name="connsiteY64" fmla="*/ 99166 h 285887"/>
                <a:gd name="connsiteX65" fmla="*/ 664845 w 771573"/>
                <a:gd name="connsiteY65" fmla="*/ 95356 h 285887"/>
                <a:gd name="connsiteX66" fmla="*/ 655320 w 771573"/>
                <a:gd name="connsiteY66" fmla="*/ 89641 h 285887"/>
                <a:gd name="connsiteX67" fmla="*/ 640080 w 771573"/>
                <a:gd name="connsiteY67" fmla="*/ 83926 h 285887"/>
                <a:gd name="connsiteX68" fmla="*/ 626745 w 771573"/>
                <a:gd name="connsiteY68" fmla="*/ 74401 h 285887"/>
                <a:gd name="connsiteX69" fmla="*/ 621030 w 771573"/>
                <a:gd name="connsiteY69" fmla="*/ 72496 h 285887"/>
                <a:gd name="connsiteX70" fmla="*/ 609600 w 771573"/>
                <a:gd name="connsiteY70" fmla="*/ 64876 h 285887"/>
                <a:gd name="connsiteX71" fmla="*/ 598170 w 771573"/>
                <a:gd name="connsiteY71" fmla="*/ 59161 h 285887"/>
                <a:gd name="connsiteX72" fmla="*/ 592455 w 771573"/>
                <a:gd name="connsiteY72" fmla="*/ 55351 h 285887"/>
                <a:gd name="connsiteX73" fmla="*/ 584835 w 771573"/>
                <a:gd name="connsiteY73" fmla="*/ 49636 h 285887"/>
                <a:gd name="connsiteX74" fmla="*/ 573405 w 771573"/>
                <a:gd name="connsiteY74" fmla="*/ 45826 h 285887"/>
                <a:gd name="connsiteX75" fmla="*/ 567690 w 771573"/>
                <a:gd name="connsiteY75" fmla="*/ 42016 h 285887"/>
                <a:gd name="connsiteX76" fmla="*/ 556260 w 771573"/>
                <a:gd name="connsiteY76" fmla="*/ 38206 h 285887"/>
                <a:gd name="connsiteX77" fmla="*/ 548640 w 771573"/>
                <a:gd name="connsiteY77" fmla="*/ 34396 h 285887"/>
                <a:gd name="connsiteX78" fmla="*/ 537210 w 771573"/>
                <a:gd name="connsiteY78" fmla="*/ 26776 h 285887"/>
                <a:gd name="connsiteX79" fmla="*/ 493395 w 771573"/>
                <a:gd name="connsiteY79" fmla="*/ 17251 h 285887"/>
                <a:gd name="connsiteX80" fmla="*/ 485775 w 771573"/>
                <a:gd name="connsiteY80" fmla="*/ 15346 h 285887"/>
                <a:gd name="connsiteX81" fmla="*/ 472440 w 771573"/>
                <a:gd name="connsiteY81" fmla="*/ 11536 h 285887"/>
                <a:gd name="connsiteX82" fmla="*/ 409575 w 771573"/>
                <a:gd name="connsiteY82" fmla="*/ 3916 h 285887"/>
                <a:gd name="connsiteX83" fmla="*/ 360045 w 771573"/>
                <a:gd name="connsiteY83" fmla="*/ 106 h 285887"/>
                <a:gd name="connsiteX84" fmla="*/ 300990 w 771573"/>
                <a:gd name="connsiteY84" fmla="*/ 2011 h 285887"/>
                <a:gd name="connsiteX85" fmla="*/ 268605 w 771573"/>
                <a:gd name="connsiteY85" fmla="*/ 9631 h 285887"/>
                <a:gd name="connsiteX86" fmla="*/ 226695 w 771573"/>
                <a:gd name="connsiteY86" fmla="*/ 26776 h 285887"/>
                <a:gd name="connsiteX87" fmla="*/ 182880 w 771573"/>
                <a:gd name="connsiteY87" fmla="*/ 53446 h 285887"/>
                <a:gd name="connsiteX88" fmla="*/ 123825 w 771573"/>
                <a:gd name="connsiteY88" fmla="*/ 95356 h 285887"/>
                <a:gd name="connsiteX89" fmla="*/ 87630 w 771573"/>
                <a:gd name="connsiteY89" fmla="*/ 125836 h 285887"/>
                <a:gd name="connsiteX90" fmla="*/ 55245 w 771573"/>
                <a:gd name="connsiteY90" fmla="*/ 158221 h 285887"/>
                <a:gd name="connsiteX91" fmla="*/ 20955 w 771573"/>
                <a:gd name="connsiteY91" fmla="*/ 203941 h 285887"/>
                <a:gd name="connsiteX92" fmla="*/ 0 w 771573"/>
                <a:gd name="connsiteY92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78105 w 771573"/>
                <a:gd name="connsiteY7" fmla="*/ 226801 h 285887"/>
                <a:gd name="connsiteX8" fmla="*/ 112386 w 771573"/>
                <a:gd name="connsiteY8" fmla="*/ 198946 h 285887"/>
                <a:gd name="connsiteX9" fmla="*/ 140970 w 771573"/>
                <a:gd name="connsiteY9" fmla="*/ 175366 h 285887"/>
                <a:gd name="connsiteX10" fmla="*/ 180975 w 771573"/>
                <a:gd name="connsiteY10" fmla="*/ 150601 h 285887"/>
                <a:gd name="connsiteX11" fmla="*/ 200025 w 771573"/>
                <a:gd name="connsiteY11" fmla="*/ 131551 h 285887"/>
                <a:gd name="connsiteX12" fmla="*/ 226695 w 771573"/>
                <a:gd name="connsiteY12" fmla="*/ 112501 h 285887"/>
                <a:gd name="connsiteX13" fmla="*/ 238125 w 771573"/>
                <a:gd name="connsiteY13" fmla="*/ 108691 h 285887"/>
                <a:gd name="connsiteX14" fmla="*/ 251460 w 771573"/>
                <a:gd name="connsiteY14" fmla="*/ 101071 h 285887"/>
                <a:gd name="connsiteX15" fmla="*/ 259080 w 771573"/>
                <a:gd name="connsiteY15" fmla="*/ 99166 h 285887"/>
                <a:gd name="connsiteX16" fmla="*/ 276225 w 771573"/>
                <a:gd name="connsiteY16" fmla="*/ 93451 h 285887"/>
                <a:gd name="connsiteX17" fmla="*/ 283845 w 771573"/>
                <a:gd name="connsiteY17" fmla="*/ 91546 h 285887"/>
                <a:gd name="connsiteX18" fmla="*/ 319563 w 771573"/>
                <a:gd name="connsiteY18" fmla="*/ 82846 h 285887"/>
                <a:gd name="connsiteX19" fmla="*/ 372425 w 771573"/>
                <a:gd name="connsiteY19" fmla="*/ 78470 h 285887"/>
                <a:gd name="connsiteX20" fmla="*/ 456259 w 771573"/>
                <a:gd name="connsiteY20" fmla="*/ 78263 h 285887"/>
                <a:gd name="connsiteX21" fmla="*/ 521970 w 771573"/>
                <a:gd name="connsiteY21" fmla="*/ 85831 h 285887"/>
                <a:gd name="connsiteX22" fmla="*/ 537210 w 771573"/>
                <a:gd name="connsiteY22" fmla="*/ 89641 h 285887"/>
                <a:gd name="connsiteX23" fmla="*/ 542925 w 771573"/>
                <a:gd name="connsiteY23" fmla="*/ 93451 h 285887"/>
                <a:gd name="connsiteX24" fmla="*/ 550545 w 771573"/>
                <a:gd name="connsiteY24" fmla="*/ 97261 h 285887"/>
                <a:gd name="connsiteX25" fmla="*/ 565785 w 771573"/>
                <a:gd name="connsiteY25" fmla="*/ 104881 h 285887"/>
                <a:gd name="connsiteX26" fmla="*/ 575310 w 771573"/>
                <a:gd name="connsiteY26" fmla="*/ 114406 h 285887"/>
                <a:gd name="connsiteX27" fmla="*/ 581025 w 771573"/>
                <a:gd name="connsiteY27" fmla="*/ 118216 h 285887"/>
                <a:gd name="connsiteX28" fmla="*/ 600075 w 771573"/>
                <a:gd name="connsiteY28" fmla="*/ 133456 h 285887"/>
                <a:gd name="connsiteX29" fmla="*/ 607695 w 771573"/>
                <a:gd name="connsiteY29" fmla="*/ 142981 h 285887"/>
                <a:gd name="connsiteX30" fmla="*/ 621030 w 771573"/>
                <a:gd name="connsiteY30" fmla="*/ 156316 h 285887"/>
                <a:gd name="connsiteX31" fmla="*/ 628650 w 771573"/>
                <a:gd name="connsiteY31" fmla="*/ 167746 h 285887"/>
                <a:gd name="connsiteX32" fmla="*/ 638175 w 771573"/>
                <a:gd name="connsiteY32" fmla="*/ 182986 h 285887"/>
                <a:gd name="connsiteX33" fmla="*/ 647700 w 771573"/>
                <a:gd name="connsiteY33" fmla="*/ 200131 h 285887"/>
                <a:gd name="connsiteX34" fmla="*/ 657225 w 771573"/>
                <a:gd name="connsiteY34" fmla="*/ 211561 h 285887"/>
                <a:gd name="connsiteX35" fmla="*/ 668655 w 771573"/>
                <a:gd name="connsiteY35" fmla="*/ 219181 h 285887"/>
                <a:gd name="connsiteX36" fmla="*/ 672465 w 771573"/>
                <a:gd name="connsiteY36" fmla="*/ 224896 h 285887"/>
                <a:gd name="connsiteX37" fmla="*/ 678180 w 771573"/>
                <a:gd name="connsiteY37" fmla="*/ 226801 h 285887"/>
                <a:gd name="connsiteX38" fmla="*/ 681990 w 771573"/>
                <a:gd name="connsiteY38" fmla="*/ 234421 h 285887"/>
                <a:gd name="connsiteX39" fmla="*/ 697230 w 771573"/>
                <a:gd name="connsiteY39" fmla="*/ 251566 h 285887"/>
                <a:gd name="connsiteX40" fmla="*/ 701040 w 771573"/>
                <a:gd name="connsiteY40" fmla="*/ 266806 h 285887"/>
                <a:gd name="connsiteX41" fmla="*/ 710565 w 771573"/>
                <a:gd name="connsiteY41" fmla="*/ 276331 h 285887"/>
                <a:gd name="connsiteX42" fmla="*/ 723900 w 771573"/>
                <a:gd name="connsiteY42" fmla="*/ 274426 h 285887"/>
                <a:gd name="connsiteX43" fmla="*/ 727710 w 771573"/>
                <a:gd name="connsiteY43" fmla="*/ 268711 h 285887"/>
                <a:gd name="connsiteX44" fmla="*/ 741045 w 771573"/>
                <a:gd name="connsiteY44" fmla="*/ 255376 h 285887"/>
                <a:gd name="connsiteX45" fmla="*/ 746760 w 771573"/>
                <a:gd name="connsiteY45" fmla="*/ 249661 h 285887"/>
                <a:gd name="connsiteX46" fmla="*/ 754380 w 771573"/>
                <a:gd name="connsiteY46" fmla="*/ 243946 h 285887"/>
                <a:gd name="connsiteX47" fmla="*/ 762000 w 771573"/>
                <a:gd name="connsiteY47" fmla="*/ 240136 h 285887"/>
                <a:gd name="connsiteX48" fmla="*/ 767715 w 771573"/>
                <a:gd name="connsiteY48" fmla="*/ 236326 h 285887"/>
                <a:gd name="connsiteX49" fmla="*/ 771525 w 771573"/>
                <a:gd name="connsiteY49" fmla="*/ 230611 h 285887"/>
                <a:gd name="connsiteX50" fmla="*/ 765810 w 771573"/>
                <a:gd name="connsiteY50" fmla="*/ 200131 h 285887"/>
                <a:gd name="connsiteX51" fmla="*/ 762000 w 771573"/>
                <a:gd name="connsiteY51" fmla="*/ 194416 h 285887"/>
                <a:gd name="connsiteX52" fmla="*/ 756285 w 771573"/>
                <a:gd name="connsiteY52" fmla="*/ 181081 h 285887"/>
                <a:gd name="connsiteX53" fmla="*/ 748665 w 771573"/>
                <a:gd name="connsiteY53" fmla="*/ 165841 h 285887"/>
                <a:gd name="connsiteX54" fmla="*/ 739140 w 771573"/>
                <a:gd name="connsiteY54" fmla="*/ 152506 h 285887"/>
                <a:gd name="connsiteX55" fmla="*/ 737235 w 771573"/>
                <a:gd name="connsiteY55" fmla="*/ 146791 h 285887"/>
                <a:gd name="connsiteX56" fmla="*/ 727710 w 771573"/>
                <a:gd name="connsiteY56" fmla="*/ 135361 h 285887"/>
                <a:gd name="connsiteX57" fmla="*/ 720090 w 771573"/>
                <a:gd name="connsiteY57" fmla="*/ 129646 h 285887"/>
                <a:gd name="connsiteX58" fmla="*/ 714375 w 771573"/>
                <a:gd name="connsiteY58" fmla="*/ 127741 h 285887"/>
                <a:gd name="connsiteX59" fmla="*/ 702945 w 771573"/>
                <a:gd name="connsiteY59" fmla="*/ 118216 h 285887"/>
                <a:gd name="connsiteX60" fmla="*/ 697230 w 771573"/>
                <a:gd name="connsiteY60" fmla="*/ 112501 h 285887"/>
                <a:gd name="connsiteX61" fmla="*/ 691515 w 771573"/>
                <a:gd name="connsiteY61" fmla="*/ 108691 h 285887"/>
                <a:gd name="connsiteX62" fmla="*/ 683895 w 771573"/>
                <a:gd name="connsiteY62" fmla="*/ 102976 h 285887"/>
                <a:gd name="connsiteX63" fmla="*/ 676275 w 771573"/>
                <a:gd name="connsiteY63" fmla="*/ 99166 h 285887"/>
                <a:gd name="connsiteX64" fmla="*/ 664845 w 771573"/>
                <a:gd name="connsiteY64" fmla="*/ 95356 h 285887"/>
                <a:gd name="connsiteX65" fmla="*/ 655320 w 771573"/>
                <a:gd name="connsiteY65" fmla="*/ 89641 h 285887"/>
                <a:gd name="connsiteX66" fmla="*/ 640080 w 771573"/>
                <a:gd name="connsiteY66" fmla="*/ 83926 h 285887"/>
                <a:gd name="connsiteX67" fmla="*/ 626745 w 771573"/>
                <a:gd name="connsiteY67" fmla="*/ 74401 h 285887"/>
                <a:gd name="connsiteX68" fmla="*/ 621030 w 771573"/>
                <a:gd name="connsiteY68" fmla="*/ 72496 h 285887"/>
                <a:gd name="connsiteX69" fmla="*/ 609600 w 771573"/>
                <a:gd name="connsiteY69" fmla="*/ 64876 h 285887"/>
                <a:gd name="connsiteX70" fmla="*/ 598170 w 771573"/>
                <a:gd name="connsiteY70" fmla="*/ 59161 h 285887"/>
                <a:gd name="connsiteX71" fmla="*/ 592455 w 771573"/>
                <a:gd name="connsiteY71" fmla="*/ 55351 h 285887"/>
                <a:gd name="connsiteX72" fmla="*/ 584835 w 771573"/>
                <a:gd name="connsiteY72" fmla="*/ 49636 h 285887"/>
                <a:gd name="connsiteX73" fmla="*/ 573405 w 771573"/>
                <a:gd name="connsiteY73" fmla="*/ 45826 h 285887"/>
                <a:gd name="connsiteX74" fmla="*/ 567690 w 771573"/>
                <a:gd name="connsiteY74" fmla="*/ 42016 h 285887"/>
                <a:gd name="connsiteX75" fmla="*/ 556260 w 771573"/>
                <a:gd name="connsiteY75" fmla="*/ 38206 h 285887"/>
                <a:gd name="connsiteX76" fmla="*/ 548640 w 771573"/>
                <a:gd name="connsiteY76" fmla="*/ 34396 h 285887"/>
                <a:gd name="connsiteX77" fmla="*/ 537210 w 771573"/>
                <a:gd name="connsiteY77" fmla="*/ 26776 h 285887"/>
                <a:gd name="connsiteX78" fmla="*/ 493395 w 771573"/>
                <a:gd name="connsiteY78" fmla="*/ 17251 h 285887"/>
                <a:gd name="connsiteX79" fmla="*/ 485775 w 771573"/>
                <a:gd name="connsiteY79" fmla="*/ 15346 h 285887"/>
                <a:gd name="connsiteX80" fmla="*/ 472440 w 771573"/>
                <a:gd name="connsiteY80" fmla="*/ 11536 h 285887"/>
                <a:gd name="connsiteX81" fmla="*/ 409575 w 771573"/>
                <a:gd name="connsiteY81" fmla="*/ 3916 h 285887"/>
                <a:gd name="connsiteX82" fmla="*/ 360045 w 771573"/>
                <a:gd name="connsiteY82" fmla="*/ 106 h 285887"/>
                <a:gd name="connsiteX83" fmla="*/ 300990 w 771573"/>
                <a:gd name="connsiteY83" fmla="*/ 2011 h 285887"/>
                <a:gd name="connsiteX84" fmla="*/ 268605 w 771573"/>
                <a:gd name="connsiteY84" fmla="*/ 9631 h 285887"/>
                <a:gd name="connsiteX85" fmla="*/ 226695 w 771573"/>
                <a:gd name="connsiteY85" fmla="*/ 26776 h 285887"/>
                <a:gd name="connsiteX86" fmla="*/ 182880 w 771573"/>
                <a:gd name="connsiteY86" fmla="*/ 53446 h 285887"/>
                <a:gd name="connsiteX87" fmla="*/ 123825 w 771573"/>
                <a:gd name="connsiteY87" fmla="*/ 95356 h 285887"/>
                <a:gd name="connsiteX88" fmla="*/ 87630 w 771573"/>
                <a:gd name="connsiteY88" fmla="*/ 125836 h 285887"/>
                <a:gd name="connsiteX89" fmla="*/ 55245 w 771573"/>
                <a:gd name="connsiteY89" fmla="*/ 158221 h 285887"/>
                <a:gd name="connsiteX90" fmla="*/ 20955 w 771573"/>
                <a:gd name="connsiteY90" fmla="*/ 203941 h 285887"/>
                <a:gd name="connsiteX91" fmla="*/ 0 w 771573"/>
                <a:gd name="connsiteY91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72390 w 771573"/>
                <a:gd name="connsiteY6" fmla="*/ 238231 h 285887"/>
                <a:gd name="connsiteX7" fmla="*/ 112386 w 771573"/>
                <a:gd name="connsiteY7" fmla="*/ 198946 h 285887"/>
                <a:gd name="connsiteX8" fmla="*/ 140970 w 771573"/>
                <a:gd name="connsiteY8" fmla="*/ 175366 h 285887"/>
                <a:gd name="connsiteX9" fmla="*/ 180975 w 771573"/>
                <a:gd name="connsiteY9" fmla="*/ 150601 h 285887"/>
                <a:gd name="connsiteX10" fmla="*/ 200025 w 771573"/>
                <a:gd name="connsiteY10" fmla="*/ 131551 h 285887"/>
                <a:gd name="connsiteX11" fmla="*/ 226695 w 771573"/>
                <a:gd name="connsiteY11" fmla="*/ 112501 h 285887"/>
                <a:gd name="connsiteX12" fmla="*/ 238125 w 771573"/>
                <a:gd name="connsiteY12" fmla="*/ 108691 h 285887"/>
                <a:gd name="connsiteX13" fmla="*/ 251460 w 771573"/>
                <a:gd name="connsiteY13" fmla="*/ 101071 h 285887"/>
                <a:gd name="connsiteX14" fmla="*/ 259080 w 771573"/>
                <a:gd name="connsiteY14" fmla="*/ 99166 h 285887"/>
                <a:gd name="connsiteX15" fmla="*/ 276225 w 771573"/>
                <a:gd name="connsiteY15" fmla="*/ 93451 h 285887"/>
                <a:gd name="connsiteX16" fmla="*/ 283845 w 771573"/>
                <a:gd name="connsiteY16" fmla="*/ 91546 h 285887"/>
                <a:gd name="connsiteX17" fmla="*/ 319563 w 771573"/>
                <a:gd name="connsiteY17" fmla="*/ 82846 h 285887"/>
                <a:gd name="connsiteX18" fmla="*/ 372425 w 771573"/>
                <a:gd name="connsiteY18" fmla="*/ 78470 h 285887"/>
                <a:gd name="connsiteX19" fmla="*/ 456259 w 771573"/>
                <a:gd name="connsiteY19" fmla="*/ 78263 h 285887"/>
                <a:gd name="connsiteX20" fmla="*/ 521970 w 771573"/>
                <a:gd name="connsiteY20" fmla="*/ 85831 h 285887"/>
                <a:gd name="connsiteX21" fmla="*/ 537210 w 771573"/>
                <a:gd name="connsiteY21" fmla="*/ 89641 h 285887"/>
                <a:gd name="connsiteX22" fmla="*/ 542925 w 771573"/>
                <a:gd name="connsiteY22" fmla="*/ 93451 h 285887"/>
                <a:gd name="connsiteX23" fmla="*/ 550545 w 771573"/>
                <a:gd name="connsiteY23" fmla="*/ 97261 h 285887"/>
                <a:gd name="connsiteX24" fmla="*/ 565785 w 771573"/>
                <a:gd name="connsiteY24" fmla="*/ 104881 h 285887"/>
                <a:gd name="connsiteX25" fmla="*/ 575310 w 771573"/>
                <a:gd name="connsiteY25" fmla="*/ 114406 h 285887"/>
                <a:gd name="connsiteX26" fmla="*/ 581025 w 771573"/>
                <a:gd name="connsiteY26" fmla="*/ 118216 h 285887"/>
                <a:gd name="connsiteX27" fmla="*/ 600075 w 771573"/>
                <a:gd name="connsiteY27" fmla="*/ 133456 h 285887"/>
                <a:gd name="connsiteX28" fmla="*/ 607695 w 771573"/>
                <a:gd name="connsiteY28" fmla="*/ 142981 h 285887"/>
                <a:gd name="connsiteX29" fmla="*/ 621030 w 771573"/>
                <a:gd name="connsiteY29" fmla="*/ 156316 h 285887"/>
                <a:gd name="connsiteX30" fmla="*/ 628650 w 771573"/>
                <a:gd name="connsiteY30" fmla="*/ 167746 h 285887"/>
                <a:gd name="connsiteX31" fmla="*/ 638175 w 771573"/>
                <a:gd name="connsiteY31" fmla="*/ 182986 h 285887"/>
                <a:gd name="connsiteX32" fmla="*/ 647700 w 771573"/>
                <a:gd name="connsiteY32" fmla="*/ 200131 h 285887"/>
                <a:gd name="connsiteX33" fmla="*/ 657225 w 771573"/>
                <a:gd name="connsiteY33" fmla="*/ 211561 h 285887"/>
                <a:gd name="connsiteX34" fmla="*/ 668655 w 771573"/>
                <a:gd name="connsiteY34" fmla="*/ 219181 h 285887"/>
                <a:gd name="connsiteX35" fmla="*/ 672465 w 771573"/>
                <a:gd name="connsiteY35" fmla="*/ 224896 h 285887"/>
                <a:gd name="connsiteX36" fmla="*/ 678180 w 771573"/>
                <a:gd name="connsiteY36" fmla="*/ 226801 h 285887"/>
                <a:gd name="connsiteX37" fmla="*/ 681990 w 771573"/>
                <a:gd name="connsiteY37" fmla="*/ 234421 h 285887"/>
                <a:gd name="connsiteX38" fmla="*/ 697230 w 771573"/>
                <a:gd name="connsiteY38" fmla="*/ 251566 h 285887"/>
                <a:gd name="connsiteX39" fmla="*/ 701040 w 771573"/>
                <a:gd name="connsiteY39" fmla="*/ 266806 h 285887"/>
                <a:gd name="connsiteX40" fmla="*/ 710565 w 771573"/>
                <a:gd name="connsiteY40" fmla="*/ 276331 h 285887"/>
                <a:gd name="connsiteX41" fmla="*/ 723900 w 771573"/>
                <a:gd name="connsiteY41" fmla="*/ 274426 h 285887"/>
                <a:gd name="connsiteX42" fmla="*/ 727710 w 771573"/>
                <a:gd name="connsiteY42" fmla="*/ 268711 h 285887"/>
                <a:gd name="connsiteX43" fmla="*/ 741045 w 771573"/>
                <a:gd name="connsiteY43" fmla="*/ 255376 h 285887"/>
                <a:gd name="connsiteX44" fmla="*/ 746760 w 771573"/>
                <a:gd name="connsiteY44" fmla="*/ 249661 h 285887"/>
                <a:gd name="connsiteX45" fmla="*/ 754380 w 771573"/>
                <a:gd name="connsiteY45" fmla="*/ 243946 h 285887"/>
                <a:gd name="connsiteX46" fmla="*/ 762000 w 771573"/>
                <a:gd name="connsiteY46" fmla="*/ 240136 h 285887"/>
                <a:gd name="connsiteX47" fmla="*/ 767715 w 771573"/>
                <a:gd name="connsiteY47" fmla="*/ 236326 h 285887"/>
                <a:gd name="connsiteX48" fmla="*/ 771525 w 771573"/>
                <a:gd name="connsiteY48" fmla="*/ 230611 h 285887"/>
                <a:gd name="connsiteX49" fmla="*/ 765810 w 771573"/>
                <a:gd name="connsiteY49" fmla="*/ 200131 h 285887"/>
                <a:gd name="connsiteX50" fmla="*/ 762000 w 771573"/>
                <a:gd name="connsiteY50" fmla="*/ 194416 h 285887"/>
                <a:gd name="connsiteX51" fmla="*/ 756285 w 771573"/>
                <a:gd name="connsiteY51" fmla="*/ 181081 h 285887"/>
                <a:gd name="connsiteX52" fmla="*/ 748665 w 771573"/>
                <a:gd name="connsiteY52" fmla="*/ 165841 h 285887"/>
                <a:gd name="connsiteX53" fmla="*/ 739140 w 771573"/>
                <a:gd name="connsiteY53" fmla="*/ 152506 h 285887"/>
                <a:gd name="connsiteX54" fmla="*/ 737235 w 771573"/>
                <a:gd name="connsiteY54" fmla="*/ 146791 h 285887"/>
                <a:gd name="connsiteX55" fmla="*/ 727710 w 771573"/>
                <a:gd name="connsiteY55" fmla="*/ 135361 h 285887"/>
                <a:gd name="connsiteX56" fmla="*/ 720090 w 771573"/>
                <a:gd name="connsiteY56" fmla="*/ 129646 h 285887"/>
                <a:gd name="connsiteX57" fmla="*/ 714375 w 771573"/>
                <a:gd name="connsiteY57" fmla="*/ 127741 h 285887"/>
                <a:gd name="connsiteX58" fmla="*/ 702945 w 771573"/>
                <a:gd name="connsiteY58" fmla="*/ 118216 h 285887"/>
                <a:gd name="connsiteX59" fmla="*/ 697230 w 771573"/>
                <a:gd name="connsiteY59" fmla="*/ 112501 h 285887"/>
                <a:gd name="connsiteX60" fmla="*/ 691515 w 771573"/>
                <a:gd name="connsiteY60" fmla="*/ 108691 h 285887"/>
                <a:gd name="connsiteX61" fmla="*/ 683895 w 771573"/>
                <a:gd name="connsiteY61" fmla="*/ 102976 h 285887"/>
                <a:gd name="connsiteX62" fmla="*/ 676275 w 771573"/>
                <a:gd name="connsiteY62" fmla="*/ 99166 h 285887"/>
                <a:gd name="connsiteX63" fmla="*/ 664845 w 771573"/>
                <a:gd name="connsiteY63" fmla="*/ 95356 h 285887"/>
                <a:gd name="connsiteX64" fmla="*/ 655320 w 771573"/>
                <a:gd name="connsiteY64" fmla="*/ 89641 h 285887"/>
                <a:gd name="connsiteX65" fmla="*/ 640080 w 771573"/>
                <a:gd name="connsiteY65" fmla="*/ 83926 h 285887"/>
                <a:gd name="connsiteX66" fmla="*/ 626745 w 771573"/>
                <a:gd name="connsiteY66" fmla="*/ 74401 h 285887"/>
                <a:gd name="connsiteX67" fmla="*/ 621030 w 771573"/>
                <a:gd name="connsiteY67" fmla="*/ 72496 h 285887"/>
                <a:gd name="connsiteX68" fmla="*/ 609600 w 771573"/>
                <a:gd name="connsiteY68" fmla="*/ 64876 h 285887"/>
                <a:gd name="connsiteX69" fmla="*/ 598170 w 771573"/>
                <a:gd name="connsiteY69" fmla="*/ 59161 h 285887"/>
                <a:gd name="connsiteX70" fmla="*/ 592455 w 771573"/>
                <a:gd name="connsiteY70" fmla="*/ 55351 h 285887"/>
                <a:gd name="connsiteX71" fmla="*/ 584835 w 771573"/>
                <a:gd name="connsiteY71" fmla="*/ 49636 h 285887"/>
                <a:gd name="connsiteX72" fmla="*/ 573405 w 771573"/>
                <a:gd name="connsiteY72" fmla="*/ 45826 h 285887"/>
                <a:gd name="connsiteX73" fmla="*/ 567690 w 771573"/>
                <a:gd name="connsiteY73" fmla="*/ 42016 h 285887"/>
                <a:gd name="connsiteX74" fmla="*/ 556260 w 771573"/>
                <a:gd name="connsiteY74" fmla="*/ 38206 h 285887"/>
                <a:gd name="connsiteX75" fmla="*/ 548640 w 771573"/>
                <a:gd name="connsiteY75" fmla="*/ 34396 h 285887"/>
                <a:gd name="connsiteX76" fmla="*/ 537210 w 771573"/>
                <a:gd name="connsiteY76" fmla="*/ 26776 h 285887"/>
                <a:gd name="connsiteX77" fmla="*/ 493395 w 771573"/>
                <a:gd name="connsiteY77" fmla="*/ 17251 h 285887"/>
                <a:gd name="connsiteX78" fmla="*/ 485775 w 771573"/>
                <a:gd name="connsiteY78" fmla="*/ 15346 h 285887"/>
                <a:gd name="connsiteX79" fmla="*/ 472440 w 771573"/>
                <a:gd name="connsiteY79" fmla="*/ 11536 h 285887"/>
                <a:gd name="connsiteX80" fmla="*/ 409575 w 771573"/>
                <a:gd name="connsiteY80" fmla="*/ 3916 h 285887"/>
                <a:gd name="connsiteX81" fmla="*/ 360045 w 771573"/>
                <a:gd name="connsiteY81" fmla="*/ 106 h 285887"/>
                <a:gd name="connsiteX82" fmla="*/ 300990 w 771573"/>
                <a:gd name="connsiteY82" fmla="*/ 2011 h 285887"/>
                <a:gd name="connsiteX83" fmla="*/ 268605 w 771573"/>
                <a:gd name="connsiteY83" fmla="*/ 9631 h 285887"/>
                <a:gd name="connsiteX84" fmla="*/ 226695 w 771573"/>
                <a:gd name="connsiteY84" fmla="*/ 26776 h 285887"/>
                <a:gd name="connsiteX85" fmla="*/ 182880 w 771573"/>
                <a:gd name="connsiteY85" fmla="*/ 53446 h 285887"/>
                <a:gd name="connsiteX86" fmla="*/ 123825 w 771573"/>
                <a:gd name="connsiteY86" fmla="*/ 95356 h 285887"/>
                <a:gd name="connsiteX87" fmla="*/ 87630 w 771573"/>
                <a:gd name="connsiteY87" fmla="*/ 125836 h 285887"/>
                <a:gd name="connsiteX88" fmla="*/ 55245 w 771573"/>
                <a:gd name="connsiteY88" fmla="*/ 158221 h 285887"/>
                <a:gd name="connsiteX89" fmla="*/ 20955 w 771573"/>
                <a:gd name="connsiteY89" fmla="*/ 203941 h 285887"/>
                <a:gd name="connsiteX90" fmla="*/ 0 w 771573"/>
                <a:gd name="connsiteY90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62865 w 771573"/>
                <a:gd name="connsiteY5" fmla="*/ 251566 h 285887"/>
                <a:gd name="connsiteX6" fmla="*/ 112386 w 771573"/>
                <a:gd name="connsiteY6" fmla="*/ 198946 h 285887"/>
                <a:gd name="connsiteX7" fmla="*/ 140970 w 771573"/>
                <a:gd name="connsiteY7" fmla="*/ 175366 h 285887"/>
                <a:gd name="connsiteX8" fmla="*/ 180975 w 771573"/>
                <a:gd name="connsiteY8" fmla="*/ 150601 h 285887"/>
                <a:gd name="connsiteX9" fmla="*/ 200025 w 771573"/>
                <a:gd name="connsiteY9" fmla="*/ 131551 h 285887"/>
                <a:gd name="connsiteX10" fmla="*/ 226695 w 771573"/>
                <a:gd name="connsiteY10" fmla="*/ 112501 h 285887"/>
                <a:gd name="connsiteX11" fmla="*/ 238125 w 771573"/>
                <a:gd name="connsiteY11" fmla="*/ 108691 h 285887"/>
                <a:gd name="connsiteX12" fmla="*/ 251460 w 771573"/>
                <a:gd name="connsiteY12" fmla="*/ 101071 h 285887"/>
                <a:gd name="connsiteX13" fmla="*/ 259080 w 771573"/>
                <a:gd name="connsiteY13" fmla="*/ 99166 h 285887"/>
                <a:gd name="connsiteX14" fmla="*/ 276225 w 771573"/>
                <a:gd name="connsiteY14" fmla="*/ 93451 h 285887"/>
                <a:gd name="connsiteX15" fmla="*/ 283845 w 771573"/>
                <a:gd name="connsiteY15" fmla="*/ 91546 h 285887"/>
                <a:gd name="connsiteX16" fmla="*/ 319563 w 771573"/>
                <a:gd name="connsiteY16" fmla="*/ 82846 h 285887"/>
                <a:gd name="connsiteX17" fmla="*/ 372425 w 771573"/>
                <a:gd name="connsiteY17" fmla="*/ 78470 h 285887"/>
                <a:gd name="connsiteX18" fmla="*/ 456259 w 771573"/>
                <a:gd name="connsiteY18" fmla="*/ 78263 h 285887"/>
                <a:gd name="connsiteX19" fmla="*/ 521970 w 771573"/>
                <a:gd name="connsiteY19" fmla="*/ 85831 h 285887"/>
                <a:gd name="connsiteX20" fmla="*/ 537210 w 771573"/>
                <a:gd name="connsiteY20" fmla="*/ 89641 h 285887"/>
                <a:gd name="connsiteX21" fmla="*/ 542925 w 771573"/>
                <a:gd name="connsiteY21" fmla="*/ 93451 h 285887"/>
                <a:gd name="connsiteX22" fmla="*/ 550545 w 771573"/>
                <a:gd name="connsiteY22" fmla="*/ 97261 h 285887"/>
                <a:gd name="connsiteX23" fmla="*/ 565785 w 771573"/>
                <a:gd name="connsiteY23" fmla="*/ 104881 h 285887"/>
                <a:gd name="connsiteX24" fmla="*/ 575310 w 771573"/>
                <a:gd name="connsiteY24" fmla="*/ 114406 h 285887"/>
                <a:gd name="connsiteX25" fmla="*/ 581025 w 771573"/>
                <a:gd name="connsiteY25" fmla="*/ 118216 h 285887"/>
                <a:gd name="connsiteX26" fmla="*/ 600075 w 771573"/>
                <a:gd name="connsiteY26" fmla="*/ 133456 h 285887"/>
                <a:gd name="connsiteX27" fmla="*/ 607695 w 771573"/>
                <a:gd name="connsiteY27" fmla="*/ 142981 h 285887"/>
                <a:gd name="connsiteX28" fmla="*/ 621030 w 771573"/>
                <a:gd name="connsiteY28" fmla="*/ 156316 h 285887"/>
                <a:gd name="connsiteX29" fmla="*/ 628650 w 771573"/>
                <a:gd name="connsiteY29" fmla="*/ 167746 h 285887"/>
                <a:gd name="connsiteX30" fmla="*/ 638175 w 771573"/>
                <a:gd name="connsiteY30" fmla="*/ 182986 h 285887"/>
                <a:gd name="connsiteX31" fmla="*/ 647700 w 771573"/>
                <a:gd name="connsiteY31" fmla="*/ 200131 h 285887"/>
                <a:gd name="connsiteX32" fmla="*/ 657225 w 771573"/>
                <a:gd name="connsiteY32" fmla="*/ 211561 h 285887"/>
                <a:gd name="connsiteX33" fmla="*/ 668655 w 771573"/>
                <a:gd name="connsiteY33" fmla="*/ 219181 h 285887"/>
                <a:gd name="connsiteX34" fmla="*/ 672465 w 771573"/>
                <a:gd name="connsiteY34" fmla="*/ 224896 h 285887"/>
                <a:gd name="connsiteX35" fmla="*/ 678180 w 771573"/>
                <a:gd name="connsiteY35" fmla="*/ 226801 h 285887"/>
                <a:gd name="connsiteX36" fmla="*/ 681990 w 771573"/>
                <a:gd name="connsiteY36" fmla="*/ 234421 h 285887"/>
                <a:gd name="connsiteX37" fmla="*/ 697230 w 771573"/>
                <a:gd name="connsiteY37" fmla="*/ 251566 h 285887"/>
                <a:gd name="connsiteX38" fmla="*/ 701040 w 771573"/>
                <a:gd name="connsiteY38" fmla="*/ 266806 h 285887"/>
                <a:gd name="connsiteX39" fmla="*/ 710565 w 771573"/>
                <a:gd name="connsiteY39" fmla="*/ 276331 h 285887"/>
                <a:gd name="connsiteX40" fmla="*/ 723900 w 771573"/>
                <a:gd name="connsiteY40" fmla="*/ 274426 h 285887"/>
                <a:gd name="connsiteX41" fmla="*/ 727710 w 771573"/>
                <a:gd name="connsiteY41" fmla="*/ 268711 h 285887"/>
                <a:gd name="connsiteX42" fmla="*/ 741045 w 771573"/>
                <a:gd name="connsiteY42" fmla="*/ 255376 h 285887"/>
                <a:gd name="connsiteX43" fmla="*/ 746760 w 771573"/>
                <a:gd name="connsiteY43" fmla="*/ 249661 h 285887"/>
                <a:gd name="connsiteX44" fmla="*/ 754380 w 771573"/>
                <a:gd name="connsiteY44" fmla="*/ 243946 h 285887"/>
                <a:gd name="connsiteX45" fmla="*/ 762000 w 771573"/>
                <a:gd name="connsiteY45" fmla="*/ 240136 h 285887"/>
                <a:gd name="connsiteX46" fmla="*/ 767715 w 771573"/>
                <a:gd name="connsiteY46" fmla="*/ 236326 h 285887"/>
                <a:gd name="connsiteX47" fmla="*/ 771525 w 771573"/>
                <a:gd name="connsiteY47" fmla="*/ 230611 h 285887"/>
                <a:gd name="connsiteX48" fmla="*/ 765810 w 771573"/>
                <a:gd name="connsiteY48" fmla="*/ 200131 h 285887"/>
                <a:gd name="connsiteX49" fmla="*/ 762000 w 771573"/>
                <a:gd name="connsiteY49" fmla="*/ 194416 h 285887"/>
                <a:gd name="connsiteX50" fmla="*/ 756285 w 771573"/>
                <a:gd name="connsiteY50" fmla="*/ 181081 h 285887"/>
                <a:gd name="connsiteX51" fmla="*/ 748665 w 771573"/>
                <a:gd name="connsiteY51" fmla="*/ 165841 h 285887"/>
                <a:gd name="connsiteX52" fmla="*/ 739140 w 771573"/>
                <a:gd name="connsiteY52" fmla="*/ 152506 h 285887"/>
                <a:gd name="connsiteX53" fmla="*/ 737235 w 771573"/>
                <a:gd name="connsiteY53" fmla="*/ 146791 h 285887"/>
                <a:gd name="connsiteX54" fmla="*/ 727710 w 771573"/>
                <a:gd name="connsiteY54" fmla="*/ 135361 h 285887"/>
                <a:gd name="connsiteX55" fmla="*/ 720090 w 771573"/>
                <a:gd name="connsiteY55" fmla="*/ 129646 h 285887"/>
                <a:gd name="connsiteX56" fmla="*/ 714375 w 771573"/>
                <a:gd name="connsiteY56" fmla="*/ 127741 h 285887"/>
                <a:gd name="connsiteX57" fmla="*/ 702945 w 771573"/>
                <a:gd name="connsiteY57" fmla="*/ 118216 h 285887"/>
                <a:gd name="connsiteX58" fmla="*/ 697230 w 771573"/>
                <a:gd name="connsiteY58" fmla="*/ 112501 h 285887"/>
                <a:gd name="connsiteX59" fmla="*/ 691515 w 771573"/>
                <a:gd name="connsiteY59" fmla="*/ 108691 h 285887"/>
                <a:gd name="connsiteX60" fmla="*/ 683895 w 771573"/>
                <a:gd name="connsiteY60" fmla="*/ 102976 h 285887"/>
                <a:gd name="connsiteX61" fmla="*/ 676275 w 771573"/>
                <a:gd name="connsiteY61" fmla="*/ 99166 h 285887"/>
                <a:gd name="connsiteX62" fmla="*/ 664845 w 771573"/>
                <a:gd name="connsiteY62" fmla="*/ 95356 h 285887"/>
                <a:gd name="connsiteX63" fmla="*/ 655320 w 771573"/>
                <a:gd name="connsiteY63" fmla="*/ 89641 h 285887"/>
                <a:gd name="connsiteX64" fmla="*/ 640080 w 771573"/>
                <a:gd name="connsiteY64" fmla="*/ 83926 h 285887"/>
                <a:gd name="connsiteX65" fmla="*/ 626745 w 771573"/>
                <a:gd name="connsiteY65" fmla="*/ 74401 h 285887"/>
                <a:gd name="connsiteX66" fmla="*/ 621030 w 771573"/>
                <a:gd name="connsiteY66" fmla="*/ 72496 h 285887"/>
                <a:gd name="connsiteX67" fmla="*/ 609600 w 771573"/>
                <a:gd name="connsiteY67" fmla="*/ 64876 h 285887"/>
                <a:gd name="connsiteX68" fmla="*/ 598170 w 771573"/>
                <a:gd name="connsiteY68" fmla="*/ 59161 h 285887"/>
                <a:gd name="connsiteX69" fmla="*/ 592455 w 771573"/>
                <a:gd name="connsiteY69" fmla="*/ 55351 h 285887"/>
                <a:gd name="connsiteX70" fmla="*/ 584835 w 771573"/>
                <a:gd name="connsiteY70" fmla="*/ 49636 h 285887"/>
                <a:gd name="connsiteX71" fmla="*/ 573405 w 771573"/>
                <a:gd name="connsiteY71" fmla="*/ 45826 h 285887"/>
                <a:gd name="connsiteX72" fmla="*/ 567690 w 771573"/>
                <a:gd name="connsiteY72" fmla="*/ 42016 h 285887"/>
                <a:gd name="connsiteX73" fmla="*/ 556260 w 771573"/>
                <a:gd name="connsiteY73" fmla="*/ 38206 h 285887"/>
                <a:gd name="connsiteX74" fmla="*/ 548640 w 771573"/>
                <a:gd name="connsiteY74" fmla="*/ 34396 h 285887"/>
                <a:gd name="connsiteX75" fmla="*/ 537210 w 771573"/>
                <a:gd name="connsiteY75" fmla="*/ 26776 h 285887"/>
                <a:gd name="connsiteX76" fmla="*/ 493395 w 771573"/>
                <a:gd name="connsiteY76" fmla="*/ 17251 h 285887"/>
                <a:gd name="connsiteX77" fmla="*/ 485775 w 771573"/>
                <a:gd name="connsiteY77" fmla="*/ 15346 h 285887"/>
                <a:gd name="connsiteX78" fmla="*/ 472440 w 771573"/>
                <a:gd name="connsiteY78" fmla="*/ 11536 h 285887"/>
                <a:gd name="connsiteX79" fmla="*/ 409575 w 771573"/>
                <a:gd name="connsiteY79" fmla="*/ 3916 h 285887"/>
                <a:gd name="connsiteX80" fmla="*/ 360045 w 771573"/>
                <a:gd name="connsiteY80" fmla="*/ 106 h 285887"/>
                <a:gd name="connsiteX81" fmla="*/ 300990 w 771573"/>
                <a:gd name="connsiteY81" fmla="*/ 2011 h 285887"/>
                <a:gd name="connsiteX82" fmla="*/ 268605 w 771573"/>
                <a:gd name="connsiteY82" fmla="*/ 9631 h 285887"/>
                <a:gd name="connsiteX83" fmla="*/ 226695 w 771573"/>
                <a:gd name="connsiteY83" fmla="*/ 26776 h 285887"/>
                <a:gd name="connsiteX84" fmla="*/ 182880 w 771573"/>
                <a:gd name="connsiteY84" fmla="*/ 53446 h 285887"/>
                <a:gd name="connsiteX85" fmla="*/ 123825 w 771573"/>
                <a:gd name="connsiteY85" fmla="*/ 95356 h 285887"/>
                <a:gd name="connsiteX86" fmla="*/ 87630 w 771573"/>
                <a:gd name="connsiteY86" fmla="*/ 125836 h 285887"/>
                <a:gd name="connsiteX87" fmla="*/ 55245 w 771573"/>
                <a:gd name="connsiteY87" fmla="*/ 158221 h 285887"/>
                <a:gd name="connsiteX88" fmla="*/ 20955 w 771573"/>
                <a:gd name="connsiteY88" fmla="*/ 203941 h 285887"/>
                <a:gd name="connsiteX89" fmla="*/ 0 w 771573"/>
                <a:gd name="connsiteY89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60960 w 771573"/>
                <a:gd name="connsiteY4" fmla="*/ 257281 h 285887"/>
                <a:gd name="connsiteX5" fmla="*/ 112386 w 771573"/>
                <a:gd name="connsiteY5" fmla="*/ 198946 h 285887"/>
                <a:gd name="connsiteX6" fmla="*/ 140970 w 771573"/>
                <a:gd name="connsiteY6" fmla="*/ 175366 h 285887"/>
                <a:gd name="connsiteX7" fmla="*/ 180975 w 771573"/>
                <a:gd name="connsiteY7" fmla="*/ 150601 h 285887"/>
                <a:gd name="connsiteX8" fmla="*/ 200025 w 771573"/>
                <a:gd name="connsiteY8" fmla="*/ 131551 h 285887"/>
                <a:gd name="connsiteX9" fmla="*/ 226695 w 771573"/>
                <a:gd name="connsiteY9" fmla="*/ 112501 h 285887"/>
                <a:gd name="connsiteX10" fmla="*/ 238125 w 771573"/>
                <a:gd name="connsiteY10" fmla="*/ 108691 h 285887"/>
                <a:gd name="connsiteX11" fmla="*/ 251460 w 771573"/>
                <a:gd name="connsiteY11" fmla="*/ 101071 h 285887"/>
                <a:gd name="connsiteX12" fmla="*/ 259080 w 771573"/>
                <a:gd name="connsiteY12" fmla="*/ 99166 h 285887"/>
                <a:gd name="connsiteX13" fmla="*/ 276225 w 771573"/>
                <a:gd name="connsiteY13" fmla="*/ 93451 h 285887"/>
                <a:gd name="connsiteX14" fmla="*/ 283845 w 771573"/>
                <a:gd name="connsiteY14" fmla="*/ 91546 h 285887"/>
                <a:gd name="connsiteX15" fmla="*/ 319563 w 771573"/>
                <a:gd name="connsiteY15" fmla="*/ 82846 h 285887"/>
                <a:gd name="connsiteX16" fmla="*/ 372425 w 771573"/>
                <a:gd name="connsiteY16" fmla="*/ 78470 h 285887"/>
                <a:gd name="connsiteX17" fmla="*/ 456259 w 771573"/>
                <a:gd name="connsiteY17" fmla="*/ 78263 h 285887"/>
                <a:gd name="connsiteX18" fmla="*/ 521970 w 771573"/>
                <a:gd name="connsiteY18" fmla="*/ 85831 h 285887"/>
                <a:gd name="connsiteX19" fmla="*/ 537210 w 771573"/>
                <a:gd name="connsiteY19" fmla="*/ 89641 h 285887"/>
                <a:gd name="connsiteX20" fmla="*/ 542925 w 771573"/>
                <a:gd name="connsiteY20" fmla="*/ 93451 h 285887"/>
                <a:gd name="connsiteX21" fmla="*/ 550545 w 771573"/>
                <a:gd name="connsiteY21" fmla="*/ 97261 h 285887"/>
                <a:gd name="connsiteX22" fmla="*/ 565785 w 771573"/>
                <a:gd name="connsiteY22" fmla="*/ 104881 h 285887"/>
                <a:gd name="connsiteX23" fmla="*/ 575310 w 771573"/>
                <a:gd name="connsiteY23" fmla="*/ 114406 h 285887"/>
                <a:gd name="connsiteX24" fmla="*/ 581025 w 771573"/>
                <a:gd name="connsiteY24" fmla="*/ 118216 h 285887"/>
                <a:gd name="connsiteX25" fmla="*/ 600075 w 771573"/>
                <a:gd name="connsiteY25" fmla="*/ 133456 h 285887"/>
                <a:gd name="connsiteX26" fmla="*/ 607695 w 771573"/>
                <a:gd name="connsiteY26" fmla="*/ 142981 h 285887"/>
                <a:gd name="connsiteX27" fmla="*/ 621030 w 771573"/>
                <a:gd name="connsiteY27" fmla="*/ 156316 h 285887"/>
                <a:gd name="connsiteX28" fmla="*/ 628650 w 771573"/>
                <a:gd name="connsiteY28" fmla="*/ 167746 h 285887"/>
                <a:gd name="connsiteX29" fmla="*/ 638175 w 771573"/>
                <a:gd name="connsiteY29" fmla="*/ 182986 h 285887"/>
                <a:gd name="connsiteX30" fmla="*/ 647700 w 771573"/>
                <a:gd name="connsiteY30" fmla="*/ 200131 h 285887"/>
                <a:gd name="connsiteX31" fmla="*/ 657225 w 771573"/>
                <a:gd name="connsiteY31" fmla="*/ 211561 h 285887"/>
                <a:gd name="connsiteX32" fmla="*/ 668655 w 771573"/>
                <a:gd name="connsiteY32" fmla="*/ 219181 h 285887"/>
                <a:gd name="connsiteX33" fmla="*/ 672465 w 771573"/>
                <a:gd name="connsiteY33" fmla="*/ 224896 h 285887"/>
                <a:gd name="connsiteX34" fmla="*/ 678180 w 771573"/>
                <a:gd name="connsiteY34" fmla="*/ 226801 h 285887"/>
                <a:gd name="connsiteX35" fmla="*/ 681990 w 771573"/>
                <a:gd name="connsiteY35" fmla="*/ 234421 h 285887"/>
                <a:gd name="connsiteX36" fmla="*/ 697230 w 771573"/>
                <a:gd name="connsiteY36" fmla="*/ 251566 h 285887"/>
                <a:gd name="connsiteX37" fmla="*/ 701040 w 771573"/>
                <a:gd name="connsiteY37" fmla="*/ 266806 h 285887"/>
                <a:gd name="connsiteX38" fmla="*/ 710565 w 771573"/>
                <a:gd name="connsiteY38" fmla="*/ 276331 h 285887"/>
                <a:gd name="connsiteX39" fmla="*/ 723900 w 771573"/>
                <a:gd name="connsiteY39" fmla="*/ 274426 h 285887"/>
                <a:gd name="connsiteX40" fmla="*/ 727710 w 771573"/>
                <a:gd name="connsiteY40" fmla="*/ 268711 h 285887"/>
                <a:gd name="connsiteX41" fmla="*/ 741045 w 771573"/>
                <a:gd name="connsiteY41" fmla="*/ 255376 h 285887"/>
                <a:gd name="connsiteX42" fmla="*/ 746760 w 771573"/>
                <a:gd name="connsiteY42" fmla="*/ 249661 h 285887"/>
                <a:gd name="connsiteX43" fmla="*/ 754380 w 771573"/>
                <a:gd name="connsiteY43" fmla="*/ 243946 h 285887"/>
                <a:gd name="connsiteX44" fmla="*/ 762000 w 771573"/>
                <a:gd name="connsiteY44" fmla="*/ 240136 h 285887"/>
                <a:gd name="connsiteX45" fmla="*/ 767715 w 771573"/>
                <a:gd name="connsiteY45" fmla="*/ 236326 h 285887"/>
                <a:gd name="connsiteX46" fmla="*/ 771525 w 771573"/>
                <a:gd name="connsiteY46" fmla="*/ 230611 h 285887"/>
                <a:gd name="connsiteX47" fmla="*/ 765810 w 771573"/>
                <a:gd name="connsiteY47" fmla="*/ 200131 h 285887"/>
                <a:gd name="connsiteX48" fmla="*/ 762000 w 771573"/>
                <a:gd name="connsiteY48" fmla="*/ 194416 h 285887"/>
                <a:gd name="connsiteX49" fmla="*/ 756285 w 771573"/>
                <a:gd name="connsiteY49" fmla="*/ 181081 h 285887"/>
                <a:gd name="connsiteX50" fmla="*/ 748665 w 771573"/>
                <a:gd name="connsiteY50" fmla="*/ 165841 h 285887"/>
                <a:gd name="connsiteX51" fmla="*/ 739140 w 771573"/>
                <a:gd name="connsiteY51" fmla="*/ 152506 h 285887"/>
                <a:gd name="connsiteX52" fmla="*/ 737235 w 771573"/>
                <a:gd name="connsiteY52" fmla="*/ 146791 h 285887"/>
                <a:gd name="connsiteX53" fmla="*/ 727710 w 771573"/>
                <a:gd name="connsiteY53" fmla="*/ 135361 h 285887"/>
                <a:gd name="connsiteX54" fmla="*/ 720090 w 771573"/>
                <a:gd name="connsiteY54" fmla="*/ 129646 h 285887"/>
                <a:gd name="connsiteX55" fmla="*/ 714375 w 771573"/>
                <a:gd name="connsiteY55" fmla="*/ 127741 h 285887"/>
                <a:gd name="connsiteX56" fmla="*/ 702945 w 771573"/>
                <a:gd name="connsiteY56" fmla="*/ 118216 h 285887"/>
                <a:gd name="connsiteX57" fmla="*/ 697230 w 771573"/>
                <a:gd name="connsiteY57" fmla="*/ 112501 h 285887"/>
                <a:gd name="connsiteX58" fmla="*/ 691515 w 771573"/>
                <a:gd name="connsiteY58" fmla="*/ 108691 h 285887"/>
                <a:gd name="connsiteX59" fmla="*/ 683895 w 771573"/>
                <a:gd name="connsiteY59" fmla="*/ 102976 h 285887"/>
                <a:gd name="connsiteX60" fmla="*/ 676275 w 771573"/>
                <a:gd name="connsiteY60" fmla="*/ 99166 h 285887"/>
                <a:gd name="connsiteX61" fmla="*/ 664845 w 771573"/>
                <a:gd name="connsiteY61" fmla="*/ 95356 h 285887"/>
                <a:gd name="connsiteX62" fmla="*/ 655320 w 771573"/>
                <a:gd name="connsiteY62" fmla="*/ 89641 h 285887"/>
                <a:gd name="connsiteX63" fmla="*/ 640080 w 771573"/>
                <a:gd name="connsiteY63" fmla="*/ 83926 h 285887"/>
                <a:gd name="connsiteX64" fmla="*/ 626745 w 771573"/>
                <a:gd name="connsiteY64" fmla="*/ 74401 h 285887"/>
                <a:gd name="connsiteX65" fmla="*/ 621030 w 771573"/>
                <a:gd name="connsiteY65" fmla="*/ 72496 h 285887"/>
                <a:gd name="connsiteX66" fmla="*/ 609600 w 771573"/>
                <a:gd name="connsiteY66" fmla="*/ 64876 h 285887"/>
                <a:gd name="connsiteX67" fmla="*/ 598170 w 771573"/>
                <a:gd name="connsiteY67" fmla="*/ 59161 h 285887"/>
                <a:gd name="connsiteX68" fmla="*/ 592455 w 771573"/>
                <a:gd name="connsiteY68" fmla="*/ 55351 h 285887"/>
                <a:gd name="connsiteX69" fmla="*/ 584835 w 771573"/>
                <a:gd name="connsiteY69" fmla="*/ 49636 h 285887"/>
                <a:gd name="connsiteX70" fmla="*/ 573405 w 771573"/>
                <a:gd name="connsiteY70" fmla="*/ 45826 h 285887"/>
                <a:gd name="connsiteX71" fmla="*/ 567690 w 771573"/>
                <a:gd name="connsiteY71" fmla="*/ 42016 h 285887"/>
                <a:gd name="connsiteX72" fmla="*/ 556260 w 771573"/>
                <a:gd name="connsiteY72" fmla="*/ 38206 h 285887"/>
                <a:gd name="connsiteX73" fmla="*/ 548640 w 771573"/>
                <a:gd name="connsiteY73" fmla="*/ 34396 h 285887"/>
                <a:gd name="connsiteX74" fmla="*/ 537210 w 771573"/>
                <a:gd name="connsiteY74" fmla="*/ 26776 h 285887"/>
                <a:gd name="connsiteX75" fmla="*/ 493395 w 771573"/>
                <a:gd name="connsiteY75" fmla="*/ 17251 h 285887"/>
                <a:gd name="connsiteX76" fmla="*/ 485775 w 771573"/>
                <a:gd name="connsiteY76" fmla="*/ 15346 h 285887"/>
                <a:gd name="connsiteX77" fmla="*/ 472440 w 771573"/>
                <a:gd name="connsiteY77" fmla="*/ 11536 h 285887"/>
                <a:gd name="connsiteX78" fmla="*/ 409575 w 771573"/>
                <a:gd name="connsiteY78" fmla="*/ 3916 h 285887"/>
                <a:gd name="connsiteX79" fmla="*/ 360045 w 771573"/>
                <a:gd name="connsiteY79" fmla="*/ 106 h 285887"/>
                <a:gd name="connsiteX80" fmla="*/ 300990 w 771573"/>
                <a:gd name="connsiteY80" fmla="*/ 2011 h 285887"/>
                <a:gd name="connsiteX81" fmla="*/ 268605 w 771573"/>
                <a:gd name="connsiteY81" fmla="*/ 9631 h 285887"/>
                <a:gd name="connsiteX82" fmla="*/ 226695 w 771573"/>
                <a:gd name="connsiteY82" fmla="*/ 26776 h 285887"/>
                <a:gd name="connsiteX83" fmla="*/ 182880 w 771573"/>
                <a:gd name="connsiteY83" fmla="*/ 53446 h 285887"/>
                <a:gd name="connsiteX84" fmla="*/ 123825 w 771573"/>
                <a:gd name="connsiteY84" fmla="*/ 95356 h 285887"/>
                <a:gd name="connsiteX85" fmla="*/ 87630 w 771573"/>
                <a:gd name="connsiteY85" fmla="*/ 125836 h 285887"/>
                <a:gd name="connsiteX86" fmla="*/ 55245 w 771573"/>
                <a:gd name="connsiteY86" fmla="*/ 158221 h 285887"/>
                <a:gd name="connsiteX87" fmla="*/ 20955 w 771573"/>
                <a:gd name="connsiteY87" fmla="*/ 203941 h 285887"/>
                <a:gd name="connsiteX88" fmla="*/ 0 w 771573"/>
                <a:gd name="connsiteY88" fmla="*/ 251566 h 285887"/>
                <a:gd name="connsiteX0" fmla="*/ 0 w 771573"/>
                <a:gd name="connsiteY0" fmla="*/ 251566 h 285887"/>
                <a:gd name="connsiteX1" fmla="*/ 19050 w 771573"/>
                <a:gd name="connsiteY1" fmla="*/ 268711 h 285887"/>
                <a:gd name="connsiteX2" fmla="*/ 45720 w 771573"/>
                <a:gd name="connsiteY2" fmla="*/ 285856 h 285887"/>
                <a:gd name="connsiteX3" fmla="*/ 55245 w 771573"/>
                <a:gd name="connsiteY3" fmla="*/ 272521 h 285887"/>
                <a:gd name="connsiteX4" fmla="*/ 112386 w 771573"/>
                <a:gd name="connsiteY4" fmla="*/ 198946 h 285887"/>
                <a:gd name="connsiteX5" fmla="*/ 140970 w 771573"/>
                <a:gd name="connsiteY5" fmla="*/ 175366 h 285887"/>
                <a:gd name="connsiteX6" fmla="*/ 180975 w 771573"/>
                <a:gd name="connsiteY6" fmla="*/ 150601 h 285887"/>
                <a:gd name="connsiteX7" fmla="*/ 200025 w 771573"/>
                <a:gd name="connsiteY7" fmla="*/ 131551 h 285887"/>
                <a:gd name="connsiteX8" fmla="*/ 226695 w 771573"/>
                <a:gd name="connsiteY8" fmla="*/ 112501 h 285887"/>
                <a:gd name="connsiteX9" fmla="*/ 238125 w 771573"/>
                <a:gd name="connsiteY9" fmla="*/ 108691 h 285887"/>
                <a:gd name="connsiteX10" fmla="*/ 251460 w 771573"/>
                <a:gd name="connsiteY10" fmla="*/ 101071 h 285887"/>
                <a:gd name="connsiteX11" fmla="*/ 259080 w 771573"/>
                <a:gd name="connsiteY11" fmla="*/ 99166 h 285887"/>
                <a:gd name="connsiteX12" fmla="*/ 276225 w 771573"/>
                <a:gd name="connsiteY12" fmla="*/ 93451 h 285887"/>
                <a:gd name="connsiteX13" fmla="*/ 283845 w 771573"/>
                <a:gd name="connsiteY13" fmla="*/ 91546 h 285887"/>
                <a:gd name="connsiteX14" fmla="*/ 319563 w 771573"/>
                <a:gd name="connsiteY14" fmla="*/ 82846 h 285887"/>
                <a:gd name="connsiteX15" fmla="*/ 372425 w 771573"/>
                <a:gd name="connsiteY15" fmla="*/ 78470 h 285887"/>
                <a:gd name="connsiteX16" fmla="*/ 456259 w 771573"/>
                <a:gd name="connsiteY16" fmla="*/ 78263 h 285887"/>
                <a:gd name="connsiteX17" fmla="*/ 521970 w 771573"/>
                <a:gd name="connsiteY17" fmla="*/ 85831 h 285887"/>
                <a:gd name="connsiteX18" fmla="*/ 537210 w 771573"/>
                <a:gd name="connsiteY18" fmla="*/ 89641 h 285887"/>
                <a:gd name="connsiteX19" fmla="*/ 542925 w 771573"/>
                <a:gd name="connsiteY19" fmla="*/ 93451 h 285887"/>
                <a:gd name="connsiteX20" fmla="*/ 550545 w 771573"/>
                <a:gd name="connsiteY20" fmla="*/ 97261 h 285887"/>
                <a:gd name="connsiteX21" fmla="*/ 565785 w 771573"/>
                <a:gd name="connsiteY21" fmla="*/ 104881 h 285887"/>
                <a:gd name="connsiteX22" fmla="*/ 575310 w 771573"/>
                <a:gd name="connsiteY22" fmla="*/ 114406 h 285887"/>
                <a:gd name="connsiteX23" fmla="*/ 581025 w 771573"/>
                <a:gd name="connsiteY23" fmla="*/ 118216 h 285887"/>
                <a:gd name="connsiteX24" fmla="*/ 600075 w 771573"/>
                <a:gd name="connsiteY24" fmla="*/ 133456 h 285887"/>
                <a:gd name="connsiteX25" fmla="*/ 607695 w 771573"/>
                <a:gd name="connsiteY25" fmla="*/ 142981 h 285887"/>
                <a:gd name="connsiteX26" fmla="*/ 621030 w 771573"/>
                <a:gd name="connsiteY26" fmla="*/ 156316 h 285887"/>
                <a:gd name="connsiteX27" fmla="*/ 628650 w 771573"/>
                <a:gd name="connsiteY27" fmla="*/ 167746 h 285887"/>
                <a:gd name="connsiteX28" fmla="*/ 638175 w 771573"/>
                <a:gd name="connsiteY28" fmla="*/ 182986 h 285887"/>
                <a:gd name="connsiteX29" fmla="*/ 647700 w 771573"/>
                <a:gd name="connsiteY29" fmla="*/ 200131 h 285887"/>
                <a:gd name="connsiteX30" fmla="*/ 657225 w 771573"/>
                <a:gd name="connsiteY30" fmla="*/ 211561 h 285887"/>
                <a:gd name="connsiteX31" fmla="*/ 668655 w 771573"/>
                <a:gd name="connsiteY31" fmla="*/ 219181 h 285887"/>
                <a:gd name="connsiteX32" fmla="*/ 672465 w 771573"/>
                <a:gd name="connsiteY32" fmla="*/ 224896 h 285887"/>
                <a:gd name="connsiteX33" fmla="*/ 678180 w 771573"/>
                <a:gd name="connsiteY33" fmla="*/ 226801 h 285887"/>
                <a:gd name="connsiteX34" fmla="*/ 681990 w 771573"/>
                <a:gd name="connsiteY34" fmla="*/ 234421 h 285887"/>
                <a:gd name="connsiteX35" fmla="*/ 697230 w 771573"/>
                <a:gd name="connsiteY35" fmla="*/ 251566 h 285887"/>
                <a:gd name="connsiteX36" fmla="*/ 701040 w 771573"/>
                <a:gd name="connsiteY36" fmla="*/ 266806 h 285887"/>
                <a:gd name="connsiteX37" fmla="*/ 710565 w 771573"/>
                <a:gd name="connsiteY37" fmla="*/ 276331 h 285887"/>
                <a:gd name="connsiteX38" fmla="*/ 723900 w 771573"/>
                <a:gd name="connsiteY38" fmla="*/ 274426 h 285887"/>
                <a:gd name="connsiteX39" fmla="*/ 727710 w 771573"/>
                <a:gd name="connsiteY39" fmla="*/ 268711 h 285887"/>
                <a:gd name="connsiteX40" fmla="*/ 741045 w 771573"/>
                <a:gd name="connsiteY40" fmla="*/ 255376 h 285887"/>
                <a:gd name="connsiteX41" fmla="*/ 746760 w 771573"/>
                <a:gd name="connsiteY41" fmla="*/ 249661 h 285887"/>
                <a:gd name="connsiteX42" fmla="*/ 754380 w 771573"/>
                <a:gd name="connsiteY42" fmla="*/ 243946 h 285887"/>
                <a:gd name="connsiteX43" fmla="*/ 762000 w 771573"/>
                <a:gd name="connsiteY43" fmla="*/ 240136 h 285887"/>
                <a:gd name="connsiteX44" fmla="*/ 767715 w 771573"/>
                <a:gd name="connsiteY44" fmla="*/ 236326 h 285887"/>
                <a:gd name="connsiteX45" fmla="*/ 771525 w 771573"/>
                <a:gd name="connsiteY45" fmla="*/ 230611 h 285887"/>
                <a:gd name="connsiteX46" fmla="*/ 765810 w 771573"/>
                <a:gd name="connsiteY46" fmla="*/ 200131 h 285887"/>
                <a:gd name="connsiteX47" fmla="*/ 762000 w 771573"/>
                <a:gd name="connsiteY47" fmla="*/ 194416 h 285887"/>
                <a:gd name="connsiteX48" fmla="*/ 756285 w 771573"/>
                <a:gd name="connsiteY48" fmla="*/ 181081 h 285887"/>
                <a:gd name="connsiteX49" fmla="*/ 748665 w 771573"/>
                <a:gd name="connsiteY49" fmla="*/ 165841 h 285887"/>
                <a:gd name="connsiteX50" fmla="*/ 739140 w 771573"/>
                <a:gd name="connsiteY50" fmla="*/ 152506 h 285887"/>
                <a:gd name="connsiteX51" fmla="*/ 737235 w 771573"/>
                <a:gd name="connsiteY51" fmla="*/ 146791 h 285887"/>
                <a:gd name="connsiteX52" fmla="*/ 727710 w 771573"/>
                <a:gd name="connsiteY52" fmla="*/ 135361 h 285887"/>
                <a:gd name="connsiteX53" fmla="*/ 720090 w 771573"/>
                <a:gd name="connsiteY53" fmla="*/ 129646 h 285887"/>
                <a:gd name="connsiteX54" fmla="*/ 714375 w 771573"/>
                <a:gd name="connsiteY54" fmla="*/ 127741 h 285887"/>
                <a:gd name="connsiteX55" fmla="*/ 702945 w 771573"/>
                <a:gd name="connsiteY55" fmla="*/ 118216 h 285887"/>
                <a:gd name="connsiteX56" fmla="*/ 697230 w 771573"/>
                <a:gd name="connsiteY56" fmla="*/ 112501 h 285887"/>
                <a:gd name="connsiteX57" fmla="*/ 691515 w 771573"/>
                <a:gd name="connsiteY57" fmla="*/ 108691 h 285887"/>
                <a:gd name="connsiteX58" fmla="*/ 683895 w 771573"/>
                <a:gd name="connsiteY58" fmla="*/ 102976 h 285887"/>
                <a:gd name="connsiteX59" fmla="*/ 676275 w 771573"/>
                <a:gd name="connsiteY59" fmla="*/ 99166 h 285887"/>
                <a:gd name="connsiteX60" fmla="*/ 664845 w 771573"/>
                <a:gd name="connsiteY60" fmla="*/ 95356 h 285887"/>
                <a:gd name="connsiteX61" fmla="*/ 655320 w 771573"/>
                <a:gd name="connsiteY61" fmla="*/ 89641 h 285887"/>
                <a:gd name="connsiteX62" fmla="*/ 640080 w 771573"/>
                <a:gd name="connsiteY62" fmla="*/ 83926 h 285887"/>
                <a:gd name="connsiteX63" fmla="*/ 626745 w 771573"/>
                <a:gd name="connsiteY63" fmla="*/ 74401 h 285887"/>
                <a:gd name="connsiteX64" fmla="*/ 621030 w 771573"/>
                <a:gd name="connsiteY64" fmla="*/ 72496 h 285887"/>
                <a:gd name="connsiteX65" fmla="*/ 609600 w 771573"/>
                <a:gd name="connsiteY65" fmla="*/ 64876 h 285887"/>
                <a:gd name="connsiteX66" fmla="*/ 598170 w 771573"/>
                <a:gd name="connsiteY66" fmla="*/ 59161 h 285887"/>
                <a:gd name="connsiteX67" fmla="*/ 592455 w 771573"/>
                <a:gd name="connsiteY67" fmla="*/ 55351 h 285887"/>
                <a:gd name="connsiteX68" fmla="*/ 584835 w 771573"/>
                <a:gd name="connsiteY68" fmla="*/ 49636 h 285887"/>
                <a:gd name="connsiteX69" fmla="*/ 573405 w 771573"/>
                <a:gd name="connsiteY69" fmla="*/ 45826 h 285887"/>
                <a:gd name="connsiteX70" fmla="*/ 567690 w 771573"/>
                <a:gd name="connsiteY70" fmla="*/ 42016 h 285887"/>
                <a:gd name="connsiteX71" fmla="*/ 556260 w 771573"/>
                <a:gd name="connsiteY71" fmla="*/ 38206 h 285887"/>
                <a:gd name="connsiteX72" fmla="*/ 548640 w 771573"/>
                <a:gd name="connsiteY72" fmla="*/ 34396 h 285887"/>
                <a:gd name="connsiteX73" fmla="*/ 537210 w 771573"/>
                <a:gd name="connsiteY73" fmla="*/ 26776 h 285887"/>
                <a:gd name="connsiteX74" fmla="*/ 493395 w 771573"/>
                <a:gd name="connsiteY74" fmla="*/ 17251 h 285887"/>
                <a:gd name="connsiteX75" fmla="*/ 485775 w 771573"/>
                <a:gd name="connsiteY75" fmla="*/ 15346 h 285887"/>
                <a:gd name="connsiteX76" fmla="*/ 472440 w 771573"/>
                <a:gd name="connsiteY76" fmla="*/ 11536 h 285887"/>
                <a:gd name="connsiteX77" fmla="*/ 409575 w 771573"/>
                <a:gd name="connsiteY77" fmla="*/ 3916 h 285887"/>
                <a:gd name="connsiteX78" fmla="*/ 360045 w 771573"/>
                <a:gd name="connsiteY78" fmla="*/ 106 h 285887"/>
                <a:gd name="connsiteX79" fmla="*/ 300990 w 771573"/>
                <a:gd name="connsiteY79" fmla="*/ 2011 h 285887"/>
                <a:gd name="connsiteX80" fmla="*/ 268605 w 771573"/>
                <a:gd name="connsiteY80" fmla="*/ 9631 h 285887"/>
                <a:gd name="connsiteX81" fmla="*/ 226695 w 771573"/>
                <a:gd name="connsiteY81" fmla="*/ 26776 h 285887"/>
                <a:gd name="connsiteX82" fmla="*/ 182880 w 771573"/>
                <a:gd name="connsiteY82" fmla="*/ 53446 h 285887"/>
                <a:gd name="connsiteX83" fmla="*/ 123825 w 771573"/>
                <a:gd name="connsiteY83" fmla="*/ 95356 h 285887"/>
                <a:gd name="connsiteX84" fmla="*/ 87630 w 771573"/>
                <a:gd name="connsiteY84" fmla="*/ 125836 h 285887"/>
                <a:gd name="connsiteX85" fmla="*/ 55245 w 771573"/>
                <a:gd name="connsiteY85" fmla="*/ 158221 h 285887"/>
                <a:gd name="connsiteX86" fmla="*/ 20955 w 771573"/>
                <a:gd name="connsiteY86" fmla="*/ 203941 h 285887"/>
                <a:gd name="connsiteX87" fmla="*/ 0 w 771573"/>
                <a:gd name="connsiteY87" fmla="*/ 251566 h 285887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80975 w 771573"/>
                <a:gd name="connsiteY6" fmla="*/ 150601 h 286109"/>
                <a:gd name="connsiteX7" fmla="*/ 200025 w 771573"/>
                <a:gd name="connsiteY7" fmla="*/ 131551 h 286109"/>
                <a:gd name="connsiteX8" fmla="*/ 226695 w 771573"/>
                <a:gd name="connsiteY8" fmla="*/ 112501 h 286109"/>
                <a:gd name="connsiteX9" fmla="*/ 238125 w 771573"/>
                <a:gd name="connsiteY9" fmla="*/ 108691 h 286109"/>
                <a:gd name="connsiteX10" fmla="*/ 251460 w 771573"/>
                <a:gd name="connsiteY10" fmla="*/ 101071 h 286109"/>
                <a:gd name="connsiteX11" fmla="*/ 259080 w 771573"/>
                <a:gd name="connsiteY11" fmla="*/ 99166 h 286109"/>
                <a:gd name="connsiteX12" fmla="*/ 276225 w 771573"/>
                <a:gd name="connsiteY12" fmla="*/ 93451 h 286109"/>
                <a:gd name="connsiteX13" fmla="*/ 283845 w 771573"/>
                <a:gd name="connsiteY13" fmla="*/ 91546 h 286109"/>
                <a:gd name="connsiteX14" fmla="*/ 319563 w 771573"/>
                <a:gd name="connsiteY14" fmla="*/ 82846 h 286109"/>
                <a:gd name="connsiteX15" fmla="*/ 372425 w 771573"/>
                <a:gd name="connsiteY15" fmla="*/ 78470 h 286109"/>
                <a:gd name="connsiteX16" fmla="*/ 456259 w 771573"/>
                <a:gd name="connsiteY16" fmla="*/ 78263 h 286109"/>
                <a:gd name="connsiteX17" fmla="*/ 521970 w 771573"/>
                <a:gd name="connsiteY17" fmla="*/ 85831 h 286109"/>
                <a:gd name="connsiteX18" fmla="*/ 537210 w 771573"/>
                <a:gd name="connsiteY18" fmla="*/ 89641 h 286109"/>
                <a:gd name="connsiteX19" fmla="*/ 542925 w 771573"/>
                <a:gd name="connsiteY19" fmla="*/ 93451 h 286109"/>
                <a:gd name="connsiteX20" fmla="*/ 550545 w 771573"/>
                <a:gd name="connsiteY20" fmla="*/ 97261 h 286109"/>
                <a:gd name="connsiteX21" fmla="*/ 565785 w 771573"/>
                <a:gd name="connsiteY21" fmla="*/ 104881 h 286109"/>
                <a:gd name="connsiteX22" fmla="*/ 575310 w 771573"/>
                <a:gd name="connsiteY22" fmla="*/ 114406 h 286109"/>
                <a:gd name="connsiteX23" fmla="*/ 581025 w 771573"/>
                <a:gd name="connsiteY23" fmla="*/ 118216 h 286109"/>
                <a:gd name="connsiteX24" fmla="*/ 600075 w 771573"/>
                <a:gd name="connsiteY24" fmla="*/ 133456 h 286109"/>
                <a:gd name="connsiteX25" fmla="*/ 607695 w 771573"/>
                <a:gd name="connsiteY25" fmla="*/ 142981 h 286109"/>
                <a:gd name="connsiteX26" fmla="*/ 621030 w 771573"/>
                <a:gd name="connsiteY26" fmla="*/ 156316 h 286109"/>
                <a:gd name="connsiteX27" fmla="*/ 628650 w 771573"/>
                <a:gd name="connsiteY27" fmla="*/ 167746 h 286109"/>
                <a:gd name="connsiteX28" fmla="*/ 638175 w 771573"/>
                <a:gd name="connsiteY28" fmla="*/ 182986 h 286109"/>
                <a:gd name="connsiteX29" fmla="*/ 647700 w 771573"/>
                <a:gd name="connsiteY29" fmla="*/ 200131 h 286109"/>
                <a:gd name="connsiteX30" fmla="*/ 657225 w 771573"/>
                <a:gd name="connsiteY30" fmla="*/ 211561 h 286109"/>
                <a:gd name="connsiteX31" fmla="*/ 668655 w 771573"/>
                <a:gd name="connsiteY31" fmla="*/ 219181 h 286109"/>
                <a:gd name="connsiteX32" fmla="*/ 672465 w 771573"/>
                <a:gd name="connsiteY32" fmla="*/ 224896 h 286109"/>
                <a:gd name="connsiteX33" fmla="*/ 678180 w 771573"/>
                <a:gd name="connsiteY33" fmla="*/ 226801 h 286109"/>
                <a:gd name="connsiteX34" fmla="*/ 681990 w 771573"/>
                <a:gd name="connsiteY34" fmla="*/ 234421 h 286109"/>
                <a:gd name="connsiteX35" fmla="*/ 697230 w 771573"/>
                <a:gd name="connsiteY35" fmla="*/ 251566 h 286109"/>
                <a:gd name="connsiteX36" fmla="*/ 701040 w 771573"/>
                <a:gd name="connsiteY36" fmla="*/ 266806 h 286109"/>
                <a:gd name="connsiteX37" fmla="*/ 710565 w 771573"/>
                <a:gd name="connsiteY37" fmla="*/ 276331 h 286109"/>
                <a:gd name="connsiteX38" fmla="*/ 723900 w 771573"/>
                <a:gd name="connsiteY38" fmla="*/ 274426 h 286109"/>
                <a:gd name="connsiteX39" fmla="*/ 727710 w 771573"/>
                <a:gd name="connsiteY39" fmla="*/ 268711 h 286109"/>
                <a:gd name="connsiteX40" fmla="*/ 741045 w 771573"/>
                <a:gd name="connsiteY40" fmla="*/ 255376 h 286109"/>
                <a:gd name="connsiteX41" fmla="*/ 746760 w 771573"/>
                <a:gd name="connsiteY41" fmla="*/ 249661 h 286109"/>
                <a:gd name="connsiteX42" fmla="*/ 754380 w 771573"/>
                <a:gd name="connsiteY42" fmla="*/ 243946 h 286109"/>
                <a:gd name="connsiteX43" fmla="*/ 762000 w 771573"/>
                <a:gd name="connsiteY43" fmla="*/ 240136 h 286109"/>
                <a:gd name="connsiteX44" fmla="*/ 767715 w 771573"/>
                <a:gd name="connsiteY44" fmla="*/ 236326 h 286109"/>
                <a:gd name="connsiteX45" fmla="*/ 771525 w 771573"/>
                <a:gd name="connsiteY45" fmla="*/ 230611 h 286109"/>
                <a:gd name="connsiteX46" fmla="*/ 765810 w 771573"/>
                <a:gd name="connsiteY46" fmla="*/ 200131 h 286109"/>
                <a:gd name="connsiteX47" fmla="*/ 762000 w 771573"/>
                <a:gd name="connsiteY47" fmla="*/ 194416 h 286109"/>
                <a:gd name="connsiteX48" fmla="*/ 756285 w 771573"/>
                <a:gd name="connsiteY48" fmla="*/ 181081 h 286109"/>
                <a:gd name="connsiteX49" fmla="*/ 748665 w 771573"/>
                <a:gd name="connsiteY49" fmla="*/ 165841 h 286109"/>
                <a:gd name="connsiteX50" fmla="*/ 739140 w 771573"/>
                <a:gd name="connsiteY50" fmla="*/ 152506 h 286109"/>
                <a:gd name="connsiteX51" fmla="*/ 737235 w 771573"/>
                <a:gd name="connsiteY51" fmla="*/ 146791 h 286109"/>
                <a:gd name="connsiteX52" fmla="*/ 727710 w 771573"/>
                <a:gd name="connsiteY52" fmla="*/ 135361 h 286109"/>
                <a:gd name="connsiteX53" fmla="*/ 720090 w 771573"/>
                <a:gd name="connsiteY53" fmla="*/ 129646 h 286109"/>
                <a:gd name="connsiteX54" fmla="*/ 714375 w 771573"/>
                <a:gd name="connsiteY54" fmla="*/ 127741 h 286109"/>
                <a:gd name="connsiteX55" fmla="*/ 702945 w 771573"/>
                <a:gd name="connsiteY55" fmla="*/ 118216 h 286109"/>
                <a:gd name="connsiteX56" fmla="*/ 697230 w 771573"/>
                <a:gd name="connsiteY56" fmla="*/ 112501 h 286109"/>
                <a:gd name="connsiteX57" fmla="*/ 691515 w 771573"/>
                <a:gd name="connsiteY57" fmla="*/ 108691 h 286109"/>
                <a:gd name="connsiteX58" fmla="*/ 683895 w 771573"/>
                <a:gd name="connsiteY58" fmla="*/ 102976 h 286109"/>
                <a:gd name="connsiteX59" fmla="*/ 676275 w 771573"/>
                <a:gd name="connsiteY59" fmla="*/ 99166 h 286109"/>
                <a:gd name="connsiteX60" fmla="*/ 664845 w 771573"/>
                <a:gd name="connsiteY60" fmla="*/ 95356 h 286109"/>
                <a:gd name="connsiteX61" fmla="*/ 655320 w 771573"/>
                <a:gd name="connsiteY61" fmla="*/ 89641 h 286109"/>
                <a:gd name="connsiteX62" fmla="*/ 640080 w 771573"/>
                <a:gd name="connsiteY62" fmla="*/ 83926 h 286109"/>
                <a:gd name="connsiteX63" fmla="*/ 626745 w 771573"/>
                <a:gd name="connsiteY63" fmla="*/ 74401 h 286109"/>
                <a:gd name="connsiteX64" fmla="*/ 621030 w 771573"/>
                <a:gd name="connsiteY64" fmla="*/ 72496 h 286109"/>
                <a:gd name="connsiteX65" fmla="*/ 609600 w 771573"/>
                <a:gd name="connsiteY65" fmla="*/ 64876 h 286109"/>
                <a:gd name="connsiteX66" fmla="*/ 598170 w 771573"/>
                <a:gd name="connsiteY66" fmla="*/ 59161 h 286109"/>
                <a:gd name="connsiteX67" fmla="*/ 592455 w 771573"/>
                <a:gd name="connsiteY67" fmla="*/ 55351 h 286109"/>
                <a:gd name="connsiteX68" fmla="*/ 584835 w 771573"/>
                <a:gd name="connsiteY68" fmla="*/ 49636 h 286109"/>
                <a:gd name="connsiteX69" fmla="*/ 573405 w 771573"/>
                <a:gd name="connsiteY69" fmla="*/ 45826 h 286109"/>
                <a:gd name="connsiteX70" fmla="*/ 567690 w 771573"/>
                <a:gd name="connsiteY70" fmla="*/ 42016 h 286109"/>
                <a:gd name="connsiteX71" fmla="*/ 556260 w 771573"/>
                <a:gd name="connsiteY71" fmla="*/ 38206 h 286109"/>
                <a:gd name="connsiteX72" fmla="*/ 548640 w 771573"/>
                <a:gd name="connsiteY72" fmla="*/ 34396 h 286109"/>
                <a:gd name="connsiteX73" fmla="*/ 537210 w 771573"/>
                <a:gd name="connsiteY73" fmla="*/ 26776 h 286109"/>
                <a:gd name="connsiteX74" fmla="*/ 493395 w 771573"/>
                <a:gd name="connsiteY74" fmla="*/ 17251 h 286109"/>
                <a:gd name="connsiteX75" fmla="*/ 485775 w 771573"/>
                <a:gd name="connsiteY75" fmla="*/ 15346 h 286109"/>
                <a:gd name="connsiteX76" fmla="*/ 472440 w 771573"/>
                <a:gd name="connsiteY76" fmla="*/ 11536 h 286109"/>
                <a:gd name="connsiteX77" fmla="*/ 409575 w 771573"/>
                <a:gd name="connsiteY77" fmla="*/ 3916 h 286109"/>
                <a:gd name="connsiteX78" fmla="*/ 360045 w 771573"/>
                <a:gd name="connsiteY78" fmla="*/ 106 h 286109"/>
                <a:gd name="connsiteX79" fmla="*/ 300990 w 771573"/>
                <a:gd name="connsiteY79" fmla="*/ 2011 h 286109"/>
                <a:gd name="connsiteX80" fmla="*/ 268605 w 771573"/>
                <a:gd name="connsiteY80" fmla="*/ 9631 h 286109"/>
                <a:gd name="connsiteX81" fmla="*/ 226695 w 771573"/>
                <a:gd name="connsiteY81" fmla="*/ 26776 h 286109"/>
                <a:gd name="connsiteX82" fmla="*/ 182880 w 771573"/>
                <a:gd name="connsiteY82" fmla="*/ 53446 h 286109"/>
                <a:gd name="connsiteX83" fmla="*/ 123825 w 771573"/>
                <a:gd name="connsiteY83" fmla="*/ 95356 h 286109"/>
                <a:gd name="connsiteX84" fmla="*/ 87630 w 771573"/>
                <a:gd name="connsiteY84" fmla="*/ 125836 h 286109"/>
                <a:gd name="connsiteX85" fmla="*/ 55245 w 771573"/>
                <a:gd name="connsiteY85" fmla="*/ 158221 h 286109"/>
                <a:gd name="connsiteX86" fmla="*/ 20955 w 771573"/>
                <a:gd name="connsiteY86" fmla="*/ 203941 h 286109"/>
                <a:gd name="connsiteX87" fmla="*/ 0 w 771573"/>
                <a:gd name="connsiteY87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0025 w 771573"/>
                <a:gd name="connsiteY7" fmla="*/ 131551 h 286109"/>
                <a:gd name="connsiteX8" fmla="*/ 226695 w 771573"/>
                <a:gd name="connsiteY8" fmla="*/ 112501 h 286109"/>
                <a:gd name="connsiteX9" fmla="*/ 238125 w 771573"/>
                <a:gd name="connsiteY9" fmla="*/ 108691 h 286109"/>
                <a:gd name="connsiteX10" fmla="*/ 251460 w 771573"/>
                <a:gd name="connsiteY10" fmla="*/ 101071 h 286109"/>
                <a:gd name="connsiteX11" fmla="*/ 259080 w 771573"/>
                <a:gd name="connsiteY11" fmla="*/ 99166 h 286109"/>
                <a:gd name="connsiteX12" fmla="*/ 276225 w 771573"/>
                <a:gd name="connsiteY12" fmla="*/ 93451 h 286109"/>
                <a:gd name="connsiteX13" fmla="*/ 283845 w 771573"/>
                <a:gd name="connsiteY13" fmla="*/ 91546 h 286109"/>
                <a:gd name="connsiteX14" fmla="*/ 319563 w 771573"/>
                <a:gd name="connsiteY14" fmla="*/ 82846 h 286109"/>
                <a:gd name="connsiteX15" fmla="*/ 372425 w 771573"/>
                <a:gd name="connsiteY15" fmla="*/ 78470 h 286109"/>
                <a:gd name="connsiteX16" fmla="*/ 456259 w 771573"/>
                <a:gd name="connsiteY16" fmla="*/ 78263 h 286109"/>
                <a:gd name="connsiteX17" fmla="*/ 521970 w 771573"/>
                <a:gd name="connsiteY17" fmla="*/ 85831 h 286109"/>
                <a:gd name="connsiteX18" fmla="*/ 537210 w 771573"/>
                <a:gd name="connsiteY18" fmla="*/ 89641 h 286109"/>
                <a:gd name="connsiteX19" fmla="*/ 542925 w 771573"/>
                <a:gd name="connsiteY19" fmla="*/ 93451 h 286109"/>
                <a:gd name="connsiteX20" fmla="*/ 550545 w 771573"/>
                <a:gd name="connsiteY20" fmla="*/ 97261 h 286109"/>
                <a:gd name="connsiteX21" fmla="*/ 565785 w 771573"/>
                <a:gd name="connsiteY21" fmla="*/ 104881 h 286109"/>
                <a:gd name="connsiteX22" fmla="*/ 575310 w 771573"/>
                <a:gd name="connsiteY22" fmla="*/ 114406 h 286109"/>
                <a:gd name="connsiteX23" fmla="*/ 581025 w 771573"/>
                <a:gd name="connsiteY23" fmla="*/ 118216 h 286109"/>
                <a:gd name="connsiteX24" fmla="*/ 600075 w 771573"/>
                <a:gd name="connsiteY24" fmla="*/ 133456 h 286109"/>
                <a:gd name="connsiteX25" fmla="*/ 607695 w 771573"/>
                <a:gd name="connsiteY25" fmla="*/ 142981 h 286109"/>
                <a:gd name="connsiteX26" fmla="*/ 621030 w 771573"/>
                <a:gd name="connsiteY26" fmla="*/ 156316 h 286109"/>
                <a:gd name="connsiteX27" fmla="*/ 628650 w 771573"/>
                <a:gd name="connsiteY27" fmla="*/ 167746 h 286109"/>
                <a:gd name="connsiteX28" fmla="*/ 638175 w 771573"/>
                <a:gd name="connsiteY28" fmla="*/ 182986 h 286109"/>
                <a:gd name="connsiteX29" fmla="*/ 647700 w 771573"/>
                <a:gd name="connsiteY29" fmla="*/ 200131 h 286109"/>
                <a:gd name="connsiteX30" fmla="*/ 657225 w 771573"/>
                <a:gd name="connsiteY30" fmla="*/ 211561 h 286109"/>
                <a:gd name="connsiteX31" fmla="*/ 668655 w 771573"/>
                <a:gd name="connsiteY31" fmla="*/ 219181 h 286109"/>
                <a:gd name="connsiteX32" fmla="*/ 672465 w 771573"/>
                <a:gd name="connsiteY32" fmla="*/ 224896 h 286109"/>
                <a:gd name="connsiteX33" fmla="*/ 678180 w 771573"/>
                <a:gd name="connsiteY33" fmla="*/ 226801 h 286109"/>
                <a:gd name="connsiteX34" fmla="*/ 681990 w 771573"/>
                <a:gd name="connsiteY34" fmla="*/ 234421 h 286109"/>
                <a:gd name="connsiteX35" fmla="*/ 697230 w 771573"/>
                <a:gd name="connsiteY35" fmla="*/ 251566 h 286109"/>
                <a:gd name="connsiteX36" fmla="*/ 701040 w 771573"/>
                <a:gd name="connsiteY36" fmla="*/ 266806 h 286109"/>
                <a:gd name="connsiteX37" fmla="*/ 710565 w 771573"/>
                <a:gd name="connsiteY37" fmla="*/ 276331 h 286109"/>
                <a:gd name="connsiteX38" fmla="*/ 723900 w 771573"/>
                <a:gd name="connsiteY38" fmla="*/ 274426 h 286109"/>
                <a:gd name="connsiteX39" fmla="*/ 727710 w 771573"/>
                <a:gd name="connsiteY39" fmla="*/ 268711 h 286109"/>
                <a:gd name="connsiteX40" fmla="*/ 741045 w 771573"/>
                <a:gd name="connsiteY40" fmla="*/ 255376 h 286109"/>
                <a:gd name="connsiteX41" fmla="*/ 746760 w 771573"/>
                <a:gd name="connsiteY41" fmla="*/ 249661 h 286109"/>
                <a:gd name="connsiteX42" fmla="*/ 754380 w 771573"/>
                <a:gd name="connsiteY42" fmla="*/ 243946 h 286109"/>
                <a:gd name="connsiteX43" fmla="*/ 762000 w 771573"/>
                <a:gd name="connsiteY43" fmla="*/ 240136 h 286109"/>
                <a:gd name="connsiteX44" fmla="*/ 767715 w 771573"/>
                <a:gd name="connsiteY44" fmla="*/ 236326 h 286109"/>
                <a:gd name="connsiteX45" fmla="*/ 771525 w 771573"/>
                <a:gd name="connsiteY45" fmla="*/ 230611 h 286109"/>
                <a:gd name="connsiteX46" fmla="*/ 765810 w 771573"/>
                <a:gd name="connsiteY46" fmla="*/ 200131 h 286109"/>
                <a:gd name="connsiteX47" fmla="*/ 762000 w 771573"/>
                <a:gd name="connsiteY47" fmla="*/ 194416 h 286109"/>
                <a:gd name="connsiteX48" fmla="*/ 756285 w 771573"/>
                <a:gd name="connsiteY48" fmla="*/ 181081 h 286109"/>
                <a:gd name="connsiteX49" fmla="*/ 748665 w 771573"/>
                <a:gd name="connsiteY49" fmla="*/ 165841 h 286109"/>
                <a:gd name="connsiteX50" fmla="*/ 739140 w 771573"/>
                <a:gd name="connsiteY50" fmla="*/ 152506 h 286109"/>
                <a:gd name="connsiteX51" fmla="*/ 737235 w 771573"/>
                <a:gd name="connsiteY51" fmla="*/ 146791 h 286109"/>
                <a:gd name="connsiteX52" fmla="*/ 727710 w 771573"/>
                <a:gd name="connsiteY52" fmla="*/ 135361 h 286109"/>
                <a:gd name="connsiteX53" fmla="*/ 720090 w 771573"/>
                <a:gd name="connsiteY53" fmla="*/ 129646 h 286109"/>
                <a:gd name="connsiteX54" fmla="*/ 714375 w 771573"/>
                <a:gd name="connsiteY54" fmla="*/ 127741 h 286109"/>
                <a:gd name="connsiteX55" fmla="*/ 702945 w 771573"/>
                <a:gd name="connsiteY55" fmla="*/ 118216 h 286109"/>
                <a:gd name="connsiteX56" fmla="*/ 697230 w 771573"/>
                <a:gd name="connsiteY56" fmla="*/ 112501 h 286109"/>
                <a:gd name="connsiteX57" fmla="*/ 691515 w 771573"/>
                <a:gd name="connsiteY57" fmla="*/ 108691 h 286109"/>
                <a:gd name="connsiteX58" fmla="*/ 683895 w 771573"/>
                <a:gd name="connsiteY58" fmla="*/ 102976 h 286109"/>
                <a:gd name="connsiteX59" fmla="*/ 676275 w 771573"/>
                <a:gd name="connsiteY59" fmla="*/ 99166 h 286109"/>
                <a:gd name="connsiteX60" fmla="*/ 664845 w 771573"/>
                <a:gd name="connsiteY60" fmla="*/ 95356 h 286109"/>
                <a:gd name="connsiteX61" fmla="*/ 655320 w 771573"/>
                <a:gd name="connsiteY61" fmla="*/ 89641 h 286109"/>
                <a:gd name="connsiteX62" fmla="*/ 640080 w 771573"/>
                <a:gd name="connsiteY62" fmla="*/ 83926 h 286109"/>
                <a:gd name="connsiteX63" fmla="*/ 626745 w 771573"/>
                <a:gd name="connsiteY63" fmla="*/ 74401 h 286109"/>
                <a:gd name="connsiteX64" fmla="*/ 621030 w 771573"/>
                <a:gd name="connsiteY64" fmla="*/ 72496 h 286109"/>
                <a:gd name="connsiteX65" fmla="*/ 609600 w 771573"/>
                <a:gd name="connsiteY65" fmla="*/ 64876 h 286109"/>
                <a:gd name="connsiteX66" fmla="*/ 598170 w 771573"/>
                <a:gd name="connsiteY66" fmla="*/ 59161 h 286109"/>
                <a:gd name="connsiteX67" fmla="*/ 592455 w 771573"/>
                <a:gd name="connsiteY67" fmla="*/ 55351 h 286109"/>
                <a:gd name="connsiteX68" fmla="*/ 584835 w 771573"/>
                <a:gd name="connsiteY68" fmla="*/ 49636 h 286109"/>
                <a:gd name="connsiteX69" fmla="*/ 573405 w 771573"/>
                <a:gd name="connsiteY69" fmla="*/ 45826 h 286109"/>
                <a:gd name="connsiteX70" fmla="*/ 567690 w 771573"/>
                <a:gd name="connsiteY70" fmla="*/ 42016 h 286109"/>
                <a:gd name="connsiteX71" fmla="*/ 556260 w 771573"/>
                <a:gd name="connsiteY71" fmla="*/ 38206 h 286109"/>
                <a:gd name="connsiteX72" fmla="*/ 548640 w 771573"/>
                <a:gd name="connsiteY72" fmla="*/ 34396 h 286109"/>
                <a:gd name="connsiteX73" fmla="*/ 537210 w 771573"/>
                <a:gd name="connsiteY73" fmla="*/ 26776 h 286109"/>
                <a:gd name="connsiteX74" fmla="*/ 493395 w 771573"/>
                <a:gd name="connsiteY74" fmla="*/ 17251 h 286109"/>
                <a:gd name="connsiteX75" fmla="*/ 485775 w 771573"/>
                <a:gd name="connsiteY75" fmla="*/ 15346 h 286109"/>
                <a:gd name="connsiteX76" fmla="*/ 472440 w 771573"/>
                <a:gd name="connsiteY76" fmla="*/ 11536 h 286109"/>
                <a:gd name="connsiteX77" fmla="*/ 409575 w 771573"/>
                <a:gd name="connsiteY77" fmla="*/ 3916 h 286109"/>
                <a:gd name="connsiteX78" fmla="*/ 360045 w 771573"/>
                <a:gd name="connsiteY78" fmla="*/ 106 h 286109"/>
                <a:gd name="connsiteX79" fmla="*/ 300990 w 771573"/>
                <a:gd name="connsiteY79" fmla="*/ 2011 h 286109"/>
                <a:gd name="connsiteX80" fmla="*/ 268605 w 771573"/>
                <a:gd name="connsiteY80" fmla="*/ 9631 h 286109"/>
                <a:gd name="connsiteX81" fmla="*/ 226695 w 771573"/>
                <a:gd name="connsiteY81" fmla="*/ 26776 h 286109"/>
                <a:gd name="connsiteX82" fmla="*/ 182880 w 771573"/>
                <a:gd name="connsiteY82" fmla="*/ 53446 h 286109"/>
                <a:gd name="connsiteX83" fmla="*/ 123825 w 771573"/>
                <a:gd name="connsiteY83" fmla="*/ 95356 h 286109"/>
                <a:gd name="connsiteX84" fmla="*/ 87630 w 771573"/>
                <a:gd name="connsiteY84" fmla="*/ 125836 h 286109"/>
                <a:gd name="connsiteX85" fmla="*/ 55245 w 771573"/>
                <a:gd name="connsiteY85" fmla="*/ 158221 h 286109"/>
                <a:gd name="connsiteX86" fmla="*/ 20955 w 771573"/>
                <a:gd name="connsiteY86" fmla="*/ 203941 h 286109"/>
                <a:gd name="connsiteX87" fmla="*/ 0 w 771573"/>
                <a:gd name="connsiteY87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1453 w 771573"/>
                <a:gd name="connsiteY7" fmla="*/ 123057 h 286109"/>
                <a:gd name="connsiteX8" fmla="*/ 226695 w 771573"/>
                <a:gd name="connsiteY8" fmla="*/ 112501 h 286109"/>
                <a:gd name="connsiteX9" fmla="*/ 238125 w 771573"/>
                <a:gd name="connsiteY9" fmla="*/ 108691 h 286109"/>
                <a:gd name="connsiteX10" fmla="*/ 251460 w 771573"/>
                <a:gd name="connsiteY10" fmla="*/ 101071 h 286109"/>
                <a:gd name="connsiteX11" fmla="*/ 259080 w 771573"/>
                <a:gd name="connsiteY11" fmla="*/ 99166 h 286109"/>
                <a:gd name="connsiteX12" fmla="*/ 276225 w 771573"/>
                <a:gd name="connsiteY12" fmla="*/ 93451 h 286109"/>
                <a:gd name="connsiteX13" fmla="*/ 283845 w 771573"/>
                <a:gd name="connsiteY13" fmla="*/ 91546 h 286109"/>
                <a:gd name="connsiteX14" fmla="*/ 319563 w 771573"/>
                <a:gd name="connsiteY14" fmla="*/ 82846 h 286109"/>
                <a:gd name="connsiteX15" fmla="*/ 372425 w 771573"/>
                <a:gd name="connsiteY15" fmla="*/ 78470 h 286109"/>
                <a:gd name="connsiteX16" fmla="*/ 456259 w 771573"/>
                <a:gd name="connsiteY16" fmla="*/ 78263 h 286109"/>
                <a:gd name="connsiteX17" fmla="*/ 521970 w 771573"/>
                <a:gd name="connsiteY17" fmla="*/ 85831 h 286109"/>
                <a:gd name="connsiteX18" fmla="*/ 537210 w 771573"/>
                <a:gd name="connsiteY18" fmla="*/ 89641 h 286109"/>
                <a:gd name="connsiteX19" fmla="*/ 542925 w 771573"/>
                <a:gd name="connsiteY19" fmla="*/ 93451 h 286109"/>
                <a:gd name="connsiteX20" fmla="*/ 550545 w 771573"/>
                <a:gd name="connsiteY20" fmla="*/ 97261 h 286109"/>
                <a:gd name="connsiteX21" fmla="*/ 565785 w 771573"/>
                <a:gd name="connsiteY21" fmla="*/ 104881 h 286109"/>
                <a:gd name="connsiteX22" fmla="*/ 575310 w 771573"/>
                <a:gd name="connsiteY22" fmla="*/ 114406 h 286109"/>
                <a:gd name="connsiteX23" fmla="*/ 581025 w 771573"/>
                <a:gd name="connsiteY23" fmla="*/ 118216 h 286109"/>
                <a:gd name="connsiteX24" fmla="*/ 600075 w 771573"/>
                <a:gd name="connsiteY24" fmla="*/ 133456 h 286109"/>
                <a:gd name="connsiteX25" fmla="*/ 607695 w 771573"/>
                <a:gd name="connsiteY25" fmla="*/ 142981 h 286109"/>
                <a:gd name="connsiteX26" fmla="*/ 621030 w 771573"/>
                <a:gd name="connsiteY26" fmla="*/ 156316 h 286109"/>
                <a:gd name="connsiteX27" fmla="*/ 628650 w 771573"/>
                <a:gd name="connsiteY27" fmla="*/ 167746 h 286109"/>
                <a:gd name="connsiteX28" fmla="*/ 638175 w 771573"/>
                <a:gd name="connsiteY28" fmla="*/ 182986 h 286109"/>
                <a:gd name="connsiteX29" fmla="*/ 647700 w 771573"/>
                <a:gd name="connsiteY29" fmla="*/ 200131 h 286109"/>
                <a:gd name="connsiteX30" fmla="*/ 657225 w 771573"/>
                <a:gd name="connsiteY30" fmla="*/ 211561 h 286109"/>
                <a:gd name="connsiteX31" fmla="*/ 668655 w 771573"/>
                <a:gd name="connsiteY31" fmla="*/ 219181 h 286109"/>
                <a:gd name="connsiteX32" fmla="*/ 672465 w 771573"/>
                <a:gd name="connsiteY32" fmla="*/ 224896 h 286109"/>
                <a:gd name="connsiteX33" fmla="*/ 678180 w 771573"/>
                <a:gd name="connsiteY33" fmla="*/ 226801 h 286109"/>
                <a:gd name="connsiteX34" fmla="*/ 681990 w 771573"/>
                <a:gd name="connsiteY34" fmla="*/ 234421 h 286109"/>
                <a:gd name="connsiteX35" fmla="*/ 697230 w 771573"/>
                <a:gd name="connsiteY35" fmla="*/ 251566 h 286109"/>
                <a:gd name="connsiteX36" fmla="*/ 701040 w 771573"/>
                <a:gd name="connsiteY36" fmla="*/ 266806 h 286109"/>
                <a:gd name="connsiteX37" fmla="*/ 710565 w 771573"/>
                <a:gd name="connsiteY37" fmla="*/ 276331 h 286109"/>
                <a:gd name="connsiteX38" fmla="*/ 723900 w 771573"/>
                <a:gd name="connsiteY38" fmla="*/ 274426 h 286109"/>
                <a:gd name="connsiteX39" fmla="*/ 727710 w 771573"/>
                <a:gd name="connsiteY39" fmla="*/ 268711 h 286109"/>
                <a:gd name="connsiteX40" fmla="*/ 741045 w 771573"/>
                <a:gd name="connsiteY40" fmla="*/ 255376 h 286109"/>
                <a:gd name="connsiteX41" fmla="*/ 746760 w 771573"/>
                <a:gd name="connsiteY41" fmla="*/ 249661 h 286109"/>
                <a:gd name="connsiteX42" fmla="*/ 754380 w 771573"/>
                <a:gd name="connsiteY42" fmla="*/ 243946 h 286109"/>
                <a:gd name="connsiteX43" fmla="*/ 762000 w 771573"/>
                <a:gd name="connsiteY43" fmla="*/ 240136 h 286109"/>
                <a:gd name="connsiteX44" fmla="*/ 767715 w 771573"/>
                <a:gd name="connsiteY44" fmla="*/ 236326 h 286109"/>
                <a:gd name="connsiteX45" fmla="*/ 771525 w 771573"/>
                <a:gd name="connsiteY45" fmla="*/ 230611 h 286109"/>
                <a:gd name="connsiteX46" fmla="*/ 765810 w 771573"/>
                <a:gd name="connsiteY46" fmla="*/ 200131 h 286109"/>
                <a:gd name="connsiteX47" fmla="*/ 762000 w 771573"/>
                <a:gd name="connsiteY47" fmla="*/ 194416 h 286109"/>
                <a:gd name="connsiteX48" fmla="*/ 756285 w 771573"/>
                <a:gd name="connsiteY48" fmla="*/ 181081 h 286109"/>
                <a:gd name="connsiteX49" fmla="*/ 748665 w 771573"/>
                <a:gd name="connsiteY49" fmla="*/ 165841 h 286109"/>
                <a:gd name="connsiteX50" fmla="*/ 739140 w 771573"/>
                <a:gd name="connsiteY50" fmla="*/ 152506 h 286109"/>
                <a:gd name="connsiteX51" fmla="*/ 737235 w 771573"/>
                <a:gd name="connsiteY51" fmla="*/ 146791 h 286109"/>
                <a:gd name="connsiteX52" fmla="*/ 727710 w 771573"/>
                <a:gd name="connsiteY52" fmla="*/ 135361 h 286109"/>
                <a:gd name="connsiteX53" fmla="*/ 720090 w 771573"/>
                <a:gd name="connsiteY53" fmla="*/ 129646 h 286109"/>
                <a:gd name="connsiteX54" fmla="*/ 714375 w 771573"/>
                <a:gd name="connsiteY54" fmla="*/ 127741 h 286109"/>
                <a:gd name="connsiteX55" fmla="*/ 702945 w 771573"/>
                <a:gd name="connsiteY55" fmla="*/ 118216 h 286109"/>
                <a:gd name="connsiteX56" fmla="*/ 697230 w 771573"/>
                <a:gd name="connsiteY56" fmla="*/ 112501 h 286109"/>
                <a:gd name="connsiteX57" fmla="*/ 691515 w 771573"/>
                <a:gd name="connsiteY57" fmla="*/ 108691 h 286109"/>
                <a:gd name="connsiteX58" fmla="*/ 683895 w 771573"/>
                <a:gd name="connsiteY58" fmla="*/ 102976 h 286109"/>
                <a:gd name="connsiteX59" fmla="*/ 676275 w 771573"/>
                <a:gd name="connsiteY59" fmla="*/ 99166 h 286109"/>
                <a:gd name="connsiteX60" fmla="*/ 664845 w 771573"/>
                <a:gd name="connsiteY60" fmla="*/ 95356 h 286109"/>
                <a:gd name="connsiteX61" fmla="*/ 655320 w 771573"/>
                <a:gd name="connsiteY61" fmla="*/ 89641 h 286109"/>
                <a:gd name="connsiteX62" fmla="*/ 640080 w 771573"/>
                <a:gd name="connsiteY62" fmla="*/ 83926 h 286109"/>
                <a:gd name="connsiteX63" fmla="*/ 626745 w 771573"/>
                <a:gd name="connsiteY63" fmla="*/ 74401 h 286109"/>
                <a:gd name="connsiteX64" fmla="*/ 621030 w 771573"/>
                <a:gd name="connsiteY64" fmla="*/ 72496 h 286109"/>
                <a:gd name="connsiteX65" fmla="*/ 609600 w 771573"/>
                <a:gd name="connsiteY65" fmla="*/ 64876 h 286109"/>
                <a:gd name="connsiteX66" fmla="*/ 598170 w 771573"/>
                <a:gd name="connsiteY66" fmla="*/ 59161 h 286109"/>
                <a:gd name="connsiteX67" fmla="*/ 592455 w 771573"/>
                <a:gd name="connsiteY67" fmla="*/ 55351 h 286109"/>
                <a:gd name="connsiteX68" fmla="*/ 584835 w 771573"/>
                <a:gd name="connsiteY68" fmla="*/ 49636 h 286109"/>
                <a:gd name="connsiteX69" fmla="*/ 573405 w 771573"/>
                <a:gd name="connsiteY69" fmla="*/ 45826 h 286109"/>
                <a:gd name="connsiteX70" fmla="*/ 567690 w 771573"/>
                <a:gd name="connsiteY70" fmla="*/ 42016 h 286109"/>
                <a:gd name="connsiteX71" fmla="*/ 556260 w 771573"/>
                <a:gd name="connsiteY71" fmla="*/ 38206 h 286109"/>
                <a:gd name="connsiteX72" fmla="*/ 548640 w 771573"/>
                <a:gd name="connsiteY72" fmla="*/ 34396 h 286109"/>
                <a:gd name="connsiteX73" fmla="*/ 537210 w 771573"/>
                <a:gd name="connsiteY73" fmla="*/ 26776 h 286109"/>
                <a:gd name="connsiteX74" fmla="*/ 493395 w 771573"/>
                <a:gd name="connsiteY74" fmla="*/ 17251 h 286109"/>
                <a:gd name="connsiteX75" fmla="*/ 485775 w 771573"/>
                <a:gd name="connsiteY75" fmla="*/ 15346 h 286109"/>
                <a:gd name="connsiteX76" fmla="*/ 472440 w 771573"/>
                <a:gd name="connsiteY76" fmla="*/ 11536 h 286109"/>
                <a:gd name="connsiteX77" fmla="*/ 409575 w 771573"/>
                <a:gd name="connsiteY77" fmla="*/ 3916 h 286109"/>
                <a:gd name="connsiteX78" fmla="*/ 360045 w 771573"/>
                <a:gd name="connsiteY78" fmla="*/ 106 h 286109"/>
                <a:gd name="connsiteX79" fmla="*/ 300990 w 771573"/>
                <a:gd name="connsiteY79" fmla="*/ 2011 h 286109"/>
                <a:gd name="connsiteX80" fmla="*/ 268605 w 771573"/>
                <a:gd name="connsiteY80" fmla="*/ 9631 h 286109"/>
                <a:gd name="connsiteX81" fmla="*/ 226695 w 771573"/>
                <a:gd name="connsiteY81" fmla="*/ 26776 h 286109"/>
                <a:gd name="connsiteX82" fmla="*/ 182880 w 771573"/>
                <a:gd name="connsiteY82" fmla="*/ 53446 h 286109"/>
                <a:gd name="connsiteX83" fmla="*/ 123825 w 771573"/>
                <a:gd name="connsiteY83" fmla="*/ 95356 h 286109"/>
                <a:gd name="connsiteX84" fmla="*/ 87630 w 771573"/>
                <a:gd name="connsiteY84" fmla="*/ 125836 h 286109"/>
                <a:gd name="connsiteX85" fmla="*/ 55245 w 771573"/>
                <a:gd name="connsiteY85" fmla="*/ 158221 h 286109"/>
                <a:gd name="connsiteX86" fmla="*/ 20955 w 771573"/>
                <a:gd name="connsiteY86" fmla="*/ 203941 h 286109"/>
                <a:gd name="connsiteX87" fmla="*/ 0 w 771573"/>
                <a:gd name="connsiteY87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1453 w 771573"/>
                <a:gd name="connsiteY7" fmla="*/ 123057 h 286109"/>
                <a:gd name="connsiteX8" fmla="*/ 238125 w 771573"/>
                <a:gd name="connsiteY8" fmla="*/ 108691 h 286109"/>
                <a:gd name="connsiteX9" fmla="*/ 251460 w 771573"/>
                <a:gd name="connsiteY9" fmla="*/ 101071 h 286109"/>
                <a:gd name="connsiteX10" fmla="*/ 259080 w 771573"/>
                <a:gd name="connsiteY10" fmla="*/ 99166 h 286109"/>
                <a:gd name="connsiteX11" fmla="*/ 276225 w 771573"/>
                <a:gd name="connsiteY11" fmla="*/ 93451 h 286109"/>
                <a:gd name="connsiteX12" fmla="*/ 283845 w 771573"/>
                <a:gd name="connsiteY12" fmla="*/ 91546 h 286109"/>
                <a:gd name="connsiteX13" fmla="*/ 319563 w 771573"/>
                <a:gd name="connsiteY13" fmla="*/ 82846 h 286109"/>
                <a:gd name="connsiteX14" fmla="*/ 372425 w 771573"/>
                <a:gd name="connsiteY14" fmla="*/ 78470 h 286109"/>
                <a:gd name="connsiteX15" fmla="*/ 456259 w 771573"/>
                <a:gd name="connsiteY15" fmla="*/ 78263 h 286109"/>
                <a:gd name="connsiteX16" fmla="*/ 521970 w 771573"/>
                <a:gd name="connsiteY16" fmla="*/ 85831 h 286109"/>
                <a:gd name="connsiteX17" fmla="*/ 537210 w 771573"/>
                <a:gd name="connsiteY17" fmla="*/ 89641 h 286109"/>
                <a:gd name="connsiteX18" fmla="*/ 542925 w 771573"/>
                <a:gd name="connsiteY18" fmla="*/ 93451 h 286109"/>
                <a:gd name="connsiteX19" fmla="*/ 550545 w 771573"/>
                <a:gd name="connsiteY19" fmla="*/ 97261 h 286109"/>
                <a:gd name="connsiteX20" fmla="*/ 565785 w 771573"/>
                <a:gd name="connsiteY20" fmla="*/ 104881 h 286109"/>
                <a:gd name="connsiteX21" fmla="*/ 575310 w 771573"/>
                <a:gd name="connsiteY21" fmla="*/ 114406 h 286109"/>
                <a:gd name="connsiteX22" fmla="*/ 581025 w 771573"/>
                <a:gd name="connsiteY22" fmla="*/ 118216 h 286109"/>
                <a:gd name="connsiteX23" fmla="*/ 600075 w 771573"/>
                <a:gd name="connsiteY23" fmla="*/ 133456 h 286109"/>
                <a:gd name="connsiteX24" fmla="*/ 607695 w 771573"/>
                <a:gd name="connsiteY24" fmla="*/ 142981 h 286109"/>
                <a:gd name="connsiteX25" fmla="*/ 621030 w 771573"/>
                <a:gd name="connsiteY25" fmla="*/ 156316 h 286109"/>
                <a:gd name="connsiteX26" fmla="*/ 628650 w 771573"/>
                <a:gd name="connsiteY26" fmla="*/ 167746 h 286109"/>
                <a:gd name="connsiteX27" fmla="*/ 638175 w 771573"/>
                <a:gd name="connsiteY27" fmla="*/ 182986 h 286109"/>
                <a:gd name="connsiteX28" fmla="*/ 647700 w 771573"/>
                <a:gd name="connsiteY28" fmla="*/ 200131 h 286109"/>
                <a:gd name="connsiteX29" fmla="*/ 657225 w 771573"/>
                <a:gd name="connsiteY29" fmla="*/ 211561 h 286109"/>
                <a:gd name="connsiteX30" fmla="*/ 668655 w 771573"/>
                <a:gd name="connsiteY30" fmla="*/ 219181 h 286109"/>
                <a:gd name="connsiteX31" fmla="*/ 672465 w 771573"/>
                <a:gd name="connsiteY31" fmla="*/ 224896 h 286109"/>
                <a:gd name="connsiteX32" fmla="*/ 678180 w 771573"/>
                <a:gd name="connsiteY32" fmla="*/ 226801 h 286109"/>
                <a:gd name="connsiteX33" fmla="*/ 681990 w 771573"/>
                <a:gd name="connsiteY33" fmla="*/ 234421 h 286109"/>
                <a:gd name="connsiteX34" fmla="*/ 697230 w 771573"/>
                <a:gd name="connsiteY34" fmla="*/ 251566 h 286109"/>
                <a:gd name="connsiteX35" fmla="*/ 701040 w 771573"/>
                <a:gd name="connsiteY35" fmla="*/ 266806 h 286109"/>
                <a:gd name="connsiteX36" fmla="*/ 710565 w 771573"/>
                <a:gd name="connsiteY36" fmla="*/ 276331 h 286109"/>
                <a:gd name="connsiteX37" fmla="*/ 723900 w 771573"/>
                <a:gd name="connsiteY37" fmla="*/ 274426 h 286109"/>
                <a:gd name="connsiteX38" fmla="*/ 727710 w 771573"/>
                <a:gd name="connsiteY38" fmla="*/ 268711 h 286109"/>
                <a:gd name="connsiteX39" fmla="*/ 741045 w 771573"/>
                <a:gd name="connsiteY39" fmla="*/ 255376 h 286109"/>
                <a:gd name="connsiteX40" fmla="*/ 746760 w 771573"/>
                <a:gd name="connsiteY40" fmla="*/ 249661 h 286109"/>
                <a:gd name="connsiteX41" fmla="*/ 754380 w 771573"/>
                <a:gd name="connsiteY41" fmla="*/ 243946 h 286109"/>
                <a:gd name="connsiteX42" fmla="*/ 762000 w 771573"/>
                <a:gd name="connsiteY42" fmla="*/ 240136 h 286109"/>
                <a:gd name="connsiteX43" fmla="*/ 767715 w 771573"/>
                <a:gd name="connsiteY43" fmla="*/ 236326 h 286109"/>
                <a:gd name="connsiteX44" fmla="*/ 771525 w 771573"/>
                <a:gd name="connsiteY44" fmla="*/ 230611 h 286109"/>
                <a:gd name="connsiteX45" fmla="*/ 765810 w 771573"/>
                <a:gd name="connsiteY45" fmla="*/ 200131 h 286109"/>
                <a:gd name="connsiteX46" fmla="*/ 762000 w 771573"/>
                <a:gd name="connsiteY46" fmla="*/ 194416 h 286109"/>
                <a:gd name="connsiteX47" fmla="*/ 756285 w 771573"/>
                <a:gd name="connsiteY47" fmla="*/ 181081 h 286109"/>
                <a:gd name="connsiteX48" fmla="*/ 748665 w 771573"/>
                <a:gd name="connsiteY48" fmla="*/ 165841 h 286109"/>
                <a:gd name="connsiteX49" fmla="*/ 739140 w 771573"/>
                <a:gd name="connsiteY49" fmla="*/ 152506 h 286109"/>
                <a:gd name="connsiteX50" fmla="*/ 737235 w 771573"/>
                <a:gd name="connsiteY50" fmla="*/ 146791 h 286109"/>
                <a:gd name="connsiteX51" fmla="*/ 727710 w 771573"/>
                <a:gd name="connsiteY51" fmla="*/ 135361 h 286109"/>
                <a:gd name="connsiteX52" fmla="*/ 720090 w 771573"/>
                <a:gd name="connsiteY52" fmla="*/ 129646 h 286109"/>
                <a:gd name="connsiteX53" fmla="*/ 714375 w 771573"/>
                <a:gd name="connsiteY53" fmla="*/ 127741 h 286109"/>
                <a:gd name="connsiteX54" fmla="*/ 702945 w 771573"/>
                <a:gd name="connsiteY54" fmla="*/ 118216 h 286109"/>
                <a:gd name="connsiteX55" fmla="*/ 697230 w 771573"/>
                <a:gd name="connsiteY55" fmla="*/ 112501 h 286109"/>
                <a:gd name="connsiteX56" fmla="*/ 691515 w 771573"/>
                <a:gd name="connsiteY56" fmla="*/ 108691 h 286109"/>
                <a:gd name="connsiteX57" fmla="*/ 683895 w 771573"/>
                <a:gd name="connsiteY57" fmla="*/ 102976 h 286109"/>
                <a:gd name="connsiteX58" fmla="*/ 676275 w 771573"/>
                <a:gd name="connsiteY58" fmla="*/ 99166 h 286109"/>
                <a:gd name="connsiteX59" fmla="*/ 664845 w 771573"/>
                <a:gd name="connsiteY59" fmla="*/ 95356 h 286109"/>
                <a:gd name="connsiteX60" fmla="*/ 655320 w 771573"/>
                <a:gd name="connsiteY60" fmla="*/ 89641 h 286109"/>
                <a:gd name="connsiteX61" fmla="*/ 640080 w 771573"/>
                <a:gd name="connsiteY61" fmla="*/ 83926 h 286109"/>
                <a:gd name="connsiteX62" fmla="*/ 626745 w 771573"/>
                <a:gd name="connsiteY62" fmla="*/ 74401 h 286109"/>
                <a:gd name="connsiteX63" fmla="*/ 621030 w 771573"/>
                <a:gd name="connsiteY63" fmla="*/ 72496 h 286109"/>
                <a:gd name="connsiteX64" fmla="*/ 609600 w 771573"/>
                <a:gd name="connsiteY64" fmla="*/ 64876 h 286109"/>
                <a:gd name="connsiteX65" fmla="*/ 598170 w 771573"/>
                <a:gd name="connsiteY65" fmla="*/ 59161 h 286109"/>
                <a:gd name="connsiteX66" fmla="*/ 592455 w 771573"/>
                <a:gd name="connsiteY66" fmla="*/ 55351 h 286109"/>
                <a:gd name="connsiteX67" fmla="*/ 584835 w 771573"/>
                <a:gd name="connsiteY67" fmla="*/ 49636 h 286109"/>
                <a:gd name="connsiteX68" fmla="*/ 573405 w 771573"/>
                <a:gd name="connsiteY68" fmla="*/ 45826 h 286109"/>
                <a:gd name="connsiteX69" fmla="*/ 567690 w 771573"/>
                <a:gd name="connsiteY69" fmla="*/ 42016 h 286109"/>
                <a:gd name="connsiteX70" fmla="*/ 556260 w 771573"/>
                <a:gd name="connsiteY70" fmla="*/ 38206 h 286109"/>
                <a:gd name="connsiteX71" fmla="*/ 548640 w 771573"/>
                <a:gd name="connsiteY71" fmla="*/ 34396 h 286109"/>
                <a:gd name="connsiteX72" fmla="*/ 537210 w 771573"/>
                <a:gd name="connsiteY72" fmla="*/ 26776 h 286109"/>
                <a:gd name="connsiteX73" fmla="*/ 493395 w 771573"/>
                <a:gd name="connsiteY73" fmla="*/ 17251 h 286109"/>
                <a:gd name="connsiteX74" fmla="*/ 485775 w 771573"/>
                <a:gd name="connsiteY74" fmla="*/ 15346 h 286109"/>
                <a:gd name="connsiteX75" fmla="*/ 472440 w 771573"/>
                <a:gd name="connsiteY75" fmla="*/ 11536 h 286109"/>
                <a:gd name="connsiteX76" fmla="*/ 409575 w 771573"/>
                <a:gd name="connsiteY76" fmla="*/ 3916 h 286109"/>
                <a:gd name="connsiteX77" fmla="*/ 360045 w 771573"/>
                <a:gd name="connsiteY77" fmla="*/ 106 h 286109"/>
                <a:gd name="connsiteX78" fmla="*/ 300990 w 771573"/>
                <a:gd name="connsiteY78" fmla="*/ 2011 h 286109"/>
                <a:gd name="connsiteX79" fmla="*/ 268605 w 771573"/>
                <a:gd name="connsiteY79" fmla="*/ 9631 h 286109"/>
                <a:gd name="connsiteX80" fmla="*/ 226695 w 771573"/>
                <a:gd name="connsiteY80" fmla="*/ 26776 h 286109"/>
                <a:gd name="connsiteX81" fmla="*/ 182880 w 771573"/>
                <a:gd name="connsiteY81" fmla="*/ 53446 h 286109"/>
                <a:gd name="connsiteX82" fmla="*/ 123825 w 771573"/>
                <a:gd name="connsiteY82" fmla="*/ 95356 h 286109"/>
                <a:gd name="connsiteX83" fmla="*/ 87630 w 771573"/>
                <a:gd name="connsiteY83" fmla="*/ 125836 h 286109"/>
                <a:gd name="connsiteX84" fmla="*/ 55245 w 771573"/>
                <a:gd name="connsiteY84" fmla="*/ 158221 h 286109"/>
                <a:gd name="connsiteX85" fmla="*/ 20955 w 771573"/>
                <a:gd name="connsiteY85" fmla="*/ 203941 h 286109"/>
                <a:gd name="connsiteX86" fmla="*/ 0 w 771573"/>
                <a:gd name="connsiteY86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1453 w 771573"/>
                <a:gd name="connsiteY7" fmla="*/ 123057 h 286109"/>
                <a:gd name="connsiteX8" fmla="*/ 251460 w 771573"/>
                <a:gd name="connsiteY8" fmla="*/ 101071 h 286109"/>
                <a:gd name="connsiteX9" fmla="*/ 259080 w 771573"/>
                <a:gd name="connsiteY9" fmla="*/ 99166 h 286109"/>
                <a:gd name="connsiteX10" fmla="*/ 276225 w 771573"/>
                <a:gd name="connsiteY10" fmla="*/ 93451 h 286109"/>
                <a:gd name="connsiteX11" fmla="*/ 283845 w 771573"/>
                <a:gd name="connsiteY11" fmla="*/ 91546 h 286109"/>
                <a:gd name="connsiteX12" fmla="*/ 319563 w 771573"/>
                <a:gd name="connsiteY12" fmla="*/ 82846 h 286109"/>
                <a:gd name="connsiteX13" fmla="*/ 372425 w 771573"/>
                <a:gd name="connsiteY13" fmla="*/ 78470 h 286109"/>
                <a:gd name="connsiteX14" fmla="*/ 456259 w 771573"/>
                <a:gd name="connsiteY14" fmla="*/ 78263 h 286109"/>
                <a:gd name="connsiteX15" fmla="*/ 521970 w 771573"/>
                <a:gd name="connsiteY15" fmla="*/ 85831 h 286109"/>
                <a:gd name="connsiteX16" fmla="*/ 537210 w 771573"/>
                <a:gd name="connsiteY16" fmla="*/ 89641 h 286109"/>
                <a:gd name="connsiteX17" fmla="*/ 542925 w 771573"/>
                <a:gd name="connsiteY17" fmla="*/ 93451 h 286109"/>
                <a:gd name="connsiteX18" fmla="*/ 550545 w 771573"/>
                <a:gd name="connsiteY18" fmla="*/ 97261 h 286109"/>
                <a:gd name="connsiteX19" fmla="*/ 565785 w 771573"/>
                <a:gd name="connsiteY19" fmla="*/ 104881 h 286109"/>
                <a:gd name="connsiteX20" fmla="*/ 575310 w 771573"/>
                <a:gd name="connsiteY20" fmla="*/ 114406 h 286109"/>
                <a:gd name="connsiteX21" fmla="*/ 581025 w 771573"/>
                <a:gd name="connsiteY21" fmla="*/ 118216 h 286109"/>
                <a:gd name="connsiteX22" fmla="*/ 600075 w 771573"/>
                <a:gd name="connsiteY22" fmla="*/ 133456 h 286109"/>
                <a:gd name="connsiteX23" fmla="*/ 607695 w 771573"/>
                <a:gd name="connsiteY23" fmla="*/ 142981 h 286109"/>
                <a:gd name="connsiteX24" fmla="*/ 621030 w 771573"/>
                <a:gd name="connsiteY24" fmla="*/ 156316 h 286109"/>
                <a:gd name="connsiteX25" fmla="*/ 628650 w 771573"/>
                <a:gd name="connsiteY25" fmla="*/ 167746 h 286109"/>
                <a:gd name="connsiteX26" fmla="*/ 638175 w 771573"/>
                <a:gd name="connsiteY26" fmla="*/ 182986 h 286109"/>
                <a:gd name="connsiteX27" fmla="*/ 647700 w 771573"/>
                <a:gd name="connsiteY27" fmla="*/ 200131 h 286109"/>
                <a:gd name="connsiteX28" fmla="*/ 657225 w 771573"/>
                <a:gd name="connsiteY28" fmla="*/ 211561 h 286109"/>
                <a:gd name="connsiteX29" fmla="*/ 668655 w 771573"/>
                <a:gd name="connsiteY29" fmla="*/ 219181 h 286109"/>
                <a:gd name="connsiteX30" fmla="*/ 672465 w 771573"/>
                <a:gd name="connsiteY30" fmla="*/ 224896 h 286109"/>
                <a:gd name="connsiteX31" fmla="*/ 678180 w 771573"/>
                <a:gd name="connsiteY31" fmla="*/ 226801 h 286109"/>
                <a:gd name="connsiteX32" fmla="*/ 681990 w 771573"/>
                <a:gd name="connsiteY32" fmla="*/ 234421 h 286109"/>
                <a:gd name="connsiteX33" fmla="*/ 697230 w 771573"/>
                <a:gd name="connsiteY33" fmla="*/ 251566 h 286109"/>
                <a:gd name="connsiteX34" fmla="*/ 701040 w 771573"/>
                <a:gd name="connsiteY34" fmla="*/ 266806 h 286109"/>
                <a:gd name="connsiteX35" fmla="*/ 710565 w 771573"/>
                <a:gd name="connsiteY35" fmla="*/ 276331 h 286109"/>
                <a:gd name="connsiteX36" fmla="*/ 723900 w 771573"/>
                <a:gd name="connsiteY36" fmla="*/ 274426 h 286109"/>
                <a:gd name="connsiteX37" fmla="*/ 727710 w 771573"/>
                <a:gd name="connsiteY37" fmla="*/ 268711 h 286109"/>
                <a:gd name="connsiteX38" fmla="*/ 741045 w 771573"/>
                <a:gd name="connsiteY38" fmla="*/ 255376 h 286109"/>
                <a:gd name="connsiteX39" fmla="*/ 746760 w 771573"/>
                <a:gd name="connsiteY39" fmla="*/ 249661 h 286109"/>
                <a:gd name="connsiteX40" fmla="*/ 754380 w 771573"/>
                <a:gd name="connsiteY40" fmla="*/ 243946 h 286109"/>
                <a:gd name="connsiteX41" fmla="*/ 762000 w 771573"/>
                <a:gd name="connsiteY41" fmla="*/ 240136 h 286109"/>
                <a:gd name="connsiteX42" fmla="*/ 767715 w 771573"/>
                <a:gd name="connsiteY42" fmla="*/ 236326 h 286109"/>
                <a:gd name="connsiteX43" fmla="*/ 771525 w 771573"/>
                <a:gd name="connsiteY43" fmla="*/ 230611 h 286109"/>
                <a:gd name="connsiteX44" fmla="*/ 765810 w 771573"/>
                <a:gd name="connsiteY44" fmla="*/ 200131 h 286109"/>
                <a:gd name="connsiteX45" fmla="*/ 762000 w 771573"/>
                <a:gd name="connsiteY45" fmla="*/ 194416 h 286109"/>
                <a:gd name="connsiteX46" fmla="*/ 756285 w 771573"/>
                <a:gd name="connsiteY46" fmla="*/ 181081 h 286109"/>
                <a:gd name="connsiteX47" fmla="*/ 748665 w 771573"/>
                <a:gd name="connsiteY47" fmla="*/ 165841 h 286109"/>
                <a:gd name="connsiteX48" fmla="*/ 739140 w 771573"/>
                <a:gd name="connsiteY48" fmla="*/ 152506 h 286109"/>
                <a:gd name="connsiteX49" fmla="*/ 737235 w 771573"/>
                <a:gd name="connsiteY49" fmla="*/ 146791 h 286109"/>
                <a:gd name="connsiteX50" fmla="*/ 727710 w 771573"/>
                <a:gd name="connsiteY50" fmla="*/ 135361 h 286109"/>
                <a:gd name="connsiteX51" fmla="*/ 720090 w 771573"/>
                <a:gd name="connsiteY51" fmla="*/ 129646 h 286109"/>
                <a:gd name="connsiteX52" fmla="*/ 714375 w 771573"/>
                <a:gd name="connsiteY52" fmla="*/ 127741 h 286109"/>
                <a:gd name="connsiteX53" fmla="*/ 702945 w 771573"/>
                <a:gd name="connsiteY53" fmla="*/ 118216 h 286109"/>
                <a:gd name="connsiteX54" fmla="*/ 697230 w 771573"/>
                <a:gd name="connsiteY54" fmla="*/ 112501 h 286109"/>
                <a:gd name="connsiteX55" fmla="*/ 691515 w 771573"/>
                <a:gd name="connsiteY55" fmla="*/ 108691 h 286109"/>
                <a:gd name="connsiteX56" fmla="*/ 683895 w 771573"/>
                <a:gd name="connsiteY56" fmla="*/ 102976 h 286109"/>
                <a:gd name="connsiteX57" fmla="*/ 676275 w 771573"/>
                <a:gd name="connsiteY57" fmla="*/ 99166 h 286109"/>
                <a:gd name="connsiteX58" fmla="*/ 664845 w 771573"/>
                <a:gd name="connsiteY58" fmla="*/ 95356 h 286109"/>
                <a:gd name="connsiteX59" fmla="*/ 655320 w 771573"/>
                <a:gd name="connsiteY59" fmla="*/ 89641 h 286109"/>
                <a:gd name="connsiteX60" fmla="*/ 640080 w 771573"/>
                <a:gd name="connsiteY60" fmla="*/ 83926 h 286109"/>
                <a:gd name="connsiteX61" fmla="*/ 626745 w 771573"/>
                <a:gd name="connsiteY61" fmla="*/ 74401 h 286109"/>
                <a:gd name="connsiteX62" fmla="*/ 621030 w 771573"/>
                <a:gd name="connsiteY62" fmla="*/ 72496 h 286109"/>
                <a:gd name="connsiteX63" fmla="*/ 609600 w 771573"/>
                <a:gd name="connsiteY63" fmla="*/ 64876 h 286109"/>
                <a:gd name="connsiteX64" fmla="*/ 598170 w 771573"/>
                <a:gd name="connsiteY64" fmla="*/ 59161 h 286109"/>
                <a:gd name="connsiteX65" fmla="*/ 592455 w 771573"/>
                <a:gd name="connsiteY65" fmla="*/ 55351 h 286109"/>
                <a:gd name="connsiteX66" fmla="*/ 584835 w 771573"/>
                <a:gd name="connsiteY66" fmla="*/ 49636 h 286109"/>
                <a:gd name="connsiteX67" fmla="*/ 573405 w 771573"/>
                <a:gd name="connsiteY67" fmla="*/ 45826 h 286109"/>
                <a:gd name="connsiteX68" fmla="*/ 567690 w 771573"/>
                <a:gd name="connsiteY68" fmla="*/ 42016 h 286109"/>
                <a:gd name="connsiteX69" fmla="*/ 556260 w 771573"/>
                <a:gd name="connsiteY69" fmla="*/ 38206 h 286109"/>
                <a:gd name="connsiteX70" fmla="*/ 548640 w 771573"/>
                <a:gd name="connsiteY70" fmla="*/ 34396 h 286109"/>
                <a:gd name="connsiteX71" fmla="*/ 537210 w 771573"/>
                <a:gd name="connsiteY71" fmla="*/ 26776 h 286109"/>
                <a:gd name="connsiteX72" fmla="*/ 493395 w 771573"/>
                <a:gd name="connsiteY72" fmla="*/ 17251 h 286109"/>
                <a:gd name="connsiteX73" fmla="*/ 485775 w 771573"/>
                <a:gd name="connsiteY73" fmla="*/ 15346 h 286109"/>
                <a:gd name="connsiteX74" fmla="*/ 472440 w 771573"/>
                <a:gd name="connsiteY74" fmla="*/ 11536 h 286109"/>
                <a:gd name="connsiteX75" fmla="*/ 409575 w 771573"/>
                <a:gd name="connsiteY75" fmla="*/ 3916 h 286109"/>
                <a:gd name="connsiteX76" fmla="*/ 360045 w 771573"/>
                <a:gd name="connsiteY76" fmla="*/ 106 h 286109"/>
                <a:gd name="connsiteX77" fmla="*/ 300990 w 771573"/>
                <a:gd name="connsiteY77" fmla="*/ 2011 h 286109"/>
                <a:gd name="connsiteX78" fmla="*/ 268605 w 771573"/>
                <a:gd name="connsiteY78" fmla="*/ 9631 h 286109"/>
                <a:gd name="connsiteX79" fmla="*/ 226695 w 771573"/>
                <a:gd name="connsiteY79" fmla="*/ 26776 h 286109"/>
                <a:gd name="connsiteX80" fmla="*/ 182880 w 771573"/>
                <a:gd name="connsiteY80" fmla="*/ 53446 h 286109"/>
                <a:gd name="connsiteX81" fmla="*/ 123825 w 771573"/>
                <a:gd name="connsiteY81" fmla="*/ 95356 h 286109"/>
                <a:gd name="connsiteX82" fmla="*/ 87630 w 771573"/>
                <a:gd name="connsiteY82" fmla="*/ 125836 h 286109"/>
                <a:gd name="connsiteX83" fmla="*/ 55245 w 771573"/>
                <a:gd name="connsiteY83" fmla="*/ 158221 h 286109"/>
                <a:gd name="connsiteX84" fmla="*/ 20955 w 771573"/>
                <a:gd name="connsiteY84" fmla="*/ 203941 h 286109"/>
                <a:gd name="connsiteX85" fmla="*/ 0 w 771573"/>
                <a:gd name="connsiteY85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1453 w 771573"/>
                <a:gd name="connsiteY7" fmla="*/ 123057 h 286109"/>
                <a:gd name="connsiteX8" fmla="*/ 259080 w 771573"/>
                <a:gd name="connsiteY8" fmla="*/ 99166 h 286109"/>
                <a:gd name="connsiteX9" fmla="*/ 276225 w 771573"/>
                <a:gd name="connsiteY9" fmla="*/ 93451 h 286109"/>
                <a:gd name="connsiteX10" fmla="*/ 283845 w 771573"/>
                <a:gd name="connsiteY10" fmla="*/ 91546 h 286109"/>
                <a:gd name="connsiteX11" fmla="*/ 319563 w 771573"/>
                <a:gd name="connsiteY11" fmla="*/ 82846 h 286109"/>
                <a:gd name="connsiteX12" fmla="*/ 372425 w 771573"/>
                <a:gd name="connsiteY12" fmla="*/ 78470 h 286109"/>
                <a:gd name="connsiteX13" fmla="*/ 456259 w 771573"/>
                <a:gd name="connsiteY13" fmla="*/ 78263 h 286109"/>
                <a:gd name="connsiteX14" fmla="*/ 521970 w 771573"/>
                <a:gd name="connsiteY14" fmla="*/ 85831 h 286109"/>
                <a:gd name="connsiteX15" fmla="*/ 537210 w 771573"/>
                <a:gd name="connsiteY15" fmla="*/ 89641 h 286109"/>
                <a:gd name="connsiteX16" fmla="*/ 542925 w 771573"/>
                <a:gd name="connsiteY16" fmla="*/ 93451 h 286109"/>
                <a:gd name="connsiteX17" fmla="*/ 550545 w 771573"/>
                <a:gd name="connsiteY17" fmla="*/ 97261 h 286109"/>
                <a:gd name="connsiteX18" fmla="*/ 565785 w 771573"/>
                <a:gd name="connsiteY18" fmla="*/ 104881 h 286109"/>
                <a:gd name="connsiteX19" fmla="*/ 575310 w 771573"/>
                <a:gd name="connsiteY19" fmla="*/ 114406 h 286109"/>
                <a:gd name="connsiteX20" fmla="*/ 581025 w 771573"/>
                <a:gd name="connsiteY20" fmla="*/ 118216 h 286109"/>
                <a:gd name="connsiteX21" fmla="*/ 600075 w 771573"/>
                <a:gd name="connsiteY21" fmla="*/ 133456 h 286109"/>
                <a:gd name="connsiteX22" fmla="*/ 607695 w 771573"/>
                <a:gd name="connsiteY22" fmla="*/ 142981 h 286109"/>
                <a:gd name="connsiteX23" fmla="*/ 621030 w 771573"/>
                <a:gd name="connsiteY23" fmla="*/ 156316 h 286109"/>
                <a:gd name="connsiteX24" fmla="*/ 628650 w 771573"/>
                <a:gd name="connsiteY24" fmla="*/ 167746 h 286109"/>
                <a:gd name="connsiteX25" fmla="*/ 638175 w 771573"/>
                <a:gd name="connsiteY25" fmla="*/ 182986 h 286109"/>
                <a:gd name="connsiteX26" fmla="*/ 647700 w 771573"/>
                <a:gd name="connsiteY26" fmla="*/ 200131 h 286109"/>
                <a:gd name="connsiteX27" fmla="*/ 657225 w 771573"/>
                <a:gd name="connsiteY27" fmla="*/ 211561 h 286109"/>
                <a:gd name="connsiteX28" fmla="*/ 668655 w 771573"/>
                <a:gd name="connsiteY28" fmla="*/ 219181 h 286109"/>
                <a:gd name="connsiteX29" fmla="*/ 672465 w 771573"/>
                <a:gd name="connsiteY29" fmla="*/ 224896 h 286109"/>
                <a:gd name="connsiteX30" fmla="*/ 678180 w 771573"/>
                <a:gd name="connsiteY30" fmla="*/ 226801 h 286109"/>
                <a:gd name="connsiteX31" fmla="*/ 681990 w 771573"/>
                <a:gd name="connsiteY31" fmla="*/ 234421 h 286109"/>
                <a:gd name="connsiteX32" fmla="*/ 697230 w 771573"/>
                <a:gd name="connsiteY32" fmla="*/ 251566 h 286109"/>
                <a:gd name="connsiteX33" fmla="*/ 701040 w 771573"/>
                <a:gd name="connsiteY33" fmla="*/ 266806 h 286109"/>
                <a:gd name="connsiteX34" fmla="*/ 710565 w 771573"/>
                <a:gd name="connsiteY34" fmla="*/ 276331 h 286109"/>
                <a:gd name="connsiteX35" fmla="*/ 723900 w 771573"/>
                <a:gd name="connsiteY35" fmla="*/ 274426 h 286109"/>
                <a:gd name="connsiteX36" fmla="*/ 727710 w 771573"/>
                <a:gd name="connsiteY36" fmla="*/ 268711 h 286109"/>
                <a:gd name="connsiteX37" fmla="*/ 741045 w 771573"/>
                <a:gd name="connsiteY37" fmla="*/ 255376 h 286109"/>
                <a:gd name="connsiteX38" fmla="*/ 746760 w 771573"/>
                <a:gd name="connsiteY38" fmla="*/ 249661 h 286109"/>
                <a:gd name="connsiteX39" fmla="*/ 754380 w 771573"/>
                <a:gd name="connsiteY39" fmla="*/ 243946 h 286109"/>
                <a:gd name="connsiteX40" fmla="*/ 762000 w 771573"/>
                <a:gd name="connsiteY40" fmla="*/ 240136 h 286109"/>
                <a:gd name="connsiteX41" fmla="*/ 767715 w 771573"/>
                <a:gd name="connsiteY41" fmla="*/ 236326 h 286109"/>
                <a:gd name="connsiteX42" fmla="*/ 771525 w 771573"/>
                <a:gd name="connsiteY42" fmla="*/ 230611 h 286109"/>
                <a:gd name="connsiteX43" fmla="*/ 765810 w 771573"/>
                <a:gd name="connsiteY43" fmla="*/ 200131 h 286109"/>
                <a:gd name="connsiteX44" fmla="*/ 762000 w 771573"/>
                <a:gd name="connsiteY44" fmla="*/ 194416 h 286109"/>
                <a:gd name="connsiteX45" fmla="*/ 756285 w 771573"/>
                <a:gd name="connsiteY45" fmla="*/ 181081 h 286109"/>
                <a:gd name="connsiteX46" fmla="*/ 748665 w 771573"/>
                <a:gd name="connsiteY46" fmla="*/ 165841 h 286109"/>
                <a:gd name="connsiteX47" fmla="*/ 739140 w 771573"/>
                <a:gd name="connsiteY47" fmla="*/ 152506 h 286109"/>
                <a:gd name="connsiteX48" fmla="*/ 737235 w 771573"/>
                <a:gd name="connsiteY48" fmla="*/ 146791 h 286109"/>
                <a:gd name="connsiteX49" fmla="*/ 727710 w 771573"/>
                <a:gd name="connsiteY49" fmla="*/ 135361 h 286109"/>
                <a:gd name="connsiteX50" fmla="*/ 720090 w 771573"/>
                <a:gd name="connsiteY50" fmla="*/ 129646 h 286109"/>
                <a:gd name="connsiteX51" fmla="*/ 714375 w 771573"/>
                <a:gd name="connsiteY51" fmla="*/ 127741 h 286109"/>
                <a:gd name="connsiteX52" fmla="*/ 702945 w 771573"/>
                <a:gd name="connsiteY52" fmla="*/ 118216 h 286109"/>
                <a:gd name="connsiteX53" fmla="*/ 697230 w 771573"/>
                <a:gd name="connsiteY53" fmla="*/ 112501 h 286109"/>
                <a:gd name="connsiteX54" fmla="*/ 691515 w 771573"/>
                <a:gd name="connsiteY54" fmla="*/ 108691 h 286109"/>
                <a:gd name="connsiteX55" fmla="*/ 683895 w 771573"/>
                <a:gd name="connsiteY55" fmla="*/ 102976 h 286109"/>
                <a:gd name="connsiteX56" fmla="*/ 676275 w 771573"/>
                <a:gd name="connsiteY56" fmla="*/ 99166 h 286109"/>
                <a:gd name="connsiteX57" fmla="*/ 664845 w 771573"/>
                <a:gd name="connsiteY57" fmla="*/ 95356 h 286109"/>
                <a:gd name="connsiteX58" fmla="*/ 655320 w 771573"/>
                <a:gd name="connsiteY58" fmla="*/ 89641 h 286109"/>
                <a:gd name="connsiteX59" fmla="*/ 640080 w 771573"/>
                <a:gd name="connsiteY59" fmla="*/ 83926 h 286109"/>
                <a:gd name="connsiteX60" fmla="*/ 626745 w 771573"/>
                <a:gd name="connsiteY60" fmla="*/ 74401 h 286109"/>
                <a:gd name="connsiteX61" fmla="*/ 621030 w 771573"/>
                <a:gd name="connsiteY61" fmla="*/ 72496 h 286109"/>
                <a:gd name="connsiteX62" fmla="*/ 609600 w 771573"/>
                <a:gd name="connsiteY62" fmla="*/ 64876 h 286109"/>
                <a:gd name="connsiteX63" fmla="*/ 598170 w 771573"/>
                <a:gd name="connsiteY63" fmla="*/ 59161 h 286109"/>
                <a:gd name="connsiteX64" fmla="*/ 592455 w 771573"/>
                <a:gd name="connsiteY64" fmla="*/ 55351 h 286109"/>
                <a:gd name="connsiteX65" fmla="*/ 584835 w 771573"/>
                <a:gd name="connsiteY65" fmla="*/ 49636 h 286109"/>
                <a:gd name="connsiteX66" fmla="*/ 573405 w 771573"/>
                <a:gd name="connsiteY66" fmla="*/ 45826 h 286109"/>
                <a:gd name="connsiteX67" fmla="*/ 567690 w 771573"/>
                <a:gd name="connsiteY67" fmla="*/ 42016 h 286109"/>
                <a:gd name="connsiteX68" fmla="*/ 556260 w 771573"/>
                <a:gd name="connsiteY68" fmla="*/ 38206 h 286109"/>
                <a:gd name="connsiteX69" fmla="*/ 548640 w 771573"/>
                <a:gd name="connsiteY69" fmla="*/ 34396 h 286109"/>
                <a:gd name="connsiteX70" fmla="*/ 537210 w 771573"/>
                <a:gd name="connsiteY70" fmla="*/ 26776 h 286109"/>
                <a:gd name="connsiteX71" fmla="*/ 493395 w 771573"/>
                <a:gd name="connsiteY71" fmla="*/ 17251 h 286109"/>
                <a:gd name="connsiteX72" fmla="*/ 485775 w 771573"/>
                <a:gd name="connsiteY72" fmla="*/ 15346 h 286109"/>
                <a:gd name="connsiteX73" fmla="*/ 472440 w 771573"/>
                <a:gd name="connsiteY73" fmla="*/ 11536 h 286109"/>
                <a:gd name="connsiteX74" fmla="*/ 409575 w 771573"/>
                <a:gd name="connsiteY74" fmla="*/ 3916 h 286109"/>
                <a:gd name="connsiteX75" fmla="*/ 360045 w 771573"/>
                <a:gd name="connsiteY75" fmla="*/ 106 h 286109"/>
                <a:gd name="connsiteX76" fmla="*/ 300990 w 771573"/>
                <a:gd name="connsiteY76" fmla="*/ 2011 h 286109"/>
                <a:gd name="connsiteX77" fmla="*/ 268605 w 771573"/>
                <a:gd name="connsiteY77" fmla="*/ 9631 h 286109"/>
                <a:gd name="connsiteX78" fmla="*/ 226695 w 771573"/>
                <a:gd name="connsiteY78" fmla="*/ 26776 h 286109"/>
                <a:gd name="connsiteX79" fmla="*/ 182880 w 771573"/>
                <a:gd name="connsiteY79" fmla="*/ 53446 h 286109"/>
                <a:gd name="connsiteX80" fmla="*/ 123825 w 771573"/>
                <a:gd name="connsiteY80" fmla="*/ 95356 h 286109"/>
                <a:gd name="connsiteX81" fmla="*/ 87630 w 771573"/>
                <a:gd name="connsiteY81" fmla="*/ 125836 h 286109"/>
                <a:gd name="connsiteX82" fmla="*/ 55245 w 771573"/>
                <a:gd name="connsiteY82" fmla="*/ 158221 h 286109"/>
                <a:gd name="connsiteX83" fmla="*/ 20955 w 771573"/>
                <a:gd name="connsiteY83" fmla="*/ 203941 h 286109"/>
                <a:gd name="connsiteX84" fmla="*/ 0 w 771573"/>
                <a:gd name="connsiteY84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1453 w 771573"/>
                <a:gd name="connsiteY7" fmla="*/ 123057 h 286109"/>
                <a:gd name="connsiteX8" fmla="*/ 259080 w 771573"/>
                <a:gd name="connsiteY8" fmla="*/ 99166 h 286109"/>
                <a:gd name="connsiteX9" fmla="*/ 276225 w 771573"/>
                <a:gd name="connsiteY9" fmla="*/ 93451 h 286109"/>
                <a:gd name="connsiteX10" fmla="*/ 319563 w 771573"/>
                <a:gd name="connsiteY10" fmla="*/ 82846 h 286109"/>
                <a:gd name="connsiteX11" fmla="*/ 372425 w 771573"/>
                <a:gd name="connsiteY11" fmla="*/ 78470 h 286109"/>
                <a:gd name="connsiteX12" fmla="*/ 456259 w 771573"/>
                <a:gd name="connsiteY12" fmla="*/ 78263 h 286109"/>
                <a:gd name="connsiteX13" fmla="*/ 521970 w 771573"/>
                <a:gd name="connsiteY13" fmla="*/ 85831 h 286109"/>
                <a:gd name="connsiteX14" fmla="*/ 537210 w 771573"/>
                <a:gd name="connsiteY14" fmla="*/ 89641 h 286109"/>
                <a:gd name="connsiteX15" fmla="*/ 542925 w 771573"/>
                <a:gd name="connsiteY15" fmla="*/ 93451 h 286109"/>
                <a:gd name="connsiteX16" fmla="*/ 550545 w 771573"/>
                <a:gd name="connsiteY16" fmla="*/ 97261 h 286109"/>
                <a:gd name="connsiteX17" fmla="*/ 565785 w 771573"/>
                <a:gd name="connsiteY17" fmla="*/ 104881 h 286109"/>
                <a:gd name="connsiteX18" fmla="*/ 575310 w 771573"/>
                <a:gd name="connsiteY18" fmla="*/ 114406 h 286109"/>
                <a:gd name="connsiteX19" fmla="*/ 581025 w 771573"/>
                <a:gd name="connsiteY19" fmla="*/ 118216 h 286109"/>
                <a:gd name="connsiteX20" fmla="*/ 600075 w 771573"/>
                <a:gd name="connsiteY20" fmla="*/ 133456 h 286109"/>
                <a:gd name="connsiteX21" fmla="*/ 607695 w 771573"/>
                <a:gd name="connsiteY21" fmla="*/ 142981 h 286109"/>
                <a:gd name="connsiteX22" fmla="*/ 621030 w 771573"/>
                <a:gd name="connsiteY22" fmla="*/ 156316 h 286109"/>
                <a:gd name="connsiteX23" fmla="*/ 628650 w 771573"/>
                <a:gd name="connsiteY23" fmla="*/ 167746 h 286109"/>
                <a:gd name="connsiteX24" fmla="*/ 638175 w 771573"/>
                <a:gd name="connsiteY24" fmla="*/ 182986 h 286109"/>
                <a:gd name="connsiteX25" fmla="*/ 647700 w 771573"/>
                <a:gd name="connsiteY25" fmla="*/ 200131 h 286109"/>
                <a:gd name="connsiteX26" fmla="*/ 657225 w 771573"/>
                <a:gd name="connsiteY26" fmla="*/ 211561 h 286109"/>
                <a:gd name="connsiteX27" fmla="*/ 668655 w 771573"/>
                <a:gd name="connsiteY27" fmla="*/ 219181 h 286109"/>
                <a:gd name="connsiteX28" fmla="*/ 672465 w 771573"/>
                <a:gd name="connsiteY28" fmla="*/ 224896 h 286109"/>
                <a:gd name="connsiteX29" fmla="*/ 678180 w 771573"/>
                <a:gd name="connsiteY29" fmla="*/ 226801 h 286109"/>
                <a:gd name="connsiteX30" fmla="*/ 681990 w 771573"/>
                <a:gd name="connsiteY30" fmla="*/ 234421 h 286109"/>
                <a:gd name="connsiteX31" fmla="*/ 697230 w 771573"/>
                <a:gd name="connsiteY31" fmla="*/ 251566 h 286109"/>
                <a:gd name="connsiteX32" fmla="*/ 701040 w 771573"/>
                <a:gd name="connsiteY32" fmla="*/ 266806 h 286109"/>
                <a:gd name="connsiteX33" fmla="*/ 710565 w 771573"/>
                <a:gd name="connsiteY33" fmla="*/ 276331 h 286109"/>
                <a:gd name="connsiteX34" fmla="*/ 723900 w 771573"/>
                <a:gd name="connsiteY34" fmla="*/ 274426 h 286109"/>
                <a:gd name="connsiteX35" fmla="*/ 727710 w 771573"/>
                <a:gd name="connsiteY35" fmla="*/ 268711 h 286109"/>
                <a:gd name="connsiteX36" fmla="*/ 741045 w 771573"/>
                <a:gd name="connsiteY36" fmla="*/ 255376 h 286109"/>
                <a:gd name="connsiteX37" fmla="*/ 746760 w 771573"/>
                <a:gd name="connsiteY37" fmla="*/ 249661 h 286109"/>
                <a:gd name="connsiteX38" fmla="*/ 754380 w 771573"/>
                <a:gd name="connsiteY38" fmla="*/ 243946 h 286109"/>
                <a:gd name="connsiteX39" fmla="*/ 762000 w 771573"/>
                <a:gd name="connsiteY39" fmla="*/ 240136 h 286109"/>
                <a:gd name="connsiteX40" fmla="*/ 767715 w 771573"/>
                <a:gd name="connsiteY40" fmla="*/ 236326 h 286109"/>
                <a:gd name="connsiteX41" fmla="*/ 771525 w 771573"/>
                <a:gd name="connsiteY41" fmla="*/ 230611 h 286109"/>
                <a:gd name="connsiteX42" fmla="*/ 765810 w 771573"/>
                <a:gd name="connsiteY42" fmla="*/ 200131 h 286109"/>
                <a:gd name="connsiteX43" fmla="*/ 762000 w 771573"/>
                <a:gd name="connsiteY43" fmla="*/ 194416 h 286109"/>
                <a:gd name="connsiteX44" fmla="*/ 756285 w 771573"/>
                <a:gd name="connsiteY44" fmla="*/ 181081 h 286109"/>
                <a:gd name="connsiteX45" fmla="*/ 748665 w 771573"/>
                <a:gd name="connsiteY45" fmla="*/ 165841 h 286109"/>
                <a:gd name="connsiteX46" fmla="*/ 739140 w 771573"/>
                <a:gd name="connsiteY46" fmla="*/ 152506 h 286109"/>
                <a:gd name="connsiteX47" fmla="*/ 737235 w 771573"/>
                <a:gd name="connsiteY47" fmla="*/ 146791 h 286109"/>
                <a:gd name="connsiteX48" fmla="*/ 727710 w 771573"/>
                <a:gd name="connsiteY48" fmla="*/ 135361 h 286109"/>
                <a:gd name="connsiteX49" fmla="*/ 720090 w 771573"/>
                <a:gd name="connsiteY49" fmla="*/ 129646 h 286109"/>
                <a:gd name="connsiteX50" fmla="*/ 714375 w 771573"/>
                <a:gd name="connsiteY50" fmla="*/ 127741 h 286109"/>
                <a:gd name="connsiteX51" fmla="*/ 702945 w 771573"/>
                <a:gd name="connsiteY51" fmla="*/ 118216 h 286109"/>
                <a:gd name="connsiteX52" fmla="*/ 697230 w 771573"/>
                <a:gd name="connsiteY52" fmla="*/ 112501 h 286109"/>
                <a:gd name="connsiteX53" fmla="*/ 691515 w 771573"/>
                <a:gd name="connsiteY53" fmla="*/ 108691 h 286109"/>
                <a:gd name="connsiteX54" fmla="*/ 683895 w 771573"/>
                <a:gd name="connsiteY54" fmla="*/ 102976 h 286109"/>
                <a:gd name="connsiteX55" fmla="*/ 676275 w 771573"/>
                <a:gd name="connsiteY55" fmla="*/ 99166 h 286109"/>
                <a:gd name="connsiteX56" fmla="*/ 664845 w 771573"/>
                <a:gd name="connsiteY56" fmla="*/ 95356 h 286109"/>
                <a:gd name="connsiteX57" fmla="*/ 655320 w 771573"/>
                <a:gd name="connsiteY57" fmla="*/ 89641 h 286109"/>
                <a:gd name="connsiteX58" fmla="*/ 640080 w 771573"/>
                <a:gd name="connsiteY58" fmla="*/ 83926 h 286109"/>
                <a:gd name="connsiteX59" fmla="*/ 626745 w 771573"/>
                <a:gd name="connsiteY59" fmla="*/ 74401 h 286109"/>
                <a:gd name="connsiteX60" fmla="*/ 621030 w 771573"/>
                <a:gd name="connsiteY60" fmla="*/ 72496 h 286109"/>
                <a:gd name="connsiteX61" fmla="*/ 609600 w 771573"/>
                <a:gd name="connsiteY61" fmla="*/ 64876 h 286109"/>
                <a:gd name="connsiteX62" fmla="*/ 598170 w 771573"/>
                <a:gd name="connsiteY62" fmla="*/ 59161 h 286109"/>
                <a:gd name="connsiteX63" fmla="*/ 592455 w 771573"/>
                <a:gd name="connsiteY63" fmla="*/ 55351 h 286109"/>
                <a:gd name="connsiteX64" fmla="*/ 584835 w 771573"/>
                <a:gd name="connsiteY64" fmla="*/ 49636 h 286109"/>
                <a:gd name="connsiteX65" fmla="*/ 573405 w 771573"/>
                <a:gd name="connsiteY65" fmla="*/ 45826 h 286109"/>
                <a:gd name="connsiteX66" fmla="*/ 567690 w 771573"/>
                <a:gd name="connsiteY66" fmla="*/ 42016 h 286109"/>
                <a:gd name="connsiteX67" fmla="*/ 556260 w 771573"/>
                <a:gd name="connsiteY67" fmla="*/ 38206 h 286109"/>
                <a:gd name="connsiteX68" fmla="*/ 548640 w 771573"/>
                <a:gd name="connsiteY68" fmla="*/ 34396 h 286109"/>
                <a:gd name="connsiteX69" fmla="*/ 537210 w 771573"/>
                <a:gd name="connsiteY69" fmla="*/ 26776 h 286109"/>
                <a:gd name="connsiteX70" fmla="*/ 493395 w 771573"/>
                <a:gd name="connsiteY70" fmla="*/ 17251 h 286109"/>
                <a:gd name="connsiteX71" fmla="*/ 485775 w 771573"/>
                <a:gd name="connsiteY71" fmla="*/ 15346 h 286109"/>
                <a:gd name="connsiteX72" fmla="*/ 472440 w 771573"/>
                <a:gd name="connsiteY72" fmla="*/ 11536 h 286109"/>
                <a:gd name="connsiteX73" fmla="*/ 409575 w 771573"/>
                <a:gd name="connsiteY73" fmla="*/ 3916 h 286109"/>
                <a:gd name="connsiteX74" fmla="*/ 360045 w 771573"/>
                <a:gd name="connsiteY74" fmla="*/ 106 h 286109"/>
                <a:gd name="connsiteX75" fmla="*/ 300990 w 771573"/>
                <a:gd name="connsiteY75" fmla="*/ 2011 h 286109"/>
                <a:gd name="connsiteX76" fmla="*/ 268605 w 771573"/>
                <a:gd name="connsiteY76" fmla="*/ 9631 h 286109"/>
                <a:gd name="connsiteX77" fmla="*/ 226695 w 771573"/>
                <a:gd name="connsiteY77" fmla="*/ 26776 h 286109"/>
                <a:gd name="connsiteX78" fmla="*/ 182880 w 771573"/>
                <a:gd name="connsiteY78" fmla="*/ 53446 h 286109"/>
                <a:gd name="connsiteX79" fmla="*/ 123825 w 771573"/>
                <a:gd name="connsiteY79" fmla="*/ 95356 h 286109"/>
                <a:gd name="connsiteX80" fmla="*/ 87630 w 771573"/>
                <a:gd name="connsiteY80" fmla="*/ 125836 h 286109"/>
                <a:gd name="connsiteX81" fmla="*/ 55245 w 771573"/>
                <a:gd name="connsiteY81" fmla="*/ 158221 h 286109"/>
                <a:gd name="connsiteX82" fmla="*/ 20955 w 771573"/>
                <a:gd name="connsiteY82" fmla="*/ 203941 h 286109"/>
                <a:gd name="connsiteX83" fmla="*/ 0 w 771573"/>
                <a:gd name="connsiteY83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1453 w 771573"/>
                <a:gd name="connsiteY7" fmla="*/ 123057 h 286109"/>
                <a:gd name="connsiteX8" fmla="*/ 259080 w 771573"/>
                <a:gd name="connsiteY8" fmla="*/ 99166 h 286109"/>
                <a:gd name="connsiteX9" fmla="*/ 282649 w 771573"/>
                <a:gd name="connsiteY9" fmla="*/ 86656 h 286109"/>
                <a:gd name="connsiteX10" fmla="*/ 319563 w 771573"/>
                <a:gd name="connsiteY10" fmla="*/ 82846 h 286109"/>
                <a:gd name="connsiteX11" fmla="*/ 372425 w 771573"/>
                <a:gd name="connsiteY11" fmla="*/ 78470 h 286109"/>
                <a:gd name="connsiteX12" fmla="*/ 456259 w 771573"/>
                <a:gd name="connsiteY12" fmla="*/ 78263 h 286109"/>
                <a:gd name="connsiteX13" fmla="*/ 521970 w 771573"/>
                <a:gd name="connsiteY13" fmla="*/ 85831 h 286109"/>
                <a:gd name="connsiteX14" fmla="*/ 537210 w 771573"/>
                <a:gd name="connsiteY14" fmla="*/ 89641 h 286109"/>
                <a:gd name="connsiteX15" fmla="*/ 542925 w 771573"/>
                <a:gd name="connsiteY15" fmla="*/ 93451 h 286109"/>
                <a:gd name="connsiteX16" fmla="*/ 550545 w 771573"/>
                <a:gd name="connsiteY16" fmla="*/ 97261 h 286109"/>
                <a:gd name="connsiteX17" fmla="*/ 565785 w 771573"/>
                <a:gd name="connsiteY17" fmla="*/ 104881 h 286109"/>
                <a:gd name="connsiteX18" fmla="*/ 575310 w 771573"/>
                <a:gd name="connsiteY18" fmla="*/ 114406 h 286109"/>
                <a:gd name="connsiteX19" fmla="*/ 581025 w 771573"/>
                <a:gd name="connsiteY19" fmla="*/ 118216 h 286109"/>
                <a:gd name="connsiteX20" fmla="*/ 600075 w 771573"/>
                <a:gd name="connsiteY20" fmla="*/ 133456 h 286109"/>
                <a:gd name="connsiteX21" fmla="*/ 607695 w 771573"/>
                <a:gd name="connsiteY21" fmla="*/ 142981 h 286109"/>
                <a:gd name="connsiteX22" fmla="*/ 621030 w 771573"/>
                <a:gd name="connsiteY22" fmla="*/ 156316 h 286109"/>
                <a:gd name="connsiteX23" fmla="*/ 628650 w 771573"/>
                <a:gd name="connsiteY23" fmla="*/ 167746 h 286109"/>
                <a:gd name="connsiteX24" fmla="*/ 638175 w 771573"/>
                <a:gd name="connsiteY24" fmla="*/ 182986 h 286109"/>
                <a:gd name="connsiteX25" fmla="*/ 647700 w 771573"/>
                <a:gd name="connsiteY25" fmla="*/ 200131 h 286109"/>
                <a:gd name="connsiteX26" fmla="*/ 657225 w 771573"/>
                <a:gd name="connsiteY26" fmla="*/ 211561 h 286109"/>
                <a:gd name="connsiteX27" fmla="*/ 668655 w 771573"/>
                <a:gd name="connsiteY27" fmla="*/ 219181 h 286109"/>
                <a:gd name="connsiteX28" fmla="*/ 672465 w 771573"/>
                <a:gd name="connsiteY28" fmla="*/ 224896 h 286109"/>
                <a:gd name="connsiteX29" fmla="*/ 678180 w 771573"/>
                <a:gd name="connsiteY29" fmla="*/ 226801 h 286109"/>
                <a:gd name="connsiteX30" fmla="*/ 681990 w 771573"/>
                <a:gd name="connsiteY30" fmla="*/ 234421 h 286109"/>
                <a:gd name="connsiteX31" fmla="*/ 697230 w 771573"/>
                <a:gd name="connsiteY31" fmla="*/ 251566 h 286109"/>
                <a:gd name="connsiteX32" fmla="*/ 701040 w 771573"/>
                <a:gd name="connsiteY32" fmla="*/ 266806 h 286109"/>
                <a:gd name="connsiteX33" fmla="*/ 710565 w 771573"/>
                <a:gd name="connsiteY33" fmla="*/ 276331 h 286109"/>
                <a:gd name="connsiteX34" fmla="*/ 723900 w 771573"/>
                <a:gd name="connsiteY34" fmla="*/ 274426 h 286109"/>
                <a:gd name="connsiteX35" fmla="*/ 727710 w 771573"/>
                <a:gd name="connsiteY35" fmla="*/ 268711 h 286109"/>
                <a:gd name="connsiteX36" fmla="*/ 741045 w 771573"/>
                <a:gd name="connsiteY36" fmla="*/ 255376 h 286109"/>
                <a:gd name="connsiteX37" fmla="*/ 746760 w 771573"/>
                <a:gd name="connsiteY37" fmla="*/ 249661 h 286109"/>
                <a:gd name="connsiteX38" fmla="*/ 754380 w 771573"/>
                <a:gd name="connsiteY38" fmla="*/ 243946 h 286109"/>
                <a:gd name="connsiteX39" fmla="*/ 762000 w 771573"/>
                <a:gd name="connsiteY39" fmla="*/ 240136 h 286109"/>
                <a:gd name="connsiteX40" fmla="*/ 767715 w 771573"/>
                <a:gd name="connsiteY40" fmla="*/ 236326 h 286109"/>
                <a:gd name="connsiteX41" fmla="*/ 771525 w 771573"/>
                <a:gd name="connsiteY41" fmla="*/ 230611 h 286109"/>
                <a:gd name="connsiteX42" fmla="*/ 765810 w 771573"/>
                <a:gd name="connsiteY42" fmla="*/ 200131 h 286109"/>
                <a:gd name="connsiteX43" fmla="*/ 762000 w 771573"/>
                <a:gd name="connsiteY43" fmla="*/ 194416 h 286109"/>
                <a:gd name="connsiteX44" fmla="*/ 756285 w 771573"/>
                <a:gd name="connsiteY44" fmla="*/ 181081 h 286109"/>
                <a:gd name="connsiteX45" fmla="*/ 748665 w 771573"/>
                <a:gd name="connsiteY45" fmla="*/ 165841 h 286109"/>
                <a:gd name="connsiteX46" fmla="*/ 739140 w 771573"/>
                <a:gd name="connsiteY46" fmla="*/ 152506 h 286109"/>
                <a:gd name="connsiteX47" fmla="*/ 737235 w 771573"/>
                <a:gd name="connsiteY47" fmla="*/ 146791 h 286109"/>
                <a:gd name="connsiteX48" fmla="*/ 727710 w 771573"/>
                <a:gd name="connsiteY48" fmla="*/ 135361 h 286109"/>
                <a:gd name="connsiteX49" fmla="*/ 720090 w 771573"/>
                <a:gd name="connsiteY49" fmla="*/ 129646 h 286109"/>
                <a:gd name="connsiteX50" fmla="*/ 714375 w 771573"/>
                <a:gd name="connsiteY50" fmla="*/ 127741 h 286109"/>
                <a:gd name="connsiteX51" fmla="*/ 702945 w 771573"/>
                <a:gd name="connsiteY51" fmla="*/ 118216 h 286109"/>
                <a:gd name="connsiteX52" fmla="*/ 697230 w 771573"/>
                <a:gd name="connsiteY52" fmla="*/ 112501 h 286109"/>
                <a:gd name="connsiteX53" fmla="*/ 691515 w 771573"/>
                <a:gd name="connsiteY53" fmla="*/ 108691 h 286109"/>
                <a:gd name="connsiteX54" fmla="*/ 683895 w 771573"/>
                <a:gd name="connsiteY54" fmla="*/ 102976 h 286109"/>
                <a:gd name="connsiteX55" fmla="*/ 676275 w 771573"/>
                <a:gd name="connsiteY55" fmla="*/ 99166 h 286109"/>
                <a:gd name="connsiteX56" fmla="*/ 664845 w 771573"/>
                <a:gd name="connsiteY56" fmla="*/ 95356 h 286109"/>
                <a:gd name="connsiteX57" fmla="*/ 655320 w 771573"/>
                <a:gd name="connsiteY57" fmla="*/ 89641 h 286109"/>
                <a:gd name="connsiteX58" fmla="*/ 640080 w 771573"/>
                <a:gd name="connsiteY58" fmla="*/ 83926 h 286109"/>
                <a:gd name="connsiteX59" fmla="*/ 626745 w 771573"/>
                <a:gd name="connsiteY59" fmla="*/ 74401 h 286109"/>
                <a:gd name="connsiteX60" fmla="*/ 621030 w 771573"/>
                <a:gd name="connsiteY60" fmla="*/ 72496 h 286109"/>
                <a:gd name="connsiteX61" fmla="*/ 609600 w 771573"/>
                <a:gd name="connsiteY61" fmla="*/ 64876 h 286109"/>
                <a:gd name="connsiteX62" fmla="*/ 598170 w 771573"/>
                <a:gd name="connsiteY62" fmla="*/ 59161 h 286109"/>
                <a:gd name="connsiteX63" fmla="*/ 592455 w 771573"/>
                <a:gd name="connsiteY63" fmla="*/ 55351 h 286109"/>
                <a:gd name="connsiteX64" fmla="*/ 584835 w 771573"/>
                <a:gd name="connsiteY64" fmla="*/ 49636 h 286109"/>
                <a:gd name="connsiteX65" fmla="*/ 573405 w 771573"/>
                <a:gd name="connsiteY65" fmla="*/ 45826 h 286109"/>
                <a:gd name="connsiteX66" fmla="*/ 567690 w 771573"/>
                <a:gd name="connsiteY66" fmla="*/ 42016 h 286109"/>
                <a:gd name="connsiteX67" fmla="*/ 556260 w 771573"/>
                <a:gd name="connsiteY67" fmla="*/ 38206 h 286109"/>
                <a:gd name="connsiteX68" fmla="*/ 548640 w 771573"/>
                <a:gd name="connsiteY68" fmla="*/ 34396 h 286109"/>
                <a:gd name="connsiteX69" fmla="*/ 537210 w 771573"/>
                <a:gd name="connsiteY69" fmla="*/ 26776 h 286109"/>
                <a:gd name="connsiteX70" fmla="*/ 493395 w 771573"/>
                <a:gd name="connsiteY70" fmla="*/ 17251 h 286109"/>
                <a:gd name="connsiteX71" fmla="*/ 485775 w 771573"/>
                <a:gd name="connsiteY71" fmla="*/ 15346 h 286109"/>
                <a:gd name="connsiteX72" fmla="*/ 472440 w 771573"/>
                <a:gd name="connsiteY72" fmla="*/ 11536 h 286109"/>
                <a:gd name="connsiteX73" fmla="*/ 409575 w 771573"/>
                <a:gd name="connsiteY73" fmla="*/ 3916 h 286109"/>
                <a:gd name="connsiteX74" fmla="*/ 360045 w 771573"/>
                <a:gd name="connsiteY74" fmla="*/ 106 h 286109"/>
                <a:gd name="connsiteX75" fmla="*/ 300990 w 771573"/>
                <a:gd name="connsiteY75" fmla="*/ 2011 h 286109"/>
                <a:gd name="connsiteX76" fmla="*/ 268605 w 771573"/>
                <a:gd name="connsiteY76" fmla="*/ 9631 h 286109"/>
                <a:gd name="connsiteX77" fmla="*/ 226695 w 771573"/>
                <a:gd name="connsiteY77" fmla="*/ 26776 h 286109"/>
                <a:gd name="connsiteX78" fmla="*/ 182880 w 771573"/>
                <a:gd name="connsiteY78" fmla="*/ 53446 h 286109"/>
                <a:gd name="connsiteX79" fmla="*/ 123825 w 771573"/>
                <a:gd name="connsiteY79" fmla="*/ 95356 h 286109"/>
                <a:gd name="connsiteX80" fmla="*/ 87630 w 771573"/>
                <a:gd name="connsiteY80" fmla="*/ 125836 h 286109"/>
                <a:gd name="connsiteX81" fmla="*/ 55245 w 771573"/>
                <a:gd name="connsiteY81" fmla="*/ 158221 h 286109"/>
                <a:gd name="connsiteX82" fmla="*/ 20955 w 771573"/>
                <a:gd name="connsiteY82" fmla="*/ 203941 h 286109"/>
                <a:gd name="connsiteX83" fmla="*/ 0 w 771573"/>
                <a:gd name="connsiteY83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1453 w 771573"/>
                <a:gd name="connsiteY7" fmla="*/ 123057 h 286109"/>
                <a:gd name="connsiteX8" fmla="*/ 259080 w 771573"/>
                <a:gd name="connsiteY8" fmla="*/ 99166 h 286109"/>
                <a:gd name="connsiteX9" fmla="*/ 282649 w 771573"/>
                <a:gd name="connsiteY9" fmla="*/ 86656 h 286109"/>
                <a:gd name="connsiteX10" fmla="*/ 324559 w 771573"/>
                <a:gd name="connsiteY10" fmla="*/ 75485 h 286109"/>
                <a:gd name="connsiteX11" fmla="*/ 372425 w 771573"/>
                <a:gd name="connsiteY11" fmla="*/ 78470 h 286109"/>
                <a:gd name="connsiteX12" fmla="*/ 456259 w 771573"/>
                <a:gd name="connsiteY12" fmla="*/ 78263 h 286109"/>
                <a:gd name="connsiteX13" fmla="*/ 521970 w 771573"/>
                <a:gd name="connsiteY13" fmla="*/ 85831 h 286109"/>
                <a:gd name="connsiteX14" fmla="*/ 537210 w 771573"/>
                <a:gd name="connsiteY14" fmla="*/ 89641 h 286109"/>
                <a:gd name="connsiteX15" fmla="*/ 542925 w 771573"/>
                <a:gd name="connsiteY15" fmla="*/ 93451 h 286109"/>
                <a:gd name="connsiteX16" fmla="*/ 550545 w 771573"/>
                <a:gd name="connsiteY16" fmla="*/ 97261 h 286109"/>
                <a:gd name="connsiteX17" fmla="*/ 565785 w 771573"/>
                <a:gd name="connsiteY17" fmla="*/ 104881 h 286109"/>
                <a:gd name="connsiteX18" fmla="*/ 575310 w 771573"/>
                <a:gd name="connsiteY18" fmla="*/ 114406 h 286109"/>
                <a:gd name="connsiteX19" fmla="*/ 581025 w 771573"/>
                <a:gd name="connsiteY19" fmla="*/ 118216 h 286109"/>
                <a:gd name="connsiteX20" fmla="*/ 600075 w 771573"/>
                <a:gd name="connsiteY20" fmla="*/ 133456 h 286109"/>
                <a:gd name="connsiteX21" fmla="*/ 607695 w 771573"/>
                <a:gd name="connsiteY21" fmla="*/ 142981 h 286109"/>
                <a:gd name="connsiteX22" fmla="*/ 621030 w 771573"/>
                <a:gd name="connsiteY22" fmla="*/ 156316 h 286109"/>
                <a:gd name="connsiteX23" fmla="*/ 628650 w 771573"/>
                <a:gd name="connsiteY23" fmla="*/ 167746 h 286109"/>
                <a:gd name="connsiteX24" fmla="*/ 638175 w 771573"/>
                <a:gd name="connsiteY24" fmla="*/ 182986 h 286109"/>
                <a:gd name="connsiteX25" fmla="*/ 647700 w 771573"/>
                <a:gd name="connsiteY25" fmla="*/ 200131 h 286109"/>
                <a:gd name="connsiteX26" fmla="*/ 657225 w 771573"/>
                <a:gd name="connsiteY26" fmla="*/ 211561 h 286109"/>
                <a:gd name="connsiteX27" fmla="*/ 668655 w 771573"/>
                <a:gd name="connsiteY27" fmla="*/ 219181 h 286109"/>
                <a:gd name="connsiteX28" fmla="*/ 672465 w 771573"/>
                <a:gd name="connsiteY28" fmla="*/ 224896 h 286109"/>
                <a:gd name="connsiteX29" fmla="*/ 678180 w 771573"/>
                <a:gd name="connsiteY29" fmla="*/ 226801 h 286109"/>
                <a:gd name="connsiteX30" fmla="*/ 681990 w 771573"/>
                <a:gd name="connsiteY30" fmla="*/ 234421 h 286109"/>
                <a:gd name="connsiteX31" fmla="*/ 697230 w 771573"/>
                <a:gd name="connsiteY31" fmla="*/ 251566 h 286109"/>
                <a:gd name="connsiteX32" fmla="*/ 701040 w 771573"/>
                <a:gd name="connsiteY32" fmla="*/ 266806 h 286109"/>
                <a:gd name="connsiteX33" fmla="*/ 710565 w 771573"/>
                <a:gd name="connsiteY33" fmla="*/ 276331 h 286109"/>
                <a:gd name="connsiteX34" fmla="*/ 723900 w 771573"/>
                <a:gd name="connsiteY34" fmla="*/ 274426 h 286109"/>
                <a:gd name="connsiteX35" fmla="*/ 727710 w 771573"/>
                <a:gd name="connsiteY35" fmla="*/ 268711 h 286109"/>
                <a:gd name="connsiteX36" fmla="*/ 741045 w 771573"/>
                <a:gd name="connsiteY36" fmla="*/ 255376 h 286109"/>
                <a:gd name="connsiteX37" fmla="*/ 746760 w 771573"/>
                <a:gd name="connsiteY37" fmla="*/ 249661 h 286109"/>
                <a:gd name="connsiteX38" fmla="*/ 754380 w 771573"/>
                <a:gd name="connsiteY38" fmla="*/ 243946 h 286109"/>
                <a:gd name="connsiteX39" fmla="*/ 762000 w 771573"/>
                <a:gd name="connsiteY39" fmla="*/ 240136 h 286109"/>
                <a:gd name="connsiteX40" fmla="*/ 767715 w 771573"/>
                <a:gd name="connsiteY40" fmla="*/ 236326 h 286109"/>
                <a:gd name="connsiteX41" fmla="*/ 771525 w 771573"/>
                <a:gd name="connsiteY41" fmla="*/ 230611 h 286109"/>
                <a:gd name="connsiteX42" fmla="*/ 765810 w 771573"/>
                <a:gd name="connsiteY42" fmla="*/ 200131 h 286109"/>
                <a:gd name="connsiteX43" fmla="*/ 762000 w 771573"/>
                <a:gd name="connsiteY43" fmla="*/ 194416 h 286109"/>
                <a:gd name="connsiteX44" fmla="*/ 756285 w 771573"/>
                <a:gd name="connsiteY44" fmla="*/ 181081 h 286109"/>
                <a:gd name="connsiteX45" fmla="*/ 748665 w 771573"/>
                <a:gd name="connsiteY45" fmla="*/ 165841 h 286109"/>
                <a:gd name="connsiteX46" fmla="*/ 739140 w 771573"/>
                <a:gd name="connsiteY46" fmla="*/ 152506 h 286109"/>
                <a:gd name="connsiteX47" fmla="*/ 737235 w 771573"/>
                <a:gd name="connsiteY47" fmla="*/ 146791 h 286109"/>
                <a:gd name="connsiteX48" fmla="*/ 727710 w 771573"/>
                <a:gd name="connsiteY48" fmla="*/ 135361 h 286109"/>
                <a:gd name="connsiteX49" fmla="*/ 720090 w 771573"/>
                <a:gd name="connsiteY49" fmla="*/ 129646 h 286109"/>
                <a:gd name="connsiteX50" fmla="*/ 714375 w 771573"/>
                <a:gd name="connsiteY50" fmla="*/ 127741 h 286109"/>
                <a:gd name="connsiteX51" fmla="*/ 702945 w 771573"/>
                <a:gd name="connsiteY51" fmla="*/ 118216 h 286109"/>
                <a:gd name="connsiteX52" fmla="*/ 697230 w 771573"/>
                <a:gd name="connsiteY52" fmla="*/ 112501 h 286109"/>
                <a:gd name="connsiteX53" fmla="*/ 691515 w 771573"/>
                <a:gd name="connsiteY53" fmla="*/ 108691 h 286109"/>
                <a:gd name="connsiteX54" fmla="*/ 683895 w 771573"/>
                <a:gd name="connsiteY54" fmla="*/ 102976 h 286109"/>
                <a:gd name="connsiteX55" fmla="*/ 676275 w 771573"/>
                <a:gd name="connsiteY55" fmla="*/ 99166 h 286109"/>
                <a:gd name="connsiteX56" fmla="*/ 664845 w 771573"/>
                <a:gd name="connsiteY56" fmla="*/ 95356 h 286109"/>
                <a:gd name="connsiteX57" fmla="*/ 655320 w 771573"/>
                <a:gd name="connsiteY57" fmla="*/ 89641 h 286109"/>
                <a:gd name="connsiteX58" fmla="*/ 640080 w 771573"/>
                <a:gd name="connsiteY58" fmla="*/ 83926 h 286109"/>
                <a:gd name="connsiteX59" fmla="*/ 626745 w 771573"/>
                <a:gd name="connsiteY59" fmla="*/ 74401 h 286109"/>
                <a:gd name="connsiteX60" fmla="*/ 621030 w 771573"/>
                <a:gd name="connsiteY60" fmla="*/ 72496 h 286109"/>
                <a:gd name="connsiteX61" fmla="*/ 609600 w 771573"/>
                <a:gd name="connsiteY61" fmla="*/ 64876 h 286109"/>
                <a:gd name="connsiteX62" fmla="*/ 598170 w 771573"/>
                <a:gd name="connsiteY62" fmla="*/ 59161 h 286109"/>
                <a:gd name="connsiteX63" fmla="*/ 592455 w 771573"/>
                <a:gd name="connsiteY63" fmla="*/ 55351 h 286109"/>
                <a:gd name="connsiteX64" fmla="*/ 584835 w 771573"/>
                <a:gd name="connsiteY64" fmla="*/ 49636 h 286109"/>
                <a:gd name="connsiteX65" fmla="*/ 573405 w 771573"/>
                <a:gd name="connsiteY65" fmla="*/ 45826 h 286109"/>
                <a:gd name="connsiteX66" fmla="*/ 567690 w 771573"/>
                <a:gd name="connsiteY66" fmla="*/ 42016 h 286109"/>
                <a:gd name="connsiteX67" fmla="*/ 556260 w 771573"/>
                <a:gd name="connsiteY67" fmla="*/ 38206 h 286109"/>
                <a:gd name="connsiteX68" fmla="*/ 548640 w 771573"/>
                <a:gd name="connsiteY68" fmla="*/ 34396 h 286109"/>
                <a:gd name="connsiteX69" fmla="*/ 537210 w 771573"/>
                <a:gd name="connsiteY69" fmla="*/ 26776 h 286109"/>
                <a:gd name="connsiteX70" fmla="*/ 493395 w 771573"/>
                <a:gd name="connsiteY70" fmla="*/ 17251 h 286109"/>
                <a:gd name="connsiteX71" fmla="*/ 485775 w 771573"/>
                <a:gd name="connsiteY71" fmla="*/ 15346 h 286109"/>
                <a:gd name="connsiteX72" fmla="*/ 472440 w 771573"/>
                <a:gd name="connsiteY72" fmla="*/ 11536 h 286109"/>
                <a:gd name="connsiteX73" fmla="*/ 409575 w 771573"/>
                <a:gd name="connsiteY73" fmla="*/ 3916 h 286109"/>
                <a:gd name="connsiteX74" fmla="*/ 360045 w 771573"/>
                <a:gd name="connsiteY74" fmla="*/ 106 h 286109"/>
                <a:gd name="connsiteX75" fmla="*/ 300990 w 771573"/>
                <a:gd name="connsiteY75" fmla="*/ 2011 h 286109"/>
                <a:gd name="connsiteX76" fmla="*/ 268605 w 771573"/>
                <a:gd name="connsiteY76" fmla="*/ 9631 h 286109"/>
                <a:gd name="connsiteX77" fmla="*/ 226695 w 771573"/>
                <a:gd name="connsiteY77" fmla="*/ 26776 h 286109"/>
                <a:gd name="connsiteX78" fmla="*/ 182880 w 771573"/>
                <a:gd name="connsiteY78" fmla="*/ 53446 h 286109"/>
                <a:gd name="connsiteX79" fmla="*/ 123825 w 771573"/>
                <a:gd name="connsiteY79" fmla="*/ 95356 h 286109"/>
                <a:gd name="connsiteX80" fmla="*/ 87630 w 771573"/>
                <a:gd name="connsiteY80" fmla="*/ 125836 h 286109"/>
                <a:gd name="connsiteX81" fmla="*/ 55245 w 771573"/>
                <a:gd name="connsiteY81" fmla="*/ 158221 h 286109"/>
                <a:gd name="connsiteX82" fmla="*/ 20955 w 771573"/>
                <a:gd name="connsiteY82" fmla="*/ 203941 h 286109"/>
                <a:gd name="connsiteX83" fmla="*/ 0 w 771573"/>
                <a:gd name="connsiteY83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1453 w 771573"/>
                <a:gd name="connsiteY7" fmla="*/ 123057 h 286109"/>
                <a:gd name="connsiteX8" fmla="*/ 244091 w 771573"/>
                <a:gd name="connsiteY8" fmla="*/ 103696 h 286109"/>
                <a:gd name="connsiteX9" fmla="*/ 282649 w 771573"/>
                <a:gd name="connsiteY9" fmla="*/ 86656 h 286109"/>
                <a:gd name="connsiteX10" fmla="*/ 324559 w 771573"/>
                <a:gd name="connsiteY10" fmla="*/ 75485 h 286109"/>
                <a:gd name="connsiteX11" fmla="*/ 372425 w 771573"/>
                <a:gd name="connsiteY11" fmla="*/ 78470 h 286109"/>
                <a:gd name="connsiteX12" fmla="*/ 456259 w 771573"/>
                <a:gd name="connsiteY12" fmla="*/ 78263 h 286109"/>
                <a:gd name="connsiteX13" fmla="*/ 521970 w 771573"/>
                <a:gd name="connsiteY13" fmla="*/ 85831 h 286109"/>
                <a:gd name="connsiteX14" fmla="*/ 537210 w 771573"/>
                <a:gd name="connsiteY14" fmla="*/ 89641 h 286109"/>
                <a:gd name="connsiteX15" fmla="*/ 542925 w 771573"/>
                <a:gd name="connsiteY15" fmla="*/ 93451 h 286109"/>
                <a:gd name="connsiteX16" fmla="*/ 550545 w 771573"/>
                <a:gd name="connsiteY16" fmla="*/ 97261 h 286109"/>
                <a:gd name="connsiteX17" fmla="*/ 565785 w 771573"/>
                <a:gd name="connsiteY17" fmla="*/ 104881 h 286109"/>
                <a:gd name="connsiteX18" fmla="*/ 575310 w 771573"/>
                <a:gd name="connsiteY18" fmla="*/ 114406 h 286109"/>
                <a:gd name="connsiteX19" fmla="*/ 581025 w 771573"/>
                <a:gd name="connsiteY19" fmla="*/ 118216 h 286109"/>
                <a:gd name="connsiteX20" fmla="*/ 600075 w 771573"/>
                <a:gd name="connsiteY20" fmla="*/ 133456 h 286109"/>
                <a:gd name="connsiteX21" fmla="*/ 607695 w 771573"/>
                <a:gd name="connsiteY21" fmla="*/ 142981 h 286109"/>
                <a:gd name="connsiteX22" fmla="*/ 621030 w 771573"/>
                <a:gd name="connsiteY22" fmla="*/ 156316 h 286109"/>
                <a:gd name="connsiteX23" fmla="*/ 628650 w 771573"/>
                <a:gd name="connsiteY23" fmla="*/ 167746 h 286109"/>
                <a:gd name="connsiteX24" fmla="*/ 638175 w 771573"/>
                <a:gd name="connsiteY24" fmla="*/ 182986 h 286109"/>
                <a:gd name="connsiteX25" fmla="*/ 647700 w 771573"/>
                <a:gd name="connsiteY25" fmla="*/ 200131 h 286109"/>
                <a:gd name="connsiteX26" fmla="*/ 657225 w 771573"/>
                <a:gd name="connsiteY26" fmla="*/ 211561 h 286109"/>
                <a:gd name="connsiteX27" fmla="*/ 668655 w 771573"/>
                <a:gd name="connsiteY27" fmla="*/ 219181 h 286109"/>
                <a:gd name="connsiteX28" fmla="*/ 672465 w 771573"/>
                <a:gd name="connsiteY28" fmla="*/ 224896 h 286109"/>
                <a:gd name="connsiteX29" fmla="*/ 678180 w 771573"/>
                <a:gd name="connsiteY29" fmla="*/ 226801 h 286109"/>
                <a:gd name="connsiteX30" fmla="*/ 681990 w 771573"/>
                <a:gd name="connsiteY30" fmla="*/ 234421 h 286109"/>
                <a:gd name="connsiteX31" fmla="*/ 697230 w 771573"/>
                <a:gd name="connsiteY31" fmla="*/ 251566 h 286109"/>
                <a:gd name="connsiteX32" fmla="*/ 701040 w 771573"/>
                <a:gd name="connsiteY32" fmla="*/ 266806 h 286109"/>
                <a:gd name="connsiteX33" fmla="*/ 710565 w 771573"/>
                <a:gd name="connsiteY33" fmla="*/ 276331 h 286109"/>
                <a:gd name="connsiteX34" fmla="*/ 723900 w 771573"/>
                <a:gd name="connsiteY34" fmla="*/ 274426 h 286109"/>
                <a:gd name="connsiteX35" fmla="*/ 727710 w 771573"/>
                <a:gd name="connsiteY35" fmla="*/ 268711 h 286109"/>
                <a:gd name="connsiteX36" fmla="*/ 741045 w 771573"/>
                <a:gd name="connsiteY36" fmla="*/ 255376 h 286109"/>
                <a:gd name="connsiteX37" fmla="*/ 746760 w 771573"/>
                <a:gd name="connsiteY37" fmla="*/ 249661 h 286109"/>
                <a:gd name="connsiteX38" fmla="*/ 754380 w 771573"/>
                <a:gd name="connsiteY38" fmla="*/ 243946 h 286109"/>
                <a:gd name="connsiteX39" fmla="*/ 762000 w 771573"/>
                <a:gd name="connsiteY39" fmla="*/ 240136 h 286109"/>
                <a:gd name="connsiteX40" fmla="*/ 767715 w 771573"/>
                <a:gd name="connsiteY40" fmla="*/ 236326 h 286109"/>
                <a:gd name="connsiteX41" fmla="*/ 771525 w 771573"/>
                <a:gd name="connsiteY41" fmla="*/ 230611 h 286109"/>
                <a:gd name="connsiteX42" fmla="*/ 765810 w 771573"/>
                <a:gd name="connsiteY42" fmla="*/ 200131 h 286109"/>
                <a:gd name="connsiteX43" fmla="*/ 762000 w 771573"/>
                <a:gd name="connsiteY43" fmla="*/ 194416 h 286109"/>
                <a:gd name="connsiteX44" fmla="*/ 756285 w 771573"/>
                <a:gd name="connsiteY44" fmla="*/ 181081 h 286109"/>
                <a:gd name="connsiteX45" fmla="*/ 748665 w 771573"/>
                <a:gd name="connsiteY45" fmla="*/ 165841 h 286109"/>
                <a:gd name="connsiteX46" fmla="*/ 739140 w 771573"/>
                <a:gd name="connsiteY46" fmla="*/ 152506 h 286109"/>
                <a:gd name="connsiteX47" fmla="*/ 737235 w 771573"/>
                <a:gd name="connsiteY47" fmla="*/ 146791 h 286109"/>
                <a:gd name="connsiteX48" fmla="*/ 727710 w 771573"/>
                <a:gd name="connsiteY48" fmla="*/ 135361 h 286109"/>
                <a:gd name="connsiteX49" fmla="*/ 720090 w 771573"/>
                <a:gd name="connsiteY49" fmla="*/ 129646 h 286109"/>
                <a:gd name="connsiteX50" fmla="*/ 714375 w 771573"/>
                <a:gd name="connsiteY50" fmla="*/ 127741 h 286109"/>
                <a:gd name="connsiteX51" fmla="*/ 702945 w 771573"/>
                <a:gd name="connsiteY51" fmla="*/ 118216 h 286109"/>
                <a:gd name="connsiteX52" fmla="*/ 697230 w 771573"/>
                <a:gd name="connsiteY52" fmla="*/ 112501 h 286109"/>
                <a:gd name="connsiteX53" fmla="*/ 691515 w 771573"/>
                <a:gd name="connsiteY53" fmla="*/ 108691 h 286109"/>
                <a:gd name="connsiteX54" fmla="*/ 683895 w 771573"/>
                <a:gd name="connsiteY54" fmla="*/ 102976 h 286109"/>
                <a:gd name="connsiteX55" fmla="*/ 676275 w 771573"/>
                <a:gd name="connsiteY55" fmla="*/ 99166 h 286109"/>
                <a:gd name="connsiteX56" fmla="*/ 664845 w 771573"/>
                <a:gd name="connsiteY56" fmla="*/ 95356 h 286109"/>
                <a:gd name="connsiteX57" fmla="*/ 655320 w 771573"/>
                <a:gd name="connsiteY57" fmla="*/ 89641 h 286109"/>
                <a:gd name="connsiteX58" fmla="*/ 640080 w 771573"/>
                <a:gd name="connsiteY58" fmla="*/ 83926 h 286109"/>
                <a:gd name="connsiteX59" fmla="*/ 626745 w 771573"/>
                <a:gd name="connsiteY59" fmla="*/ 74401 h 286109"/>
                <a:gd name="connsiteX60" fmla="*/ 621030 w 771573"/>
                <a:gd name="connsiteY60" fmla="*/ 72496 h 286109"/>
                <a:gd name="connsiteX61" fmla="*/ 609600 w 771573"/>
                <a:gd name="connsiteY61" fmla="*/ 64876 h 286109"/>
                <a:gd name="connsiteX62" fmla="*/ 598170 w 771573"/>
                <a:gd name="connsiteY62" fmla="*/ 59161 h 286109"/>
                <a:gd name="connsiteX63" fmla="*/ 592455 w 771573"/>
                <a:gd name="connsiteY63" fmla="*/ 55351 h 286109"/>
                <a:gd name="connsiteX64" fmla="*/ 584835 w 771573"/>
                <a:gd name="connsiteY64" fmla="*/ 49636 h 286109"/>
                <a:gd name="connsiteX65" fmla="*/ 573405 w 771573"/>
                <a:gd name="connsiteY65" fmla="*/ 45826 h 286109"/>
                <a:gd name="connsiteX66" fmla="*/ 567690 w 771573"/>
                <a:gd name="connsiteY66" fmla="*/ 42016 h 286109"/>
                <a:gd name="connsiteX67" fmla="*/ 556260 w 771573"/>
                <a:gd name="connsiteY67" fmla="*/ 38206 h 286109"/>
                <a:gd name="connsiteX68" fmla="*/ 548640 w 771573"/>
                <a:gd name="connsiteY68" fmla="*/ 34396 h 286109"/>
                <a:gd name="connsiteX69" fmla="*/ 537210 w 771573"/>
                <a:gd name="connsiteY69" fmla="*/ 26776 h 286109"/>
                <a:gd name="connsiteX70" fmla="*/ 493395 w 771573"/>
                <a:gd name="connsiteY70" fmla="*/ 17251 h 286109"/>
                <a:gd name="connsiteX71" fmla="*/ 485775 w 771573"/>
                <a:gd name="connsiteY71" fmla="*/ 15346 h 286109"/>
                <a:gd name="connsiteX72" fmla="*/ 472440 w 771573"/>
                <a:gd name="connsiteY72" fmla="*/ 11536 h 286109"/>
                <a:gd name="connsiteX73" fmla="*/ 409575 w 771573"/>
                <a:gd name="connsiteY73" fmla="*/ 3916 h 286109"/>
                <a:gd name="connsiteX74" fmla="*/ 360045 w 771573"/>
                <a:gd name="connsiteY74" fmla="*/ 106 h 286109"/>
                <a:gd name="connsiteX75" fmla="*/ 300990 w 771573"/>
                <a:gd name="connsiteY75" fmla="*/ 2011 h 286109"/>
                <a:gd name="connsiteX76" fmla="*/ 268605 w 771573"/>
                <a:gd name="connsiteY76" fmla="*/ 9631 h 286109"/>
                <a:gd name="connsiteX77" fmla="*/ 226695 w 771573"/>
                <a:gd name="connsiteY77" fmla="*/ 26776 h 286109"/>
                <a:gd name="connsiteX78" fmla="*/ 182880 w 771573"/>
                <a:gd name="connsiteY78" fmla="*/ 53446 h 286109"/>
                <a:gd name="connsiteX79" fmla="*/ 123825 w 771573"/>
                <a:gd name="connsiteY79" fmla="*/ 95356 h 286109"/>
                <a:gd name="connsiteX80" fmla="*/ 87630 w 771573"/>
                <a:gd name="connsiteY80" fmla="*/ 125836 h 286109"/>
                <a:gd name="connsiteX81" fmla="*/ 55245 w 771573"/>
                <a:gd name="connsiteY81" fmla="*/ 158221 h 286109"/>
                <a:gd name="connsiteX82" fmla="*/ 20955 w 771573"/>
                <a:gd name="connsiteY82" fmla="*/ 203941 h 286109"/>
                <a:gd name="connsiteX83" fmla="*/ 0 w 771573"/>
                <a:gd name="connsiteY83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01453 w 771573"/>
                <a:gd name="connsiteY7" fmla="*/ 123057 h 286109"/>
                <a:gd name="connsiteX8" fmla="*/ 244091 w 771573"/>
                <a:gd name="connsiteY8" fmla="*/ 103696 h 286109"/>
                <a:gd name="connsiteX9" fmla="*/ 282649 w 771573"/>
                <a:gd name="connsiteY9" fmla="*/ 86656 h 286109"/>
                <a:gd name="connsiteX10" fmla="*/ 324559 w 771573"/>
                <a:gd name="connsiteY10" fmla="*/ 75485 h 286109"/>
                <a:gd name="connsiteX11" fmla="*/ 382418 w 771573"/>
                <a:gd name="connsiteY11" fmla="*/ 73940 h 286109"/>
                <a:gd name="connsiteX12" fmla="*/ 456259 w 771573"/>
                <a:gd name="connsiteY12" fmla="*/ 78263 h 286109"/>
                <a:gd name="connsiteX13" fmla="*/ 521970 w 771573"/>
                <a:gd name="connsiteY13" fmla="*/ 85831 h 286109"/>
                <a:gd name="connsiteX14" fmla="*/ 537210 w 771573"/>
                <a:gd name="connsiteY14" fmla="*/ 89641 h 286109"/>
                <a:gd name="connsiteX15" fmla="*/ 542925 w 771573"/>
                <a:gd name="connsiteY15" fmla="*/ 93451 h 286109"/>
                <a:gd name="connsiteX16" fmla="*/ 550545 w 771573"/>
                <a:gd name="connsiteY16" fmla="*/ 97261 h 286109"/>
                <a:gd name="connsiteX17" fmla="*/ 565785 w 771573"/>
                <a:gd name="connsiteY17" fmla="*/ 104881 h 286109"/>
                <a:gd name="connsiteX18" fmla="*/ 575310 w 771573"/>
                <a:gd name="connsiteY18" fmla="*/ 114406 h 286109"/>
                <a:gd name="connsiteX19" fmla="*/ 581025 w 771573"/>
                <a:gd name="connsiteY19" fmla="*/ 118216 h 286109"/>
                <a:gd name="connsiteX20" fmla="*/ 600075 w 771573"/>
                <a:gd name="connsiteY20" fmla="*/ 133456 h 286109"/>
                <a:gd name="connsiteX21" fmla="*/ 607695 w 771573"/>
                <a:gd name="connsiteY21" fmla="*/ 142981 h 286109"/>
                <a:gd name="connsiteX22" fmla="*/ 621030 w 771573"/>
                <a:gd name="connsiteY22" fmla="*/ 156316 h 286109"/>
                <a:gd name="connsiteX23" fmla="*/ 628650 w 771573"/>
                <a:gd name="connsiteY23" fmla="*/ 167746 h 286109"/>
                <a:gd name="connsiteX24" fmla="*/ 638175 w 771573"/>
                <a:gd name="connsiteY24" fmla="*/ 182986 h 286109"/>
                <a:gd name="connsiteX25" fmla="*/ 647700 w 771573"/>
                <a:gd name="connsiteY25" fmla="*/ 200131 h 286109"/>
                <a:gd name="connsiteX26" fmla="*/ 657225 w 771573"/>
                <a:gd name="connsiteY26" fmla="*/ 211561 h 286109"/>
                <a:gd name="connsiteX27" fmla="*/ 668655 w 771573"/>
                <a:gd name="connsiteY27" fmla="*/ 219181 h 286109"/>
                <a:gd name="connsiteX28" fmla="*/ 672465 w 771573"/>
                <a:gd name="connsiteY28" fmla="*/ 224896 h 286109"/>
                <a:gd name="connsiteX29" fmla="*/ 678180 w 771573"/>
                <a:gd name="connsiteY29" fmla="*/ 226801 h 286109"/>
                <a:gd name="connsiteX30" fmla="*/ 681990 w 771573"/>
                <a:gd name="connsiteY30" fmla="*/ 234421 h 286109"/>
                <a:gd name="connsiteX31" fmla="*/ 697230 w 771573"/>
                <a:gd name="connsiteY31" fmla="*/ 251566 h 286109"/>
                <a:gd name="connsiteX32" fmla="*/ 701040 w 771573"/>
                <a:gd name="connsiteY32" fmla="*/ 266806 h 286109"/>
                <a:gd name="connsiteX33" fmla="*/ 710565 w 771573"/>
                <a:gd name="connsiteY33" fmla="*/ 276331 h 286109"/>
                <a:gd name="connsiteX34" fmla="*/ 723900 w 771573"/>
                <a:gd name="connsiteY34" fmla="*/ 274426 h 286109"/>
                <a:gd name="connsiteX35" fmla="*/ 727710 w 771573"/>
                <a:gd name="connsiteY35" fmla="*/ 268711 h 286109"/>
                <a:gd name="connsiteX36" fmla="*/ 741045 w 771573"/>
                <a:gd name="connsiteY36" fmla="*/ 255376 h 286109"/>
                <a:gd name="connsiteX37" fmla="*/ 746760 w 771573"/>
                <a:gd name="connsiteY37" fmla="*/ 249661 h 286109"/>
                <a:gd name="connsiteX38" fmla="*/ 754380 w 771573"/>
                <a:gd name="connsiteY38" fmla="*/ 243946 h 286109"/>
                <a:gd name="connsiteX39" fmla="*/ 762000 w 771573"/>
                <a:gd name="connsiteY39" fmla="*/ 240136 h 286109"/>
                <a:gd name="connsiteX40" fmla="*/ 767715 w 771573"/>
                <a:gd name="connsiteY40" fmla="*/ 236326 h 286109"/>
                <a:gd name="connsiteX41" fmla="*/ 771525 w 771573"/>
                <a:gd name="connsiteY41" fmla="*/ 230611 h 286109"/>
                <a:gd name="connsiteX42" fmla="*/ 765810 w 771573"/>
                <a:gd name="connsiteY42" fmla="*/ 200131 h 286109"/>
                <a:gd name="connsiteX43" fmla="*/ 762000 w 771573"/>
                <a:gd name="connsiteY43" fmla="*/ 194416 h 286109"/>
                <a:gd name="connsiteX44" fmla="*/ 756285 w 771573"/>
                <a:gd name="connsiteY44" fmla="*/ 181081 h 286109"/>
                <a:gd name="connsiteX45" fmla="*/ 748665 w 771573"/>
                <a:gd name="connsiteY45" fmla="*/ 165841 h 286109"/>
                <a:gd name="connsiteX46" fmla="*/ 739140 w 771573"/>
                <a:gd name="connsiteY46" fmla="*/ 152506 h 286109"/>
                <a:gd name="connsiteX47" fmla="*/ 737235 w 771573"/>
                <a:gd name="connsiteY47" fmla="*/ 146791 h 286109"/>
                <a:gd name="connsiteX48" fmla="*/ 727710 w 771573"/>
                <a:gd name="connsiteY48" fmla="*/ 135361 h 286109"/>
                <a:gd name="connsiteX49" fmla="*/ 720090 w 771573"/>
                <a:gd name="connsiteY49" fmla="*/ 129646 h 286109"/>
                <a:gd name="connsiteX50" fmla="*/ 714375 w 771573"/>
                <a:gd name="connsiteY50" fmla="*/ 127741 h 286109"/>
                <a:gd name="connsiteX51" fmla="*/ 702945 w 771573"/>
                <a:gd name="connsiteY51" fmla="*/ 118216 h 286109"/>
                <a:gd name="connsiteX52" fmla="*/ 697230 w 771573"/>
                <a:gd name="connsiteY52" fmla="*/ 112501 h 286109"/>
                <a:gd name="connsiteX53" fmla="*/ 691515 w 771573"/>
                <a:gd name="connsiteY53" fmla="*/ 108691 h 286109"/>
                <a:gd name="connsiteX54" fmla="*/ 683895 w 771573"/>
                <a:gd name="connsiteY54" fmla="*/ 102976 h 286109"/>
                <a:gd name="connsiteX55" fmla="*/ 676275 w 771573"/>
                <a:gd name="connsiteY55" fmla="*/ 99166 h 286109"/>
                <a:gd name="connsiteX56" fmla="*/ 664845 w 771573"/>
                <a:gd name="connsiteY56" fmla="*/ 95356 h 286109"/>
                <a:gd name="connsiteX57" fmla="*/ 655320 w 771573"/>
                <a:gd name="connsiteY57" fmla="*/ 89641 h 286109"/>
                <a:gd name="connsiteX58" fmla="*/ 640080 w 771573"/>
                <a:gd name="connsiteY58" fmla="*/ 83926 h 286109"/>
                <a:gd name="connsiteX59" fmla="*/ 626745 w 771573"/>
                <a:gd name="connsiteY59" fmla="*/ 74401 h 286109"/>
                <a:gd name="connsiteX60" fmla="*/ 621030 w 771573"/>
                <a:gd name="connsiteY60" fmla="*/ 72496 h 286109"/>
                <a:gd name="connsiteX61" fmla="*/ 609600 w 771573"/>
                <a:gd name="connsiteY61" fmla="*/ 64876 h 286109"/>
                <a:gd name="connsiteX62" fmla="*/ 598170 w 771573"/>
                <a:gd name="connsiteY62" fmla="*/ 59161 h 286109"/>
                <a:gd name="connsiteX63" fmla="*/ 592455 w 771573"/>
                <a:gd name="connsiteY63" fmla="*/ 55351 h 286109"/>
                <a:gd name="connsiteX64" fmla="*/ 584835 w 771573"/>
                <a:gd name="connsiteY64" fmla="*/ 49636 h 286109"/>
                <a:gd name="connsiteX65" fmla="*/ 573405 w 771573"/>
                <a:gd name="connsiteY65" fmla="*/ 45826 h 286109"/>
                <a:gd name="connsiteX66" fmla="*/ 567690 w 771573"/>
                <a:gd name="connsiteY66" fmla="*/ 42016 h 286109"/>
                <a:gd name="connsiteX67" fmla="*/ 556260 w 771573"/>
                <a:gd name="connsiteY67" fmla="*/ 38206 h 286109"/>
                <a:gd name="connsiteX68" fmla="*/ 548640 w 771573"/>
                <a:gd name="connsiteY68" fmla="*/ 34396 h 286109"/>
                <a:gd name="connsiteX69" fmla="*/ 537210 w 771573"/>
                <a:gd name="connsiteY69" fmla="*/ 26776 h 286109"/>
                <a:gd name="connsiteX70" fmla="*/ 493395 w 771573"/>
                <a:gd name="connsiteY70" fmla="*/ 17251 h 286109"/>
                <a:gd name="connsiteX71" fmla="*/ 485775 w 771573"/>
                <a:gd name="connsiteY71" fmla="*/ 15346 h 286109"/>
                <a:gd name="connsiteX72" fmla="*/ 472440 w 771573"/>
                <a:gd name="connsiteY72" fmla="*/ 11536 h 286109"/>
                <a:gd name="connsiteX73" fmla="*/ 409575 w 771573"/>
                <a:gd name="connsiteY73" fmla="*/ 3916 h 286109"/>
                <a:gd name="connsiteX74" fmla="*/ 360045 w 771573"/>
                <a:gd name="connsiteY74" fmla="*/ 106 h 286109"/>
                <a:gd name="connsiteX75" fmla="*/ 300990 w 771573"/>
                <a:gd name="connsiteY75" fmla="*/ 2011 h 286109"/>
                <a:gd name="connsiteX76" fmla="*/ 268605 w 771573"/>
                <a:gd name="connsiteY76" fmla="*/ 9631 h 286109"/>
                <a:gd name="connsiteX77" fmla="*/ 226695 w 771573"/>
                <a:gd name="connsiteY77" fmla="*/ 26776 h 286109"/>
                <a:gd name="connsiteX78" fmla="*/ 182880 w 771573"/>
                <a:gd name="connsiteY78" fmla="*/ 53446 h 286109"/>
                <a:gd name="connsiteX79" fmla="*/ 123825 w 771573"/>
                <a:gd name="connsiteY79" fmla="*/ 95356 h 286109"/>
                <a:gd name="connsiteX80" fmla="*/ 87630 w 771573"/>
                <a:gd name="connsiteY80" fmla="*/ 125836 h 286109"/>
                <a:gd name="connsiteX81" fmla="*/ 55245 w 771573"/>
                <a:gd name="connsiteY81" fmla="*/ 158221 h 286109"/>
                <a:gd name="connsiteX82" fmla="*/ 20955 w 771573"/>
                <a:gd name="connsiteY82" fmla="*/ 203941 h 286109"/>
                <a:gd name="connsiteX83" fmla="*/ 0 w 771573"/>
                <a:gd name="connsiteY83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40970 w 771573"/>
                <a:gd name="connsiteY5" fmla="*/ 175366 h 286109"/>
                <a:gd name="connsiteX6" fmla="*/ 171696 w 771573"/>
                <a:gd name="connsiteY6" fmla="*/ 148902 h 286109"/>
                <a:gd name="connsiteX7" fmla="*/ 244091 w 771573"/>
                <a:gd name="connsiteY7" fmla="*/ 103696 h 286109"/>
                <a:gd name="connsiteX8" fmla="*/ 282649 w 771573"/>
                <a:gd name="connsiteY8" fmla="*/ 86656 h 286109"/>
                <a:gd name="connsiteX9" fmla="*/ 324559 w 771573"/>
                <a:gd name="connsiteY9" fmla="*/ 75485 h 286109"/>
                <a:gd name="connsiteX10" fmla="*/ 382418 w 771573"/>
                <a:gd name="connsiteY10" fmla="*/ 73940 h 286109"/>
                <a:gd name="connsiteX11" fmla="*/ 456259 w 771573"/>
                <a:gd name="connsiteY11" fmla="*/ 78263 h 286109"/>
                <a:gd name="connsiteX12" fmla="*/ 521970 w 771573"/>
                <a:gd name="connsiteY12" fmla="*/ 85831 h 286109"/>
                <a:gd name="connsiteX13" fmla="*/ 537210 w 771573"/>
                <a:gd name="connsiteY13" fmla="*/ 89641 h 286109"/>
                <a:gd name="connsiteX14" fmla="*/ 542925 w 771573"/>
                <a:gd name="connsiteY14" fmla="*/ 93451 h 286109"/>
                <a:gd name="connsiteX15" fmla="*/ 550545 w 771573"/>
                <a:gd name="connsiteY15" fmla="*/ 97261 h 286109"/>
                <a:gd name="connsiteX16" fmla="*/ 565785 w 771573"/>
                <a:gd name="connsiteY16" fmla="*/ 104881 h 286109"/>
                <a:gd name="connsiteX17" fmla="*/ 575310 w 771573"/>
                <a:gd name="connsiteY17" fmla="*/ 114406 h 286109"/>
                <a:gd name="connsiteX18" fmla="*/ 581025 w 771573"/>
                <a:gd name="connsiteY18" fmla="*/ 118216 h 286109"/>
                <a:gd name="connsiteX19" fmla="*/ 600075 w 771573"/>
                <a:gd name="connsiteY19" fmla="*/ 133456 h 286109"/>
                <a:gd name="connsiteX20" fmla="*/ 607695 w 771573"/>
                <a:gd name="connsiteY20" fmla="*/ 142981 h 286109"/>
                <a:gd name="connsiteX21" fmla="*/ 621030 w 771573"/>
                <a:gd name="connsiteY21" fmla="*/ 156316 h 286109"/>
                <a:gd name="connsiteX22" fmla="*/ 628650 w 771573"/>
                <a:gd name="connsiteY22" fmla="*/ 167746 h 286109"/>
                <a:gd name="connsiteX23" fmla="*/ 638175 w 771573"/>
                <a:gd name="connsiteY23" fmla="*/ 182986 h 286109"/>
                <a:gd name="connsiteX24" fmla="*/ 647700 w 771573"/>
                <a:gd name="connsiteY24" fmla="*/ 200131 h 286109"/>
                <a:gd name="connsiteX25" fmla="*/ 657225 w 771573"/>
                <a:gd name="connsiteY25" fmla="*/ 211561 h 286109"/>
                <a:gd name="connsiteX26" fmla="*/ 668655 w 771573"/>
                <a:gd name="connsiteY26" fmla="*/ 219181 h 286109"/>
                <a:gd name="connsiteX27" fmla="*/ 672465 w 771573"/>
                <a:gd name="connsiteY27" fmla="*/ 224896 h 286109"/>
                <a:gd name="connsiteX28" fmla="*/ 678180 w 771573"/>
                <a:gd name="connsiteY28" fmla="*/ 226801 h 286109"/>
                <a:gd name="connsiteX29" fmla="*/ 681990 w 771573"/>
                <a:gd name="connsiteY29" fmla="*/ 234421 h 286109"/>
                <a:gd name="connsiteX30" fmla="*/ 697230 w 771573"/>
                <a:gd name="connsiteY30" fmla="*/ 251566 h 286109"/>
                <a:gd name="connsiteX31" fmla="*/ 701040 w 771573"/>
                <a:gd name="connsiteY31" fmla="*/ 266806 h 286109"/>
                <a:gd name="connsiteX32" fmla="*/ 710565 w 771573"/>
                <a:gd name="connsiteY32" fmla="*/ 276331 h 286109"/>
                <a:gd name="connsiteX33" fmla="*/ 723900 w 771573"/>
                <a:gd name="connsiteY33" fmla="*/ 274426 h 286109"/>
                <a:gd name="connsiteX34" fmla="*/ 727710 w 771573"/>
                <a:gd name="connsiteY34" fmla="*/ 268711 h 286109"/>
                <a:gd name="connsiteX35" fmla="*/ 741045 w 771573"/>
                <a:gd name="connsiteY35" fmla="*/ 255376 h 286109"/>
                <a:gd name="connsiteX36" fmla="*/ 746760 w 771573"/>
                <a:gd name="connsiteY36" fmla="*/ 249661 h 286109"/>
                <a:gd name="connsiteX37" fmla="*/ 754380 w 771573"/>
                <a:gd name="connsiteY37" fmla="*/ 243946 h 286109"/>
                <a:gd name="connsiteX38" fmla="*/ 762000 w 771573"/>
                <a:gd name="connsiteY38" fmla="*/ 240136 h 286109"/>
                <a:gd name="connsiteX39" fmla="*/ 767715 w 771573"/>
                <a:gd name="connsiteY39" fmla="*/ 236326 h 286109"/>
                <a:gd name="connsiteX40" fmla="*/ 771525 w 771573"/>
                <a:gd name="connsiteY40" fmla="*/ 230611 h 286109"/>
                <a:gd name="connsiteX41" fmla="*/ 765810 w 771573"/>
                <a:gd name="connsiteY41" fmla="*/ 200131 h 286109"/>
                <a:gd name="connsiteX42" fmla="*/ 762000 w 771573"/>
                <a:gd name="connsiteY42" fmla="*/ 194416 h 286109"/>
                <a:gd name="connsiteX43" fmla="*/ 756285 w 771573"/>
                <a:gd name="connsiteY43" fmla="*/ 181081 h 286109"/>
                <a:gd name="connsiteX44" fmla="*/ 748665 w 771573"/>
                <a:gd name="connsiteY44" fmla="*/ 165841 h 286109"/>
                <a:gd name="connsiteX45" fmla="*/ 739140 w 771573"/>
                <a:gd name="connsiteY45" fmla="*/ 152506 h 286109"/>
                <a:gd name="connsiteX46" fmla="*/ 737235 w 771573"/>
                <a:gd name="connsiteY46" fmla="*/ 146791 h 286109"/>
                <a:gd name="connsiteX47" fmla="*/ 727710 w 771573"/>
                <a:gd name="connsiteY47" fmla="*/ 135361 h 286109"/>
                <a:gd name="connsiteX48" fmla="*/ 720090 w 771573"/>
                <a:gd name="connsiteY48" fmla="*/ 129646 h 286109"/>
                <a:gd name="connsiteX49" fmla="*/ 714375 w 771573"/>
                <a:gd name="connsiteY49" fmla="*/ 127741 h 286109"/>
                <a:gd name="connsiteX50" fmla="*/ 702945 w 771573"/>
                <a:gd name="connsiteY50" fmla="*/ 118216 h 286109"/>
                <a:gd name="connsiteX51" fmla="*/ 697230 w 771573"/>
                <a:gd name="connsiteY51" fmla="*/ 112501 h 286109"/>
                <a:gd name="connsiteX52" fmla="*/ 691515 w 771573"/>
                <a:gd name="connsiteY52" fmla="*/ 108691 h 286109"/>
                <a:gd name="connsiteX53" fmla="*/ 683895 w 771573"/>
                <a:gd name="connsiteY53" fmla="*/ 102976 h 286109"/>
                <a:gd name="connsiteX54" fmla="*/ 676275 w 771573"/>
                <a:gd name="connsiteY54" fmla="*/ 99166 h 286109"/>
                <a:gd name="connsiteX55" fmla="*/ 664845 w 771573"/>
                <a:gd name="connsiteY55" fmla="*/ 95356 h 286109"/>
                <a:gd name="connsiteX56" fmla="*/ 655320 w 771573"/>
                <a:gd name="connsiteY56" fmla="*/ 89641 h 286109"/>
                <a:gd name="connsiteX57" fmla="*/ 640080 w 771573"/>
                <a:gd name="connsiteY57" fmla="*/ 83926 h 286109"/>
                <a:gd name="connsiteX58" fmla="*/ 626745 w 771573"/>
                <a:gd name="connsiteY58" fmla="*/ 74401 h 286109"/>
                <a:gd name="connsiteX59" fmla="*/ 621030 w 771573"/>
                <a:gd name="connsiteY59" fmla="*/ 72496 h 286109"/>
                <a:gd name="connsiteX60" fmla="*/ 609600 w 771573"/>
                <a:gd name="connsiteY60" fmla="*/ 64876 h 286109"/>
                <a:gd name="connsiteX61" fmla="*/ 598170 w 771573"/>
                <a:gd name="connsiteY61" fmla="*/ 59161 h 286109"/>
                <a:gd name="connsiteX62" fmla="*/ 592455 w 771573"/>
                <a:gd name="connsiteY62" fmla="*/ 55351 h 286109"/>
                <a:gd name="connsiteX63" fmla="*/ 584835 w 771573"/>
                <a:gd name="connsiteY63" fmla="*/ 49636 h 286109"/>
                <a:gd name="connsiteX64" fmla="*/ 573405 w 771573"/>
                <a:gd name="connsiteY64" fmla="*/ 45826 h 286109"/>
                <a:gd name="connsiteX65" fmla="*/ 567690 w 771573"/>
                <a:gd name="connsiteY65" fmla="*/ 42016 h 286109"/>
                <a:gd name="connsiteX66" fmla="*/ 556260 w 771573"/>
                <a:gd name="connsiteY66" fmla="*/ 38206 h 286109"/>
                <a:gd name="connsiteX67" fmla="*/ 548640 w 771573"/>
                <a:gd name="connsiteY67" fmla="*/ 34396 h 286109"/>
                <a:gd name="connsiteX68" fmla="*/ 537210 w 771573"/>
                <a:gd name="connsiteY68" fmla="*/ 26776 h 286109"/>
                <a:gd name="connsiteX69" fmla="*/ 493395 w 771573"/>
                <a:gd name="connsiteY69" fmla="*/ 17251 h 286109"/>
                <a:gd name="connsiteX70" fmla="*/ 485775 w 771573"/>
                <a:gd name="connsiteY70" fmla="*/ 15346 h 286109"/>
                <a:gd name="connsiteX71" fmla="*/ 472440 w 771573"/>
                <a:gd name="connsiteY71" fmla="*/ 11536 h 286109"/>
                <a:gd name="connsiteX72" fmla="*/ 409575 w 771573"/>
                <a:gd name="connsiteY72" fmla="*/ 3916 h 286109"/>
                <a:gd name="connsiteX73" fmla="*/ 360045 w 771573"/>
                <a:gd name="connsiteY73" fmla="*/ 106 h 286109"/>
                <a:gd name="connsiteX74" fmla="*/ 300990 w 771573"/>
                <a:gd name="connsiteY74" fmla="*/ 2011 h 286109"/>
                <a:gd name="connsiteX75" fmla="*/ 268605 w 771573"/>
                <a:gd name="connsiteY75" fmla="*/ 9631 h 286109"/>
                <a:gd name="connsiteX76" fmla="*/ 226695 w 771573"/>
                <a:gd name="connsiteY76" fmla="*/ 26776 h 286109"/>
                <a:gd name="connsiteX77" fmla="*/ 182880 w 771573"/>
                <a:gd name="connsiteY77" fmla="*/ 53446 h 286109"/>
                <a:gd name="connsiteX78" fmla="*/ 123825 w 771573"/>
                <a:gd name="connsiteY78" fmla="*/ 95356 h 286109"/>
                <a:gd name="connsiteX79" fmla="*/ 87630 w 771573"/>
                <a:gd name="connsiteY79" fmla="*/ 125836 h 286109"/>
                <a:gd name="connsiteX80" fmla="*/ 55245 w 771573"/>
                <a:gd name="connsiteY80" fmla="*/ 158221 h 286109"/>
                <a:gd name="connsiteX81" fmla="*/ 20955 w 771573"/>
                <a:gd name="connsiteY81" fmla="*/ 203941 h 286109"/>
                <a:gd name="connsiteX82" fmla="*/ 0 w 771573"/>
                <a:gd name="connsiteY82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21970 w 771573"/>
                <a:gd name="connsiteY11" fmla="*/ 85831 h 286109"/>
                <a:gd name="connsiteX12" fmla="*/ 537210 w 771573"/>
                <a:gd name="connsiteY12" fmla="*/ 89641 h 286109"/>
                <a:gd name="connsiteX13" fmla="*/ 542925 w 771573"/>
                <a:gd name="connsiteY13" fmla="*/ 93451 h 286109"/>
                <a:gd name="connsiteX14" fmla="*/ 550545 w 771573"/>
                <a:gd name="connsiteY14" fmla="*/ 97261 h 286109"/>
                <a:gd name="connsiteX15" fmla="*/ 565785 w 771573"/>
                <a:gd name="connsiteY15" fmla="*/ 104881 h 286109"/>
                <a:gd name="connsiteX16" fmla="*/ 575310 w 771573"/>
                <a:gd name="connsiteY16" fmla="*/ 114406 h 286109"/>
                <a:gd name="connsiteX17" fmla="*/ 581025 w 771573"/>
                <a:gd name="connsiteY17" fmla="*/ 118216 h 286109"/>
                <a:gd name="connsiteX18" fmla="*/ 600075 w 771573"/>
                <a:gd name="connsiteY18" fmla="*/ 133456 h 286109"/>
                <a:gd name="connsiteX19" fmla="*/ 607695 w 771573"/>
                <a:gd name="connsiteY19" fmla="*/ 142981 h 286109"/>
                <a:gd name="connsiteX20" fmla="*/ 621030 w 771573"/>
                <a:gd name="connsiteY20" fmla="*/ 156316 h 286109"/>
                <a:gd name="connsiteX21" fmla="*/ 628650 w 771573"/>
                <a:gd name="connsiteY21" fmla="*/ 167746 h 286109"/>
                <a:gd name="connsiteX22" fmla="*/ 638175 w 771573"/>
                <a:gd name="connsiteY22" fmla="*/ 182986 h 286109"/>
                <a:gd name="connsiteX23" fmla="*/ 647700 w 771573"/>
                <a:gd name="connsiteY23" fmla="*/ 200131 h 286109"/>
                <a:gd name="connsiteX24" fmla="*/ 657225 w 771573"/>
                <a:gd name="connsiteY24" fmla="*/ 211561 h 286109"/>
                <a:gd name="connsiteX25" fmla="*/ 668655 w 771573"/>
                <a:gd name="connsiteY25" fmla="*/ 219181 h 286109"/>
                <a:gd name="connsiteX26" fmla="*/ 672465 w 771573"/>
                <a:gd name="connsiteY26" fmla="*/ 224896 h 286109"/>
                <a:gd name="connsiteX27" fmla="*/ 678180 w 771573"/>
                <a:gd name="connsiteY27" fmla="*/ 226801 h 286109"/>
                <a:gd name="connsiteX28" fmla="*/ 681990 w 771573"/>
                <a:gd name="connsiteY28" fmla="*/ 234421 h 286109"/>
                <a:gd name="connsiteX29" fmla="*/ 697230 w 771573"/>
                <a:gd name="connsiteY29" fmla="*/ 251566 h 286109"/>
                <a:gd name="connsiteX30" fmla="*/ 701040 w 771573"/>
                <a:gd name="connsiteY30" fmla="*/ 266806 h 286109"/>
                <a:gd name="connsiteX31" fmla="*/ 710565 w 771573"/>
                <a:gd name="connsiteY31" fmla="*/ 276331 h 286109"/>
                <a:gd name="connsiteX32" fmla="*/ 723900 w 771573"/>
                <a:gd name="connsiteY32" fmla="*/ 274426 h 286109"/>
                <a:gd name="connsiteX33" fmla="*/ 727710 w 771573"/>
                <a:gd name="connsiteY33" fmla="*/ 268711 h 286109"/>
                <a:gd name="connsiteX34" fmla="*/ 741045 w 771573"/>
                <a:gd name="connsiteY34" fmla="*/ 255376 h 286109"/>
                <a:gd name="connsiteX35" fmla="*/ 746760 w 771573"/>
                <a:gd name="connsiteY35" fmla="*/ 249661 h 286109"/>
                <a:gd name="connsiteX36" fmla="*/ 754380 w 771573"/>
                <a:gd name="connsiteY36" fmla="*/ 243946 h 286109"/>
                <a:gd name="connsiteX37" fmla="*/ 762000 w 771573"/>
                <a:gd name="connsiteY37" fmla="*/ 240136 h 286109"/>
                <a:gd name="connsiteX38" fmla="*/ 767715 w 771573"/>
                <a:gd name="connsiteY38" fmla="*/ 236326 h 286109"/>
                <a:gd name="connsiteX39" fmla="*/ 771525 w 771573"/>
                <a:gd name="connsiteY39" fmla="*/ 230611 h 286109"/>
                <a:gd name="connsiteX40" fmla="*/ 765810 w 771573"/>
                <a:gd name="connsiteY40" fmla="*/ 200131 h 286109"/>
                <a:gd name="connsiteX41" fmla="*/ 762000 w 771573"/>
                <a:gd name="connsiteY41" fmla="*/ 194416 h 286109"/>
                <a:gd name="connsiteX42" fmla="*/ 756285 w 771573"/>
                <a:gd name="connsiteY42" fmla="*/ 181081 h 286109"/>
                <a:gd name="connsiteX43" fmla="*/ 748665 w 771573"/>
                <a:gd name="connsiteY43" fmla="*/ 165841 h 286109"/>
                <a:gd name="connsiteX44" fmla="*/ 739140 w 771573"/>
                <a:gd name="connsiteY44" fmla="*/ 152506 h 286109"/>
                <a:gd name="connsiteX45" fmla="*/ 737235 w 771573"/>
                <a:gd name="connsiteY45" fmla="*/ 146791 h 286109"/>
                <a:gd name="connsiteX46" fmla="*/ 727710 w 771573"/>
                <a:gd name="connsiteY46" fmla="*/ 135361 h 286109"/>
                <a:gd name="connsiteX47" fmla="*/ 720090 w 771573"/>
                <a:gd name="connsiteY47" fmla="*/ 129646 h 286109"/>
                <a:gd name="connsiteX48" fmla="*/ 714375 w 771573"/>
                <a:gd name="connsiteY48" fmla="*/ 127741 h 286109"/>
                <a:gd name="connsiteX49" fmla="*/ 702945 w 771573"/>
                <a:gd name="connsiteY49" fmla="*/ 118216 h 286109"/>
                <a:gd name="connsiteX50" fmla="*/ 697230 w 771573"/>
                <a:gd name="connsiteY50" fmla="*/ 112501 h 286109"/>
                <a:gd name="connsiteX51" fmla="*/ 691515 w 771573"/>
                <a:gd name="connsiteY51" fmla="*/ 108691 h 286109"/>
                <a:gd name="connsiteX52" fmla="*/ 683895 w 771573"/>
                <a:gd name="connsiteY52" fmla="*/ 102976 h 286109"/>
                <a:gd name="connsiteX53" fmla="*/ 676275 w 771573"/>
                <a:gd name="connsiteY53" fmla="*/ 99166 h 286109"/>
                <a:gd name="connsiteX54" fmla="*/ 664845 w 771573"/>
                <a:gd name="connsiteY54" fmla="*/ 95356 h 286109"/>
                <a:gd name="connsiteX55" fmla="*/ 655320 w 771573"/>
                <a:gd name="connsiteY55" fmla="*/ 89641 h 286109"/>
                <a:gd name="connsiteX56" fmla="*/ 640080 w 771573"/>
                <a:gd name="connsiteY56" fmla="*/ 83926 h 286109"/>
                <a:gd name="connsiteX57" fmla="*/ 626745 w 771573"/>
                <a:gd name="connsiteY57" fmla="*/ 74401 h 286109"/>
                <a:gd name="connsiteX58" fmla="*/ 621030 w 771573"/>
                <a:gd name="connsiteY58" fmla="*/ 72496 h 286109"/>
                <a:gd name="connsiteX59" fmla="*/ 609600 w 771573"/>
                <a:gd name="connsiteY59" fmla="*/ 64876 h 286109"/>
                <a:gd name="connsiteX60" fmla="*/ 598170 w 771573"/>
                <a:gd name="connsiteY60" fmla="*/ 59161 h 286109"/>
                <a:gd name="connsiteX61" fmla="*/ 592455 w 771573"/>
                <a:gd name="connsiteY61" fmla="*/ 55351 h 286109"/>
                <a:gd name="connsiteX62" fmla="*/ 584835 w 771573"/>
                <a:gd name="connsiteY62" fmla="*/ 49636 h 286109"/>
                <a:gd name="connsiteX63" fmla="*/ 573405 w 771573"/>
                <a:gd name="connsiteY63" fmla="*/ 45826 h 286109"/>
                <a:gd name="connsiteX64" fmla="*/ 567690 w 771573"/>
                <a:gd name="connsiteY64" fmla="*/ 42016 h 286109"/>
                <a:gd name="connsiteX65" fmla="*/ 556260 w 771573"/>
                <a:gd name="connsiteY65" fmla="*/ 38206 h 286109"/>
                <a:gd name="connsiteX66" fmla="*/ 548640 w 771573"/>
                <a:gd name="connsiteY66" fmla="*/ 34396 h 286109"/>
                <a:gd name="connsiteX67" fmla="*/ 537210 w 771573"/>
                <a:gd name="connsiteY67" fmla="*/ 26776 h 286109"/>
                <a:gd name="connsiteX68" fmla="*/ 493395 w 771573"/>
                <a:gd name="connsiteY68" fmla="*/ 17251 h 286109"/>
                <a:gd name="connsiteX69" fmla="*/ 485775 w 771573"/>
                <a:gd name="connsiteY69" fmla="*/ 15346 h 286109"/>
                <a:gd name="connsiteX70" fmla="*/ 472440 w 771573"/>
                <a:gd name="connsiteY70" fmla="*/ 11536 h 286109"/>
                <a:gd name="connsiteX71" fmla="*/ 409575 w 771573"/>
                <a:gd name="connsiteY71" fmla="*/ 3916 h 286109"/>
                <a:gd name="connsiteX72" fmla="*/ 360045 w 771573"/>
                <a:gd name="connsiteY72" fmla="*/ 106 h 286109"/>
                <a:gd name="connsiteX73" fmla="*/ 300990 w 771573"/>
                <a:gd name="connsiteY73" fmla="*/ 2011 h 286109"/>
                <a:gd name="connsiteX74" fmla="*/ 268605 w 771573"/>
                <a:gd name="connsiteY74" fmla="*/ 9631 h 286109"/>
                <a:gd name="connsiteX75" fmla="*/ 226695 w 771573"/>
                <a:gd name="connsiteY75" fmla="*/ 26776 h 286109"/>
                <a:gd name="connsiteX76" fmla="*/ 182880 w 771573"/>
                <a:gd name="connsiteY76" fmla="*/ 53446 h 286109"/>
                <a:gd name="connsiteX77" fmla="*/ 123825 w 771573"/>
                <a:gd name="connsiteY77" fmla="*/ 95356 h 286109"/>
                <a:gd name="connsiteX78" fmla="*/ 87630 w 771573"/>
                <a:gd name="connsiteY78" fmla="*/ 125836 h 286109"/>
                <a:gd name="connsiteX79" fmla="*/ 55245 w 771573"/>
                <a:gd name="connsiteY79" fmla="*/ 158221 h 286109"/>
                <a:gd name="connsiteX80" fmla="*/ 20955 w 771573"/>
                <a:gd name="connsiteY80" fmla="*/ 203941 h 286109"/>
                <a:gd name="connsiteX81" fmla="*/ 0 w 771573"/>
                <a:gd name="connsiteY81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65785 w 771573"/>
                <a:gd name="connsiteY14" fmla="*/ 104881 h 286109"/>
                <a:gd name="connsiteX15" fmla="*/ 575310 w 771573"/>
                <a:gd name="connsiteY15" fmla="*/ 114406 h 286109"/>
                <a:gd name="connsiteX16" fmla="*/ 581025 w 771573"/>
                <a:gd name="connsiteY16" fmla="*/ 118216 h 286109"/>
                <a:gd name="connsiteX17" fmla="*/ 600075 w 771573"/>
                <a:gd name="connsiteY17" fmla="*/ 133456 h 286109"/>
                <a:gd name="connsiteX18" fmla="*/ 607695 w 771573"/>
                <a:gd name="connsiteY18" fmla="*/ 142981 h 286109"/>
                <a:gd name="connsiteX19" fmla="*/ 621030 w 771573"/>
                <a:gd name="connsiteY19" fmla="*/ 156316 h 286109"/>
                <a:gd name="connsiteX20" fmla="*/ 628650 w 771573"/>
                <a:gd name="connsiteY20" fmla="*/ 167746 h 286109"/>
                <a:gd name="connsiteX21" fmla="*/ 638175 w 771573"/>
                <a:gd name="connsiteY21" fmla="*/ 182986 h 286109"/>
                <a:gd name="connsiteX22" fmla="*/ 647700 w 771573"/>
                <a:gd name="connsiteY22" fmla="*/ 200131 h 286109"/>
                <a:gd name="connsiteX23" fmla="*/ 657225 w 771573"/>
                <a:gd name="connsiteY23" fmla="*/ 211561 h 286109"/>
                <a:gd name="connsiteX24" fmla="*/ 668655 w 771573"/>
                <a:gd name="connsiteY24" fmla="*/ 219181 h 286109"/>
                <a:gd name="connsiteX25" fmla="*/ 672465 w 771573"/>
                <a:gd name="connsiteY25" fmla="*/ 224896 h 286109"/>
                <a:gd name="connsiteX26" fmla="*/ 678180 w 771573"/>
                <a:gd name="connsiteY26" fmla="*/ 226801 h 286109"/>
                <a:gd name="connsiteX27" fmla="*/ 681990 w 771573"/>
                <a:gd name="connsiteY27" fmla="*/ 234421 h 286109"/>
                <a:gd name="connsiteX28" fmla="*/ 697230 w 771573"/>
                <a:gd name="connsiteY28" fmla="*/ 251566 h 286109"/>
                <a:gd name="connsiteX29" fmla="*/ 701040 w 771573"/>
                <a:gd name="connsiteY29" fmla="*/ 266806 h 286109"/>
                <a:gd name="connsiteX30" fmla="*/ 710565 w 771573"/>
                <a:gd name="connsiteY30" fmla="*/ 276331 h 286109"/>
                <a:gd name="connsiteX31" fmla="*/ 723900 w 771573"/>
                <a:gd name="connsiteY31" fmla="*/ 274426 h 286109"/>
                <a:gd name="connsiteX32" fmla="*/ 727710 w 771573"/>
                <a:gd name="connsiteY32" fmla="*/ 268711 h 286109"/>
                <a:gd name="connsiteX33" fmla="*/ 741045 w 771573"/>
                <a:gd name="connsiteY33" fmla="*/ 255376 h 286109"/>
                <a:gd name="connsiteX34" fmla="*/ 746760 w 771573"/>
                <a:gd name="connsiteY34" fmla="*/ 249661 h 286109"/>
                <a:gd name="connsiteX35" fmla="*/ 754380 w 771573"/>
                <a:gd name="connsiteY35" fmla="*/ 243946 h 286109"/>
                <a:gd name="connsiteX36" fmla="*/ 762000 w 771573"/>
                <a:gd name="connsiteY36" fmla="*/ 240136 h 286109"/>
                <a:gd name="connsiteX37" fmla="*/ 767715 w 771573"/>
                <a:gd name="connsiteY37" fmla="*/ 236326 h 286109"/>
                <a:gd name="connsiteX38" fmla="*/ 771525 w 771573"/>
                <a:gd name="connsiteY38" fmla="*/ 230611 h 286109"/>
                <a:gd name="connsiteX39" fmla="*/ 765810 w 771573"/>
                <a:gd name="connsiteY39" fmla="*/ 200131 h 286109"/>
                <a:gd name="connsiteX40" fmla="*/ 762000 w 771573"/>
                <a:gd name="connsiteY40" fmla="*/ 194416 h 286109"/>
                <a:gd name="connsiteX41" fmla="*/ 756285 w 771573"/>
                <a:gd name="connsiteY41" fmla="*/ 181081 h 286109"/>
                <a:gd name="connsiteX42" fmla="*/ 748665 w 771573"/>
                <a:gd name="connsiteY42" fmla="*/ 165841 h 286109"/>
                <a:gd name="connsiteX43" fmla="*/ 739140 w 771573"/>
                <a:gd name="connsiteY43" fmla="*/ 152506 h 286109"/>
                <a:gd name="connsiteX44" fmla="*/ 737235 w 771573"/>
                <a:gd name="connsiteY44" fmla="*/ 146791 h 286109"/>
                <a:gd name="connsiteX45" fmla="*/ 727710 w 771573"/>
                <a:gd name="connsiteY45" fmla="*/ 135361 h 286109"/>
                <a:gd name="connsiteX46" fmla="*/ 720090 w 771573"/>
                <a:gd name="connsiteY46" fmla="*/ 129646 h 286109"/>
                <a:gd name="connsiteX47" fmla="*/ 714375 w 771573"/>
                <a:gd name="connsiteY47" fmla="*/ 127741 h 286109"/>
                <a:gd name="connsiteX48" fmla="*/ 702945 w 771573"/>
                <a:gd name="connsiteY48" fmla="*/ 118216 h 286109"/>
                <a:gd name="connsiteX49" fmla="*/ 697230 w 771573"/>
                <a:gd name="connsiteY49" fmla="*/ 112501 h 286109"/>
                <a:gd name="connsiteX50" fmla="*/ 691515 w 771573"/>
                <a:gd name="connsiteY50" fmla="*/ 108691 h 286109"/>
                <a:gd name="connsiteX51" fmla="*/ 683895 w 771573"/>
                <a:gd name="connsiteY51" fmla="*/ 102976 h 286109"/>
                <a:gd name="connsiteX52" fmla="*/ 676275 w 771573"/>
                <a:gd name="connsiteY52" fmla="*/ 99166 h 286109"/>
                <a:gd name="connsiteX53" fmla="*/ 664845 w 771573"/>
                <a:gd name="connsiteY53" fmla="*/ 95356 h 286109"/>
                <a:gd name="connsiteX54" fmla="*/ 655320 w 771573"/>
                <a:gd name="connsiteY54" fmla="*/ 89641 h 286109"/>
                <a:gd name="connsiteX55" fmla="*/ 640080 w 771573"/>
                <a:gd name="connsiteY55" fmla="*/ 83926 h 286109"/>
                <a:gd name="connsiteX56" fmla="*/ 626745 w 771573"/>
                <a:gd name="connsiteY56" fmla="*/ 74401 h 286109"/>
                <a:gd name="connsiteX57" fmla="*/ 621030 w 771573"/>
                <a:gd name="connsiteY57" fmla="*/ 72496 h 286109"/>
                <a:gd name="connsiteX58" fmla="*/ 609600 w 771573"/>
                <a:gd name="connsiteY58" fmla="*/ 64876 h 286109"/>
                <a:gd name="connsiteX59" fmla="*/ 598170 w 771573"/>
                <a:gd name="connsiteY59" fmla="*/ 59161 h 286109"/>
                <a:gd name="connsiteX60" fmla="*/ 592455 w 771573"/>
                <a:gd name="connsiteY60" fmla="*/ 55351 h 286109"/>
                <a:gd name="connsiteX61" fmla="*/ 584835 w 771573"/>
                <a:gd name="connsiteY61" fmla="*/ 49636 h 286109"/>
                <a:gd name="connsiteX62" fmla="*/ 573405 w 771573"/>
                <a:gd name="connsiteY62" fmla="*/ 45826 h 286109"/>
                <a:gd name="connsiteX63" fmla="*/ 567690 w 771573"/>
                <a:gd name="connsiteY63" fmla="*/ 42016 h 286109"/>
                <a:gd name="connsiteX64" fmla="*/ 556260 w 771573"/>
                <a:gd name="connsiteY64" fmla="*/ 38206 h 286109"/>
                <a:gd name="connsiteX65" fmla="*/ 548640 w 771573"/>
                <a:gd name="connsiteY65" fmla="*/ 34396 h 286109"/>
                <a:gd name="connsiteX66" fmla="*/ 537210 w 771573"/>
                <a:gd name="connsiteY66" fmla="*/ 26776 h 286109"/>
                <a:gd name="connsiteX67" fmla="*/ 493395 w 771573"/>
                <a:gd name="connsiteY67" fmla="*/ 17251 h 286109"/>
                <a:gd name="connsiteX68" fmla="*/ 485775 w 771573"/>
                <a:gd name="connsiteY68" fmla="*/ 15346 h 286109"/>
                <a:gd name="connsiteX69" fmla="*/ 472440 w 771573"/>
                <a:gd name="connsiteY69" fmla="*/ 11536 h 286109"/>
                <a:gd name="connsiteX70" fmla="*/ 409575 w 771573"/>
                <a:gd name="connsiteY70" fmla="*/ 3916 h 286109"/>
                <a:gd name="connsiteX71" fmla="*/ 360045 w 771573"/>
                <a:gd name="connsiteY71" fmla="*/ 106 h 286109"/>
                <a:gd name="connsiteX72" fmla="*/ 300990 w 771573"/>
                <a:gd name="connsiteY72" fmla="*/ 2011 h 286109"/>
                <a:gd name="connsiteX73" fmla="*/ 268605 w 771573"/>
                <a:gd name="connsiteY73" fmla="*/ 9631 h 286109"/>
                <a:gd name="connsiteX74" fmla="*/ 226695 w 771573"/>
                <a:gd name="connsiteY74" fmla="*/ 26776 h 286109"/>
                <a:gd name="connsiteX75" fmla="*/ 182880 w 771573"/>
                <a:gd name="connsiteY75" fmla="*/ 53446 h 286109"/>
                <a:gd name="connsiteX76" fmla="*/ 123825 w 771573"/>
                <a:gd name="connsiteY76" fmla="*/ 95356 h 286109"/>
                <a:gd name="connsiteX77" fmla="*/ 87630 w 771573"/>
                <a:gd name="connsiteY77" fmla="*/ 125836 h 286109"/>
                <a:gd name="connsiteX78" fmla="*/ 55245 w 771573"/>
                <a:gd name="connsiteY78" fmla="*/ 158221 h 286109"/>
                <a:gd name="connsiteX79" fmla="*/ 20955 w 771573"/>
                <a:gd name="connsiteY79" fmla="*/ 203941 h 286109"/>
                <a:gd name="connsiteX80" fmla="*/ 0 w 771573"/>
                <a:gd name="connsiteY80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1030 w 771573"/>
                <a:gd name="connsiteY18" fmla="*/ 156316 h 286109"/>
                <a:gd name="connsiteX19" fmla="*/ 628650 w 771573"/>
                <a:gd name="connsiteY19" fmla="*/ 167746 h 286109"/>
                <a:gd name="connsiteX20" fmla="*/ 638175 w 771573"/>
                <a:gd name="connsiteY20" fmla="*/ 182986 h 286109"/>
                <a:gd name="connsiteX21" fmla="*/ 647700 w 771573"/>
                <a:gd name="connsiteY21" fmla="*/ 200131 h 286109"/>
                <a:gd name="connsiteX22" fmla="*/ 657225 w 771573"/>
                <a:gd name="connsiteY22" fmla="*/ 211561 h 286109"/>
                <a:gd name="connsiteX23" fmla="*/ 668655 w 771573"/>
                <a:gd name="connsiteY23" fmla="*/ 219181 h 286109"/>
                <a:gd name="connsiteX24" fmla="*/ 672465 w 771573"/>
                <a:gd name="connsiteY24" fmla="*/ 224896 h 286109"/>
                <a:gd name="connsiteX25" fmla="*/ 678180 w 771573"/>
                <a:gd name="connsiteY25" fmla="*/ 226801 h 286109"/>
                <a:gd name="connsiteX26" fmla="*/ 681990 w 771573"/>
                <a:gd name="connsiteY26" fmla="*/ 234421 h 286109"/>
                <a:gd name="connsiteX27" fmla="*/ 697230 w 771573"/>
                <a:gd name="connsiteY27" fmla="*/ 251566 h 286109"/>
                <a:gd name="connsiteX28" fmla="*/ 701040 w 771573"/>
                <a:gd name="connsiteY28" fmla="*/ 266806 h 286109"/>
                <a:gd name="connsiteX29" fmla="*/ 710565 w 771573"/>
                <a:gd name="connsiteY29" fmla="*/ 276331 h 286109"/>
                <a:gd name="connsiteX30" fmla="*/ 723900 w 771573"/>
                <a:gd name="connsiteY30" fmla="*/ 274426 h 286109"/>
                <a:gd name="connsiteX31" fmla="*/ 727710 w 771573"/>
                <a:gd name="connsiteY31" fmla="*/ 268711 h 286109"/>
                <a:gd name="connsiteX32" fmla="*/ 741045 w 771573"/>
                <a:gd name="connsiteY32" fmla="*/ 255376 h 286109"/>
                <a:gd name="connsiteX33" fmla="*/ 746760 w 771573"/>
                <a:gd name="connsiteY33" fmla="*/ 249661 h 286109"/>
                <a:gd name="connsiteX34" fmla="*/ 754380 w 771573"/>
                <a:gd name="connsiteY34" fmla="*/ 243946 h 286109"/>
                <a:gd name="connsiteX35" fmla="*/ 762000 w 771573"/>
                <a:gd name="connsiteY35" fmla="*/ 240136 h 286109"/>
                <a:gd name="connsiteX36" fmla="*/ 767715 w 771573"/>
                <a:gd name="connsiteY36" fmla="*/ 236326 h 286109"/>
                <a:gd name="connsiteX37" fmla="*/ 771525 w 771573"/>
                <a:gd name="connsiteY37" fmla="*/ 230611 h 286109"/>
                <a:gd name="connsiteX38" fmla="*/ 765810 w 771573"/>
                <a:gd name="connsiteY38" fmla="*/ 200131 h 286109"/>
                <a:gd name="connsiteX39" fmla="*/ 762000 w 771573"/>
                <a:gd name="connsiteY39" fmla="*/ 194416 h 286109"/>
                <a:gd name="connsiteX40" fmla="*/ 756285 w 771573"/>
                <a:gd name="connsiteY40" fmla="*/ 181081 h 286109"/>
                <a:gd name="connsiteX41" fmla="*/ 748665 w 771573"/>
                <a:gd name="connsiteY41" fmla="*/ 165841 h 286109"/>
                <a:gd name="connsiteX42" fmla="*/ 739140 w 771573"/>
                <a:gd name="connsiteY42" fmla="*/ 152506 h 286109"/>
                <a:gd name="connsiteX43" fmla="*/ 737235 w 771573"/>
                <a:gd name="connsiteY43" fmla="*/ 146791 h 286109"/>
                <a:gd name="connsiteX44" fmla="*/ 727710 w 771573"/>
                <a:gd name="connsiteY44" fmla="*/ 135361 h 286109"/>
                <a:gd name="connsiteX45" fmla="*/ 720090 w 771573"/>
                <a:gd name="connsiteY45" fmla="*/ 129646 h 286109"/>
                <a:gd name="connsiteX46" fmla="*/ 714375 w 771573"/>
                <a:gd name="connsiteY46" fmla="*/ 127741 h 286109"/>
                <a:gd name="connsiteX47" fmla="*/ 702945 w 771573"/>
                <a:gd name="connsiteY47" fmla="*/ 118216 h 286109"/>
                <a:gd name="connsiteX48" fmla="*/ 697230 w 771573"/>
                <a:gd name="connsiteY48" fmla="*/ 112501 h 286109"/>
                <a:gd name="connsiteX49" fmla="*/ 691515 w 771573"/>
                <a:gd name="connsiteY49" fmla="*/ 108691 h 286109"/>
                <a:gd name="connsiteX50" fmla="*/ 683895 w 771573"/>
                <a:gd name="connsiteY50" fmla="*/ 102976 h 286109"/>
                <a:gd name="connsiteX51" fmla="*/ 676275 w 771573"/>
                <a:gd name="connsiteY51" fmla="*/ 99166 h 286109"/>
                <a:gd name="connsiteX52" fmla="*/ 664845 w 771573"/>
                <a:gd name="connsiteY52" fmla="*/ 95356 h 286109"/>
                <a:gd name="connsiteX53" fmla="*/ 655320 w 771573"/>
                <a:gd name="connsiteY53" fmla="*/ 89641 h 286109"/>
                <a:gd name="connsiteX54" fmla="*/ 640080 w 771573"/>
                <a:gd name="connsiteY54" fmla="*/ 83926 h 286109"/>
                <a:gd name="connsiteX55" fmla="*/ 626745 w 771573"/>
                <a:gd name="connsiteY55" fmla="*/ 74401 h 286109"/>
                <a:gd name="connsiteX56" fmla="*/ 621030 w 771573"/>
                <a:gd name="connsiteY56" fmla="*/ 72496 h 286109"/>
                <a:gd name="connsiteX57" fmla="*/ 609600 w 771573"/>
                <a:gd name="connsiteY57" fmla="*/ 64876 h 286109"/>
                <a:gd name="connsiteX58" fmla="*/ 598170 w 771573"/>
                <a:gd name="connsiteY58" fmla="*/ 59161 h 286109"/>
                <a:gd name="connsiteX59" fmla="*/ 592455 w 771573"/>
                <a:gd name="connsiteY59" fmla="*/ 55351 h 286109"/>
                <a:gd name="connsiteX60" fmla="*/ 584835 w 771573"/>
                <a:gd name="connsiteY60" fmla="*/ 49636 h 286109"/>
                <a:gd name="connsiteX61" fmla="*/ 573405 w 771573"/>
                <a:gd name="connsiteY61" fmla="*/ 45826 h 286109"/>
                <a:gd name="connsiteX62" fmla="*/ 567690 w 771573"/>
                <a:gd name="connsiteY62" fmla="*/ 42016 h 286109"/>
                <a:gd name="connsiteX63" fmla="*/ 556260 w 771573"/>
                <a:gd name="connsiteY63" fmla="*/ 38206 h 286109"/>
                <a:gd name="connsiteX64" fmla="*/ 548640 w 771573"/>
                <a:gd name="connsiteY64" fmla="*/ 34396 h 286109"/>
                <a:gd name="connsiteX65" fmla="*/ 537210 w 771573"/>
                <a:gd name="connsiteY65" fmla="*/ 26776 h 286109"/>
                <a:gd name="connsiteX66" fmla="*/ 493395 w 771573"/>
                <a:gd name="connsiteY66" fmla="*/ 17251 h 286109"/>
                <a:gd name="connsiteX67" fmla="*/ 485775 w 771573"/>
                <a:gd name="connsiteY67" fmla="*/ 15346 h 286109"/>
                <a:gd name="connsiteX68" fmla="*/ 472440 w 771573"/>
                <a:gd name="connsiteY68" fmla="*/ 11536 h 286109"/>
                <a:gd name="connsiteX69" fmla="*/ 409575 w 771573"/>
                <a:gd name="connsiteY69" fmla="*/ 3916 h 286109"/>
                <a:gd name="connsiteX70" fmla="*/ 360045 w 771573"/>
                <a:gd name="connsiteY70" fmla="*/ 106 h 286109"/>
                <a:gd name="connsiteX71" fmla="*/ 300990 w 771573"/>
                <a:gd name="connsiteY71" fmla="*/ 2011 h 286109"/>
                <a:gd name="connsiteX72" fmla="*/ 268605 w 771573"/>
                <a:gd name="connsiteY72" fmla="*/ 9631 h 286109"/>
                <a:gd name="connsiteX73" fmla="*/ 226695 w 771573"/>
                <a:gd name="connsiteY73" fmla="*/ 26776 h 286109"/>
                <a:gd name="connsiteX74" fmla="*/ 182880 w 771573"/>
                <a:gd name="connsiteY74" fmla="*/ 53446 h 286109"/>
                <a:gd name="connsiteX75" fmla="*/ 123825 w 771573"/>
                <a:gd name="connsiteY75" fmla="*/ 95356 h 286109"/>
                <a:gd name="connsiteX76" fmla="*/ 87630 w 771573"/>
                <a:gd name="connsiteY76" fmla="*/ 125836 h 286109"/>
                <a:gd name="connsiteX77" fmla="*/ 55245 w 771573"/>
                <a:gd name="connsiteY77" fmla="*/ 158221 h 286109"/>
                <a:gd name="connsiteX78" fmla="*/ 20955 w 771573"/>
                <a:gd name="connsiteY78" fmla="*/ 203941 h 286109"/>
                <a:gd name="connsiteX79" fmla="*/ 0 w 771573"/>
                <a:gd name="connsiteY79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47700 w 771573"/>
                <a:gd name="connsiteY20" fmla="*/ 200131 h 286109"/>
                <a:gd name="connsiteX21" fmla="*/ 657225 w 771573"/>
                <a:gd name="connsiteY21" fmla="*/ 211561 h 286109"/>
                <a:gd name="connsiteX22" fmla="*/ 668655 w 771573"/>
                <a:gd name="connsiteY22" fmla="*/ 219181 h 286109"/>
                <a:gd name="connsiteX23" fmla="*/ 672465 w 771573"/>
                <a:gd name="connsiteY23" fmla="*/ 224896 h 286109"/>
                <a:gd name="connsiteX24" fmla="*/ 678180 w 771573"/>
                <a:gd name="connsiteY24" fmla="*/ 226801 h 286109"/>
                <a:gd name="connsiteX25" fmla="*/ 681990 w 771573"/>
                <a:gd name="connsiteY25" fmla="*/ 234421 h 286109"/>
                <a:gd name="connsiteX26" fmla="*/ 697230 w 771573"/>
                <a:gd name="connsiteY26" fmla="*/ 251566 h 286109"/>
                <a:gd name="connsiteX27" fmla="*/ 701040 w 771573"/>
                <a:gd name="connsiteY27" fmla="*/ 266806 h 286109"/>
                <a:gd name="connsiteX28" fmla="*/ 710565 w 771573"/>
                <a:gd name="connsiteY28" fmla="*/ 276331 h 286109"/>
                <a:gd name="connsiteX29" fmla="*/ 723900 w 771573"/>
                <a:gd name="connsiteY29" fmla="*/ 274426 h 286109"/>
                <a:gd name="connsiteX30" fmla="*/ 727710 w 771573"/>
                <a:gd name="connsiteY30" fmla="*/ 268711 h 286109"/>
                <a:gd name="connsiteX31" fmla="*/ 741045 w 771573"/>
                <a:gd name="connsiteY31" fmla="*/ 255376 h 286109"/>
                <a:gd name="connsiteX32" fmla="*/ 746760 w 771573"/>
                <a:gd name="connsiteY32" fmla="*/ 249661 h 286109"/>
                <a:gd name="connsiteX33" fmla="*/ 754380 w 771573"/>
                <a:gd name="connsiteY33" fmla="*/ 243946 h 286109"/>
                <a:gd name="connsiteX34" fmla="*/ 762000 w 771573"/>
                <a:gd name="connsiteY34" fmla="*/ 240136 h 286109"/>
                <a:gd name="connsiteX35" fmla="*/ 767715 w 771573"/>
                <a:gd name="connsiteY35" fmla="*/ 236326 h 286109"/>
                <a:gd name="connsiteX36" fmla="*/ 771525 w 771573"/>
                <a:gd name="connsiteY36" fmla="*/ 230611 h 286109"/>
                <a:gd name="connsiteX37" fmla="*/ 765810 w 771573"/>
                <a:gd name="connsiteY37" fmla="*/ 200131 h 286109"/>
                <a:gd name="connsiteX38" fmla="*/ 762000 w 771573"/>
                <a:gd name="connsiteY38" fmla="*/ 194416 h 286109"/>
                <a:gd name="connsiteX39" fmla="*/ 756285 w 771573"/>
                <a:gd name="connsiteY39" fmla="*/ 181081 h 286109"/>
                <a:gd name="connsiteX40" fmla="*/ 748665 w 771573"/>
                <a:gd name="connsiteY40" fmla="*/ 165841 h 286109"/>
                <a:gd name="connsiteX41" fmla="*/ 739140 w 771573"/>
                <a:gd name="connsiteY41" fmla="*/ 152506 h 286109"/>
                <a:gd name="connsiteX42" fmla="*/ 737235 w 771573"/>
                <a:gd name="connsiteY42" fmla="*/ 146791 h 286109"/>
                <a:gd name="connsiteX43" fmla="*/ 727710 w 771573"/>
                <a:gd name="connsiteY43" fmla="*/ 135361 h 286109"/>
                <a:gd name="connsiteX44" fmla="*/ 720090 w 771573"/>
                <a:gd name="connsiteY44" fmla="*/ 129646 h 286109"/>
                <a:gd name="connsiteX45" fmla="*/ 714375 w 771573"/>
                <a:gd name="connsiteY45" fmla="*/ 127741 h 286109"/>
                <a:gd name="connsiteX46" fmla="*/ 702945 w 771573"/>
                <a:gd name="connsiteY46" fmla="*/ 118216 h 286109"/>
                <a:gd name="connsiteX47" fmla="*/ 697230 w 771573"/>
                <a:gd name="connsiteY47" fmla="*/ 112501 h 286109"/>
                <a:gd name="connsiteX48" fmla="*/ 691515 w 771573"/>
                <a:gd name="connsiteY48" fmla="*/ 108691 h 286109"/>
                <a:gd name="connsiteX49" fmla="*/ 683895 w 771573"/>
                <a:gd name="connsiteY49" fmla="*/ 102976 h 286109"/>
                <a:gd name="connsiteX50" fmla="*/ 676275 w 771573"/>
                <a:gd name="connsiteY50" fmla="*/ 99166 h 286109"/>
                <a:gd name="connsiteX51" fmla="*/ 664845 w 771573"/>
                <a:gd name="connsiteY51" fmla="*/ 95356 h 286109"/>
                <a:gd name="connsiteX52" fmla="*/ 655320 w 771573"/>
                <a:gd name="connsiteY52" fmla="*/ 89641 h 286109"/>
                <a:gd name="connsiteX53" fmla="*/ 640080 w 771573"/>
                <a:gd name="connsiteY53" fmla="*/ 83926 h 286109"/>
                <a:gd name="connsiteX54" fmla="*/ 626745 w 771573"/>
                <a:gd name="connsiteY54" fmla="*/ 74401 h 286109"/>
                <a:gd name="connsiteX55" fmla="*/ 621030 w 771573"/>
                <a:gd name="connsiteY55" fmla="*/ 72496 h 286109"/>
                <a:gd name="connsiteX56" fmla="*/ 609600 w 771573"/>
                <a:gd name="connsiteY56" fmla="*/ 64876 h 286109"/>
                <a:gd name="connsiteX57" fmla="*/ 598170 w 771573"/>
                <a:gd name="connsiteY57" fmla="*/ 59161 h 286109"/>
                <a:gd name="connsiteX58" fmla="*/ 592455 w 771573"/>
                <a:gd name="connsiteY58" fmla="*/ 55351 h 286109"/>
                <a:gd name="connsiteX59" fmla="*/ 584835 w 771573"/>
                <a:gd name="connsiteY59" fmla="*/ 49636 h 286109"/>
                <a:gd name="connsiteX60" fmla="*/ 573405 w 771573"/>
                <a:gd name="connsiteY60" fmla="*/ 45826 h 286109"/>
                <a:gd name="connsiteX61" fmla="*/ 567690 w 771573"/>
                <a:gd name="connsiteY61" fmla="*/ 42016 h 286109"/>
                <a:gd name="connsiteX62" fmla="*/ 556260 w 771573"/>
                <a:gd name="connsiteY62" fmla="*/ 38206 h 286109"/>
                <a:gd name="connsiteX63" fmla="*/ 548640 w 771573"/>
                <a:gd name="connsiteY63" fmla="*/ 34396 h 286109"/>
                <a:gd name="connsiteX64" fmla="*/ 537210 w 771573"/>
                <a:gd name="connsiteY64" fmla="*/ 26776 h 286109"/>
                <a:gd name="connsiteX65" fmla="*/ 493395 w 771573"/>
                <a:gd name="connsiteY65" fmla="*/ 17251 h 286109"/>
                <a:gd name="connsiteX66" fmla="*/ 485775 w 771573"/>
                <a:gd name="connsiteY66" fmla="*/ 15346 h 286109"/>
                <a:gd name="connsiteX67" fmla="*/ 472440 w 771573"/>
                <a:gd name="connsiteY67" fmla="*/ 11536 h 286109"/>
                <a:gd name="connsiteX68" fmla="*/ 409575 w 771573"/>
                <a:gd name="connsiteY68" fmla="*/ 3916 h 286109"/>
                <a:gd name="connsiteX69" fmla="*/ 360045 w 771573"/>
                <a:gd name="connsiteY69" fmla="*/ 106 h 286109"/>
                <a:gd name="connsiteX70" fmla="*/ 300990 w 771573"/>
                <a:gd name="connsiteY70" fmla="*/ 2011 h 286109"/>
                <a:gd name="connsiteX71" fmla="*/ 268605 w 771573"/>
                <a:gd name="connsiteY71" fmla="*/ 9631 h 286109"/>
                <a:gd name="connsiteX72" fmla="*/ 226695 w 771573"/>
                <a:gd name="connsiteY72" fmla="*/ 26776 h 286109"/>
                <a:gd name="connsiteX73" fmla="*/ 182880 w 771573"/>
                <a:gd name="connsiteY73" fmla="*/ 53446 h 286109"/>
                <a:gd name="connsiteX74" fmla="*/ 123825 w 771573"/>
                <a:gd name="connsiteY74" fmla="*/ 95356 h 286109"/>
                <a:gd name="connsiteX75" fmla="*/ 87630 w 771573"/>
                <a:gd name="connsiteY75" fmla="*/ 125836 h 286109"/>
                <a:gd name="connsiteX76" fmla="*/ 55245 w 771573"/>
                <a:gd name="connsiteY76" fmla="*/ 158221 h 286109"/>
                <a:gd name="connsiteX77" fmla="*/ 20955 w 771573"/>
                <a:gd name="connsiteY77" fmla="*/ 203941 h 286109"/>
                <a:gd name="connsiteX78" fmla="*/ 0 w 771573"/>
                <a:gd name="connsiteY78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57225 w 771573"/>
                <a:gd name="connsiteY20" fmla="*/ 211561 h 286109"/>
                <a:gd name="connsiteX21" fmla="*/ 668655 w 771573"/>
                <a:gd name="connsiteY21" fmla="*/ 219181 h 286109"/>
                <a:gd name="connsiteX22" fmla="*/ 672465 w 771573"/>
                <a:gd name="connsiteY22" fmla="*/ 224896 h 286109"/>
                <a:gd name="connsiteX23" fmla="*/ 678180 w 771573"/>
                <a:gd name="connsiteY23" fmla="*/ 226801 h 286109"/>
                <a:gd name="connsiteX24" fmla="*/ 681990 w 771573"/>
                <a:gd name="connsiteY24" fmla="*/ 234421 h 286109"/>
                <a:gd name="connsiteX25" fmla="*/ 697230 w 771573"/>
                <a:gd name="connsiteY25" fmla="*/ 251566 h 286109"/>
                <a:gd name="connsiteX26" fmla="*/ 701040 w 771573"/>
                <a:gd name="connsiteY26" fmla="*/ 266806 h 286109"/>
                <a:gd name="connsiteX27" fmla="*/ 710565 w 771573"/>
                <a:gd name="connsiteY27" fmla="*/ 276331 h 286109"/>
                <a:gd name="connsiteX28" fmla="*/ 723900 w 771573"/>
                <a:gd name="connsiteY28" fmla="*/ 274426 h 286109"/>
                <a:gd name="connsiteX29" fmla="*/ 727710 w 771573"/>
                <a:gd name="connsiteY29" fmla="*/ 268711 h 286109"/>
                <a:gd name="connsiteX30" fmla="*/ 741045 w 771573"/>
                <a:gd name="connsiteY30" fmla="*/ 255376 h 286109"/>
                <a:gd name="connsiteX31" fmla="*/ 746760 w 771573"/>
                <a:gd name="connsiteY31" fmla="*/ 249661 h 286109"/>
                <a:gd name="connsiteX32" fmla="*/ 754380 w 771573"/>
                <a:gd name="connsiteY32" fmla="*/ 243946 h 286109"/>
                <a:gd name="connsiteX33" fmla="*/ 762000 w 771573"/>
                <a:gd name="connsiteY33" fmla="*/ 240136 h 286109"/>
                <a:gd name="connsiteX34" fmla="*/ 767715 w 771573"/>
                <a:gd name="connsiteY34" fmla="*/ 236326 h 286109"/>
                <a:gd name="connsiteX35" fmla="*/ 771525 w 771573"/>
                <a:gd name="connsiteY35" fmla="*/ 230611 h 286109"/>
                <a:gd name="connsiteX36" fmla="*/ 765810 w 771573"/>
                <a:gd name="connsiteY36" fmla="*/ 200131 h 286109"/>
                <a:gd name="connsiteX37" fmla="*/ 762000 w 771573"/>
                <a:gd name="connsiteY37" fmla="*/ 194416 h 286109"/>
                <a:gd name="connsiteX38" fmla="*/ 756285 w 771573"/>
                <a:gd name="connsiteY38" fmla="*/ 181081 h 286109"/>
                <a:gd name="connsiteX39" fmla="*/ 748665 w 771573"/>
                <a:gd name="connsiteY39" fmla="*/ 165841 h 286109"/>
                <a:gd name="connsiteX40" fmla="*/ 739140 w 771573"/>
                <a:gd name="connsiteY40" fmla="*/ 152506 h 286109"/>
                <a:gd name="connsiteX41" fmla="*/ 737235 w 771573"/>
                <a:gd name="connsiteY41" fmla="*/ 146791 h 286109"/>
                <a:gd name="connsiteX42" fmla="*/ 727710 w 771573"/>
                <a:gd name="connsiteY42" fmla="*/ 135361 h 286109"/>
                <a:gd name="connsiteX43" fmla="*/ 720090 w 771573"/>
                <a:gd name="connsiteY43" fmla="*/ 129646 h 286109"/>
                <a:gd name="connsiteX44" fmla="*/ 714375 w 771573"/>
                <a:gd name="connsiteY44" fmla="*/ 127741 h 286109"/>
                <a:gd name="connsiteX45" fmla="*/ 702945 w 771573"/>
                <a:gd name="connsiteY45" fmla="*/ 118216 h 286109"/>
                <a:gd name="connsiteX46" fmla="*/ 697230 w 771573"/>
                <a:gd name="connsiteY46" fmla="*/ 112501 h 286109"/>
                <a:gd name="connsiteX47" fmla="*/ 691515 w 771573"/>
                <a:gd name="connsiteY47" fmla="*/ 108691 h 286109"/>
                <a:gd name="connsiteX48" fmla="*/ 683895 w 771573"/>
                <a:gd name="connsiteY48" fmla="*/ 102976 h 286109"/>
                <a:gd name="connsiteX49" fmla="*/ 676275 w 771573"/>
                <a:gd name="connsiteY49" fmla="*/ 99166 h 286109"/>
                <a:gd name="connsiteX50" fmla="*/ 664845 w 771573"/>
                <a:gd name="connsiteY50" fmla="*/ 95356 h 286109"/>
                <a:gd name="connsiteX51" fmla="*/ 655320 w 771573"/>
                <a:gd name="connsiteY51" fmla="*/ 89641 h 286109"/>
                <a:gd name="connsiteX52" fmla="*/ 640080 w 771573"/>
                <a:gd name="connsiteY52" fmla="*/ 83926 h 286109"/>
                <a:gd name="connsiteX53" fmla="*/ 626745 w 771573"/>
                <a:gd name="connsiteY53" fmla="*/ 74401 h 286109"/>
                <a:gd name="connsiteX54" fmla="*/ 621030 w 771573"/>
                <a:gd name="connsiteY54" fmla="*/ 72496 h 286109"/>
                <a:gd name="connsiteX55" fmla="*/ 609600 w 771573"/>
                <a:gd name="connsiteY55" fmla="*/ 64876 h 286109"/>
                <a:gd name="connsiteX56" fmla="*/ 598170 w 771573"/>
                <a:gd name="connsiteY56" fmla="*/ 59161 h 286109"/>
                <a:gd name="connsiteX57" fmla="*/ 592455 w 771573"/>
                <a:gd name="connsiteY57" fmla="*/ 55351 h 286109"/>
                <a:gd name="connsiteX58" fmla="*/ 584835 w 771573"/>
                <a:gd name="connsiteY58" fmla="*/ 49636 h 286109"/>
                <a:gd name="connsiteX59" fmla="*/ 573405 w 771573"/>
                <a:gd name="connsiteY59" fmla="*/ 45826 h 286109"/>
                <a:gd name="connsiteX60" fmla="*/ 567690 w 771573"/>
                <a:gd name="connsiteY60" fmla="*/ 42016 h 286109"/>
                <a:gd name="connsiteX61" fmla="*/ 556260 w 771573"/>
                <a:gd name="connsiteY61" fmla="*/ 38206 h 286109"/>
                <a:gd name="connsiteX62" fmla="*/ 548640 w 771573"/>
                <a:gd name="connsiteY62" fmla="*/ 34396 h 286109"/>
                <a:gd name="connsiteX63" fmla="*/ 537210 w 771573"/>
                <a:gd name="connsiteY63" fmla="*/ 26776 h 286109"/>
                <a:gd name="connsiteX64" fmla="*/ 493395 w 771573"/>
                <a:gd name="connsiteY64" fmla="*/ 17251 h 286109"/>
                <a:gd name="connsiteX65" fmla="*/ 485775 w 771573"/>
                <a:gd name="connsiteY65" fmla="*/ 15346 h 286109"/>
                <a:gd name="connsiteX66" fmla="*/ 472440 w 771573"/>
                <a:gd name="connsiteY66" fmla="*/ 11536 h 286109"/>
                <a:gd name="connsiteX67" fmla="*/ 409575 w 771573"/>
                <a:gd name="connsiteY67" fmla="*/ 3916 h 286109"/>
                <a:gd name="connsiteX68" fmla="*/ 360045 w 771573"/>
                <a:gd name="connsiteY68" fmla="*/ 106 h 286109"/>
                <a:gd name="connsiteX69" fmla="*/ 300990 w 771573"/>
                <a:gd name="connsiteY69" fmla="*/ 2011 h 286109"/>
                <a:gd name="connsiteX70" fmla="*/ 268605 w 771573"/>
                <a:gd name="connsiteY70" fmla="*/ 9631 h 286109"/>
                <a:gd name="connsiteX71" fmla="*/ 226695 w 771573"/>
                <a:gd name="connsiteY71" fmla="*/ 26776 h 286109"/>
                <a:gd name="connsiteX72" fmla="*/ 182880 w 771573"/>
                <a:gd name="connsiteY72" fmla="*/ 53446 h 286109"/>
                <a:gd name="connsiteX73" fmla="*/ 123825 w 771573"/>
                <a:gd name="connsiteY73" fmla="*/ 95356 h 286109"/>
                <a:gd name="connsiteX74" fmla="*/ 87630 w 771573"/>
                <a:gd name="connsiteY74" fmla="*/ 125836 h 286109"/>
                <a:gd name="connsiteX75" fmla="*/ 55245 w 771573"/>
                <a:gd name="connsiteY75" fmla="*/ 158221 h 286109"/>
                <a:gd name="connsiteX76" fmla="*/ 20955 w 771573"/>
                <a:gd name="connsiteY76" fmla="*/ 203941 h 286109"/>
                <a:gd name="connsiteX77" fmla="*/ 0 w 771573"/>
                <a:gd name="connsiteY77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57225 w 771573"/>
                <a:gd name="connsiteY20" fmla="*/ 211561 h 286109"/>
                <a:gd name="connsiteX21" fmla="*/ 672465 w 771573"/>
                <a:gd name="connsiteY21" fmla="*/ 224896 h 286109"/>
                <a:gd name="connsiteX22" fmla="*/ 678180 w 771573"/>
                <a:gd name="connsiteY22" fmla="*/ 226801 h 286109"/>
                <a:gd name="connsiteX23" fmla="*/ 681990 w 771573"/>
                <a:gd name="connsiteY23" fmla="*/ 234421 h 286109"/>
                <a:gd name="connsiteX24" fmla="*/ 697230 w 771573"/>
                <a:gd name="connsiteY24" fmla="*/ 251566 h 286109"/>
                <a:gd name="connsiteX25" fmla="*/ 701040 w 771573"/>
                <a:gd name="connsiteY25" fmla="*/ 266806 h 286109"/>
                <a:gd name="connsiteX26" fmla="*/ 710565 w 771573"/>
                <a:gd name="connsiteY26" fmla="*/ 276331 h 286109"/>
                <a:gd name="connsiteX27" fmla="*/ 723900 w 771573"/>
                <a:gd name="connsiteY27" fmla="*/ 274426 h 286109"/>
                <a:gd name="connsiteX28" fmla="*/ 727710 w 771573"/>
                <a:gd name="connsiteY28" fmla="*/ 268711 h 286109"/>
                <a:gd name="connsiteX29" fmla="*/ 741045 w 771573"/>
                <a:gd name="connsiteY29" fmla="*/ 255376 h 286109"/>
                <a:gd name="connsiteX30" fmla="*/ 746760 w 771573"/>
                <a:gd name="connsiteY30" fmla="*/ 249661 h 286109"/>
                <a:gd name="connsiteX31" fmla="*/ 754380 w 771573"/>
                <a:gd name="connsiteY31" fmla="*/ 243946 h 286109"/>
                <a:gd name="connsiteX32" fmla="*/ 762000 w 771573"/>
                <a:gd name="connsiteY32" fmla="*/ 240136 h 286109"/>
                <a:gd name="connsiteX33" fmla="*/ 767715 w 771573"/>
                <a:gd name="connsiteY33" fmla="*/ 236326 h 286109"/>
                <a:gd name="connsiteX34" fmla="*/ 771525 w 771573"/>
                <a:gd name="connsiteY34" fmla="*/ 230611 h 286109"/>
                <a:gd name="connsiteX35" fmla="*/ 765810 w 771573"/>
                <a:gd name="connsiteY35" fmla="*/ 200131 h 286109"/>
                <a:gd name="connsiteX36" fmla="*/ 762000 w 771573"/>
                <a:gd name="connsiteY36" fmla="*/ 194416 h 286109"/>
                <a:gd name="connsiteX37" fmla="*/ 756285 w 771573"/>
                <a:gd name="connsiteY37" fmla="*/ 181081 h 286109"/>
                <a:gd name="connsiteX38" fmla="*/ 748665 w 771573"/>
                <a:gd name="connsiteY38" fmla="*/ 165841 h 286109"/>
                <a:gd name="connsiteX39" fmla="*/ 739140 w 771573"/>
                <a:gd name="connsiteY39" fmla="*/ 152506 h 286109"/>
                <a:gd name="connsiteX40" fmla="*/ 737235 w 771573"/>
                <a:gd name="connsiteY40" fmla="*/ 146791 h 286109"/>
                <a:gd name="connsiteX41" fmla="*/ 727710 w 771573"/>
                <a:gd name="connsiteY41" fmla="*/ 135361 h 286109"/>
                <a:gd name="connsiteX42" fmla="*/ 720090 w 771573"/>
                <a:gd name="connsiteY42" fmla="*/ 129646 h 286109"/>
                <a:gd name="connsiteX43" fmla="*/ 714375 w 771573"/>
                <a:gd name="connsiteY43" fmla="*/ 127741 h 286109"/>
                <a:gd name="connsiteX44" fmla="*/ 702945 w 771573"/>
                <a:gd name="connsiteY44" fmla="*/ 118216 h 286109"/>
                <a:gd name="connsiteX45" fmla="*/ 697230 w 771573"/>
                <a:gd name="connsiteY45" fmla="*/ 112501 h 286109"/>
                <a:gd name="connsiteX46" fmla="*/ 691515 w 771573"/>
                <a:gd name="connsiteY46" fmla="*/ 108691 h 286109"/>
                <a:gd name="connsiteX47" fmla="*/ 683895 w 771573"/>
                <a:gd name="connsiteY47" fmla="*/ 102976 h 286109"/>
                <a:gd name="connsiteX48" fmla="*/ 676275 w 771573"/>
                <a:gd name="connsiteY48" fmla="*/ 99166 h 286109"/>
                <a:gd name="connsiteX49" fmla="*/ 664845 w 771573"/>
                <a:gd name="connsiteY49" fmla="*/ 95356 h 286109"/>
                <a:gd name="connsiteX50" fmla="*/ 655320 w 771573"/>
                <a:gd name="connsiteY50" fmla="*/ 89641 h 286109"/>
                <a:gd name="connsiteX51" fmla="*/ 640080 w 771573"/>
                <a:gd name="connsiteY51" fmla="*/ 83926 h 286109"/>
                <a:gd name="connsiteX52" fmla="*/ 626745 w 771573"/>
                <a:gd name="connsiteY52" fmla="*/ 74401 h 286109"/>
                <a:gd name="connsiteX53" fmla="*/ 621030 w 771573"/>
                <a:gd name="connsiteY53" fmla="*/ 72496 h 286109"/>
                <a:gd name="connsiteX54" fmla="*/ 609600 w 771573"/>
                <a:gd name="connsiteY54" fmla="*/ 64876 h 286109"/>
                <a:gd name="connsiteX55" fmla="*/ 598170 w 771573"/>
                <a:gd name="connsiteY55" fmla="*/ 59161 h 286109"/>
                <a:gd name="connsiteX56" fmla="*/ 592455 w 771573"/>
                <a:gd name="connsiteY56" fmla="*/ 55351 h 286109"/>
                <a:gd name="connsiteX57" fmla="*/ 584835 w 771573"/>
                <a:gd name="connsiteY57" fmla="*/ 49636 h 286109"/>
                <a:gd name="connsiteX58" fmla="*/ 573405 w 771573"/>
                <a:gd name="connsiteY58" fmla="*/ 45826 h 286109"/>
                <a:gd name="connsiteX59" fmla="*/ 567690 w 771573"/>
                <a:gd name="connsiteY59" fmla="*/ 42016 h 286109"/>
                <a:gd name="connsiteX60" fmla="*/ 556260 w 771573"/>
                <a:gd name="connsiteY60" fmla="*/ 38206 h 286109"/>
                <a:gd name="connsiteX61" fmla="*/ 548640 w 771573"/>
                <a:gd name="connsiteY61" fmla="*/ 34396 h 286109"/>
                <a:gd name="connsiteX62" fmla="*/ 537210 w 771573"/>
                <a:gd name="connsiteY62" fmla="*/ 26776 h 286109"/>
                <a:gd name="connsiteX63" fmla="*/ 493395 w 771573"/>
                <a:gd name="connsiteY63" fmla="*/ 17251 h 286109"/>
                <a:gd name="connsiteX64" fmla="*/ 485775 w 771573"/>
                <a:gd name="connsiteY64" fmla="*/ 15346 h 286109"/>
                <a:gd name="connsiteX65" fmla="*/ 472440 w 771573"/>
                <a:gd name="connsiteY65" fmla="*/ 11536 h 286109"/>
                <a:gd name="connsiteX66" fmla="*/ 409575 w 771573"/>
                <a:gd name="connsiteY66" fmla="*/ 3916 h 286109"/>
                <a:gd name="connsiteX67" fmla="*/ 360045 w 771573"/>
                <a:gd name="connsiteY67" fmla="*/ 106 h 286109"/>
                <a:gd name="connsiteX68" fmla="*/ 300990 w 771573"/>
                <a:gd name="connsiteY68" fmla="*/ 2011 h 286109"/>
                <a:gd name="connsiteX69" fmla="*/ 268605 w 771573"/>
                <a:gd name="connsiteY69" fmla="*/ 9631 h 286109"/>
                <a:gd name="connsiteX70" fmla="*/ 226695 w 771573"/>
                <a:gd name="connsiteY70" fmla="*/ 26776 h 286109"/>
                <a:gd name="connsiteX71" fmla="*/ 182880 w 771573"/>
                <a:gd name="connsiteY71" fmla="*/ 53446 h 286109"/>
                <a:gd name="connsiteX72" fmla="*/ 123825 w 771573"/>
                <a:gd name="connsiteY72" fmla="*/ 95356 h 286109"/>
                <a:gd name="connsiteX73" fmla="*/ 87630 w 771573"/>
                <a:gd name="connsiteY73" fmla="*/ 125836 h 286109"/>
                <a:gd name="connsiteX74" fmla="*/ 55245 w 771573"/>
                <a:gd name="connsiteY74" fmla="*/ 158221 h 286109"/>
                <a:gd name="connsiteX75" fmla="*/ 20955 w 771573"/>
                <a:gd name="connsiteY75" fmla="*/ 203941 h 286109"/>
                <a:gd name="connsiteX76" fmla="*/ 0 w 771573"/>
                <a:gd name="connsiteY76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57225 w 771573"/>
                <a:gd name="connsiteY20" fmla="*/ 211561 h 286109"/>
                <a:gd name="connsiteX21" fmla="*/ 672465 w 771573"/>
                <a:gd name="connsiteY21" fmla="*/ 224896 h 286109"/>
                <a:gd name="connsiteX22" fmla="*/ 681990 w 771573"/>
                <a:gd name="connsiteY22" fmla="*/ 234421 h 286109"/>
                <a:gd name="connsiteX23" fmla="*/ 697230 w 771573"/>
                <a:gd name="connsiteY23" fmla="*/ 251566 h 286109"/>
                <a:gd name="connsiteX24" fmla="*/ 701040 w 771573"/>
                <a:gd name="connsiteY24" fmla="*/ 266806 h 286109"/>
                <a:gd name="connsiteX25" fmla="*/ 710565 w 771573"/>
                <a:gd name="connsiteY25" fmla="*/ 276331 h 286109"/>
                <a:gd name="connsiteX26" fmla="*/ 723900 w 771573"/>
                <a:gd name="connsiteY26" fmla="*/ 274426 h 286109"/>
                <a:gd name="connsiteX27" fmla="*/ 727710 w 771573"/>
                <a:gd name="connsiteY27" fmla="*/ 268711 h 286109"/>
                <a:gd name="connsiteX28" fmla="*/ 741045 w 771573"/>
                <a:gd name="connsiteY28" fmla="*/ 255376 h 286109"/>
                <a:gd name="connsiteX29" fmla="*/ 746760 w 771573"/>
                <a:gd name="connsiteY29" fmla="*/ 249661 h 286109"/>
                <a:gd name="connsiteX30" fmla="*/ 754380 w 771573"/>
                <a:gd name="connsiteY30" fmla="*/ 243946 h 286109"/>
                <a:gd name="connsiteX31" fmla="*/ 762000 w 771573"/>
                <a:gd name="connsiteY31" fmla="*/ 240136 h 286109"/>
                <a:gd name="connsiteX32" fmla="*/ 767715 w 771573"/>
                <a:gd name="connsiteY32" fmla="*/ 236326 h 286109"/>
                <a:gd name="connsiteX33" fmla="*/ 771525 w 771573"/>
                <a:gd name="connsiteY33" fmla="*/ 230611 h 286109"/>
                <a:gd name="connsiteX34" fmla="*/ 765810 w 771573"/>
                <a:gd name="connsiteY34" fmla="*/ 200131 h 286109"/>
                <a:gd name="connsiteX35" fmla="*/ 762000 w 771573"/>
                <a:gd name="connsiteY35" fmla="*/ 194416 h 286109"/>
                <a:gd name="connsiteX36" fmla="*/ 756285 w 771573"/>
                <a:gd name="connsiteY36" fmla="*/ 181081 h 286109"/>
                <a:gd name="connsiteX37" fmla="*/ 748665 w 771573"/>
                <a:gd name="connsiteY37" fmla="*/ 165841 h 286109"/>
                <a:gd name="connsiteX38" fmla="*/ 739140 w 771573"/>
                <a:gd name="connsiteY38" fmla="*/ 152506 h 286109"/>
                <a:gd name="connsiteX39" fmla="*/ 737235 w 771573"/>
                <a:gd name="connsiteY39" fmla="*/ 146791 h 286109"/>
                <a:gd name="connsiteX40" fmla="*/ 727710 w 771573"/>
                <a:gd name="connsiteY40" fmla="*/ 135361 h 286109"/>
                <a:gd name="connsiteX41" fmla="*/ 720090 w 771573"/>
                <a:gd name="connsiteY41" fmla="*/ 129646 h 286109"/>
                <a:gd name="connsiteX42" fmla="*/ 714375 w 771573"/>
                <a:gd name="connsiteY42" fmla="*/ 127741 h 286109"/>
                <a:gd name="connsiteX43" fmla="*/ 702945 w 771573"/>
                <a:gd name="connsiteY43" fmla="*/ 118216 h 286109"/>
                <a:gd name="connsiteX44" fmla="*/ 697230 w 771573"/>
                <a:gd name="connsiteY44" fmla="*/ 112501 h 286109"/>
                <a:gd name="connsiteX45" fmla="*/ 691515 w 771573"/>
                <a:gd name="connsiteY45" fmla="*/ 108691 h 286109"/>
                <a:gd name="connsiteX46" fmla="*/ 683895 w 771573"/>
                <a:gd name="connsiteY46" fmla="*/ 102976 h 286109"/>
                <a:gd name="connsiteX47" fmla="*/ 676275 w 771573"/>
                <a:gd name="connsiteY47" fmla="*/ 99166 h 286109"/>
                <a:gd name="connsiteX48" fmla="*/ 664845 w 771573"/>
                <a:gd name="connsiteY48" fmla="*/ 95356 h 286109"/>
                <a:gd name="connsiteX49" fmla="*/ 655320 w 771573"/>
                <a:gd name="connsiteY49" fmla="*/ 89641 h 286109"/>
                <a:gd name="connsiteX50" fmla="*/ 640080 w 771573"/>
                <a:gd name="connsiteY50" fmla="*/ 83926 h 286109"/>
                <a:gd name="connsiteX51" fmla="*/ 626745 w 771573"/>
                <a:gd name="connsiteY51" fmla="*/ 74401 h 286109"/>
                <a:gd name="connsiteX52" fmla="*/ 621030 w 771573"/>
                <a:gd name="connsiteY52" fmla="*/ 72496 h 286109"/>
                <a:gd name="connsiteX53" fmla="*/ 609600 w 771573"/>
                <a:gd name="connsiteY53" fmla="*/ 64876 h 286109"/>
                <a:gd name="connsiteX54" fmla="*/ 598170 w 771573"/>
                <a:gd name="connsiteY54" fmla="*/ 59161 h 286109"/>
                <a:gd name="connsiteX55" fmla="*/ 592455 w 771573"/>
                <a:gd name="connsiteY55" fmla="*/ 55351 h 286109"/>
                <a:gd name="connsiteX56" fmla="*/ 584835 w 771573"/>
                <a:gd name="connsiteY56" fmla="*/ 49636 h 286109"/>
                <a:gd name="connsiteX57" fmla="*/ 573405 w 771573"/>
                <a:gd name="connsiteY57" fmla="*/ 45826 h 286109"/>
                <a:gd name="connsiteX58" fmla="*/ 567690 w 771573"/>
                <a:gd name="connsiteY58" fmla="*/ 42016 h 286109"/>
                <a:gd name="connsiteX59" fmla="*/ 556260 w 771573"/>
                <a:gd name="connsiteY59" fmla="*/ 38206 h 286109"/>
                <a:gd name="connsiteX60" fmla="*/ 548640 w 771573"/>
                <a:gd name="connsiteY60" fmla="*/ 34396 h 286109"/>
                <a:gd name="connsiteX61" fmla="*/ 537210 w 771573"/>
                <a:gd name="connsiteY61" fmla="*/ 26776 h 286109"/>
                <a:gd name="connsiteX62" fmla="*/ 493395 w 771573"/>
                <a:gd name="connsiteY62" fmla="*/ 17251 h 286109"/>
                <a:gd name="connsiteX63" fmla="*/ 485775 w 771573"/>
                <a:gd name="connsiteY63" fmla="*/ 15346 h 286109"/>
                <a:gd name="connsiteX64" fmla="*/ 472440 w 771573"/>
                <a:gd name="connsiteY64" fmla="*/ 11536 h 286109"/>
                <a:gd name="connsiteX65" fmla="*/ 409575 w 771573"/>
                <a:gd name="connsiteY65" fmla="*/ 3916 h 286109"/>
                <a:gd name="connsiteX66" fmla="*/ 360045 w 771573"/>
                <a:gd name="connsiteY66" fmla="*/ 106 h 286109"/>
                <a:gd name="connsiteX67" fmla="*/ 300990 w 771573"/>
                <a:gd name="connsiteY67" fmla="*/ 2011 h 286109"/>
                <a:gd name="connsiteX68" fmla="*/ 268605 w 771573"/>
                <a:gd name="connsiteY68" fmla="*/ 9631 h 286109"/>
                <a:gd name="connsiteX69" fmla="*/ 226695 w 771573"/>
                <a:gd name="connsiteY69" fmla="*/ 26776 h 286109"/>
                <a:gd name="connsiteX70" fmla="*/ 182880 w 771573"/>
                <a:gd name="connsiteY70" fmla="*/ 53446 h 286109"/>
                <a:gd name="connsiteX71" fmla="*/ 123825 w 771573"/>
                <a:gd name="connsiteY71" fmla="*/ 95356 h 286109"/>
                <a:gd name="connsiteX72" fmla="*/ 87630 w 771573"/>
                <a:gd name="connsiteY72" fmla="*/ 125836 h 286109"/>
                <a:gd name="connsiteX73" fmla="*/ 55245 w 771573"/>
                <a:gd name="connsiteY73" fmla="*/ 158221 h 286109"/>
                <a:gd name="connsiteX74" fmla="*/ 20955 w 771573"/>
                <a:gd name="connsiteY74" fmla="*/ 203941 h 286109"/>
                <a:gd name="connsiteX75" fmla="*/ 0 w 771573"/>
                <a:gd name="connsiteY75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57225 w 771573"/>
                <a:gd name="connsiteY20" fmla="*/ 211561 h 286109"/>
                <a:gd name="connsiteX21" fmla="*/ 672465 w 771573"/>
                <a:gd name="connsiteY21" fmla="*/ 224896 h 286109"/>
                <a:gd name="connsiteX22" fmla="*/ 697230 w 771573"/>
                <a:gd name="connsiteY22" fmla="*/ 251566 h 286109"/>
                <a:gd name="connsiteX23" fmla="*/ 701040 w 771573"/>
                <a:gd name="connsiteY23" fmla="*/ 266806 h 286109"/>
                <a:gd name="connsiteX24" fmla="*/ 710565 w 771573"/>
                <a:gd name="connsiteY24" fmla="*/ 276331 h 286109"/>
                <a:gd name="connsiteX25" fmla="*/ 723900 w 771573"/>
                <a:gd name="connsiteY25" fmla="*/ 274426 h 286109"/>
                <a:gd name="connsiteX26" fmla="*/ 727710 w 771573"/>
                <a:gd name="connsiteY26" fmla="*/ 268711 h 286109"/>
                <a:gd name="connsiteX27" fmla="*/ 741045 w 771573"/>
                <a:gd name="connsiteY27" fmla="*/ 255376 h 286109"/>
                <a:gd name="connsiteX28" fmla="*/ 746760 w 771573"/>
                <a:gd name="connsiteY28" fmla="*/ 249661 h 286109"/>
                <a:gd name="connsiteX29" fmla="*/ 754380 w 771573"/>
                <a:gd name="connsiteY29" fmla="*/ 243946 h 286109"/>
                <a:gd name="connsiteX30" fmla="*/ 762000 w 771573"/>
                <a:gd name="connsiteY30" fmla="*/ 240136 h 286109"/>
                <a:gd name="connsiteX31" fmla="*/ 767715 w 771573"/>
                <a:gd name="connsiteY31" fmla="*/ 236326 h 286109"/>
                <a:gd name="connsiteX32" fmla="*/ 771525 w 771573"/>
                <a:gd name="connsiteY32" fmla="*/ 230611 h 286109"/>
                <a:gd name="connsiteX33" fmla="*/ 765810 w 771573"/>
                <a:gd name="connsiteY33" fmla="*/ 200131 h 286109"/>
                <a:gd name="connsiteX34" fmla="*/ 762000 w 771573"/>
                <a:gd name="connsiteY34" fmla="*/ 194416 h 286109"/>
                <a:gd name="connsiteX35" fmla="*/ 756285 w 771573"/>
                <a:gd name="connsiteY35" fmla="*/ 181081 h 286109"/>
                <a:gd name="connsiteX36" fmla="*/ 748665 w 771573"/>
                <a:gd name="connsiteY36" fmla="*/ 165841 h 286109"/>
                <a:gd name="connsiteX37" fmla="*/ 739140 w 771573"/>
                <a:gd name="connsiteY37" fmla="*/ 152506 h 286109"/>
                <a:gd name="connsiteX38" fmla="*/ 737235 w 771573"/>
                <a:gd name="connsiteY38" fmla="*/ 146791 h 286109"/>
                <a:gd name="connsiteX39" fmla="*/ 727710 w 771573"/>
                <a:gd name="connsiteY39" fmla="*/ 135361 h 286109"/>
                <a:gd name="connsiteX40" fmla="*/ 720090 w 771573"/>
                <a:gd name="connsiteY40" fmla="*/ 129646 h 286109"/>
                <a:gd name="connsiteX41" fmla="*/ 714375 w 771573"/>
                <a:gd name="connsiteY41" fmla="*/ 127741 h 286109"/>
                <a:gd name="connsiteX42" fmla="*/ 702945 w 771573"/>
                <a:gd name="connsiteY42" fmla="*/ 118216 h 286109"/>
                <a:gd name="connsiteX43" fmla="*/ 697230 w 771573"/>
                <a:gd name="connsiteY43" fmla="*/ 112501 h 286109"/>
                <a:gd name="connsiteX44" fmla="*/ 691515 w 771573"/>
                <a:gd name="connsiteY44" fmla="*/ 108691 h 286109"/>
                <a:gd name="connsiteX45" fmla="*/ 683895 w 771573"/>
                <a:gd name="connsiteY45" fmla="*/ 102976 h 286109"/>
                <a:gd name="connsiteX46" fmla="*/ 676275 w 771573"/>
                <a:gd name="connsiteY46" fmla="*/ 99166 h 286109"/>
                <a:gd name="connsiteX47" fmla="*/ 664845 w 771573"/>
                <a:gd name="connsiteY47" fmla="*/ 95356 h 286109"/>
                <a:gd name="connsiteX48" fmla="*/ 655320 w 771573"/>
                <a:gd name="connsiteY48" fmla="*/ 89641 h 286109"/>
                <a:gd name="connsiteX49" fmla="*/ 640080 w 771573"/>
                <a:gd name="connsiteY49" fmla="*/ 83926 h 286109"/>
                <a:gd name="connsiteX50" fmla="*/ 626745 w 771573"/>
                <a:gd name="connsiteY50" fmla="*/ 74401 h 286109"/>
                <a:gd name="connsiteX51" fmla="*/ 621030 w 771573"/>
                <a:gd name="connsiteY51" fmla="*/ 72496 h 286109"/>
                <a:gd name="connsiteX52" fmla="*/ 609600 w 771573"/>
                <a:gd name="connsiteY52" fmla="*/ 64876 h 286109"/>
                <a:gd name="connsiteX53" fmla="*/ 598170 w 771573"/>
                <a:gd name="connsiteY53" fmla="*/ 59161 h 286109"/>
                <a:gd name="connsiteX54" fmla="*/ 592455 w 771573"/>
                <a:gd name="connsiteY54" fmla="*/ 55351 h 286109"/>
                <a:gd name="connsiteX55" fmla="*/ 584835 w 771573"/>
                <a:gd name="connsiteY55" fmla="*/ 49636 h 286109"/>
                <a:gd name="connsiteX56" fmla="*/ 573405 w 771573"/>
                <a:gd name="connsiteY56" fmla="*/ 45826 h 286109"/>
                <a:gd name="connsiteX57" fmla="*/ 567690 w 771573"/>
                <a:gd name="connsiteY57" fmla="*/ 42016 h 286109"/>
                <a:gd name="connsiteX58" fmla="*/ 556260 w 771573"/>
                <a:gd name="connsiteY58" fmla="*/ 38206 h 286109"/>
                <a:gd name="connsiteX59" fmla="*/ 548640 w 771573"/>
                <a:gd name="connsiteY59" fmla="*/ 34396 h 286109"/>
                <a:gd name="connsiteX60" fmla="*/ 537210 w 771573"/>
                <a:gd name="connsiteY60" fmla="*/ 26776 h 286109"/>
                <a:gd name="connsiteX61" fmla="*/ 493395 w 771573"/>
                <a:gd name="connsiteY61" fmla="*/ 17251 h 286109"/>
                <a:gd name="connsiteX62" fmla="*/ 485775 w 771573"/>
                <a:gd name="connsiteY62" fmla="*/ 15346 h 286109"/>
                <a:gd name="connsiteX63" fmla="*/ 472440 w 771573"/>
                <a:gd name="connsiteY63" fmla="*/ 11536 h 286109"/>
                <a:gd name="connsiteX64" fmla="*/ 409575 w 771573"/>
                <a:gd name="connsiteY64" fmla="*/ 3916 h 286109"/>
                <a:gd name="connsiteX65" fmla="*/ 360045 w 771573"/>
                <a:gd name="connsiteY65" fmla="*/ 106 h 286109"/>
                <a:gd name="connsiteX66" fmla="*/ 300990 w 771573"/>
                <a:gd name="connsiteY66" fmla="*/ 2011 h 286109"/>
                <a:gd name="connsiteX67" fmla="*/ 268605 w 771573"/>
                <a:gd name="connsiteY67" fmla="*/ 9631 h 286109"/>
                <a:gd name="connsiteX68" fmla="*/ 226695 w 771573"/>
                <a:gd name="connsiteY68" fmla="*/ 26776 h 286109"/>
                <a:gd name="connsiteX69" fmla="*/ 182880 w 771573"/>
                <a:gd name="connsiteY69" fmla="*/ 53446 h 286109"/>
                <a:gd name="connsiteX70" fmla="*/ 123825 w 771573"/>
                <a:gd name="connsiteY70" fmla="*/ 95356 h 286109"/>
                <a:gd name="connsiteX71" fmla="*/ 87630 w 771573"/>
                <a:gd name="connsiteY71" fmla="*/ 125836 h 286109"/>
                <a:gd name="connsiteX72" fmla="*/ 55245 w 771573"/>
                <a:gd name="connsiteY72" fmla="*/ 158221 h 286109"/>
                <a:gd name="connsiteX73" fmla="*/ 20955 w 771573"/>
                <a:gd name="connsiteY73" fmla="*/ 203941 h 286109"/>
                <a:gd name="connsiteX74" fmla="*/ 0 w 771573"/>
                <a:gd name="connsiteY74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57225 w 771573"/>
                <a:gd name="connsiteY20" fmla="*/ 211561 h 286109"/>
                <a:gd name="connsiteX21" fmla="*/ 697230 w 771573"/>
                <a:gd name="connsiteY21" fmla="*/ 251566 h 286109"/>
                <a:gd name="connsiteX22" fmla="*/ 701040 w 771573"/>
                <a:gd name="connsiteY22" fmla="*/ 266806 h 286109"/>
                <a:gd name="connsiteX23" fmla="*/ 710565 w 771573"/>
                <a:gd name="connsiteY23" fmla="*/ 276331 h 286109"/>
                <a:gd name="connsiteX24" fmla="*/ 723900 w 771573"/>
                <a:gd name="connsiteY24" fmla="*/ 274426 h 286109"/>
                <a:gd name="connsiteX25" fmla="*/ 727710 w 771573"/>
                <a:gd name="connsiteY25" fmla="*/ 268711 h 286109"/>
                <a:gd name="connsiteX26" fmla="*/ 741045 w 771573"/>
                <a:gd name="connsiteY26" fmla="*/ 255376 h 286109"/>
                <a:gd name="connsiteX27" fmla="*/ 746760 w 771573"/>
                <a:gd name="connsiteY27" fmla="*/ 249661 h 286109"/>
                <a:gd name="connsiteX28" fmla="*/ 754380 w 771573"/>
                <a:gd name="connsiteY28" fmla="*/ 243946 h 286109"/>
                <a:gd name="connsiteX29" fmla="*/ 762000 w 771573"/>
                <a:gd name="connsiteY29" fmla="*/ 240136 h 286109"/>
                <a:gd name="connsiteX30" fmla="*/ 767715 w 771573"/>
                <a:gd name="connsiteY30" fmla="*/ 236326 h 286109"/>
                <a:gd name="connsiteX31" fmla="*/ 771525 w 771573"/>
                <a:gd name="connsiteY31" fmla="*/ 230611 h 286109"/>
                <a:gd name="connsiteX32" fmla="*/ 765810 w 771573"/>
                <a:gd name="connsiteY32" fmla="*/ 200131 h 286109"/>
                <a:gd name="connsiteX33" fmla="*/ 762000 w 771573"/>
                <a:gd name="connsiteY33" fmla="*/ 194416 h 286109"/>
                <a:gd name="connsiteX34" fmla="*/ 756285 w 771573"/>
                <a:gd name="connsiteY34" fmla="*/ 181081 h 286109"/>
                <a:gd name="connsiteX35" fmla="*/ 748665 w 771573"/>
                <a:gd name="connsiteY35" fmla="*/ 165841 h 286109"/>
                <a:gd name="connsiteX36" fmla="*/ 739140 w 771573"/>
                <a:gd name="connsiteY36" fmla="*/ 152506 h 286109"/>
                <a:gd name="connsiteX37" fmla="*/ 737235 w 771573"/>
                <a:gd name="connsiteY37" fmla="*/ 146791 h 286109"/>
                <a:gd name="connsiteX38" fmla="*/ 727710 w 771573"/>
                <a:gd name="connsiteY38" fmla="*/ 135361 h 286109"/>
                <a:gd name="connsiteX39" fmla="*/ 720090 w 771573"/>
                <a:gd name="connsiteY39" fmla="*/ 129646 h 286109"/>
                <a:gd name="connsiteX40" fmla="*/ 714375 w 771573"/>
                <a:gd name="connsiteY40" fmla="*/ 127741 h 286109"/>
                <a:gd name="connsiteX41" fmla="*/ 702945 w 771573"/>
                <a:gd name="connsiteY41" fmla="*/ 118216 h 286109"/>
                <a:gd name="connsiteX42" fmla="*/ 697230 w 771573"/>
                <a:gd name="connsiteY42" fmla="*/ 112501 h 286109"/>
                <a:gd name="connsiteX43" fmla="*/ 691515 w 771573"/>
                <a:gd name="connsiteY43" fmla="*/ 108691 h 286109"/>
                <a:gd name="connsiteX44" fmla="*/ 683895 w 771573"/>
                <a:gd name="connsiteY44" fmla="*/ 102976 h 286109"/>
                <a:gd name="connsiteX45" fmla="*/ 676275 w 771573"/>
                <a:gd name="connsiteY45" fmla="*/ 99166 h 286109"/>
                <a:gd name="connsiteX46" fmla="*/ 664845 w 771573"/>
                <a:gd name="connsiteY46" fmla="*/ 95356 h 286109"/>
                <a:gd name="connsiteX47" fmla="*/ 655320 w 771573"/>
                <a:gd name="connsiteY47" fmla="*/ 89641 h 286109"/>
                <a:gd name="connsiteX48" fmla="*/ 640080 w 771573"/>
                <a:gd name="connsiteY48" fmla="*/ 83926 h 286109"/>
                <a:gd name="connsiteX49" fmla="*/ 626745 w 771573"/>
                <a:gd name="connsiteY49" fmla="*/ 74401 h 286109"/>
                <a:gd name="connsiteX50" fmla="*/ 621030 w 771573"/>
                <a:gd name="connsiteY50" fmla="*/ 72496 h 286109"/>
                <a:gd name="connsiteX51" fmla="*/ 609600 w 771573"/>
                <a:gd name="connsiteY51" fmla="*/ 64876 h 286109"/>
                <a:gd name="connsiteX52" fmla="*/ 598170 w 771573"/>
                <a:gd name="connsiteY52" fmla="*/ 59161 h 286109"/>
                <a:gd name="connsiteX53" fmla="*/ 592455 w 771573"/>
                <a:gd name="connsiteY53" fmla="*/ 55351 h 286109"/>
                <a:gd name="connsiteX54" fmla="*/ 584835 w 771573"/>
                <a:gd name="connsiteY54" fmla="*/ 49636 h 286109"/>
                <a:gd name="connsiteX55" fmla="*/ 573405 w 771573"/>
                <a:gd name="connsiteY55" fmla="*/ 45826 h 286109"/>
                <a:gd name="connsiteX56" fmla="*/ 567690 w 771573"/>
                <a:gd name="connsiteY56" fmla="*/ 42016 h 286109"/>
                <a:gd name="connsiteX57" fmla="*/ 556260 w 771573"/>
                <a:gd name="connsiteY57" fmla="*/ 38206 h 286109"/>
                <a:gd name="connsiteX58" fmla="*/ 548640 w 771573"/>
                <a:gd name="connsiteY58" fmla="*/ 34396 h 286109"/>
                <a:gd name="connsiteX59" fmla="*/ 537210 w 771573"/>
                <a:gd name="connsiteY59" fmla="*/ 26776 h 286109"/>
                <a:gd name="connsiteX60" fmla="*/ 493395 w 771573"/>
                <a:gd name="connsiteY60" fmla="*/ 17251 h 286109"/>
                <a:gd name="connsiteX61" fmla="*/ 485775 w 771573"/>
                <a:gd name="connsiteY61" fmla="*/ 15346 h 286109"/>
                <a:gd name="connsiteX62" fmla="*/ 472440 w 771573"/>
                <a:gd name="connsiteY62" fmla="*/ 11536 h 286109"/>
                <a:gd name="connsiteX63" fmla="*/ 409575 w 771573"/>
                <a:gd name="connsiteY63" fmla="*/ 3916 h 286109"/>
                <a:gd name="connsiteX64" fmla="*/ 360045 w 771573"/>
                <a:gd name="connsiteY64" fmla="*/ 106 h 286109"/>
                <a:gd name="connsiteX65" fmla="*/ 300990 w 771573"/>
                <a:gd name="connsiteY65" fmla="*/ 2011 h 286109"/>
                <a:gd name="connsiteX66" fmla="*/ 268605 w 771573"/>
                <a:gd name="connsiteY66" fmla="*/ 9631 h 286109"/>
                <a:gd name="connsiteX67" fmla="*/ 226695 w 771573"/>
                <a:gd name="connsiteY67" fmla="*/ 26776 h 286109"/>
                <a:gd name="connsiteX68" fmla="*/ 182880 w 771573"/>
                <a:gd name="connsiteY68" fmla="*/ 53446 h 286109"/>
                <a:gd name="connsiteX69" fmla="*/ 123825 w 771573"/>
                <a:gd name="connsiteY69" fmla="*/ 95356 h 286109"/>
                <a:gd name="connsiteX70" fmla="*/ 87630 w 771573"/>
                <a:gd name="connsiteY70" fmla="*/ 125836 h 286109"/>
                <a:gd name="connsiteX71" fmla="*/ 55245 w 771573"/>
                <a:gd name="connsiteY71" fmla="*/ 158221 h 286109"/>
                <a:gd name="connsiteX72" fmla="*/ 20955 w 771573"/>
                <a:gd name="connsiteY72" fmla="*/ 203941 h 286109"/>
                <a:gd name="connsiteX73" fmla="*/ 0 w 771573"/>
                <a:gd name="connsiteY73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67218 w 771573"/>
                <a:gd name="connsiteY20" fmla="*/ 206465 h 286109"/>
                <a:gd name="connsiteX21" fmla="*/ 697230 w 771573"/>
                <a:gd name="connsiteY21" fmla="*/ 251566 h 286109"/>
                <a:gd name="connsiteX22" fmla="*/ 701040 w 771573"/>
                <a:gd name="connsiteY22" fmla="*/ 266806 h 286109"/>
                <a:gd name="connsiteX23" fmla="*/ 710565 w 771573"/>
                <a:gd name="connsiteY23" fmla="*/ 276331 h 286109"/>
                <a:gd name="connsiteX24" fmla="*/ 723900 w 771573"/>
                <a:gd name="connsiteY24" fmla="*/ 274426 h 286109"/>
                <a:gd name="connsiteX25" fmla="*/ 727710 w 771573"/>
                <a:gd name="connsiteY25" fmla="*/ 268711 h 286109"/>
                <a:gd name="connsiteX26" fmla="*/ 741045 w 771573"/>
                <a:gd name="connsiteY26" fmla="*/ 255376 h 286109"/>
                <a:gd name="connsiteX27" fmla="*/ 746760 w 771573"/>
                <a:gd name="connsiteY27" fmla="*/ 249661 h 286109"/>
                <a:gd name="connsiteX28" fmla="*/ 754380 w 771573"/>
                <a:gd name="connsiteY28" fmla="*/ 243946 h 286109"/>
                <a:gd name="connsiteX29" fmla="*/ 762000 w 771573"/>
                <a:gd name="connsiteY29" fmla="*/ 240136 h 286109"/>
                <a:gd name="connsiteX30" fmla="*/ 767715 w 771573"/>
                <a:gd name="connsiteY30" fmla="*/ 236326 h 286109"/>
                <a:gd name="connsiteX31" fmla="*/ 771525 w 771573"/>
                <a:gd name="connsiteY31" fmla="*/ 230611 h 286109"/>
                <a:gd name="connsiteX32" fmla="*/ 765810 w 771573"/>
                <a:gd name="connsiteY32" fmla="*/ 200131 h 286109"/>
                <a:gd name="connsiteX33" fmla="*/ 762000 w 771573"/>
                <a:gd name="connsiteY33" fmla="*/ 194416 h 286109"/>
                <a:gd name="connsiteX34" fmla="*/ 756285 w 771573"/>
                <a:gd name="connsiteY34" fmla="*/ 181081 h 286109"/>
                <a:gd name="connsiteX35" fmla="*/ 748665 w 771573"/>
                <a:gd name="connsiteY35" fmla="*/ 165841 h 286109"/>
                <a:gd name="connsiteX36" fmla="*/ 739140 w 771573"/>
                <a:gd name="connsiteY36" fmla="*/ 152506 h 286109"/>
                <a:gd name="connsiteX37" fmla="*/ 737235 w 771573"/>
                <a:gd name="connsiteY37" fmla="*/ 146791 h 286109"/>
                <a:gd name="connsiteX38" fmla="*/ 727710 w 771573"/>
                <a:gd name="connsiteY38" fmla="*/ 135361 h 286109"/>
                <a:gd name="connsiteX39" fmla="*/ 720090 w 771573"/>
                <a:gd name="connsiteY39" fmla="*/ 129646 h 286109"/>
                <a:gd name="connsiteX40" fmla="*/ 714375 w 771573"/>
                <a:gd name="connsiteY40" fmla="*/ 127741 h 286109"/>
                <a:gd name="connsiteX41" fmla="*/ 702945 w 771573"/>
                <a:gd name="connsiteY41" fmla="*/ 118216 h 286109"/>
                <a:gd name="connsiteX42" fmla="*/ 697230 w 771573"/>
                <a:gd name="connsiteY42" fmla="*/ 112501 h 286109"/>
                <a:gd name="connsiteX43" fmla="*/ 691515 w 771573"/>
                <a:gd name="connsiteY43" fmla="*/ 108691 h 286109"/>
                <a:gd name="connsiteX44" fmla="*/ 683895 w 771573"/>
                <a:gd name="connsiteY44" fmla="*/ 102976 h 286109"/>
                <a:gd name="connsiteX45" fmla="*/ 676275 w 771573"/>
                <a:gd name="connsiteY45" fmla="*/ 99166 h 286109"/>
                <a:gd name="connsiteX46" fmla="*/ 664845 w 771573"/>
                <a:gd name="connsiteY46" fmla="*/ 95356 h 286109"/>
                <a:gd name="connsiteX47" fmla="*/ 655320 w 771573"/>
                <a:gd name="connsiteY47" fmla="*/ 89641 h 286109"/>
                <a:gd name="connsiteX48" fmla="*/ 640080 w 771573"/>
                <a:gd name="connsiteY48" fmla="*/ 83926 h 286109"/>
                <a:gd name="connsiteX49" fmla="*/ 626745 w 771573"/>
                <a:gd name="connsiteY49" fmla="*/ 74401 h 286109"/>
                <a:gd name="connsiteX50" fmla="*/ 621030 w 771573"/>
                <a:gd name="connsiteY50" fmla="*/ 72496 h 286109"/>
                <a:gd name="connsiteX51" fmla="*/ 609600 w 771573"/>
                <a:gd name="connsiteY51" fmla="*/ 64876 h 286109"/>
                <a:gd name="connsiteX52" fmla="*/ 598170 w 771573"/>
                <a:gd name="connsiteY52" fmla="*/ 59161 h 286109"/>
                <a:gd name="connsiteX53" fmla="*/ 592455 w 771573"/>
                <a:gd name="connsiteY53" fmla="*/ 55351 h 286109"/>
                <a:gd name="connsiteX54" fmla="*/ 584835 w 771573"/>
                <a:gd name="connsiteY54" fmla="*/ 49636 h 286109"/>
                <a:gd name="connsiteX55" fmla="*/ 573405 w 771573"/>
                <a:gd name="connsiteY55" fmla="*/ 45826 h 286109"/>
                <a:gd name="connsiteX56" fmla="*/ 567690 w 771573"/>
                <a:gd name="connsiteY56" fmla="*/ 42016 h 286109"/>
                <a:gd name="connsiteX57" fmla="*/ 556260 w 771573"/>
                <a:gd name="connsiteY57" fmla="*/ 38206 h 286109"/>
                <a:gd name="connsiteX58" fmla="*/ 548640 w 771573"/>
                <a:gd name="connsiteY58" fmla="*/ 34396 h 286109"/>
                <a:gd name="connsiteX59" fmla="*/ 537210 w 771573"/>
                <a:gd name="connsiteY59" fmla="*/ 26776 h 286109"/>
                <a:gd name="connsiteX60" fmla="*/ 493395 w 771573"/>
                <a:gd name="connsiteY60" fmla="*/ 17251 h 286109"/>
                <a:gd name="connsiteX61" fmla="*/ 485775 w 771573"/>
                <a:gd name="connsiteY61" fmla="*/ 15346 h 286109"/>
                <a:gd name="connsiteX62" fmla="*/ 472440 w 771573"/>
                <a:gd name="connsiteY62" fmla="*/ 11536 h 286109"/>
                <a:gd name="connsiteX63" fmla="*/ 409575 w 771573"/>
                <a:gd name="connsiteY63" fmla="*/ 3916 h 286109"/>
                <a:gd name="connsiteX64" fmla="*/ 360045 w 771573"/>
                <a:gd name="connsiteY64" fmla="*/ 106 h 286109"/>
                <a:gd name="connsiteX65" fmla="*/ 300990 w 771573"/>
                <a:gd name="connsiteY65" fmla="*/ 2011 h 286109"/>
                <a:gd name="connsiteX66" fmla="*/ 268605 w 771573"/>
                <a:gd name="connsiteY66" fmla="*/ 9631 h 286109"/>
                <a:gd name="connsiteX67" fmla="*/ 226695 w 771573"/>
                <a:gd name="connsiteY67" fmla="*/ 26776 h 286109"/>
                <a:gd name="connsiteX68" fmla="*/ 182880 w 771573"/>
                <a:gd name="connsiteY68" fmla="*/ 53446 h 286109"/>
                <a:gd name="connsiteX69" fmla="*/ 123825 w 771573"/>
                <a:gd name="connsiteY69" fmla="*/ 95356 h 286109"/>
                <a:gd name="connsiteX70" fmla="*/ 87630 w 771573"/>
                <a:gd name="connsiteY70" fmla="*/ 125836 h 286109"/>
                <a:gd name="connsiteX71" fmla="*/ 55245 w 771573"/>
                <a:gd name="connsiteY71" fmla="*/ 158221 h 286109"/>
                <a:gd name="connsiteX72" fmla="*/ 20955 w 771573"/>
                <a:gd name="connsiteY72" fmla="*/ 203941 h 286109"/>
                <a:gd name="connsiteX73" fmla="*/ 0 w 771573"/>
                <a:gd name="connsiteY73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67218 w 771573"/>
                <a:gd name="connsiteY20" fmla="*/ 206465 h 286109"/>
                <a:gd name="connsiteX21" fmla="*/ 697230 w 771573"/>
                <a:gd name="connsiteY21" fmla="*/ 251566 h 286109"/>
                <a:gd name="connsiteX22" fmla="*/ 710565 w 771573"/>
                <a:gd name="connsiteY22" fmla="*/ 276331 h 286109"/>
                <a:gd name="connsiteX23" fmla="*/ 723900 w 771573"/>
                <a:gd name="connsiteY23" fmla="*/ 274426 h 286109"/>
                <a:gd name="connsiteX24" fmla="*/ 727710 w 771573"/>
                <a:gd name="connsiteY24" fmla="*/ 268711 h 286109"/>
                <a:gd name="connsiteX25" fmla="*/ 741045 w 771573"/>
                <a:gd name="connsiteY25" fmla="*/ 255376 h 286109"/>
                <a:gd name="connsiteX26" fmla="*/ 746760 w 771573"/>
                <a:gd name="connsiteY26" fmla="*/ 249661 h 286109"/>
                <a:gd name="connsiteX27" fmla="*/ 754380 w 771573"/>
                <a:gd name="connsiteY27" fmla="*/ 243946 h 286109"/>
                <a:gd name="connsiteX28" fmla="*/ 762000 w 771573"/>
                <a:gd name="connsiteY28" fmla="*/ 240136 h 286109"/>
                <a:gd name="connsiteX29" fmla="*/ 767715 w 771573"/>
                <a:gd name="connsiteY29" fmla="*/ 236326 h 286109"/>
                <a:gd name="connsiteX30" fmla="*/ 771525 w 771573"/>
                <a:gd name="connsiteY30" fmla="*/ 230611 h 286109"/>
                <a:gd name="connsiteX31" fmla="*/ 765810 w 771573"/>
                <a:gd name="connsiteY31" fmla="*/ 200131 h 286109"/>
                <a:gd name="connsiteX32" fmla="*/ 762000 w 771573"/>
                <a:gd name="connsiteY32" fmla="*/ 194416 h 286109"/>
                <a:gd name="connsiteX33" fmla="*/ 756285 w 771573"/>
                <a:gd name="connsiteY33" fmla="*/ 181081 h 286109"/>
                <a:gd name="connsiteX34" fmla="*/ 748665 w 771573"/>
                <a:gd name="connsiteY34" fmla="*/ 165841 h 286109"/>
                <a:gd name="connsiteX35" fmla="*/ 739140 w 771573"/>
                <a:gd name="connsiteY35" fmla="*/ 152506 h 286109"/>
                <a:gd name="connsiteX36" fmla="*/ 737235 w 771573"/>
                <a:gd name="connsiteY36" fmla="*/ 146791 h 286109"/>
                <a:gd name="connsiteX37" fmla="*/ 727710 w 771573"/>
                <a:gd name="connsiteY37" fmla="*/ 135361 h 286109"/>
                <a:gd name="connsiteX38" fmla="*/ 720090 w 771573"/>
                <a:gd name="connsiteY38" fmla="*/ 129646 h 286109"/>
                <a:gd name="connsiteX39" fmla="*/ 714375 w 771573"/>
                <a:gd name="connsiteY39" fmla="*/ 127741 h 286109"/>
                <a:gd name="connsiteX40" fmla="*/ 702945 w 771573"/>
                <a:gd name="connsiteY40" fmla="*/ 118216 h 286109"/>
                <a:gd name="connsiteX41" fmla="*/ 697230 w 771573"/>
                <a:gd name="connsiteY41" fmla="*/ 112501 h 286109"/>
                <a:gd name="connsiteX42" fmla="*/ 691515 w 771573"/>
                <a:gd name="connsiteY42" fmla="*/ 108691 h 286109"/>
                <a:gd name="connsiteX43" fmla="*/ 683895 w 771573"/>
                <a:gd name="connsiteY43" fmla="*/ 102976 h 286109"/>
                <a:gd name="connsiteX44" fmla="*/ 676275 w 771573"/>
                <a:gd name="connsiteY44" fmla="*/ 99166 h 286109"/>
                <a:gd name="connsiteX45" fmla="*/ 664845 w 771573"/>
                <a:gd name="connsiteY45" fmla="*/ 95356 h 286109"/>
                <a:gd name="connsiteX46" fmla="*/ 655320 w 771573"/>
                <a:gd name="connsiteY46" fmla="*/ 89641 h 286109"/>
                <a:gd name="connsiteX47" fmla="*/ 640080 w 771573"/>
                <a:gd name="connsiteY47" fmla="*/ 83926 h 286109"/>
                <a:gd name="connsiteX48" fmla="*/ 626745 w 771573"/>
                <a:gd name="connsiteY48" fmla="*/ 74401 h 286109"/>
                <a:gd name="connsiteX49" fmla="*/ 621030 w 771573"/>
                <a:gd name="connsiteY49" fmla="*/ 72496 h 286109"/>
                <a:gd name="connsiteX50" fmla="*/ 609600 w 771573"/>
                <a:gd name="connsiteY50" fmla="*/ 64876 h 286109"/>
                <a:gd name="connsiteX51" fmla="*/ 598170 w 771573"/>
                <a:gd name="connsiteY51" fmla="*/ 59161 h 286109"/>
                <a:gd name="connsiteX52" fmla="*/ 592455 w 771573"/>
                <a:gd name="connsiteY52" fmla="*/ 55351 h 286109"/>
                <a:gd name="connsiteX53" fmla="*/ 584835 w 771573"/>
                <a:gd name="connsiteY53" fmla="*/ 49636 h 286109"/>
                <a:gd name="connsiteX54" fmla="*/ 573405 w 771573"/>
                <a:gd name="connsiteY54" fmla="*/ 45826 h 286109"/>
                <a:gd name="connsiteX55" fmla="*/ 567690 w 771573"/>
                <a:gd name="connsiteY55" fmla="*/ 42016 h 286109"/>
                <a:gd name="connsiteX56" fmla="*/ 556260 w 771573"/>
                <a:gd name="connsiteY56" fmla="*/ 38206 h 286109"/>
                <a:gd name="connsiteX57" fmla="*/ 548640 w 771573"/>
                <a:gd name="connsiteY57" fmla="*/ 34396 h 286109"/>
                <a:gd name="connsiteX58" fmla="*/ 537210 w 771573"/>
                <a:gd name="connsiteY58" fmla="*/ 26776 h 286109"/>
                <a:gd name="connsiteX59" fmla="*/ 493395 w 771573"/>
                <a:gd name="connsiteY59" fmla="*/ 17251 h 286109"/>
                <a:gd name="connsiteX60" fmla="*/ 485775 w 771573"/>
                <a:gd name="connsiteY60" fmla="*/ 15346 h 286109"/>
                <a:gd name="connsiteX61" fmla="*/ 472440 w 771573"/>
                <a:gd name="connsiteY61" fmla="*/ 11536 h 286109"/>
                <a:gd name="connsiteX62" fmla="*/ 409575 w 771573"/>
                <a:gd name="connsiteY62" fmla="*/ 3916 h 286109"/>
                <a:gd name="connsiteX63" fmla="*/ 360045 w 771573"/>
                <a:gd name="connsiteY63" fmla="*/ 106 h 286109"/>
                <a:gd name="connsiteX64" fmla="*/ 300990 w 771573"/>
                <a:gd name="connsiteY64" fmla="*/ 2011 h 286109"/>
                <a:gd name="connsiteX65" fmla="*/ 268605 w 771573"/>
                <a:gd name="connsiteY65" fmla="*/ 9631 h 286109"/>
                <a:gd name="connsiteX66" fmla="*/ 226695 w 771573"/>
                <a:gd name="connsiteY66" fmla="*/ 26776 h 286109"/>
                <a:gd name="connsiteX67" fmla="*/ 182880 w 771573"/>
                <a:gd name="connsiteY67" fmla="*/ 53446 h 286109"/>
                <a:gd name="connsiteX68" fmla="*/ 123825 w 771573"/>
                <a:gd name="connsiteY68" fmla="*/ 95356 h 286109"/>
                <a:gd name="connsiteX69" fmla="*/ 87630 w 771573"/>
                <a:gd name="connsiteY69" fmla="*/ 125836 h 286109"/>
                <a:gd name="connsiteX70" fmla="*/ 55245 w 771573"/>
                <a:gd name="connsiteY70" fmla="*/ 158221 h 286109"/>
                <a:gd name="connsiteX71" fmla="*/ 20955 w 771573"/>
                <a:gd name="connsiteY71" fmla="*/ 203941 h 286109"/>
                <a:gd name="connsiteX72" fmla="*/ 0 w 771573"/>
                <a:gd name="connsiteY72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67218 w 771573"/>
                <a:gd name="connsiteY20" fmla="*/ 206465 h 286109"/>
                <a:gd name="connsiteX21" fmla="*/ 697230 w 771573"/>
                <a:gd name="connsiteY21" fmla="*/ 251566 h 286109"/>
                <a:gd name="connsiteX22" fmla="*/ 710565 w 771573"/>
                <a:gd name="connsiteY22" fmla="*/ 276331 h 286109"/>
                <a:gd name="connsiteX23" fmla="*/ 727710 w 771573"/>
                <a:gd name="connsiteY23" fmla="*/ 268711 h 286109"/>
                <a:gd name="connsiteX24" fmla="*/ 741045 w 771573"/>
                <a:gd name="connsiteY24" fmla="*/ 255376 h 286109"/>
                <a:gd name="connsiteX25" fmla="*/ 746760 w 771573"/>
                <a:gd name="connsiteY25" fmla="*/ 249661 h 286109"/>
                <a:gd name="connsiteX26" fmla="*/ 754380 w 771573"/>
                <a:gd name="connsiteY26" fmla="*/ 243946 h 286109"/>
                <a:gd name="connsiteX27" fmla="*/ 762000 w 771573"/>
                <a:gd name="connsiteY27" fmla="*/ 240136 h 286109"/>
                <a:gd name="connsiteX28" fmla="*/ 767715 w 771573"/>
                <a:gd name="connsiteY28" fmla="*/ 236326 h 286109"/>
                <a:gd name="connsiteX29" fmla="*/ 771525 w 771573"/>
                <a:gd name="connsiteY29" fmla="*/ 230611 h 286109"/>
                <a:gd name="connsiteX30" fmla="*/ 765810 w 771573"/>
                <a:gd name="connsiteY30" fmla="*/ 200131 h 286109"/>
                <a:gd name="connsiteX31" fmla="*/ 762000 w 771573"/>
                <a:gd name="connsiteY31" fmla="*/ 194416 h 286109"/>
                <a:gd name="connsiteX32" fmla="*/ 756285 w 771573"/>
                <a:gd name="connsiteY32" fmla="*/ 181081 h 286109"/>
                <a:gd name="connsiteX33" fmla="*/ 748665 w 771573"/>
                <a:gd name="connsiteY33" fmla="*/ 165841 h 286109"/>
                <a:gd name="connsiteX34" fmla="*/ 739140 w 771573"/>
                <a:gd name="connsiteY34" fmla="*/ 152506 h 286109"/>
                <a:gd name="connsiteX35" fmla="*/ 737235 w 771573"/>
                <a:gd name="connsiteY35" fmla="*/ 146791 h 286109"/>
                <a:gd name="connsiteX36" fmla="*/ 727710 w 771573"/>
                <a:gd name="connsiteY36" fmla="*/ 135361 h 286109"/>
                <a:gd name="connsiteX37" fmla="*/ 720090 w 771573"/>
                <a:gd name="connsiteY37" fmla="*/ 129646 h 286109"/>
                <a:gd name="connsiteX38" fmla="*/ 714375 w 771573"/>
                <a:gd name="connsiteY38" fmla="*/ 127741 h 286109"/>
                <a:gd name="connsiteX39" fmla="*/ 702945 w 771573"/>
                <a:gd name="connsiteY39" fmla="*/ 118216 h 286109"/>
                <a:gd name="connsiteX40" fmla="*/ 697230 w 771573"/>
                <a:gd name="connsiteY40" fmla="*/ 112501 h 286109"/>
                <a:gd name="connsiteX41" fmla="*/ 691515 w 771573"/>
                <a:gd name="connsiteY41" fmla="*/ 108691 h 286109"/>
                <a:gd name="connsiteX42" fmla="*/ 683895 w 771573"/>
                <a:gd name="connsiteY42" fmla="*/ 102976 h 286109"/>
                <a:gd name="connsiteX43" fmla="*/ 676275 w 771573"/>
                <a:gd name="connsiteY43" fmla="*/ 99166 h 286109"/>
                <a:gd name="connsiteX44" fmla="*/ 664845 w 771573"/>
                <a:gd name="connsiteY44" fmla="*/ 95356 h 286109"/>
                <a:gd name="connsiteX45" fmla="*/ 655320 w 771573"/>
                <a:gd name="connsiteY45" fmla="*/ 89641 h 286109"/>
                <a:gd name="connsiteX46" fmla="*/ 640080 w 771573"/>
                <a:gd name="connsiteY46" fmla="*/ 83926 h 286109"/>
                <a:gd name="connsiteX47" fmla="*/ 626745 w 771573"/>
                <a:gd name="connsiteY47" fmla="*/ 74401 h 286109"/>
                <a:gd name="connsiteX48" fmla="*/ 621030 w 771573"/>
                <a:gd name="connsiteY48" fmla="*/ 72496 h 286109"/>
                <a:gd name="connsiteX49" fmla="*/ 609600 w 771573"/>
                <a:gd name="connsiteY49" fmla="*/ 64876 h 286109"/>
                <a:gd name="connsiteX50" fmla="*/ 598170 w 771573"/>
                <a:gd name="connsiteY50" fmla="*/ 59161 h 286109"/>
                <a:gd name="connsiteX51" fmla="*/ 592455 w 771573"/>
                <a:gd name="connsiteY51" fmla="*/ 55351 h 286109"/>
                <a:gd name="connsiteX52" fmla="*/ 584835 w 771573"/>
                <a:gd name="connsiteY52" fmla="*/ 49636 h 286109"/>
                <a:gd name="connsiteX53" fmla="*/ 573405 w 771573"/>
                <a:gd name="connsiteY53" fmla="*/ 45826 h 286109"/>
                <a:gd name="connsiteX54" fmla="*/ 567690 w 771573"/>
                <a:gd name="connsiteY54" fmla="*/ 42016 h 286109"/>
                <a:gd name="connsiteX55" fmla="*/ 556260 w 771573"/>
                <a:gd name="connsiteY55" fmla="*/ 38206 h 286109"/>
                <a:gd name="connsiteX56" fmla="*/ 548640 w 771573"/>
                <a:gd name="connsiteY56" fmla="*/ 34396 h 286109"/>
                <a:gd name="connsiteX57" fmla="*/ 537210 w 771573"/>
                <a:gd name="connsiteY57" fmla="*/ 26776 h 286109"/>
                <a:gd name="connsiteX58" fmla="*/ 493395 w 771573"/>
                <a:gd name="connsiteY58" fmla="*/ 17251 h 286109"/>
                <a:gd name="connsiteX59" fmla="*/ 485775 w 771573"/>
                <a:gd name="connsiteY59" fmla="*/ 15346 h 286109"/>
                <a:gd name="connsiteX60" fmla="*/ 472440 w 771573"/>
                <a:gd name="connsiteY60" fmla="*/ 11536 h 286109"/>
                <a:gd name="connsiteX61" fmla="*/ 409575 w 771573"/>
                <a:gd name="connsiteY61" fmla="*/ 3916 h 286109"/>
                <a:gd name="connsiteX62" fmla="*/ 360045 w 771573"/>
                <a:gd name="connsiteY62" fmla="*/ 106 h 286109"/>
                <a:gd name="connsiteX63" fmla="*/ 300990 w 771573"/>
                <a:gd name="connsiteY63" fmla="*/ 2011 h 286109"/>
                <a:gd name="connsiteX64" fmla="*/ 268605 w 771573"/>
                <a:gd name="connsiteY64" fmla="*/ 9631 h 286109"/>
                <a:gd name="connsiteX65" fmla="*/ 226695 w 771573"/>
                <a:gd name="connsiteY65" fmla="*/ 26776 h 286109"/>
                <a:gd name="connsiteX66" fmla="*/ 182880 w 771573"/>
                <a:gd name="connsiteY66" fmla="*/ 53446 h 286109"/>
                <a:gd name="connsiteX67" fmla="*/ 123825 w 771573"/>
                <a:gd name="connsiteY67" fmla="*/ 95356 h 286109"/>
                <a:gd name="connsiteX68" fmla="*/ 87630 w 771573"/>
                <a:gd name="connsiteY68" fmla="*/ 125836 h 286109"/>
                <a:gd name="connsiteX69" fmla="*/ 55245 w 771573"/>
                <a:gd name="connsiteY69" fmla="*/ 158221 h 286109"/>
                <a:gd name="connsiteX70" fmla="*/ 20955 w 771573"/>
                <a:gd name="connsiteY70" fmla="*/ 203941 h 286109"/>
                <a:gd name="connsiteX71" fmla="*/ 0 w 771573"/>
                <a:gd name="connsiteY71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67218 w 771573"/>
                <a:gd name="connsiteY20" fmla="*/ 206465 h 286109"/>
                <a:gd name="connsiteX21" fmla="*/ 697230 w 771573"/>
                <a:gd name="connsiteY21" fmla="*/ 251566 h 286109"/>
                <a:gd name="connsiteX22" fmla="*/ 710565 w 771573"/>
                <a:gd name="connsiteY22" fmla="*/ 276331 h 286109"/>
                <a:gd name="connsiteX23" fmla="*/ 727710 w 771573"/>
                <a:gd name="connsiteY23" fmla="*/ 268711 h 286109"/>
                <a:gd name="connsiteX24" fmla="*/ 741045 w 771573"/>
                <a:gd name="connsiteY24" fmla="*/ 255376 h 286109"/>
                <a:gd name="connsiteX25" fmla="*/ 746760 w 771573"/>
                <a:gd name="connsiteY25" fmla="*/ 249661 h 286109"/>
                <a:gd name="connsiteX26" fmla="*/ 754380 w 771573"/>
                <a:gd name="connsiteY26" fmla="*/ 243946 h 286109"/>
                <a:gd name="connsiteX27" fmla="*/ 762000 w 771573"/>
                <a:gd name="connsiteY27" fmla="*/ 240136 h 286109"/>
                <a:gd name="connsiteX28" fmla="*/ 767715 w 771573"/>
                <a:gd name="connsiteY28" fmla="*/ 236326 h 286109"/>
                <a:gd name="connsiteX29" fmla="*/ 771525 w 771573"/>
                <a:gd name="connsiteY29" fmla="*/ 230611 h 286109"/>
                <a:gd name="connsiteX30" fmla="*/ 765810 w 771573"/>
                <a:gd name="connsiteY30" fmla="*/ 200131 h 286109"/>
                <a:gd name="connsiteX31" fmla="*/ 762000 w 771573"/>
                <a:gd name="connsiteY31" fmla="*/ 194416 h 286109"/>
                <a:gd name="connsiteX32" fmla="*/ 756285 w 771573"/>
                <a:gd name="connsiteY32" fmla="*/ 181081 h 286109"/>
                <a:gd name="connsiteX33" fmla="*/ 748665 w 771573"/>
                <a:gd name="connsiteY33" fmla="*/ 165841 h 286109"/>
                <a:gd name="connsiteX34" fmla="*/ 739140 w 771573"/>
                <a:gd name="connsiteY34" fmla="*/ 152506 h 286109"/>
                <a:gd name="connsiteX35" fmla="*/ 737235 w 771573"/>
                <a:gd name="connsiteY35" fmla="*/ 146791 h 286109"/>
                <a:gd name="connsiteX36" fmla="*/ 727710 w 771573"/>
                <a:gd name="connsiteY36" fmla="*/ 135361 h 286109"/>
                <a:gd name="connsiteX37" fmla="*/ 720090 w 771573"/>
                <a:gd name="connsiteY37" fmla="*/ 129646 h 286109"/>
                <a:gd name="connsiteX38" fmla="*/ 714375 w 771573"/>
                <a:gd name="connsiteY38" fmla="*/ 127741 h 286109"/>
                <a:gd name="connsiteX39" fmla="*/ 702945 w 771573"/>
                <a:gd name="connsiteY39" fmla="*/ 118216 h 286109"/>
                <a:gd name="connsiteX40" fmla="*/ 697230 w 771573"/>
                <a:gd name="connsiteY40" fmla="*/ 112501 h 286109"/>
                <a:gd name="connsiteX41" fmla="*/ 691515 w 771573"/>
                <a:gd name="connsiteY41" fmla="*/ 108691 h 286109"/>
                <a:gd name="connsiteX42" fmla="*/ 676275 w 771573"/>
                <a:gd name="connsiteY42" fmla="*/ 99166 h 286109"/>
                <a:gd name="connsiteX43" fmla="*/ 664845 w 771573"/>
                <a:gd name="connsiteY43" fmla="*/ 95356 h 286109"/>
                <a:gd name="connsiteX44" fmla="*/ 655320 w 771573"/>
                <a:gd name="connsiteY44" fmla="*/ 89641 h 286109"/>
                <a:gd name="connsiteX45" fmla="*/ 640080 w 771573"/>
                <a:gd name="connsiteY45" fmla="*/ 83926 h 286109"/>
                <a:gd name="connsiteX46" fmla="*/ 626745 w 771573"/>
                <a:gd name="connsiteY46" fmla="*/ 74401 h 286109"/>
                <a:gd name="connsiteX47" fmla="*/ 621030 w 771573"/>
                <a:gd name="connsiteY47" fmla="*/ 72496 h 286109"/>
                <a:gd name="connsiteX48" fmla="*/ 609600 w 771573"/>
                <a:gd name="connsiteY48" fmla="*/ 64876 h 286109"/>
                <a:gd name="connsiteX49" fmla="*/ 598170 w 771573"/>
                <a:gd name="connsiteY49" fmla="*/ 59161 h 286109"/>
                <a:gd name="connsiteX50" fmla="*/ 592455 w 771573"/>
                <a:gd name="connsiteY50" fmla="*/ 55351 h 286109"/>
                <a:gd name="connsiteX51" fmla="*/ 584835 w 771573"/>
                <a:gd name="connsiteY51" fmla="*/ 49636 h 286109"/>
                <a:gd name="connsiteX52" fmla="*/ 573405 w 771573"/>
                <a:gd name="connsiteY52" fmla="*/ 45826 h 286109"/>
                <a:gd name="connsiteX53" fmla="*/ 567690 w 771573"/>
                <a:gd name="connsiteY53" fmla="*/ 42016 h 286109"/>
                <a:gd name="connsiteX54" fmla="*/ 556260 w 771573"/>
                <a:gd name="connsiteY54" fmla="*/ 38206 h 286109"/>
                <a:gd name="connsiteX55" fmla="*/ 548640 w 771573"/>
                <a:gd name="connsiteY55" fmla="*/ 34396 h 286109"/>
                <a:gd name="connsiteX56" fmla="*/ 537210 w 771573"/>
                <a:gd name="connsiteY56" fmla="*/ 26776 h 286109"/>
                <a:gd name="connsiteX57" fmla="*/ 493395 w 771573"/>
                <a:gd name="connsiteY57" fmla="*/ 17251 h 286109"/>
                <a:gd name="connsiteX58" fmla="*/ 485775 w 771573"/>
                <a:gd name="connsiteY58" fmla="*/ 15346 h 286109"/>
                <a:gd name="connsiteX59" fmla="*/ 472440 w 771573"/>
                <a:gd name="connsiteY59" fmla="*/ 11536 h 286109"/>
                <a:gd name="connsiteX60" fmla="*/ 409575 w 771573"/>
                <a:gd name="connsiteY60" fmla="*/ 3916 h 286109"/>
                <a:gd name="connsiteX61" fmla="*/ 360045 w 771573"/>
                <a:gd name="connsiteY61" fmla="*/ 106 h 286109"/>
                <a:gd name="connsiteX62" fmla="*/ 300990 w 771573"/>
                <a:gd name="connsiteY62" fmla="*/ 2011 h 286109"/>
                <a:gd name="connsiteX63" fmla="*/ 268605 w 771573"/>
                <a:gd name="connsiteY63" fmla="*/ 9631 h 286109"/>
                <a:gd name="connsiteX64" fmla="*/ 226695 w 771573"/>
                <a:gd name="connsiteY64" fmla="*/ 26776 h 286109"/>
                <a:gd name="connsiteX65" fmla="*/ 182880 w 771573"/>
                <a:gd name="connsiteY65" fmla="*/ 53446 h 286109"/>
                <a:gd name="connsiteX66" fmla="*/ 123825 w 771573"/>
                <a:gd name="connsiteY66" fmla="*/ 95356 h 286109"/>
                <a:gd name="connsiteX67" fmla="*/ 87630 w 771573"/>
                <a:gd name="connsiteY67" fmla="*/ 125836 h 286109"/>
                <a:gd name="connsiteX68" fmla="*/ 55245 w 771573"/>
                <a:gd name="connsiteY68" fmla="*/ 158221 h 286109"/>
                <a:gd name="connsiteX69" fmla="*/ 20955 w 771573"/>
                <a:gd name="connsiteY69" fmla="*/ 203941 h 286109"/>
                <a:gd name="connsiteX70" fmla="*/ 0 w 771573"/>
                <a:gd name="connsiteY70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67218 w 771573"/>
                <a:gd name="connsiteY20" fmla="*/ 206465 h 286109"/>
                <a:gd name="connsiteX21" fmla="*/ 697230 w 771573"/>
                <a:gd name="connsiteY21" fmla="*/ 251566 h 286109"/>
                <a:gd name="connsiteX22" fmla="*/ 710565 w 771573"/>
                <a:gd name="connsiteY22" fmla="*/ 276331 h 286109"/>
                <a:gd name="connsiteX23" fmla="*/ 727710 w 771573"/>
                <a:gd name="connsiteY23" fmla="*/ 268711 h 286109"/>
                <a:gd name="connsiteX24" fmla="*/ 741045 w 771573"/>
                <a:gd name="connsiteY24" fmla="*/ 255376 h 286109"/>
                <a:gd name="connsiteX25" fmla="*/ 746760 w 771573"/>
                <a:gd name="connsiteY25" fmla="*/ 249661 h 286109"/>
                <a:gd name="connsiteX26" fmla="*/ 754380 w 771573"/>
                <a:gd name="connsiteY26" fmla="*/ 243946 h 286109"/>
                <a:gd name="connsiteX27" fmla="*/ 762000 w 771573"/>
                <a:gd name="connsiteY27" fmla="*/ 240136 h 286109"/>
                <a:gd name="connsiteX28" fmla="*/ 767715 w 771573"/>
                <a:gd name="connsiteY28" fmla="*/ 236326 h 286109"/>
                <a:gd name="connsiteX29" fmla="*/ 771525 w 771573"/>
                <a:gd name="connsiteY29" fmla="*/ 230611 h 286109"/>
                <a:gd name="connsiteX30" fmla="*/ 765810 w 771573"/>
                <a:gd name="connsiteY30" fmla="*/ 200131 h 286109"/>
                <a:gd name="connsiteX31" fmla="*/ 762000 w 771573"/>
                <a:gd name="connsiteY31" fmla="*/ 194416 h 286109"/>
                <a:gd name="connsiteX32" fmla="*/ 756285 w 771573"/>
                <a:gd name="connsiteY32" fmla="*/ 181081 h 286109"/>
                <a:gd name="connsiteX33" fmla="*/ 748665 w 771573"/>
                <a:gd name="connsiteY33" fmla="*/ 165841 h 286109"/>
                <a:gd name="connsiteX34" fmla="*/ 739140 w 771573"/>
                <a:gd name="connsiteY34" fmla="*/ 152506 h 286109"/>
                <a:gd name="connsiteX35" fmla="*/ 737235 w 771573"/>
                <a:gd name="connsiteY35" fmla="*/ 146791 h 286109"/>
                <a:gd name="connsiteX36" fmla="*/ 727710 w 771573"/>
                <a:gd name="connsiteY36" fmla="*/ 135361 h 286109"/>
                <a:gd name="connsiteX37" fmla="*/ 720090 w 771573"/>
                <a:gd name="connsiteY37" fmla="*/ 129646 h 286109"/>
                <a:gd name="connsiteX38" fmla="*/ 714375 w 771573"/>
                <a:gd name="connsiteY38" fmla="*/ 127741 h 286109"/>
                <a:gd name="connsiteX39" fmla="*/ 702945 w 771573"/>
                <a:gd name="connsiteY39" fmla="*/ 118216 h 286109"/>
                <a:gd name="connsiteX40" fmla="*/ 697230 w 771573"/>
                <a:gd name="connsiteY40" fmla="*/ 112501 h 286109"/>
                <a:gd name="connsiteX41" fmla="*/ 691515 w 771573"/>
                <a:gd name="connsiteY41" fmla="*/ 108691 h 286109"/>
                <a:gd name="connsiteX42" fmla="*/ 676275 w 771573"/>
                <a:gd name="connsiteY42" fmla="*/ 99166 h 286109"/>
                <a:gd name="connsiteX43" fmla="*/ 664845 w 771573"/>
                <a:gd name="connsiteY43" fmla="*/ 95356 h 286109"/>
                <a:gd name="connsiteX44" fmla="*/ 655320 w 771573"/>
                <a:gd name="connsiteY44" fmla="*/ 89641 h 286109"/>
                <a:gd name="connsiteX45" fmla="*/ 626745 w 771573"/>
                <a:gd name="connsiteY45" fmla="*/ 74401 h 286109"/>
                <a:gd name="connsiteX46" fmla="*/ 621030 w 771573"/>
                <a:gd name="connsiteY46" fmla="*/ 72496 h 286109"/>
                <a:gd name="connsiteX47" fmla="*/ 609600 w 771573"/>
                <a:gd name="connsiteY47" fmla="*/ 64876 h 286109"/>
                <a:gd name="connsiteX48" fmla="*/ 598170 w 771573"/>
                <a:gd name="connsiteY48" fmla="*/ 59161 h 286109"/>
                <a:gd name="connsiteX49" fmla="*/ 592455 w 771573"/>
                <a:gd name="connsiteY49" fmla="*/ 55351 h 286109"/>
                <a:gd name="connsiteX50" fmla="*/ 584835 w 771573"/>
                <a:gd name="connsiteY50" fmla="*/ 49636 h 286109"/>
                <a:gd name="connsiteX51" fmla="*/ 573405 w 771573"/>
                <a:gd name="connsiteY51" fmla="*/ 45826 h 286109"/>
                <a:gd name="connsiteX52" fmla="*/ 567690 w 771573"/>
                <a:gd name="connsiteY52" fmla="*/ 42016 h 286109"/>
                <a:gd name="connsiteX53" fmla="*/ 556260 w 771573"/>
                <a:gd name="connsiteY53" fmla="*/ 38206 h 286109"/>
                <a:gd name="connsiteX54" fmla="*/ 548640 w 771573"/>
                <a:gd name="connsiteY54" fmla="*/ 34396 h 286109"/>
                <a:gd name="connsiteX55" fmla="*/ 537210 w 771573"/>
                <a:gd name="connsiteY55" fmla="*/ 26776 h 286109"/>
                <a:gd name="connsiteX56" fmla="*/ 493395 w 771573"/>
                <a:gd name="connsiteY56" fmla="*/ 17251 h 286109"/>
                <a:gd name="connsiteX57" fmla="*/ 485775 w 771573"/>
                <a:gd name="connsiteY57" fmla="*/ 15346 h 286109"/>
                <a:gd name="connsiteX58" fmla="*/ 472440 w 771573"/>
                <a:gd name="connsiteY58" fmla="*/ 11536 h 286109"/>
                <a:gd name="connsiteX59" fmla="*/ 409575 w 771573"/>
                <a:gd name="connsiteY59" fmla="*/ 3916 h 286109"/>
                <a:gd name="connsiteX60" fmla="*/ 360045 w 771573"/>
                <a:gd name="connsiteY60" fmla="*/ 106 h 286109"/>
                <a:gd name="connsiteX61" fmla="*/ 300990 w 771573"/>
                <a:gd name="connsiteY61" fmla="*/ 2011 h 286109"/>
                <a:gd name="connsiteX62" fmla="*/ 268605 w 771573"/>
                <a:gd name="connsiteY62" fmla="*/ 9631 h 286109"/>
                <a:gd name="connsiteX63" fmla="*/ 226695 w 771573"/>
                <a:gd name="connsiteY63" fmla="*/ 26776 h 286109"/>
                <a:gd name="connsiteX64" fmla="*/ 182880 w 771573"/>
                <a:gd name="connsiteY64" fmla="*/ 53446 h 286109"/>
                <a:gd name="connsiteX65" fmla="*/ 123825 w 771573"/>
                <a:gd name="connsiteY65" fmla="*/ 95356 h 286109"/>
                <a:gd name="connsiteX66" fmla="*/ 87630 w 771573"/>
                <a:gd name="connsiteY66" fmla="*/ 125836 h 286109"/>
                <a:gd name="connsiteX67" fmla="*/ 55245 w 771573"/>
                <a:gd name="connsiteY67" fmla="*/ 158221 h 286109"/>
                <a:gd name="connsiteX68" fmla="*/ 20955 w 771573"/>
                <a:gd name="connsiteY68" fmla="*/ 203941 h 286109"/>
                <a:gd name="connsiteX69" fmla="*/ 0 w 771573"/>
                <a:gd name="connsiteY69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67218 w 771573"/>
                <a:gd name="connsiteY20" fmla="*/ 206465 h 286109"/>
                <a:gd name="connsiteX21" fmla="*/ 697230 w 771573"/>
                <a:gd name="connsiteY21" fmla="*/ 251566 h 286109"/>
                <a:gd name="connsiteX22" fmla="*/ 710565 w 771573"/>
                <a:gd name="connsiteY22" fmla="*/ 276331 h 286109"/>
                <a:gd name="connsiteX23" fmla="*/ 727710 w 771573"/>
                <a:gd name="connsiteY23" fmla="*/ 268711 h 286109"/>
                <a:gd name="connsiteX24" fmla="*/ 741045 w 771573"/>
                <a:gd name="connsiteY24" fmla="*/ 255376 h 286109"/>
                <a:gd name="connsiteX25" fmla="*/ 746760 w 771573"/>
                <a:gd name="connsiteY25" fmla="*/ 249661 h 286109"/>
                <a:gd name="connsiteX26" fmla="*/ 754380 w 771573"/>
                <a:gd name="connsiteY26" fmla="*/ 243946 h 286109"/>
                <a:gd name="connsiteX27" fmla="*/ 762000 w 771573"/>
                <a:gd name="connsiteY27" fmla="*/ 240136 h 286109"/>
                <a:gd name="connsiteX28" fmla="*/ 767715 w 771573"/>
                <a:gd name="connsiteY28" fmla="*/ 236326 h 286109"/>
                <a:gd name="connsiteX29" fmla="*/ 771525 w 771573"/>
                <a:gd name="connsiteY29" fmla="*/ 230611 h 286109"/>
                <a:gd name="connsiteX30" fmla="*/ 765810 w 771573"/>
                <a:gd name="connsiteY30" fmla="*/ 200131 h 286109"/>
                <a:gd name="connsiteX31" fmla="*/ 762000 w 771573"/>
                <a:gd name="connsiteY31" fmla="*/ 194416 h 286109"/>
                <a:gd name="connsiteX32" fmla="*/ 756285 w 771573"/>
                <a:gd name="connsiteY32" fmla="*/ 181081 h 286109"/>
                <a:gd name="connsiteX33" fmla="*/ 748665 w 771573"/>
                <a:gd name="connsiteY33" fmla="*/ 165841 h 286109"/>
                <a:gd name="connsiteX34" fmla="*/ 739140 w 771573"/>
                <a:gd name="connsiteY34" fmla="*/ 152506 h 286109"/>
                <a:gd name="connsiteX35" fmla="*/ 737235 w 771573"/>
                <a:gd name="connsiteY35" fmla="*/ 146791 h 286109"/>
                <a:gd name="connsiteX36" fmla="*/ 727710 w 771573"/>
                <a:gd name="connsiteY36" fmla="*/ 135361 h 286109"/>
                <a:gd name="connsiteX37" fmla="*/ 720090 w 771573"/>
                <a:gd name="connsiteY37" fmla="*/ 129646 h 286109"/>
                <a:gd name="connsiteX38" fmla="*/ 714375 w 771573"/>
                <a:gd name="connsiteY38" fmla="*/ 127741 h 286109"/>
                <a:gd name="connsiteX39" fmla="*/ 702945 w 771573"/>
                <a:gd name="connsiteY39" fmla="*/ 118216 h 286109"/>
                <a:gd name="connsiteX40" fmla="*/ 697230 w 771573"/>
                <a:gd name="connsiteY40" fmla="*/ 112501 h 286109"/>
                <a:gd name="connsiteX41" fmla="*/ 691515 w 771573"/>
                <a:gd name="connsiteY41" fmla="*/ 108691 h 286109"/>
                <a:gd name="connsiteX42" fmla="*/ 676275 w 771573"/>
                <a:gd name="connsiteY42" fmla="*/ 99166 h 286109"/>
                <a:gd name="connsiteX43" fmla="*/ 664845 w 771573"/>
                <a:gd name="connsiteY43" fmla="*/ 95356 h 286109"/>
                <a:gd name="connsiteX44" fmla="*/ 655320 w 771573"/>
                <a:gd name="connsiteY44" fmla="*/ 89641 h 286109"/>
                <a:gd name="connsiteX45" fmla="*/ 626745 w 771573"/>
                <a:gd name="connsiteY45" fmla="*/ 74401 h 286109"/>
                <a:gd name="connsiteX46" fmla="*/ 621030 w 771573"/>
                <a:gd name="connsiteY46" fmla="*/ 72496 h 286109"/>
                <a:gd name="connsiteX47" fmla="*/ 598170 w 771573"/>
                <a:gd name="connsiteY47" fmla="*/ 59161 h 286109"/>
                <a:gd name="connsiteX48" fmla="*/ 592455 w 771573"/>
                <a:gd name="connsiteY48" fmla="*/ 55351 h 286109"/>
                <a:gd name="connsiteX49" fmla="*/ 584835 w 771573"/>
                <a:gd name="connsiteY49" fmla="*/ 49636 h 286109"/>
                <a:gd name="connsiteX50" fmla="*/ 573405 w 771573"/>
                <a:gd name="connsiteY50" fmla="*/ 45826 h 286109"/>
                <a:gd name="connsiteX51" fmla="*/ 567690 w 771573"/>
                <a:gd name="connsiteY51" fmla="*/ 42016 h 286109"/>
                <a:gd name="connsiteX52" fmla="*/ 556260 w 771573"/>
                <a:gd name="connsiteY52" fmla="*/ 38206 h 286109"/>
                <a:gd name="connsiteX53" fmla="*/ 548640 w 771573"/>
                <a:gd name="connsiteY53" fmla="*/ 34396 h 286109"/>
                <a:gd name="connsiteX54" fmla="*/ 537210 w 771573"/>
                <a:gd name="connsiteY54" fmla="*/ 26776 h 286109"/>
                <a:gd name="connsiteX55" fmla="*/ 493395 w 771573"/>
                <a:gd name="connsiteY55" fmla="*/ 17251 h 286109"/>
                <a:gd name="connsiteX56" fmla="*/ 485775 w 771573"/>
                <a:gd name="connsiteY56" fmla="*/ 15346 h 286109"/>
                <a:gd name="connsiteX57" fmla="*/ 472440 w 771573"/>
                <a:gd name="connsiteY57" fmla="*/ 11536 h 286109"/>
                <a:gd name="connsiteX58" fmla="*/ 409575 w 771573"/>
                <a:gd name="connsiteY58" fmla="*/ 3916 h 286109"/>
                <a:gd name="connsiteX59" fmla="*/ 360045 w 771573"/>
                <a:gd name="connsiteY59" fmla="*/ 106 h 286109"/>
                <a:gd name="connsiteX60" fmla="*/ 300990 w 771573"/>
                <a:gd name="connsiteY60" fmla="*/ 2011 h 286109"/>
                <a:gd name="connsiteX61" fmla="*/ 268605 w 771573"/>
                <a:gd name="connsiteY61" fmla="*/ 9631 h 286109"/>
                <a:gd name="connsiteX62" fmla="*/ 226695 w 771573"/>
                <a:gd name="connsiteY62" fmla="*/ 26776 h 286109"/>
                <a:gd name="connsiteX63" fmla="*/ 182880 w 771573"/>
                <a:gd name="connsiteY63" fmla="*/ 53446 h 286109"/>
                <a:gd name="connsiteX64" fmla="*/ 123825 w 771573"/>
                <a:gd name="connsiteY64" fmla="*/ 95356 h 286109"/>
                <a:gd name="connsiteX65" fmla="*/ 87630 w 771573"/>
                <a:gd name="connsiteY65" fmla="*/ 125836 h 286109"/>
                <a:gd name="connsiteX66" fmla="*/ 55245 w 771573"/>
                <a:gd name="connsiteY66" fmla="*/ 158221 h 286109"/>
                <a:gd name="connsiteX67" fmla="*/ 20955 w 771573"/>
                <a:gd name="connsiteY67" fmla="*/ 203941 h 286109"/>
                <a:gd name="connsiteX68" fmla="*/ 0 w 771573"/>
                <a:gd name="connsiteY68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67218 w 771573"/>
                <a:gd name="connsiteY20" fmla="*/ 206465 h 286109"/>
                <a:gd name="connsiteX21" fmla="*/ 697230 w 771573"/>
                <a:gd name="connsiteY21" fmla="*/ 251566 h 286109"/>
                <a:gd name="connsiteX22" fmla="*/ 710565 w 771573"/>
                <a:gd name="connsiteY22" fmla="*/ 276331 h 286109"/>
                <a:gd name="connsiteX23" fmla="*/ 727710 w 771573"/>
                <a:gd name="connsiteY23" fmla="*/ 268711 h 286109"/>
                <a:gd name="connsiteX24" fmla="*/ 741045 w 771573"/>
                <a:gd name="connsiteY24" fmla="*/ 255376 h 286109"/>
                <a:gd name="connsiteX25" fmla="*/ 746760 w 771573"/>
                <a:gd name="connsiteY25" fmla="*/ 249661 h 286109"/>
                <a:gd name="connsiteX26" fmla="*/ 754380 w 771573"/>
                <a:gd name="connsiteY26" fmla="*/ 243946 h 286109"/>
                <a:gd name="connsiteX27" fmla="*/ 762000 w 771573"/>
                <a:gd name="connsiteY27" fmla="*/ 240136 h 286109"/>
                <a:gd name="connsiteX28" fmla="*/ 767715 w 771573"/>
                <a:gd name="connsiteY28" fmla="*/ 236326 h 286109"/>
                <a:gd name="connsiteX29" fmla="*/ 771525 w 771573"/>
                <a:gd name="connsiteY29" fmla="*/ 230611 h 286109"/>
                <a:gd name="connsiteX30" fmla="*/ 765810 w 771573"/>
                <a:gd name="connsiteY30" fmla="*/ 200131 h 286109"/>
                <a:gd name="connsiteX31" fmla="*/ 762000 w 771573"/>
                <a:gd name="connsiteY31" fmla="*/ 194416 h 286109"/>
                <a:gd name="connsiteX32" fmla="*/ 756285 w 771573"/>
                <a:gd name="connsiteY32" fmla="*/ 181081 h 286109"/>
                <a:gd name="connsiteX33" fmla="*/ 748665 w 771573"/>
                <a:gd name="connsiteY33" fmla="*/ 165841 h 286109"/>
                <a:gd name="connsiteX34" fmla="*/ 739140 w 771573"/>
                <a:gd name="connsiteY34" fmla="*/ 152506 h 286109"/>
                <a:gd name="connsiteX35" fmla="*/ 737235 w 771573"/>
                <a:gd name="connsiteY35" fmla="*/ 146791 h 286109"/>
                <a:gd name="connsiteX36" fmla="*/ 727710 w 771573"/>
                <a:gd name="connsiteY36" fmla="*/ 135361 h 286109"/>
                <a:gd name="connsiteX37" fmla="*/ 720090 w 771573"/>
                <a:gd name="connsiteY37" fmla="*/ 129646 h 286109"/>
                <a:gd name="connsiteX38" fmla="*/ 714375 w 771573"/>
                <a:gd name="connsiteY38" fmla="*/ 127741 h 286109"/>
                <a:gd name="connsiteX39" fmla="*/ 702945 w 771573"/>
                <a:gd name="connsiteY39" fmla="*/ 118216 h 286109"/>
                <a:gd name="connsiteX40" fmla="*/ 697230 w 771573"/>
                <a:gd name="connsiteY40" fmla="*/ 112501 h 286109"/>
                <a:gd name="connsiteX41" fmla="*/ 691515 w 771573"/>
                <a:gd name="connsiteY41" fmla="*/ 108691 h 286109"/>
                <a:gd name="connsiteX42" fmla="*/ 676275 w 771573"/>
                <a:gd name="connsiteY42" fmla="*/ 99166 h 286109"/>
                <a:gd name="connsiteX43" fmla="*/ 664845 w 771573"/>
                <a:gd name="connsiteY43" fmla="*/ 95356 h 286109"/>
                <a:gd name="connsiteX44" fmla="*/ 655320 w 771573"/>
                <a:gd name="connsiteY44" fmla="*/ 89641 h 286109"/>
                <a:gd name="connsiteX45" fmla="*/ 626745 w 771573"/>
                <a:gd name="connsiteY45" fmla="*/ 74401 h 286109"/>
                <a:gd name="connsiteX46" fmla="*/ 621030 w 771573"/>
                <a:gd name="connsiteY46" fmla="*/ 72496 h 286109"/>
                <a:gd name="connsiteX47" fmla="*/ 598170 w 771573"/>
                <a:gd name="connsiteY47" fmla="*/ 59161 h 286109"/>
                <a:gd name="connsiteX48" fmla="*/ 592455 w 771573"/>
                <a:gd name="connsiteY48" fmla="*/ 55351 h 286109"/>
                <a:gd name="connsiteX49" fmla="*/ 584835 w 771573"/>
                <a:gd name="connsiteY49" fmla="*/ 49636 h 286109"/>
                <a:gd name="connsiteX50" fmla="*/ 573405 w 771573"/>
                <a:gd name="connsiteY50" fmla="*/ 45826 h 286109"/>
                <a:gd name="connsiteX51" fmla="*/ 567690 w 771573"/>
                <a:gd name="connsiteY51" fmla="*/ 42016 h 286109"/>
                <a:gd name="connsiteX52" fmla="*/ 556260 w 771573"/>
                <a:gd name="connsiteY52" fmla="*/ 38206 h 286109"/>
                <a:gd name="connsiteX53" fmla="*/ 548640 w 771573"/>
                <a:gd name="connsiteY53" fmla="*/ 34396 h 286109"/>
                <a:gd name="connsiteX54" fmla="*/ 537210 w 771573"/>
                <a:gd name="connsiteY54" fmla="*/ 26776 h 286109"/>
                <a:gd name="connsiteX55" fmla="*/ 485775 w 771573"/>
                <a:gd name="connsiteY55" fmla="*/ 15346 h 286109"/>
                <a:gd name="connsiteX56" fmla="*/ 472440 w 771573"/>
                <a:gd name="connsiteY56" fmla="*/ 11536 h 286109"/>
                <a:gd name="connsiteX57" fmla="*/ 409575 w 771573"/>
                <a:gd name="connsiteY57" fmla="*/ 3916 h 286109"/>
                <a:gd name="connsiteX58" fmla="*/ 360045 w 771573"/>
                <a:gd name="connsiteY58" fmla="*/ 106 h 286109"/>
                <a:gd name="connsiteX59" fmla="*/ 300990 w 771573"/>
                <a:gd name="connsiteY59" fmla="*/ 2011 h 286109"/>
                <a:gd name="connsiteX60" fmla="*/ 268605 w 771573"/>
                <a:gd name="connsiteY60" fmla="*/ 9631 h 286109"/>
                <a:gd name="connsiteX61" fmla="*/ 226695 w 771573"/>
                <a:gd name="connsiteY61" fmla="*/ 26776 h 286109"/>
                <a:gd name="connsiteX62" fmla="*/ 182880 w 771573"/>
                <a:gd name="connsiteY62" fmla="*/ 53446 h 286109"/>
                <a:gd name="connsiteX63" fmla="*/ 123825 w 771573"/>
                <a:gd name="connsiteY63" fmla="*/ 95356 h 286109"/>
                <a:gd name="connsiteX64" fmla="*/ 87630 w 771573"/>
                <a:gd name="connsiteY64" fmla="*/ 125836 h 286109"/>
                <a:gd name="connsiteX65" fmla="*/ 55245 w 771573"/>
                <a:gd name="connsiteY65" fmla="*/ 158221 h 286109"/>
                <a:gd name="connsiteX66" fmla="*/ 20955 w 771573"/>
                <a:gd name="connsiteY66" fmla="*/ 203941 h 286109"/>
                <a:gd name="connsiteX67" fmla="*/ 0 w 771573"/>
                <a:gd name="connsiteY67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67218 w 771573"/>
                <a:gd name="connsiteY20" fmla="*/ 206465 h 286109"/>
                <a:gd name="connsiteX21" fmla="*/ 697230 w 771573"/>
                <a:gd name="connsiteY21" fmla="*/ 251566 h 286109"/>
                <a:gd name="connsiteX22" fmla="*/ 710565 w 771573"/>
                <a:gd name="connsiteY22" fmla="*/ 276331 h 286109"/>
                <a:gd name="connsiteX23" fmla="*/ 727710 w 771573"/>
                <a:gd name="connsiteY23" fmla="*/ 268711 h 286109"/>
                <a:gd name="connsiteX24" fmla="*/ 741045 w 771573"/>
                <a:gd name="connsiteY24" fmla="*/ 255376 h 286109"/>
                <a:gd name="connsiteX25" fmla="*/ 746760 w 771573"/>
                <a:gd name="connsiteY25" fmla="*/ 249661 h 286109"/>
                <a:gd name="connsiteX26" fmla="*/ 754380 w 771573"/>
                <a:gd name="connsiteY26" fmla="*/ 243946 h 286109"/>
                <a:gd name="connsiteX27" fmla="*/ 762000 w 771573"/>
                <a:gd name="connsiteY27" fmla="*/ 240136 h 286109"/>
                <a:gd name="connsiteX28" fmla="*/ 767715 w 771573"/>
                <a:gd name="connsiteY28" fmla="*/ 236326 h 286109"/>
                <a:gd name="connsiteX29" fmla="*/ 771525 w 771573"/>
                <a:gd name="connsiteY29" fmla="*/ 230611 h 286109"/>
                <a:gd name="connsiteX30" fmla="*/ 765810 w 771573"/>
                <a:gd name="connsiteY30" fmla="*/ 200131 h 286109"/>
                <a:gd name="connsiteX31" fmla="*/ 762000 w 771573"/>
                <a:gd name="connsiteY31" fmla="*/ 194416 h 286109"/>
                <a:gd name="connsiteX32" fmla="*/ 756285 w 771573"/>
                <a:gd name="connsiteY32" fmla="*/ 181081 h 286109"/>
                <a:gd name="connsiteX33" fmla="*/ 748665 w 771573"/>
                <a:gd name="connsiteY33" fmla="*/ 165841 h 286109"/>
                <a:gd name="connsiteX34" fmla="*/ 739140 w 771573"/>
                <a:gd name="connsiteY34" fmla="*/ 152506 h 286109"/>
                <a:gd name="connsiteX35" fmla="*/ 737235 w 771573"/>
                <a:gd name="connsiteY35" fmla="*/ 146791 h 286109"/>
                <a:gd name="connsiteX36" fmla="*/ 727710 w 771573"/>
                <a:gd name="connsiteY36" fmla="*/ 135361 h 286109"/>
                <a:gd name="connsiteX37" fmla="*/ 720090 w 771573"/>
                <a:gd name="connsiteY37" fmla="*/ 129646 h 286109"/>
                <a:gd name="connsiteX38" fmla="*/ 714375 w 771573"/>
                <a:gd name="connsiteY38" fmla="*/ 127741 h 286109"/>
                <a:gd name="connsiteX39" fmla="*/ 702945 w 771573"/>
                <a:gd name="connsiteY39" fmla="*/ 118216 h 286109"/>
                <a:gd name="connsiteX40" fmla="*/ 697230 w 771573"/>
                <a:gd name="connsiteY40" fmla="*/ 112501 h 286109"/>
                <a:gd name="connsiteX41" fmla="*/ 691515 w 771573"/>
                <a:gd name="connsiteY41" fmla="*/ 108691 h 286109"/>
                <a:gd name="connsiteX42" fmla="*/ 676275 w 771573"/>
                <a:gd name="connsiteY42" fmla="*/ 99166 h 286109"/>
                <a:gd name="connsiteX43" fmla="*/ 664845 w 771573"/>
                <a:gd name="connsiteY43" fmla="*/ 95356 h 286109"/>
                <a:gd name="connsiteX44" fmla="*/ 655320 w 771573"/>
                <a:gd name="connsiteY44" fmla="*/ 89641 h 286109"/>
                <a:gd name="connsiteX45" fmla="*/ 626745 w 771573"/>
                <a:gd name="connsiteY45" fmla="*/ 74401 h 286109"/>
                <a:gd name="connsiteX46" fmla="*/ 621030 w 771573"/>
                <a:gd name="connsiteY46" fmla="*/ 72496 h 286109"/>
                <a:gd name="connsiteX47" fmla="*/ 598170 w 771573"/>
                <a:gd name="connsiteY47" fmla="*/ 59161 h 286109"/>
                <a:gd name="connsiteX48" fmla="*/ 592455 w 771573"/>
                <a:gd name="connsiteY48" fmla="*/ 55351 h 286109"/>
                <a:gd name="connsiteX49" fmla="*/ 584835 w 771573"/>
                <a:gd name="connsiteY49" fmla="*/ 49636 h 286109"/>
                <a:gd name="connsiteX50" fmla="*/ 573405 w 771573"/>
                <a:gd name="connsiteY50" fmla="*/ 45826 h 286109"/>
                <a:gd name="connsiteX51" fmla="*/ 567690 w 771573"/>
                <a:gd name="connsiteY51" fmla="*/ 42016 h 286109"/>
                <a:gd name="connsiteX52" fmla="*/ 556260 w 771573"/>
                <a:gd name="connsiteY52" fmla="*/ 38206 h 286109"/>
                <a:gd name="connsiteX53" fmla="*/ 548640 w 771573"/>
                <a:gd name="connsiteY53" fmla="*/ 34396 h 286109"/>
                <a:gd name="connsiteX54" fmla="*/ 537210 w 771573"/>
                <a:gd name="connsiteY54" fmla="*/ 26776 h 286109"/>
                <a:gd name="connsiteX55" fmla="*/ 472440 w 771573"/>
                <a:gd name="connsiteY55" fmla="*/ 11536 h 286109"/>
                <a:gd name="connsiteX56" fmla="*/ 409575 w 771573"/>
                <a:gd name="connsiteY56" fmla="*/ 3916 h 286109"/>
                <a:gd name="connsiteX57" fmla="*/ 360045 w 771573"/>
                <a:gd name="connsiteY57" fmla="*/ 106 h 286109"/>
                <a:gd name="connsiteX58" fmla="*/ 300990 w 771573"/>
                <a:gd name="connsiteY58" fmla="*/ 2011 h 286109"/>
                <a:gd name="connsiteX59" fmla="*/ 268605 w 771573"/>
                <a:gd name="connsiteY59" fmla="*/ 9631 h 286109"/>
                <a:gd name="connsiteX60" fmla="*/ 226695 w 771573"/>
                <a:gd name="connsiteY60" fmla="*/ 26776 h 286109"/>
                <a:gd name="connsiteX61" fmla="*/ 182880 w 771573"/>
                <a:gd name="connsiteY61" fmla="*/ 53446 h 286109"/>
                <a:gd name="connsiteX62" fmla="*/ 123825 w 771573"/>
                <a:gd name="connsiteY62" fmla="*/ 95356 h 286109"/>
                <a:gd name="connsiteX63" fmla="*/ 87630 w 771573"/>
                <a:gd name="connsiteY63" fmla="*/ 125836 h 286109"/>
                <a:gd name="connsiteX64" fmla="*/ 55245 w 771573"/>
                <a:gd name="connsiteY64" fmla="*/ 158221 h 286109"/>
                <a:gd name="connsiteX65" fmla="*/ 20955 w 771573"/>
                <a:gd name="connsiteY65" fmla="*/ 203941 h 286109"/>
                <a:gd name="connsiteX66" fmla="*/ 0 w 771573"/>
                <a:gd name="connsiteY66" fmla="*/ 251566 h 286109"/>
                <a:gd name="connsiteX0" fmla="*/ 0 w 771573"/>
                <a:gd name="connsiteY0" fmla="*/ 251566 h 286109"/>
                <a:gd name="connsiteX1" fmla="*/ 19050 w 771573"/>
                <a:gd name="connsiteY1" fmla="*/ 268711 h 286109"/>
                <a:gd name="connsiteX2" fmla="*/ 45720 w 771573"/>
                <a:gd name="connsiteY2" fmla="*/ 285856 h 286109"/>
                <a:gd name="connsiteX3" fmla="*/ 66666 w 771573"/>
                <a:gd name="connsiteY3" fmla="*/ 254401 h 286109"/>
                <a:gd name="connsiteX4" fmla="*/ 112386 w 771573"/>
                <a:gd name="connsiteY4" fmla="*/ 198946 h 286109"/>
                <a:gd name="connsiteX5" fmla="*/ 171696 w 771573"/>
                <a:gd name="connsiteY5" fmla="*/ 148902 h 286109"/>
                <a:gd name="connsiteX6" fmla="*/ 244091 w 771573"/>
                <a:gd name="connsiteY6" fmla="*/ 103696 h 286109"/>
                <a:gd name="connsiteX7" fmla="*/ 282649 w 771573"/>
                <a:gd name="connsiteY7" fmla="*/ 86656 h 286109"/>
                <a:gd name="connsiteX8" fmla="*/ 324559 w 771573"/>
                <a:gd name="connsiteY8" fmla="*/ 75485 h 286109"/>
                <a:gd name="connsiteX9" fmla="*/ 382418 w 771573"/>
                <a:gd name="connsiteY9" fmla="*/ 73940 h 286109"/>
                <a:gd name="connsiteX10" fmla="*/ 456259 w 771573"/>
                <a:gd name="connsiteY10" fmla="*/ 78263 h 286109"/>
                <a:gd name="connsiteX11" fmla="*/ 537210 w 771573"/>
                <a:gd name="connsiteY11" fmla="*/ 89641 h 286109"/>
                <a:gd name="connsiteX12" fmla="*/ 542925 w 771573"/>
                <a:gd name="connsiteY12" fmla="*/ 93451 h 286109"/>
                <a:gd name="connsiteX13" fmla="*/ 550545 w 771573"/>
                <a:gd name="connsiteY13" fmla="*/ 97261 h 286109"/>
                <a:gd name="connsiteX14" fmla="*/ 575310 w 771573"/>
                <a:gd name="connsiteY14" fmla="*/ 114406 h 286109"/>
                <a:gd name="connsiteX15" fmla="*/ 581025 w 771573"/>
                <a:gd name="connsiteY15" fmla="*/ 118216 h 286109"/>
                <a:gd name="connsiteX16" fmla="*/ 600075 w 771573"/>
                <a:gd name="connsiteY16" fmla="*/ 133456 h 286109"/>
                <a:gd name="connsiteX17" fmla="*/ 607695 w 771573"/>
                <a:gd name="connsiteY17" fmla="*/ 142981 h 286109"/>
                <a:gd name="connsiteX18" fmla="*/ 628650 w 771573"/>
                <a:gd name="connsiteY18" fmla="*/ 167746 h 286109"/>
                <a:gd name="connsiteX19" fmla="*/ 638175 w 771573"/>
                <a:gd name="connsiteY19" fmla="*/ 182986 h 286109"/>
                <a:gd name="connsiteX20" fmla="*/ 667218 w 771573"/>
                <a:gd name="connsiteY20" fmla="*/ 206465 h 286109"/>
                <a:gd name="connsiteX21" fmla="*/ 697230 w 771573"/>
                <a:gd name="connsiteY21" fmla="*/ 251566 h 286109"/>
                <a:gd name="connsiteX22" fmla="*/ 710565 w 771573"/>
                <a:gd name="connsiteY22" fmla="*/ 276331 h 286109"/>
                <a:gd name="connsiteX23" fmla="*/ 727710 w 771573"/>
                <a:gd name="connsiteY23" fmla="*/ 268711 h 286109"/>
                <a:gd name="connsiteX24" fmla="*/ 741045 w 771573"/>
                <a:gd name="connsiteY24" fmla="*/ 255376 h 286109"/>
                <a:gd name="connsiteX25" fmla="*/ 746760 w 771573"/>
                <a:gd name="connsiteY25" fmla="*/ 249661 h 286109"/>
                <a:gd name="connsiteX26" fmla="*/ 754380 w 771573"/>
                <a:gd name="connsiteY26" fmla="*/ 243946 h 286109"/>
                <a:gd name="connsiteX27" fmla="*/ 762000 w 771573"/>
                <a:gd name="connsiteY27" fmla="*/ 240136 h 286109"/>
                <a:gd name="connsiteX28" fmla="*/ 767715 w 771573"/>
                <a:gd name="connsiteY28" fmla="*/ 236326 h 286109"/>
                <a:gd name="connsiteX29" fmla="*/ 771525 w 771573"/>
                <a:gd name="connsiteY29" fmla="*/ 230611 h 286109"/>
                <a:gd name="connsiteX30" fmla="*/ 765810 w 771573"/>
                <a:gd name="connsiteY30" fmla="*/ 200131 h 286109"/>
                <a:gd name="connsiteX31" fmla="*/ 762000 w 771573"/>
                <a:gd name="connsiteY31" fmla="*/ 194416 h 286109"/>
                <a:gd name="connsiteX32" fmla="*/ 756285 w 771573"/>
                <a:gd name="connsiteY32" fmla="*/ 181081 h 286109"/>
                <a:gd name="connsiteX33" fmla="*/ 748665 w 771573"/>
                <a:gd name="connsiteY33" fmla="*/ 165841 h 286109"/>
                <a:gd name="connsiteX34" fmla="*/ 739140 w 771573"/>
                <a:gd name="connsiteY34" fmla="*/ 152506 h 286109"/>
                <a:gd name="connsiteX35" fmla="*/ 737235 w 771573"/>
                <a:gd name="connsiteY35" fmla="*/ 146791 h 286109"/>
                <a:gd name="connsiteX36" fmla="*/ 727710 w 771573"/>
                <a:gd name="connsiteY36" fmla="*/ 135361 h 286109"/>
                <a:gd name="connsiteX37" fmla="*/ 720090 w 771573"/>
                <a:gd name="connsiteY37" fmla="*/ 129646 h 286109"/>
                <a:gd name="connsiteX38" fmla="*/ 714375 w 771573"/>
                <a:gd name="connsiteY38" fmla="*/ 127741 h 286109"/>
                <a:gd name="connsiteX39" fmla="*/ 702945 w 771573"/>
                <a:gd name="connsiteY39" fmla="*/ 118216 h 286109"/>
                <a:gd name="connsiteX40" fmla="*/ 697230 w 771573"/>
                <a:gd name="connsiteY40" fmla="*/ 112501 h 286109"/>
                <a:gd name="connsiteX41" fmla="*/ 691515 w 771573"/>
                <a:gd name="connsiteY41" fmla="*/ 108691 h 286109"/>
                <a:gd name="connsiteX42" fmla="*/ 676275 w 771573"/>
                <a:gd name="connsiteY42" fmla="*/ 99166 h 286109"/>
                <a:gd name="connsiteX43" fmla="*/ 664845 w 771573"/>
                <a:gd name="connsiteY43" fmla="*/ 95356 h 286109"/>
                <a:gd name="connsiteX44" fmla="*/ 655320 w 771573"/>
                <a:gd name="connsiteY44" fmla="*/ 89641 h 286109"/>
                <a:gd name="connsiteX45" fmla="*/ 626745 w 771573"/>
                <a:gd name="connsiteY45" fmla="*/ 74401 h 286109"/>
                <a:gd name="connsiteX46" fmla="*/ 621030 w 771573"/>
                <a:gd name="connsiteY46" fmla="*/ 72496 h 286109"/>
                <a:gd name="connsiteX47" fmla="*/ 598170 w 771573"/>
                <a:gd name="connsiteY47" fmla="*/ 59161 h 286109"/>
                <a:gd name="connsiteX48" fmla="*/ 592455 w 771573"/>
                <a:gd name="connsiteY48" fmla="*/ 55351 h 286109"/>
                <a:gd name="connsiteX49" fmla="*/ 584835 w 771573"/>
                <a:gd name="connsiteY49" fmla="*/ 49636 h 286109"/>
                <a:gd name="connsiteX50" fmla="*/ 573405 w 771573"/>
                <a:gd name="connsiteY50" fmla="*/ 45826 h 286109"/>
                <a:gd name="connsiteX51" fmla="*/ 567690 w 771573"/>
                <a:gd name="connsiteY51" fmla="*/ 42016 h 286109"/>
                <a:gd name="connsiteX52" fmla="*/ 556260 w 771573"/>
                <a:gd name="connsiteY52" fmla="*/ 38206 h 286109"/>
                <a:gd name="connsiteX53" fmla="*/ 548640 w 771573"/>
                <a:gd name="connsiteY53" fmla="*/ 34396 h 286109"/>
                <a:gd name="connsiteX54" fmla="*/ 537210 w 771573"/>
                <a:gd name="connsiteY54" fmla="*/ 26776 h 286109"/>
                <a:gd name="connsiteX55" fmla="*/ 472440 w 771573"/>
                <a:gd name="connsiteY55" fmla="*/ 7006 h 286109"/>
                <a:gd name="connsiteX56" fmla="*/ 409575 w 771573"/>
                <a:gd name="connsiteY56" fmla="*/ 3916 h 286109"/>
                <a:gd name="connsiteX57" fmla="*/ 360045 w 771573"/>
                <a:gd name="connsiteY57" fmla="*/ 106 h 286109"/>
                <a:gd name="connsiteX58" fmla="*/ 300990 w 771573"/>
                <a:gd name="connsiteY58" fmla="*/ 2011 h 286109"/>
                <a:gd name="connsiteX59" fmla="*/ 268605 w 771573"/>
                <a:gd name="connsiteY59" fmla="*/ 9631 h 286109"/>
                <a:gd name="connsiteX60" fmla="*/ 226695 w 771573"/>
                <a:gd name="connsiteY60" fmla="*/ 26776 h 286109"/>
                <a:gd name="connsiteX61" fmla="*/ 182880 w 771573"/>
                <a:gd name="connsiteY61" fmla="*/ 53446 h 286109"/>
                <a:gd name="connsiteX62" fmla="*/ 123825 w 771573"/>
                <a:gd name="connsiteY62" fmla="*/ 95356 h 286109"/>
                <a:gd name="connsiteX63" fmla="*/ 87630 w 771573"/>
                <a:gd name="connsiteY63" fmla="*/ 125836 h 286109"/>
                <a:gd name="connsiteX64" fmla="*/ 55245 w 771573"/>
                <a:gd name="connsiteY64" fmla="*/ 158221 h 286109"/>
                <a:gd name="connsiteX65" fmla="*/ 20955 w 771573"/>
                <a:gd name="connsiteY65" fmla="*/ 203941 h 286109"/>
                <a:gd name="connsiteX66" fmla="*/ 0 w 771573"/>
                <a:gd name="connsiteY66" fmla="*/ 251566 h 286109"/>
                <a:gd name="connsiteX0" fmla="*/ 0 w 771573"/>
                <a:gd name="connsiteY0" fmla="*/ 253836 h 288379"/>
                <a:gd name="connsiteX1" fmla="*/ 19050 w 771573"/>
                <a:gd name="connsiteY1" fmla="*/ 270981 h 288379"/>
                <a:gd name="connsiteX2" fmla="*/ 45720 w 771573"/>
                <a:gd name="connsiteY2" fmla="*/ 288126 h 288379"/>
                <a:gd name="connsiteX3" fmla="*/ 66666 w 771573"/>
                <a:gd name="connsiteY3" fmla="*/ 256671 h 288379"/>
                <a:gd name="connsiteX4" fmla="*/ 112386 w 771573"/>
                <a:gd name="connsiteY4" fmla="*/ 201216 h 288379"/>
                <a:gd name="connsiteX5" fmla="*/ 171696 w 771573"/>
                <a:gd name="connsiteY5" fmla="*/ 151172 h 288379"/>
                <a:gd name="connsiteX6" fmla="*/ 244091 w 771573"/>
                <a:gd name="connsiteY6" fmla="*/ 105966 h 288379"/>
                <a:gd name="connsiteX7" fmla="*/ 282649 w 771573"/>
                <a:gd name="connsiteY7" fmla="*/ 88926 h 288379"/>
                <a:gd name="connsiteX8" fmla="*/ 324559 w 771573"/>
                <a:gd name="connsiteY8" fmla="*/ 77755 h 288379"/>
                <a:gd name="connsiteX9" fmla="*/ 382418 w 771573"/>
                <a:gd name="connsiteY9" fmla="*/ 76210 h 288379"/>
                <a:gd name="connsiteX10" fmla="*/ 456259 w 771573"/>
                <a:gd name="connsiteY10" fmla="*/ 80533 h 288379"/>
                <a:gd name="connsiteX11" fmla="*/ 537210 w 771573"/>
                <a:gd name="connsiteY11" fmla="*/ 91911 h 288379"/>
                <a:gd name="connsiteX12" fmla="*/ 542925 w 771573"/>
                <a:gd name="connsiteY12" fmla="*/ 95721 h 288379"/>
                <a:gd name="connsiteX13" fmla="*/ 550545 w 771573"/>
                <a:gd name="connsiteY13" fmla="*/ 99531 h 288379"/>
                <a:gd name="connsiteX14" fmla="*/ 575310 w 771573"/>
                <a:gd name="connsiteY14" fmla="*/ 116676 h 288379"/>
                <a:gd name="connsiteX15" fmla="*/ 581025 w 771573"/>
                <a:gd name="connsiteY15" fmla="*/ 120486 h 288379"/>
                <a:gd name="connsiteX16" fmla="*/ 600075 w 771573"/>
                <a:gd name="connsiteY16" fmla="*/ 135726 h 288379"/>
                <a:gd name="connsiteX17" fmla="*/ 607695 w 771573"/>
                <a:gd name="connsiteY17" fmla="*/ 145251 h 288379"/>
                <a:gd name="connsiteX18" fmla="*/ 628650 w 771573"/>
                <a:gd name="connsiteY18" fmla="*/ 170016 h 288379"/>
                <a:gd name="connsiteX19" fmla="*/ 638175 w 771573"/>
                <a:gd name="connsiteY19" fmla="*/ 185256 h 288379"/>
                <a:gd name="connsiteX20" fmla="*/ 667218 w 771573"/>
                <a:gd name="connsiteY20" fmla="*/ 208735 h 288379"/>
                <a:gd name="connsiteX21" fmla="*/ 697230 w 771573"/>
                <a:gd name="connsiteY21" fmla="*/ 253836 h 288379"/>
                <a:gd name="connsiteX22" fmla="*/ 710565 w 771573"/>
                <a:gd name="connsiteY22" fmla="*/ 278601 h 288379"/>
                <a:gd name="connsiteX23" fmla="*/ 727710 w 771573"/>
                <a:gd name="connsiteY23" fmla="*/ 270981 h 288379"/>
                <a:gd name="connsiteX24" fmla="*/ 741045 w 771573"/>
                <a:gd name="connsiteY24" fmla="*/ 257646 h 288379"/>
                <a:gd name="connsiteX25" fmla="*/ 746760 w 771573"/>
                <a:gd name="connsiteY25" fmla="*/ 251931 h 288379"/>
                <a:gd name="connsiteX26" fmla="*/ 754380 w 771573"/>
                <a:gd name="connsiteY26" fmla="*/ 246216 h 288379"/>
                <a:gd name="connsiteX27" fmla="*/ 762000 w 771573"/>
                <a:gd name="connsiteY27" fmla="*/ 242406 h 288379"/>
                <a:gd name="connsiteX28" fmla="*/ 767715 w 771573"/>
                <a:gd name="connsiteY28" fmla="*/ 238596 h 288379"/>
                <a:gd name="connsiteX29" fmla="*/ 771525 w 771573"/>
                <a:gd name="connsiteY29" fmla="*/ 232881 h 288379"/>
                <a:gd name="connsiteX30" fmla="*/ 765810 w 771573"/>
                <a:gd name="connsiteY30" fmla="*/ 202401 h 288379"/>
                <a:gd name="connsiteX31" fmla="*/ 762000 w 771573"/>
                <a:gd name="connsiteY31" fmla="*/ 196686 h 288379"/>
                <a:gd name="connsiteX32" fmla="*/ 756285 w 771573"/>
                <a:gd name="connsiteY32" fmla="*/ 183351 h 288379"/>
                <a:gd name="connsiteX33" fmla="*/ 748665 w 771573"/>
                <a:gd name="connsiteY33" fmla="*/ 168111 h 288379"/>
                <a:gd name="connsiteX34" fmla="*/ 739140 w 771573"/>
                <a:gd name="connsiteY34" fmla="*/ 154776 h 288379"/>
                <a:gd name="connsiteX35" fmla="*/ 737235 w 771573"/>
                <a:gd name="connsiteY35" fmla="*/ 149061 h 288379"/>
                <a:gd name="connsiteX36" fmla="*/ 727710 w 771573"/>
                <a:gd name="connsiteY36" fmla="*/ 137631 h 288379"/>
                <a:gd name="connsiteX37" fmla="*/ 720090 w 771573"/>
                <a:gd name="connsiteY37" fmla="*/ 131916 h 288379"/>
                <a:gd name="connsiteX38" fmla="*/ 714375 w 771573"/>
                <a:gd name="connsiteY38" fmla="*/ 130011 h 288379"/>
                <a:gd name="connsiteX39" fmla="*/ 702945 w 771573"/>
                <a:gd name="connsiteY39" fmla="*/ 120486 h 288379"/>
                <a:gd name="connsiteX40" fmla="*/ 697230 w 771573"/>
                <a:gd name="connsiteY40" fmla="*/ 114771 h 288379"/>
                <a:gd name="connsiteX41" fmla="*/ 691515 w 771573"/>
                <a:gd name="connsiteY41" fmla="*/ 110961 h 288379"/>
                <a:gd name="connsiteX42" fmla="*/ 676275 w 771573"/>
                <a:gd name="connsiteY42" fmla="*/ 101436 h 288379"/>
                <a:gd name="connsiteX43" fmla="*/ 664845 w 771573"/>
                <a:gd name="connsiteY43" fmla="*/ 97626 h 288379"/>
                <a:gd name="connsiteX44" fmla="*/ 655320 w 771573"/>
                <a:gd name="connsiteY44" fmla="*/ 91911 h 288379"/>
                <a:gd name="connsiteX45" fmla="*/ 626745 w 771573"/>
                <a:gd name="connsiteY45" fmla="*/ 76671 h 288379"/>
                <a:gd name="connsiteX46" fmla="*/ 621030 w 771573"/>
                <a:gd name="connsiteY46" fmla="*/ 74766 h 288379"/>
                <a:gd name="connsiteX47" fmla="*/ 598170 w 771573"/>
                <a:gd name="connsiteY47" fmla="*/ 61431 h 288379"/>
                <a:gd name="connsiteX48" fmla="*/ 592455 w 771573"/>
                <a:gd name="connsiteY48" fmla="*/ 57621 h 288379"/>
                <a:gd name="connsiteX49" fmla="*/ 584835 w 771573"/>
                <a:gd name="connsiteY49" fmla="*/ 51906 h 288379"/>
                <a:gd name="connsiteX50" fmla="*/ 573405 w 771573"/>
                <a:gd name="connsiteY50" fmla="*/ 48096 h 288379"/>
                <a:gd name="connsiteX51" fmla="*/ 567690 w 771573"/>
                <a:gd name="connsiteY51" fmla="*/ 44286 h 288379"/>
                <a:gd name="connsiteX52" fmla="*/ 556260 w 771573"/>
                <a:gd name="connsiteY52" fmla="*/ 40476 h 288379"/>
                <a:gd name="connsiteX53" fmla="*/ 548640 w 771573"/>
                <a:gd name="connsiteY53" fmla="*/ 36666 h 288379"/>
                <a:gd name="connsiteX54" fmla="*/ 537210 w 771573"/>
                <a:gd name="connsiteY54" fmla="*/ 29046 h 288379"/>
                <a:gd name="connsiteX55" fmla="*/ 472440 w 771573"/>
                <a:gd name="connsiteY55" fmla="*/ 9276 h 288379"/>
                <a:gd name="connsiteX56" fmla="*/ 412430 w 771573"/>
                <a:gd name="connsiteY56" fmla="*/ 2222 h 288379"/>
                <a:gd name="connsiteX57" fmla="*/ 360045 w 771573"/>
                <a:gd name="connsiteY57" fmla="*/ 2376 h 288379"/>
                <a:gd name="connsiteX58" fmla="*/ 300990 w 771573"/>
                <a:gd name="connsiteY58" fmla="*/ 4281 h 288379"/>
                <a:gd name="connsiteX59" fmla="*/ 268605 w 771573"/>
                <a:gd name="connsiteY59" fmla="*/ 11901 h 288379"/>
                <a:gd name="connsiteX60" fmla="*/ 226695 w 771573"/>
                <a:gd name="connsiteY60" fmla="*/ 29046 h 288379"/>
                <a:gd name="connsiteX61" fmla="*/ 182880 w 771573"/>
                <a:gd name="connsiteY61" fmla="*/ 55716 h 288379"/>
                <a:gd name="connsiteX62" fmla="*/ 123825 w 771573"/>
                <a:gd name="connsiteY62" fmla="*/ 97626 h 288379"/>
                <a:gd name="connsiteX63" fmla="*/ 87630 w 771573"/>
                <a:gd name="connsiteY63" fmla="*/ 128106 h 288379"/>
                <a:gd name="connsiteX64" fmla="*/ 55245 w 771573"/>
                <a:gd name="connsiteY64" fmla="*/ 160491 h 288379"/>
                <a:gd name="connsiteX65" fmla="*/ 20955 w 771573"/>
                <a:gd name="connsiteY65" fmla="*/ 206211 h 288379"/>
                <a:gd name="connsiteX66" fmla="*/ 0 w 771573"/>
                <a:gd name="connsiteY66" fmla="*/ 253836 h 288379"/>
                <a:gd name="connsiteX0" fmla="*/ 0 w 771573"/>
                <a:gd name="connsiteY0" fmla="*/ 251614 h 286157"/>
                <a:gd name="connsiteX1" fmla="*/ 19050 w 771573"/>
                <a:gd name="connsiteY1" fmla="*/ 268759 h 286157"/>
                <a:gd name="connsiteX2" fmla="*/ 45720 w 771573"/>
                <a:gd name="connsiteY2" fmla="*/ 285904 h 286157"/>
                <a:gd name="connsiteX3" fmla="*/ 66666 w 771573"/>
                <a:gd name="connsiteY3" fmla="*/ 254449 h 286157"/>
                <a:gd name="connsiteX4" fmla="*/ 112386 w 771573"/>
                <a:gd name="connsiteY4" fmla="*/ 198994 h 286157"/>
                <a:gd name="connsiteX5" fmla="*/ 171696 w 771573"/>
                <a:gd name="connsiteY5" fmla="*/ 148950 h 286157"/>
                <a:gd name="connsiteX6" fmla="*/ 244091 w 771573"/>
                <a:gd name="connsiteY6" fmla="*/ 103744 h 286157"/>
                <a:gd name="connsiteX7" fmla="*/ 282649 w 771573"/>
                <a:gd name="connsiteY7" fmla="*/ 86704 h 286157"/>
                <a:gd name="connsiteX8" fmla="*/ 324559 w 771573"/>
                <a:gd name="connsiteY8" fmla="*/ 75533 h 286157"/>
                <a:gd name="connsiteX9" fmla="*/ 382418 w 771573"/>
                <a:gd name="connsiteY9" fmla="*/ 73988 h 286157"/>
                <a:gd name="connsiteX10" fmla="*/ 456259 w 771573"/>
                <a:gd name="connsiteY10" fmla="*/ 78311 h 286157"/>
                <a:gd name="connsiteX11" fmla="*/ 537210 w 771573"/>
                <a:gd name="connsiteY11" fmla="*/ 89689 h 286157"/>
                <a:gd name="connsiteX12" fmla="*/ 542925 w 771573"/>
                <a:gd name="connsiteY12" fmla="*/ 93499 h 286157"/>
                <a:gd name="connsiteX13" fmla="*/ 550545 w 771573"/>
                <a:gd name="connsiteY13" fmla="*/ 97309 h 286157"/>
                <a:gd name="connsiteX14" fmla="*/ 575310 w 771573"/>
                <a:gd name="connsiteY14" fmla="*/ 114454 h 286157"/>
                <a:gd name="connsiteX15" fmla="*/ 581025 w 771573"/>
                <a:gd name="connsiteY15" fmla="*/ 118264 h 286157"/>
                <a:gd name="connsiteX16" fmla="*/ 600075 w 771573"/>
                <a:gd name="connsiteY16" fmla="*/ 133504 h 286157"/>
                <a:gd name="connsiteX17" fmla="*/ 607695 w 771573"/>
                <a:gd name="connsiteY17" fmla="*/ 143029 h 286157"/>
                <a:gd name="connsiteX18" fmla="*/ 628650 w 771573"/>
                <a:gd name="connsiteY18" fmla="*/ 167794 h 286157"/>
                <a:gd name="connsiteX19" fmla="*/ 638175 w 771573"/>
                <a:gd name="connsiteY19" fmla="*/ 183034 h 286157"/>
                <a:gd name="connsiteX20" fmla="*/ 667218 w 771573"/>
                <a:gd name="connsiteY20" fmla="*/ 206513 h 286157"/>
                <a:gd name="connsiteX21" fmla="*/ 697230 w 771573"/>
                <a:gd name="connsiteY21" fmla="*/ 251614 h 286157"/>
                <a:gd name="connsiteX22" fmla="*/ 710565 w 771573"/>
                <a:gd name="connsiteY22" fmla="*/ 276379 h 286157"/>
                <a:gd name="connsiteX23" fmla="*/ 727710 w 771573"/>
                <a:gd name="connsiteY23" fmla="*/ 268759 h 286157"/>
                <a:gd name="connsiteX24" fmla="*/ 741045 w 771573"/>
                <a:gd name="connsiteY24" fmla="*/ 255424 h 286157"/>
                <a:gd name="connsiteX25" fmla="*/ 746760 w 771573"/>
                <a:gd name="connsiteY25" fmla="*/ 249709 h 286157"/>
                <a:gd name="connsiteX26" fmla="*/ 754380 w 771573"/>
                <a:gd name="connsiteY26" fmla="*/ 243994 h 286157"/>
                <a:gd name="connsiteX27" fmla="*/ 762000 w 771573"/>
                <a:gd name="connsiteY27" fmla="*/ 240184 h 286157"/>
                <a:gd name="connsiteX28" fmla="*/ 767715 w 771573"/>
                <a:gd name="connsiteY28" fmla="*/ 236374 h 286157"/>
                <a:gd name="connsiteX29" fmla="*/ 771525 w 771573"/>
                <a:gd name="connsiteY29" fmla="*/ 230659 h 286157"/>
                <a:gd name="connsiteX30" fmla="*/ 765810 w 771573"/>
                <a:gd name="connsiteY30" fmla="*/ 200179 h 286157"/>
                <a:gd name="connsiteX31" fmla="*/ 762000 w 771573"/>
                <a:gd name="connsiteY31" fmla="*/ 194464 h 286157"/>
                <a:gd name="connsiteX32" fmla="*/ 756285 w 771573"/>
                <a:gd name="connsiteY32" fmla="*/ 181129 h 286157"/>
                <a:gd name="connsiteX33" fmla="*/ 748665 w 771573"/>
                <a:gd name="connsiteY33" fmla="*/ 165889 h 286157"/>
                <a:gd name="connsiteX34" fmla="*/ 739140 w 771573"/>
                <a:gd name="connsiteY34" fmla="*/ 152554 h 286157"/>
                <a:gd name="connsiteX35" fmla="*/ 737235 w 771573"/>
                <a:gd name="connsiteY35" fmla="*/ 146839 h 286157"/>
                <a:gd name="connsiteX36" fmla="*/ 727710 w 771573"/>
                <a:gd name="connsiteY36" fmla="*/ 135409 h 286157"/>
                <a:gd name="connsiteX37" fmla="*/ 720090 w 771573"/>
                <a:gd name="connsiteY37" fmla="*/ 129694 h 286157"/>
                <a:gd name="connsiteX38" fmla="*/ 714375 w 771573"/>
                <a:gd name="connsiteY38" fmla="*/ 127789 h 286157"/>
                <a:gd name="connsiteX39" fmla="*/ 702945 w 771573"/>
                <a:gd name="connsiteY39" fmla="*/ 118264 h 286157"/>
                <a:gd name="connsiteX40" fmla="*/ 697230 w 771573"/>
                <a:gd name="connsiteY40" fmla="*/ 112549 h 286157"/>
                <a:gd name="connsiteX41" fmla="*/ 691515 w 771573"/>
                <a:gd name="connsiteY41" fmla="*/ 108739 h 286157"/>
                <a:gd name="connsiteX42" fmla="*/ 676275 w 771573"/>
                <a:gd name="connsiteY42" fmla="*/ 99214 h 286157"/>
                <a:gd name="connsiteX43" fmla="*/ 664845 w 771573"/>
                <a:gd name="connsiteY43" fmla="*/ 95404 h 286157"/>
                <a:gd name="connsiteX44" fmla="*/ 655320 w 771573"/>
                <a:gd name="connsiteY44" fmla="*/ 89689 h 286157"/>
                <a:gd name="connsiteX45" fmla="*/ 626745 w 771573"/>
                <a:gd name="connsiteY45" fmla="*/ 74449 h 286157"/>
                <a:gd name="connsiteX46" fmla="*/ 621030 w 771573"/>
                <a:gd name="connsiteY46" fmla="*/ 72544 h 286157"/>
                <a:gd name="connsiteX47" fmla="*/ 598170 w 771573"/>
                <a:gd name="connsiteY47" fmla="*/ 59209 h 286157"/>
                <a:gd name="connsiteX48" fmla="*/ 592455 w 771573"/>
                <a:gd name="connsiteY48" fmla="*/ 55399 h 286157"/>
                <a:gd name="connsiteX49" fmla="*/ 584835 w 771573"/>
                <a:gd name="connsiteY49" fmla="*/ 49684 h 286157"/>
                <a:gd name="connsiteX50" fmla="*/ 573405 w 771573"/>
                <a:gd name="connsiteY50" fmla="*/ 45874 h 286157"/>
                <a:gd name="connsiteX51" fmla="*/ 567690 w 771573"/>
                <a:gd name="connsiteY51" fmla="*/ 42064 h 286157"/>
                <a:gd name="connsiteX52" fmla="*/ 556260 w 771573"/>
                <a:gd name="connsiteY52" fmla="*/ 38254 h 286157"/>
                <a:gd name="connsiteX53" fmla="*/ 548640 w 771573"/>
                <a:gd name="connsiteY53" fmla="*/ 34444 h 286157"/>
                <a:gd name="connsiteX54" fmla="*/ 537210 w 771573"/>
                <a:gd name="connsiteY54" fmla="*/ 26824 h 286157"/>
                <a:gd name="connsiteX55" fmla="*/ 472440 w 771573"/>
                <a:gd name="connsiteY55" fmla="*/ 7054 h 286157"/>
                <a:gd name="connsiteX56" fmla="*/ 412430 w 771573"/>
                <a:gd name="connsiteY56" fmla="*/ 0 h 286157"/>
                <a:gd name="connsiteX57" fmla="*/ 360045 w 771573"/>
                <a:gd name="connsiteY57" fmla="*/ 154 h 286157"/>
                <a:gd name="connsiteX58" fmla="*/ 300990 w 771573"/>
                <a:gd name="connsiteY58" fmla="*/ 2059 h 286157"/>
                <a:gd name="connsiteX59" fmla="*/ 268605 w 771573"/>
                <a:gd name="connsiteY59" fmla="*/ 9679 h 286157"/>
                <a:gd name="connsiteX60" fmla="*/ 226695 w 771573"/>
                <a:gd name="connsiteY60" fmla="*/ 26824 h 286157"/>
                <a:gd name="connsiteX61" fmla="*/ 182880 w 771573"/>
                <a:gd name="connsiteY61" fmla="*/ 53494 h 286157"/>
                <a:gd name="connsiteX62" fmla="*/ 123825 w 771573"/>
                <a:gd name="connsiteY62" fmla="*/ 95404 h 286157"/>
                <a:gd name="connsiteX63" fmla="*/ 87630 w 771573"/>
                <a:gd name="connsiteY63" fmla="*/ 125884 h 286157"/>
                <a:gd name="connsiteX64" fmla="*/ 55245 w 771573"/>
                <a:gd name="connsiteY64" fmla="*/ 158269 h 286157"/>
                <a:gd name="connsiteX65" fmla="*/ 20955 w 771573"/>
                <a:gd name="connsiteY65" fmla="*/ 203989 h 286157"/>
                <a:gd name="connsiteX66" fmla="*/ 0 w 771573"/>
                <a:gd name="connsiteY66" fmla="*/ 251614 h 286157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7210 w 771573"/>
                <a:gd name="connsiteY11" fmla="*/ 91800 h 288268"/>
                <a:gd name="connsiteX12" fmla="*/ 542925 w 771573"/>
                <a:gd name="connsiteY12" fmla="*/ 95610 h 288268"/>
                <a:gd name="connsiteX13" fmla="*/ 550545 w 771573"/>
                <a:gd name="connsiteY13" fmla="*/ 99420 h 288268"/>
                <a:gd name="connsiteX14" fmla="*/ 575310 w 771573"/>
                <a:gd name="connsiteY14" fmla="*/ 116565 h 288268"/>
                <a:gd name="connsiteX15" fmla="*/ 581025 w 771573"/>
                <a:gd name="connsiteY15" fmla="*/ 120375 h 288268"/>
                <a:gd name="connsiteX16" fmla="*/ 600075 w 771573"/>
                <a:gd name="connsiteY16" fmla="*/ 135615 h 288268"/>
                <a:gd name="connsiteX17" fmla="*/ 607695 w 771573"/>
                <a:gd name="connsiteY17" fmla="*/ 145140 h 288268"/>
                <a:gd name="connsiteX18" fmla="*/ 628650 w 771573"/>
                <a:gd name="connsiteY18" fmla="*/ 169905 h 288268"/>
                <a:gd name="connsiteX19" fmla="*/ 638175 w 771573"/>
                <a:gd name="connsiteY19" fmla="*/ 185145 h 288268"/>
                <a:gd name="connsiteX20" fmla="*/ 667218 w 771573"/>
                <a:gd name="connsiteY20" fmla="*/ 208624 h 288268"/>
                <a:gd name="connsiteX21" fmla="*/ 697230 w 771573"/>
                <a:gd name="connsiteY21" fmla="*/ 253725 h 288268"/>
                <a:gd name="connsiteX22" fmla="*/ 710565 w 771573"/>
                <a:gd name="connsiteY22" fmla="*/ 278490 h 288268"/>
                <a:gd name="connsiteX23" fmla="*/ 727710 w 771573"/>
                <a:gd name="connsiteY23" fmla="*/ 270870 h 288268"/>
                <a:gd name="connsiteX24" fmla="*/ 741045 w 771573"/>
                <a:gd name="connsiteY24" fmla="*/ 257535 h 288268"/>
                <a:gd name="connsiteX25" fmla="*/ 746760 w 771573"/>
                <a:gd name="connsiteY25" fmla="*/ 251820 h 288268"/>
                <a:gd name="connsiteX26" fmla="*/ 754380 w 771573"/>
                <a:gd name="connsiteY26" fmla="*/ 246105 h 288268"/>
                <a:gd name="connsiteX27" fmla="*/ 762000 w 771573"/>
                <a:gd name="connsiteY27" fmla="*/ 242295 h 288268"/>
                <a:gd name="connsiteX28" fmla="*/ 767715 w 771573"/>
                <a:gd name="connsiteY28" fmla="*/ 238485 h 288268"/>
                <a:gd name="connsiteX29" fmla="*/ 771525 w 771573"/>
                <a:gd name="connsiteY29" fmla="*/ 232770 h 288268"/>
                <a:gd name="connsiteX30" fmla="*/ 765810 w 771573"/>
                <a:gd name="connsiteY30" fmla="*/ 202290 h 288268"/>
                <a:gd name="connsiteX31" fmla="*/ 762000 w 771573"/>
                <a:gd name="connsiteY31" fmla="*/ 196575 h 288268"/>
                <a:gd name="connsiteX32" fmla="*/ 756285 w 771573"/>
                <a:gd name="connsiteY32" fmla="*/ 183240 h 288268"/>
                <a:gd name="connsiteX33" fmla="*/ 748665 w 771573"/>
                <a:gd name="connsiteY33" fmla="*/ 168000 h 288268"/>
                <a:gd name="connsiteX34" fmla="*/ 739140 w 771573"/>
                <a:gd name="connsiteY34" fmla="*/ 154665 h 288268"/>
                <a:gd name="connsiteX35" fmla="*/ 737235 w 771573"/>
                <a:gd name="connsiteY35" fmla="*/ 148950 h 288268"/>
                <a:gd name="connsiteX36" fmla="*/ 727710 w 771573"/>
                <a:gd name="connsiteY36" fmla="*/ 137520 h 288268"/>
                <a:gd name="connsiteX37" fmla="*/ 720090 w 771573"/>
                <a:gd name="connsiteY37" fmla="*/ 131805 h 288268"/>
                <a:gd name="connsiteX38" fmla="*/ 714375 w 771573"/>
                <a:gd name="connsiteY38" fmla="*/ 129900 h 288268"/>
                <a:gd name="connsiteX39" fmla="*/ 702945 w 771573"/>
                <a:gd name="connsiteY39" fmla="*/ 120375 h 288268"/>
                <a:gd name="connsiteX40" fmla="*/ 697230 w 771573"/>
                <a:gd name="connsiteY40" fmla="*/ 114660 h 288268"/>
                <a:gd name="connsiteX41" fmla="*/ 691515 w 771573"/>
                <a:gd name="connsiteY41" fmla="*/ 110850 h 288268"/>
                <a:gd name="connsiteX42" fmla="*/ 676275 w 771573"/>
                <a:gd name="connsiteY42" fmla="*/ 101325 h 288268"/>
                <a:gd name="connsiteX43" fmla="*/ 664845 w 771573"/>
                <a:gd name="connsiteY43" fmla="*/ 97515 h 288268"/>
                <a:gd name="connsiteX44" fmla="*/ 655320 w 771573"/>
                <a:gd name="connsiteY44" fmla="*/ 91800 h 288268"/>
                <a:gd name="connsiteX45" fmla="*/ 626745 w 771573"/>
                <a:gd name="connsiteY45" fmla="*/ 76560 h 288268"/>
                <a:gd name="connsiteX46" fmla="*/ 621030 w 771573"/>
                <a:gd name="connsiteY46" fmla="*/ 74655 h 288268"/>
                <a:gd name="connsiteX47" fmla="*/ 598170 w 771573"/>
                <a:gd name="connsiteY47" fmla="*/ 61320 h 288268"/>
                <a:gd name="connsiteX48" fmla="*/ 592455 w 771573"/>
                <a:gd name="connsiteY48" fmla="*/ 57510 h 288268"/>
                <a:gd name="connsiteX49" fmla="*/ 584835 w 771573"/>
                <a:gd name="connsiteY49" fmla="*/ 51795 h 288268"/>
                <a:gd name="connsiteX50" fmla="*/ 573405 w 771573"/>
                <a:gd name="connsiteY50" fmla="*/ 47985 h 288268"/>
                <a:gd name="connsiteX51" fmla="*/ 567690 w 771573"/>
                <a:gd name="connsiteY51" fmla="*/ 44175 h 288268"/>
                <a:gd name="connsiteX52" fmla="*/ 556260 w 771573"/>
                <a:gd name="connsiteY52" fmla="*/ 40365 h 288268"/>
                <a:gd name="connsiteX53" fmla="*/ 548640 w 771573"/>
                <a:gd name="connsiteY53" fmla="*/ 36555 h 288268"/>
                <a:gd name="connsiteX54" fmla="*/ 537210 w 771573"/>
                <a:gd name="connsiteY54" fmla="*/ 28935 h 288268"/>
                <a:gd name="connsiteX55" fmla="*/ 472440 w 771573"/>
                <a:gd name="connsiteY55" fmla="*/ 9165 h 288268"/>
                <a:gd name="connsiteX56" fmla="*/ 412430 w 771573"/>
                <a:gd name="connsiteY56" fmla="*/ 2111 h 288268"/>
                <a:gd name="connsiteX57" fmla="*/ 350052 w 771573"/>
                <a:gd name="connsiteY57" fmla="*/ 0 h 288268"/>
                <a:gd name="connsiteX58" fmla="*/ 300990 w 771573"/>
                <a:gd name="connsiteY58" fmla="*/ 4170 h 288268"/>
                <a:gd name="connsiteX59" fmla="*/ 268605 w 771573"/>
                <a:gd name="connsiteY59" fmla="*/ 11790 h 288268"/>
                <a:gd name="connsiteX60" fmla="*/ 226695 w 771573"/>
                <a:gd name="connsiteY60" fmla="*/ 28935 h 288268"/>
                <a:gd name="connsiteX61" fmla="*/ 182880 w 771573"/>
                <a:gd name="connsiteY61" fmla="*/ 55605 h 288268"/>
                <a:gd name="connsiteX62" fmla="*/ 123825 w 771573"/>
                <a:gd name="connsiteY62" fmla="*/ 97515 h 288268"/>
                <a:gd name="connsiteX63" fmla="*/ 87630 w 771573"/>
                <a:gd name="connsiteY63" fmla="*/ 127995 h 288268"/>
                <a:gd name="connsiteX64" fmla="*/ 55245 w 771573"/>
                <a:gd name="connsiteY64" fmla="*/ 160380 h 288268"/>
                <a:gd name="connsiteX65" fmla="*/ 20955 w 771573"/>
                <a:gd name="connsiteY65" fmla="*/ 206100 h 288268"/>
                <a:gd name="connsiteX66" fmla="*/ 0 w 771573"/>
                <a:gd name="connsiteY66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7210 w 771573"/>
                <a:gd name="connsiteY11" fmla="*/ 91800 h 288268"/>
                <a:gd name="connsiteX12" fmla="*/ 542925 w 771573"/>
                <a:gd name="connsiteY12" fmla="*/ 95610 h 288268"/>
                <a:gd name="connsiteX13" fmla="*/ 550545 w 771573"/>
                <a:gd name="connsiteY13" fmla="*/ 99420 h 288268"/>
                <a:gd name="connsiteX14" fmla="*/ 575310 w 771573"/>
                <a:gd name="connsiteY14" fmla="*/ 116565 h 288268"/>
                <a:gd name="connsiteX15" fmla="*/ 581025 w 771573"/>
                <a:gd name="connsiteY15" fmla="*/ 120375 h 288268"/>
                <a:gd name="connsiteX16" fmla="*/ 600075 w 771573"/>
                <a:gd name="connsiteY16" fmla="*/ 135615 h 288268"/>
                <a:gd name="connsiteX17" fmla="*/ 607695 w 771573"/>
                <a:gd name="connsiteY17" fmla="*/ 145140 h 288268"/>
                <a:gd name="connsiteX18" fmla="*/ 628650 w 771573"/>
                <a:gd name="connsiteY18" fmla="*/ 169905 h 288268"/>
                <a:gd name="connsiteX19" fmla="*/ 638175 w 771573"/>
                <a:gd name="connsiteY19" fmla="*/ 185145 h 288268"/>
                <a:gd name="connsiteX20" fmla="*/ 667218 w 771573"/>
                <a:gd name="connsiteY20" fmla="*/ 208624 h 288268"/>
                <a:gd name="connsiteX21" fmla="*/ 697230 w 771573"/>
                <a:gd name="connsiteY21" fmla="*/ 253725 h 288268"/>
                <a:gd name="connsiteX22" fmla="*/ 710565 w 771573"/>
                <a:gd name="connsiteY22" fmla="*/ 278490 h 288268"/>
                <a:gd name="connsiteX23" fmla="*/ 727710 w 771573"/>
                <a:gd name="connsiteY23" fmla="*/ 270870 h 288268"/>
                <a:gd name="connsiteX24" fmla="*/ 741045 w 771573"/>
                <a:gd name="connsiteY24" fmla="*/ 257535 h 288268"/>
                <a:gd name="connsiteX25" fmla="*/ 746760 w 771573"/>
                <a:gd name="connsiteY25" fmla="*/ 251820 h 288268"/>
                <a:gd name="connsiteX26" fmla="*/ 754380 w 771573"/>
                <a:gd name="connsiteY26" fmla="*/ 246105 h 288268"/>
                <a:gd name="connsiteX27" fmla="*/ 762000 w 771573"/>
                <a:gd name="connsiteY27" fmla="*/ 242295 h 288268"/>
                <a:gd name="connsiteX28" fmla="*/ 767715 w 771573"/>
                <a:gd name="connsiteY28" fmla="*/ 238485 h 288268"/>
                <a:gd name="connsiteX29" fmla="*/ 771525 w 771573"/>
                <a:gd name="connsiteY29" fmla="*/ 232770 h 288268"/>
                <a:gd name="connsiteX30" fmla="*/ 765810 w 771573"/>
                <a:gd name="connsiteY30" fmla="*/ 202290 h 288268"/>
                <a:gd name="connsiteX31" fmla="*/ 762000 w 771573"/>
                <a:gd name="connsiteY31" fmla="*/ 196575 h 288268"/>
                <a:gd name="connsiteX32" fmla="*/ 756285 w 771573"/>
                <a:gd name="connsiteY32" fmla="*/ 183240 h 288268"/>
                <a:gd name="connsiteX33" fmla="*/ 748665 w 771573"/>
                <a:gd name="connsiteY33" fmla="*/ 168000 h 288268"/>
                <a:gd name="connsiteX34" fmla="*/ 739140 w 771573"/>
                <a:gd name="connsiteY34" fmla="*/ 154665 h 288268"/>
                <a:gd name="connsiteX35" fmla="*/ 737235 w 771573"/>
                <a:gd name="connsiteY35" fmla="*/ 148950 h 288268"/>
                <a:gd name="connsiteX36" fmla="*/ 727710 w 771573"/>
                <a:gd name="connsiteY36" fmla="*/ 137520 h 288268"/>
                <a:gd name="connsiteX37" fmla="*/ 720090 w 771573"/>
                <a:gd name="connsiteY37" fmla="*/ 131805 h 288268"/>
                <a:gd name="connsiteX38" fmla="*/ 714375 w 771573"/>
                <a:gd name="connsiteY38" fmla="*/ 129900 h 288268"/>
                <a:gd name="connsiteX39" fmla="*/ 702945 w 771573"/>
                <a:gd name="connsiteY39" fmla="*/ 120375 h 288268"/>
                <a:gd name="connsiteX40" fmla="*/ 697230 w 771573"/>
                <a:gd name="connsiteY40" fmla="*/ 114660 h 288268"/>
                <a:gd name="connsiteX41" fmla="*/ 691515 w 771573"/>
                <a:gd name="connsiteY41" fmla="*/ 110850 h 288268"/>
                <a:gd name="connsiteX42" fmla="*/ 676275 w 771573"/>
                <a:gd name="connsiteY42" fmla="*/ 101325 h 288268"/>
                <a:gd name="connsiteX43" fmla="*/ 664845 w 771573"/>
                <a:gd name="connsiteY43" fmla="*/ 97515 h 288268"/>
                <a:gd name="connsiteX44" fmla="*/ 655320 w 771573"/>
                <a:gd name="connsiteY44" fmla="*/ 91800 h 288268"/>
                <a:gd name="connsiteX45" fmla="*/ 626745 w 771573"/>
                <a:gd name="connsiteY45" fmla="*/ 76560 h 288268"/>
                <a:gd name="connsiteX46" fmla="*/ 621030 w 771573"/>
                <a:gd name="connsiteY46" fmla="*/ 74655 h 288268"/>
                <a:gd name="connsiteX47" fmla="*/ 598170 w 771573"/>
                <a:gd name="connsiteY47" fmla="*/ 61320 h 288268"/>
                <a:gd name="connsiteX48" fmla="*/ 592455 w 771573"/>
                <a:gd name="connsiteY48" fmla="*/ 57510 h 288268"/>
                <a:gd name="connsiteX49" fmla="*/ 584835 w 771573"/>
                <a:gd name="connsiteY49" fmla="*/ 51795 h 288268"/>
                <a:gd name="connsiteX50" fmla="*/ 567690 w 771573"/>
                <a:gd name="connsiteY50" fmla="*/ 44175 h 288268"/>
                <a:gd name="connsiteX51" fmla="*/ 556260 w 771573"/>
                <a:gd name="connsiteY51" fmla="*/ 40365 h 288268"/>
                <a:gd name="connsiteX52" fmla="*/ 548640 w 771573"/>
                <a:gd name="connsiteY52" fmla="*/ 36555 h 288268"/>
                <a:gd name="connsiteX53" fmla="*/ 537210 w 771573"/>
                <a:gd name="connsiteY53" fmla="*/ 28935 h 288268"/>
                <a:gd name="connsiteX54" fmla="*/ 472440 w 771573"/>
                <a:gd name="connsiteY54" fmla="*/ 9165 h 288268"/>
                <a:gd name="connsiteX55" fmla="*/ 412430 w 771573"/>
                <a:gd name="connsiteY55" fmla="*/ 2111 h 288268"/>
                <a:gd name="connsiteX56" fmla="*/ 350052 w 771573"/>
                <a:gd name="connsiteY56" fmla="*/ 0 h 288268"/>
                <a:gd name="connsiteX57" fmla="*/ 300990 w 771573"/>
                <a:gd name="connsiteY57" fmla="*/ 4170 h 288268"/>
                <a:gd name="connsiteX58" fmla="*/ 268605 w 771573"/>
                <a:gd name="connsiteY58" fmla="*/ 11790 h 288268"/>
                <a:gd name="connsiteX59" fmla="*/ 226695 w 771573"/>
                <a:gd name="connsiteY59" fmla="*/ 28935 h 288268"/>
                <a:gd name="connsiteX60" fmla="*/ 182880 w 771573"/>
                <a:gd name="connsiteY60" fmla="*/ 55605 h 288268"/>
                <a:gd name="connsiteX61" fmla="*/ 123825 w 771573"/>
                <a:gd name="connsiteY61" fmla="*/ 97515 h 288268"/>
                <a:gd name="connsiteX62" fmla="*/ 87630 w 771573"/>
                <a:gd name="connsiteY62" fmla="*/ 127995 h 288268"/>
                <a:gd name="connsiteX63" fmla="*/ 55245 w 771573"/>
                <a:gd name="connsiteY63" fmla="*/ 160380 h 288268"/>
                <a:gd name="connsiteX64" fmla="*/ 20955 w 771573"/>
                <a:gd name="connsiteY64" fmla="*/ 206100 h 288268"/>
                <a:gd name="connsiteX65" fmla="*/ 0 w 771573"/>
                <a:gd name="connsiteY65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42925 w 771573"/>
                <a:gd name="connsiteY12" fmla="*/ 95610 h 288268"/>
                <a:gd name="connsiteX13" fmla="*/ 550545 w 771573"/>
                <a:gd name="connsiteY13" fmla="*/ 99420 h 288268"/>
                <a:gd name="connsiteX14" fmla="*/ 575310 w 771573"/>
                <a:gd name="connsiteY14" fmla="*/ 116565 h 288268"/>
                <a:gd name="connsiteX15" fmla="*/ 581025 w 771573"/>
                <a:gd name="connsiteY15" fmla="*/ 120375 h 288268"/>
                <a:gd name="connsiteX16" fmla="*/ 600075 w 771573"/>
                <a:gd name="connsiteY16" fmla="*/ 135615 h 288268"/>
                <a:gd name="connsiteX17" fmla="*/ 607695 w 771573"/>
                <a:gd name="connsiteY17" fmla="*/ 145140 h 288268"/>
                <a:gd name="connsiteX18" fmla="*/ 628650 w 771573"/>
                <a:gd name="connsiteY18" fmla="*/ 169905 h 288268"/>
                <a:gd name="connsiteX19" fmla="*/ 638175 w 771573"/>
                <a:gd name="connsiteY19" fmla="*/ 185145 h 288268"/>
                <a:gd name="connsiteX20" fmla="*/ 667218 w 771573"/>
                <a:gd name="connsiteY20" fmla="*/ 208624 h 288268"/>
                <a:gd name="connsiteX21" fmla="*/ 697230 w 771573"/>
                <a:gd name="connsiteY21" fmla="*/ 253725 h 288268"/>
                <a:gd name="connsiteX22" fmla="*/ 710565 w 771573"/>
                <a:gd name="connsiteY22" fmla="*/ 278490 h 288268"/>
                <a:gd name="connsiteX23" fmla="*/ 727710 w 771573"/>
                <a:gd name="connsiteY23" fmla="*/ 270870 h 288268"/>
                <a:gd name="connsiteX24" fmla="*/ 741045 w 771573"/>
                <a:gd name="connsiteY24" fmla="*/ 257535 h 288268"/>
                <a:gd name="connsiteX25" fmla="*/ 746760 w 771573"/>
                <a:gd name="connsiteY25" fmla="*/ 251820 h 288268"/>
                <a:gd name="connsiteX26" fmla="*/ 754380 w 771573"/>
                <a:gd name="connsiteY26" fmla="*/ 246105 h 288268"/>
                <a:gd name="connsiteX27" fmla="*/ 762000 w 771573"/>
                <a:gd name="connsiteY27" fmla="*/ 242295 h 288268"/>
                <a:gd name="connsiteX28" fmla="*/ 767715 w 771573"/>
                <a:gd name="connsiteY28" fmla="*/ 238485 h 288268"/>
                <a:gd name="connsiteX29" fmla="*/ 771525 w 771573"/>
                <a:gd name="connsiteY29" fmla="*/ 232770 h 288268"/>
                <a:gd name="connsiteX30" fmla="*/ 765810 w 771573"/>
                <a:gd name="connsiteY30" fmla="*/ 202290 h 288268"/>
                <a:gd name="connsiteX31" fmla="*/ 762000 w 771573"/>
                <a:gd name="connsiteY31" fmla="*/ 196575 h 288268"/>
                <a:gd name="connsiteX32" fmla="*/ 756285 w 771573"/>
                <a:gd name="connsiteY32" fmla="*/ 183240 h 288268"/>
                <a:gd name="connsiteX33" fmla="*/ 748665 w 771573"/>
                <a:gd name="connsiteY33" fmla="*/ 168000 h 288268"/>
                <a:gd name="connsiteX34" fmla="*/ 739140 w 771573"/>
                <a:gd name="connsiteY34" fmla="*/ 154665 h 288268"/>
                <a:gd name="connsiteX35" fmla="*/ 737235 w 771573"/>
                <a:gd name="connsiteY35" fmla="*/ 148950 h 288268"/>
                <a:gd name="connsiteX36" fmla="*/ 727710 w 771573"/>
                <a:gd name="connsiteY36" fmla="*/ 137520 h 288268"/>
                <a:gd name="connsiteX37" fmla="*/ 720090 w 771573"/>
                <a:gd name="connsiteY37" fmla="*/ 131805 h 288268"/>
                <a:gd name="connsiteX38" fmla="*/ 714375 w 771573"/>
                <a:gd name="connsiteY38" fmla="*/ 129900 h 288268"/>
                <a:gd name="connsiteX39" fmla="*/ 702945 w 771573"/>
                <a:gd name="connsiteY39" fmla="*/ 120375 h 288268"/>
                <a:gd name="connsiteX40" fmla="*/ 697230 w 771573"/>
                <a:gd name="connsiteY40" fmla="*/ 114660 h 288268"/>
                <a:gd name="connsiteX41" fmla="*/ 691515 w 771573"/>
                <a:gd name="connsiteY41" fmla="*/ 110850 h 288268"/>
                <a:gd name="connsiteX42" fmla="*/ 676275 w 771573"/>
                <a:gd name="connsiteY42" fmla="*/ 101325 h 288268"/>
                <a:gd name="connsiteX43" fmla="*/ 664845 w 771573"/>
                <a:gd name="connsiteY43" fmla="*/ 97515 h 288268"/>
                <a:gd name="connsiteX44" fmla="*/ 655320 w 771573"/>
                <a:gd name="connsiteY44" fmla="*/ 91800 h 288268"/>
                <a:gd name="connsiteX45" fmla="*/ 626745 w 771573"/>
                <a:gd name="connsiteY45" fmla="*/ 76560 h 288268"/>
                <a:gd name="connsiteX46" fmla="*/ 621030 w 771573"/>
                <a:gd name="connsiteY46" fmla="*/ 74655 h 288268"/>
                <a:gd name="connsiteX47" fmla="*/ 598170 w 771573"/>
                <a:gd name="connsiteY47" fmla="*/ 61320 h 288268"/>
                <a:gd name="connsiteX48" fmla="*/ 592455 w 771573"/>
                <a:gd name="connsiteY48" fmla="*/ 57510 h 288268"/>
                <a:gd name="connsiteX49" fmla="*/ 584835 w 771573"/>
                <a:gd name="connsiteY49" fmla="*/ 51795 h 288268"/>
                <a:gd name="connsiteX50" fmla="*/ 567690 w 771573"/>
                <a:gd name="connsiteY50" fmla="*/ 44175 h 288268"/>
                <a:gd name="connsiteX51" fmla="*/ 556260 w 771573"/>
                <a:gd name="connsiteY51" fmla="*/ 40365 h 288268"/>
                <a:gd name="connsiteX52" fmla="*/ 548640 w 771573"/>
                <a:gd name="connsiteY52" fmla="*/ 36555 h 288268"/>
                <a:gd name="connsiteX53" fmla="*/ 537210 w 771573"/>
                <a:gd name="connsiteY53" fmla="*/ 28935 h 288268"/>
                <a:gd name="connsiteX54" fmla="*/ 472440 w 771573"/>
                <a:gd name="connsiteY54" fmla="*/ 9165 h 288268"/>
                <a:gd name="connsiteX55" fmla="*/ 412430 w 771573"/>
                <a:gd name="connsiteY55" fmla="*/ 2111 h 288268"/>
                <a:gd name="connsiteX56" fmla="*/ 350052 w 771573"/>
                <a:gd name="connsiteY56" fmla="*/ 0 h 288268"/>
                <a:gd name="connsiteX57" fmla="*/ 300990 w 771573"/>
                <a:gd name="connsiteY57" fmla="*/ 4170 h 288268"/>
                <a:gd name="connsiteX58" fmla="*/ 268605 w 771573"/>
                <a:gd name="connsiteY58" fmla="*/ 11790 h 288268"/>
                <a:gd name="connsiteX59" fmla="*/ 226695 w 771573"/>
                <a:gd name="connsiteY59" fmla="*/ 28935 h 288268"/>
                <a:gd name="connsiteX60" fmla="*/ 182880 w 771573"/>
                <a:gd name="connsiteY60" fmla="*/ 55605 h 288268"/>
                <a:gd name="connsiteX61" fmla="*/ 123825 w 771573"/>
                <a:gd name="connsiteY61" fmla="*/ 97515 h 288268"/>
                <a:gd name="connsiteX62" fmla="*/ 87630 w 771573"/>
                <a:gd name="connsiteY62" fmla="*/ 127995 h 288268"/>
                <a:gd name="connsiteX63" fmla="*/ 55245 w 771573"/>
                <a:gd name="connsiteY63" fmla="*/ 160380 h 288268"/>
                <a:gd name="connsiteX64" fmla="*/ 20955 w 771573"/>
                <a:gd name="connsiteY64" fmla="*/ 206100 h 288268"/>
                <a:gd name="connsiteX65" fmla="*/ 0 w 771573"/>
                <a:gd name="connsiteY65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99420 h 288268"/>
                <a:gd name="connsiteX13" fmla="*/ 575310 w 771573"/>
                <a:gd name="connsiteY13" fmla="*/ 116565 h 288268"/>
                <a:gd name="connsiteX14" fmla="*/ 581025 w 771573"/>
                <a:gd name="connsiteY14" fmla="*/ 120375 h 288268"/>
                <a:gd name="connsiteX15" fmla="*/ 600075 w 771573"/>
                <a:gd name="connsiteY15" fmla="*/ 135615 h 288268"/>
                <a:gd name="connsiteX16" fmla="*/ 607695 w 771573"/>
                <a:gd name="connsiteY16" fmla="*/ 145140 h 288268"/>
                <a:gd name="connsiteX17" fmla="*/ 628650 w 771573"/>
                <a:gd name="connsiteY17" fmla="*/ 169905 h 288268"/>
                <a:gd name="connsiteX18" fmla="*/ 638175 w 771573"/>
                <a:gd name="connsiteY18" fmla="*/ 185145 h 288268"/>
                <a:gd name="connsiteX19" fmla="*/ 667218 w 771573"/>
                <a:gd name="connsiteY19" fmla="*/ 208624 h 288268"/>
                <a:gd name="connsiteX20" fmla="*/ 697230 w 771573"/>
                <a:gd name="connsiteY20" fmla="*/ 253725 h 288268"/>
                <a:gd name="connsiteX21" fmla="*/ 710565 w 771573"/>
                <a:gd name="connsiteY21" fmla="*/ 278490 h 288268"/>
                <a:gd name="connsiteX22" fmla="*/ 727710 w 771573"/>
                <a:gd name="connsiteY22" fmla="*/ 270870 h 288268"/>
                <a:gd name="connsiteX23" fmla="*/ 741045 w 771573"/>
                <a:gd name="connsiteY23" fmla="*/ 257535 h 288268"/>
                <a:gd name="connsiteX24" fmla="*/ 746760 w 771573"/>
                <a:gd name="connsiteY24" fmla="*/ 251820 h 288268"/>
                <a:gd name="connsiteX25" fmla="*/ 754380 w 771573"/>
                <a:gd name="connsiteY25" fmla="*/ 246105 h 288268"/>
                <a:gd name="connsiteX26" fmla="*/ 762000 w 771573"/>
                <a:gd name="connsiteY26" fmla="*/ 242295 h 288268"/>
                <a:gd name="connsiteX27" fmla="*/ 767715 w 771573"/>
                <a:gd name="connsiteY27" fmla="*/ 238485 h 288268"/>
                <a:gd name="connsiteX28" fmla="*/ 771525 w 771573"/>
                <a:gd name="connsiteY28" fmla="*/ 232770 h 288268"/>
                <a:gd name="connsiteX29" fmla="*/ 765810 w 771573"/>
                <a:gd name="connsiteY29" fmla="*/ 202290 h 288268"/>
                <a:gd name="connsiteX30" fmla="*/ 762000 w 771573"/>
                <a:gd name="connsiteY30" fmla="*/ 196575 h 288268"/>
                <a:gd name="connsiteX31" fmla="*/ 756285 w 771573"/>
                <a:gd name="connsiteY31" fmla="*/ 183240 h 288268"/>
                <a:gd name="connsiteX32" fmla="*/ 748665 w 771573"/>
                <a:gd name="connsiteY32" fmla="*/ 168000 h 288268"/>
                <a:gd name="connsiteX33" fmla="*/ 739140 w 771573"/>
                <a:gd name="connsiteY33" fmla="*/ 154665 h 288268"/>
                <a:gd name="connsiteX34" fmla="*/ 737235 w 771573"/>
                <a:gd name="connsiteY34" fmla="*/ 148950 h 288268"/>
                <a:gd name="connsiteX35" fmla="*/ 727710 w 771573"/>
                <a:gd name="connsiteY35" fmla="*/ 137520 h 288268"/>
                <a:gd name="connsiteX36" fmla="*/ 720090 w 771573"/>
                <a:gd name="connsiteY36" fmla="*/ 131805 h 288268"/>
                <a:gd name="connsiteX37" fmla="*/ 714375 w 771573"/>
                <a:gd name="connsiteY37" fmla="*/ 129900 h 288268"/>
                <a:gd name="connsiteX38" fmla="*/ 702945 w 771573"/>
                <a:gd name="connsiteY38" fmla="*/ 120375 h 288268"/>
                <a:gd name="connsiteX39" fmla="*/ 697230 w 771573"/>
                <a:gd name="connsiteY39" fmla="*/ 114660 h 288268"/>
                <a:gd name="connsiteX40" fmla="*/ 691515 w 771573"/>
                <a:gd name="connsiteY40" fmla="*/ 110850 h 288268"/>
                <a:gd name="connsiteX41" fmla="*/ 676275 w 771573"/>
                <a:gd name="connsiteY41" fmla="*/ 101325 h 288268"/>
                <a:gd name="connsiteX42" fmla="*/ 664845 w 771573"/>
                <a:gd name="connsiteY42" fmla="*/ 97515 h 288268"/>
                <a:gd name="connsiteX43" fmla="*/ 655320 w 771573"/>
                <a:gd name="connsiteY43" fmla="*/ 91800 h 288268"/>
                <a:gd name="connsiteX44" fmla="*/ 626745 w 771573"/>
                <a:gd name="connsiteY44" fmla="*/ 76560 h 288268"/>
                <a:gd name="connsiteX45" fmla="*/ 621030 w 771573"/>
                <a:gd name="connsiteY45" fmla="*/ 74655 h 288268"/>
                <a:gd name="connsiteX46" fmla="*/ 598170 w 771573"/>
                <a:gd name="connsiteY46" fmla="*/ 61320 h 288268"/>
                <a:gd name="connsiteX47" fmla="*/ 592455 w 771573"/>
                <a:gd name="connsiteY47" fmla="*/ 57510 h 288268"/>
                <a:gd name="connsiteX48" fmla="*/ 584835 w 771573"/>
                <a:gd name="connsiteY48" fmla="*/ 51795 h 288268"/>
                <a:gd name="connsiteX49" fmla="*/ 567690 w 771573"/>
                <a:gd name="connsiteY49" fmla="*/ 44175 h 288268"/>
                <a:gd name="connsiteX50" fmla="*/ 556260 w 771573"/>
                <a:gd name="connsiteY50" fmla="*/ 40365 h 288268"/>
                <a:gd name="connsiteX51" fmla="*/ 548640 w 771573"/>
                <a:gd name="connsiteY51" fmla="*/ 36555 h 288268"/>
                <a:gd name="connsiteX52" fmla="*/ 537210 w 771573"/>
                <a:gd name="connsiteY52" fmla="*/ 28935 h 288268"/>
                <a:gd name="connsiteX53" fmla="*/ 472440 w 771573"/>
                <a:gd name="connsiteY53" fmla="*/ 9165 h 288268"/>
                <a:gd name="connsiteX54" fmla="*/ 412430 w 771573"/>
                <a:gd name="connsiteY54" fmla="*/ 2111 h 288268"/>
                <a:gd name="connsiteX55" fmla="*/ 350052 w 771573"/>
                <a:gd name="connsiteY55" fmla="*/ 0 h 288268"/>
                <a:gd name="connsiteX56" fmla="*/ 300990 w 771573"/>
                <a:gd name="connsiteY56" fmla="*/ 4170 h 288268"/>
                <a:gd name="connsiteX57" fmla="*/ 268605 w 771573"/>
                <a:gd name="connsiteY57" fmla="*/ 11790 h 288268"/>
                <a:gd name="connsiteX58" fmla="*/ 226695 w 771573"/>
                <a:gd name="connsiteY58" fmla="*/ 28935 h 288268"/>
                <a:gd name="connsiteX59" fmla="*/ 182880 w 771573"/>
                <a:gd name="connsiteY59" fmla="*/ 55605 h 288268"/>
                <a:gd name="connsiteX60" fmla="*/ 123825 w 771573"/>
                <a:gd name="connsiteY60" fmla="*/ 97515 h 288268"/>
                <a:gd name="connsiteX61" fmla="*/ 87630 w 771573"/>
                <a:gd name="connsiteY61" fmla="*/ 127995 h 288268"/>
                <a:gd name="connsiteX62" fmla="*/ 55245 w 771573"/>
                <a:gd name="connsiteY62" fmla="*/ 160380 h 288268"/>
                <a:gd name="connsiteX63" fmla="*/ 20955 w 771573"/>
                <a:gd name="connsiteY63" fmla="*/ 206100 h 288268"/>
                <a:gd name="connsiteX64" fmla="*/ 0 w 771573"/>
                <a:gd name="connsiteY64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75310 w 771573"/>
                <a:gd name="connsiteY13" fmla="*/ 116565 h 288268"/>
                <a:gd name="connsiteX14" fmla="*/ 581025 w 771573"/>
                <a:gd name="connsiteY14" fmla="*/ 120375 h 288268"/>
                <a:gd name="connsiteX15" fmla="*/ 600075 w 771573"/>
                <a:gd name="connsiteY15" fmla="*/ 135615 h 288268"/>
                <a:gd name="connsiteX16" fmla="*/ 607695 w 771573"/>
                <a:gd name="connsiteY16" fmla="*/ 145140 h 288268"/>
                <a:gd name="connsiteX17" fmla="*/ 628650 w 771573"/>
                <a:gd name="connsiteY17" fmla="*/ 169905 h 288268"/>
                <a:gd name="connsiteX18" fmla="*/ 638175 w 771573"/>
                <a:gd name="connsiteY18" fmla="*/ 185145 h 288268"/>
                <a:gd name="connsiteX19" fmla="*/ 667218 w 771573"/>
                <a:gd name="connsiteY19" fmla="*/ 208624 h 288268"/>
                <a:gd name="connsiteX20" fmla="*/ 697230 w 771573"/>
                <a:gd name="connsiteY20" fmla="*/ 253725 h 288268"/>
                <a:gd name="connsiteX21" fmla="*/ 710565 w 771573"/>
                <a:gd name="connsiteY21" fmla="*/ 278490 h 288268"/>
                <a:gd name="connsiteX22" fmla="*/ 727710 w 771573"/>
                <a:gd name="connsiteY22" fmla="*/ 270870 h 288268"/>
                <a:gd name="connsiteX23" fmla="*/ 741045 w 771573"/>
                <a:gd name="connsiteY23" fmla="*/ 257535 h 288268"/>
                <a:gd name="connsiteX24" fmla="*/ 746760 w 771573"/>
                <a:gd name="connsiteY24" fmla="*/ 251820 h 288268"/>
                <a:gd name="connsiteX25" fmla="*/ 754380 w 771573"/>
                <a:gd name="connsiteY25" fmla="*/ 246105 h 288268"/>
                <a:gd name="connsiteX26" fmla="*/ 762000 w 771573"/>
                <a:gd name="connsiteY26" fmla="*/ 242295 h 288268"/>
                <a:gd name="connsiteX27" fmla="*/ 767715 w 771573"/>
                <a:gd name="connsiteY27" fmla="*/ 238485 h 288268"/>
                <a:gd name="connsiteX28" fmla="*/ 771525 w 771573"/>
                <a:gd name="connsiteY28" fmla="*/ 232770 h 288268"/>
                <a:gd name="connsiteX29" fmla="*/ 765810 w 771573"/>
                <a:gd name="connsiteY29" fmla="*/ 202290 h 288268"/>
                <a:gd name="connsiteX30" fmla="*/ 762000 w 771573"/>
                <a:gd name="connsiteY30" fmla="*/ 196575 h 288268"/>
                <a:gd name="connsiteX31" fmla="*/ 756285 w 771573"/>
                <a:gd name="connsiteY31" fmla="*/ 183240 h 288268"/>
                <a:gd name="connsiteX32" fmla="*/ 748665 w 771573"/>
                <a:gd name="connsiteY32" fmla="*/ 168000 h 288268"/>
                <a:gd name="connsiteX33" fmla="*/ 739140 w 771573"/>
                <a:gd name="connsiteY33" fmla="*/ 154665 h 288268"/>
                <a:gd name="connsiteX34" fmla="*/ 737235 w 771573"/>
                <a:gd name="connsiteY34" fmla="*/ 148950 h 288268"/>
                <a:gd name="connsiteX35" fmla="*/ 727710 w 771573"/>
                <a:gd name="connsiteY35" fmla="*/ 137520 h 288268"/>
                <a:gd name="connsiteX36" fmla="*/ 720090 w 771573"/>
                <a:gd name="connsiteY36" fmla="*/ 131805 h 288268"/>
                <a:gd name="connsiteX37" fmla="*/ 714375 w 771573"/>
                <a:gd name="connsiteY37" fmla="*/ 129900 h 288268"/>
                <a:gd name="connsiteX38" fmla="*/ 702945 w 771573"/>
                <a:gd name="connsiteY38" fmla="*/ 120375 h 288268"/>
                <a:gd name="connsiteX39" fmla="*/ 697230 w 771573"/>
                <a:gd name="connsiteY39" fmla="*/ 114660 h 288268"/>
                <a:gd name="connsiteX40" fmla="*/ 691515 w 771573"/>
                <a:gd name="connsiteY40" fmla="*/ 110850 h 288268"/>
                <a:gd name="connsiteX41" fmla="*/ 676275 w 771573"/>
                <a:gd name="connsiteY41" fmla="*/ 101325 h 288268"/>
                <a:gd name="connsiteX42" fmla="*/ 664845 w 771573"/>
                <a:gd name="connsiteY42" fmla="*/ 97515 h 288268"/>
                <a:gd name="connsiteX43" fmla="*/ 655320 w 771573"/>
                <a:gd name="connsiteY43" fmla="*/ 91800 h 288268"/>
                <a:gd name="connsiteX44" fmla="*/ 626745 w 771573"/>
                <a:gd name="connsiteY44" fmla="*/ 76560 h 288268"/>
                <a:gd name="connsiteX45" fmla="*/ 621030 w 771573"/>
                <a:gd name="connsiteY45" fmla="*/ 74655 h 288268"/>
                <a:gd name="connsiteX46" fmla="*/ 598170 w 771573"/>
                <a:gd name="connsiteY46" fmla="*/ 61320 h 288268"/>
                <a:gd name="connsiteX47" fmla="*/ 592455 w 771573"/>
                <a:gd name="connsiteY47" fmla="*/ 57510 h 288268"/>
                <a:gd name="connsiteX48" fmla="*/ 584835 w 771573"/>
                <a:gd name="connsiteY48" fmla="*/ 51795 h 288268"/>
                <a:gd name="connsiteX49" fmla="*/ 567690 w 771573"/>
                <a:gd name="connsiteY49" fmla="*/ 44175 h 288268"/>
                <a:gd name="connsiteX50" fmla="*/ 556260 w 771573"/>
                <a:gd name="connsiteY50" fmla="*/ 40365 h 288268"/>
                <a:gd name="connsiteX51" fmla="*/ 548640 w 771573"/>
                <a:gd name="connsiteY51" fmla="*/ 36555 h 288268"/>
                <a:gd name="connsiteX52" fmla="*/ 537210 w 771573"/>
                <a:gd name="connsiteY52" fmla="*/ 28935 h 288268"/>
                <a:gd name="connsiteX53" fmla="*/ 472440 w 771573"/>
                <a:gd name="connsiteY53" fmla="*/ 9165 h 288268"/>
                <a:gd name="connsiteX54" fmla="*/ 412430 w 771573"/>
                <a:gd name="connsiteY54" fmla="*/ 2111 h 288268"/>
                <a:gd name="connsiteX55" fmla="*/ 350052 w 771573"/>
                <a:gd name="connsiteY55" fmla="*/ 0 h 288268"/>
                <a:gd name="connsiteX56" fmla="*/ 300990 w 771573"/>
                <a:gd name="connsiteY56" fmla="*/ 4170 h 288268"/>
                <a:gd name="connsiteX57" fmla="*/ 268605 w 771573"/>
                <a:gd name="connsiteY57" fmla="*/ 11790 h 288268"/>
                <a:gd name="connsiteX58" fmla="*/ 226695 w 771573"/>
                <a:gd name="connsiteY58" fmla="*/ 28935 h 288268"/>
                <a:gd name="connsiteX59" fmla="*/ 182880 w 771573"/>
                <a:gd name="connsiteY59" fmla="*/ 55605 h 288268"/>
                <a:gd name="connsiteX60" fmla="*/ 123825 w 771573"/>
                <a:gd name="connsiteY60" fmla="*/ 97515 h 288268"/>
                <a:gd name="connsiteX61" fmla="*/ 87630 w 771573"/>
                <a:gd name="connsiteY61" fmla="*/ 127995 h 288268"/>
                <a:gd name="connsiteX62" fmla="*/ 55245 w 771573"/>
                <a:gd name="connsiteY62" fmla="*/ 160380 h 288268"/>
                <a:gd name="connsiteX63" fmla="*/ 20955 w 771573"/>
                <a:gd name="connsiteY63" fmla="*/ 206100 h 288268"/>
                <a:gd name="connsiteX64" fmla="*/ 0 w 771573"/>
                <a:gd name="connsiteY64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81025 w 771573"/>
                <a:gd name="connsiteY13" fmla="*/ 120375 h 288268"/>
                <a:gd name="connsiteX14" fmla="*/ 600075 w 771573"/>
                <a:gd name="connsiteY14" fmla="*/ 135615 h 288268"/>
                <a:gd name="connsiteX15" fmla="*/ 607695 w 771573"/>
                <a:gd name="connsiteY15" fmla="*/ 145140 h 288268"/>
                <a:gd name="connsiteX16" fmla="*/ 628650 w 771573"/>
                <a:gd name="connsiteY16" fmla="*/ 169905 h 288268"/>
                <a:gd name="connsiteX17" fmla="*/ 638175 w 771573"/>
                <a:gd name="connsiteY17" fmla="*/ 185145 h 288268"/>
                <a:gd name="connsiteX18" fmla="*/ 667218 w 771573"/>
                <a:gd name="connsiteY18" fmla="*/ 208624 h 288268"/>
                <a:gd name="connsiteX19" fmla="*/ 697230 w 771573"/>
                <a:gd name="connsiteY19" fmla="*/ 253725 h 288268"/>
                <a:gd name="connsiteX20" fmla="*/ 710565 w 771573"/>
                <a:gd name="connsiteY20" fmla="*/ 278490 h 288268"/>
                <a:gd name="connsiteX21" fmla="*/ 727710 w 771573"/>
                <a:gd name="connsiteY21" fmla="*/ 270870 h 288268"/>
                <a:gd name="connsiteX22" fmla="*/ 741045 w 771573"/>
                <a:gd name="connsiteY22" fmla="*/ 257535 h 288268"/>
                <a:gd name="connsiteX23" fmla="*/ 746760 w 771573"/>
                <a:gd name="connsiteY23" fmla="*/ 251820 h 288268"/>
                <a:gd name="connsiteX24" fmla="*/ 754380 w 771573"/>
                <a:gd name="connsiteY24" fmla="*/ 246105 h 288268"/>
                <a:gd name="connsiteX25" fmla="*/ 762000 w 771573"/>
                <a:gd name="connsiteY25" fmla="*/ 242295 h 288268"/>
                <a:gd name="connsiteX26" fmla="*/ 767715 w 771573"/>
                <a:gd name="connsiteY26" fmla="*/ 238485 h 288268"/>
                <a:gd name="connsiteX27" fmla="*/ 771525 w 771573"/>
                <a:gd name="connsiteY27" fmla="*/ 232770 h 288268"/>
                <a:gd name="connsiteX28" fmla="*/ 765810 w 771573"/>
                <a:gd name="connsiteY28" fmla="*/ 202290 h 288268"/>
                <a:gd name="connsiteX29" fmla="*/ 762000 w 771573"/>
                <a:gd name="connsiteY29" fmla="*/ 196575 h 288268"/>
                <a:gd name="connsiteX30" fmla="*/ 756285 w 771573"/>
                <a:gd name="connsiteY30" fmla="*/ 183240 h 288268"/>
                <a:gd name="connsiteX31" fmla="*/ 748665 w 771573"/>
                <a:gd name="connsiteY31" fmla="*/ 168000 h 288268"/>
                <a:gd name="connsiteX32" fmla="*/ 739140 w 771573"/>
                <a:gd name="connsiteY32" fmla="*/ 154665 h 288268"/>
                <a:gd name="connsiteX33" fmla="*/ 737235 w 771573"/>
                <a:gd name="connsiteY33" fmla="*/ 148950 h 288268"/>
                <a:gd name="connsiteX34" fmla="*/ 727710 w 771573"/>
                <a:gd name="connsiteY34" fmla="*/ 137520 h 288268"/>
                <a:gd name="connsiteX35" fmla="*/ 720090 w 771573"/>
                <a:gd name="connsiteY35" fmla="*/ 131805 h 288268"/>
                <a:gd name="connsiteX36" fmla="*/ 714375 w 771573"/>
                <a:gd name="connsiteY36" fmla="*/ 129900 h 288268"/>
                <a:gd name="connsiteX37" fmla="*/ 702945 w 771573"/>
                <a:gd name="connsiteY37" fmla="*/ 120375 h 288268"/>
                <a:gd name="connsiteX38" fmla="*/ 697230 w 771573"/>
                <a:gd name="connsiteY38" fmla="*/ 114660 h 288268"/>
                <a:gd name="connsiteX39" fmla="*/ 691515 w 771573"/>
                <a:gd name="connsiteY39" fmla="*/ 110850 h 288268"/>
                <a:gd name="connsiteX40" fmla="*/ 676275 w 771573"/>
                <a:gd name="connsiteY40" fmla="*/ 101325 h 288268"/>
                <a:gd name="connsiteX41" fmla="*/ 664845 w 771573"/>
                <a:gd name="connsiteY41" fmla="*/ 97515 h 288268"/>
                <a:gd name="connsiteX42" fmla="*/ 655320 w 771573"/>
                <a:gd name="connsiteY42" fmla="*/ 91800 h 288268"/>
                <a:gd name="connsiteX43" fmla="*/ 626745 w 771573"/>
                <a:gd name="connsiteY43" fmla="*/ 76560 h 288268"/>
                <a:gd name="connsiteX44" fmla="*/ 621030 w 771573"/>
                <a:gd name="connsiteY44" fmla="*/ 74655 h 288268"/>
                <a:gd name="connsiteX45" fmla="*/ 598170 w 771573"/>
                <a:gd name="connsiteY45" fmla="*/ 61320 h 288268"/>
                <a:gd name="connsiteX46" fmla="*/ 592455 w 771573"/>
                <a:gd name="connsiteY46" fmla="*/ 57510 h 288268"/>
                <a:gd name="connsiteX47" fmla="*/ 584835 w 771573"/>
                <a:gd name="connsiteY47" fmla="*/ 51795 h 288268"/>
                <a:gd name="connsiteX48" fmla="*/ 567690 w 771573"/>
                <a:gd name="connsiteY48" fmla="*/ 44175 h 288268"/>
                <a:gd name="connsiteX49" fmla="*/ 556260 w 771573"/>
                <a:gd name="connsiteY49" fmla="*/ 40365 h 288268"/>
                <a:gd name="connsiteX50" fmla="*/ 548640 w 771573"/>
                <a:gd name="connsiteY50" fmla="*/ 36555 h 288268"/>
                <a:gd name="connsiteX51" fmla="*/ 537210 w 771573"/>
                <a:gd name="connsiteY51" fmla="*/ 28935 h 288268"/>
                <a:gd name="connsiteX52" fmla="*/ 472440 w 771573"/>
                <a:gd name="connsiteY52" fmla="*/ 9165 h 288268"/>
                <a:gd name="connsiteX53" fmla="*/ 412430 w 771573"/>
                <a:gd name="connsiteY53" fmla="*/ 2111 h 288268"/>
                <a:gd name="connsiteX54" fmla="*/ 350052 w 771573"/>
                <a:gd name="connsiteY54" fmla="*/ 0 h 288268"/>
                <a:gd name="connsiteX55" fmla="*/ 300990 w 771573"/>
                <a:gd name="connsiteY55" fmla="*/ 4170 h 288268"/>
                <a:gd name="connsiteX56" fmla="*/ 268605 w 771573"/>
                <a:gd name="connsiteY56" fmla="*/ 11790 h 288268"/>
                <a:gd name="connsiteX57" fmla="*/ 226695 w 771573"/>
                <a:gd name="connsiteY57" fmla="*/ 28935 h 288268"/>
                <a:gd name="connsiteX58" fmla="*/ 182880 w 771573"/>
                <a:gd name="connsiteY58" fmla="*/ 55605 h 288268"/>
                <a:gd name="connsiteX59" fmla="*/ 123825 w 771573"/>
                <a:gd name="connsiteY59" fmla="*/ 97515 h 288268"/>
                <a:gd name="connsiteX60" fmla="*/ 87630 w 771573"/>
                <a:gd name="connsiteY60" fmla="*/ 127995 h 288268"/>
                <a:gd name="connsiteX61" fmla="*/ 55245 w 771573"/>
                <a:gd name="connsiteY61" fmla="*/ 160380 h 288268"/>
                <a:gd name="connsiteX62" fmla="*/ 20955 w 771573"/>
                <a:gd name="connsiteY62" fmla="*/ 206100 h 288268"/>
                <a:gd name="connsiteX63" fmla="*/ 0 w 771573"/>
                <a:gd name="connsiteY63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76742 w 771573"/>
                <a:gd name="connsiteY13" fmla="*/ 130001 h 288268"/>
                <a:gd name="connsiteX14" fmla="*/ 600075 w 771573"/>
                <a:gd name="connsiteY14" fmla="*/ 135615 h 288268"/>
                <a:gd name="connsiteX15" fmla="*/ 607695 w 771573"/>
                <a:gd name="connsiteY15" fmla="*/ 145140 h 288268"/>
                <a:gd name="connsiteX16" fmla="*/ 628650 w 771573"/>
                <a:gd name="connsiteY16" fmla="*/ 169905 h 288268"/>
                <a:gd name="connsiteX17" fmla="*/ 638175 w 771573"/>
                <a:gd name="connsiteY17" fmla="*/ 185145 h 288268"/>
                <a:gd name="connsiteX18" fmla="*/ 667218 w 771573"/>
                <a:gd name="connsiteY18" fmla="*/ 208624 h 288268"/>
                <a:gd name="connsiteX19" fmla="*/ 697230 w 771573"/>
                <a:gd name="connsiteY19" fmla="*/ 253725 h 288268"/>
                <a:gd name="connsiteX20" fmla="*/ 710565 w 771573"/>
                <a:gd name="connsiteY20" fmla="*/ 278490 h 288268"/>
                <a:gd name="connsiteX21" fmla="*/ 727710 w 771573"/>
                <a:gd name="connsiteY21" fmla="*/ 270870 h 288268"/>
                <a:gd name="connsiteX22" fmla="*/ 741045 w 771573"/>
                <a:gd name="connsiteY22" fmla="*/ 257535 h 288268"/>
                <a:gd name="connsiteX23" fmla="*/ 746760 w 771573"/>
                <a:gd name="connsiteY23" fmla="*/ 251820 h 288268"/>
                <a:gd name="connsiteX24" fmla="*/ 754380 w 771573"/>
                <a:gd name="connsiteY24" fmla="*/ 246105 h 288268"/>
                <a:gd name="connsiteX25" fmla="*/ 762000 w 771573"/>
                <a:gd name="connsiteY25" fmla="*/ 242295 h 288268"/>
                <a:gd name="connsiteX26" fmla="*/ 767715 w 771573"/>
                <a:gd name="connsiteY26" fmla="*/ 238485 h 288268"/>
                <a:gd name="connsiteX27" fmla="*/ 771525 w 771573"/>
                <a:gd name="connsiteY27" fmla="*/ 232770 h 288268"/>
                <a:gd name="connsiteX28" fmla="*/ 765810 w 771573"/>
                <a:gd name="connsiteY28" fmla="*/ 202290 h 288268"/>
                <a:gd name="connsiteX29" fmla="*/ 762000 w 771573"/>
                <a:gd name="connsiteY29" fmla="*/ 196575 h 288268"/>
                <a:gd name="connsiteX30" fmla="*/ 756285 w 771573"/>
                <a:gd name="connsiteY30" fmla="*/ 183240 h 288268"/>
                <a:gd name="connsiteX31" fmla="*/ 748665 w 771573"/>
                <a:gd name="connsiteY31" fmla="*/ 168000 h 288268"/>
                <a:gd name="connsiteX32" fmla="*/ 739140 w 771573"/>
                <a:gd name="connsiteY32" fmla="*/ 154665 h 288268"/>
                <a:gd name="connsiteX33" fmla="*/ 737235 w 771573"/>
                <a:gd name="connsiteY33" fmla="*/ 148950 h 288268"/>
                <a:gd name="connsiteX34" fmla="*/ 727710 w 771573"/>
                <a:gd name="connsiteY34" fmla="*/ 137520 h 288268"/>
                <a:gd name="connsiteX35" fmla="*/ 720090 w 771573"/>
                <a:gd name="connsiteY35" fmla="*/ 131805 h 288268"/>
                <a:gd name="connsiteX36" fmla="*/ 714375 w 771573"/>
                <a:gd name="connsiteY36" fmla="*/ 129900 h 288268"/>
                <a:gd name="connsiteX37" fmla="*/ 702945 w 771573"/>
                <a:gd name="connsiteY37" fmla="*/ 120375 h 288268"/>
                <a:gd name="connsiteX38" fmla="*/ 697230 w 771573"/>
                <a:gd name="connsiteY38" fmla="*/ 114660 h 288268"/>
                <a:gd name="connsiteX39" fmla="*/ 691515 w 771573"/>
                <a:gd name="connsiteY39" fmla="*/ 110850 h 288268"/>
                <a:gd name="connsiteX40" fmla="*/ 676275 w 771573"/>
                <a:gd name="connsiteY40" fmla="*/ 101325 h 288268"/>
                <a:gd name="connsiteX41" fmla="*/ 664845 w 771573"/>
                <a:gd name="connsiteY41" fmla="*/ 97515 h 288268"/>
                <a:gd name="connsiteX42" fmla="*/ 655320 w 771573"/>
                <a:gd name="connsiteY42" fmla="*/ 91800 h 288268"/>
                <a:gd name="connsiteX43" fmla="*/ 626745 w 771573"/>
                <a:gd name="connsiteY43" fmla="*/ 76560 h 288268"/>
                <a:gd name="connsiteX44" fmla="*/ 621030 w 771573"/>
                <a:gd name="connsiteY44" fmla="*/ 74655 h 288268"/>
                <a:gd name="connsiteX45" fmla="*/ 598170 w 771573"/>
                <a:gd name="connsiteY45" fmla="*/ 61320 h 288268"/>
                <a:gd name="connsiteX46" fmla="*/ 592455 w 771573"/>
                <a:gd name="connsiteY46" fmla="*/ 57510 h 288268"/>
                <a:gd name="connsiteX47" fmla="*/ 584835 w 771573"/>
                <a:gd name="connsiteY47" fmla="*/ 51795 h 288268"/>
                <a:gd name="connsiteX48" fmla="*/ 567690 w 771573"/>
                <a:gd name="connsiteY48" fmla="*/ 44175 h 288268"/>
                <a:gd name="connsiteX49" fmla="*/ 556260 w 771573"/>
                <a:gd name="connsiteY49" fmla="*/ 40365 h 288268"/>
                <a:gd name="connsiteX50" fmla="*/ 548640 w 771573"/>
                <a:gd name="connsiteY50" fmla="*/ 36555 h 288268"/>
                <a:gd name="connsiteX51" fmla="*/ 537210 w 771573"/>
                <a:gd name="connsiteY51" fmla="*/ 28935 h 288268"/>
                <a:gd name="connsiteX52" fmla="*/ 472440 w 771573"/>
                <a:gd name="connsiteY52" fmla="*/ 9165 h 288268"/>
                <a:gd name="connsiteX53" fmla="*/ 412430 w 771573"/>
                <a:gd name="connsiteY53" fmla="*/ 2111 h 288268"/>
                <a:gd name="connsiteX54" fmla="*/ 350052 w 771573"/>
                <a:gd name="connsiteY54" fmla="*/ 0 h 288268"/>
                <a:gd name="connsiteX55" fmla="*/ 300990 w 771573"/>
                <a:gd name="connsiteY55" fmla="*/ 4170 h 288268"/>
                <a:gd name="connsiteX56" fmla="*/ 268605 w 771573"/>
                <a:gd name="connsiteY56" fmla="*/ 11790 h 288268"/>
                <a:gd name="connsiteX57" fmla="*/ 226695 w 771573"/>
                <a:gd name="connsiteY57" fmla="*/ 28935 h 288268"/>
                <a:gd name="connsiteX58" fmla="*/ 182880 w 771573"/>
                <a:gd name="connsiteY58" fmla="*/ 55605 h 288268"/>
                <a:gd name="connsiteX59" fmla="*/ 123825 w 771573"/>
                <a:gd name="connsiteY59" fmla="*/ 97515 h 288268"/>
                <a:gd name="connsiteX60" fmla="*/ 87630 w 771573"/>
                <a:gd name="connsiteY60" fmla="*/ 127995 h 288268"/>
                <a:gd name="connsiteX61" fmla="*/ 55245 w 771573"/>
                <a:gd name="connsiteY61" fmla="*/ 160380 h 288268"/>
                <a:gd name="connsiteX62" fmla="*/ 20955 w 771573"/>
                <a:gd name="connsiteY62" fmla="*/ 206100 h 288268"/>
                <a:gd name="connsiteX63" fmla="*/ 0 w 771573"/>
                <a:gd name="connsiteY63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76742 w 771573"/>
                <a:gd name="connsiteY13" fmla="*/ 130001 h 288268"/>
                <a:gd name="connsiteX14" fmla="*/ 607695 w 771573"/>
                <a:gd name="connsiteY14" fmla="*/ 145140 h 288268"/>
                <a:gd name="connsiteX15" fmla="*/ 628650 w 771573"/>
                <a:gd name="connsiteY15" fmla="*/ 169905 h 288268"/>
                <a:gd name="connsiteX16" fmla="*/ 638175 w 771573"/>
                <a:gd name="connsiteY16" fmla="*/ 185145 h 288268"/>
                <a:gd name="connsiteX17" fmla="*/ 667218 w 771573"/>
                <a:gd name="connsiteY17" fmla="*/ 208624 h 288268"/>
                <a:gd name="connsiteX18" fmla="*/ 697230 w 771573"/>
                <a:gd name="connsiteY18" fmla="*/ 253725 h 288268"/>
                <a:gd name="connsiteX19" fmla="*/ 710565 w 771573"/>
                <a:gd name="connsiteY19" fmla="*/ 278490 h 288268"/>
                <a:gd name="connsiteX20" fmla="*/ 727710 w 771573"/>
                <a:gd name="connsiteY20" fmla="*/ 270870 h 288268"/>
                <a:gd name="connsiteX21" fmla="*/ 741045 w 771573"/>
                <a:gd name="connsiteY21" fmla="*/ 257535 h 288268"/>
                <a:gd name="connsiteX22" fmla="*/ 746760 w 771573"/>
                <a:gd name="connsiteY22" fmla="*/ 251820 h 288268"/>
                <a:gd name="connsiteX23" fmla="*/ 754380 w 771573"/>
                <a:gd name="connsiteY23" fmla="*/ 246105 h 288268"/>
                <a:gd name="connsiteX24" fmla="*/ 762000 w 771573"/>
                <a:gd name="connsiteY24" fmla="*/ 242295 h 288268"/>
                <a:gd name="connsiteX25" fmla="*/ 767715 w 771573"/>
                <a:gd name="connsiteY25" fmla="*/ 238485 h 288268"/>
                <a:gd name="connsiteX26" fmla="*/ 771525 w 771573"/>
                <a:gd name="connsiteY26" fmla="*/ 232770 h 288268"/>
                <a:gd name="connsiteX27" fmla="*/ 765810 w 771573"/>
                <a:gd name="connsiteY27" fmla="*/ 202290 h 288268"/>
                <a:gd name="connsiteX28" fmla="*/ 762000 w 771573"/>
                <a:gd name="connsiteY28" fmla="*/ 196575 h 288268"/>
                <a:gd name="connsiteX29" fmla="*/ 756285 w 771573"/>
                <a:gd name="connsiteY29" fmla="*/ 183240 h 288268"/>
                <a:gd name="connsiteX30" fmla="*/ 748665 w 771573"/>
                <a:gd name="connsiteY30" fmla="*/ 168000 h 288268"/>
                <a:gd name="connsiteX31" fmla="*/ 739140 w 771573"/>
                <a:gd name="connsiteY31" fmla="*/ 154665 h 288268"/>
                <a:gd name="connsiteX32" fmla="*/ 737235 w 771573"/>
                <a:gd name="connsiteY32" fmla="*/ 148950 h 288268"/>
                <a:gd name="connsiteX33" fmla="*/ 727710 w 771573"/>
                <a:gd name="connsiteY33" fmla="*/ 137520 h 288268"/>
                <a:gd name="connsiteX34" fmla="*/ 720090 w 771573"/>
                <a:gd name="connsiteY34" fmla="*/ 131805 h 288268"/>
                <a:gd name="connsiteX35" fmla="*/ 714375 w 771573"/>
                <a:gd name="connsiteY35" fmla="*/ 129900 h 288268"/>
                <a:gd name="connsiteX36" fmla="*/ 702945 w 771573"/>
                <a:gd name="connsiteY36" fmla="*/ 120375 h 288268"/>
                <a:gd name="connsiteX37" fmla="*/ 697230 w 771573"/>
                <a:gd name="connsiteY37" fmla="*/ 114660 h 288268"/>
                <a:gd name="connsiteX38" fmla="*/ 691515 w 771573"/>
                <a:gd name="connsiteY38" fmla="*/ 110850 h 288268"/>
                <a:gd name="connsiteX39" fmla="*/ 676275 w 771573"/>
                <a:gd name="connsiteY39" fmla="*/ 101325 h 288268"/>
                <a:gd name="connsiteX40" fmla="*/ 664845 w 771573"/>
                <a:gd name="connsiteY40" fmla="*/ 97515 h 288268"/>
                <a:gd name="connsiteX41" fmla="*/ 655320 w 771573"/>
                <a:gd name="connsiteY41" fmla="*/ 91800 h 288268"/>
                <a:gd name="connsiteX42" fmla="*/ 626745 w 771573"/>
                <a:gd name="connsiteY42" fmla="*/ 76560 h 288268"/>
                <a:gd name="connsiteX43" fmla="*/ 621030 w 771573"/>
                <a:gd name="connsiteY43" fmla="*/ 74655 h 288268"/>
                <a:gd name="connsiteX44" fmla="*/ 598170 w 771573"/>
                <a:gd name="connsiteY44" fmla="*/ 61320 h 288268"/>
                <a:gd name="connsiteX45" fmla="*/ 592455 w 771573"/>
                <a:gd name="connsiteY45" fmla="*/ 57510 h 288268"/>
                <a:gd name="connsiteX46" fmla="*/ 584835 w 771573"/>
                <a:gd name="connsiteY46" fmla="*/ 51795 h 288268"/>
                <a:gd name="connsiteX47" fmla="*/ 567690 w 771573"/>
                <a:gd name="connsiteY47" fmla="*/ 44175 h 288268"/>
                <a:gd name="connsiteX48" fmla="*/ 556260 w 771573"/>
                <a:gd name="connsiteY48" fmla="*/ 40365 h 288268"/>
                <a:gd name="connsiteX49" fmla="*/ 548640 w 771573"/>
                <a:gd name="connsiteY49" fmla="*/ 36555 h 288268"/>
                <a:gd name="connsiteX50" fmla="*/ 537210 w 771573"/>
                <a:gd name="connsiteY50" fmla="*/ 28935 h 288268"/>
                <a:gd name="connsiteX51" fmla="*/ 472440 w 771573"/>
                <a:gd name="connsiteY51" fmla="*/ 9165 h 288268"/>
                <a:gd name="connsiteX52" fmla="*/ 412430 w 771573"/>
                <a:gd name="connsiteY52" fmla="*/ 2111 h 288268"/>
                <a:gd name="connsiteX53" fmla="*/ 350052 w 771573"/>
                <a:gd name="connsiteY53" fmla="*/ 0 h 288268"/>
                <a:gd name="connsiteX54" fmla="*/ 300990 w 771573"/>
                <a:gd name="connsiteY54" fmla="*/ 4170 h 288268"/>
                <a:gd name="connsiteX55" fmla="*/ 268605 w 771573"/>
                <a:gd name="connsiteY55" fmla="*/ 11790 h 288268"/>
                <a:gd name="connsiteX56" fmla="*/ 226695 w 771573"/>
                <a:gd name="connsiteY56" fmla="*/ 28935 h 288268"/>
                <a:gd name="connsiteX57" fmla="*/ 182880 w 771573"/>
                <a:gd name="connsiteY57" fmla="*/ 55605 h 288268"/>
                <a:gd name="connsiteX58" fmla="*/ 123825 w 771573"/>
                <a:gd name="connsiteY58" fmla="*/ 97515 h 288268"/>
                <a:gd name="connsiteX59" fmla="*/ 87630 w 771573"/>
                <a:gd name="connsiteY59" fmla="*/ 127995 h 288268"/>
                <a:gd name="connsiteX60" fmla="*/ 55245 w 771573"/>
                <a:gd name="connsiteY60" fmla="*/ 160380 h 288268"/>
                <a:gd name="connsiteX61" fmla="*/ 20955 w 771573"/>
                <a:gd name="connsiteY61" fmla="*/ 206100 h 288268"/>
                <a:gd name="connsiteX62" fmla="*/ 0 w 771573"/>
                <a:gd name="connsiteY62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83880 w 771573"/>
                <a:gd name="connsiteY13" fmla="*/ 130001 h 288268"/>
                <a:gd name="connsiteX14" fmla="*/ 607695 w 771573"/>
                <a:gd name="connsiteY14" fmla="*/ 145140 h 288268"/>
                <a:gd name="connsiteX15" fmla="*/ 628650 w 771573"/>
                <a:gd name="connsiteY15" fmla="*/ 169905 h 288268"/>
                <a:gd name="connsiteX16" fmla="*/ 638175 w 771573"/>
                <a:gd name="connsiteY16" fmla="*/ 185145 h 288268"/>
                <a:gd name="connsiteX17" fmla="*/ 667218 w 771573"/>
                <a:gd name="connsiteY17" fmla="*/ 208624 h 288268"/>
                <a:gd name="connsiteX18" fmla="*/ 697230 w 771573"/>
                <a:gd name="connsiteY18" fmla="*/ 253725 h 288268"/>
                <a:gd name="connsiteX19" fmla="*/ 710565 w 771573"/>
                <a:gd name="connsiteY19" fmla="*/ 278490 h 288268"/>
                <a:gd name="connsiteX20" fmla="*/ 727710 w 771573"/>
                <a:gd name="connsiteY20" fmla="*/ 270870 h 288268"/>
                <a:gd name="connsiteX21" fmla="*/ 741045 w 771573"/>
                <a:gd name="connsiteY21" fmla="*/ 257535 h 288268"/>
                <a:gd name="connsiteX22" fmla="*/ 746760 w 771573"/>
                <a:gd name="connsiteY22" fmla="*/ 251820 h 288268"/>
                <a:gd name="connsiteX23" fmla="*/ 754380 w 771573"/>
                <a:gd name="connsiteY23" fmla="*/ 246105 h 288268"/>
                <a:gd name="connsiteX24" fmla="*/ 762000 w 771573"/>
                <a:gd name="connsiteY24" fmla="*/ 242295 h 288268"/>
                <a:gd name="connsiteX25" fmla="*/ 767715 w 771573"/>
                <a:gd name="connsiteY25" fmla="*/ 238485 h 288268"/>
                <a:gd name="connsiteX26" fmla="*/ 771525 w 771573"/>
                <a:gd name="connsiteY26" fmla="*/ 232770 h 288268"/>
                <a:gd name="connsiteX27" fmla="*/ 765810 w 771573"/>
                <a:gd name="connsiteY27" fmla="*/ 202290 h 288268"/>
                <a:gd name="connsiteX28" fmla="*/ 762000 w 771573"/>
                <a:gd name="connsiteY28" fmla="*/ 196575 h 288268"/>
                <a:gd name="connsiteX29" fmla="*/ 756285 w 771573"/>
                <a:gd name="connsiteY29" fmla="*/ 183240 h 288268"/>
                <a:gd name="connsiteX30" fmla="*/ 748665 w 771573"/>
                <a:gd name="connsiteY30" fmla="*/ 168000 h 288268"/>
                <a:gd name="connsiteX31" fmla="*/ 739140 w 771573"/>
                <a:gd name="connsiteY31" fmla="*/ 154665 h 288268"/>
                <a:gd name="connsiteX32" fmla="*/ 737235 w 771573"/>
                <a:gd name="connsiteY32" fmla="*/ 148950 h 288268"/>
                <a:gd name="connsiteX33" fmla="*/ 727710 w 771573"/>
                <a:gd name="connsiteY33" fmla="*/ 137520 h 288268"/>
                <a:gd name="connsiteX34" fmla="*/ 720090 w 771573"/>
                <a:gd name="connsiteY34" fmla="*/ 131805 h 288268"/>
                <a:gd name="connsiteX35" fmla="*/ 714375 w 771573"/>
                <a:gd name="connsiteY35" fmla="*/ 129900 h 288268"/>
                <a:gd name="connsiteX36" fmla="*/ 702945 w 771573"/>
                <a:gd name="connsiteY36" fmla="*/ 120375 h 288268"/>
                <a:gd name="connsiteX37" fmla="*/ 697230 w 771573"/>
                <a:gd name="connsiteY37" fmla="*/ 114660 h 288268"/>
                <a:gd name="connsiteX38" fmla="*/ 691515 w 771573"/>
                <a:gd name="connsiteY38" fmla="*/ 110850 h 288268"/>
                <a:gd name="connsiteX39" fmla="*/ 676275 w 771573"/>
                <a:gd name="connsiteY39" fmla="*/ 101325 h 288268"/>
                <a:gd name="connsiteX40" fmla="*/ 664845 w 771573"/>
                <a:gd name="connsiteY40" fmla="*/ 97515 h 288268"/>
                <a:gd name="connsiteX41" fmla="*/ 655320 w 771573"/>
                <a:gd name="connsiteY41" fmla="*/ 91800 h 288268"/>
                <a:gd name="connsiteX42" fmla="*/ 626745 w 771573"/>
                <a:gd name="connsiteY42" fmla="*/ 76560 h 288268"/>
                <a:gd name="connsiteX43" fmla="*/ 621030 w 771573"/>
                <a:gd name="connsiteY43" fmla="*/ 74655 h 288268"/>
                <a:gd name="connsiteX44" fmla="*/ 598170 w 771573"/>
                <a:gd name="connsiteY44" fmla="*/ 61320 h 288268"/>
                <a:gd name="connsiteX45" fmla="*/ 592455 w 771573"/>
                <a:gd name="connsiteY45" fmla="*/ 57510 h 288268"/>
                <a:gd name="connsiteX46" fmla="*/ 584835 w 771573"/>
                <a:gd name="connsiteY46" fmla="*/ 51795 h 288268"/>
                <a:gd name="connsiteX47" fmla="*/ 567690 w 771573"/>
                <a:gd name="connsiteY47" fmla="*/ 44175 h 288268"/>
                <a:gd name="connsiteX48" fmla="*/ 556260 w 771573"/>
                <a:gd name="connsiteY48" fmla="*/ 40365 h 288268"/>
                <a:gd name="connsiteX49" fmla="*/ 548640 w 771573"/>
                <a:gd name="connsiteY49" fmla="*/ 36555 h 288268"/>
                <a:gd name="connsiteX50" fmla="*/ 537210 w 771573"/>
                <a:gd name="connsiteY50" fmla="*/ 28935 h 288268"/>
                <a:gd name="connsiteX51" fmla="*/ 472440 w 771573"/>
                <a:gd name="connsiteY51" fmla="*/ 9165 h 288268"/>
                <a:gd name="connsiteX52" fmla="*/ 412430 w 771573"/>
                <a:gd name="connsiteY52" fmla="*/ 2111 h 288268"/>
                <a:gd name="connsiteX53" fmla="*/ 350052 w 771573"/>
                <a:gd name="connsiteY53" fmla="*/ 0 h 288268"/>
                <a:gd name="connsiteX54" fmla="*/ 300990 w 771573"/>
                <a:gd name="connsiteY54" fmla="*/ 4170 h 288268"/>
                <a:gd name="connsiteX55" fmla="*/ 268605 w 771573"/>
                <a:gd name="connsiteY55" fmla="*/ 11790 h 288268"/>
                <a:gd name="connsiteX56" fmla="*/ 226695 w 771573"/>
                <a:gd name="connsiteY56" fmla="*/ 28935 h 288268"/>
                <a:gd name="connsiteX57" fmla="*/ 182880 w 771573"/>
                <a:gd name="connsiteY57" fmla="*/ 55605 h 288268"/>
                <a:gd name="connsiteX58" fmla="*/ 123825 w 771573"/>
                <a:gd name="connsiteY58" fmla="*/ 97515 h 288268"/>
                <a:gd name="connsiteX59" fmla="*/ 87630 w 771573"/>
                <a:gd name="connsiteY59" fmla="*/ 127995 h 288268"/>
                <a:gd name="connsiteX60" fmla="*/ 55245 w 771573"/>
                <a:gd name="connsiteY60" fmla="*/ 160380 h 288268"/>
                <a:gd name="connsiteX61" fmla="*/ 20955 w 771573"/>
                <a:gd name="connsiteY61" fmla="*/ 206100 h 288268"/>
                <a:gd name="connsiteX62" fmla="*/ 0 w 771573"/>
                <a:gd name="connsiteY62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83880 w 771573"/>
                <a:gd name="connsiteY13" fmla="*/ 130001 h 288268"/>
                <a:gd name="connsiteX14" fmla="*/ 628650 w 771573"/>
                <a:gd name="connsiteY14" fmla="*/ 169905 h 288268"/>
                <a:gd name="connsiteX15" fmla="*/ 638175 w 771573"/>
                <a:gd name="connsiteY15" fmla="*/ 185145 h 288268"/>
                <a:gd name="connsiteX16" fmla="*/ 667218 w 771573"/>
                <a:gd name="connsiteY16" fmla="*/ 208624 h 288268"/>
                <a:gd name="connsiteX17" fmla="*/ 697230 w 771573"/>
                <a:gd name="connsiteY17" fmla="*/ 253725 h 288268"/>
                <a:gd name="connsiteX18" fmla="*/ 710565 w 771573"/>
                <a:gd name="connsiteY18" fmla="*/ 278490 h 288268"/>
                <a:gd name="connsiteX19" fmla="*/ 727710 w 771573"/>
                <a:gd name="connsiteY19" fmla="*/ 270870 h 288268"/>
                <a:gd name="connsiteX20" fmla="*/ 741045 w 771573"/>
                <a:gd name="connsiteY20" fmla="*/ 257535 h 288268"/>
                <a:gd name="connsiteX21" fmla="*/ 746760 w 771573"/>
                <a:gd name="connsiteY21" fmla="*/ 251820 h 288268"/>
                <a:gd name="connsiteX22" fmla="*/ 754380 w 771573"/>
                <a:gd name="connsiteY22" fmla="*/ 246105 h 288268"/>
                <a:gd name="connsiteX23" fmla="*/ 762000 w 771573"/>
                <a:gd name="connsiteY23" fmla="*/ 242295 h 288268"/>
                <a:gd name="connsiteX24" fmla="*/ 767715 w 771573"/>
                <a:gd name="connsiteY24" fmla="*/ 238485 h 288268"/>
                <a:gd name="connsiteX25" fmla="*/ 771525 w 771573"/>
                <a:gd name="connsiteY25" fmla="*/ 232770 h 288268"/>
                <a:gd name="connsiteX26" fmla="*/ 765810 w 771573"/>
                <a:gd name="connsiteY26" fmla="*/ 202290 h 288268"/>
                <a:gd name="connsiteX27" fmla="*/ 762000 w 771573"/>
                <a:gd name="connsiteY27" fmla="*/ 196575 h 288268"/>
                <a:gd name="connsiteX28" fmla="*/ 756285 w 771573"/>
                <a:gd name="connsiteY28" fmla="*/ 183240 h 288268"/>
                <a:gd name="connsiteX29" fmla="*/ 748665 w 771573"/>
                <a:gd name="connsiteY29" fmla="*/ 168000 h 288268"/>
                <a:gd name="connsiteX30" fmla="*/ 739140 w 771573"/>
                <a:gd name="connsiteY30" fmla="*/ 154665 h 288268"/>
                <a:gd name="connsiteX31" fmla="*/ 737235 w 771573"/>
                <a:gd name="connsiteY31" fmla="*/ 148950 h 288268"/>
                <a:gd name="connsiteX32" fmla="*/ 727710 w 771573"/>
                <a:gd name="connsiteY32" fmla="*/ 137520 h 288268"/>
                <a:gd name="connsiteX33" fmla="*/ 720090 w 771573"/>
                <a:gd name="connsiteY33" fmla="*/ 131805 h 288268"/>
                <a:gd name="connsiteX34" fmla="*/ 714375 w 771573"/>
                <a:gd name="connsiteY34" fmla="*/ 129900 h 288268"/>
                <a:gd name="connsiteX35" fmla="*/ 702945 w 771573"/>
                <a:gd name="connsiteY35" fmla="*/ 120375 h 288268"/>
                <a:gd name="connsiteX36" fmla="*/ 697230 w 771573"/>
                <a:gd name="connsiteY36" fmla="*/ 114660 h 288268"/>
                <a:gd name="connsiteX37" fmla="*/ 691515 w 771573"/>
                <a:gd name="connsiteY37" fmla="*/ 110850 h 288268"/>
                <a:gd name="connsiteX38" fmla="*/ 676275 w 771573"/>
                <a:gd name="connsiteY38" fmla="*/ 101325 h 288268"/>
                <a:gd name="connsiteX39" fmla="*/ 664845 w 771573"/>
                <a:gd name="connsiteY39" fmla="*/ 97515 h 288268"/>
                <a:gd name="connsiteX40" fmla="*/ 655320 w 771573"/>
                <a:gd name="connsiteY40" fmla="*/ 91800 h 288268"/>
                <a:gd name="connsiteX41" fmla="*/ 626745 w 771573"/>
                <a:gd name="connsiteY41" fmla="*/ 76560 h 288268"/>
                <a:gd name="connsiteX42" fmla="*/ 621030 w 771573"/>
                <a:gd name="connsiteY42" fmla="*/ 74655 h 288268"/>
                <a:gd name="connsiteX43" fmla="*/ 598170 w 771573"/>
                <a:gd name="connsiteY43" fmla="*/ 61320 h 288268"/>
                <a:gd name="connsiteX44" fmla="*/ 592455 w 771573"/>
                <a:gd name="connsiteY44" fmla="*/ 57510 h 288268"/>
                <a:gd name="connsiteX45" fmla="*/ 584835 w 771573"/>
                <a:gd name="connsiteY45" fmla="*/ 51795 h 288268"/>
                <a:gd name="connsiteX46" fmla="*/ 567690 w 771573"/>
                <a:gd name="connsiteY46" fmla="*/ 44175 h 288268"/>
                <a:gd name="connsiteX47" fmla="*/ 556260 w 771573"/>
                <a:gd name="connsiteY47" fmla="*/ 40365 h 288268"/>
                <a:gd name="connsiteX48" fmla="*/ 548640 w 771573"/>
                <a:gd name="connsiteY48" fmla="*/ 36555 h 288268"/>
                <a:gd name="connsiteX49" fmla="*/ 537210 w 771573"/>
                <a:gd name="connsiteY49" fmla="*/ 28935 h 288268"/>
                <a:gd name="connsiteX50" fmla="*/ 472440 w 771573"/>
                <a:gd name="connsiteY50" fmla="*/ 9165 h 288268"/>
                <a:gd name="connsiteX51" fmla="*/ 412430 w 771573"/>
                <a:gd name="connsiteY51" fmla="*/ 2111 h 288268"/>
                <a:gd name="connsiteX52" fmla="*/ 350052 w 771573"/>
                <a:gd name="connsiteY52" fmla="*/ 0 h 288268"/>
                <a:gd name="connsiteX53" fmla="*/ 300990 w 771573"/>
                <a:gd name="connsiteY53" fmla="*/ 4170 h 288268"/>
                <a:gd name="connsiteX54" fmla="*/ 268605 w 771573"/>
                <a:gd name="connsiteY54" fmla="*/ 11790 h 288268"/>
                <a:gd name="connsiteX55" fmla="*/ 226695 w 771573"/>
                <a:gd name="connsiteY55" fmla="*/ 28935 h 288268"/>
                <a:gd name="connsiteX56" fmla="*/ 182880 w 771573"/>
                <a:gd name="connsiteY56" fmla="*/ 55605 h 288268"/>
                <a:gd name="connsiteX57" fmla="*/ 123825 w 771573"/>
                <a:gd name="connsiteY57" fmla="*/ 97515 h 288268"/>
                <a:gd name="connsiteX58" fmla="*/ 87630 w 771573"/>
                <a:gd name="connsiteY58" fmla="*/ 127995 h 288268"/>
                <a:gd name="connsiteX59" fmla="*/ 55245 w 771573"/>
                <a:gd name="connsiteY59" fmla="*/ 160380 h 288268"/>
                <a:gd name="connsiteX60" fmla="*/ 20955 w 771573"/>
                <a:gd name="connsiteY60" fmla="*/ 206100 h 288268"/>
                <a:gd name="connsiteX61" fmla="*/ 0 w 771573"/>
                <a:gd name="connsiteY61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83880 w 771573"/>
                <a:gd name="connsiteY13" fmla="*/ 130001 h 288268"/>
                <a:gd name="connsiteX14" fmla="*/ 628650 w 771573"/>
                <a:gd name="connsiteY14" fmla="*/ 169905 h 288268"/>
                <a:gd name="connsiteX15" fmla="*/ 667218 w 771573"/>
                <a:gd name="connsiteY15" fmla="*/ 208624 h 288268"/>
                <a:gd name="connsiteX16" fmla="*/ 697230 w 771573"/>
                <a:gd name="connsiteY16" fmla="*/ 253725 h 288268"/>
                <a:gd name="connsiteX17" fmla="*/ 710565 w 771573"/>
                <a:gd name="connsiteY17" fmla="*/ 278490 h 288268"/>
                <a:gd name="connsiteX18" fmla="*/ 727710 w 771573"/>
                <a:gd name="connsiteY18" fmla="*/ 270870 h 288268"/>
                <a:gd name="connsiteX19" fmla="*/ 741045 w 771573"/>
                <a:gd name="connsiteY19" fmla="*/ 257535 h 288268"/>
                <a:gd name="connsiteX20" fmla="*/ 746760 w 771573"/>
                <a:gd name="connsiteY20" fmla="*/ 251820 h 288268"/>
                <a:gd name="connsiteX21" fmla="*/ 754380 w 771573"/>
                <a:gd name="connsiteY21" fmla="*/ 246105 h 288268"/>
                <a:gd name="connsiteX22" fmla="*/ 762000 w 771573"/>
                <a:gd name="connsiteY22" fmla="*/ 242295 h 288268"/>
                <a:gd name="connsiteX23" fmla="*/ 767715 w 771573"/>
                <a:gd name="connsiteY23" fmla="*/ 238485 h 288268"/>
                <a:gd name="connsiteX24" fmla="*/ 771525 w 771573"/>
                <a:gd name="connsiteY24" fmla="*/ 232770 h 288268"/>
                <a:gd name="connsiteX25" fmla="*/ 765810 w 771573"/>
                <a:gd name="connsiteY25" fmla="*/ 202290 h 288268"/>
                <a:gd name="connsiteX26" fmla="*/ 762000 w 771573"/>
                <a:gd name="connsiteY26" fmla="*/ 196575 h 288268"/>
                <a:gd name="connsiteX27" fmla="*/ 756285 w 771573"/>
                <a:gd name="connsiteY27" fmla="*/ 183240 h 288268"/>
                <a:gd name="connsiteX28" fmla="*/ 748665 w 771573"/>
                <a:gd name="connsiteY28" fmla="*/ 168000 h 288268"/>
                <a:gd name="connsiteX29" fmla="*/ 739140 w 771573"/>
                <a:gd name="connsiteY29" fmla="*/ 154665 h 288268"/>
                <a:gd name="connsiteX30" fmla="*/ 737235 w 771573"/>
                <a:gd name="connsiteY30" fmla="*/ 148950 h 288268"/>
                <a:gd name="connsiteX31" fmla="*/ 727710 w 771573"/>
                <a:gd name="connsiteY31" fmla="*/ 137520 h 288268"/>
                <a:gd name="connsiteX32" fmla="*/ 720090 w 771573"/>
                <a:gd name="connsiteY32" fmla="*/ 131805 h 288268"/>
                <a:gd name="connsiteX33" fmla="*/ 714375 w 771573"/>
                <a:gd name="connsiteY33" fmla="*/ 129900 h 288268"/>
                <a:gd name="connsiteX34" fmla="*/ 702945 w 771573"/>
                <a:gd name="connsiteY34" fmla="*/ 120375 h 288268"/>
                <a:gd name="connsiteX35" fmla="*/ 697230 w 771573"/>
                <a:gd name="connsiteY35" fmla="*/ 114660 h 288268"/>
                <a:gd name="connsiteX36" fmla="*/ 691515 w 771573"/>
                <a:gd name="connsiteY36" fmla="*/ 110850 h 288268"/>
                <a:gd name="connsiteX37" fmla="*/ 676275 w 771573"/>
                <a:gd name="connsiteY37" fmla="*/ 101325 h 288268"/>
                <a:gd name="connsiteX38" fmla="*/ 664845 w 771573"/>
                <a:gd name="connsiteY38" fmla="*/ 97515 h 288268"/>
                <a:gd name="connsiteX39" fmla="*/ 655320 w 771573"/>
                <a:gd name="connsiteY39" fmla="*/ 91800 h 288268"/>
                <a:gd name="connsiteX40" fmla="*/ 626745 w 771573"/>
                <a:gd name="connsiteY40" fmla="*/ 76560 h 288268"/>
                <a:gd name="connsiteX41" fmla="*/ 621030 w 771573"/>
                <a:gd name="connsiteY41" fmla="*/ 74655 h 288268"/>
                <a:gd name="connsiteX42" fmla="*/ 598170 w 771573"/>
                <a:gd name="connsiteY42" fmla="*/ 61320 h 288268"/>
                <a:gd name="connsiteX43" fmla="*/ 592455 w 771573"/>
                <a:gd name="connsiteY43" fmla="*/ 57510 h 288268"/>
                <a:gd name="connsiteX44" fmla="*/ 584835 w 771573"/>
                <a:gd name="connsiteY44" fmla="*/ 51795 h 288268"/>
                <a:gd name="connsiteX45" fmla="*/ 567690 w 771573"/>
                <a:gd name="connsiteY45" fmla="*/ 44175 h 288268"/>
                <a:gd name="connsiteX46" fmla="*/ 556260 w 771573"/>
                <a:gd name="connsiteY46" fmla="*/ 40365 h 288268"/>
                <a:gd name="connsiteX47" fmla="*/ 548640 w 771573"/>
                <a:gd name="connsiteY47" fmla="*/ 36555 h 288268"/>
                <a:gd name="connsiteX48" fmla="*/ 537210 w 771573"/>
                <a:gd name="connsiteY48" fmla="*/ 28935 h 288268"/>
                <a:gd name="connsiteX49" fmla="*/ 472440 w 771573"/>
                <a:gd name="connsiteY49" fmla="*/ 9165 h 288268"/>
                <a:gd name="connsiteX50" fmla="*/ 412430 w 771573"/>
                <a:gd name="connsiteY50" fmla="*/ 2111 h 288268"/>
                <a:gd name="connsiteX51" fmla="*/ 350052 w 771573"/>
                <a:gd name="connsiteY51" fmla="*/ 0 h 288268"/>
                <a:gd name="connsiteX52" fmla="*/ 300990 w 771573"/>
                <a:gd name="connsiteY52" fmla="*/ 4170 h 288268"/>
                <a:gd name="connsiteX53" fmla="*/ 268605 w 771573"/>
                <a:gd name="connsiteY53" fmla="*/ 11790 h 288268"/>
                <a:gd name="connsiteX54" fmla="*/ 226695 w 771573"/>
                <a:gd name="connsiteY54" fmla="*/ 28935 h 288268"/>
                <a:gd name="connsiteX55" fmla="*/ 182880 w 771573"/>
                <a:gd name="connsiteY55" fmla="*/ 55605 h 288268"/>
                <a:gd name="connsiteX56" fmla="*/ 123825 w 771573"/>
                <a:gd name="connsiteY56" fmla="*/ 97515 h 288268"/>
                <a:gd name="connsiteX57" fmla="*/ 87630 w 771573"/>
                <a:gd name="connsiteY57" fmla="*/ 127995 h 288268"/>
                <a:gd name="connsiteX58" fmla="*/ 55245 w 771573"/>
                <a:gd name="connsiteY58" fmla="*/ 160380 h 288268"/>
                <a:gd name="connsiteX59" fmla="*/ 20955 w 771573"/>
                <a:gd name="connsiteY59" fmla="*/ 206100 h 288268"/>
                <a:gd name="connsiteX60" fmla="*/ 0 w 771573"/>
                <a:gd name="connsiteY60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83880 w 771573"/>
                <a:gd name="connsiteY13" fmla="*/ 130001 h 288268"/>
                <a:gd name="connsiteX14" fmla="*/ 628650 w 771573"/>
                <a:gd name="connsiteY14" fmla="*/ 169905 h 288268"/>
                <a:gd name="connsiteX15" fmla="*/ 667218 w 771573"/>
                <a:gd name="connsiteY15" fmla="*/ 208624 h 288268"/>
                <a:gd name="connsiteX16" fmla="*/ 710565 w 771573"/>
                <a:gd name="connsiteY16" fmla="*/ 278490 h 288268"/>
                <a:gd name="connsiteX17" fmla="*/ 727710 w 771573"/>
                <a:gd name="connsiteY17" fmla="*/ 270870 h 288268"/>
                <a:gd name="connsiteX18" fmla="*/ 741045 w 771573"/>
                <a:gd name="connsiteY18" fmla="*/ 257535 h 288268"/>
                <a:gd name="connsiteX19" fmla="*/ 746760 w 771573"/>
                <a:gd name="connsiteY19" fmla="*/ 251820 h 288268"/>
                <a:gd name="connsiteX20" fmla="*/ 754380 w 771573"/>
                <a:gd name="connsiteY20" fmla="*/ 246105 h 288268"/>
                <a:gd name="connsiteX21" fmla="*/ 762000 w 771573"/>
                <a:gd name="connsiteY21" fmla="*/ 242295 h 288268"/>
                <a:gd name="connsiteX22" fmla="*/ 767715 w 771573"/>
                <a:gd name="connsiteY22" fmla="*/ 238485 h 288268"/>
                <a:gd name="connsiteX23" fmla="*/ 771525 w 771573"/>
                <a:gd name="connsiteY23" fmla="*/ 232770 h 288268"/>
                <a:gd name="connsiteX24" fmla="*/ 765810 w 771573"/>
                <a:gd name="connsiteY24" fmla="*/ 202290 h 288268"/>
                <a:gd name="connsiteX25" fmla="*/ 762000 w 771573"/>
                <a:gd name="connsiteY25" fmla="*/ 196575 h 288268"/>
                <a:gd name="connsiteX26" fmla="*/ 756285 w 771573"/>
                <a:gd name="connsiteY26" fmla="*/ 183240 h 288268"/>
                <a:gd name="connsiteX27" fmla="*/ 748665 w 771573"/>
                <a:gd name="connsiteY27" fmla="*/ 168000 h 288268"/>
                <a:gd name="connsiteX28" fmla="*/ 739140 w 771573"/>
                <a:gd name="connsiteY28" fmla="*/ 154665 h 288268"/>
                <a:gd name="connsiteX29" fmla="*/ 737235 w 771573"/>
                <a:gd name="connsiteY29" fmla="*/ 148950 h 288268"/>
                <a:gd name="connsiteX30" fmla="*/ 727710 w 771573"/>
                <a:gd name="connsiteY30" fmla="*/ 137520 h 288268"/>
                <a:gd name="connsiteX31" fmla="*/ 720090 w 771573"/>
                <a:gd name="connsiteY31" fmla="*/ 131805 h 288268"/>
                <a:gd name="connsiteX32" fmla="*/ 714375 w 771573"/>
                <a:gd name="connsiteY32" fmla="*/ 129900 h 288268"/>
                <a:gd name="connsiteX33" fmla="*/ 702945 w 771573"/>
                <a:gd name="connsiteY33" fmla="*/ 120375 h 288268"/>
                <a:gd name="connsiteX34" fmla="*/ 697230 w 771573"/>
                <a:gd name="connsiteY34" fmla="*/ 114660 h 288268"/>
                <a:gd name="connsiteX35" fmla="*/ 691515 w 771573"/>
                <a:gd name="connsiteY35" fmla="*/ 110850 h 288268"/>
                <a:gd name="connsiteX36" fmla="*/ 676275 w 771573"/>
                <a:gd name="connsiteY36" fmla="*/ 101325 h 288268"/>
                <a:gd name="connsiteX37" fmla="*/ 664845 w 771573"/>
                <a:gd name="connsiteY37" fmla="*/ 97515 h 288268"/>
                <a:gd name="connsiteX38" fmla="*/ 655320 w 771573"/>
                <a:gd name="connsiteY38" fmla="*/ 91800 h 288268"/>
                <a:gd name="connsiteX39" fmla="*/ 626745 w 771573"/>
                <a:gd name="connsiteY39" fmla="*/ 76560 h 288268"/>
                <a:gd name="connsiteX40" fmla="*/ 621030 w 771573"/>
                <a:gd name="connsiteY40" fmla="*/ 74655 h 288268"/>
                <a:gd name="connsiteX41" fmla="*/ 598170 w 771573"/>
                <a:gd name="connsiteY41" fmla="*/ 61320 h 288268"/>
                <a:gd name="connsiteX42" fmla="*/ 592455 w 771573"/>
                <a:gd name="connsiteY42" fmla="*/ 57510 h 288268"/>
                <a:gd name="connsiteX43" fmla="*/ 584835 w 771573"/>
                <a:gd name="connsiteY43" fmla="*/ 51795 h 288268"/>
                <a:gd name="connsiteX44" fmla="*/ 567690 w 771573"/>
                <a:gd name="connsiteY44" fmla="*/ 44175 h 288268"/>
                <a:gd name="connsiteX45" fmla="*/ 556260 w 771573"/>
                <a:gd name="connsiteY45" fmla="*/ 40365 h 288268"/>
                <a:gd name="connsiteX46" fmla="*/ 548640 w 771573"/>
                <a:gd name="connsiteY46" fmla="*/ 36555 h 288268"/>
                <a:gd name="connsiteX47" fmla="*/ 537210 w 771573"/>
                <a:gd name="connsiteY47" fmla="*/ 28935 h 288268"/>
                <a:gd name="connsiteX48" fmla="*/ 472440 w 771573"/>
                <a:gd name="connsiteY48" fmla="*/ 9165 h 288268"/>
                <a:gd name="connsiteX49" fmla="*/ 412430 w 771573"/>
                <a:gd name="connsiteY49" fmla="*/ 2111 h 288268"/>
                <a:gd name="connsiteX50" fmla="*/ 350052 w 771573"/>
                <a:gd name="connsiteY50" fmla="*/ 0 h 288268"/>
                <a:gd name="connsiteX51" fmla="*/ 300990 w 771573"/>
                <a:gd name="connsiteY51" fmla="*/ 4170 h 288268"/>
                <a:gd name="connsiteX52" fmla="*/ 268605 w 771573"/>
                <a:gd name="connsiteY52" fmla="*/ 11790 h 288268"/>
                <a:gd name="connsiteX53" fmla="*/ 226695 w 771573"/>
                <a:gd name="connsiteY53" fmla="*/ 28935 h 288268"/>
                <a:gd name="connsiteX54" fmla="*/ 182880 w 771573"/>
                <a:gd name="connsiteY54" fmla="*/ 55605 h 288268"/>
                <a:gd name="connsiteX55" fmla="*/ 123825 w 771573"/>
                <a:gd name="connsiteY55" fmla="*/ 97515 h 288268"/>
                <a:gd name="connsiteX56" fmla="*/ 87630 w 771573"/>
                <a:gd name="connsiteY56" fmla="*/ 127995 h 288268"/>
                <a:gd name="connsiteX57" fmla="*/ 55245 w 771573"/>
                <a:gd name="connsiteY57" fmla="*/ 160380 h 288268"/>
                <a:gd name="connsiteX58" fmla="*/ 20955 w 771573"/>
                <a:gd name="connsiteY58" fmla="*/ 206100 h 288268"/>
                <a:gd name="connsiteX59" fmla="*/ 0 w 771573"/>
                <a:gd name="connsiteY59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83880 w 771573"/>
                <a:gd name="connsiteY13" fmla="*/ 130001 h 288268"/>
                <a:gd name="connsiteX14" fmla="*/ 628650 w 771573"/>
                <a:gd name="connsiteY14" fmla="*/ 169905 h 288268"/>
                <a:gd name="connsiteX15" fmla="*/ 667218 w 771573"/>
                <a:gd name="connsiteY15" fmla="*/ 208624 h 288268"/>
                <a:gd name="connsiteX16" fmla="*/ 709137 w 771573"/>
                <a:gd name="connsiteY16" fmla="*/ 271695 h 288268"/>
                <a:gd name="connsiteX17" fmla="*/ 727710 w 771573"/>
                <a:gd name="connsiteY17" fmla="*/ 270870 h 288268"/>
                <a:gd name="connsiteX18" fmla="*/ 741045 w 771573"/>
                <a:gd name="connsiteY18" fmla="*/ 257535 h 288268"/>
                <a:gd name="connsiteX19" fmla="*/ 746760 w 771573"/>
                <a:gd name="connsiteY19" fmla="*/ 251820 h 288268"/>
                <a:gd name="connsiteX20" fmla="*/ 754380 w 771573"/>
                <a:gd name="connsiteY20" fmla="*/ 246105 h 288268"/>
                <a:gd name="connsiteX21" fmla="*/ 762000 w 771573"/>
                <a:gd name="connsiteY21" fmla="*/ 242295 h 288268"/>
                <a:gd name="connsiteX22" fmla="*/ 767715 w 771573"/>
                <a:gd name="connsiteY22" fmla="*/ 238485 h 288268"/>
                <a:gd name="connsiteX23" fmla="*/ 771525 w 771573"/>
                <a:gd name="connsiteY23" fmla="*/ 232770 h 288268"/>
                <a:gd name="connsiteX24" fmla="*/ 765810 w 771573"/>
                <a:gd name="connsiteY24" fmla="*/ 202290 h 288268"/>
                <a:gd name="connsiteX25" fmla="*/ 762000 w 771573"/>
                <a:gd name="connsiteY25" fmla="*/ 196575 h 288268"/>
                <a:gd name="connsiteX26" fmla="*/ 756285 w 771573"/>
                <a:gd name="connsiteY26" fmla="*/ 183240 h 288268"/>
                <a:gd name="connsiteX27" fmla="*/ 748665 w 771573"/>
                <a:gd name="connsiteY27" fmla="*/ 168000 h 288268"/>
                <a:gd name="connsiteX28" fmla="*/ 739140 w 771573"/>
                <a:gd name="connsiteY28" fmla="*/ 154665 h 288268"/>
                <a:gd name="connsiteX29" fmla="*/ 737235 w 771573"/>
                <a:gd name="connsiteY29" fmla="*/ 148950 h 288268"/>
                <a:gd name="connsiteX30" fmla="*/ 727710 w 771573"/>
                <a:gd name="connsiteY30" fmla="*/ 137520 h 288268"/>
                <a:gd name="connsiteX31" fmla="*/ 720090 w 771573"/>
                <a:gd name="connsiteY31" fmla="*/ 131805 h 288268"/>
                <a:gd name="connsiteX32" fmla="*/ 714375 w 771573"/>
                <a:gd name="connsiteY32" fmla="*/ 129900 h 288268"/>
                <a:gd name="connsiteX33" fmla="*/ 702945 w 771573"/>
                <a:gd name="connsiteY33" fmla="*/ 120375 h 288268"/>
                <a:gd name="connsiteX34" fmla="*/ 697230 w 771573"/>
                <a:gd name="connsiteY34" fmla="*/ 114660 h 288268"/>
                <a:gd name="connsiteX35" fmla="*/ 691515 w 771573"/>
                <a:gd name="connsiteY35" fmla="*/ 110850 h 288268"/>
                <a:gd name="connsiteX36" fmla="*/ 676275 w 771573"/>
                <a:gd name="connsiteY36" fmla="*/ 101325 h 288268"/>
                <a:gd name="connsiteX37" fmla="*/ 664845 w 771573"/>
                <a:gd name="connsiteY37" fmla="*/ 97515 h 288268"/>
                <a:gd name="connsiteX38" fmla="*/ 655320 w 771573"/>
                <a:gd name="connsiteY38" fmla="*/ 91800 h 288268"/>
                <a:gd name="connsiteX39" fmla="*/ 626745 w 771573"/>
                <a:gd name="connsiteY39" fmla="*/ 76560 h 288268"/>
                <a:gd name="connsiteX40" fmla="*/ 621030 w 771573"/>
                <a:gd name="connsiteY40" fmla="*/ 74655 h 288268"/>
                <a:gd name="connsiteX41" fmla="*/ 598170 w 771573"/>
                <a:gd name="connsiteY41" fmla="*/ 61320 h 288268"/>
                <a:gd name="connsiteX42" fmla="*/ 592455 w 771573"/>
                <a:gd name="connsiteY42" fmla="*/ 57510 h 288268"/>
                <a:gd name="connsiteX43" fmla="*/ 584835 w 771573"/>
                <a:gd name="connsiteY43" fmla="*/ 51795 h 288268"/>
                <a:gd name="connsiteX44" fmla="*/ 567690 w 771573"/>
                <a:gd name="connsiteY44" fmla="*/ 44175 h 288268"/>
                <a:gd name="connsiteX45" fmla="*/ 556260 w 771573"/>
                <a:gd name="connsiteY45" fmla="*/ 40365 h 288268"/>
                <a:gd name="connsiteX46" fmla="*/ 548640 w 771573"/>
                <a:gd name="connsiteY46" fmla="*/ 36555 h 288268"/>
                <a:gd name="connsiteX47" fmla="*/ 537210 w 771573"/>
                <a:gd name="connsiteY47" fmla="*/ 28935 h 288268"/>
                <a:gd name="connsiteX48" fmla="*/ 472440 w 771573"/>
                <a:gd name="connsiteY48" fmla="*/ 9165 h 288268"/>
                <a:gd name="connsiteX49" fmla="*/ 412430 w 771573"/>
                <a:gd name="connsiteY49" fmla="*/ 2111 h 288268"/>
                <a:gd name="connsiteX50" fmla="*/ 350052 w 771573"/>
                <a:gd name="connsiteY50" fmla="*/ 0 h 288268"/>
                <a:gd name="connsiteX51" fmla="*/ 300990 w 771573"/>
                <a:gd name="connsiteY51" fmla="*/ 4170 h 288268"/>
                <a:gd name="connsiteX52" fmla="*/ 268605 w 771573"/>
                <a:gd name="connsiteY52" fmla="*/ 11790 h 288268"/>
                <a:gd name="connsiteX53" fmla="*/ 226695 w 771573"/>
                <a:gd name="connsiteY53" fmla="*/ 28935 h 288268"/>
                <a:gd name="connsiteX54" fmla="*/ 182880 w 771573"/>
                <a:gd name="connsiteY54" fmla="*/ 55605 h 288268"/>
                <a:gd name="connsiteX55" fmla="*/ 123825 w 771573"/>
                <a:gd name="connsiteY55" fmla="*/ 97515 h 288268"/>
                <a:gd name="connsiteX56" fmla="*/ 87630 w 771573"/>
                <a:gd name="connsiteY56" fmla="*/ 127995 h 288268"/>
                <a:gd name="connsiteX57" fmla="*/ 55245 w 771573"/>
                <a:gd name="connsiteY57" fmla="*/ 160380 h 288268"/>
                <a:gd name="connsiteX58" fmla="*/ 20955 w 771573"/>
                <a:gd name="connsiteY58" fmla="*/ 206100 h 288268"/>
                <a:gd name="connsiteX59" fmla="*/ 0 w 771573"/>
                <a:gd name="connsiteY59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83880 w 771573"/>
                <a:gd name="connsiteY13" fmla="*/ 130001 h 288268"/>
                <a:gd name="connsiteX14" fmla="*/ 628650 w 771573"/>
                <a:gd name="connsiteY14" fmla="*/ 169905 h 288268"/>
                <a:gd name="connsiteX15" fmla="*/ 667218 w 771573"/>
                <a:gd name="connsiteY15" fmla="*/ 208624 h 288268"/>
                <a:gd name="connsiteX16" fmla="*/ 709137 w 771573"/>
                <a:gd name="connsiteY16" fmla="*/ 271695 h 288268"/>
                <a:gd name="connsiteX17" fmla="*/ 727710 w 771573"/>
                <a:gd name="connsiteY17" fmla="*/ 270870 h 288268"/>
                <a:gd name="connsiteX18" fmla="*/ 741045 w 771573"/>
                <a:gd name="connsiteY18" fmla="*/ 257535 h 288268"/>
                <a:gd name="connsiteX19" fmla="*/ 746760 w 771573"/>
                <a:gd name="connsiteY19" fmla="*/ 251820 h 288268"/>
                <a:gd name="connsiteX20" fmla="*/ 762000 w 771573"/>
                <a:gd name="connsiteY20" fmla="*/ 242295 h 288268"/>
                <a:gd name="connsiteX21" fmla="*/ 767715 w 771573"/>
                <a:gd name="connsiteY21" fmla="*/ 238485 h 288268"/>
                <a:gd name="connsiteX22" fmla="*/ 771525 w 771573"/>
                <a:gd name="connsiteY22" fmla="*/ 232770 h 288268"/>
                <a:gd name="connsiteX23" fmla="*/ 765810 w 771573"/>
                <a:gd name="connsiteY23" fmla="*/ 202290 h 288268"/>
                <a:gd name="connsiteX24" fmla="*/ 762000 w 771573"/>
                <a:gd name="connsiteY24" fmla="*/ 196575 h 288268"/>
                <a:gd name="connsiteX25" fmla="*/ 756285 w 771573"/>
                <a:gd name="connsiteY25" fmla="*/ 183240 h 288268"/>
                <a:gd name="connsiteX26" fmla="*/ 748665 w 771573"/>
                <a:gd name="connsiteY26" fmla="*/ 168000 h 288268"/>
                <a:gd name="connsiteX27" fmla="*/ 739140 w 771573"/>
                <a:gd name="connsiteY27" fmla="*/ 154665 h 288268"/>
                <a:gd name="connsiteX28" fmla="*/ 737235 w 771573"/>
                <a:gd name="connsiteY28" fmla="*/ 148950 h 288268"/>
                <a:gd name="connsiteX29" fmla="*/ 727710 w 771573"/>
                <a:gd name="connsiteY29" fmla="*/ 137520 h 288268"/>
                <a:gd name="connsiteX30" fmla="*/ 720090 w 771573"/>
                <a:gd name="connsiteY30" fmla="*/ 131805 h 288268"/>
                <a:gd name="connsiteX31" fmla="*/ 714375 w 771573"/>
                <a:gd name="connsiteY31" fmla="*/ 129900 h 288268"/>
                <a:gd name="connsiteX32" fmla="*/ 702945 w 771573"/>
                <a:gd name="connsiteY32" fmla="*/ 120375 h 288268"/>
                <a:gd name="connsiteX33" fmla="*/ 697230 w 771573"/>
                <a:gd name="connsiteY33" fmla="*/ 114660 h 288268"/>
                <a:gd name="connsiteX34" fmla="*/ 691515 w 771573"/>
                <a:gd name="connsiteY34" fmla="*/ 110850 h 288268"/>
                <a:gd name="connsiteX35" fmla="*/ 676275 w 771573"/>
                <a:gd name="connsiteY35" fmla="*/ 101325 h 288268"/>
                <a:gd name="connsiteX36" fmla="*/ 664845 w 771573"/>
                <a:gd name="connsiteY36" fmla="*/ 97515 h 288268"/>
                <a:gd name="connsiteX37" fmla="*/ 655320 w 771573"/>
                <a:gd name="connsiteY37" fmla="*/ 91800 h 288268"/>
                <a:gd name="connsiteX38" fmla="*/ 626745 w 771573"/>
                <a:gd name="connsiteY38" fmla="*/ 76560 h 288268"/>
                <a:gd name="connsiteX39" fmla="*/ 621030 w 771573"/>
                <a:gd name="connsiteY39" fmla="*/ 74655 h 288268"/>
                <a:gd name="connsiteX40" fmla="*/ 598170 w 771573"/>
                <a:gd name="connsiteY40" fmla="*/ 61320 h 288268"/>
                <a:gd name="connsiteX41" fmla="*/ 592455 w 771573"/>
                <a:gd name="connsiteY41" fmla="*/ 57510 h 288268"/>
                <a:gd name="connsiteX42" fmla="*/ 584835 w 771573"/>
                <a:gd name="connsiteY42" fmla="*/ 51795 h 288268"/>
                <a:gd name="connsiteX43" fmla="*/ 567690 w 771573"/>
                <a:gd name="connsiteY43" fmla="*/ 44175 h 288268"/>
                <a:gd name="connsiteX44" fmla="*/ 556260 w 771573"/>
                <a:gd name="connsiteY44" fmla="*/ 40365 h 288268"/>
                <a:gd name="connsiteX45" fmla="*/ 548640 w 771573"/>
                <a:gd name="connsiteY45" fmla="*/ 36555 h 288268"/>
                <a:gd name="connsiteX46" fmla="*/ 537210 w 771573"/>
                <a:gd name="connsiteY46" fmla="*/ 28935 h 288268"/>
                <a:gd name="connsiteX47" fmla="*/ 472440 w 771573"/>
                <a:gd name="connsiteY47" fmla="*/ 9165 h 288268"/>
                <a:gd name="connsiteX48" fmla="*/ 412430 w 771573"/>
                <a:gd name="connsiteY48" fmla="*/ 2111 h 288268"/>
                <a:gd name="connsiteX49" fmla="*/ 350052 w 771573"/>
                <a:gd name="connsiteY49" fmla="*/ 0 h 288268"/>
                <a:gd name="connsiteX50" fmla="*/ 300990 w 771573"/>
                <a:gd name="connsiteY50" fmla="*/ 4170 h 288268"/>
                <a:gd name="connsiteX51" fmla="*/ 268605 w 771573"/>
                <a:gd name="connsiteY51" fmla="*/ 11790 h 288268"/>
                <a:gd name="connsiteX52" fmla="*/ 226695 w 771573"/>
                <a:gd name="connsiteY52" fmla="*/ 28935 h 288268"/>
                <a:gd name="connsiteX53" fmla="*/ 182880 w 771573"/>
                <a:gd name="connsiteY53" fmla="*/ 55605 h 288268"/>
                <a:gd name="connsiteX54" fmla="*/ 123825 w 771573"/>
                <a:gd name="connsiteY54" fmla="*/ 97515 h 288268"/>
                <a:gd name="connsiteX55" fmla="*/ 87630 w 771573"/>
                <a:gd name="connsiteY55" fmla="*/ 127995 h 288268"/>
                <a:gd name="connsiteX56" fmla="*/ 55245 w 771573"/>
                <a:gd name="connsiteY56" fmla="*/ 160380 h 288268"/>
                <a:gd name="connsiteX57" fmla="*/ 20955 w 771573"/>
                <a:gd name="connsiteY57" fmla="*/ 206100 h 288268"/>
                <a:gd name="connsiteX58" fmla="*/ 0 w 771573"/>
                <a:gd name="connsiteY58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83880 w 771573"/>
                <a:gd name="connsiteY13" fmla="*/ 130001 h 288268"/>
                <a:gd name="connsiteX14" fmla="*/ 628650 w 771573"/>
                <a:gd name="connsiteY14" fmla="*/ 169905 h 288268"/>
                <a:gd name="connsiteX15" fmla="*/ 667218 w 771573"/>
                <a:gd name="connsiteY15" fmla="*/ 208624 h 288268"/>
                <a:gd name="connsiteX16" fmla="*/ 709137 w 771573"/>
                <a:gd name="connsiteY16" fmla="*/ 271695 h 288268"/>
                <a:gd name="connsiteX17" fmla="*/ 727710 w 771573"/>
                <a:gd name="connsiteY17" fmla="*/ 270870 h 288268"/>
                <a:gd name="connsiteX18" fmla="*/ 741045 w 771573"/>
                <a:gd name="connsiteY18" fmla="*/ 257535 h 288268"/>
                <a:gd name="connsiteX19" fmla="*/ 762000 w 771573"/>
                <a:gd name="connsiteY19" fmla="*/ 242295 h 288268"/>
                <a:gd name="connsiteX20" fmla="*/ 767715 w 771573"/>
                <a:gd name="connsiteY20" fmla="*/ 238485 h 288268"/>
                <a:gd name="connsiteX21" fmla="*/ 771525 w 771573"/>
                <a:gd name="connsiteY21" fmla="*/ 232770 h 288268"/>
                <a:gd name="connsiteX22" fmla="*/ 765810 w 771573"/>
                <a:gd name="connsiteY22" fmla="*/ 202290 h 288268"/>
                <a:gd name="connsiteX23" fmla="*/ 762000 w 771573"/>
                <a:gd name="connsiteY23" fmla="*/ 196575 h 288268"/>
                <a:gd name="connsiteX24" fmla="*/ 756285 w 771573"/>
                <a:gd name="connsiteY24" fmla="*/ 183240 h 288268"/>
                <a:gd name="connsiteX25" fmla="*/ 748665 w 771573"/>
                <a:gd name="connsiteY25" fmla="*/ 168000 h 288268"/>
                <a:gd name="connsiteX26" fmla="*/ 739140 w 771573"/>
                <a:gd name="connsiteY26" fmla="*/ 154665 h 288268"/>
                <a:gd name="connsiteX27" fmla="*/ 737235 w 771573"/>
                <a:gd name="connsiteY27" fmla="*/ 148950 h 288268"/>
                <a:gd name="connsiteX28" fmla="*/ 727710 w 771573"/>
                <a:gd name="connsiteY28" fmla="*/ 137520 h 288268"/>
                <a:gd name="connsiteX29" fmla="*/ 720090 w 771573"/>
                <a:gd name="connsiteY29" fmla="*/ 131805 h 288268"/>
                <a:gd name="connsiteX30" fmla="*/ 714375 w 771573"/>
                <a:gd name="connsiteY30" fmla="*/ 129900 h 288268"/>
                <a:gd name="connsiteX31" fmla="*/ 702945 w 771573"/>
                <a:gd name="connsiteY31" fmla="*/ 120375 h 288268"/>
                <a:gd name="connsiteX32" fmla="*/ 697230 w 771573"/>
                <a:gd name="connsiteY32" fmla="*/ 114660 h 288268"/>
                <a:gd name="connsiteX33" fmla="*/ 691515 w 771573"/>
                <a:gd name="connsiteY33" fmla="*/ 110850 h 288268"/>
                <a:gd name="connsiteX34" fmla="*/ 676275 w 771573"/>
                <a:gd name="connsiteY34" fmla="*/ 101325 h 288268"/>
                <a:gd name="connsiteX35" fmla="*/ 664845 w 771573"/>
                <a:gd name="connsiteY35" fmla="*/ 97515 h 288268"/>
                <a:gd name="connsiteX36" fmla="*/ 655320 w 771573"/>
                <a:gd name="connsiteY36" fmla="*/ 91800 h 288268"/>
                <a:gd name="connsiteX37" fmla="*/ 626745 w 771573"/>
                <a:gd name="connsiteY37" fmla="*/ 76560 h 288268"/>
                <a:gd name="connsiteX38" fmla="*/ 621030 w 771573"/>
                <a:gd name="connsiteY38" fmla="*/ 74655 h 288268"/>
                <a:gd name="connsiteX39" fmla="*/ 598170 w 771573"/>
                <a:gd name="connsiteY39" fmla="*/ 61320 h 288268"/>
                <a:gd name="connsiteX40" fmla="*/ 592455 w 771573"/>
                <a:gd name="connsiteY40" fmla="*/ 57510 h 288268"/>
                <a:gd name="connsiteX41" fmla="*/ 584835 w 771573"/>
                <a:gd name="connsiteY41" fmla="*/ 51795 h 288268"/>
                <a:gd name="connsiteX42" fmla="*/ 567690 w 771573"/>
                <a:gd name="connsiteY42" fmla="*/ 44175 h 288268"/>
                <a:gd name="connsiteX43" fmla="*/ 556260 w 771573"/>
                <a:gd name="connsiteY43" fmla="*/ 40365 h 288268"/>
                <a:gd name="connsiteX44" fmla="*/ 548640 w 771573"/>
                <a:gd name="connsiteY44" fmla="*/ 36555 h 288268"/>
                <a:gd name="connsiteX45" fmla="*/ 537210 w 771573"/>
                <a:gd name="connsiteY45" fmla="*/ 28935 h 288268"/>
                <a:gd name="connsiteX46" fmla="*/ 472440 w 771573"/>
                <a:gd name="connsiteY46" fmla="*/ 9165 h 288268"/>
                <a:gd name="connsiteX47" fmla="*/ 412430 w 771573"/>
                <a:gd name="connsiteY47" fmla="*/ 2111 h 288268"/>
                <a:gd name="connsiteX48" fmla="*/ 350052 w 771573"/>
                <a:gd name="connsiteY48" fmla="*/ 0 h 288268"/>
                <a:gd name="connsiteX49" fmla="*/ 300990 w 771573"/>
                <a:gd name="connsiteY49" fmla="*/ 4170 h 288268"/>
                <a:gd name="connsiteX50" fmla="*/ 268605 w 771573"/>
                <a:gd name="connsiteY50" fmla="*/ 11790 h 288268"/>
                <a:gd name="connsiteX51" fmla="*/ 226695 w 771573"/>
                <a:gd name="connsiteY51" fmla="*/ 28935 h 288268"/>
                <a:gd name="connsiteX52" fmla="*/ 182880 w 771573"/>
                <a:gd name="connsiteY52" fmla="*/ 55605 h 288268"/>
                <a:gd name="connsiteX53" fmla="*/ 123825 w 771573"/>
                <a:gd name="connsiteY53" fmla="*/ 97515 h 288268"/>
                <a:gd name="connsiteX54" fmla="*/ 87630 w 771573"/>
                <a:gd name="connsiteY54" fmla="*/ 127995 h 288268"/>
                <a:gd name="connsiteX55" fmla="*/ 55245 w 771573"/>
                <a:gd name="connsiteY55" fmla="*/ 160380 h 288268"/>
                <a:gd name="connsiteX56" fmla="*/ 20955 w 771573"/>
                <a:gd name="connsiteY56" fmla="*/ 206100 h 288268"/>
                <a:gd name="connsiteX57" fmla="*/ 0 w 771573"/>
                <a:gd name="connsiteY57" fmla="*/ 253725 h 288268"/>
                <a:gd name="connsiteX0" fmla="*/ 0 w 771573"/>
                <a:gd name="connsiteY0" fmla="*/ 253725 h 288268"/>
                <a:gd name="connsiteX1" fmla="*/ 19050 w 771573"/>
                <a:gd name="connsiteY1" fmla="*/ 270870 h 288268"/>
                <a:gd name="connsiteX2" fmla="*/ 45720 w 771573"/>
                <a:gd name="connsiteY2" fmla="*/ 288015 h 288268"/>
                <a:gd name="connsiteX3" fmla="*/ 66666 w 771573"/>
                <a:gd name="connsiteY3" fmla="*/ 256560 h 288268"/>
                <a:gd name="connsiteX4" fmla="*/ 112386 w 771573"/>
                <a:gd name="connsiteY4" fmla="*/ 201105 h 288268"/>
                <a:gd name="connsiteX5" fmla="*/ 171696 w 771573"/>
                <a:gd name="connsiteY5" fmla="*/ 151061 h 288268"/>
                <a:gd name="connsiteX6" fmla="*/ 244091 w 771573"/>
                <a:gd name="connsiteY6" fmla="*/ 105855 h 288268"/>
                <a:gd name="connsiteX7" fmla="*/ 282649 w 771573"/>
                <a:gd name="connsiteY7" fmla="*/ 88815 h 288268"/>
                <a:gd name="connsiteX8" fmla="*/ 324559 w 771573"/>
                <a:gd name="connsiteY8" fmla="*/ 77644 h 288268"/>
                <a:gd name="connsiteX9" fmla="*/ 382418 w 771573"/>
                <a:gd name="connsiteY9" fmla="*/ 76099 h 288268"/>
                <a:gd name="connsiteX10" fmla="*/ 456259 w 771573"/>
                <a:gd name="connsiteY10" fmla="*/ 80422 h 288268"/>
                <a:gd name="connsiteX11" fmla="*/ 531500 w 771573"/>
                <a:gd name="connsiteY11" fmla="*/ 96330 h 288268"/>
                <a:gd name="connsiteX12" fmla="*/ 550545 w 771573"/>
                <a:gd name="connsiteY12" fmla="*/ 107348 h 288268"/>
                <a:gd name="connsiteX13" fmla="*/ 583880 w 771573"/>
                <a:gd name="connsiteY13" fmla="*/ 130001 h 288268"/>
                <a:gd name="connsiteX14" fmla="*/ 628650 w 771573"/>
                <a:gd name="connsiteY14" fmla="*/ 169905 h 288268"/>
                <a:gd name="connsiteX15" fmla="*/ 667218 w 771573"/>
                <a:gd name="connsiteY15" fmla="*/ 208624 h 288268"/>
                <a:gd name="connsiteX16" fmla="*/ 709137 w 771573"/>
                <a:gd name="connsiteY16" fmla="*/ 271695 h 288268"/>
                <a:gd name="connsiteX17" fmla="*/ 727710 w 771573"/>
                <a:gd name="connsiteY17" fmla="*/ 270870 h 288268"/>
                <a:gd name="connsiteX18" fmla="*/ 762000 w 771573"/>
                <a:gd name="connsiteY18" fmla="*/ 242295 h 288268"/>
                <a:gd name="connsiteX19" fmla="*/ 767715 w 771573"/>
                <a:gd name="connsiteY19" fmla="*/ 238485 h 288268"/>
                <a:gd name="connsiteX20" fmla="*/ 771525 w 771573"/>
                <a:gd name="connsiteY20" fmla="*/ 232770 h 288268"/>
                <a:gd name="connsiteX21" fmla="*/ 765810 w 771573"/>
                <a:gd name="connsiteY21" fmla="*/ 202290 h 288268"/>
                <a:gd name="connsiteX22" fmla="*/ 762000 w 771573"/>
                <a:gd name="connsiteY22" fmla="*/ 196575 h 288268"/>
                <a:gd name="connsiteX23" fmla="*/ 756285 w 771573"/>
                <a:gd name="connsiteY23" fmla="*/ 183240 h 288268"/>
                <a:gd name="connsiteX24" fmla="*/ 748665 w 771573"/>
                <a:gd name="connsiteY24" fmla="*/ 168000 h 288268"/>
                <a:gd name="connsiteX25" fmla="*/ 739140 w 771573"/>
                <a:gd name="connsiteY25" fmla="*/ 154665 h 288268"/>
                <a:gd name="connsiteX26" fmla="*/ 737235 w 771573"/>
                <a:gd name="connsiteY26" fmla="*/ 148950 h 288268"/>
                <a:gd name="connsiteX27" fmla="*/ 727710 w 771573"/>
                <a:gd name="connsiteY27" fmla="*/ 137520 h 288268"/>
                <a:gd name="connsiteX28" fmla="*/ 720090 w 771573"/>
                <a:gd name="connsiteY28" fmla="*/ 131805 h 288268"/>
                <a:gd name="connsiteX29" fmla="*/ 714375 w 771573"/>
                <a:gd name="connsiteY29" fmla="*/ 129900 h 288268"/>
                <a:gd name="connsiteX30" fmla="*/ 702945 w 771573"/>
                <a:gd name="connsiteY30" fmla="*/ 120375 h 288268"/>
                <a:gd name="connsiteX31" fmla="*/ 697230 w 771573"/>
                <a:gd name="connsiteY31" fmla="*/ 114660 h 288268"/>
                <a:gd name="connsiteX32" fmla="*/ 691515 w 771573"/>
                <a:gd name="connsiteY32" fmla="*/ 110850 h 288268"/>
                <a:gd name="connsiteX33" fmla="*/ 676275 w 771573"/>
                <a:gd name="connsiteY33" fmla="*/ 101325 h 288268"/>
                <a:gd name="connsiteX34" fmla="*/ 664845 w 771573"/>
                <a:gd name="connsiteY34" fmla="*/ 97515 h 288268"/>
                <a:gd name="connsiteX35" fmla="*/ 655320 w 771573"/>
                <a:gd name="connsiteY35" fmla="*/ 91800 h 288268"/>
                <a:gd name="connsiteX36" fmla="*/ 626745 w 771573"/>
                <a:gd name="connsiteY36" fmla="*/ 76560 h 288268"/>
                <a:gd name="connsiteX37" fmla="*/ 621030 w 771573"/>
                <a:gd name="connsiteY37" fmla="*/ 74655 h 288268"/>
                <a:gd name="connsiteX38" fmla="*/ 598170 w 771573"/>
                <a:gd name="connsiteY38" fmla="*/ 61320 h 288268"/>
                <a:gd name="connsiteX39" fmla="*/ 592455 w 771573"/>
                <a:gd name="connsiteY39" fmla="*/ 57510 h 288268"/>
                <a:gd name="connsiteX40" fmla="*/ 584835 w 771573"/>
                <a:gd name="connsiteY40" fmla="*/ 51795 h 288268"/>
                <a:gd name="connsiteX41" fmla="*/ 567690 w 771573"/>
                <a:gd name="connsiteY41" fmla="*/ 44175 h 288268"/>
                <a:gd name="connsiteX42" fmla="*/ 556260 w 771573"/>
                <a:gd name="connsiteY42" fmla="*/ 40365 h 288268"/>
                <a:gd name="connsiteX43" fmla="*/ 548640 w 771573"/>
                <a:gd name="connsiteY43" fmla="*/ 36555 h 288268"/>
                <a:gd name="connsiteX44" fmla="*/ 537210 w 771573"/>
                <a:gd name="connsiteY44" fmla="*/ 28935 h 288268"/>
                <a:gd name="connsiteX45" fmla="*/ 472440 w 771573"/>
                <a:gd name="connsiteY45" fmla="*/ 9165 h 288268"/>
                <a:gd name="connsiteX46" fmla="*/ 412430 w 771573"/>
                <a:gd name="connsiteY46" fmla="*/ 2111 h 288268"/>
                <a:gd name="connsiteX47" fmla="*/ 350052 w 771573"/>
                <a:gd name="connsiteY47" fmla="*/ 0 h 288268"/>
                <a:gd name="connsiteX48" fmla="*/ 300990 w 771573"/>
                <a:gd name="connsiteY48" fmla="*/ 4170 h 288268"/>
                <a:gd name="connsiteX49" fmla="*/ 268605 w 771573"/>
                <a:gd name="connsiteY49" fmla="*/ 11790 h 288268"/>
                <a:gd name="connsiteX50" fmla="*/ 226695 w 771573"/>
                <a:gd name="connsiteY50" fmla="*/ 28935 h 288268"/>
                <a:gd name="connsiteX51" fmla="*/ 182880 w 771573"/>
                <a:gd name="connsiteY51" fmla="*/ 55605 h 288268"/>
                <a:gd name="connsiteX52" fmla="*/ 123825 w 771573"/>
                <a:gd name="connsiteY52" fmla="*/ 97515 h 288268"/>
                <a:gd name="connsiteX53" fmla="*/ 87630 w 771573"/>
                <a:gd name="connsiteY53" fmla="*/ 127995 h 288268"/>
                <a:gd name="connsiteX54" fmla="*/ 55245 w 771573"/>
                <a:gd name="connsiteY54" fmla="*/ 160380 h 288268"/>
                <a:gd name="connsiteX55" fmla="*/ 20955 w 771573"/>
                <a:gd name="connsiteY55" fmla="*/ 206100 h 288268"/>
                <a:gd name="connsiteX56" fmla="*/ 0 w 771573"/>
                <a:gd name="connsiteY56" fmla="*/ 253725 h 288268"/>
                <a:gd name="connsiteX0" fmla="*/ 0 w 771632"/>
                <a:gd name="connsiteY0" fmla="*/ 253725 h 288268"/>
                <a:gd name="connsiteX1" fmla="*/ 19050 w 771632"/>
                <a:gd name="connsiteY1" fmla="*/ 270870 h 288268"/>
                <a:gd name="connsiteX2" fmla="*/ 45720 w 771632"/>
                <a:gd name="connsiteY2" fmla="*/ 288015 h 288268"/>
                <a:gd name="connsiteX3" fmla="*/ 66666 w 771632"/>
                <a:gd name="connsiteY3" fmla="*/ 256560 h 288268"/>
                <a:gd name="connsiteX4" fmla="*/ 112386 w 771632"/>
                <a:gd name="connsiteY4" fmla="*/ 201105 h 288268"/>
                <a:gd name="connsiteX5" fmla="*/ 171696 w 771632"/>
                <a:gd name="connsiteY5" fmla="*/ 151061 h 288268"/>
                <a:gd name="connsiteX6" fmla="*/ 244091 w 771632"/>
                <a:gd name="connsiteY6" fmla="*/ 105855 h 288268"/>
                <a:gd name="connsiteX7" fmla="*/ 282649 w 771632"/>
                <a:gd name="connsiteY7" fmla="*/ 88815 h 288268"/>
                <a:gd name="connsiteX8" fmla="*/ 324559 w 771632"/>
                <a:gd name="connsiteY8" fmla="*/ 77644 h 288268"/>
                <a:gd name="connsiteX9" fmla="*/ 382418 w 771632"/>
                <a:gd name="connsiteY9" fmla="*/ 76099 h 288268"/>
                <a:gd name="connsiteX10" fmla="*/ 456259 w 771632"/>
                <a:gd name="connsiteY10" fmla="*/ 80422 h 288268"/>
                <a:gd name="connsiteX11" fmla="*/ 531500 w 771632"/>
                <a:gd name="connsiteY11" fmla="*/ 96330 h 288268"/>
                <a:gd name="connsiteX12" fmla="*/ 550545 w 771632"/>
                <a:gd name="connsiteY12" fmla="*/ 107348 h 288268"/>
                <a:gd name="connsiteX13" fmla="*/ 583880 w 771632"/>
                <a:gd name="connsiteY13" fmla="*/ 130001 h 288268"/>
                <a:gd name="connsiteX14" fmla="*/ 628650 w 771632"/>
                <a:gd name="connsiteY14" fmla="*/ 169905 h 288268"/>
                <a:gd name="connsiteX15" fmla="*/ 667218 w 771632"/>
                <a:gd name="connsiteY15" fmla="*/ 208624 h 288268"/>
                <a:gd name="connsiteX16" fmla="*/ 709137 w 771632"/>
                <a:gd name="connsiteY16" fmla="*/ 271695 h 288268"/>
                <a:gd name="connsiteX17" fmla="*/ 727710 w 771632"/>
                <a:gd name="connsiteY17" fmla="*/ 270870 h 288268"/>
                <a:gd name="connsiteX18" fmla="*/ 762000 w 771632"/>
                <a:gd name="connsiteY18" fmla="*/ 242295 h 288268"/>
                <a:gd name="connsiteX19" fmla="*/ 771525 w 771632"/>
                <a:gd name="connsiteY19" fmla="*/ 232770 h 288268"/>
                <a:gd name="connsiteX20" fmla="*/ 765810 w 771632"/>
                <a:gd name="connsiteY20" fmla="*/ 202290 h 288268"/>
                <a:gd name="connsiteX21" fmla="*/ 762000 w 771632"/>
                <a:gd name="connsiteY21" fmla="*/ 196575 h 288268"/>
                <a:gd name="connsiteX22" fmla="*/ 756285 w 771632"/>
                <a:gd name="connsiteY22" fmla="*/ 183240 h 288268"/>
                <a:gd name="connsiteX23" fmla="*/ 748665 w 771632"/>
                <a:gd name="connsiteY23" fmla="*/ 168000 h 288268"/>
                <a:gd name="connsiteX24" fmla="*/ 739140 w 771632"/>
                <a:gd name="connsiteY24" fmla="*/ 154665 h 288268"/>
                <a:gd name="connsiteX25" fmla="*/ 737235 w 771632"/>
                <a:gd name="connsiteY25" fmla="*/ 148950 h 288268"/>
                <a:gd name="connsiteX26" fmla="*/ 727710 w 771632"/>
                <a:gd name="connsiteY26" fmla="*/ 137520 h 288268"/>
                <a:gd name="connsiteX27" fmla="*/ 720090 w 771632"/>
                <a:gd name="connsiteY27" fmla="*/ 131805 h 288268"/>
                <a:gd name="connsiteX28" fmla="*/ 714375 w 771632"/>
                <a:gd name="connsiteY28" fmla="*/ 129900 h 288268"/>
                <a:gd name="connsiteX29" fmla="*/ 702945 w 771632"/>
                <a:gd name="connsiteY29" fmla="*/ 120375 h 288268"/>
                <a:gd name="connsiteX30" fmla="*/ 697230 w 771632"/>
                <a:gd name="connsiteY30" fmla="*/ 114660 h 288268"/>
                <a:gd name="connsiteX31" fmla="*/ 691515 w 771632"/>
                <a:gd name="connsiteY31" fmla="*/ 110850 h 288268"/>
                <a:gd name="connsiteX32" fmla="*/ 676275 w 771632"/>
                <a:gd name="connsiteY32" fmla="*/ 101325 h 288268"/>
                <a:gd name="connsiteX33" fmla="*/ 664845 w 771632"/>
                <a:gd name="connsiteY33" fmla="*/ 97515 h 288268"/>
                <a:gd name="connsiteX34" fmla="*/ 655320 w 771632"/>
                <a:gd name="connsiteY34" fmla="*/ 91800 h 288268"/>
                <a:gd name="connsiteX35" fmla="*/ 626745 w 771632"/>
                <a:gd name="connsiteY35" fmla="*/ 76560 h 288268"/>
                <a:gd name="connsiteX36" fmla="*/ 621030 w 771632"/>
                <a:gd name="connsiteY36" fmla="*/ 74655 h 288268"/>
                <a:gd name="connsiteX37" fmla="*/ 598170 w 771632"/>
                <a:gd name="connsiteY37" fmla="*/ 61320 h 288268"/>
                <a:gd name="connsiteX38" fmla="*/ 592455 w 771632"/>
                <a:gd name="connsiteY38" fmla="*/ 57510 h 288268"/>
                <a:gd name="connsiteX39" fmla="*/ 584835 w 771632"/>
                <a:gd name="connsiteY39" fmla="*/ 51795 h 288268"/>
                <a:gd name="connsiteX40" fmla="*/ 567690 w 771632"/>
                <a:gd name="connsiteY40" fmla="*/ 44175 h 288268"/>
                <a:gd name="connsiteX41" fmla="*/ 556260 w 771632"/>
                <a:gd name="connsiteY41" fmla="*/ 40365 h 288268"/>
                <a:gd name="connsiteX42" fmla="*/ 548640 w 771632"/>
                <a:gd name="connsiteY42" fmla="*/ 36555 h 288268"/>
                <a:gd name="connsiteX43" fmla="*/ 537210 w 771632"/>
                <a:gd name="connsiteY43" fmla="*/ 28935 h 288268"/>
                <a:gd name="connsiteX44" fmla="*/ 472440 w 771632"/>
                <a:gd name="connsiteY44" fmla="*/ 9165 h 288268"/>
                <a:gd name="connsiteX45" fmla="*/ 412430 w 771632"/>
                <a:gd name="connsiteY45" fmla="*/ 2111 h 288268"/>
                <a:gd name="connsiteX46" fmla="*/ 350052 w 771632"/>
                <a:gd name="connsiteY46" fmla="*/ 0 h 288268"/>
                <a:gd name="connsiteX47" fmla="*/ 300990 w 771632"/>
                <a:gd name="connsiteY47" fmla="*/ 4170 h 288268"/>
                <a:gd name="connsiteX48" fmla="*/ 268605 w 771632"/>
                <a:gd name="connsiteY48" fmla="*/ 11790 h 288268"/>
                <a:gd name="connsiteX49" fmla="*/ 226695 w 771632"/>
                <a:gd name="connsiteY49" fmla="*/ 28935 h 288268"/>
                <a:gd name="connsiteX50" fmla="*/ 182880 w 771632"/>
                <a:gd name="connsiteY50" fmla="*/ 55605 h 288268"/>
                <a:gd name="connsiteX51" fmla="*/ 123825 w 771632"/>
                <a:gd name="connsiteY51" fmla="*/ 97515 h 288268"/>
                <a:gd name="connsiteX52" fmla="*/ 87630 w 771632"/>
                <a:gd name="connsiteY52" fmla="*/ 127995 h 288268"/>
                <a:gd name="connsiteX53" fmla="*/ 55245 w 771632"/>
                <a:gd name="connsiteY53" fmla="*/ 160380 h 288268"/>
                <a:gd name="connsiteX54" fmla="*/ 20955 w 771632"/>
                <a:gd name="connsiteY54" fmla="*/ 206100 h 288268"/>
                <a:gd name="connsiteX55" fmla="*/ 0 w 771632"/>
                <a:gd name="connsiteY55" fmla="*/ 253725 h 288268"/>
                <a:gd name="connsiteX0" fmla="*/ 0 w 771632"/>
                <a:gd name="connsiteY0" fmla="*/ 253725 h 288268"/>
                <a:gd name="connsiteX1" fmla="*/ 19050 w 771632"/>
                <a:gd name="connsiteY1" fmla="*/ 270870 h 288268"/>
                <a:gd name="connsiteX2" fmla="*/ 45720 w 771632"/>
                <a:gd name="connsiteY2" fmla="*/ 288015 h 288268"/>
                <a:gd name="connsiteX3" fmla="*/ 66666 w 771632"/>
                <a:gd name="connsiteY3" fmla="*/ 256560 h 288268"/>
                <a:gd name="connsiteX4" fmla="*/ 112386 w 771632"/>
                <a:gd name="connsiteY4" fmla="*/ 201105 h 288268"/>
                <a:gd name="connsiteX5" fmla="*/ 171696 w 771632"/>
                <a:gd name="connsiteY5" fmla="*/ 151061 h 288268"/>
                <a:gd name="connsiteX6" fmla="*/ 244091 w 771632"/>
                <a:gd name="connsiteY6" fmla="*/ 105855 h 288268"/>
                <a:gd name="connsiteX7" fmla="*/ 282649 w 771632"/>
                <a:gd name="connsiteY7" fmla="*/ 88815 h 288268"/>
                <a:gd name="connsiteX8" fmla="*/ 324559 w 771632"/>
                <a:gd name="connsiteY8" fmla="*/ 77644 h 288268"/>
                <a:gd name="connsiteX9" fmla="*/ 382418 w 771632"/>
                <a:gd name="connsiteY9" fmla="*/ 76099 h 288268"/>
                <a:gd name="connsiteX10" fmla="*/ 456259 w 771632"/>
                <a:gd name="connsiteY10" fmla="*/ 80422 h 288268"/>
                <a:gd name="connsiteX11" fmla="*/ 531500 w 771632"/>
                <a:gd name="connsiteY11" fmla="*/ 96330 h 288268"/>
                <a:gd name="connsiteX12" fmla="*/ 550545 w 771632"/>
                <a:gd name="connsiteY12" fmla="*/ 107348 h 288268"/>
                <a:gd name="connsiteX13" fmla="*/ 583880 w 771632"/>
                <a:gd name="connsiteY13" fmla="*/ 130001 h 288268"/>
                <a:gd name="connsiteX14" fmla="*/ 628650 w 771632"/>
                <a:gd name="connsiteY14" fmla="*/ 169905 h 288268"/>
                <a:gd name="connsiteX15" fmla="*/ 667218 w 771632"/>
                <a:gd name="connsiteY15" fmla="*/ 208624 h 288268"/>
                <a:gd name="connsiteX16" fmla="*/ 709137 w 771632"/>
                <a:gd name="connsiteY16" fmla="*/ 271695 h 288268"/>
                <a:gd name="connsiteX17" fmla="*/ 727710 w 771632"/>
                <a:gd name="connsiteY17" fmla="*/ 270870 h 288268"/>
                <a:gd name="connsiteX18" fmla="*/ 762000 w 771632"/>
                <a:gd name="connsiteY18" fmla="*/ 242295 h 288268"/>
                <a:gd name="connsiteX19" fmla="*/ 771525 w 771632"/>
                <a:gd name="connsiteY19" fmla="*/ 232770 h 288268"/>
                <a:gd name="connsiteX20" fmla="*/ 765810 w 771632"/>
                <a:gd name="connsiteY20" fmla="*/ 202290 h 288268"/>
                <a:gd name="connsiteX21" fmla="*/ 756285 w 771632"/>
                <a:gd name="connsiteY21" fmla="*/ 183240 h 288268"/>
                <a:gd name="connsiteX22" fmla="*/ 748665 w 771632"/>
                <a:gd name="connsiteY22" fmla="*/ 168000 h 288268"/>
                <a:gd name="connsiteX23" fmla="*/ 739140 w 771632"/>
                <a:gd name="connsiteY23" fmla="*/ 154665 h 288268"/>
                <a:gd name="connsiteX24" fmla="*/ 737235 w 771632"/>
                <a:gd name="connsiteY24" fmla="*/ 148950 h 288268"/>
                <a:gd name="connsiteX25" fmla="*/ 727710 w 771632"/>
                <a:gd name="connsiteY25" fmla="*/ 137520 h 288268"/>
                <a:gd name="connsiteX26" fmla="*/ 720090 w 771632"/>
                <a:gd name="connsiteY26" fmla="*/ 131805 h 288268"/>
                <a:gd name="connsiteX27" fmla="*/ 714375 w 771632"/>
                <a:gd name="connsiteY27" fmla="*/ 129900 h 288268"/>
                <a:gd name="connsiteX28" fmla="*/ 702945 w 771632"/>
                <a:gd name="connsiteY28" fmla="*/ 120375 h 288268"/>
                <a:gd name="connsiteX29" fmla="*/ 697230 w 771632"/>
                <a:gd name="connsiteY29" fmla="*/ 114660 h 288268"/>
                <a:gd name="connsiteX30" fmla="*/ 691515 w 771632"/>
                <a:gd name="connsiteY30" fmla="*/ 110850 h 288268"/>
                <a:gd name="connsiteX31" fmla="*/ 676275 w 771632"/>
                <a:gd name="connsiteY31" fmla="*/ 101325 h 288268"/>
                <a:gd name="connsiteX32" fmla="*/ 664845 w 771632"/>
                <a:gd name="connsiteY32" fmla="*/ 97515 h 288268"/>
                <a:gd name="connsiteX33" fmla="*/ 655320 w 771632"/>
                <a:gd name="connsiteY33" fmla="*/ 91800 h 288268"/>
                <a:gd name="connsiteX34" fmla="*/ 626745 w 771632"/>
                <a:gd name="connsiteY34" fmla="*/ 76560 h 288268"/>
                <a:gd name="connsiteX35" fmla="*/ 621030 w 771632"/>
                <a:gd name="connsiteY35" fmla="*/ 74655 h 288268"/>
                <a:gd name="connsiteX36" fmla="*/ 598170 w 771632"/>
                <a:gd name="connsiteY36" fmla="*/ 61320 h 288268"/>
                <a:gd name="connsiteX37" fmla="*/ 592455 w 771632"/>
                <a:gd name="connsiteY37" fmla="*/ 57510 h 288268"/>
                <a:gd name="connsiteX38" fmla="*/ 584835 w 771632"/>
                <a:gd name="connsiteY38" fmla="*/ 51795 h 288268"/>
                <a:gd name="connsiteX39" fmla="*/ 567690 w 771632"/>
                <a:gd name="connsiteY39" fmla="*/ 44175 h 288268"/>
                <a:gd name="connsiteX40" fmla="*/ 556260 w 771632"/>
                <a:gd name="connsiteY40" fmla="*/ 40365 h 288268"/>
                <a:gd name="connsiteX41" fmla="*/ 548640 w 771632"/>
                <a:gd name="connsiteY41" fmla="*/ 36555 h 288268"/>
                <a:gd name="connsiteX42" fmla="*/ 537210 w 771632"/>
                <a:gd name="connsiteY42" fmla="*/ 28935 h 288268"/>
                <a:gd name="connsiteX43" fmla="*/ 472440 w 771632"/>
                <a:gd name="connsiteY43" fmla="*/ 9165 h 288268"/>
                <a:gd name="connsiteX44" fmla="*/ 412430 w 771632"/>
                <a:gd name="connsiteY44" fmla="*/ 2111 h 288268"/>
                <a:gd name="connsiteX45" fmla="*/ 350052 w 771632"/>
                <a:gd name="connsiteY45" fmla="*/ 0 h 288268"/>
                <a:gd name="connsiteX46" fmla="*/ 300990 w 771632"/>
                <a:gd name="connsiteY46" fmla="*/ 4170 h 288268"/>
                <a:gd name="connsiteX47" fmla="*/ 268605 w 771632"/>
                <a:gd name="connsiteY47" fmla="*/ 11790 h 288268"/>
                <a:gd name="connsiteX48" fmla="*/ 226695 w 771632"/>
                <a:gd name="connsiteY48" fmla="*/ 28935 h 288268"/>
                <a:gd name="connsiteX49" fmla="*/ 182880 w 771632"/>
                <a:gd name="connsiteY49" fmla="*/ 55605 h 288268"/>
                <a:gd name="connsiteX50" fmla="*/ 123825 w 771632"/>
                <a:gd name="connsiteY50" fmla="*/ 97515 h 288268"/>
                <a:gd name="connsiteX51" fmla="*/ 87630 w 771632"/>
                <a:gd name="connsiteY51" fmla="*/ 127995 h 288268"/>
                <a:gd name="connsiteX52" fmla="*/ 55245 w 771632"/>
                <a:gd name="connsiteY52" fmla="*/ 160380 h 288268"/>
                <a:gd name="connsiteX53" fmla="*/ 20955 w 771632"/>
                <a:gd name="connsiteY53" fmla="*/ 206100 h 288268"/>
                <a:gd name="connsiteX54" fmla="*/ 0 w 771632"/>
                <a:gd name="connsiteY54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48665 w 777980"/>
                <a:gd name="connsiteY22" fmla="*/ 168000 h 288268"/>
                <a:gd name="connsiteX23" fmla="*/ 739140 w 777980"/>
                <a:gd name="connsiteY23" fmla="*/ 154665 h 288268"/>
                <a:gd name="connsiteX24" fmla="*/ 737235 w 777980"/>
                <a:gd name="connsiteY24" fmla="*/ 148950 h 288268"/>
                <a:gd name="connsiteX25" fmla="*/ 727710 w 777980"/>
                <a:gd name="connsiteY25" fmla="*/ 137520 h 288268"/>
                <a:gd name="connsiteX26" fmla="*/ 720090 w 777980"/>
                <a:gd name="connsiteY26" fmla="*/ 131805 h 288268"/>
                <a:gd name="connsiteX27" fmla="*/ 714375 w 777980"/>
                <a:gd name="connsiteY27" fmla="*/ 129900 h 288268"/>
                <a:gd name="connsiteX28" fmla="*/ 702945 w 777980"/>
                <a:gd name="connsiteY28" fmla="*/ 120375 h 288268"/>
                <a:gd name="connsiteX29" fmla="*/ 697230 w 777980"/>
                <a:gd name="connsiteY29" fmla="*/ 114660 h 288268"/>
                <a:gd name="connsiteX30" fmla="*/ 691515 w 777980"/>
                <a:gd name="connsiteY30" fmla="*/ 110850 h 288268"/>
                <a:gd name="connsiteX31" fmla="*/ 676275 w 777980"/>
                <a:gd name="connsiteY31" fmla="*/ 101325 h 288268"/>
                <a:gd name="connsiteX32" fmla="*/ 664845 w 777980"/>
                <a:gd name="connsiteY32" fmla="*/ 97515 h 288268"/>
                <a:gd name="connsiteX33" fmla="*/ 655320 w 777980"/>
                <a:gd name="connsiteY33" fmla="*/ 91800 h 288268"/>
                <a:gd name="connsiteX34" fmla="*/ 626745 w 777980"/>
                <a:gd name="connsiteY34" fmla="*/ 76560 h 288268"/>
                <a:gd name="connsiteX35" fmla="*/ 621030 w 777980"/>
                <a:gd name="connsiteY35" fmla="*/ 74655 h 288268"/>
                <a:gd name="connsiteX36" fmla="*/ 598170 w 777980"/>
                <a:gd name="connsiteY36" fmla="*/ 61320 h 288268"/>
                <a:gd name="connsiteX37" fmla="*/ 592455 w 777980"/>
                <a:gd name="connsiteY37" fmla="*/ 57510 h 288268"/>
                <a:gd name="connsiteX38" fmla="*/ 584835 w 777980"/>
                <a:gd name="connsiteY38" fmla="*/ 51795 h 288268"/>
                <a:gd name="connsiteX39" fmla="*/ 567690 w 777980"/>
                <a:gd name="connsiteY39" fmla="*/ 44175 h 288268"/>
                <a:gd name="connsiteX40" fmla="*/ 556260 w 777980"/>
                <a:gd name="connsiteY40" fmla="*/ 40365 h 288268"/>
                <a:gd name="connsiteX41" fmla="*/ 548640 w 777980"/>
                <a:gd name="connsiteY41" fmla="*/ 36555 h 288268"/>
                <a:gd name="connsiteX42" fmla="*/ 537210 w 777980"/>
                <a:gd name="connsiteY42" fmla="*/ 28935 h 288268"/>
                <a:gd name="connsiteX43" fmla="*/ 472440 w 777980"/>
                <a:gd name="connsiteY43" fmla="*/ 9165 h 288268"/>
                <a:gd name="connsiteX44" fmla="*/ 412430 w 777980"/>
                <a:gd name="connsiteY44" fmla="*/ 2111 h 288268"/>
                <a:gd name="connsiteX45" fmla="*/ 350052 w 777980"/>
                <a:gd name="connsiteY45" fmla="*/ 0 h 288268"/>
                <a:gd name="connsiteX46" fmla="*/ 300990 w 777980"/>
                <a:gd name="connsiteY46" fmla="*/ 4170 h 288268"/>
                <a:gd name="connsiteX47" fmla="*/ 268605 w 777980"/>
                <a:gd name="connsiteY47" fmla="*/ 11790 h 288268"/>
                <a:gd name="connsiteX48" fmla="*/ 226695 w 777980"/>
                <a:gd name="connsiteY48" fmla="*/ 28935 h 288268"/>
                <a:gd name="connsiteX49" fmla="*/ 182880 w 777980"/>
                <a:gd name="connsiteY49" fmla="*/ 55605 h 288268"/>
                <a:gd name="connsiteX50" fmla="*/ 123825 w 777980"/>
                <a:gd name="connsiteY50" fmla="*/ 97515 h 288268"/>
                <a:gd name="connsiteX51" fmla="*/ 87630 w 777980"/>
                <a:gd name="connsiteY51" fmla="*/ 127995 h 288268"/>
                <a:gd name="connsiteX52" fmla="*/ 55245 w 777980"/>
                <a:gd name="connsiteY52" fmla="*/ 160380 h 288268"/>
                <a:gd name="connsiteX53" fmla="*/ 20955 w 777980"/>
                <a:gd name="connsiteY53" fmla="*/ 206100 h 288268"/>
                <a:gd name="connsiteX54" fmla="*/ 0 w 777980"/>
                <a:gd name="connsiteY54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37235 w 777980"/>
                <a:gd name="connsiteY23" fmla="*/ 148950 h 288268"/>
                <a:gd name="connsiteX24" fmla="*/ 727710 w 777980"/>
                <a:gd name="connsiteY24" fmla="*/ 137520 h 288268"/>
                <a:gd name="connsiteX25" fmla="*/ 720090 w 777980"/>
                <a:gd name="connsiteY25" fmla="*/ 131805 h 288268"/>
                <a:gd name="connsiteX26" fmla="*/ 714375 w 777980"/>
                <a:gd name="connsiteY26" fmla="*/ 129900 h 288268"/>
                <a:gd name="connsiteX27" fmla="*/ 702945 w 777980"/>
                <a:gd name="connsiteY27" fmla="*/ 120375 h 288268"/>
                <a:gd name="connsiteX28" fmla="*/ 697230 w 777980"/>
                <a:gd name="connsiteY28" fmla="*/ 114660 h 288268"/>
                <a:gd name="connsiteX29" fmla="*/ 691515 w 777980"/>
                <a:gd name="connsiteY29" fmla="*/ 110850 h 288268"/>
                <a:gd name="connsiteX30" fmla="*/ 676275 w 777980"/>
                <a:gd name="connsiteY30" fmla="*/ 101325 h 288268"/>
                <a:gd name="connsiteX31" fmla="*/ 664845 w 777980"/>
                <a:gd name="connsiteY31" fmla="*/ 97515 h 288268"/>
                <a:gd name="connsiteX32" fmla="*/ 655320 w 777980"/>
                <a:gd name="connsiteY32" fmla="*/ 91800 h 288268"/>
                <a:gd name="connsiteX33" fmla="*/ 626745 w 777980"/>
                <a:gd name="connsiteY33" fmla="*/ 76560 h 288268"/>
                <a:gd name="connsiteX34" fmla="*/ 621030 w 777980"/>
                <a:gd name="connsiteY34" fmla="*/ 74655 h 288268"/>
                <a:gd name="connsiteX35" fmla="*/ 598170 w 777980"/>
                <a:gd name="connsiteY35" fmla="*/ 61320 h 288268"/>
                <a:gd name="connsiteX36" fmla="*/ 592455 w 777980"/>
                <a:gd name="connsiteY36" fmla="*/ 57510 h 288268"/>
                <a:gd name="connsiteX37" fmla="*/ 584835 w 777980"/>
                <a:gd name="connsiteY37" fmla="*/ 51795 h 288268"/>
                <a:gd name="connsiteX38" fmla="*/ 567690 w 777980"/>
                <a:gd name="connsiteY38" fmla="*/ 44175 h 288268"/>
                <a:gd name="connsiteX39" fmla="*/ 556260 w 777980"/>
                <a:gd name="connsiteY39" fmla="*/ 40365 h 288268"/>
                <a:gd name="connsiteX40" fmla="*/ 548640 w 777980"/>
                <a:gd name="connsiteY40" fmla="*/ 36555 h 288268"/>
                <a:gd name="connsiteX41" fmla="*/ 537210 w 777980"/>
                <a:gd name="connsiteY41" fmla="*/ 28935 h 288268"/>
                <a:gd name="connsiteX42" fmla="*/ 472440 w 777980"/>
                <a:gd name="connsiteY42" fmla="*/ 9165 h 288268"/>
                <a:gd name="connsiteX43" fmla="*/ 412430 w 777980"/>
                <a:gd name="connsiteY43" fmla="*/ 2111 h 288268"/>
                <a:gd name="connsiteX44" fmla="*/ 350052 w 777980"/>
                <a:gd name="connsiteY44" fmla="*/ 0 h 288268"/>
                <a:gd name="connsiteX45" fmla="*/ 300990 w 777980"/>
                <a:gd name="connsiteY45" fmla="*/ 4170 h 288268"/>
                <a:gd name="connsiteX46" fmla="*/ 268605 w 777980"/>
                <a:gd name="connsiteY46" fmla="*/ 11790 h 288268"/>
                <a:gd name="connsiteX47" fmla="*/ 226695 w 777980"/>
                <a:gd name="connsiteY47" fmla="*/ 28935 h 288268"/>
                <a:gd name="connsiteX48" fmla="*/ 182880 w 777980"/>
                <a:gd name="connsiteY48" fmla="*/ 55605 h 288268"/>
                <a:gd name="connsiteX49" fmla="*/ 123825 w 777980"/>
                <a:gd name="connsiteY49" fmla="*/ 97515 h 288268"/>
                <a:gd name="connsiteX50" fmla="*/ 87630 w 777980"/>
                <a:gd name="connsiteY50" fmla="*/ 127995 h 288268"/>
                <a:gd name="connsiteX51" fmla="*/ 55245 w 777980"/>
                <a:gd name="connsiteY51" fmla="*/ 160380 h 288268"/>
                <a:gd name="connsiteX52" fmla="*/ 20955 w 777980"/>
                <a:gd name="connsiteY52" fmla="*/ 206100 h 288268"/>
                <a:gd name="connsiteX53" fmla="*/ 0 w 777980"/>
                <a:gd name="connsiteY53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714375 w 777980"/>
                <a:gd name="connsiteY25" fmla="*/ 129900 h 288268"/>
                <a:gd name="connsiteX26" fmla="*/ 702945 w 777980"/>
                <a:gd name="connsiteY26" fmla="*/ 120375 h 288268"/>
                <a:gd name="connsiteX27" fmla="*/ 697230 w 777980"/>
                <a:gd name="connsiteY27" fmla="*/ 114660 h 288268"/>
                <a:gd name="connsiteX28" fmla="*/ 691515 w 777980"/>
                <a:gd name="connsiteY28" fmla="*/ 110850 h 288268"/>
                <a:gd name="connsiteX29" fmla="*/ 676275 w 777980"/>
                <a:gd name="connsiteY29" fmla="*/ 101325 h 288268"/>
                <a:gd name="connsiteX30" fmla="*/ 664845 w 777980"/>
                <a:gd name="connsiteY30" fmla="*/ 97515 h 288268"/>
                <a:gd name="connsiteX31" fmla="*/ 655320 w 777980"/>
                <a:gd name="connsiteY31" fmla="*/ 91800 h 288268"/>
                <a:gd name="connsiteX32" fmla="*/ 626745 w 777980"/>
                <a:gd name="connsiteY32" fmla="*/ 76560 h 288268"/>
                <a:gd name="connsiteX33" fmla="*/ 621030 w 777980"/>
                <a:gd name="connsiteY33" fmla="*/ 74655 h 288268"/>
                <a:gd name="connsiteX34" fmla="*/ 598170 w 777980"/>
                <a:gd name="connsiteY34" fmla="*/ 61320 h 288268"/>
                <a:gd name="connsiteX35" fmla="*/ 592455 w 777980"/>
                <a:gd name="connsiteY35" fmla="*/ 57510 h 288268"/>
                <a:gd name="connsiteX36" fmla="*/ 584835 w 777980"/>
                <a:gd name="connsiteY36" fmla="*/ 51795 h 288268"/>
                <a:gd name="connsiteX37" fmla="*/ 567690 w 777980"/>
                <a:gd name="connsiteY37" fmla="*/ 44175 h 288268"/>
                <a:gd name="connsiteX38" fmla="*/ 556260 w 777980"/>
                <a:gd name="connsiteY38" fmla="*/ 40365 h 288268"/>
                <a:gd name="connsiteX39" fmla="*/ 548640 w 777980"/>
                <a:gd name="connsiteY39" fmla="*/ 36555 h 288268"/>
                <a:gd name="connsiteX40" fmla="*/ 537210 w 777980"/>
                <a:gd name="connsiteY40" fmla="*/ 28935 h 288268"/>
                <a:gd name="connsiteX41" fmla="*/ 472440 w 777980"/>
                <a:gd name="connsiteY41" fmla="*/ 9165 h 288268"/>
                <a:gd name="connsiteX42" fmla="*/ 412430 w 777980"/>
                <a:gd name="connsiteY42" fmla="*/ 2111 h 288268"/>
                <a:gd name="connsiteX43" fmla="*/ 350052 w 777980"/>
                <a:gd name="connsiteY43" fmla="*/ 0 h 288268"/>
                <a:gd name="connsiteX44" fmla="*/ 300990 w 777980"/>
                <a:gd name="connsiteY44" fmla="*/ 4170 h 288268"/>
                <a:gd name="connsiteX45" fmla="*/ 268605 w 777980"/>
                <a:gd name="connsiteY45" fmla="*/ 11790 h 288268"/>
                <a:gd name="connsiteX46" fmla="*/ 226695 w 777980"/>
                <a:gd name="connsiteY46" fmla="*/ 28935 h 288268"/>
                <a:gd name="connsiteX47" fmla="*/ 182880 w 777980"/>
                <a:gd name="connsiteY47" fmla="*/ 55605 h 288268"/>
                <a:gd name="connsiteX48" fmla="*/ 123825 w 777980"/>
                <a:gd name="connsiteY48" fmla="*/ 97515 h 288268"/>
                <a:gd name="connsiteX49" fmla="*/ 87630 w 777980"/>
                <a:gd name="connsiteY49" fmla="*/ 127995 h 288268"/>
                <a:gd name="connsiteX50" fmla="*/ 55245 w 777980"/>
                <a:gd name="connsiteY50" fmla="*/ 160380 h 288268"/>
                <a:gd name="connsiteX51" fmla="*/ 20955 w 777980"/>
                <a:gd name="connsiteY51" fmla="*/ 206100 h 288268"/>
                <a:gd name="connsiteX52" fmla="*/ 0 w 777980"/>
                <a:gd name="connsiteY52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702945 w 777980"/>
                <a:gd name="connsiteY25" fmla="*/ 120375 h 288268"/>
                <a:gd name="connsiteX26" fmla="*/ 697230 w 777980"/>
                <a:gd name="connsiteY26" fmla="*/ 114660 h 288268"/>
                <a:gd name="connsiteX27" fmla="*/ 691515 w 777980"/>
                <a:gd name="connsiteY27" fmla="*/ 110850 h 288268"/>
                <a:gd name="connsiteX28" fmla="*/ 676275 w 777980"/>
                <a:gd name="connsiteY28" fmla="*/ 101325 h 288268"/>
                <a:gd name="connsiteX29" fmla="*/ 664845 w 777980"/>
                <a:gd name="connsiteY29" fmla="*/ 97515 h 288268"/>
                <a:gd name="connsiteX30" fmla="*/ 655320 w 777980"/>
                <a:gd name="connsiteY30" fmla="*/ 91800 h 288268"/>
                <a:gd name="connsiteX31" fmla="*/ 626745 w 777980"/>
                <a:gd name="connsiteY31" fmla="*/ 76560 h 288268"/>
                <a:gd name="connsiteX32" fmla="*/ 621030 w 777980"/>
                <a:gd name="connsiteY32" fmla="*/ 74655 h 288268"/>
                <a:gd name="connsiteX33" fmla="*/ 598170 w 777980"/>
                <a:gd name="connsiteY33" fmla="*/ 61320 h 288268"/>
                <a:gd name="connsiteX34" fmla="*/ 592455 w 777980"/>
                <a:gd name="connsiteY34" fmla="*/ 57510 h 288268"/>
                <a:gd name="connsiteX35" fmla="*/ 584835 w 777980"/>
                <a:gd name="connsiteY35" fmla="*/ 51795 h 288268"/>
                <a:gd name="connsiteX36" fmla="*/ 567690 w 777980"/>
                <a:gd name="connsiteY36" fmla="*/ 44175 h 288268"/>
                <a:gd name="connsiteX37" fmla="*/ 556260 w 777980"/>
                <a:gd name="connsiteY37" fmla="*/ 40365 h 288268"/>
                <a:gd name="connsiteX38" fmla="*/ 548640 w 777980"/>
                <a:gd name="connsiteY38" fmla="*/ 36555 h 288268"/>
                <a:gd name="connsiteX39" fmla="*/ 537210 w 777980"/>
                <a:gd name="connsiteY39" fmla="*/ 28935 h 288268"/>
                <a:gd name="connsiteX40" fmla="*/ 472440 w 777980"/>
                <a:gd name="connsiteY40" fmla="*/ 9165 h 288268"/>
                <a:gd name="connsiteX41" fmla="*/ 412430 w 777980"/>
                <a:gd name="connsiteY41" fmla="*/ 2111 h 288268"/>
                <a:gd name="connsiteX42" fmla="*/ 350052 w 777980"/>
                <a:gd name="connsiteY42" fmla="*/ 0 h 288268"/>
                <a:gd name="connsiteX43" fmla="*/ 300990 w 777980"/>
                <a:gd name="connsiteY43" fmla="*/ 4170 h 288268"/>
                <a:gd name="connsiteX44" fmla="*/ 268605 w 777980"/>
                <a:gd name="connsiteY44" fmla="*/ 11790 h 288268"/>
                <a:gd name="connsiteX45" fmla="*/ 226695 w 777980"/>
                <a:gd name="connsiteY45" fmla="*/ 28935 h 288268"/>
                <a:gd name="connsiteX46" fmla="*/ 182880 w 777980"/>
                <a:gd name="connsiteY46" fmla="*/ 55605 h 288268"/>
                <a:gd name="connsiteX47" fmla="*/ 123825 w 777980"/>
                <a:gd name="connsiteY47" fmla="*/ 97515 h 288268"/>
                <a:gd name="connsiteX48" fmla="*/ 87630 w 777980"/>
                <a:gd name="connsiteY48" fmla="*/ 127995 h 288268"/>
                <a:gd name="connsiteX49" fmla="*/ 55245 w 777980"/>
                <a:gd name="connsiteY49" fmla="*/ 160380 h 288268"/>
                <a:gd name="connsiteX50" fmla="*/ 20955 w 777980"/>
                <a:gd name="connsiteY50" fmla="*/ 206100 h 288268"/>
                <a:gd name="connsiteX51" fmla="*/ 0 w 777980"/>
                <a:gd name="connsiteY51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91515 w 777980"/>
                <a:gd name="connsiteY26" fmla="*/ 110850 h 288268"/>
                <a:gd name="connsiteX27" fmla="*/ 676275 w 777980"/>
                <a:gd name="connsiteY27" fmla="*/ 101325 h 288268"/>
                <a:gd name="connsiteX28" fmla="*/ 664845 w 777980"/>
                <a:gd name="connsiteY28" fmla="*/ 97515 h 288268"/>
                <a:gd name="connsiteX29" fmla="*/ 655320 w 777980"/>
                <a:gd name="connsiteY29" fmla="*/ 91800 h 288268"/>
                <a:gd name="connsiteX30" fmla="*/ 626745 w 777980"/>
                <a:gd name="connsiteY30" fmla="*/ 76560 h 288268"/>
                <a:gd name="connsiteX31" fmla="*/ 621030 w 777980"/>
                <a:gd name="connsiteY31" fmla="*/ 74655 h 288268"/>
                <a:gd name="connsiteX32" fmla="*/ 598170 w 777980"/>
                <a:gd name="connsiteY32" fmla="*/ 61320 h 288268"/>
                <a:gd name="connsiteX33" fmla="*/ 592455 w 777980"/>
                <a:gd name="connsiteY33" fmla="*/ 57510 h 288268"/>
                <a:gd name="connsiteX34" fmla="*/ 584835 w 777980"/>
                <a:gd name="connsiteY34" fmla="*/ 51795 h 288268"/>
                <a:gd name="connsiteX35" fmla="*/ 567690 w 777980"/>
                <a:gd name="connsiteY35" fmla="*/ 44175 h 288268"/>
                <a:gd name="connsiteX36" fmla="*/ 556260 w 777980"/>
                <a:gd name="connsiteY36" fmla="*/ 40365 h 288268"/>
                <a:gd name="connsiteX37" fmla="*/ 548640 w 777980"/>
                <a:gd name="connsiteY37" fmla="*/ 36555 h 288268"/>
                <a:gd name="connsiteX38" fmla="*/ 537210 w 777980"/>
                <a:gd name="connsiteY38" fmla="*/ 28935 h 288268"/>
                <a:gd name="connsiteX39" fmla="*/ 472440 w 777980"/>
                <a:gd name="connsiteY39" fmla="*/ 9165 h 288268"/>
                <a:gd name="connsiteX40" fmla="*/ 412430 w 777980"/>
                <a:gd name="connsiteY40" fmla="*/ 2111 h 288268"/>
                <a:gd name="connsiteX41" fmla="*/ 350052 w 777980"/>
                <a:gd name="connsiteY41" fmla="*/ 0 h 288268"/>
                <a:gd name="connsiteX42" fmla="*/ 300990 w 777980"/>
                <a:gd name="connsiteY42" fmla="*/ 4170 h 288268"/>
                <a:gd name="connsiteX43" fmla="*/ 268605 w 777980"/>
                <a:gd name="connsiteY43" fmla="*/ 11790 h 288268"/>
                <a:gd name="connsiteX44" fmla="*/ 226695 w 777980"/>
                <a:gd name="connsiteY44" fmla="*/ 28935 h 288268"/>
                <a:gd name="connsiteX45" fmla="*/ 182880 w 777980"/>
                <a:gd name="connsiteY45" fmla="*/ 55605 h 288268"/>
                <a:gd name="connsiteX46" fmla="*/ 123825 w 777980"/>
                <a:gd name="connsiteY46" fmla="*/ 97515 h 288268"/>
                <a:gd name="connsiteX47" fmla="*/ 87630 w 777980"/>
                <a:gd name="connsiteY47" fmla="*/ 127995 h 288268"/>
                <a:gd name="connsiteX48" fmla="*/ 55245 w 777980"/>
                <a:gd name="connsiteY48" fmla="*/ 160380 h 288268"/>
                <a:gd name="connsiteX49" fmla="*/ 20955 w 777980"/>
                <a:gd name="connsiteY49" fmla="*/ 206100 h 288268"/>
                <a:gd name="connsiteX50" fmla="*/ 0 w 777980"/>
                <a:gd name="connsiteY50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64845 w 777980"/>
                <a:gd name="connsiteY27" fmla="*/ 97515 h 288268"/>
                <a:gd name="connsiteX28" fmla="*/ 655320 w 777980"/>
                <a:gd name="connsiteY28" fmla="*/ 91800 h 288268"/>
                <a:gd name="connsiteX29" fmla="*/ 626745 w 777980"/>
                <a:gd name="connsiteY29" fmla="*/ 76560 h 288268"/>
                <a:gd name="connsiteX30" fmla="*/ 621030 w 777980"/>
                <a:gd name="connsiteY30" fmla="*/ 74655 h 288268"/>
                <a:gd name="connsiteX31" fmla="*/ 598170 w 777980"/>
                <a:gd name="connsiteY31" fmla="*/ 61320 h 288268"/>
                <a:gd name="connsiteX32" fmla="*/ 592455 w 777980"/>
                <a:gd name="connsiteY32" fmla="*/ 57510 h 288268"/>
                <a:gd name="connsiteX33" fmla="*/ 584835 w 777980"/>
                <a:gd name="connsiteY33" fmla="*/ 51795 h 288268"/>
                <a:gd name="connsiteX34" fmla="*/ 567690 w 777980"/>
                <a:gd name="connsiteY34" fmla="*/ 44175 h 288268"/>
                <a:gd name="connsiteX35" fmla="*/ 556260 w 777980"/>
                <a:gd name="connsiteY35" fmla="*/ 40365 h 288268"/>
                <a:gd name="connsiteX36" fmla="*/ 548640 w 777980"/>
                <a:gd name="connsiteY36" fmla="*/ 36555 h 288268"/>
                <a:gd name="connsiteX37" fmla="*/ 537210 w 777980"/>
                <a:gd name="connsiteY37" fmla="*/ 28935 h 288268"/>
                <a:gd name="connsiteX38" fmla="*/ 472440 w 777980"/>
                <a:gd name="connsiteY38" fmla="*/ 9165 h 288268"/>
                <a:gd name="connsiteX39" fmla="*/ 412430 w 777980"/>
                <a:gd name="connsiteY39" fmla="*/ 2111 h 288268"/>
                <a:gd name="connsiteX40" fmla="*/ 350052 w 777980"/>
                <a:gd name="connsiteY40" fmla="*/ 0 h 288268"/>
                <a:gd name="connsiteX41" fmla="*/ 300990 w 777980"/>
                <a:gd name="connsiteY41" fmla="*/ 4170 h 288268"/>
                <a:gd name="connsiteX42" fmla="*/ 268605 w 777980"/>
                <a:gd name="connsiteY42" fmla="*/ 11790 h 288268"/>
                <a:gd name="connsiteX43" fmla="*/ 226695 w 777980"/>
                <a:gd name="connsiteY43" fmla="*/ 28935 h 288268"/>
                <a:gd name="connsiteX44" fmla="*/ 182880 w 777980"/>
                <a:gd name="connsiteY44" fmla="*/ 55605 h 288268"/>
                <a:gd name="connsiteX45" fmla="*/ 123825 w 777980"/>
                <a:gd name="connsiteY45" fmla="*/ 97515 h 288268"/>
                <a:gd name="connsiteX46" fmla="*/ 87630 w 777980"/>
                <a:gd name="connsiteY46" fmla="*/ 127995 h 288268"/>
                <a:gd name="connsiteX47" fmla="*/ 55245 w 777980"/>
                <a:gd name="connsiteY47" fmla="*/ 160380 h 288268"/>
                <a:gd name="connsiteX48" fmla="*/ 20955 w 777980"/>
                <a:gd name="connsiteY48" fmla="*/ 206100 h 288268"/>
                <a:gd name="connsiteX49" fmla="*/ 0 w 777980"/>
                <a:gd name="connsiteY49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55320 w 777980"/>
                <a:gd name="connsiteY27" fmla="*/ 91800 h 288268"/>
                <a:gd name="connsiteX28" fmla="*/ 626745 w 777980"/>
                <a:gd name="connsiteY28" fmla="*/ 76560 h 288268"/>
                <a:gd name="connsiteX29" fmla="*/ 621030 w 777980"/>
                <a:gd name="connsiteY29" fmla="*/ 74655 h 288268"/>
                <a:gd name="connsiteX30" fmla="*/ 598170 w 777980"/>
                <a:gd name="connsiteY30" fmla="*/ 61320 h 288268"/>
                <a:gd name="connsiteX31" fmla="*/ 592455 w 777980"/>
                <a:gd name="connsiteY31" fmla="*/ 57510 h 288268"/>
                <a:gd name="connsiteX32" fmla="*/ 584835 w 777980"/>
                <a:gd name="connsiteY32" fmla="*/ 51795 h 288268"/>
                <a:gd name="connsiteX33" fmla="*/ 567690 w 777980"/>
                <a:gd name="connsiteY33" fmla="*/ 44175 h 288268"/>
                <a:gd name="connsiteX34" fmla="*/ 556260 w 777980"/>
                <a:gd name="connsiteY34" fmla="*/ 40365 h 288268"/>
                <a:gd name="connsiteX35" fmla="*/ 548640 w 777980"/>
                <a:gd name="connsiteY35" fmla="*/ 36555 h 288268"/>
                <a:gd name="connsiteX36" fmla="*/ 537210 w 777980"/>
                <a:gd name="connsiteY36" fmla="*/ 28935 h 288268"/>
                <a:gd name="connsiteX37" fmla="*/ 472440 w 777980"/>
                <a:gd name="connsiteY37" fmla="*/ 9165 h 288268"/>
                <a:gd name="connsiteX38" fmla="*/ 412430 w 777980"/>
                <a:gd name="connsiteY38" fmla="*/ 2111 h 288268"/>
                <a:gd name="connsiteX39" fmla="*/ 350052 w 777980"/>
                <a:gd name="connsiteY39" fmla="*/ 0 h 288268"/>
                <a:gd name="connsiteX40" fmla="*/ 300990 w 777980"/>
                <a:gd name="connsiteY40" fmla="*/ 4170 h 288268"/>
                <a:gd name="connsiteX41" fmla="*/ 268605 w 777980"/>
                <a:gd name="connsiteY41" fmla="*/ 11790 h 288268"/>
                <a:gd name="connsiteX42" fmla="*/ 226695 w 777980"/>
                <a:gd name="connsiteY42" fmla="*/ 28935 h 288268"/>
                <a:gd name="connsiteX43" fmla="*/ 182880 w 777980"/>
                <a:gd name="connsiteY43" fmla="*/ 55605 h 288268"/>
                <a:gd name="connsiteX44" fmla="*/ 123825 w 777980"/>
                <a:gd name="connsiteY44" fmla="*/ 97515 h 288268"/>
                <a:gd name="connsiteX45" fmla="*/ 87630 w 777980"/>
                <a:gd name="connsiteY45" fmla="*/ 127995 h 288268"/>
                <a:gd name="connsiteX46" fmla="*/ 55245 w 777980"/>
                <a:gd name="connsiteY46" fmla="*/ 160380 h 288268"/>
                <a:gd name="connsiteX47" fmla="*/ 20955 w 777980"/>
                <a:gd name="connsiteY47" fmla="*/ 206100 h 288268"/>
                <a:gd name="connsiteX48" fmla="*/ 0 w 777980"/>
                <a:gd name="connsiteY48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26745 w 777980"/>
                <a:gd name="connsiteY27" fmla="*/ 76560 h 288268"/>
                <a:gd name="connsiteX28" fmla="*/ 621030 w 777980"/>
                <a:gd name="connsiteY28" fmla="*/ 74655 h 288268"/>
                <a:gd name="connsiteX29" fmla="*/ 598170 w 777980"/>
                <a:gd name="connsiteY29" fmla="*/ 61320 h 288268"/>
                <a:gd name="connsiteX30" fmla="*/ 592455 w 777980"/>
                <a:gd name="connsiteY30" fmla="*/ 57510 h 288268"/>
                <a:gd name="connsiteX31" fmla="*/ 584835 w 777980"/>
                <a:gd name="connsiteY31" fmla="*/ 51795 h 288268"/>
                <a:gd name="connsiteX32" fmla="*/ 567690 w 777980"/>
                <a:gd name="connsiteY32" fmla="*/ 44175 h 288268"/>
                <a:gd name="connsiteX33" fmla="*/ 556260 w 777980"/>
                <a:gd name="connsiteY33" fmla="*/ 40365 h 288268"/>
                <a:gd name="connsiteX34" fmla="*/ 548640 w 777980"/>
                <a:gd name="connsiteY34" fmla="*/ 36555 h 288268"/>
                <a:gd name="connsiteX35" fmla="*/ 537210 w 777980"/>
                <a:gd name="connsiteY35" fmla="*/ 28935 h 288268"/>
                <a:gd name="connsiteX36" fmla="*/ 472440 w 777980"/>
                <a:gd name="connsiteY36" fmla="*/ 9165 h 288268"/>
                <a:gd name="connsiteX37" fmla="*/ 412430 w 777980"/>
                <a:gd name="connsiteY37" fmla="*/ 2111 h 288268"/>
                <a:gd name="connsiteX38" fmla="*/ 350052 w 777980"/>
                <a:gd name="connsiteY38" fmla="*/ 0 h 288268"/>
                <a:gd name="connsiteX39" fmla="*/ 300990 w 777980"/>
                <a:gd name="connsiteY39" fmla="*/ 4170 h 288268"/>
                <a:gd name="connsiteX40" fmla="*/ 268605 w 777980"/>
                <a:gd name="connsiteY40" fmla="*/ 11790 h 288268"/>
                <a:gd name="connsiteX41" fmla="*/ 226695 w 777980"/>
                <a:gd name="connsiteY41" fmla="*/ 28935 h 288268"/>
                <a:gd name="connsiteX42" fmla="*/ 182880 w 777980"/>
                <a:gd name="connsiteY42" fmla="*/ 55605 h 288268"/>
                <a:gd name="connsiteX43" fmla="*/ 123825 w 777980"/>
                <a:gd name="connsiteY43" fmla="*/ 97515 h 288268"/>
                <a:gd name="connsiteX44" fmla="*/ 87630 w 777980"/>
                <a:gd name="connsiteY44" fmla="*/ 127995 h 288268"/>
                <a:gd name="connsiteX45" fmla="*/ 55245 w 777980"/>
                <a:gd name="connsiteY45" fmla="*/ 160380 h 288268"/>
                <a:gd name="connsiteX46" fmla="*/ 20955 w 777980"/>
                <a:gd name="connsiteY46" fmla="*/ 206100 h 288268"/>
                <a:gd name="connsiteX47" fmla="*/ 0 w 777980"/>
                <a:gd name="connsiteY47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21030 w 777980"/>
                <a:gd name="connsiteY27" fmla="*/ 74655 h 288268"/>
                <a:gd name="connsiteX28" fmla="*/ 598170 w 777980"/>
                <a:gd name="connsiteY28" fmla="*/ 61320 h 288268"/>
                <a:gd name="connsiteX29" fmla="*/ 592455 w 777980"/>
                <a:gd name="connsiteY29" fmla="*/ 57510 h 288268"/>
                <a:gd name="connsiteX30" fmla="*/ 584835 w 777980"/>
                <a:gd name="connsiteY30" fmla="*/ 51795 h 288268"/>
                <a:gd name="connsiteX31" fmla="*/ 567690 w 777980"/>
                <a:gd name="connsiteY31" fmla="*/ 44175 h 288268"/>
                <a:gd name="connsiteX32" fmla="*/ 556260 w 777980"/>
                <a:gd name="connsiteY32" fmla="*/ 40365 h 288268"/>
                <a:gd name="connsiteX33" fmla="*/ 548640 w 777980"/>
                <a:gd name="connsiteY33" fmla="*/ 36555 h 288268"/>
                <a:gd name="connsiteX34" fmla="*/ 537210 w 777980"/>
                <a:gd name="connsiteY34" fmla="*/ 28935 h 288268"/>
                <a:gd name="connsiteX35" fmla="*/ 472440 w 777980"/>
                <a:gd name="connsiteY35" fmla="*/ 9165 h 288268"/>
                <a:gd name="connsiteX36" fmla="*/ 412430 w 777980"/>
                <a:gd name="connsiteY36" fmla="*/ 2111 h 288268"/>
                <a:gd name="connsiteX37" fmla="*/ 350052 w 777980"/>
                <a:gd name="connsiteY37" fmla="*/ 0 h 288268"/>
                <a:gd name="connsiteX38" fmla="*/ 300990 w 777980"/>
                <a:gd name="connsiteY38" fmla="*/ 4170 h 288268"/>
                <a:gd name="connsiteX39" fmla="*/ 268605 w 777980"/>
                <a:gd name="connsiteY39" fmla="*/ 11790 h 288268"/>
                <a:gd name="connsiteX40" fmla="*/ 226695 w 777980"/>
                <a:gd name="connsiteY40" fmla="*/ 28935 h 288268"/>
                <a:gd name="connsiteX41" fmla="*/ 182880 w 777980"/>
                <a:gd name="connsiteY41" fmla="*/ 55605 h 288268"/>
                <a:gd name="connsiteX42" fmla="*/ 123825 w 777980"/>
                <a:gd name="connsiteY42" fmla="*/ 97515 h 288268"/>
                <a:gd name="connsiteX43" fmla="*/ 87630 w 777980"/>
                <a:gd name="connsiteY43" fmla="*/ 127995 h 288268"/>
                <a:gd name="connsiteX44" fmla="*/ 55245 w 777980"/>
                <a:gd name="connsiteY44" fmla="*/ 160380 h 288268"/>
                <a:gd name="connsiteX45" fmla="*/ 20955 w 777980"/>
                <a:gd name="connsiteY45" fmla="*/ 206100 h 288268"/>
                <a:gd name="connsiteX46" fmla="*/ 0 w 777980"/>
                <a:gd name="connsiteY46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598170 w 777980"/>
                <a:gd name="connsiteY27" fmla="*/ 61320 h 288268"/>
                <a:gd name="connsiteX28" fmla="*/ 592455 w 777980"/>
                <a:gd name="connsiteY28" fmla="*/ 57510 h 288268"/>
                <a:gd name="connsiteX29" fmla="*/ 584835 w 777980"/>
                <a:gd name="connsiteY29" fmla="*/ 51795 h 288268"/>
                <a:gd name="connsiteX30" fmla="*/ 567690 w 777980"/>
                <a:gd name="connsiteY30" fmla="*/ 44175 h 288268"/>
                <a:gd name="connsiteX31" fmla="*/ 556260 w 777980"/>
                <a:gd name="connsiteY31" fmla="*/ 40365 h 288268"/>
                <a:gd name="connsiteX32" fmla="*/ 548640 w 777980"/>
                <a:gd name="connsiteY32" fmla="*/ 36555 h 288268"/>
                <a:gd name="connsiteX33" fmla="*/ 537210 w 777980"/>
                <a:gd name="connsiteY33" fmla="*/ 28935 h 288268"/>
                <a:gd name="connsiteX34" fmla="*/ 472440 w 777980"/>
                <a:gd name="connsiteY34" fmla="*/ 9165 h 288268"/>
                <a:gd name="connsiteX35" fmla="*/ 412430 w 777980"/>
                <a:gd name="connsiteY35" fmla="*/ 2111 h 288268"/>
                <a:gd name="connsiteX36" fmla="*/ 350052 w 777980"/>
                <a:gd name="connsiteY36" fmla="*/ 0 h 288268"/>
                <a:gd name="connsiteX37" fmla="*/ 300990 w 777980"/>
                <a:gd name="connsiteY37" fmla="*/ 4170 h 288268"/>
                <a:gd name="connsiteX38" fmla="*/ 268605 w 777980"/>
                <a:gd name="connsiteY38" fmla="*/ 11790 h 288268"/>
                <a:gd name="connsiteX39" fmla="*/ 226695 w 777980"/>
                <a:gd name="connsiteY39" fmla="*/ 28935 h 288268"/>
                <a:gd name="connsiteX40" fmla="*/ 182880 w 777980"/>
                <a:gd name="connsiteY40" fmla="*/ 55605 h 288268"/>
                <a:gd name="connsiteX41" fmla="*/ 123825 w 777980"/>
                <a:gd name="connsiteY41" fmla="*/ 97515 h 288268"/>
                <a:gd name="connsiteX42" fmla="*/ 87630 w 777980"/>
                <a:gd name="connsiteY42" fmla="*/ 127995 h 288268"/>
                <a:gd name="connsiteX43" fmla="*/ 55245 w 777980"/>
                <a:gd name="connsiteY43" fmla="*/ 160380 h 288268"/>
                <a:gd name="connsiteX44" fmla="*/ 20955 w 777980"/>
                <a:gd name="connsiteY44" fmla="*/ 206100 h 288268"/>
                <a:gd name="connsiteX45" fmla="*/ 0 w 777980"/>
                <a:gd name="connsiteY45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01025 w 777980"/>
                <a:gd name="connsiteY27" fmla="*/ 53959 h 288268"/>
                <a:gd name="connsiteX28" fmla="*/ 592455 w 777980"/>
                <a:gd name="connsiteY28" fmla="*/ 57510 h 288268"/>
                <a:gd name="connsiteX29" fmla="*/ 584835 w 777980"/>
                <a:gd name="connsiteY29" fmla="*/ 51795 h 288268"/>
                <a:gd name="connsiteX30" fmla="*/ 567690 w 777980"/>
                <a:gd name="connsiteY30" fmla="*/ 44175 h 288268"/>
                <a:gd name="connsiteX31" fmla="*/ 556260 w 777980"/>
                <a:gd name="connsiteY31" fmla="*/ 40365 h 288268"/>
                <a:gd name="connsiteX32" fmla="*/ 548640 w 777980"/>
                <a:gd name="connsiteY32" fmla="*/ 36555 h 288268"/>
                <a:gd name="connsiteX33" fmla="*/ 537210 w 777980"/>
                <a:gd name="connsiteY33" fmla="*/ 28935 h 288268"/>
                <a:gd name="connsiteX34" fmla="*/ 472440 w 777980"/>
                <a:gd name="connsiteY34" fmla="*/ 9165 h 288268"/>
                <a:gd name="connsiteX35" fmla="*/ 412430 w 777980"/>
                <a:gd name="connsiteY35" fmla="*/ 2111 h 288268"/>
                <a:gd name="connsiteX36" fmla="*/ 350052 w 777980"/>
                <a:gd name="connsiteY36" fmla="*/ 0 h 288268"/>
                <a:gd name="connsiteX37" fmla="*/ 300990 w 777980"/>
                <a:gd name="connsiteY37" fmla="*/ 4170 h 288268"/>
                <a:gd name="connsiteX38" fmla="*/ 268605 w 777980"/>
                <a:gd name="connsiteY38" fmla="*/ 11790 h 288268"/>
                <a:gd name="connsiteX39" fmla="*/ 226695 w 777980"/>
                <a:gd name="connsiteY39" fmla="*/ 28935 h 288268"/>
                <a:gd name="connsiteX40" fmla="*/ 182880 w 777980"/>
                <a:gd name="connsiteY40" fmla="*/ 55605 h 288268"/>
                <a:gd name="connsiteX41" fmla="*/ 123825 w 777980"/>
                <a:gd name="connsiteY41" fmla="*/ 97515 h 288268"/>
                <a:gd name="connsiteX42" fmla="*/ 87630 w 777980"/>
                <a:gd name="connsiteY42" fmla="*/ 127995 h 288268"/>
                <a:gd name="connsiteX43" fmla="*/ 55245 w 777980"/>
                <a:gd name="connsiteY43" fmla="*/ 160380 h 288268"/>
                <a:gd name="connsiteX44" fmla="*/ 20955 w 777980"/>
                <a:gd name="connsiteY44" fmla="*/ 206100 h 288268"/>
                <a:gd name="connsiteX45" fmla="*/ 0 w 777980"/>
                <a:gd name="connsiteY45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01025 w 777980"/>
                <a:gd name="connsiteY27" fmla="*/ 53959 h 288268"/>
                <a:gd name="connsiteX28" fmla="*/ 592455 w 777980"/>
                <a:gd name="connsiteY28" fmla="*/ 57510 h 288268"/>
                <a:gd name="connsiteX29" fmla="*/ 567690 w 777980"/>
                <a:gd name="connsiteY29" fmla="*/ 44175 h 288268"/>
                <a:gd name="connsiteX30" fmla="*/ 556260 w 777980"/>
                <a:gd name="connsiteY30" fmla="*/ 40365 h 288268"/>
                <a:gd name="connsiteX31" fmla="*/ 548640 w 777980"/>
                <a:gd name="connsiteY31" fmla="*/ 36555 h 288268"/>
                <a:gd name="connsiteX32" fmla="*/ 537210 w 777980"/>
                <a:gd name="connsiteY32" fmla="*/ 28935 h 288268"/>
                <a:gd name="connsiteX33" fmla="*/ 472440 w 777980"/>
                <a:gd name="connsiteY33" fmla="*/ 9165 h 288268"/>
                <a:gd name="connsiteX34" fmla="*/ 412430 w 777980"/>
                <a:gd name="connsiteY34" fmla="*/ 2111 h 288268"/>
                <a:gd name="connsiteX35" fmla="*/ 350052 w 777980"/>
                <a:gd name="connsiteY35" fmla="*/ 0 h 288268"/>
                <a:gd name="connsiteX36" fmla="*/ 300990 w 777980"/>
                <a:gd name="connsiteY36" fmla="*/ 4170 h 288268"/>
                <a:gd name="connsiteX37" fmla="*/ 268605 w 777980"/>
                <a:gd name="connsiteY37" fmla="*/ 11790 h 288268"/>
                <a:gd name="connsiteX38" fmla="*/ 226695 w 777980"/>
                <a:gd name="connsiteY38" fmla="*/ 28935 h 288268"/>
                <a:gd name="connsiteX39" fmla="*/ 182880 w 777980"/>
                <a:gd name="connsiteY39" fmla="*/ 55605 h 288268"/>
                <a:gd name="connsiteX40" fmla="*/ 123825 w 777980"/>
                <a:gd name="connsiteY40" fmla="*/ 97515 h 288268"/>
                <a:gd name="connsiteX41" fmla="*/ 87630 w 777980"/>
                <a:gd name="connsiteY41" fmla="*/ 127995 h 288268"/>
                <a:gd name="connsiteX42" fmla="*/ 55245 w 777980"/>
                <a:gd name="connsiteY42" fmla="*/ 160380 h 288268"/>
                <a:gd name="connsiteX43" fmla="*/ 20955 w 777980"/>
                <a:gd name="connsiteY43" fmla="*/ 206100 h 288268"/>
                <a:gd name="connsiteX44" fmla="*/ 0 w 777980"/>
                <a:gd name="connsiteY44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01025 w 777980"/>
                <a:gd name="connsiteY27" fmla="*/ 53959 h 288268"/>
                <a:gd name="connsiteX28" fmla="*/ 567690 w 777980"/>
                <a:gd name="connsiteY28" fmla="*/ 44175 h 288268"/>
                <a:gd name="connsiteX29" fmla="*/ 556260 w 777980"/>
                <a:gd name="connsiteY29" fmla="*/ 40365 h 288268"/>
                <a:gd name="connsiteX30" fmla="*/ 548640 w 777980"/>
                <a:gd name="connsiteY30" fmla="*/ 36555 h 288268"/>
                <a:gd name="connsiteX31" fmla="*/ 537210 w 777980"/>
                <a:gd name="connsiteY31" fmla="*/ 28935 h 288268"/>
                <a:gd name="connsiteX32" fmla="*/ 472440 w 777980"/>
                <a:gd name="connsiteY32" fmla="*/ 9165 h 288268"/>
                <a:gd name="connsiteX33" fmla="*/ 412430 w 777980"/>
                <a:gd name="connsiteY33" fmla="*/ 2111 h 288268"/>
                <a:gd name="connsiteX34" fmla="*/ 350052 w 777980"/>
                <a:gd name="connsiteY34" fmla="*/ 0 h 288268"/>
                <a:gd name="connsiteX35" fmla="*/ 300990 w 777980"/>
                <a:gd name="connsiteY35" fmla="*/ 4170 h 288268"/>
                <a:gd name="connsiteX36" fmla="*/ 268605 w 777980"/>
                <a:gd name="connsiteY36" fmla="*/ 11790 h 288268"/>
                <a:gd name="connsiteX37" fmla="*/ 226695 w 777980"/>
                <a:gd name="connsiteY37" fmla="*/ 28935 h 288268"/>
                <a:gd name="connsiteX38" fmla="*/ 182880 w 777980"/>
                <a:gd name="connsiteY38" fmla="*/ 55605 h 288268"/>
                <a:gd name="connsiteX39" fmla="*/ 123825 w 777980"/>
                <a:gd name="connsiteY39" fmla="*/ 97515 h 288268"/>
                <a:gd name="connsiteX40" fmla="*/ 87630 w 777980"/>
                <a:gd name="connsiteY40" fmla="*/ 127995 h 288268"/>
                <a:gd name="connsiteX41" fmla="*/ 55245 w 777980"/>
                <a:gd name="connsiteY41" fmla="*/ 160380 h 288268"/>
                <a:gd name="connsiteX42" fmla="*/ 20955 w 777980"/>
                <a:gd name="connsiteY42" fmla="*/ 206100 h 288268"/>
                <a:gd name="connsiteX43" fmla="*/ 0 w 777980"/>
                <a:gd name="connsiteY43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01025 w 777980"/>
                <a:gd name="connsiteY27" fmla="*/ 53959 h 288268"/>
                <a:gd name="connsiteX28" fmla="*/ 556260 w 777980"/>
                <a:gd name="connsiteY28" fmla="*/ 40365 h 288268"/>
                <a:gd name="connsiteX29" fmla="*/ 548640 w 777980"/>
                <a:gd name="connsiteY29" fmla="*/ 36555 h 288268"/>
                <a:gd name="connsiteX30" fmla="*/ 537210 w 777980"/>
                <a:gd name="connsiteY30" fmla="*/ 28935 h 288268"/>
                <a:gd name="connsiteX31" fmla="*/ 472440 w 777980"/>
                <a:gd name="connsiteY31" fmla="*/ 9165 h 288268"/>
                <a:gd name="connsiteX32" fmla="*/ 412430 w 777980"/>
                <a:gd name="connsiteY32" fmla="*/ 2111 h 288268"/>
                <a:gd name="connsiteX33" fmla="*/ 350052 w 777980"/>
                <a:gd name="connsiteY33" fmla="*/ 0 h 288268"/>
                <a:gd name="connsiteX34" fmla="*/ 300990 w 777980"/>
                <a:gd name="connsiteY34" fmla="*/ 4170 h 288268"/>
                <a:gd name="connsiteX35" fmla="*/ 268605 w 777980"/>
                <a:gd name="connsiteY35" fmla="*/ 11790 h 288268"/>
                <a:gd name="connsiteX36" fmla="*/ 226695 w 777980"/>
                <a:gd name="connsiteY36" fmla="*/ 28935 h 288268"/>
                <a:gd name="connsiteX37" fmla="*/ 182880 w 777980"/>
                <a:gd name="connsiteY37" fmla="*/ 55605 h 288268"/>
                <a:gd name="connsiteX38" fmla="*/ 123825 w 777980"/>
                <a:gd name="connsiteY38" fmla="*/ 97515 h 288268"/>
                <a:gd name="connsiteX39" fmla="*/ 87630 w 777980"/>
                <a:gd name="connsiteY39" fmla="*/ 127995 h 288268"/>
                <a:gd name="connsiteX40" fmla="*/ 55245 w 777980"/>
                <a:gd name="connsiteY40" fmla="*/ 160380 h 288268"/>
                <a:gd name="connsiteX41" fmla="*/ 20955 w 777980"/>
                <a:gd name="connsiteY41" fmla="*/ 206100 h 288268"/>
                <a:gd name="connsiteX42" fmla="*/ 0 w 777980"/>
                <a:gd name="connsiteY42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01025 w 777980"/>
                <a:gd name="connsiteY27" fmla="*/ 53959 h 288268"/>
                <a:gd name="connsiteX28" fmla="*/ 556260 w 777980"/>
                <a:gd name="connsiteY28" fmla="*/ 40365 h 288268"/>
                <a:gd name="connsiteX29" fmla="*/ 537210 w 777980"/>
                <a:gd name="connsiteY29" fmla="*/ 28935 h 288268"/>
                <a:gd name="connsiteX30" fmla="*/ 472440 w 777980"/>
                <a:gd name="connsiteY30" fmla="*/ 9165 h 288268"/>
                <a:gd name="connsiteX31" fmla="*/ 412430 w 777980"/>
                <a:gd name="connsiteY31" fmla="*/ 2111 h 288268"/>
                <a:gd name="connsiteX32" fmla="*/ 350052 w 777980"/>
                <a:gd name="connsiteY32" fmla="*/ 0 h 288268"/>
                <a:gd name="connsiteX33" fmla="*/ 300990 w 777980"/>
                <a:gd name="connsiteY33" fmla="*/ 4170 h 288268"/>
                <a:gd name="connsiteX34" fmla="*/ 268605 w 777980"/>
                <a:gd name="connsiteY34" fmla="*/ 11790 h 288268"/>
                <a:gd name="connsiteX35" fmla="*/ 226695 w 777980"/>
                <a:gd name="connsiteY35" fmla="*/ 28935 h 288268"/>
                <a:gd name="connsiteX36" fmla="*/ 182880 w 777980"/>
                <a:gd name="connsiteY36" fmla="*/ 55605 h 288268"/>
                <a:gd name="connsiteX37" fmla="*/ 123825 w 777980"/>
                <a:gd name="connsiteY37" fmla="*/ 97515 h 288268"/>
                <a:gd name="connsiteX38" fmla="*/ 87630 w 777980"/>
                <a:gd name="connsiteY38" fmla="*/ 127995 h 288268"/>
                <a:gd name="connsiteX39" fmla="*/ 55245 w 777980"/>
                <a:gd name="connsiteY39" fmla="*/ 160380 h 288268"/>
                <a:gd name="connsiteX40" fmla="*/ 20955 w 777980"/>
                <a:gd name="connsiteY40" fmla="*/ 206100 h 288268"/>
                <a:gd name="connsiteX41" fmla="*/ 0 w 777980"/>
                <a:gd name="connsiteY41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01025 w 777980"/>
                <a:gd name="connsiteY27" fmla="*/ 53959 h 288268"/>
                <a:gd name="connsiteX28" fmla="*/ 537210 w 777980"/>
                <a:gd name="connsiteY28" fmla="*/ 28935 h 288268"/>
                <a:gd name="connsiteX29" fmla="*/ 472440 w 777980"/>
                <a:gd name="connsiteY29" fmla="*/ 9165 h 288268"/>
                <a:gd name="connsiteX30" fmla="*/ 412430 w 777980"/>
                <a:gd name="connsiteY30" fmla="*/ 2111 h 288268"/>
                <a:gd name="connsiteX31" fmla="*/ 350052 w 777980"/>
                <a:gd name="connsiteY31" fmla="*/ 0 h 288268"/>
                <a:gd name="connsiteX32" fmla="*/ 300990 w 777980"/>
                <a:gd name="connsiteY32" fmla="*/ 4170 h 288268"/>
                <a:gd name="connsiteX33" fmla="*/ 268605 w 777980"/>
                <a:gd name="connsiteY33" fmla="*/ 11790 h 288268"/>
                <a:gd name="connsiteX34" fmla="*/ 226695 w 777980"/>
                <a:gd name="connsiteY34" fmla="*/ 28935 h 288268"/>
                <a:gd name="connsiteX35" fmla="*/ 182880 w 777980"/>
                <a:gd name="connsiteY35" fmla="*/ 55605 h 288268"/>
                <a:gd name="connsiteX36" fmla="*/ 123825 w 777980"/>
                <a:gd name="connsiteY36" fmla="*/ 97515 h 288268"/>
                <a:gd name="connsiteX37" fmla="*/ 87630 w 777980"/>
                <a:gd name="connsiteY37" fmla="*/ 127995 h 288268"/>
                <a:gd name="connsiteX38" fmla="*/ 55245 w 777980"/>
                <a:gd name="connsiteY38" fmla="*/ 160380 h 288268"/>
                <a:gd name="connsiteX39" fmla="*/ 20955 w 777980"/>
                <a:gd name="connsiteY39" fmla="*/ 206100 h 288268"/>
                <a:gd name="connsiteX40" fmla="*/ 0 w 777980"/>
                <a:gd name="connsiteY40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01025 w 777980"/>
                <a:gd name="connsiteY27" fmla="*/ 53959 h 288268"/>
                <a:gd name="connsiteX28" fmla="*/ 472440 w 777980"/>
                <a:gd name="connsiteY28" fmla="*/ 9165 h 288268"/>
                <a:gd name="connsiteX29" fmla="*/ 412430 w 777980"/>
                <a:gd name="connsiteY29" fmla="*/ 2111 h 288268"/>
                <a:gd name="connsiteX30" fmla="*/ 350052 w 777980"/>
                <a:gd name="connsiteY30" fmla="*/ 0 h 288268"/>
                <a:gd name="connsiteX31" fmla="*/ 300990 w 777980"/>
                <a:gd name="connsiteY31" fmla="*/ 4170 h 288268"/>
                <a:gd name="connsiteX32" fmla="*/ 268605 w 777980"/>
                <a:gd name="connsiteY32" fmla="*/ 11790 h 288268"/>
                <a:gd name="connsiteX33" fmla="*/ 226695 w 777980"/>
                <a:gd name="connsiteY33" fmla="*/ 28935 h 288268"/>
                <a:gd name="connsiteX34" fmla="*/ 182880 w 777980"/>
                <a:gd name="connsiteY34" fmla="*/ 55605 h 288268"/>
                <a:gd name="connsiteX35" fmla="*/ 123825 w 777980"/>
                <a:gd name="connsiteY35" fmla="*/ 97515 h 288268"/>
                <a:gd name="connsiteX36" fmla="*/ 87630 w 777980"/>
                <a:gd name="connsiteY36" fmla="*/ 127995 h 288268"/>
                <a:gd name="connsiteX37" fmla="*/ 55245 w 777980"/>
                <a:gd name="connsiteY37" fmla="*/ 160380 h 288268"/>
                <a:gd name="connsiteX38" fmla="*/ 20955 w 777980"/>
                <a:gd name="connsiteY38" fmla="*/ 206100 h 288268"/>
                <a:gd name="connsiteX39" fmla="*/ 0 w 777980"/>
                <a:gd name="connsiteY39" fmla="*/ 253725 h 288268"/>
                <a:gd name="connsiteX0" fmla="*/ 0 w 777980"/>
                <a:gd name="connsiteY0" fmla="*/ 253725 h 288268"/>
                <a:gd name="connsiteX1" fmla="*/ 19050 w 777980"/>
                <a:gd name="connsiteY1" fmla="*/ 270870 h 288268"/>
                <a:gd name="connsiteX2" fmla="*/ 45720 w 777980"/>
                <a:gd name="connsiteY2" fmla="*/ 288015 h 288268"/>
                <a:gd name="connsiteX3" fmla="*/ 66666 w 777980"/>
                <a:gd name="connsiteY3" fmla="*/ 256560 h 288268"/>
                <a:gd name="connsiteX4" fmla="*/ 112386 w 777980"/>
                <a:gd name="connsiteY4" fmla="*/ 201105 h 288268"/>
                <a:gd name="connsiteX5" fmla="*/ 171696 w 777980"/>
                <a:gd name="connsiteY5" fmla="*/ 151061 h 288268"/>
                <a:gd name="connsiteX6" fmla="*/ 244091 w 777980"/>
                <a:gd name="connsiteY6" fmla="*/ 105855 h 288268"/>
                <a:gd name="connsiteX7" fmla="*/ 282649 w 777980"/>
                <a:gd name="connsiteY7" fmla="*/ 88815 h 288268"/>
                <a:gd name="connsiteX8" fmla="*/ 324559 w 777980"/>
                <a:gd name="connsiteY8" fmla="*/ 77644 h 288268"/>
                <a:gd name="connsiteX9" fmla="*/ 382418 w 777980"/>
                <a:gd name="connsiteY9" fmla="*/ 76099 h 288268"/>
                <a:gd name="connsiteX10" fmla="*/ 456259 w 777980"/>
                <a:gd name="connsiteY10" fmla="*/ 80422 h 288268"/>
                <a:gd name="connsiteX11" fmla="*/ 531500 w 777980"/>
                <a:gd name="connsiteY11" fmla="*/ 96330 h 288268"/>
                <a:gd name="connsiteX12" fmla="*/ 550545 w 777980"/>
                <a:gd name="connsiteY12" fmla="*/ 107348 h 288268"/>
                <a:gd name="connsiteX13" fmla="*/ 583880 w 777980"/>
                <a:gd name="connsiteY13" fmla="*/ 130001 h 288268"/>
                <a:gd name="connsiteX14" fmla="*/ 628650 w 777980"/>
                <a:gd name="connsiteY14" fmla="*/ 169905 h 288268"/>
                <a:gd name="connsiteX15" fmla="*/ 667218 w 777980"/>
                <a:gd name="connsiteY15" fmla="*/ 208624 h 288268"/>
                <a:gd name="connsiteX16" fmla="*/ 709137 w 777980"/>
                <a:gd name="connsiteY16" fmla="*/ 271695 h 288268"/>
                <a:gd name="connsiteX17" fmla="*/ 727710 w 777980"/>
                <a:gd name="connsiteY17" fmla="*/ 270870 h 288268"/>
                <a:gd name="connsiteX18" fmla="*/ 762000 w 777980"/>
                <a:gd name="connsiteY18" fmla="*/ 242295 h 288268"/>
                <a:gd name="connsiteX19" fmla="*/ 777949 w 777980"/>
                <a:gd name="connsiteY19" fmla="*/ 229372 h 288268"/>
                <a:gd name="connsiteX20" fmla="*/ 765810 w 777980"/>
                <a:gd name="connsiteY20" fmla="*/ 202290 h 288268"/>
                <a:gd name="connsiteX21" fmla="*/ 756285 w 777980"/>
                <a:gd name="connsiteY21" fmla="*/ 183240 h 288268"/>
                <a:gd name="connsiteX22" fmla="*/ 739140 w 777980"/>
                <a:gd name="connsiteY22" fmla="*/ 154665 h 288268"/>
                <a:gd name="connsiteX23" fmla="*/ 727710 w 777980"/>
                <a:gd name="connsiteY23" fmla="*/ 137520 h 288268"/>
                <a:gd name="connsiteX24" fmla="*/ 720090 w 777980"/>
                <a:gd name="connsiteY24" fmla="*/ 131805 h 288268"/>
                <a:gd name="connsiteX25" fmla="*/ 697230 w 777980"/>
                <a:gd name="connsiteY25" fmla="*/ 114660 h 288268"/>
                <a:gd name="connsiteX26" fmla="*/ 676275 w 777980"/>
                <a:gd name="connsiteY26" fmla="*/ 101325 h 288268"/>
                <a:gd name="connsiteX27" fmla="*/ 601025 w 777980"/>
                <a:gd name="connsiteY27" fmla="*/ 53959 h 288268"/>
                <a:gd name="connsiteX28" fmla="*/ 481719 w 777980"/>
                <a:gd name="connsiteY28" fmla="*/ 6900 h 288268"/>
                <a:gd name="connsiteX29" fmla="*/ 412430 w 777980"/>
                <a:gd name="connsiteY29" fmla="*/ 2111 h 288268"/>
                <a:gd name="connsiteX30" fmla="*/ 350052 w 777980"/>
                <a:gd name="connsiteY30" fmla="*/ 0 h 288268"/>
                <a:gd name="connsiteX31" fmla="*/ 300990 w 777980"/>
                <a:gd name="connsiteY31" fmla="*/ 4170 h 288268"/>
                <a:gd name="connsiteX32" fmla="*/ 268605 w 777980"/>
                <a:gd name="connsiteY32" fmla="*/ 11790 h 288268"/>
                <a:gd name="connsiteX33" fmla="*/ 226695 w 777980"/>
                <a:gd name="connsiteY33" fmla="*/ 28935 h 288268"/>
                <a:gd name="connsiteX34" fmla="*/ 182880 w 777980"/>
                <a:gd name="connsiteY34" fmla="*/ 55605 h 288268"/>
                <a:gd name="connsiteX35" fmla="*/ 123825 w 777980"/>
                <a:gd name="connsiteY35" fmla="*/ 97515 h 288268"/>
                <a:gd name="connsiteX36" fmla="*/ 87630 w 777980"/>
                <a:gd name="connsiteY36" fmla="*/ 127995 h 288268"/>
                <a:gd name="connsiteX37" fmla="*/ 55245 w 777980"/>
                <a:gd name="connsiteY37" fmla="*/ 160380 h 288268"/>
                <a:gd name="connsiteX38" fmla="*/ 20955 w 777980"/>
                <a:gd name="connsiteY38" fmla="*/ 206100 h 288268"/>
                <a:gd name="connsiteX39" fmla="*/ 0 w 777980"/>
                <a:gd name="connsiteY39" fmla="*/ 253725 h 288268"/>
                <a:gd name="connsiteX0" fmla="*/ 0 w 777980"/>
                <a:gd name="connsiteY0" fmla="*/ 254445 h 288988"/>
                <a:gd name="connsiteX1" fmla="*/ 19050 w 777980"/>
                <a:gd name="connsiteY1" fmla="*/ 271590 h 288988"/>
                <a:gd name="connsiteX2" fmla="*/ 45720 w 777980"/>
                <a:gd name="connsiteY2" fmla="*/ 288735 h 288988"/>
                <a:gd name="connsiteX3" fmla="*/ 66666 w 777980"/>
                <a:gd name="connsiteY3" fmla="*/ 257280 h 288988"/>
                <a:gd name="connsiteX4" fmla="*/ 112386 w 777980"/>
                <a:gd name="connsiteY4" fmla="*/ 201825 h 288988"/>
                <a:gd name="connsiteX5" fmla="*/ 171696 w 777980"/>
                <a:gd name="connsiteY5" fmla="*/ 151781 h 288988"/>
                <a:gd name="connsiteX6" fmla="*/ 244091 w 777980"/>
                <a:gd name="connsiteY6" fmla="*/ 106575 h 288988"/>
                <a:gd name="connsiteX7" fmla="*/ 282649 w 777980"/>
                <a:gd name="connsiteY7" fmla="*/ 89535 h 288988"/>
                <a:gd name="connsiteX8" fmla="*/ 324559 w 777980"/>
                <a:gd name="connsiteY8" fmla="*/ 78364 h 288988"/>
                <a:gd name="connsiteX9" fmla="*/ 382418 w 777980"/>
                <a:gd name="connsiteY9" fmla="*/ 76819 h 288988"/>
                <a:gd name="connsiteX10" fmla="*/ 456259 w 777980"/>
                <a:gd name="connsiteY10" fmla="*/ 81142 h 288988"/>
                <a:gd name="connsiteX11" fmla="*/ 531500 w 777980"/>
                <a:gd name="connsiteY11" fmla="*/ 97050 h 288988"/>
                <a:gd name="connsiteX12" fmla="*/ 550545 w 777980"/>
                <a:gd name="connsiteY12" fmla="*/ 108068 h 288988"/>
                <a:gd name="connsiteX13" fmla="*/ 583880 w 777980"/>
                <a:gd name="connsiteY13" fmla="*/ 130721 h 288988"/>
                <a:gd name="connsiteX14" fmla="*/ 628650 w 777980"/>
                <a:gd name="connsiteY14" fmla="*/ 170625 h 288988"/>
                <a:gd name="connsiteX15" fmla="*/ 667218 w 777980"/>
                <a:gd name="connsiteY15" fmla="*/ 209344 h 288988"/>
                <a:gd name="connsiteX16" fmla="*/ 709137 w 777980"/>
                <a:gd name="connsiteY16" fmla="*/ 272415 h 288988"/>
                <a:gd name="connsiteX17" fmla="*/ 727710 w 777980"/>
                <a:gd name="connsiteY17" fmla="*/ 271590 h 288988"/>
                <a:gd name="connsiteX18" fmla="*/ 762000 w 777980"/>
                <a:gd name="connsiteY18" fmla="*/ 243015 h 288988"/>
                <a:gd name="connsiteX19" fmla="*/ 777949 w 777980"/>
                <a:gd name="connsiteY19" fmla="*/ 230092 h 288988"/>
                <a:gd name="connsiteX20" fmla="*/ 765810 w 777980"/>
                <a:gd name="connsiteY20" fmla="*/ 203010 h 288988"/>
                <a:gd name="connsiteX21" fmla="*/ 756285 w 777980"/>
                <a:gd name="connsiteY21" fmla="*/ 183960 h 288988"/>
                <a:gd name="connsiteX22" fmla="*/ 739140 w 777980"/>
                <a:gd name="connsiteY22" fmla="*/ 155385 h 288988"/>
                <a:gd name="connsiteX23" fmla="*/ 727710 w 777980"/>
                <a:gd name="connsiteY23" fmla="*/ 138240 h 288988"/>
                <a:gd name="connsiteX24" fmla="*/ 720090 w 777980"/>
                <a:gd name="connsiteY24" fmla="*/ 132525 h 288988"/>
                <a:gd name="connsiteX25" fmla="*/ 697230 w 777980"/>
                <a:gd name="connsiteY25" fmla="*/ 115380 h 288988"/>
                <a:gd name="connsiteX26" fmla="*/ 676275 w 777980"/>
                <a:gd name="connsiteY26" fmla="*/ 102045 h 288988"/>
                <a:gd name="connsiteX27" fmla="*/ 601025 w 777980"/>
                <a:gd name="connsiteY27" fmla="*/ 54679 h 288988"/>
                <a:gd name="connsiteX28" fmla="*/ 481719 w 777980"/>
                <a:gd name="connsiteY28" fmla="*/ 7620 h 288988"/>
                <a:gd name="connsiteX29" fmla="*/ 409575 w 777980"/>
                <a:gd name="connsiteY29" fmla="*/ 0 h 288988"/>
                <a:gd name="connsiteX30" fmla="*/ 350052 w 777980"/>
                <a:gd name="connsiteY30" fmla="*/ 720 h 288988"/>
                <a:gd name="connsiteX31" fmla="*/ 300990 w 777980"/>
                <a:gd name="connsiteY31" fmla="*/ 4890 h 288988"/>
                <a:gd name="connsiteX32" fmla="*/ 268605 w 777980"/>
                <a:gd name="connsiteY32" fmla="*/ 12510 h 288988"/>
                <a:gd name="connsiteX33" fmla="*/ 226695 w 777980"/>
                <a:gd name="connsiteY33" fmla="*/ 29655 h 288988"/>
                <a:gd name="connsiteX34" fmla="*/ 182880 w 777980"/>
                <a:gd name="connsiteY34" fmla="*/ 56325 h 288988"/>
                <a:gd name="connsiteX35" fmla="*/ 123825 w 777980"/>
                <a:gd name="connsiteY35" fmla="*/ 98235 h 288988"/>
                <a:gd name="connsiteX36" fmla="*/ 87630 w 777980"/>
                <a:gd name="connsiteY36" fmla="*/ 128715 h 288988"/>
                <a:gd name="connsiteX37" fmla="*/ 55245 w 777980"/>
                <a:gd name="connsiteY37" fmla="*/ 161100 h 288988"/>
                <a:gd name="connsiteX38" fmla="*/ 20955 w 777980"/>
                <a:gd name="connsiteY38" fmla="*/ 206820 h 288988"/>
                <a:gd name="connsiteX39" fmla="*/ 0 w 777980"/>
                <a:gd name="connsiteY39" fmla="*/ 254445 h 288988"/>
                <a:gd name="connsiteX0" fmla="*/ 0 w 777980"/>
                <a:gd name="connsiteY0" fmla="*/ 254445 h 288988"/>
                <a:gd name="connsiteX1" fmla="*/ 19050 w 777980"/>
                <a:gd name="connsiteY1" fmla="*/ 271590 h 288988"/>
                <a:gd name="connsiteX2" fmla="*/ 45720 w 777980"/>
                <a:gd name="connsiteY2" fmla="*/ 288735 h 288988"/>
                <a:gd name="connsiteX3" fmla="*/ 66666 w 777980"/>
                <a:gd name="connsiteY3" fmla="*/ 257280 h 288988"/>
                <a:gd name="connsiteX4" fmla="*/ 112386 w 777980"/>
                <a:gd name="connsiteY4" fmla="*/ 201825 h 288988"/>
                <a:gd name="connsiteX5" fmla="*/ 171696 w 777980"/>
                <a:gd name="connsiteY5" fmla="*/ 151781 h 288988"/>
                <a:gd name="connsiteX6" fmla="*/ 244091 w 777980"/>
                <a:gd name="connsiteY6" fmla="*/ 106575 h 288988"/>
                <a:gd name="connsiteX7" fmla="*/ 282649 w 777980"/>
                <a:gd name="connsiteY7" fmla="*/ 89535 h 288988"/>
                <a:gd name="connsiteX8" fmla="*/ 324559 w 777980"/>
                <a:gd name="connsiteY8" fmla="*/ 78364 h 288988"/>
                <a:gd name="connsiteX9" fmla="*/ 382418 w 777980"/>
                <a:gd name="connsiteY9" fmla="*/ 76819 h 288988"/>
                <a:gd name="connsiteX10" fmla="*/ 456259 w 777980"/>
                <a:gd name="connsiteY10" fmla="*/ 81142 h 288988"/>
                <a:gd name="connsiteX11" fmla="*/ 531500 w 777980"/>
                <a:gd name="connsiteY11" fmla="*/ 97050 h 288988"/>
                <a:gd name="connsiteX12" fmla="*/ 550545 w 777980"/>
                <a:gd name="connsiteY12" fmla="*/ 108068 h 288988"/>
                <a:gd name="connsiteX13" fmla="*/ 583880 w 777980"/>
                <a:gd name="connsiteY13" fmla="*/ 130721 h 288988"/>
                <a:gd name="connsiteX14" fmla="*/ 628650 w 777980"/>
                <a:gd name="connsiteY14" fmla="*/ 170625 h 288988"/>
                <a:gd name="connsiteX15" fmla="*/ 667218 w 777980"/>
                <a:gd name="connsiteY15" fmla="*/ 209344 h 288988"/>
                <a:gd name="connsiteX16" fmla="*/ 709137 w 777980"/>
                <a:gd name="connsiteY16" fmla="*/ 272415 h 288988"/>
                <a:gd name="connsiteX17" fmla="*/ 727710 w 777980"/>
                <a:gd name="connsiteY17" fmla="*/ 271590 h 288988"/>
                <a:gd name="connsiteX18" fmla="*/ 762000 w 777980"/>
                <a:gd name="connsiteY18" fmla="*/ 243015 h 288988"/>
                <a:gd name="connsiteX19" fmla="*/ 777949 w 777980"/>
                <a:gd name="connsiteY19" fmla="*/ 230092 h 288988"/>
                <a:gd name="connsiteX20" fmla="*/ 765810 w 777980"/>
                <a:gd name="connsiteY20" fmla="*/ 203010 h 288988"/>
                <a:gd name="connsiteX21" fmla="*/ 756285 w 777980"/>
                <a:gd name="connsiteY21" fmla="*/ 183960 h 288988"/>
                <a:gd name="connsiteX22" fmla="*/ 739140 w 777980"/>
                <a:gd name="connsiteY22" fmla="*/ 155385 h 288988"/>
                <a:gd name="connsiteX23" fmla="*/ 727710 w 777980"/>
                <a:gd name="connsiteY23" fmla="*/ 138240 h 288988"/>
                <a:gd name="connsiteX24" fmla="*/ 720090 w 777980"/>
                <a:gd name="connsiteY24" fmla="*/ 132525 h 288988"/>
                <a:gd name="connsiteX25" fmla="*/ 697230 w 777980"/>
                <a:gd name="connsiteY25" fmla="*/ 115380 h 288988"/>
                <a:gd name="connsiteX26" fmla="*/ 676275 w 777980"/>
                <a:gd name="connsiteY26" fmla="*/ 102045 h 288988"/>
                <a:gd name="connsiteX27" fmla="*/ 596029 w 777980"/>
                <a:gd name="connsiteY27" fmla="*/ 45052 h 288988"/>
                <a:gd name="connsiteX28" fmla="*/ 481719 w 777980"/>
                <a:gd name="connsiteY28" fmla="*/ 7620 h 288988"/>
                <a:gd name="connsiteX29" fmla="*/ 409575 w 777980"/>
                <a:gd name="connsiteY29" fmla="*/ 0 h 288988"/>
                <a:gd name="connsiteX30" fmla="*/ 350052 w 777980"/>
                <a:gd name="connsiteY30" fmla="*/ 720 h 288988"/>
                <a:gd name="connsiteX31" fmla="*/ 300990 w 777980"/>
                <a:gd name="connsiteY31" fmla="*/ 4890 h 288988"/>
                <a:gd name="connsiteX32" fmla="*/ 268605 w 777980"/>
                <a:gd name="connsiteY32" fmla="*/ 12510 h 288988"/>
                <a:gd name="connsiteX33" fmla="*/ 226695 w 777980"/>
                <a:gd name="connsiteY33" fmla="*/ 29655 h 288988"/>
                <a:gd name="connsiteX34" fmla="*/ 182880 w 777980"/>
                <a:gd name="connsiteY34" fmla="*/ 56325 h 288988"/>
                <a:gd name="connsiteX35" fmla="*/ 123825 w 777980"/>
                <a:gd name="connsiteY35" fmla="*/ 98235 h 288988"/>
                <a:gd name="connsiteX36" fmla="*/ 87630 w 777980"/>
                <a:gd name="connsiteY36" fmla="*/ 128715 h 288988"/>
                <a:gd name="connsiteX37" fmla="*/ 55245 w 777980"/>
                <a:gd name="connsiteY37" fmla="*/ 161100 h 288988"/>
                <a:gd name="connsiteX38" fmla="*/ 20955 w 777980"/>
                <a:gd name="connsiteY38" fmla="*/ 206820 h 288988"/>
                <a:gd name="connsiteX39" fmla="*/ 0 w 777980"/>
                <a:gd name="connsiteY39" fmla="*/ 254445 h 288988"/>
                <a:gd name="connsiteX0" fmla="*/ 0 w 777980"/>
                <a:gd name="connsiteY0" fmla="*/ 254445 h 288988"/>
                <a:gd name="connsiteX1" fmla="*/ 19050 w 777980"/>
                <a:gd name="connsiteY1" fmla="*/ 271590 h 288988"/>
                <a:gd name="connsiteX2" fmla="*/ 45720 w 777980"/>
                <a:gd name="connsiteY2" fmla="*/ 288735 h 288988"/>
                <a:gd name="connsiteX3" fmla="*/ 66666 w 777980"/>
                <a:gd name="connsiteY3" fmla="*/ 257280 h 288988"/>
                <a:gd name="connsiteX4" fmla="*/ 112386 w 777980"/>
                <a:gd name="connsiteY4" fmla="*/ 201825 h 288988"/>
                <a:gd name="connsiteX5" fmla="*/ 171696 w 777980"/>
                <a:gd name="connsiteY5" fmla="*/ 151781 h 288988"/>
                <a:gd name="connsiteX6" fmla="*/ 244091 w 777980"/>
                <a:gd name="connsiteY6" fmla="*/ 106575 h 288988"/>
                <a:gd name="connsiteX7" fmla="*/ 282649 w 777980"/>
                <a:gd name="connsiteY7" fmla="*/ 89535 h 288988"/>
                <a:gd name="connsiteX8" fmla="*/ 324559 w 777980"/>
                <a:gd name="connsiteY8" fmla="*/ 78364 h 288988"/>
                <a:gd name="connsiteX9" fmla="*/ 382418 w 777980"/>
                <a:gd name="connsiteY9" fmla="*/ 76819 h 288988"/>
                <a:gd name="connsiteX10" fmla="*/ 456259 w 777980"/>
                <a:gd name="connsiteY10" fmla="*/ 81142 h 288988"/>
                <a:gd name="connsiteX11" fmla="*/ 531500 w 777980"/>
                <a:gd name="connsiteY11" fmla="*/ 97050 h 288988"/>
                <a:gd name="connsiteX12" fmla="*/ 550545 w 777980"/>
                <a:gd name="connsiteY12" fmla="*/ 108068 h 288988"/>
                <a:gd name="connsiteX13" fmla="*/ 583880 w 777980"/>
                <a:gd name="connsiteY13" fmla="*/ 130721 h 288988"/>
                <a:gd name="connsiteX14" fmla="*/ 628650 w 777980"/>
                <a:gd name="connsiteY14" fmla="*/ 170625 h 288988"/>
                <a:gd name="connsiteX15" fmla="*/ 667218 w 777980"/>
                <a:gd name="connsiteY15" fmla="*/ 209344 h 288988"/>
                <a:gd name="connsiteX16" fmla="*/ 709137 w 777980"/>
                <a:gd name="connsiteY16" fmla="*/ 272415 h 288988"/>
                <a:gd name="connsiteX17" fmla="*/ 727710 w 777980"/>
                <a:gd name="connsiteY17" fmla="*/ 271590 h 288988"/>
                <a:gd name="connsiteX18" fmla="*/ 762000 w 777980"/>
                <a:gd name="connsiteY18" fmla="*/ 243015 h 288988"/>
                <a:gd name="connsiteX19" fmla="*/ 777949 w 777980"/>
                <a:gd name="connsiteY19" fmla="*/ 230092 h 288988"/>
                <a:gd name="connsiteX20" fmla="*/ 765810 w 777980"/>
                <a:gd name="connsiteY20" fmla="*/ 203010 h 288988"/>
                <a:gd name="connsiteX21" fmla="*/ 756285 w 777980"/>
                <a:gd name="connsiteY21" fmla="*/ 183960 h 288988"/>
                <a:gd name="connsiteX22" fmla="*/ 739140 w 777980"/>
                <a:gd name="connsiteY22" fmla="*/ 155385 h 288988"/>
                <a:gd name="connsiteX23" fmla="*/ 727710 w 777980"/>
                <a:gd name="connsiteY23" fmla="*/ 138240 h 288988"/>
                <a:gd name="connsiteX24" fmla="*/ 720090 w 777980"/>
                <a:gd name="connsiteY24" fmla="*/ 132525 h 288988"/>
                <a:gd name="connsiteX25" fmla="*/ 697230 w 777980"/>
                <a:gd name="connsiteY25" fmla="*/ 115380 h 288988"/>
                <a:gd name="connsiteX26" fmla="*/ 672706 w 777980"/>
                <a:gd name="connsiteY26" fmla="*/ 97515 h 288988"/>
                <a:gd name="connsiteX27" fmla="*/ 596029 w 777980"/>
                <a:gd name="connsiteY27" fmla="*/ 45052 h 288988"/>
                <a:gd name="connsiteX28" fmla="*/ 481719 w 777980"/>
                <a:gd name="connsiteY28" fmla="*/ 7620 h 288988"/>
                <a:gd name="connsiteX29" fmla="*/ 409575 w 777980"/>
                <a:gd name="connsiteY29" fmla="*/ 0 h 288988"/>
                <a:gd name="connsiteX30" fmla="*/ 350052 w 777980"/>
                <a:gd name="connsiteY30" fmla="*/ 720 h 288988"/>
                <a:gd name="connsiteX31" fmla="*/ 300990 w 777980"/>
                <a:gd name="connsiteY31" fmla="*/ 4890 h 288988"/>
                <a:gd name="connsiteX32" fmla="*/ 268605 w 777980"/>
                <a:gd name="connsiteY32" fmla="*/ 12510 h 288988"/>
                <a:gd name="connsiteX33" fmla="*/ 226695 w 777980"/>
                <a:gd name="connsiteY33" fmla="*/ 29655 h 288988"/>
                <a:gd name="connsiteX34" fmla="*/ 182880 w 777980"/>
                <a:gd name="connsiteY34" fmla="*/ 56325 h 288988"/>
                <a:gd name="connsiteX35" fmla="*/ 123825 w 777980"/>
                <a:gd name="connsiteY35" fmla="*/ 98235 h 288988"/>
                <a:gd name="connsiteX36" fmla="*/ 87630 w 777980"/>
                <a:gd name="connsiteY36" fmla="*/ 128715 h 288988"/>
                <a:gd name="connsiteX37" fmla="*/ 55245 w 777980"/>
                <a:gd name="connsiteY37" fmla="*/ 161100 h 288988"/>
                <a:gd name="connsiteX38" fmla="*/ 20955 w 777980"/>
                <a:gd name="connsiteY38" fmla="*/ 206820 h 288988"/>
                <a:gd name="connsiteX39" fmla="*/ 0 w 777980"/>
                <a:gd name="connsiteY39" fmla="*/ 254445 h 288988"/>
                <a:gd name="connsiteX0" fmla="*/ 0 w 777980"/>
                <a:gd name="connsiteY0" fmla="*/ 254445 h 288988"/>
                <a:gd name="connsiteX1" fmla="*/ 19050 w 777980"/>
                <a:gd name="connsiteY1" fmla="*/ 271590 h 288988"/>
                <a:gd name="connsiteX2" fmla="*/ 45720 w 777980"/>
                <a:gd name="connsiteY2" fmla="*/ 288735 h 288988"/>
                <a:gd name="connsiteX3" fmla="*/ 66666 w 777980"/>
                <a:gd name="connsiteY3" fmla="*/ 257280 h 288988"/>
                <a:gd name="connsiteX4" fmla="*/ 112386 w 777980"/>
                <a:gd name="connsiteY4" fmla="*/ 201825 h 288988"/>
                <a:gd name="connsiteX5" fmla="*/ 171696 w 777980"/>
                <a:gd name="connsiteY5" fmla="*/ 151781 h 288988"/>
                <a:gd name="connsiteX6" fmla="*/ 244091 w 777980"/>
                <a:gd name="connsiteY6" fmla="*/ 106575 h 288988"/>
                <a:gd name="connsiteX7" fmla="*/ 282649 w 777980"/>
                <a:gd name="connsiteY7" fmla="*/ 89535 h 288988"/>
                <a:gd name="connsiteX8" fmla="*/ 324559 w 777980"/>
                <a:gd name="connsiteY8" fmla="*/ 78364 h 288988"/>
                <a:gd name="connsiteX9" fmla="*/ 382418 w 777980"/>
                <a:gd name="connsiteY9" fmla="*/ 76819 h 288988"/>
                <a:gd name="connsiteX10" fmla="*/ 456259 w 777980"/>
                <a:gd name="connsiteY10" fmla="*/ 81142 h 288988"/>
                <a:gd name="connsiteX11" fmla="*/ 531500 w 777980"/>
                <a:gd name="connsiteY11" fmla="*/ 97050 h 288988"/>
                <a:gd name="connsiteX12" fmla="*/ 550545 w 777980"/>
                <a:gd name="connsiteY12" fmla="*/ 108068 h 288988"/>
                <a:gd name="connsiteX13" fmla="*/ 583880 w 777980"/>
                <a:gd name="connsiteY13" fmla="*/ 130721 h 288988"/>
                <a:gd name="connsiteX14" fmla="*/ 628650 w 777980"/>
                <a:gd name="connsiteY14" fmla="*/ 170625 h 288988"/>
                <a:gd name="connsiteX15" fmla="*/ 667218 w 777980"/>
                <a:gd name="connsiteY15" fmla="*/ 209344 h 288988"/>
                <a:gd name="connsiteX16" fmla="*/ 709137 w 777980"/>
                <a:gd name="connsiteY16" fmla="*/ 272415 h 288988"/>
                <a:gd name="connsiteX17" fmla="*/ 727710 w 777980"/>
                <a:gd name="connsiteY17" fmla="*/ 271590 h 288988"/>
                <a:gd name="connsiteX18" fmla="*/ 762000 w 777980"/>
                <a:gd name="connsiteY18" fmla="*/ 243015 h 288988"/>
                <a:gd name="connsiteX19" fmla="*/ 777949 w 777980"/>
                <a:gd name="connsiteY19" fmla="*/ 230092 h 288988"/>
                <a:gd name="connsiteX20" fmla="*/ 765810 w 777980"/>
                <a:gd name="connsiteY20" fmla="*/ 203010 h 288988"/>
                <a:gd name="connsiteX21" fmla="*/ 756285 w 777980"/>
                <a:gd name="connsiteY21" fmla="*/ 183960 h 288988"/>
                <a:gd name="connsiteX22" fmla="*/ 739140 w 777980"/>
                <a:gd name="connsiteY22" fmla="*/ 155385 h 288988"/>
                <a:gd name="connsiteX23" fmla="*/ 727710 w 777980"/>
                <a:gd name="connsiteY23" fmla="*/ 138240 h 288988"/>
                <a:gd name="connsiteX24" fmla="*/ 720090 w 777980"/>
                <a:gd name="connsiteY24" fmla="*/ 132525 h 288988"/>
                <a:gd name="connsiteX25" fmla="*/ 672706 w 777980"/>
                <a:gd name="connsiteY25" fmla="*/ 97515 h 288988"/>
                <a:gd name="connsiteX26" fmla="*/ 596029 w 777980"/>
                <a:gd name="connsiteY26" fmla="*/ 45052 h 288988"/>
                <a:gd name="connsiteX27" fmla="*/ 481719 w 777980"/>
                <a:gd name="connsiteY27" fmla="*/ 7620 h 288988"/>
                <a:gd name="connsiteX28" fmla="*/ 409575 w 777980"/>
                <a:gd name="connsiteY28" fmla="*/ 0 h 288988"/>
                <a:gd name="connsiteX29" fmla="*/ 350052 w 777980"/>
                <a:gd name="connsiteY29" fmla="*/ 720 h 288988"/>
                <a:gd name="connsiteX30" fmla="*/ 300990 w 777980"/>
                <a:gd name="connsiteY30" fmla="*/ 4890 h 288988"/>
                <a:gd name="connsiteX31" fmla="*/ 268605 w 777980"/>
                <a:gd name="connsiteY31" fmla="*/ 12510 h 288988"/>
                <a:gd name="connsiteX32" fmla="*/ 226695 w 777980"/>
                <a:gd name="connsiteY32" fmla="*/ 29655 h 288988"/>
                <a:gd name="connsiteX33" fmla="*/ 182880 w 777980"/>
                <a:gd name="connsiteY33" fmla="*/ 56325 h 288988"/>
                <a:gd name="connsiteX34" fmla="*/ 123825 w 777980"/>
                <a:gd name="connsiteY34" fmla="*/ 98235 h 288988"/>
                <a:gd name="connsiteX35" fmla="*/ 87630 w 777980"/>
                <a:gd name="connsiteY35" fmla="*/ 128715 h 288988"/>
                <a:gd name="connsiteX36" fmla="*/ 55245 w 777980"/>
                <a:gd name="connsiteY36" fmla="*/ 161100 h 288988"/>
                <a:gd name="connsiteX37" fmla="*/ 20955 w 777980"/>
                <a:gd name="connsiteY37" fmla="*/ 206820 h 288988"/>
                <a:gd name="connsiteX38" fmla="*/ 0 w 777980"/>
                <a:gd name="connsiteY38" fmla="*/ 254445 h 288988"/>
                <a:gd name="connsiteX0" fmla="*/ 0 w 777980"/>
                <a:gd name="connsiteY0" fmla="*/ 254445 h 288988"/>
                <a:gd name="connsiteX1" fmla="*/ 19050 w 777980"/>
                <a:gd name="connsiteY1" fmla="*/ 271590 h 288988"/>
                <a:gd name="connsiteX2" fmla="*/ 45720 w 777980"/>
                <a:gd name="connsiteY2" fmla="*/ 288735 h 288988"/>
                <a:gd name="connsiteX3" fmla="*/ 66666 w 777980"/>
                <a:gd name="connsiteY3" fmla="*/ 257280 h 288988"/>
                <a:gd name="connsiteX4" fmla="*/ 112386 w 777980"/>
                <a:gd name="connsiteY4" fmla="*/ 201825 h 288988"/>
                <a:gd name="connsiteX5" fmla="*/ 171696 w 777980"/>
                <a:gd name="connsiteY5" fmla="*/ 151781 h 288988"/>
                <a:gd name="connsiteX6" fmla="*/ 244091 w 777980"/>
                <a:gd name="connsiteY6" fmla="*/ 106575 h 288988"/>
                <a:gd name="connsiteX7" fmla="*/ 282649 w 777980"/>
                <a:gd name="connsiteY7" fmla="*/ 89535 h 288988"/>
                <a:gd name="connsiteX8" fmla="*/ 324559 w 777980"/>
                <a:gd name="connsiteY8" fmla="*/ 78364 h 288988"/>
                <a:gd name="connsiteX9" fmla="*/ 382418 w 777980"/>
                <a:gd name="connsiteY9" fmla="*/ 76819 h 288988"/>
                <a:gd name="connsiteX10" fmla="*/ 456259 w 777980"/>
                <a:gd name="connsiteY10" fmla="*/ 81142 h 288988"/>
                <a:gd name="connsiteX11" fmla="*/ 531500 w 777980"/>
                <a:gd name="connsiteY11" fmla="*/ 97050 h 288988"/>
                <a:gd name="connsiteX12" fmla="*/ 550545 w 777980"/>
                <a:gd name="connsiteY12" fmla="*/ 108068 h 288988"/>
                <a:gd name="connsiteX13" fmla="*/ 583880 w 777980"/>
                <a:gd name="connsiteY13" fmla="*/ 130721 h 288988"/>
                <a:gd name="connsiteX14" fmla="*/ 628650 w 777980"/>
                <a:gd name="connsiteY14" fmla="*/ 170625 h 288988"/>
                <a:gd name="connsiteX15" fmla="*/ 667218 w 777980"/>
                <a:gd name="connsiteY15" fmla="*/ 209344 h 288988"/>
                <a:gd name="connsiteX16" fmla="*/ 709137 w 777980"/>
                <a:gd name="connsiteY16" fmla="*/ 272415 h 288988"/>
                <a:gd name="connsiteX17" fmla="*/ 727710 w 777980"/>
                <a:gd name="connsiteY17" fmla="*/ 271590 h 288988"/>
                <a:gd name="connsiteX18" fmla="*/ 762000 w 777980"/>
                <a:gd name="connsiteY18" fmla="*/ 243015 h 288988"/>
                <a:gd name="connsiteX19" fmla="*/ 777949 w 777980"/>
                <a:gd name="connsiteY19" fmla="*/ 230092 h 288988"/>
                <a:gd name="connsiteX20" fmla="*/ 765810 w 777980"/>
                <a:gd name="connsiteY20" fmla="*/ 203010 h 288988"/>
                <a:gd name="connsiteX21" fmla="*/ 756285 w 777980"/>
                <a:gd name="connsiteY21" fmla="*/ 183960 h 288988"/>
                <a:gd name="connsiteX22" fmla="*/ 739140 w 777980"/>
                <a:gd name="connsiteY22" fmla="*/ 155385 h 288988"/>
                <a:gd name="connsiteX23" fmla="*/ 720090 w 777980"/>
                <a:gd name="connsiteY23" fmla="*/ 132525 h 288988"/>
                <a:gd name="connsiteX24" fmla="*/ 672706 w 777980"/>
                <a:gd name="connsiteY24" fmla="*/ 97515 h 288988"/>
                <a:gd name="connsiteX25" fmla="*/ 596029 w 777980"/>
                <a:gd name="connsiteY25" fmla="*/ 45052 h 288988"/>
                <a:gd name="connsiteX26" fmla="*/ 481719 w 777980"/>
                <a:gd name="connsiteY26" fmla="*/ 7620 h 288988"/>
                <a:gd name="connsiteX27" fmla="*/ 409575 w 777980"/>
                <a:gd name="connsiteY27" fmla="*/ 0 h 288988"/>
                <a:gd name="connsiteX28" fmla="*/ 350052 w 777980"/>
                <a:gd name="connsiteY28" fmla="*/ 720 h 288988"/>
                <a:gd name="connsiteX29" fmla="*/ 300990 w 777980"/>
                <a:gd name="connsiteY29" fmla="*/ 4890 h 288988"/>
                <a:gd name="connsiteX30" fmla="*/ 268605 w 777980"/>
                <a:gd name="connsiteY30" fmla="*/ 12510 h 288988"/>
                <a:gd name="connsiteX31" fmla="*/ 226695 w 777980"/>
                <a:gd name="connsiteY31" fmla="*/ 29655 h 288988"/>
                <a:gd name="connsiteX32" fmla="*/ 182880 w 777980"/>
                <a:gd name="connsiteY32" fmla="*/ 56325 h 288988"/>
                <a:gd name="connsiteX33" fmla="*/ 123825 w 777980"/>
                <a:gd name="connsiteY33" fmla="*/ 98235 h 288988"/>
                <a:gd name="connsiteX34" fmla="*/ 87630 w 777980"/>
                <a:gd name="connsiteY34" fmla="*/ 128715 h 288988"/>
                <a:gd name="connsiteX35" fmla="*/ 55245 w 777980"/>
                <a:gd name="connsiteY35" fmla="*/ 161100 h 288988"/>
                <a:gd name="connsiteX36" fmla="*/ 20955 w 777980"/>
                <a:gd name="connsiteY36" fmla="*/ 206820 h 288988"/>
                <a:gd name="connsiteX37" fmla="*/ 0 w 777980"/>
                <a:gd name="connsiteY37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2418 w 777993"/>
                <a:gd name="connsiteY9" fmla="*/ 76819 h 288988"/>
                <a:gd name="connsiteX10" fmla="*/ 456259 w 777993"/>
                <a:gd name="connsiteY10" fmla="*/ 81142 h 288988"/>
                <a:gd name="connsiteX11" fmla="*/ 531500 w 777993"/>
                <a:gd name="connsiteY11" fmla="*/ 97050 h 288988"/>
                <a:gd name="connsiteX12" fmla="*/ 550545 w 777993"/>
                <a:gd name="connsiteY12" fmla="*/ 108068 h 288988"/>
                <a:gd name="connsiteX13" fmla="*/ 583880 w 777993"/>
                <a:gd name="connsiteY13" fmla="*/ 130721 h 288988"/>
                <a:gd name="connsiteX14" fmla="*/ 628650 w 777993"/>
                <a:gd name="connsiteY14" fmla="*/ 170625 h 288988"/>
                <a:gd name="connsiteX15" fmla="*/ 667218 w 777993"/>
                <a:gd name="connsiteY15" fmla="*/ 209344 h 288988"/>
                <a:gd name="connsiteX16" fmla="*/ 709137 w 777993"/>
                <a:gd name="connsiteY16" fmla="*/ 272415 h 288988"/>
                <a:gd name="connsiteX17" fmla="*/ 727710 w 777993"/>
                <a:gd name="connsiteY17" fmla="*/ 271590 h 288988"/>
                <a:gd name="connsiteX18" fmla="*/ 762000 w 777993"/>
                <a:gd name="connsiteY18" fmla="*/ 243015 h 288988"/>
                <a:gd name="connsiteX19" fmla="*/ 777949 w 777993"/>
                <a:gd name="connsiteY19" fmla="*/ 230092 h 288988"/>
                <a:gd name="connsiteX20" fmla="*/ 765810 w 777993"/>
                <a:gd name="connsiteY20" fmla="*/ 203010 h 288988"/>
                <a:gd name="connsiteX21" fmla="*/ 739140 w 777993"/>
                <a:gd name="connsiteY21" fmla="*/ 155385 h 288988"/>
                <a:gd name="connsiteX22" fmla="*/ 720090 w 777993"/>
                <a:gd name="connsiteY22" fmla="*/ 132525 h 288988"/>
                <a:gd name="connsiteX23" fmla="*/ 672706 w 777993"/>
                <a:gd name="connsiteY23" fmla="*/ 97515 h 288988"/>
                <a:gd name="connsiteX24" fmla="*/ 596029 w 777993"/>
                <a:gd name="connsiteY24" fmla="*/ 45052 h 288988"/>
                <a:gd name="connsiteX25" fmla="*/ 481719 w 777993"/>
                <a:gd name="connsiteY25" fmla="*/ 7620 h 288988"/>
                <a:gd name="connsiteX26" fmla="*/ 409575 w 777993"/>
                <a:gd name="connsiteY26" fmla="*/ 0 h 288988"/>
                <a:gd name="connsiteX27" fmla="*/ 350052 w 777993"/>
                <a:gd name="connsiteY27" fmla="*/ 720 h 288988"/>
                <a:gd name="connsiteX28" fmla="*/ 300990 w 777993"/>
                <a:gd name="connsiteY28" fmla="*/ 4890 h 288988"/>
                <a:gd name="connsiteX29" fmla="*/ 268605 w 777993"/>
                <a:gd name="connsiteY29" fmla="*/ 12510 h 288988"/>
                <a:gd name="connsiteX30" fmla="*/ 226695 w 777993"/>
                <a:gd name="connsiteY30" fmla="*/ 29655 h 288988"/>
                <a:gd name="connsiteX31" fmla="*/ 182880 w 777993"/>
                <a:gd name="connsiteY31" fmla="*/ 56325 h 288988"/>
                <a:gd name="connsiteX32" fmla="*/ 123825 w 777993"/>
                <a:gd name="connsiteY32" fmla="*/ 98235 h 288988"/>
                <a:gd name="connsiteX33" fmla="*/ 87630 w 777993"/>
                <a:gd name="connsiteY33" fmla="*/ 128715 h 288988"/>
                <a:gd name="connsiteX34" fmla="*/ 55245 w 777993"/>
                <a:gd name="connsiteY34" fmla="*/ 161100 h 288988"/>
                <a:gd name="connsiteX35" fmla="*/ 20955 w 777993"/>
                <a:gd name="connsiteY35" fmla="*/ 206820 h 288988"/>
                <a:gd name="connsiteX36" fmla="*/ 0 w 777993"/>
                <a:gd name="connsiteY36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2418 w 777993"/>
                <a:gd name="connsiteY9" fmla="*/ 76819 h 288988"/>
                <a:gd name="connsiteX10" fmla="*/ 456259 w 777993"/>
                <a:gd name="connsiteY10" fmla="*/ 81142 h 288988"/>
                <a:gd name="connsiteX11" fmla="*/ 531500 w 777993"/>
                <a:gd name="connsiteY11" fmla="*/ 97050 h 288988"/>
                <a:gd name="connsiteX12" fmla="*/ 557683 w 777993"/>
                <a:gd name="connsiteY12" fmla="*/ 108634 h 288988"/>
                <a:gd name="connsiteX13" fmla="*/ 583880 w 777993"/>
                <a:gd name="connsiteY13" fmla="*/ 130721 h 288988"/>
                <a:gd name="connsiteX14" fmla="*/ 628650 w 777993"/>
                <a:gd name="connsiteY14" fmla="*/ 170625 h 288988"/>
                <a:gd name="connsiteX15" fmla="*/ 667218 w 777993"/>
                <a:gd name="connsiteY15" fmla="*/ 209344 h 288988"/>
                <a:gd name="connsiteX16" fmla="*/ 709137 w 777993"/>
                <a:gd name="connsiteY16" fmla="*/ 272415 h 288988"/>
                <a:gd name="connsiteX17" fmla="*/ 727710 w 777993"/>
                <a:gd name="connsiteY17" fmla="*/ 271590 h 288988"/>
                <a:gd name="connsiteX18" fmla="*/ 762000 w 777993"/>
                <a:gd name="connsiteY18" fmla="*/ 243015 h 288988"/>
                <a:gd name="connsiteX19" fmla="*/ 777949 w 777993"/>
                <a:gd name="connsiteY19" fmla="*/ 230092 h 288988"/>
                <a:gd name="connsiteX20" fmla="*/ 765810 w 777993"/>
                <a:gd name="connsiteY20" fmla="*/ 203010 h 288988"/>
                <a:gd name="connsiteX21" fmla="*/ 739140 w 777993"/>
                <a:gd name="connsiteY21" fmla="*/ 155385 h 288988"/>
                <a:gd name="connsiteX22" fmla="*/ 720090 w 777993"/>
                <a:gd name="connsiteY22" fmla="*/ 132525 h 288988"/>
                <a:gd name="connsiteX23" fmla="*/ 672706 w 777993"/>
                <a:gd name="connsiteY23" fmla="*/ 97515 h 288988"/>
                <a:gd name="connsiteX24" fmla="*/ 596029 w 777993"/>
                <a:gd name="connsiteY24" fmla="*/ 45052 h 288988"/>
                <a:gd name="connsiteX25" fmla="*/ 481719 w 777993"/>
                <a:gd name="connsiteY25" fmla="*/ 7620 h 288988"/>
                <a:gd name="connsiteX26" fmla="*/ 409575 w 777993"/>
                <a:gd name="connsiteY26" fmla="*/ 0 h 288988"/>
                <a:gd name="connsiteX27" fmla="*/ 350052 w 777993"/>
                <a:gd name="connsiteY27" fmla="*/ 720 h 288988"/>
                <a:gd name="connsiteX28" fmla="*/ 300990 w 777993"/>
                <a:gd name="connsiteY28" fmla="*/ 4890 h 288988"/>
                <a:gd name="connsiteX29" fmla="*/ 268605 w 777993"/>
                <a:gd name="connsiteY29" fmla="*/ 12510 h 288988"/>
                <a:gd name="connsiteX30" fmla="*/ 226695 w 777993"/>
                <a:gd name="connsiteY30" fmla="*/ 29655 h 288988"/>
                <a:gd name="connsiteX31" fmla="*/ 182880 w 777993"/>
                <a:gd name="connsiteY31" fmla="*/ 56325 h 288988"/>
                <a:gd name="connsiteX32" fmla="*/ 123825 w 777993"/>
                <a:gd name="connsiteY32" fmla="*/ 98235 h 288988"/>
                <a:gd name="connsiteX33" fmla="*/ 87630 w 777993"/>
                <a:gd name="connsiteY33" fmla="*/ 128715 h 288988"/>
                <a:gd name="connsiteX34" fmla="*/ 55245 w 777993"/>
                <a:gd name="connsiteY34" fmla="*/ 161100 h 288988"/>
                <a:gd name="connsiteX35" fmla="*/ 20955 w 777993"/>
                <a:gd name="connsiteY35" fmla="*/ 206820 h 288988"/>
                <a:gd name="connsiteX36" fmla="*/ 0 w 777993"/>
                <a:gd name="connsiteY36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2418 w 777993"/>
                <a:gd name="connsiteY9" fmla="*/ 76819 h 288988"/>
                <a:gd name="connsiteX10" fmla="*/ 456259 w 777993"/>
                <a:gd name="connsiteY10" fmla="*/ 81142 h 288988"/>
                <a:gd name="connsiteX11" fmla="*/ 531500 w 777993"/>
                <a:gd name="connsiteY11" fmla="*/ 97050 h 288988"/>
                <a:gd name="connsiteX12" fmla="*/ 557683 w 777993"/>
                <a:gd name="connsiteY12" fmla="*/ 10863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68605 w 777993"/>
                <a:gd name="connsiteY28" fmla="*/ 12510 h 288988"/>
                <a:gd name="connsiteX29" fmla="*/ 226695 w 777993"/>
                <a:gd name="connsiteY29" fmla="*/ 29655 h 288988"/>
                <a:gd name="connsiteX30" fmla="*/ 182880 w 777993"/>
                <a:gd name="connsiteY30" fmla="*/ 56325 h 288988"/>
                <a:gd name="connsiteX31" fmla="*/ 123825 w 777993"/>
                <a:gd name="connsiteY31" fmla="*/ 98235 h 288988"/>
                <a:gd name="connsiteX32" fmla="*/ 87630 w 777993"/>
                <a:gd name="connsiteY32" fmla="*/ 128715 h 288988"/>
                <a:gd name="connsiteX33" fmla="*/ 55245 w 777993"/>
                <a:gd name="connsiteY33" fmla="*/ 161100 h 288988"/>
                <a:gd name="connsiteX34" fmla="*/ 20955 w 777993"/>
                <a:gd name="connsiteY34" fmla="*/ 206820 h 288988"/>
                <a:gd name="connsiteX35" fmla="*/ 0 w 777993"/>
                <a:gd name="connsiteY35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2418 w 777993"/>
                <a:gd name="connsiteY9" fmla="*/ 76819 h 288988"/>
                <a:gd name="connsiteX10" fmla="*/ 456259 w 777993"/>
                <a:gd name="connsiteY10" fmla="*/ 81142 h 288988"/>
                <a:gd name="connsiteX11" fmla="*/ 531500 w 777993"/>
                <a:gd name="connsiteY11" fmla="*/ 97050 h 288988"/>
                <a:gd name="connsiteX12" fmla="*/ 574100 w 777993"/>
                <a:gd name="connsiteY12" fmla="*/ 11769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68605 w 777993"/>
                <a:gd name="connsiteY28" fmla="*/ 12510 h 288988"/>
                <a:gd name="connsiteX29" fmla="*/ 226695 w 777993"/>
                <a:gd name="connsiteY29" fmla="*/ 29655 h 288988"/>
                <a:gd name="connsiteX30" fmla="*/ 182880 w 777993"/>
                <a:gd name="connsiteY30" fmla="*/ 56325 h 288988"/>
                <a:gd name="connsiteX31" fmla="*/ 123825 w 777993"/>
                <a:gd name="connsiteY31" fmla="*/ 98235 h 288988"/>
                <a:gd name="connsiteX32" fmla="*/ 87630 w 777993"/>
                <a:gd name="connsiteY32" fmla="*/ 128715 h 288988"/>
                <a:gd name="connsiteX33" fmla="*/ 55245 w 777993"/>
                <a:gd name="connsiteY33" fmla="*/ 161100 h 288988"/>
                <a:gd name="connsiteX34" fmla="*/ 20955 w 777993"/>
                <a:gd name="connsiteY34" fmla="*/ 206820 h 288988"/>
                <a:gd name="connsiteX35" fmla="*/ 0 w 777993"/>
                <a:gd name="connsiteY35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2418 w 777993"/>
                <a:gd name="connsiteY9" fmla="*/ 76819 h 288988"/>
                <a:gd name="connsiteX10" fmla="*/ 462683 w 777993"/>
                <a:gd name="connsiteY10" fmla="*/ 75479 h 288988"/>
                <a:gd name="connsiteX11" fmla="*/ 531500 w 777993"/>
                <a:gd name="connsiteY11" fmla="*/ 97050 h 288988"/>
                <a:gd name="connsiteX12" fmla="*/ 574100 w 777993"/>
                <a:gd name="connsiteY12" fmla="*/ 11769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68605 w 777993"/>
                <a:gd name="connsiteY28" fmla="*/ 12510 h 288988"/>
                <a:gd name="connsiteX29" fmla="*/ 226695 w 777993"/>
                <a:gd name="connsiteY29" fmla="*/ 29655 h 288988"/>
                <a:gd name="connsiteX30" fmla="*/ 182880 w 777993"/>
                <a:gd name="connsiteY30" fmla="*/ 56325 h 288988"/>
                <a:gd name="connsiteX31" fmla="*/ 123825 w 777993"/>
                <a:gd name="connsiteY31" fmla="*/ 98235 h 288988"/>
                <a:gd name="connsiteX32" fmla="*/ 87630 w 777993"/>
                <a:gd name="connsiteY32" fmla="*/ 128715 h 288988"/>
                <a:gd name="connsiteX33" fmla="*/ 55245 w 777993"/>
                <a:gd name="connsiteY33" fmla="*/ 161100 h 288988"/>
                <a:gd name="connsiteX34" fmla="*/ 20955 w 777993"/>
                <a:gd name="connsiteY34" fmla="*/ 206820 h 288988"/>
                <a:gd name="connsiteX35" fmla="*/ 0 w 777993"/>
                <a:gd name="connsiteY35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2418 w 777993"/>
                <a:gd name="connsiteY9" fmla="*/ 76819 h 288988"/>
                <a:gd name="connsiteX10" fmla="*/ 462683 w 777993"/>
                <a:gd name="connsiteY10" fmla="*/ 75479 h 288988"/>
                <a:gd name="connsiteX11" fmla="*/ 531500 w 777993"/>
                <a:gd name="connsiteY11" fmla="*/ 97050 h 288988"/>
                <a:gd name="connsiteX12" fmla="*/ 574100 w 777993"/>
                <a:gd name="connsiteY12" fmla="*/ 11769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68605 w 777993"/>
                <a:gd name="connsiteY28" fmla="*/ 12510 h 288988"/>
                <a:gd name="connsiteX29" fmla="*/ 226695 w 777993"/>
                <a:gd name="connsiteY29" fmla="*/ 29655 h 288988"/>
                <a:gd name="connsiteX30" fmla="*/ 182880 w 777993"/>
                <a:gd name="connsiteY30" fmla="*/ 56325 h 288988"/>
                <a:gd name="connsiteX31" fmla="*/ 123825 w 777993"/>
                <a:gd name="connsiteY31" fmla="*/ 98235 h 288988"/>
                <a:gd name="connsiteX32" fmla="*/ 87630 w 777993"/>
                <a:gd name="connsiteY32" fmla="*/ 128715 h 288988"/>
                <a:gd name="connsiteX33" fmla="*/ 55245 w 777993"/>
                <a:gd name="connsiteY33" fmla="*/ 161100 h 288988"/>
                <a:gd name="connsiteX34" fmla="*/ 20955 w 777993"/>
                <a:gd name="connsiteY34" fmla="*/ 206820 h 288988"/>
                <a:gd name="connsiteX35" fmla="*/ 0 w 777993"/>
                <a:gd name="connsiteY35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2418 w 777993"/>
                <a:gd name="connsiteY9" fmla="*/ 76819 h 288988"/>
                <a:gd name="connsiteX10" fmla="*/ 462683 w 777993"/>
                <a:gd name="connsiteY10" fmla="*/ 75479 h 288988"/>
                <a:gd name="connsiteX11" fmla="*/ 531500 w 777993"/>
                <a:gd name="connsiteY11" fmla="*/ 97050 h 288988"/>
                <a:gd name="connsiteX12" fmla="*/ 574100 w 777993"/>
                <a:gd name="connsiteY12" fmla="*/ 11769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68605 w 777993"/>
                <a:gd name="connsiteY28" fmla="*/ 12510 h 288988"/>
                <a:gd name="connsiteX29" fmla="*/ 226695 w 777993"/>
                <a:gd name="connsiteY29" fmla="*/ 29655 h 288988"/>
                <a:gd name="connsiteX30" fmla="*/ 182880 w 777993"/>
                <a:gd name="connsiteY30" fmla="*/ 56325 h 288988"/>
                <a:gd name="connsiteX31" fmla="*/ 123825 w 777993"/>
                <a:gd name="connsiteY31" fmla="*/ 98235 h 288988"/>
                <a:gd name="connsiteX32" fmla="*/ 87630 w 777993"/>
                <a:gd name="connsiteY32" fmla="*/ 128715 h 288988"/>
                <a:gd name="connsiteX33" fmla="*/ 55245 w 777993"/>
                <a:gd name="connsiteY33" fmla="*/ 161100 h 288988"/>
                <a:gd name="connsiteX34" fmla="*/ 20955 w 777993"/>
                <a:gd name="connsiteY34" fmla="*/ 206820 h 288988"/>
                <a:gd name="connsiteX35" fmla="*/ 0 w 777993"/>
                <a:gd name="connsiteY35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2418 w 777993"/>
                <a:gd name="connsiteY9" fmla="*/ 76819 h 288988"/>
                <a:gd name="connsiteX10" fmla="*/ 462683 w 777993"/>
                <a:gd name="connsiteY10" fmla="*/ 75479 h 288988"/>
                <a:gd name="connsiteX11" fmla="*/ 527217 w 777993"/>
                <a:gd name="connsiteY11" fmla="*/ 93652 h 288988"/>
                <a:gd name="connsiteX12" fmla="*/ 574100 w 777993"/>
                <a:gd name="connsiteY12" fmla="*/ 11769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68605 w 777993"/>
                <a:gd name="connsiteY28" fmla="*/ 12510 h 288988"/>
                <a:gd name="connsiteX29" fmla="*/ 226695 w 777993"/>
                <a:gd name="connsiteY29" fmla="*/ 29655 h 288988"/>
                <a:gd name="connsiteX30" fmla="*/ 182880 w 777993"/>
                <a:gd name="connsiteY30" fmla="*/ 56325 h 288988"/>
                <a:gd name="connsiteX31" fmla="*/ 123825 w 777993"/>
                <a:gd name="connsiteY31" fmla="*/ 98235 h 288988"/>
                <a:gd name="connsiteX32" fmla="*/ 87630 w 777993"/>
                <a:gd name="connsiteY32" fmla="*/ 128715 h 288988"/>
                <a:gd name="connsiteX33" fmla="*/ 55245 w 777993"/>
                <a:gd name="connsiteY33" fmla="*/ 161100 h 288988"/>
                <a:gd name="connsiteX34" fmla="*/ 20955 w 777993"/>
                <a:gd name="connsiteY34" fmla="*/ 206820 h 288988"/>
                <a:gd name="connsiteX35" fmla="*/ 0 w 777993"/>
                <a:gd name="connsiteY35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8842 w 777993"/>
                <a:gd name="connsiteY9" fmla="*/ 70590 h 288988"/>
                <a:gd name="connsiteX10" fmla="*/ 462683 w 777993"/>
                <a:gd name="connsiteY10" fmla="*/ 75479 h 288988"/>
                <a:gd name="connsiteX11" fmla="*/ 527217 w 777993"/>
                <a:gd name="connsiteY11" fmla="*/ 93652 h 288988"/>
                <a:gd name="connsiteX12" fmla="*/ 574100 w 777993"/>
                <a:gd name="connsiteY12" fmla="*/ 11769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68605 w 777993"/>
                <a:gd name="connsiteY28" fmla="*/ 12510 h 288988"/>
                <a:gd name="connsiteX29" fmla="*/ 226695 w 777993"/>
                <a:gd name="connsiteY29" fmla="*/ 29655 h 288988"/>
                <a:gd name="connsiteX30" fmla="*/ 182880 w 777993"/>
                <a:gd name="connsiteY30" fmla="*/ 56325 h 288988"/>
                <a:gd name="connsiteX31" fmla="*/ 123825 w 777993"/>
                <a:gd name="connsiteY31" fmla="*/ 98235 h 288988"/>
                <a:gd name="connsiteX32" fmla="*/ 87630 w 777993"/>
                <a:gd name="connsiteY32" fmla="*/ 128715 h 288988"/>
                <a:gd name="connsiteX33" fmla="*/ 55245 w 777993"/>
                <a:gd name="connsiteY33" fmla="*/ 161100 h 288988"/>
                <a:gd name="connsiteX34" fmla="*/ 20955 w 777993"/>
                <a:gd name="connsiteY34" fmla="*/ 206820 h 288988"/>
                <a:gd name="connsiteX35" fmla="*/ 0 w 777993"/>
                <a:gd name="connsiteY35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8842 w 777993"/>
                <a:gd name="connsiteY9" fmla="*/ 70590 h 288988"/>
                <a:gd name="connsiteX10" fmla="*/ 462683 w 777993"/>
                <a:gd name="connsiteY10" fmla="*/ 75479 h 288988"/>
                <a:gd name="connsiteX11" fmla="*/ 527217 w 777993"/>
                <a:gd name="connsiteY11" fmla="*/ 93652 h 288988"/>
                <a:gd name="connsiteX12" fmla="*/ 574100 w 777993"/>
                <a:gd name="connsiteY12" fmla="*/ 11769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65750 w 777993"/>
                <a:gd name="connsiteY28" fmla="*/ 15341 h 288988"/>
                <a:gd name="connsiteX29" fmla="*/ 226695 w 777993"/>
                <a:gd name="connsiteY29" fmla="*/ 29655 h 288988"/>
                <a:gd name="connsiteX30" fmla="*/ 182880 w 777993"/>
                <a:gd name="connsiteY30" fmla="*/ 56325 h 288988"/>
                <a:gd name="connsiteX31" fmla="*/ 123825 w 777993"/>
                <a:gd name="connsiteY31" fmla="*/ 98235 h 288988"/>
                <a:gd name="connsiteX32" fmla="*/ 87630 w 777993"/>
                <a:gd name="connsiteY32" fmla="*/ 128715 h 288988"/>
                <a:gd name="connsiteX33" fmla="*/ 55245 w 777993"/>
                <a:gd name="connsiteY33" fmla="*/ 161100 h 288988"/>
                <a:gd name="connsiteX34" fmla="*/ 20955 w 777993"/>
                <a:gd name="connsiteY34" fmla="*/ 206820 h 288988"/>
                <a:gd name="connsiteX35" fmla="*/ 0 w 777993"/>
                <a:gd name="connsiteY35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8842 w 777993"/>
                <a:gd name="connsiteY9" fmla="*/ 70590 h 288988"/>
                <a:gd name="connsiteX10" fmla="*/ 462683 w 777993"/>
                <a:gd name="connsiteY10" fmla="*/ 75479 h 288988"/>
                <a:gd name="connsiteX11" fmla="*/ 527217 w 777993"/>
                <a:gd name="connsiteY11" fmla="*/ 93652 h 288988"/>
                <a:gd name="connsiteX12" fmla="*/ 574100 w 777993"/>
                <a:gd name="connsiteY12" fmla="*/ 11769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26695 w 777993"/>
                <a:gd name="connsiteY28" fmla="*/ 29655 h 288988"/>
                <a:gd name="connsiteX29" fmla="*/ 182880 w 777993"/>
                <a:gd name="connsiteY29" fmla="*/ 56325 h 288988"/>
                <a:gd name="connsiteX30" fmla="*/ 123825 w 777993"/>
                <a:gd name="connsiteY30" fmla="*/ 98235 h 288988"/>
                <a:gd name="connsiteX31" fmla="*/ 87630 w 777993"/>
                <a:gd name="connsiteY31" fmla="*/ 128715 h 288988"/>
                <a:gd name="connsiteX32" fmla="*/ 55245 w 777993"/>
                <a:gd name="connsiteY32" fmla="*/ 161100 h 288988"/>
                <a:gd name="connsiteX33" fmla="*/ 20955 w 777993"/>
                <a:gd name="connsiteY33" fmla="*/ 206820 h 288988"/>
                <a:gd name="connsiteX34" fmla="*/ 0 w 777993"/>
                <a:gd name="connsiteY34" fmla="*/ 254445 h 288988"/>
                <a:gd name="connsiteX0" fmla="*/ 0 w 777993"/>
                <a:gd name="connsiteY0" fmla="*/ 254445 h 288988"/>
                <a:gd name="connsiteX1" fmla="*/ 19050 w 777993"/>
                <a:gd name="connsiteY1" fmla="*/ 271590 h 288988"/>
                <a:gd name="connsiteX2" fmla="*/ 45720 w 777993"/>
                <a:gd name="connsiteY2" fmla="*/ 288735 h 288988"/>
                <a:gd name="connsiteX3" fmla="*/ 66666 w 777993"/>
                <a:gd name="connsiteY3" fmla="*/ 257280 h 288988"/>
                <a:gd name="connsiteX4" fmla="*/ 112386 w 777993"/>
                <a:gd name="connsiteY4" fmla="*/ 201825 h 288988"/>
                <a:gd name="connsiteX5" fmla="*/ 171696 w 777993"/>
                <a:gd name="connsiteY5" fmla="*/ 151781 h 288988"/>
                <a:gd name="connsiteX6" fmla="*/ 244091 w 777993"/>
                <a:gd name="connsiteY6" fmla="*/ 106575 h 288988"/>
                <a:gd name="connsiteX7" fmla="*/ 282649 w 777993"/>
                <a:gd name="connsiteY7" fmla="*/ 89535 h 288988"/>
                <a:gd name="connsiteX8" fmla="*/ 324559 w 777993"/>
                <a:gd name="connsiteY8" fmla="*/ 78364 h 288988"/>
                <a:gd name="connsiteX9" fmla="*/ 388842 w 777993"/>
                <a:gd name="connsiteY9" fmla="*/ 70590 h 288988"/>
                <a:gd name="connsiteX10" fmla="*/ 462683 w 777993"/>
                <a:gd name="connsiteY10" fmla="*/ 75479 h 288988"/>
                <a:gd name="connsiteX11" fmla="*/ 527217 w 777993"/>
                <a:gd name="connsiteY11" fmla="*/ 93652 h 288988"/>
                <a:gd name="connsiteX12" fmla="*/ 574100 w 777993"/>
                <a:gd name="connsiteY12" fmla="*/ 117694 h 288988"/>
                <a:gd name="connsiteX13" fmla="*/ 628650 w 777993"/>
                <a:gd name="connsiteY13" fmla="*/ 170625 h 288988"/>
                <a:gd name="connsiteX14" fmla="*/ 667218 w 777993"/>
                <a:gd name="connsiteY14" fmla="*/ 209344 h 288988"/>
                <a:gd name="connsiteX15" fmla="*/ 709137 w 777993"/>
                <a:gd name="connsiteY15" fmla="*/ 272415 h 288988"/>
                <a:gd name="connsiteX16" fmla="*/ 727710 w 777993"/>
                <a:gd name="connsiteY16" fmla="*/ 271590 h 288988"/>
                <a:gd name="connsiteX17" fmla="*/ 762000 w 777993"/>
                <a:gd name="connsiteY17" fmla="*/ 243015 h 288988"/>
                <a:gd name="connsiteX18" fmla="*/ 777949 w 777993"/>
                <a:gd name="connsiteY18" fmla="*/ 230092 h 288988"/>
                <a:gd name="connsiteX19" fmla="*/ 765810 w 777993"/>
                <a:gd name="connsiteY19" fmla="*/ 203010 h 288988"/>
                <a:gd name="connsiteX20" fmla="*/ 739140 w 777993"/>
                <a:gd name="connsiteY20" fmla="*/ 155385 h 288988"/>
                <a:gd name="connsiteX21" fmla="*/ 720090 w 777993"/>
                <a:gd name="connsiteY21" fmla="*/ 132525 h 288988"/>
                <a:gd name="connsiteX22" fmla="*/ 672706 w 777993"/>
                <a:gd name="connsiteY22" fmla="*/ 97515 h 288988"/>
                <a:gd name="connsiteX23" fmla="*/ 596029 w 777993"/>
                <a:gd name="connsiteY23" fmla="*/ 45052 h 288988"/>
                <a:gd name="connsiteX24" fmla="*/ 481719 w 777993"/>
                <a:gd name="connsiteY24" fmla="*/ 7620 h 288988"/>
                <a:gd name="connsiteX25" fmla="*/ 409575 w 777993"/>
                <a:gd name="connsiteY25" fmla="*/ 0 h 288988"/>
                <a:gd name="connsiteX26" fmla="*/ 350052 w 777993"/>
                <a:gd name="connsiteY26" fmla="*/ 720 h 288988"/>
                <a:gd name="connsiteX27" fmla="*/ 300990 w 777993"/>
                <a:gd name="connsiteY27" fmla="*/ 4890 h 288988"/>
                <a:gd name="connsiteX28" fmla="*/ 225981 w 777993"/>
                <a:gd name="connsiteY28" fmla="*/ 33053 h 288988"/>
                <a:gd name="connsiteX29" fmla="*/ 182880 w 777993"/>
                <a:gd name="connsiteY29" fmla="*/ 56325 h 288988"/>
                <a:gd name="connsiteX30" fmla="*/ 123825 w 777993"/>
                <a:gd name="connsiteY30" fmla="*/ 98235 h 288988"/>
                <a:gd name="connsiteX31" fmla="*/ 87630 w 777993"/>
                <a:gd name="connsiteY31" fmla="*/ 128715 h 288988"/>
                <a:gd name="connsiteX32" fmla="*/ 55245 w 777993"/>
                <a:gd name="connsiteY32" fmla="*/ 161100 h 288988"/>
                <a:gd name="connsiteX33" fmla="*/ 20955 w 777993"/>
                <a:gd name="connsiteY33" fmla="*/ 206820 h 288988"/>
                <a:gd name="connsiteX34" fmla="*/ 0 w 777993"/>
                <a:gd name="connsiteY34" fmla="*/ 254445 h 288988"/>
                <a:gd name="connsiteX0" fmla="*/ 0 w 777993"/>
                <a:gd name="connsiteY0" fmla="*/ 256315 h 290858"/>
                <a:gd name="connsiteX1" fmla="*/ 19050 w 777993"/>
                <a:gd name="connsiteY1" fmla="*/ 273460 h 290858"/>
                <a:gd name="connsiteX2" fmla="*/ 45720 w 777993"/>
                <a:gd name="connsiteY2" fmla="*/ 290605 h 290858"/>
                <a:gd name="connsiteX3" fmla="*/ 66666 w 777993"/>
                <a:gd name="connsiteY3" fmla="*/ 259150 h 290858"/>
                <a:gd name="connsiteX4" fmla="*/ 112386 w 777993"/>
                <a:gd name="connsiteY4" fmla="*/ 203695 h 290858"/>
                <a:gd name="connsiteX5" fmla="*/ 171696 w 777993"/>
                <a:gd name="connsiteY5" fmla="*/ 153651 h 290858"/>
                <a:gd name="connsiteX6" fmla="*/ 244091 w 777993"/>
                <a:gd name="connsiteY6" fmla="*/ 108445 h 290858"/>
                <a:gd name="connsiteX7" fmla="*/ 282649 w 777993"/>
                <a:gd name="connsiteY7" fmla="*/ 91405 h 290858"/>
                <a:gd name="connsiteX8" fmla="*/ 324559 w 777993"/>
                <a:gd name="connsiteY8" fmla="*/ 80234 h 290858"/>
                <a:gd name="connsiteX9" fmla="*/ 388842 w 777993"/>
                <a:gd name="connsiteY9" fmla="*/ 72460 h 290858"/>
                <a:gd name="connsiteX10" fmla="*/ 462683 w 777993"/>
                <a:gd name="connsiteY10" fmla="*/ 77349 h 290858"/>
                <a:gd name="connsiteX11" fmla="*/ 527217 w 777993"/>
                <a:gd name="connsiteY11" fmla="*/ 95522 h 290858"/>
                <a:gd name="connsiteX12" fmla="*/ 574100 w 777993"/>
                <a:gd name="connsiteY12" fmla="*/ 119564 h 290858"/>
                <a:gd name="connsiteX13" fmla="*/ 628650 w 777993"/>
                <a:gd name="connsiteY13" fmla="*/ 172495 h 290858"/>
                <a:gd name="connsiteX14" fmla="*/ 667218 w 777993"/>
                <a:gd name="connsiteY14" fmla="*/ 211214 h 290858"/>
                <a:gd name="connsiteX15" fmla="*/ 709137 w 777993"/>
                <a:gd name="connsiteY15" fmla="*/ 274285 h 290858"/>
                <a:gd name="connsiteX16" fmla="*/ 727710 w 777993"/>
                <a:gd name="connsiteY16" fmla="*/ 273460 h 290858"/>
                <a:gd name="connsiteX17" fmla="*/ 762000 w 777993"/>
                <a:gd name="connsiteY17" fmla="*/ 244885 h 290858"/>
                <a:gd name="connsiteX18" fmla="*/ 777949 w 777993"/>
                <a:gd name="connsiteY18" fmla="*/ 231962 h 290858"/>
                <a:gd name="connsiteX19" fmla="*/ 765810 w 777993"/>
                <a:gd name="connsiteY19" fmla="*/ 204880 h 290858"/>
                <a:gd name="connsiteX20" fmla="*/ 739140 w 777993"/>
                <a:gd name="connsiteY20" fmla="*/ 157255 h 290858"/>
                <a:gd name="connsiteX21" fmla="*/ 720090 w 777993"/>
                <a:gd name="connsiteY21" fmla="*/ 134395 h 290858"/>
                <a:gd name="connsiteX22" fmla="*/ 672706 w 777993"/>
                <a:gd name="connsiteY22" fmla="*/ 99385 h 290858"/>
                <a:gd name="connsiteX23" fmla="*/ 596029 w 777993"/>
                <a:gd name="connsiteY23" fmla="*/ 46922 h 290858"/>
                <a:gd name="connsiteX24" fmla="*/ 481719 w 777993"/>
                <a:gd name="connsiteY24" fmla="*/ 9490 h 290858"/>
                <a:gd name="connsiteX25" fmla="*/ 409575 w 777993"/>
                <a:gd name="connsiteY25" fmla="*/ 1870 h 290858"/>
                <a:gd name="connsiteX26" fmla="*/ 350052 w 777993"/>
                <a:gd name="connsiteY26" fmla="*/ 2590 h 290858"/>
                <a:gd name="connsiteX27" fmla="*/ 225981 w 777993"/>
                <a:gd name="connsiteY27" fmla="*/ 34923 h 290858"/>
                <a:gd name="connsiteX28" fmla="*/ 182880 w 777993"/>
                <a:gd name="connsiteY28" fmla="*/ 58195 h 290858"/>
                <a:gd name="connsiteX29" fmla="*/ 123825 w 777993"/>
                <a:gd name="connsiteY29" fmla="*/ 100105 h 290858"/>
                <a:gd name="connsiteX30" fmla="*/ 87630 w 777993"/>
                <a:gd name="connsiteY30" fmla="*/ 130585 h 290858"/>
                <a:gd name="connsiteX31" fmla="*/ 55245 w 777993"/>
                <a:gd name="connsiteY31" fmla="*/ 162970 h 290858"/>
                <a:gd name="connsiteX32" fmla="*/ 20955 w 777993"/>
                <a:gd name="connsiteY32" fmla="*/ 208690 h 290858"/>
                <a:gd name="connsiteX33" fmla="*/ 0 w 777993"/>
                <a:gd name="connsiteY33" fmla="*/ 256315 h 290858"/>
                <a:gd name="connsiteX0" fmla="*/ 0 w 777993"/>
                <a:gd name="connsiteY0" fmla="*/ 255440 h 289983"/>
                <a:gd name="connsiteX1" fmla="*/ 19050 w 777993"/>
                <a:gd name="connsiteY1" fmla="*/ 272585 h 289983"/>
                <a:gd name="connsiteX2" fmla="*/ 45720 w 777993"/>
                <a:gd name="connsiteY2" fmla="*/ 289730 h 289983"/>
                <a:gd name="connsiteX3" fmla="*/ 66666 w 777993"/>
                <a:gd name="connsiteY3" fmla="*/ 258275 h 289983"/>
                <a:gd name="connsiteX4" fmla="*/ 112386 w 777993"/>
                <a:gd name="connsiteY4" fmla="*/ 202820 h 289983"/>
                <a:gd name="connsiteX5" fmla="*/ 171696 w 777993"/>
                <a:gd name="connsiteY5" fmla="*/ 152776 h 289983"/>
                <a:gd name="connsiteX6" fmla="*/ 244091 w 777993"/>
                <a:gd name="connsiteY6" fmla="*/ 107570 h 289983"/>
                <a:gd name="connsiteX7" fmla="*/ 282649 w 777993"/>
                <a:gd name="connsiteY7" fmla="*/ 90530 h 289983"/>
                <a:gd name="connsiteX8" fmla="*/ 324559 w 777993"/>
                <a:gd name="connsiteY8" fmla="*/ 79359 h 289983"/>
                <a:gd name="connsiteX9" fmla="*/ 388842 w 777993"/>
                <a:gd name="connsiteY9" fmla="*/ 71585 h 289983"/>
                <a:gd name="connsiteX10" fmla="*/ 462683 w 777993"/>
                <a:gd name="connsiteY10" fmla="*/ 76474 h 289983"/>
                <a:gd name="connsiteX11" fmla="*/ 527217 w 777993"/>
                <a:gd name="connsiteY11" fmla="*/ 94647 h 289983"/>
                <a:gd name="connsiteX12" fmla="*/ 574100 w 777993"/>
                <a:gd name="connsiteY12" fmla="*/ 118689 h 289983"/>
                <a:gd name="connsiteX13" fmla="*/ 628650 w 777993"/>
                <a:gd name="connsiteY13" fmla="*/ 171620 h 289983"/>
                <a:gd name="connsiteX14" fmla="*/ 667218 w 777993"/>
                <a:gd name="connsiteY14" fmla="*/ 210339 h 289983"/>
                <a:gd name="connsiteX15" fmla="*/ 709137 w 777993"/>
                <a:gd name="connsiteY15" fmla="*/ 273410 h 289983"/>
                <a:gd name="connsiteX16" fmla="*/ 727710 w 777993"/>
                <a:gd name="connsiteY16" fmla="*/ 272585 h 289983"/>
                <a:gd name="connsiteX17" fmla="*/ 762000 w 777993"/>
                <a:gd name="connsiteY17" fmla="*/ 244010 h 289983"/>
                <a:gd name="connsiteX18" fmla="*/ 777949 w 777993"/>
                <a:gd name="connsiteY18" fmla="*/ 231087 h 289983"/>
                <a:gd name="connsiteX19" fmla="*/ 765810 w 777993"/>
                <a:gd name="connsiteY19" fmla="*/ 204005 h 289983"/>
                <a:gd name="connsiteX20" fmla="*/ 739140 w 777993"/>
                <a:gd name="connsiteY20" fmla="*/ 156380 h 289983"/>
                <a:gd name="connsiteX21" fmla="*/ 720090 w 777993"/>
                <a:gd name="connsiteY21" fmla="*/ 133520 h 289983"/>
                <a:gd name="connsiteX22" fmla="*/ 672706 w 777993"/>
                <a:gd name="connsiteY22" fmla="*/ 98510 h 289983"/>
                <a:gd name="connsiteX23" fmla="*/ 596029 w 777993"/>
                <a:gd name="connsiteY23" fmla="*/ 46047 h 289983"/>
                <a:gd name="connsiteX24" fmla="*/ 481719 w 777993"/>
                <a:gd name="connsiteY24" fmla="*/ 8615 h 289983"/>
                <a:gd name="connsiteX25" fmla="*/ 409575 w 777993"/>
                <a:gd name="connsiteY25" fmla="*/ 995 h 289983"/>
                <a:gd name="connsiteX26" fmla="*/ 350052 w 777993"/>
                <a:gd name="connsiteY26" fmla="*/ 1715 h 289983"/>
                <a:gd name="connsiteX27" fmla="*/ 258815 w 777993"/>
                <a:gd name="connsiteY27" fmla="*/ 22156 h 289983"/>
                <a:gd name="connsiteX28" fmla="*/ 182880 w 777993"/>
                <a:gd name="connsiteY28" fmla="*/ 57320 h 289983"/>
                <a:gd name="connsiteX29" fmla="*/ 123825 w 777993"/>
                <a:gd name="connsiteY29" fmla="*/ 99230 h 289983"/>
                <a:gd name="connsiteX30" fmla="*/ 87630 w 777993"/>
                <a:gd name="connsiteY30" fmla="*/ 129710 h 289983"/>
                <a:gd name="connsiteX31" fmla="*/ 55245 w 777993"/>
                <a:gd name="connsiteY31" fmla="*/ 162095 h 289983"/>
                <a:gd name="connsiteX32" fmla="*/ 20955 w 777993"/>
                <a:gd name="connsiteY32" fmla="*/ 207815 h 289983"/>
                <a:gd name="connsiteX33" fmla="*/ 0 w 777993"/>
                <a:gd name="connsiteY33" fmla="*/ 255440 h 289983"/>
                <a:gd name="connsiteX0" fmla="*/ 0 w 777993"/>
                <a:gd name="connsiteY0" fmla="*/ 255440 h 289983"/>
                <a:gd name="connsiteX1" fmla="*/ 19050 w 777993"/>
                <a:gd name="connsiteY1" fmla="*/ 272585 h 289983"/>
                <a:gd name="connsiteX2" fmla="*/ 45720 w 777993"/>
                <a:gd name="connsiteY2" fmla="*/ 289730 h 289983"/>
                <a:gd name="connsiteX3" fmla="*/ 66666 w 777993"/>
                <a:gd name="connsiteY3" fmla="*/ 258275 h 289983"/>
                <a:gd name="connsiteX4" fmla="*/ 112386 w 777993"/>
                <a:gd name="connsiteY4" fmla="*/ 202820 h 289983"/>
                <a:gd name="connsiteX5" fmla="*/ 171696 w 777993"/>
                <a:gd name="connsiteY5" fmla="*/ 152776 h 289983"/>
                <a:gd name="connsiteX6" fmla="*/ 244091 w 777993"/>
                <a:gd name="connsiteY6" fmla="*/ 107570 h 289983"/>
                <a:gd name="connsiteX7" fmla="*/ 282649 w 777993"/>
                <a:gd name="connsiteY7" fmla="*/ 90530 h 289983"/>
                <a:gd name="connsiteX8" fmla="*/ 324559 w 777993"/>
                <a:gd name="connsiteY8" fmla="*/ 79359 h 289983"/>
                <a:gd name="connsiteX9" fmla="*/ 388842 w 777993"/>
                <a:gd name="connsiteY9" fmla="*/ 71585 h 289983"/>
                <a:gd name="connsiteX10" fmla="*/ 462683 w 777993"/>
                <a:gd name="connsiteY10" fmla="*/ 76474 h 289983"/>
                <a:gd name="connsiteX11" fmla="*/ 527217 w 777993"/>
                <a:gd name="connsiteY11" fmla="*/ 94647 h 289983"/>
                <a:gd name="connsiteX12" fmla="*/ 574100 w 777993"/>
                <a:gd name="connsiteY12" fmla="*/ 118689 h 289983"/>
                <a:gd name="connsiteX13" fmla="*/ 628650 w 777993"/>
                <a:gd name="connsiteY13" fmla="*/ 171620 h 289983"/>
                <a:gd name="connsiteX14" fmla="*/ 667218 w 777993"/>
                <a:gd name="connsiteY14" fmla="*/ 210339 h 289983"/>
                <a:gd name="connsiteX15" fmla="*/ 709137 w 777993"/>
                <a:gd name="connsiteY15" fmla="*/ 273410 h 289983"/>
                <a:gd name="connsiteX16" fmla="*/ 727710 w 777993"/>
                <a:gd name="connsiteY16" fmla="*/ 272585 h 289983"/>
                <a:gd name="connsiteX17" fmla="*/ 762000 w 777993"/>
                <a:gd name="connsiteY17" fmla="*/ 244010 h 289983"/>
                <a:gd name="connsiteX18" fmla="*/ 777949 w 777993"/>
                <a:gd name="connsiteY18" fmla="*/ 231087 h 289983"/>
                <a:gd name="connsiteX19" fmla="*/ 765810 w 777993"/>
                <a:gd name="connsiteY19" fmla="*/ 204005 h 289983"/>
                <a:gd name="connsiteX20" fmla="*/ 739140 w 777993"/>
                <a:gd name="connsiteY20" fmla="*/ 156380 h 289983"/>
                <a:gd name="connsiteX21" fmla="*/ 720090 w 777993"/>
                <a:gd name="connsiteY21" fmla="*/ 133520 h 289983"/>
                <a:gd name="connsiteX22" fmla="*/ 672706 w 777993"/>
                <a:gd name="connsiteY22" fmla="*/ 98510 h 289983"/>
                <a:gd name="connsiteX23" fmla="*/ 572474 w 777993"/>
                <a:gd name="connsiteY23" fmla="*/ 40951 h 289983"/>
                <a:gd name="connsiteX24" fmla="*/ 481719 w 777993"/>
                <a:gd name="connsiteY24" fmla="*/ 8615 h 289983"/>
                <a:gd name="connsiteX25" fmla="*/ 409575 w 777993"/>
                <a:gd name="connsiteY25" fmla="*/ 995 h 289983"/>
                <a:gd name="connsiteX26" fmla="*/ 350052 w 777993"/>
                <a:gd name="connsiteY26" fmla="*/ 1715 h 289983"/>
                <a:gd name="connsiteX27" fmla="*/ 258815 w 777993"/>
                <a:gd name="connsiteY27" fmla="*/ 22156 h 289983"/>
                <a:gd name="connsiteX28" fmla="*/ 182880 w 777993"/>
                <a:gd name="connsiteY28" fmla="*/ 57320 h 289983"/>
                <a:gd name="connsiteX29" fmla="*/ 123825 w 777993"/>
                <a:gd name="connsiteY29" fmla="*/ 99230 h 289983"/>
                <a:gd name="connsiteX30" fmla="*/ 87630 w 777993"/>
                <a:gd name="connsiteY30" fmla="*/ 129710 h 289983"/>
                <a:gd name="connsiteX31" fmla="*/ 55245 w 777993"/>
                <a:gd name="connsiteY31" fmla="*/ 162095 h 289983"/>
                <a:gd name="connsiteX32" fmla="*/ 20955 w 777993"/>
                <a:gd name="connsiteY32" fmla="*/ 207815 h 289983"/>
                <a:gd name="connsiteX33" fmla="*/ 0 w 777993"/>
                <a:gd name="connsiteY33" fmla="*/ 255440 h 289983"/>
                <a:gd name="connsiteX0" fmla="*/ 0 w 777993"/>
                <a:gd name="connsiteY0" fmla="*/ 255440 h 289983"/>
                <a:gd name="connsiteX1" fmla="*/ 19050 w 777993"/>
                <a:gd name="connsiteY1" fmla="*/ 272585 h 289983"/>
                <a:gd name="connsiteX2" fmla="*/ 45720 w 777993"/>
                <a:gd name="connsiteY2" fmla="*/ 289730 h 289983"/>
                <a:gd name="connsiteX3" fmla="*/ 66666 w 777993"/>
                <a:gd name="connsiteY3" fmla="*/ 258275 h 289983"/>
                <a:gd name="connsiteX4" fmla="*/ 112386 w 777993"/>
                <a:gd name="connsiteY4" fmla="*/ 202820 h 289983"/>
                <a:gd name="connsiteX5" fmla="*/ 171696 w 777993"/>
                <a:gd name="connsiteY5" fmla="*/ 152776 h 289983"/>
                <a:gd name="connsiteX6" fmla="*/ 244091 w 777993"/>
                <a:gd name="connsiteY6" fmla="*/ 107570 h 289983"/>
                <a:gd name="connsiteX7" fmla="*/ 282649 w 777993"/>
                <a:gd name="connsiteY7" fmla="*/ 90530 h 289983"/>
                <a:gd name="connsiteX8" fmla="*/ 324559 w 777993"/>
                <a:gd name="connsiteY8" fmla="*/ 79359 h 289983"/>
                <a:gd name="connsiteX9" fmla="*/ 388842 w 777993"/>
                <a:gd name="connsiteY9" fmla="*/ 71585 h 289983"/>
                <a:gd name="connsiteX10" fmla="*/ 462683 w 777993"/>
                <a:gd name="connsiteY10" fmla="*/ 76474 h 289983"/>
                <a:gd name="connsiteX11" fmla="*/ 527217 w 777993"/>
                <a:gd name="connsiteY11" fmla="*/ 94647 h 289983"/>
                <a:gd name="connsiteX12" fmla="*/ 574100 w 777993"/>
                <a:gd name="connsiteY12" fmla="*/ 118689 h 289983"/>
                <a:gd name="connsiteX13" fmla="*/ 628650 w 777993"/>
                <a:gd name="connsiteY13" fmla="*/ 171620 h 289983"/>
                <a:gd name="connsiteX14" fmla="*/ 667218 w 777993"/>
                <a:gd name="connsiteY14" fmla="*/ 210339 h 289983"/>
                <a:gd name="connsiteX15" fmla="*/ 709137 w 777993"/>
                <a:gd name="connsiteY15" fmla="*/ 273410 h 289983"/>
                <a:gd name="connsiteX16" fmla="*/ 727710 w 777993"/>
                <a:gd name="connsiteY16" fmla="*/ 272585 h 289983"/>
                <a:gd name="connsiteX17" fmla="*/ 762000 w 777993"/>
                <a:gd name="connsiteY17" fmla="*/ 244010 h 289983"/>
                <a:gd name="connsiteX18" fmla="*/ 777949 w 777993"/>
                <a:gd name="connsiteY18" fmla="*/ 231087 h 289983"/>
                <a:gd name="connsiteX19" fmla="*/ 765810 w 777993"/>
                <a:gd name="connsiteY19" fmla="*/ 204005 h 289983"/>
                <a:gd name="connsiteX20" fmla="*/ 739140 w 777993"/>
                <a:gd name="connsiteY20" fmla="*/ 156380 h 289983"/>
                <a:gd name="connsiteX21" fmla="*/ 720090 w 777993"/>
                <a:gd name="connsiteY21" fmla="*/ 133520 h 289983"/>
                <a:gd name="connsiteX22" fmla="*/ 672706 w 777993"/>
                <a:gd name="connsiteY22" fmla="*/ 98510 h 289983"/>
                <a:gd name="connsiteX23" fmla="*/ 578184 w 777993"/>
                <a:gd name="connsiteY23" fmla="*/ 38120 h 289983"/>
                <a:gd name="connsiteX24" fmla="*/ 481719 w 777993"/>
                <a:gd name="connsiteY24" fmla="*/ 8615 h 289983"/>
                <a:gd name="connsiteX25" fmla="*/ 409575 w 777993"/>
                <a:gd name="connsiteY25" fmla="*/ 995 h 289983"/>
                <a:gd name="connsiteX26" fmla="*/ 350052 w 777993"/>
                <a:gd name="connsiteY26" fmla="*/ 1715 h 289983"/>
                <a:gd name="connsiteX27" fmla="*/ 258815 w 777993"/>
                <a:gd name="connsiteY27" fmla="*/ 22156 h 289983"/>
                <a:gd name="connsiteX28" fmla="*/ 182880 w 777993"/>
                <a:gd name="connsiteY28" fmla="*/ 57320 h 289983"/>
                <a:gd name="connsiteX29" fmla="*/ 123825 w 777993"/>
                <a:gd name="connsiteY29" fmla="*/ 99230 h 289983"/>
                <a:gd name="connsiteX30" fmla="*/ 87630 w 777993"/>
                <a:gd name="connsiteY30" fmla="*/ 129710 h 289983"/>
                <a:gd name="connsiteX31" fmla="*/ 55245 w 777993"/>
                <a:gd name="connsiteY31" fmla="*/ 162095 h 289983"/>
                <a:gd name="connsiteX32" fmla="*/ 20955 w 777993"/>
                <a:gd name="connsiteY32" fmla="*/ 207815 h 289983"/>
                <a:gd name="connsiteX33" fmla="*/ 0 w 777993"/>
                <a:gd name="connsiteY33" fmla="*/ 255440 h 289983"/>
                <a:gd name="connsiteX0" fmla="*/ 0 w 777993"/>
                <a:gd name="connsiteY0" fmla="*/ 255440 h 289983"/>
                <a:gd name="connsiteX1" fmla="*/ 19050 w 777993"/>
                <a:gd name="connsiteY1" fmla="*/ 272585 h 289983"/>
                <a:gd name="connsiteX2" fmla="*/ 45720 w 777993"/>
                <a:gd name="connsiteY2" fmla="*/ 289730 h 289983"/>
                <a:gd name="connsiteX3" fmla="*/ 66666 w 777993"/>
                <a:gd name="connsiteY3" fmla="*/ 258275 h 289983"/>
                <a:gd name="connsiteX4" fmla="*/ 112386 w 777993"/>
                <a:gd name="connsiteY4" fmla="*/ 202820 h 289983"/>
                <a:gd name="connsiteX5" fmla="*/ 171696 w 777993"/>
                <a:gd name="connsiteY5" fmla="*/ 152776 h 289983"/>
                <a:gd name="connsiteX6" fmla="*/ 244091 w 777993"/>
                <a:gd name="connsiteY6" fmla="*/ 107570 h 289983"/>
                <a:gd name="connsiteX7" fmla="*/ 282649 w 777993"/>
                <a:gd name="connsiteY7" fmla="*/ 90530 h 289983"/>
                <a:gd name="connsiteX8" fmla="*/ 324559 w 777993"/>
                <a:gd name="connsiteY8" fmla="*/ 79359 h 289983"/>
                <a:gd name="connsiteX9" fmla="*/ 388842 w 777993"/>
                <a:gd name="connsiteY9" fmla="*/ 71585 h 289983"/>
                <a:gd name="connsiteX10" fmla="*/ 462683 w 777993"/>
                <a:gd name="connsiteY10" fmla="*/ 76474 h 289983"/>
                <a:gd name="connsiteX11" fmla="*/ 527217 w 777993"/>
                <a:gd name="connsiteY11" fmla="*/ 94647 h 289983"/>
                <a:gd name="connsiteX12" fmla="*/ 574100 w 777993"/>
                <a:gd name="connsiteY12" fmla="*/ 118689 h 289983"/>
                <a:gd name="connsiteX13" fmla="*/ 628650 w 777993"/>
                <a:gd name="connsiteY13" fmla="*/ 171620 h 289983"/>
                <a:gd name="connsiteX14" fmla="*/ 667218 w 777993"/>
                <a:gd name="connsiteY14" fmla="*/ 210339 h 289983"/>
                <a:gd name="connsiteX15" fmla="*/ 709137 w 777993"/>
                <a:gd name="connsiteY15" fmla="*/ 273410 h 289983"/>
                <a:gd name="connsiteX16" fmla="*/ 727710 w 777993"/>
                <a:gd name="connsiteY16" fmla="*/ 272585 h 289983"/>
                <a:gd name="connsiteX17" fmla="*/ 762000 w 777993"/>
                <a:gd name="connsiteY17" fmla="*/ 244010 h 289983"/>
                <a:gd name="connsiteX18" fmla="*/ 777949 w 777993"/>
                <a:gd name="connsiteY18" fmla="*/ 231087 h 289983"/>
                <a:gd name="connsiteX19" fmla="*/ 765810 w 777993"/>
                <a:gd name="connsiteY19" fmla="*/ 204005 h 289983"/>
                <a:gd name="connsiteX20" fmla="*/ 739140 w 777993"/>
                <a:gd name="connsiteY20" fmla="*/ 156380 h 289983"/>
                <a:gd name="connsiteX21" fmla="*/ 672706 w 777993"/>
                <a:gd name="connsiteY21" fmla="*/ 98510 h 289983"/>
                <a:gd name="connsiteX22" fmla="*/ 578184 w 777993"/>
                <a:gd name="connsiteY22" fmla="*/ 38120 h 289983"/>
                <a:gd name="connsiteX23" fmla="*/ 481719 w 777993"/>
                <a:gd name="connsiteY23" fmla="*/ 8615 h 289983"/>
                <a:gd name="connsiteX24" fmla="*/ 409575 w 777993"/>
                <a:gd name="connsiteY24" fmla="*/ 995 h 289983"/>
                <a:gd name="connsiteX25" fmla="*/ 350052 w 777993"/>
                <a:gd name="connsiteY25" fmla="*/ 1715 h 289983"/>
                <a:gd name="connsiteX26" fmla="*/ 258815 w 777993"/>
                <a:gd name="connsiteY26" fmla="*/ 22156 h 289983"/>
                <a:gd name="connsiteX27" fmla="*/ 182880 w 777993"/>
                <a:gd name="connsiteY27" fmla="*/ 57320 h 289983"/>
                <a:gd name="connsiteX28" fmla="*/ 123825 w 777993"/>
                <a:gd name="connsiteY28" fmla="*/ 99230 h 289983"/>
                <a:gd name="connsiteX29" fmla="*/ 87630 w 777993"/>
                <a:gd name="connsiteY29" fmla="*/ 129710 h 289983"/>
                <a:gd name="connsiteX30" fmla="*/ 55245 w 777993"/>
                <a:gd name="connsiteY30" fmla="*/ 162095 h 289983"/>
                <a:gd name="connsiteX31" fmla="*/ 20955 w 777993"/>
                <a:gd name="connsiteY31" fmla="*/ 207815 h 289983"/>
                <a:gd name="connsiteX32" fmla="*/ 0 w 777993"/>
                <a:gd name="connsiteY32" fmla="*/ 255440 h 289983"/>
                <a:gd name="connsiteX0" fmla="*/ 0 w 777997"/>
                <a:gd name="connsiteY0" fmla="*/ 255440 h 289983"/>
                <a:gd name="connsiteX1" fmla="*/ 19050 w 777997"/>
                <a:gd name="connsiteY1" fmla="*/ 272585 h 289983"/>
                <a:gd name="connsiteX2" fmla="*/ 45720 w 777997"/>
                <a:gd name="connsiteY2" fmla="*/ 289730 h 289983"/>
                <a:gd name="connsiteX3" fmla="*/ 66666 w 777997"/>
                <a:gd name="connsiteY3" fmla="*/ 258275 h 289983"/>
                <a:gd name="connsiteX4" fmla="*/ 112386 w 777997"/>
                <a:gd name="connsiteY4" fmla="*/ 202820 h 289983"/>
                <a:gd name="connsiteX5" fmla="*/ 171696 w 777997"/>
                <a:gd name="connsiteY5" fmla="*/ 152776 h 289983"/>
                <a:gd name="connsiteX6" fmla="*/ 244091 w 777997"/>
                <a:gd name="connsiteY6" fmla="*/ 107570 h 289983"/>
                <a:gd name="connsiteX7" fmla="*/ 282649 w 777997"/>
                <a:gd name="connsiteY7" fmla="*/ 90530 h 289983"/>
                <a:gd name="connsiteX8" fmla="*/ 324559 w 777997"/>
                <a:gd name="connsiteY8" fmla="*/ 79359 h 289983"/>
                <a:gd name="connsiteX9" fmla="*/ 388842 w 777997"/>
                <a:gd name="connsiteY9" fmla="*/ 71585 h 289983"/>
                <a:gd name="connsiteX10" fmla="*/ 462683 w 777997"/>
                <a:gd name="connsiteY10" fmla="*/ 76474 h 289983"/>
                <a:gd name="connsiteX11" fmla="*/ 527217 w 777997"/>
                <a:gd name="connsiteY11" fmla="*/ 94647 h 289983"/>
                <a:gd name="connsiteX12" fmla="*/ 574100 w 777997"/>
                <a:gd name="connsiteY12" fmla="*/ 118689 h 289983"/>
                <a:gd name="connsiteX13" fmla="*/ 628650 w 777997"/>
                <a:gd name="connsiteY13" fmla="*/ 171620 h 289983"/>
                <a:gd name="connsiteX14" fmla="*/ 667218 w 777997"/>
                <a:gd name="connsiteY14" fmla="*/ 210339 h 289983"/>
                <a:gd name="connsiteX15" fmla="*/ 709137 w 777997"/>
                <a:gd name="connsiteY15" fmla="*/ 273410 h 289983"/>
                <a:gd name="connsiteX16" fmla="*/ 727710 w 777997"/>
                <a:gd name="connsiteY16" fmla="*/ 272585 h 289983"/>
                <a:gd name="connsiteX17" fmla="*/ 762000 w 777997"/>
                <a:gd name="connsiteY17" fmla="*/ 244010 h 289983"/>
                <a:gd name="connsiteX18" fmla="*/ 777949 w 777997"/>
                <a:gd name="connsiteY18" fmla="*/ 231087 h 289983"/>
                <a:gd name="connsiteX19" fmla="*/ 765810 w 777997"/>
                <a:gd name="connsiteY19" fmla="*/ 204005 h 289983"/>
                <a:gd name="connsiteX20" fmla="*/ 735571 w 777997"/>
                <a:gd name="connsiteY20" fmla="*/ 160344 h 289983"/>
                <a:gd name="connsiteX21" fmla="*/ 672706 w 777997"/>
                <a:gd name="connsiteY21" fmla="*/ 98510 h 289983"/>
                <a:gd name="connsiteX22" fmla="*/ 578184 w 777997"/>
                <a:gd name="connsiteY22" fmla="*/ 38120 h 289983"/>
                <a:gd name="connsiteX23" fmla="*/ 481719 w 777997"/>
                <a:gd name="connsiteY23" fmla="*/ 8615 h 289983"/>
                <a:gd name="connsiteX24" fmla="*/ 409575 w 777997"/>
                <a:gd name="connsiteY24" fmla="*/ 995 h 289983"/>
                <a:gd name="connsiteX25" fmla="*/ 350052 w 777997"/>
                <a:gd name="connsiteY25" fmla="*/ 1715 h 289983"/>
                <a:gd name="connsiteX26" fmla="*/ 258815 w 777997"/>
                <a:gd name="connsiteY26" fmla="*/ 22156 h 289983"/>
                <a:gd name="connsiteX27" fmla="*/ 182880 w 777997"/>
                <a:gd name="connsiteY27" fmla="*/ 57320 h 289983"/>
                <a:gd name="connsiteX28" fmla="*/ 123825 w 777997"/>
                <a:gd name="connsiteY28" fmla="*/ 99230 h 289983"/>
                <a:gd name="connsiteX29" fmla="*/ 87630 w 777997"/>
                <a:gd name="connsiteY29" fmla="*/ 129710 h 289983"/>
                <a:gd name="connsiteX30" fmla="*/ 55245 w 777997"/>
                <a:gd name="connsiteY30" fmla="*/ 162095 h 289983"/>
                <a:gd name="connsiteX31" fmla="*/ 20955 w 777997"/>
                <a:gd name="connsiteY31" fmla="*/ 207815 h 289983"/>
                <a:gd name="connsiteX32" fmla="*/ 0 w 777997"/>
                <a:gd name="connsiteY32" fmla="*/ 255440 h 289983"/>
                <a:gd name="connsiteX0" fmla="*/ 0 w 777997"/>
                <a:gd name="connsiteY0" fmla="*/ 255440 h 289983"/>
                <a:gd name="connsiteX1" fmla="*/ 19050 w 777997"/>
                <a:gd name="connsiteY1" fmla="*/ 272585 h 289983"/>
                <a:gd name="connsiteX2" fmla="*/ 45720 w 777997"/>
                <a:gd name="connsiteY2" fmla="*/ 289730 h 289983"/>
                <a:gd name="connsiteX3" fmla="*/ 66666 w 777997"/>
                <a:gd name="connsiteY3" fmla="*/ 258275 h 289983"/>
                <a:gd name="connsiteX4" fmla="*/ 112386 w 777997"/>
                <a:gd name="connsiteY4" fmla="*/ 202820 h 289983"/>
                <a:gd name="connsiteX5" fmla="*/ 171696 w 777997"/>
                <a:gd name="connsiteY5" fmla="*/ 152776 h 289983"/>
                <a:gd name="connsiteX6" fmla="*/ 244091 w 777997"/>
                <a:gd name="connsiteY6" fmla="*/ 107570 h 289983"/>
                <a:gd name="connsiteX7" fmla="*/ 282649 w 777997"/>
                <a:gd name="connsiteY7" fmla="*/ 90530 h 289983"/>
                <a:gd name="connsiteX8" fmla="*/ 324559 w 777997"/>
                <a:gd name="connsiteY8" fmla="*/ 79359 h 289983"/>
                <a:gd name="connsiteX9" fmla="*/ 388842 w 777997"/>
                <a:gd name="connsiteY9" fmla="*/ 71585 h 289983"/>
                <a:gd name="connsiteX10" fmla="*/ 462683 w 777997"/>
                <a:gd name="connsiteY10" fmla="*/ 76474 h 289983"/>
                <a:gd name="connsiteX11" fmla="*/ 527217 w 777997"/>
                <a:gd name="connsiteY11" fmla="*/ 94647 h 289983"/>
                <a:gd name="connsiteX12" fmla="*/ 574100 w 777997"/>
                <a:gd name="connsiteY12" fmla="*/ 118689 h 289983"/>
                <a:gd name="connsiteX13" fmla="*/ 628650 w 777997"/>
                <a:gd name="connsiteY13" fmla="*/ 166524 h 289983"/>
                <a:gd name="connsiteX14" fmla="*/ 667218 w 777997"/>
                <a:gd name="connsiteY14" fmla="*/ 210339 h 289983"/>
                <a:gd name="connsiteX15" fmla="*/ 709137 w 777997"/>
                <a:gd name="connsiteY15" fmla="*/ 273410 h 289983"/>
                <a:gd name="connsiteX16" fmla="*/ 727710 w 777997"/>
                <a:gd name="connsiteY16" fmla="*/ 272585 h 289983"/>
                <a:gd name="connsiteX17" fmla="*/ 762000 w 777997"/>
                <a:gd name="connsiteY17" fmla="*/ 244010 h 289983"/>
                <a:gd name="connsiteX18" fmla="*/ 777949 w 777997"/>
                <a:gd name="connsiteY18" fmla="*/ 231087 h 289983"/>
                <a:gd name="connsiteX19" fmla="*/ 765810 w 777997"/>
                <a:gd name="connsiteY19" fmla="*/ 204005 h 289983"/>
                <a:gd name="connsiteX20" fmla="*/ 735571 w 777997"/>
                <a:gd name="connsiteY20" fmla="*/ 160344 h 289983"/>
                <a:gd name="connsiteX21" fmla="*/ 672706 w 777997"/>
                <a:gd name="connsiteY21" fmla="*/ 98510 h 289983"/>
                <a:gd name="connsiteX22" fmla="*/ 578184 w 777997"/>
                <a:gd name="connsiteY22" fmla="*/ 38120 h 289983"/>
                <a:gd name="connsiteX23" fmla="*/ 481719 w 777997"/>
                <a:gd name="connsiteY23" fmla="*/ 8615 h 289983"/>
                <a:gd name="connsiteX24" fmla="*/ 409575 w 777997"/>
                <a:gd name="connsiteY24" fmla="*/ 995 h 289983"/>
                <a:gd name="connsiteX25" fmla="*/ 350052 w 777997"/>
                <a:gd name="connsiteY25" fmla="*/ 1715 h 289983"/>
                <a:gd name="connsiteX26" fmla="*/ 258815 w 777997"/>
                <a:gd name="connsiteY26" fmla="*/ 22156 h 289983"/>
                <a:gd name="connsiteX27" fmla="*/ 182880 w 777997"/>
                <a:gd name="connsiteY27" fmla="*/ 57320 h 289983"/>
                <a:gd name="connsiteX28" fmla="*/ 123825 w 777997"/>
                <a:gd name="connsiteY28" fmla="*/ 99230 h 289983"/>
                <a:gd name="connsiteX29" fmla="*/ 87630 w 777997"/>
                <a:gd name="connsiteY29" fmla="*/ 129710 h 289983"/>
                <a:gd name="connsiteX30" fmla="*/ 55245 w 777997"/>
                <a:gd name="connsiteY30" fmla="*/ 162095 h 289983"/>
                <a:gd name="connsiteX31" fmla="*/ 20955 w 777997"/>
                <a:gd name="connsiteY31" fmla="*/ 207815 h 289983"/>
                <a:gd name="connsiteX32" fmla="*/ 0 w 777997"/>
                <a:gd name="connsiteY32" fmla="*/ 255440 h 289983"/>
                <a:gd name="connsiteX0" fmla="*/ 0 w 777997"/>
                <a:gd name="connsiteY0" fmla="*/ 255440 h 289983"/>
                <a:gd name="connsiteX1" fmla="*/ 19050 w 777997"/>
                <a:gd name="connsiteY1" fmla="*/ 272585 h 289983"/>
                <a:gd name="connsiteX2" fmla="*/ 45720 w 777997"/>
                <a:gd name="connsiteY2" fmla="*/ 289730 h 289983"/>
                <a:gd name="connsiteX3" fmla="*/ 66666 w 777997"/>
                <a:gd name="connsiteY3" fmla="*/ 258275 h 289983"/>
                <a:gd name="connsiteX4" fmla="*/ 112386 w 777997"/>
                <a:gd name="connsiteY4" fmla="*/ 202820 h 289983"/>
                <a:gd name="connsiteX5" fmla="*/ 171696 w 777997"/>
                <a:gd name="connsiteY5" fmla="*/ 152776 h 289983"/>
                <a:gd name="connsiteX6" fmla="*/ 244091 w 777997"/>
                <a:gd name="connsiteY6" fmla="*/ 107570 h 289983"/>
                <a:gd name="connsiteX7" fmla="*/ 324559 w 777997"/>
                <a:gd name="connsiteY7" fmla="*/ 79359 h 289983"/>
                <a:gd name="connsiteX8" fmla="*/ 388842 w 777997"/>
                <a:gd name="connsiteY8" fmla="*/ 71585 h 289983"/>
                <a:gd name="connsiteX9" fmla="*/ 462683 w 777997"/>
                <a:gd name="connsiteY9" fmla="*/ 76474 h 289983"/>
                <a:gd name="connsiteX10" fmla="*/ 527217 w 777997"/>
                <a:gd name="connsiteY10" fmla="*/ 94647 h 289983"/>
                <a:gd name="connsiteX11" fmla="*/ 574100 w 777997"/>
                <a:gd name="connsiteY11" fmla="*/ 118689 h 289983"/>
                <a:gd name="connsiteX12" fmla="*/ 628650 w 777997"/>
                <a:gd name="connsiteY12" fmla="*/ 166524 h 289983"/>
                <a:gd name="connsiteX13" fmla="*/ 667218 w 777997"/>
                <a:gd name="connsiteY13" fmla="*/ 210339 h 289983"/>
                <a:gd name="connsiteX14" fmla="*/ 709137 w 777997"/>
                <a:gd name="connsiteY14" fmla="*/ 273410 h 289983"/>
                <a:gd name="connsiteX15" fmla="*/ 727710 w 777997"/>
                <a:gd name="connsiteY15" fmla="*/ 272585 h 289983"/>
                <a:gd name="connsiteX16" fmla="*/ 762000 w 777997"/>
                <a:gd name="connsiteY16" fmla="*/ 244010 h 289983"/>
                <a:gd name="connsiteX17" fmla="*/ 777949 w 777997"/>
                <a:gd name="connsiteY17" fmla="*/ 231087 h 289983"/>
                <a:gd name="connsiteX18" fmla="*/ 765810 w 777997"/>
                <a:gd name="connsiteY18" fmla="*/ 204005 h 289983"/>
                <a:gd name="connsiteX19" fmla="*/ 735571 w 777997"/>
                <a:gd name="connsiteY19" fmla="*/ 160344 h 289983"/>
                <a:gd name="connsiteX20" fmla="*/ 672706 w 777997"/>
                <a:gd name="connsiteY20" fmla="*/ 98510 h 289983"/>
                <a:gd name="connsiteX21" fmla="*/ 578184 w 777997"/>
                <a:gd name="connsiteY21" fmla="*/ 38120 h 289983"/>
                <a:gd name="connsiteX22" fmla="*/ 481719 w 777997"/>
                <a:gd name="connsiteY22" fmla="*/ 8615 h 289983"/>
                <a:gd name="connsiteX23" fmla="*/ 409575 w 777997"/>
                <a:gd name="connsiteY23" fmla="*/ 995 h 289983"/>
                <a:gd name="connsiteX24" fmla="*/ 350052 w 777997"/>
                <a:gd name="connsiteY24" fmla="*/ 1715 h 289983"/>
                <a:gd name="connsiteX25" fmla="*/ 258815 w 777997"/>
                <a:gd name="connsiteY25" fmla="*/ 22156 h 289983"/>
                <a:gd name="connsiteX26" fmla="*/ 182880 w 777997"/>
                <a:gd name="connsiteY26" fmla="*/ 57320 h 289983"/>
                <a:gd name="connsiteX27" fmla="*/ 123825 w 777997"/>
                <a:gd name="connsiteY27" fmla="*/ 99230 h 289983"/>
                <a:gd name="connsiteX28" fmla="*/ 87630 w 777997"/>
                <a:gd name="connsiteY28" fmla="*/ 129710 h 289983"/>
                <a:gd name="connsiteX29" fmla="*/ 55245 w 777997"/>
                <a:gd name="connsiteY29" fmla="*/ 162095 h 289983"/>
                <a:gd name="connsiteX30" fmla="*/ 20955 w 777997"/>
                <a:gd name="connsiteY30" fmla="*/ 207815 h 289983"/>
                <a:gd name="connsiteX31" fmla="*/ 0 w 777997"/>
                <a:gd name="connsiteY31" fmla="*/ 255440 h 289983"/>
                <a:gd name="connsiteX0" fmla="*/ 0 w 777997"/>
                <a:gd name="connsiteY0" fmla="*/ 255440 h 289983"/>
                <a:gd name="connsiteX1" fmla="*/ 19050 w 777997"/>
                <a:gd name="connsiteY1" fmla="*/ 272585 h 289983"/>
                <a:gd name="connsiteX2" fmla="*/ 45720 w 777997"/>
                <a:gd name="connsiteY2" fmla="*/ 289730 h 289983"/>
                <a:gd name="connsiteX3" fmla="*/ 66666 w 777997"/>
                <a:gd name="connsiteY3" fmla="*/ 258275 h 289983"/>
                <a:gd name="connsiteX4" fmla="*/ 112386 w 777997"/>
                <a:gd name="connsiteY4" fmla="*/ 202820 h 289983"/>
                <a:gd name="connsiteX5" fmla="*/ 171696 w 777997"/>
                <a:gd name="connsiteY5" fmla="*/ 152776 h 289983"/>
                <a:gd name="connsiteX6" fmla="*/ 244091 w 777997"/>
                <a:gd name="connsiteY6" fmla="*/ 107570 h 289983"/>
                <a:gd name="connsiteX7" fmla="*/ 324559 w 777997"/>
                <a:gd name="connsiteY7" fmla="*/ 79359 h 289983"/>
                <a:gd name="connsiteX8" fmla="*/ 388842 w 777997"/>
                <a:gd name="connsiteY8" fmla="*/ 71585 h 289983"/>
                <a:gd name="connsiteX9" fmla="*/ 462683 w 777997"/>
                <a:gd name="connsiteY9" fmla="*/ 76474 h 289983"/>
                <a:gd name="connsiteX10" fmla="*/ 527217 w 777997"/>
                <a:gd name="connsiteY10" fmla="*/ 94647 h 289983"/>
                <a:gd name="connsiteX11" fmla="*/ 574100 w 777997"/>
                <a:gd name="connsiteY11" fmla="*/ 118689 h 289983"/>
                <a:gd name="connsiteX12" fmla="*/ 628650 w 777997"/>
                <a:gd name="connsiteY12" fmla="*/ 166524 h 289983"/>
                <a:gd name="connsiteX13" fmla="*/ 667218 w 777997"/>
                <a:gd name="connsiteY13" fmla="*/ 210339 h 289983"/>
                <a:gd name="connsiteX14" fmla="*/ 711417 w 777997"/>
                <a:gd name="connsiteY14" fmla="*/ 263652 h 289983"/>
                <a:gd name="connsiteX15" fmla="*/ 727710 w 777997"/>
                <a:gd name="connsiteY15" fmla="*/ 272585 h 289983"/>
                <a:gd name="connsiteX16" fmla="*/ 762000 w 777997"/>
                <a:gd name="connsiteY16" fmla="*/ 244010 h 289983"/>
                <a:gd name="connsiteX17" fmla="*/ 777949 w 777997"/>
                <a:gd name="connsiteY17" fmla="*/ 231087 h 289983"/>
                <a:gd name="connsiteX18" fmla="*/ 765810 w 777997"/>
                <a:gd name="connsiteY18" fmla="*/ 204005 h 289983"/>
                <a:gd name="connsiteX19" fmla="*/ 735571 w 777997"/>
                <a:gd name="connsiteY19" fmla="*/ 160344 h 289983"/>
                <a:gd name="connsiteX20" fmla="*/ 672706 w 777997"/>
                <a:gd name="connsiteY20" fmla="*/ 98510 h 289983"/>
                <a:gd name="connsiteX21" fmla="*/ 578184 w 777997"/>
                <a:gd name="connsiteY21" fmla="*/ 38120 h 289983"/>
                <a:gd name="connsiteX22" fmla="*/ 481719 w 777997"/>
                <a:gd name="connsiteY22" fmla="*/ 8615 h 289983"/>
                <a:gd name="connsiteX23" fmla="*/ 409575 w 777997"/>
                <a:gd name="connsiteY23" fmla="*/ 995 h 289983"/>
                <a:gd name="connsiteX24" fmla="*/ 350052 w 777997"/>
                <a:gd name="connsiteY24" fmla="*/ 1715 h 289983"/>
                <a:gd name="connsiteX25" fmla="*/ 258815 w 777997"/>
                <a:gd name="connsiteY25" fmla="*/ 22156 h 289983"/>
                <a:gd name="connsiteX26" fmla="*/ 182880 w 777997"/>
                <a:gd name="connsiteY26" fmla="*/ 57320 h 289983"/>
                <a:gd name="connsiteX27" fmla="*/ 123825 w 777997"/>
                <a:gd name="connsiteY27" fmla="*/ 99230 h 289983"/>
                <a:gd name="connsiteX28" fmla="*/ 87630 w 777997"/>
                <a:gd name="connsiteY28" fmla="*/ 129710 h 289983"/>
                <a:gd name="connsiteX29" fmla="*/ 55245 w 777997"/>
                <a:gd name="connsiteY29" fmla="*/ 162095 h 289983"/>
                <a:gd name="connsiteX30" fmla="*/ 20955 w 777997"/>
                <a:gd name="connsiteY30" fmla="*/ 207815 h 289983"/>
                <a:gd name="connsiteX31" fmla="*/ 0 w 777997"/>
                <a:gd name="connsiteY31" fmla="*/ 255440 h 289983"/>
                <a:gd name="connsiteX0" fmla="*/ 0 w 784077"/>
                <a:gd name="connsiteY0" fmla="*/ 252187 h 289983"/>
                <a:gd name="connsiteX1" fmla="*/ 25130 w 784077"/>
                <a:gd name="connsiteY1" fmla="*/ 272585 h 289983"/>
                <a:gd name="connsiteX2" fmla="*/ 51800 w 784077"/>
                <a:gd name="connsiteY2" fmla="*/ 289730 h 289983"/>
                <a:gd name="connsiteX3" fmla="*/ 72746 w 784077"/>
                <a:gd name="connsiteY3" fmla="*/ 258275 h 289983"/>
                <a:gd name="connsiteX4" fmla="*/ 118466 w 784077"/>
                <a:gd name="connsiteY4" fmla="*/ 202820 h 289983"/>
                <a:gd name="connsiteX5" fmla="*/ 177776 w 784077"/>
                <a:gd name="connsiteY5" fmla="*/ 152776 h 289983"/>
                <a:gd name="connsiteX6" fmla="*/ 250171 w 784077"/>
                <a:gd name="connsiteY6" fmla="*/ 107570 h 289983"/>
                <a:gd name="connsiteX7" fmla="*/ 330639 w 784077"/>
                <a:gd name="connsiteY7" fmla="*/ 79359 h 289983"/>
                <a:gd name="connsiteX8" fmla="*/ 394922 w 784077"/>
                <a:gd name="connsiteY8" fmla="*/ 71585 h 289983"/>
                <a:gd name="connsiteX9" fmla="*/ 468763 w 784077"/>
                <a:gd name="connsiteY9" fmla="*/ 76474 h 289983"/>
                <a:gd name="connsiteX10" fmla="*/ 533297 w 784077"/>
                <a:gd name="connsiteY10" fmla="*/ 94647 h 289983"/>
                <a:gd name="connsiteX11" fmla="*/ 580180 w 784077"/>
                <a:gd name="connsiteY11" fmla="*/ 118689 h 289983"/>
                <a:gd name="connsiteX12" fmla="*/ 634730 w 784077"/>
                <a:gd name="connsiteY12" fmla="*/ 166524 h 289983"/>
                <a:gd name="connsiteX13" fmla="*/ 673298 w 784077"/>
                <a:gd name="connsiteY13" fmla="*/ 210339 h 289983"/>
                <a:gd name="connsiteX14" fmla="*/ 717497 w 784077"/>
                <a:gd name="connsiteY14" fmla="*/ 263652 h 289983"/>
                <a:gd name="connsiteX15" fmla="*/ 733790 w 784077"/>
                <a:gd name="connsiteY15" fmla="*/ 272585 h 289983"/>
                <a:gd name="connsiteX16" fmla="*/ 768080 w 784077"/>
                <a:gd name="connsiteY16" fmla="*/ 244010 h 289983"/>
                <a:gd name="connsiteX17" fmla="*/ 784029 w 784077"/>
                <a:gd name="connsiteY17" fmla="*/ 231087 h 289983"/>
                <a:gd name="connsiteX18" fmla="*/ 771890 w 784077"/>
                <a:gd name="connsiteY18" fmla="*/ 204005 h 289983"/>
                <a:gd name="connsiteX19" fmla="*/ 741651 w 784077"/>
                <a:gd name="connsiteY19" fmla="*/ 160344 h 289983"/>
                <a:gd name="connsiteX20" fmla="*/ 678786 w 784077"/>
                <a:gd name="connsiteY20" fmla="*/ 98510 h 289983"/>
                <a:gd name="connsiteX21" fmla="*/ 584264 w 784077"/>
                <a:gd name="connsiteY21" fmla="*/ 38120 h 289983"/>
                <a:gd name="connsiteX22" fmla="*/ 487799 w 784077"/>
                <a:gd name="connsiteY22" fmla="*/ 8615 h 289983"/>
                <a:gd name="connsiteX23" fmla="*/ 415655 w 784077"/>
                <a:gd name="connsiteY23" fmla="*/ 995 h 289983"/>
                <a:gd name="connsiteX24" fmla="*/ 356132 w 784077"/>
                <a:gd name="connsiteY24" fmla="*/ 1715 h 289983"/>
                <a:gd name="connsiteX25" fmla="*/ 264895 w 784077"/>
                <a:gd name="connsiteY25" fmla="*/ 22156 h 289983"/>
                <a:gd name="connsiteX26" fmla="*/ 188960 w 784077"/>
                <a:gd name="connsiteY26" fmla="*/ 57320 h 289983"/>
                <a:gd name="connsiteX27" fmla="*/ 129905 w 784077"/>
                <a:gd name="connsiteY27" fmla="*/ 99230 h 289983"/>
                <a:gd name="connsiteX28" fmla="*/ 93710 w 784077"/>
                <a:gd name="connsiteY28" fmla="*/ 129710 h 289983"/>
                <a:gd name="connsiteX29" fmla="*/ 61325 w 784077"/>
                <a:gd name="connsiteY29" fmla="*/ 162095 h 289983"/>
                <a:gd name="connsiteX30" fmla="*/ 27035 w 784077"/>
                <a:gd name="connsiteY30" fmla="*/ 207815 h 289983"/>
                <a:gd name="connsiteX31" fmla="*/ 0 w 784077"/>
                <a:gd name="connsiteY31" fmla="*/ 252187 h 289983"/>
                <a:gd name="connsiteX0" fmla="*/ 0 w 784077"/>
                <a:gd name="connsiteY0" fmla="*/ 252187 h 290064"/>
                <a:gd name="connsiteX1" fmla="*/ 25130 w 784077"/>
                <a:gd name="connsiteY1" fmla="*/ 272585 h 290064"/>
                <a:gd name="connsiteX2" fmla="*/ 51800 w 784077"/>
                <a:gd name="connsiteY2" fmla="*/ 289730 h 290064"/>
                <a:gd name="connsiteX3" fmla="*/ 78825 w 784077"/>
                <a:gd name="connsiteY3" fmla="*/ 255835 h 290064"/>
                <a:gd name="connsiteX4" fmla="*/ 118466 w 784077"/>
                <a:gd name="connsiteY4" fmla="*/ 202820 h 290064"/>
                <a:gd name="connsiteX5" fmla="*/ 177776 w 784077"/>
                <a:gd name="connsiteY5" fmla="*/ 152776 h 290064"/>
                <a:gd name="connsiteX6" fmla="*/ 250171 w 784077"/>
                <a:gd name="connsiteY6" fmla="*/ 107570 h 290064"/>
                <a:gd name="connsiteX7" fmla="*/ 330639 w 784077"/>
                <a:gd name="connsiteY7" fmla="*/ 79359 h 290064"/>
                <a:gd name="connsiteX8" fmla="*/ 394922 w 784077"/>
                <a:gd name="connsiteY8" fmla="*/ 71585 h 290064"/>
                <a:gd name="connsiteX9" fmla="*/ 468763 w 784077"/>
                <a:gd name="connsiteY9" fmla="*/ 76474 h 290064"/>
                <a:gd name="connsiteX10" fmla="*/ 533297 w 784077"/>
                <a:gd name="connsiteY10" fmla="*/ 94647 h 290064"/>
                <a:gd name="connsiteX11" fmla="*/ 580180 w 784077"/>
                <a:gd name="connsiteY11" fmla="*/ 118689 h 290064"/>
                <a:gd name="connsiteX12" fmla="*/ 634730 w 784077"/>
                <a:gd name="connsiteY12" fmla="*/ 166524 h 290064"/>
                <a:gd name="connsiteX13" fmla="*/ 673298 w 784077"/>
                <a:gd name="connsiteY13" fmla="*/ 210339 h 290064"/>
                <a:gd name="connsiteX14" fmla="*/ 717497 w 784077"/>
                <a:gd name="connsiteY14" fmla="*/ 263652 h 290064"/>
                <a:gd name="connsiteX15" fmla="*/ 733790 w 784077"/>
                <a:gd name="connsiteY15" fmla="*/ 272585 h 290064"/>
                <a:gd name="connsiteX16" fmla="*/ 768080 w 784077"/>
                <a:gd name="connsiteY16" fmla="*/ 244010 h 290064"/>
                <a:gd name="connsiteX17" fmla="*/ 784029 w 784077"/>
                <a:gd name="connsiteY17" fmla="*/ 231087 h 290064"/>
                <a:gd name="connsiteX18" fmla="*/ 771890 w 784077"/>
                <a:gd name="connsiteY18" fmla="*/ 204005 h 290064"/>
                <a:gd name="connsiteX19" fmla="*/ 741651 w 784077"/>
                <a:gd name="connsiteY19" fmla="*/ 160344 h 290064"/>
                <a:gd name="connsiteX20" fmla="*/ 678786 w 784077"/>
                <a:gd name="connsiteY20" fmla="*/ 98510 h 290064"/>
                <a:gd name="connsiteX21" fmla="*/ 584264 w 784077"/>
                <a:gd name="connsiteY21" fmla="*/ 38120 h 290064"/>
                <a:gd name="connsiteX22" fmla="*/ 487799 w 784077"/>
                <a:gd name="connsiteY22" fmla="*/ 8615 h 290064"/>
                <a:gd name="connsiteX23" fmla="*/ 415655 w 784077"/>
                <a:gd name="connsiteY23" fmla="*/ 995 h 290064"/>
                <a:gd name="connsiteX24" fmla="*/ 356132 w 784077"/>
                <a:gd name="connsiteY24" fmla="*/ 1715 h 290064"/>
                <a:gd name="connsiteX25" fmla="*/ 264895 w 784077"/>
                <a:gd name="connsiteY25" fmla="*/ 22156 h 290064"/>
                <a:gd name="connsiteX26" fmla="*/ 188960 w 784077"/>
                <a:gd name="connsiteY26" fmla="*/ 57320 h 290064"/>
                <a:gd name="connsiteX27" fmla="*/ 129905 w 784077"/>
                <a:gd name="connsiteY27" fmla="*/ 99230 h 290064"/>
                <a:gd name="connsiteX28" fmla="*/ 93710 w 784077"/>
                <a:gd name="connsiteY28" fmla="*/ 129710 h 290064"/>
                <a:gd name="connsiteX29" fmla="*/ 61325 w 784077"/>
                <a:gd name="connsiteY29" fmla="*/ 162095 h 290064"/>
                <a:gd name="connsiteX30" fmla="*/ 27035 w 784077"/>
                <a:gd name="connsiteY30" fmla="*/ 207815 h 290064"/>
                <a:gd name="connsiteX31" fmla="*/ 0 w 784077"/>
                <a:gd name="connsiteY31" fmla="*/ 252187 h 290064"/>
                <a:gd name="connsiteX0" fmla="*/ 0 w 784077"/>
                <a:gd name="connsiteY0" fmla="*/ 252187 h 290064"/>
                <a:gd name="connsiteX1" fmla="*/ 25130 w 784077"/>
                <a:gd name="connsiteY1" fmla="*/ 272585 h 290064"/>
                <a:gd name="connsiteX2" fmla="*/ 51800 w 784077"/>
                <a:gd name="connsiteY2" fmla="*/ 289730 h 290064"/>
                <a:gd name="connsiteX3" fmla="*/ 78825 w 784077"/>
                <a:gd name="connsiteY3" fmla="*/ 255835 h 290064"/>
                <a:gd name="connsiteX4" fmla="*/ 118466 w 784077"/>
                <a:gd name="connsiteY4" fmla="*/ 202820 h 290064"/>
                <a:gd name="connsiteX5" fmla="*/ 177776 w 784077"/>
                <a:gd name="connsiteY5" fmla="*/ 152776 h 290064"/>
                <a:gd name="connsiteX6" fmla="*/ 250171 w 784077"/>
                <a:gd name="connsiteY6" fmla="*/ 107570 h 290064"/>
                <a:gd name="connsiteX7" fmla="*/ 330639 w 784077"/>
                <a:gd name="connsiteY7" fmla="*/ 79359 h 290064"/>
                <a:gd name="connsiteX8" fmla="*/ 394922 w 784077"/>
                <a:gd name="connsiteY8" fmla="*/ 71585 h 290064"/>
                <a:gd name="connsiteX9" fmla="*/ 468763 w 784077"/>
                <a:gd name="connsiteY9" fmla="*/ 76474 h 290064"/>
                <a:gd name="connsiteX10" fmla="*/ 533297 w 784077"/>
                <a:gd name="connsiteY10" fmla="*/ 94647 h 290064"/>
                <a:gd name="connsiteX11" fmla="*/ 580180 w 784077"/>
                <a:gd name="connsiteY11" fmla="*/ 118689 h 290064"/>
                <a:gd name="connsiteX12" fmla="*/ 634730 w 784077"/>
                <a:gd name="connsiteY12" fmla="*/ 166524 h 290064"/>
                <a:gd name="connsiteX13" fmla="*/ 673298 w 784077"/>
                <a:gd name="connsiteY13" fmla="*/ 210339 h 290064"/>
                <a:gd name="connsiteX14" fmla="*/ 706858 w 784077"/>
                <a:gd name="connsiteY14" fmla="*/ 250641 h 290064"/>
                <a:gd name="connsiteX15" fmla="*/ 733790 w 784077"/>
                <a:gd name="connsiteY15" fmla="*/ 272585 h 290064"/>
                <a:gd name="connsiteX16" fmla="*/ 768080 w 784077"/>
                <a:gd name="connsiteY16" fmla="*/ 244010 h 290064"/>
                <a:gd name="connsiteX17" fmla="*/ 784029 w 784077"/>
                <a:gd name="connsiteY17" fmla="*/ 231087 h 290064"/>
                <a:gd name="connsiteX18" fmla="*/ 771890 w 784077"/>
                <a:gd name="connsiteY18" fmla="*/ 204005 h 290064"/>
                <a:gd name="connsiteX19" fmla="*/ 741651 w 784077"/>
                <a:gd name="connsiteY19" fmla="*/ 160344 h 290064"/>
                <a:gd name="connsiteX20" fmla="*/ 678786 w 784077"/>
                <a:gd name="connsiteY20" fmla="*/ 98510 h 290064"/>
                <a:gd name="connsiteX21" fmla="*/ 584264 w 784077"/>
                <a:gd name="connsiteY21" fmla="*/ 38120 h 290064"/>
                <a:gd name="connsiteX22" fmla="*/ 487799 w 784077"/>
                <a:gd name="connsiteY22" fmla="*/ 8615 h 290064"/>
                <a:gd name="connsiteX23" fmla="*/ 415655 w 784077"/>
                <a:gd name="connsiteY23" fmla="*/ 995 h 290064"/>
                <a:gd name="connsiteX24" fmla="*/ 356132 w 784077"/>
                <a:gd name="connsiteY24" fmla="*/ 1715 h 290064"/>
                <a:gd name="connsiteX25" fmla="*/ 264895 w 784077"/>
                <a:gd name="connsiteY25" fmla="*/ 22156 h 290064"/>
                <a:gd name="connsiteX26" fmla="*/ 188960 w 784077"/>
                <a:gd name="connsiteY26" fmla="*/ 57320 h 290064"/>
                <a:gd name="connsiteX27" fmla="*/ 129905 w 784077"/>
                <a:gd name="connsiteY27" fmla="*/ 99230 h 290064"/>
                <a:gd name="connsiteX28" fmla="*/ 93710 w 784077"/>
                <a:gd name="connsiteY28" fmla="*/ 129710 h 290064"/>
                <a:gd name="connsiteX29" fmla="*/ 61325 w 784077"/>
                <a:gd name="connsiteY29" fmla="*/ 162095 h 290064"/>
                <a:gd name="connsiteX30" fmla="*/ 27035 w 784077"/>
                <a:gd name="connsiteY30" fmla="*/ 207815 h 290064"/>
                <a:gd name="connsiteX31" fmla="*/ 0 w 784077"/>
                <a:gd name="connsiteY31" fmla="*/ 252187 h 290064"/>
                <a:gd name="connsiteX0" fmla="*/ 0 w 784219"/>
                <a:gd name="connsiteY0" fmla="*/ 252187 h 290064"/>
                <a:gd name="connsiteX1" fmla="*/ 25130 w 784219"/>
                <a:gd name="connsiteY1" fmla="*/ 272585 h 290064"/>
                <a:gd name="connsiteX2" fmla="*/ 51800 w 784219"/>
                <a:gd name="connsiteY2" fmla="*/ 289730 h 290064"/>
                <a:gd name="connsiteX3" fmla="*/ 78825 w 784219"/>
                <a:gd name="connsiteY3" fmla="*/ 255835 h 290064"/>
                <a:gd name="connsiteX4" fmla="*/ 118466 w 784219"/>
                <a:gd name="connsiteY4" fmla="*/ 202820 h 290064"/>
                <a:gd name="connsiteX5" fmla="*/ 177776 w 784219"/>
                <a:gd name="connsiteY5" fmla="*/ 152776 h 290064"/>
                <a:gd name="connsiteX6" fmla="*/ 250171 w 784219"/>
                <a:gd name="connsiteY6" fmla="*/ 107570 h 290064"/>
                <a:gd name="connsiteX7" fmla="*/ 330639 w 784219"/>
                <a:gd name="connsiteY7" fmla="*/ 79359 h 290064"/>
                <a:gd name="connsiteX8" fmla="*/ 394922 w 784219"/>
                <a:gd name="connsiteY8" fmla="*/ 71585 h 290064"/>
                <a:gd name="connsiteX9" fmla="*/ 468763 w 784219"/>
                <a:gd name="connsiteY9" fmla="*/ 76474 h 290064"/>
                <a:gd name="connsiteX10" fmla="*/ 533297 w 784219"/>
                <a:gd name="connsiteY10" fmla="*/ 94647 h 290064"/>
                <a:gd name="connsiteX11" fmla="*/ 580180 w 784219"/>
                <a:gd name="connsiteY11" fmla="*/ 118689 h 290064"/>
                <a:gd name="connsiteX12" fmla="*/ 634730 w 784219"/>
                <a:gd name="connsiteY12" fmla="*/ 166524 h 290064"/>
                <a:gd name="connsiteX13" fmla="*/ 673298 w 784219"/>
                <a:gd name="connsiteY13" fmla="*/ 210339 h 290064"/>
                <a:gd name="connsiteX14" fmla="*/ 706858 w 784219"/>
                <a:gd name="connsiteY14" fmla="*/ 250641 h 290064"/>
                <a:gd name="connsiteX15" fmla="*/ 733790 w 784219"/>
                <a:gd name="connsiteY15" fmla="*/ 272585 h 290064"/>
                <a:gd name="connsiteX16" fmla="*/ 763520 w 784219"/>
                <a:gd name="connsiteY16" fmla="*/ 249702 h 290064"/>
                <a:gd name="connsiteX17" fmla="*/ 784029 w 784219"/>
                <a:gd name="connsiteY17" fmla="*/ 231087 h 290064"/>
                <a:gd name="connsiteX18" fmla="*/ 771890 w 784219"/>
                <a:gd name="connsiteY18" fmla="*/ 204005 h 290064"/>
                <a:gd name="connsiteX19" fmla="*/ 741651 w 784219"/>
                <a:gd name="connsiteY19" fmla="*/ 160344 h 290064"/>
                <a:gd name="connsiteX20" fmla="*/ 678786 w 784219"/>
                <a:gd name="connsiteY20" fmla="*/ 98510 h 290064"/>
                <a:gd name="connsiteX21" fmla="*/ 584264 w 784219"/>
                <a:gd name="connsiteY21" fmla="*/ 38120 h 290064"/>
                <a:gd name="connsiteX22" fmla="*/ 487799 w 784219"/>
                <a:gd name="connsiteY22" fmla="*/ 8615 h 290064"/>
                <a:gd name="connsiteX23" fmla="*/ 415655 w 784219"/>
                <a:gd name="connsiteY23" fmla="*/ 995 h 290064"/>
                <a:gd name="connsiteX24" fmla="*/ 356132 w 784219"/>
                <a:gd name="connsiteY24" fmla="*/ 1715 h 290064"/>
                <a:gd name="connsiteX25" fmla="*/ 264895 w 784219"/>
                <a:gd name="connsiteY25" fmla="*/ 22156 h 290064"/>
                <a:gd name="connsiteX26" fmla="*/ 188960 w 784219"/>
                <a:gd name="connsiteY26" fmla="*/ 57320 h 290064"/>
                <a:gd name="connsiteX27" fmla="*/ 129905 w 784219"/>
                <a:gd name="connsiteY27" fmla="*/ 99230 h 290064"/>
                <a:gd name="connsiteX28" fmla="*/ 93710 w 784219"/>
                <a:gd name="connsiteY28" fmla="*/ 129710 h 290064"/>
                <a:gd name="connsiteX29" fmla="*/ 61325 w 784219"/>
                <a:gd name="connsiteY29" fmla="*/ 162095 h 290064"/>
                <a:gd name="connsiteX30" fmla="*/ 27035 w 784219"/>
                <a:gd name="connsiteY30" fmla="*/ 207815 h 290064"/>
                <a:gd name="connsiteX31" fmla="*/ 0 w 784219"/>
                <a:gd name="connsiteY31" fmla="*/ 252187 h 290064"/>
                <a:gd name="connsiteX0" fmla="*/ 0 w 784249"/>
                <a:gd name="connsiteY0" fmla="*/ 252187 h 290064"/>
                <a:gd name="connsiteX1" fmla="*/ 25130 w 784249"/>
                <a:gd name="connsiteY1" fmla="*/ 272585 h 290064"/>
                <a:gd name="connsiteX2" fmla="*/ 51800 w 784249"/>
                <a:gd name="connsiteY2" fmla="*/ 289730 h 290064"/>
                <a:gd name="connsiteX3" fmla="*/ 78825 w 784249"/>
                <a:gd name="connsiteY3" fmla="*/ 255835 h 290064"/>
                <a:gd name="connsiteX4" fmla="*/ 118466 w 784249"/>
                <a:gd name="connsiteY4" fmla="*/ 202820 h 290064"/>
                <a:gd name="connsiteX5" fmla="*/ 177776 w 784249"/>
                <a:gd name="connsiteY5" fmla="*/ 152776 h 290064"/>
                <a:gd name="connsiteX6" fmla="*/ 250171 w 784249"/>
                <a:gd name="connsiteY6" fmla="*/ 107570 h 290064"/>
                <a:gd name="connsiteX7" fmla="*/ 330639 w 784249"/>
                <a:gd name="connsiteY7" fmla="*/ 79359 h 290064"/>
                <a:gd name="connsiteX8" fmla="*/ 394922 w 784249"/>
                <a:gd name="connsiteY8" fmla="*/ 71585 h 290064"/>
                <a:gd name="connsiteX9" fmla="*/ 468763 w 784249"/>
                <a:gd name="connsiteY9" fmla="*/ 76474 h 290064"/>
                <a:gd name="connsiteX10" fmla="*/ 533297 w 784249"/>
                <a:gd name="connsiteY10" fmla="*/ 94647 h 290064"/>
                <a:gd name="connsiteX11" fmla="*/ 580180 w 784249"/>
                <a:gd name="connsiteY11" fmla="*/ 118689 h 290064"/>
                <a:gd name="connsiteX12" fmla="*/ 634730 w 784249"/>
                <a:gd name="connsiteY12" fmla="*/ 166524 h 290064"/>
                <a:gd name="connsiteX13" fmla="*/ 673298 w 784249"/>
                <a:gd name="connsiteY13" fmla="*/ 210339 h 290064"/>
                <a:gd name="connsiteX14" fmla="*/ 706858 w 784249"/>
                <a:gd name="connsiteY14" fmla="*/ 250641 h 290064"/>
                <a:gd name="connsiteX15" fmla="*/ 733790 w 784249"/>
                <a:gd name="connsiteY15" fmla="*/ 272585 h 290064"/>
                <a:gd name="connsiteX16" fmla="*/ 762760 w 784249"/>
                <a:gd name="connsiteY16" fmla="*/ 252142 h 290064"/>
                <a:gd name="connsiteX17" fmla="*/ 784029 w 784249"/>
                <a:gd name="connsiteY17" fmla="*/ 231087 h 290064"/>
                <a:gd name="connsiteX18" fmla="*/ 771890 w 784249"/>
                <a:gd name="connsiteY18" fmla="*/ 204005 h 290064"/>
                <a:gd name="connsiteX19" fmla="*/ 741651 w 784249"/>
                <a:gd name="connsiteY19" fmla="*/ 160344 h 290064"/>
                <a:gd name="connsiteX20" fmla="*/ 678786 w 784249"/>
                <a:gd name="connsiteY20" fmla="*/ 98510 h 290064"/>
                <a:gd name="connsiteX21" fmla="*/ 584264 w 784249"/>
                <a:gd name="connsiteY21" fmla="*/ 38120 h 290064"/>
                <a:gd name="connsiteX22" fmla="*/ 487799 w 784249"/>
                <a:gd name="connsiteY22" fmla="*/ 8615 h 290064"/>
                <a:gd name="connsiteX23" fmla="*/ 415655 w 784249"/>
                <a:gd name="connsiteY23" fmla="*/ 995 h 290064"/>
                <a:gd name="connsiteX24" fmla="*/ 356132 w 784249"/>
                <a:gd name="connsiteY24" fmla="*/ 1715 h 290064"/>
                <a:gd name="connsiteX25" fmla="*/ 264895 w 784249"/>
                <a:gd name="connsiteY25" fmla="*/ 22156 h 290064"/>
                <a:gd name="connsiteX26" fmla="*/ 188960 w 784249"/>
                <a:gd name="connsiteY26" fmla="*/ 57320 h 290064"/>
                <a:gd name="connsiteX27" fmla="*/ 129905 w 784249"/>
                <a:gd name="connsiteY27" fmla="*/ 99230 h 290064"/>
                <a:gd name="connsiteX28" fmla="*/ 93710 w 784249"/>
                <a:gd name="connsiteY28" fmla="*/ 129710 h 290064"/>
                <a:gd name="connsiteX29" fmla="*/ 61325 w 784249"/>
                <a:gd name="connsiteY29" fmla="*/ 162095 h 290064"/>
                <a:gd name="connsiteX30" fmla="*/ 27035 w 784249"/>
                <a:gd name="connsiteY30" fmla="*/ 207815 h 290064"/>
                <a:gd name="connsiteX31" fmla="*/ 0 w 784249"/>
                <a:gd name="connsiteY31" fmla="*/ 252187 h 290064"/>
                <a:gd name="connsiteX0" fmla="*/ 0 w 784249"/>
                <a:gd name="connsiteY0" fmla="*/ 252187 h 290064"/>
                <a:gd name="connsiteX1" fmla="*/ 25130 w 784249"/>
                <a:gd name="connsiteY1" fmla="*/ 272585 h 290064"/>
                <a:gd name="connsiteX2" fmla="*/ 51800 w 784249"/>
                <a:gd name="connsiteY2" fmla="*/ 289730 h 290064"/>
                <a:gd name="connsiteX3" fmla="*/ 78825 w 784249"/>
                <a:gd name="connsiteY3" fmla="*/ 255835 h 290064"/>
                <a:gd name="connsiteX4" fmla="*/ 118466 w 784249"/>
                <a:gd name="connsiteY4" fmla="*/ 202820 h 290064"/>
                <a:gd name="connsiteX5" fmla="*/ 177776 w 784249"/>
                <a:gd name="connsiteY5" fmla="*/ 152776 h 290064"/>
                <a:gd name="connsiteX6" fmla="*/ 250171 w 784249"/>
                <a:gd name="connsiteY6" fmla="*/ 107570 h 290064"/>
                <a:gd name="connsiteX7" fmla="*/ 330639 w 784249"/>
                <a:gd name="connsiteY7" fmla="*/ 79359 h 290064"/>
                <a:gd name="connsiteX8" fmla="*/ 394922 w 784249"/>
                <a:gd name="connsiteY8" fmla="*/ 71585 h 290064"/>
                <a:gd name="connsiteX9" fmla="*/ 468763 w 784249"/>
                <a:gd name="connsiteY9" fmla="*/ 76474 h 290064"/>
                <a:gd name="connsiteX10" fmla="*/ 533297 w 784249"/>
                <a:gd name="connsiteY10" fmla="*/ 94647 h 290064"/>
                <a:gd name="connsiteX11" fmla="*/ 580180 w 784249"/>
                <a:gd name="connsiteY11" fmla="*/ 118689 h 290064"/>
                <a:gd name="connsiteX12" fmla="*/ 634730 w 784249"/>
                <a:gd name="connsiteY12" fmla="*/ 166524 h 290064"/>
                <a:gd name="connsiteX13" fmla="*/ 673298 w 784249"/>
                <a:gd name="connsiteY13" fmla="*/ 210339 h 290064"/>
                <a:gd name="connsiteX14" fmla="*/ 706858 w 784249"/>
                <a:gd name="connsiteY14" fmla="*/ 245762 h 290064"/>
                <a:gd name="connsiteX15" fmla="*/ 733790 w 784249"/>
                <a:gd name="connsiteY15" fmla="*/ 272585 h 290064"/>
                <a:gd name="connsiteX16" fmla="*/ 762760 w 784249"/>
                <a:gd name="connsiteY16" fmla="*/ 252142 h 290064"/>
                <a:gd name="connsiteX17" fmla="*/ 784029 w 784249"/>
                <a:gd name="connsiteY17" fmla="*/ 231087 h 290064"/>
                <a:gd name="connsiteX18" fmla="*/ 771890 w 784249"/>
                <a:gd name="connsiteY18" fmla="*/ 204005 h 290064"/>
                <a:gd name="connsiteX19" fmla="*/ 741651 w 784249"/>
                <a:gd name="connsiteY19" fmla="*/ 160344 h 290064"/>
                <a:gd name="connsiteX20" fmla="*/ 678786 w 784249"/>
                <a:gd name="connsiteY20" fmla="*/ 98510 h 290064"/>
                <a:gd name="connsiteX21" fmla="*/ 584264 w 784249"/>
                <a:gd name="connsiteY21" fmla="*/ 38120 h 290064"/>
                <a:gd name="connsiteX22" fmla="*/ 487799 w 784249"/>
                <a:gd name="connsiteY22" fmla="*/ 8615 h 290064"/>
                <a:gd name="connsiteX23" fmla="*/ 415655 w 784249"/>
                <a:gd name="connsiteY23" fmla="*/ 995 h 290064"/>
                <a:gd name="connsiteX24" fmla="*/ 356132 w 784249"/>
                <a:gd name="connsiteY24" fmla="*/ 1715 h 290064"/>
                <a:gd name="connsiteX25" fmla="*/ 264895 w 784249"/>
                <a:gd name="connsiteY25" fmla="*/ 22156 h 290064"/>
                <a:gd name="connsiteX26" fmla="*/ 188960 w 784249"/>
                <a:gd name="connsiteY26" fmla="*/ 57320 h 290064"/>
                <a:gd name="connsiteX27" fmla="*/ 129905 w 784249"/>
                <a:gd name="connsiteY27" fmla="*/ 99230 h 290064"/>
                <a:gd name="connsiteX28" fmla="*/ 93710 w 784249"/>
                <a:gd name="connsiteY28" fmla="*/ 129710 h 290064"/>
                <a:gd name="connsiteX29" fmla="*/ 61325 w 784249"/>
                <a:gd name="connsiteY29" fmla="*/ 162095 h 290064"/>
                <a:gd name="connsiteX30" fmla="*/ 27035 w 784249"/>
                <a:gd name="connsiteY30" fmla="*/ 207815 h 290064"/>
                <a:gd name="connsiteX31" fmla="*/ 0 w 784249"/>
                <a:gd name="connsiteY31" fmla="*/ 252187 h 290064"/>
                <a:gd name="connsiteX0" fmla="*/ 0 w 784249"/>
                <a:gd name="connsiteY0" fmla="*/ 252187 h 290064"/>
                <a:gd name="connsiteX1" fmla="*/ 25130 w 784249"/>
                <a:gd name="connsiteY1" fmla="*/ 272585 h 290064"/>
                <a:gd name="connsiteX2" fmla="*/ 51800 w 784249"/>
                <a:gd name="connsiteY2" fmla="*/ 289730 h 290064"/>
                <a:gd name="connsiteX3" fmla="*/ 78825 w 784249"/>
                <a:gd name="connsiteY3" fmla="*/ 255835 h 290064"/>
                <a:gd name="connsiteX4" fmla="*/ 118466 w 784249"/>
                <a:gd name="connsiteY4" fmla="*/ 202820 h 290064"/>
                <a:gd name="connsiteX5" fmla="*/ 177776 w 784249"/>
                <a:gd name="connsiteY5" fmla="*/ 152776 h 290064"/>
                <a:gd name="connsiteX6" fmla="*/ 250171 w 784249"/>
                <a:gd name="connsiteY6" fmla="*/ 107570 h 290064"/>
                <a:gd name="connsiteX7" fmla="*/ 330639 w 784249"/>
                <a:gd name="connsiteY7" fmla="*/ 79359 h 290064"/>
                <a:gd name="connsiteX8" fmla="*/ 394922 w 784249"/>
                <a:gd name="connsiteY8" fmla="*/ 71585 h 290064"/>
                <a:gd name="connsiteX9" fmla="*/ 468763 w 784249"/>
                <a:gd name="connsiteY9" fmla="*/ 76474 h 290064"/>
                <a:gd name="connsiteX10" fmla="*/ 533297 w 784249"/>
                <a:gd name="connsiteY10" fmla="*/ 94647 h 290064"/>
                <a:gd name="connsiteX11" fmla="*/ 580180 w 784249"/>
                <a:gd name="connsiteY11" fmla="*/ 118689 h 290064"/>
                <a:gd name="connsiteX12" fmla="*/ 634730 w 784249"/>
                <a:gd name="connsiteY12" fmla="*/ 166524 h 290064"/>
                <a:gd name="connsiteX13" fmla="*/ 669498 w 784249"/>
                <a:gd name="connsiteY13" fmla="*/ 202207 h 290064"/>
                <a:gd name="connsiteX14" fmla="*/ 706858 w 784249"/>
                <a:gd name="connsiteY14" fmla="*/ 245762 h 290064"/>
                <a:gd name="connsiteX15" fmla="*/ 733790 w 784249"/>
                <a:gd name="connsiteY15" fmla="*/ 272585 h 290064"/>
                <a:gd name="connsiteX16" fmla="*/ 762760 w 784249"/>
                <a:gd name="connsiteY16" fmla="*/ 252142 h 290064"/>
                <a:gd name="connsiteX17" fmla="*/ 784029 w 784249"/>
                <a:gd name="connsiteY17" fmla="*/ 231087 h 290064"/>
                <a:gd name="connsiteX18" fmla="*/ 771890 w 784249"/>
                <a:gd name="connsiteY18" fmla="*/ 204005 h 290064"/>
                <a:gd name="connsiteX19" fmla="*/ 741651 w 784249"/>
                <a:gd name="connsiteY19" fmla="*/ 160344 h 290064"/>
                <a:gd name="connsiteX20" fmla="*/ 678786 w 784249"/>
                <a:gd name="connsiteY20" fmla="*/ 98510 h 290064"/>
                <a:gd name="connsiteX21" fmla="*/ 584264 w 784249"/>
                <a:gd name="connsiteY21" fmla="*/ 38120 h 290064"/>
                <a:gd name="connsiteX22" fmla="*/ 487799 w 784249"/>
                <a:gd name="connsiteY22" fmla="*/ 8615 h 290064"/>
                <a:gd name="connsiteX23" fmla="*/ 415655 w 784249"/>
                <a:gd name="connsiteY23" fmla="*/ 995 h 290064"/>
                <a:gd name="connsiteX24" fmla="*/ 356132 w 784249"/>
                <a:gd name="connsiteY24" fmla="*/ 1715 h 290064"/>
                <a:gd name="connsiteX25" fmla="*/ 264895 w 784249"/>
                <a:gd name="connsiteY25" fmla="*/ 22156 h 290064"/>
                <a:gd name="connsiteX26" fmla="*/ 188960 w 784249"/>
                <a:gd name="connsiteY26" fmla="*/ 57320 h 290064"/>
                <a:gd name="connsiteX27" fmla="*/ 129905 w 784249"/>
                <a:gd name="connsiteY27" fmla="*/ 99230 h 290064"/>
                <a:gd name="connsiteX28" fmla="*/ 93710 w 784249"/>
                <a:gd name="connsiteY28" fmla="*/ 129710 h 290064"/>
                <a:gd name="connsiteX29" fmla="*/ 61325 w 784249"/>
                <a:gd name="connsiteY29" fmla="*/ 162095 h 290064"/>
                <a:gd name="connsiteX30" fmla="*/ 27035 w 784249"/>
                <a:gd name="connsiteY30" fmla="*/ 207815 h 290064"/>
                <a:gd name="connsiteX31" fmla="*/ 0 w 784249"/>
                <a:gd name="connsiteY31" fmla="*/ 252187 h 290064"/>
                <a:gd name="connsiteX0" fmla="*/ 0 w 784249"/>
                <a:gd name="connsiteY0" fmla="*/ 252187 h 290064"/>
                <a:gd name="connsiteX1" fmla="*/ 25130 w 784249"/>
                <a:gd name="connsiteY1" fmla="*/ 272585 h 290064"/>
                <a:gd name="connsiteX2" fmla="*/ 51800 w 784249"/>
                <a:gd name="connsiteY2" fmla="*/ 289730 h 290064"/>
                <a:gd name="connsiteX3" fmla="*/ 78825 w 784249"/>
                <a:gd name="connsiteY3" fmla="*/ 255835 h 290064"/>
                <a:gd name="connsiteX4" fmla="*/ 118466 w 784249"/>
                <a:gd name="connsiteY4" fmla="*/ 202820 h 290064"/>
                <a:gd name="connsiteX5" fmla="*/ 177776 w 784249"/>
                <a:gd name="connsiteY5" fmla="*/ 152776 h 290064"/>
                <a:gd name="connsiteX6" fmla="*/ 250171 w 784249"/>
                <a:gd name="connsiteY6" fmla="*/ 107570 h 290064"/>
                <a:gd name="connsiteX7" fmla="*/ 330639 w 784249"/>
                <a:gd name="connsiteY7" fmla="*/ 79359 h 290064"/>
                <a:gd name="connsiteX8" fmla="*/ 394922 w 784249"/>
                <a:gd name="connsiteY8" fmla="*/ 71585 h 290064"/>
                <a:gd name="connsiteX9" fmla="*/ 468763 w 784249"/>
                <a:gd name="connsiteY9" fmla="*/ 76474 h 290064"/>
                <a:gd name="connsiteX10" fmla="*/ 533297 w 784249"/>
                <a:gd name="connsiteY10" fmla="*/ 94647 h 290064"/>
                <a:gd name="connsiteX11" fmla="*/ 580180 w 784249"/>
                <a:gd name="connsiteY11" fmla="*/ 118689 h 290064"/>
                <a:gd name="connsiteX12" fmla="*/ 626371 w 784249"/>
                <a:gd name="connsiteY12" fmla="*/ 154326 h 290064"/>
                <a:gd name="connsiteX13" fmla="*/ 669498 w 784249"/>
                <a:gd name="connsiteY13" fmla="*/ 202207 h 290064"/>
                <a:gd name="connsiteX14" fmla="*/ 706858 w 784249"/>
                <a:gd name="connsiteY14" fmla="*/ 245762 h 290064"/>
                <a:gd name="connsiteX15" fmla="*/ 733790 w 784249"/>
                <a:gd name="connsiteY15" fmla="*/ 272585 h 290064"/>
                <a:gd name="connsiteX16" fmla="*/ 762760 w 784249"/>
                <a:gd name="connsiteY16" fmla="*/ 252142 h 290064"/>
                <a:gd name="connsiteX17" fmla="*/ 784029 w 784249"/>
                <a:gd name="connsiteY17" fmla="*/ 231087 h 290064"/>
                <a:gd name="connsiteX18" fmla="*/ 771890 w 784249"/>
                <a:gd name="connsiteY18" fmla="*/ 204005 h 290064"/>
                <a:gd name="connsiteX19" fmla="*/ 741651 w 784249"/>
                <a:gd name="connsiteY19" fmla="*/ 160344 h 290064"/>
                <a:gd name="connsiteX20" fmla="*/ 678786 w 784249"/>
                <a:gd name="connsiteY20" fmla="*/ 98510 h 290064"/>
                <a:gd name="connsiteX21" fmla="*/ 584264 w 784249"/>
                <a:gd name="connsiteY21" fmla="*/ 38120 h 290064"/>
                <a:gd name="connsiteX22" fmla="*/ 487799 w 784249"/>
                <a:gd name="connsiteY22" fmla="*/ 8615 h 290064"/>
                <a:gd name="connsiteX23" fmla="*/ 415655 w 784249"/>
                <a:gd name="connsiteY23" fmla="*/ 995 h 290064"/>
                <a:gd name="connsiteX24" fmla="*/ 356132 w 784249"/>
                <a:gd name="connsiteY24" fmla="*/ 1715 h 290064"/>
                <a:gd name="connsiteX25" fmla="*/ 264895 w 784249"/>
                <a:gd name="connsiteY25" fmla="*/ 22156 h 290064"/>
                <a:gd name="connsiteX26" fmla="*/ 188960 w 784249"/>
                <a:gd name="connsiteY26" fmla="*/ 57320 h 290064"/>
                <a:gd name="connsiteX27" fmla="*/ 129905 w 784249"/>
                <a:gd name="connsiteY27" fmla="*/ 99230 h 290064"/>
                <a:gd name="connsiteX28" fmla="*/ 93710 w 784249"/>
                <a:gd name="connsiteY28" fmla="*/ 129710 h 290064"/>
                <a:gd name="connsiteX29" fmla="*/ 61325 w 784249"/>
                <a:gd name="connsiteY29" fmla="*/ 162095 h 290064"/>
                <a:gd name="connsiteX30" fmla="*/ 27035 w 784249"/>
                <a:gd name="connsiteY30" fmla="*/ 207815 h 290064"/>
                <a:gd name="connsiteX31" fmla="*/ 0 w 784249"/>
                <a:gd name="connsiteY31" fmla="*/ 252187 h 290064"/>
                <a:gd name="connsiteX0" fmla="*/ 0 w 784249"/>
                <a:gd name="connsiteY0" fmla="*/ 252187 h 290064"/>
                <a:gd name="connsiteX1" fmla="*/ 25130 w 784249"/>
                <a:gd name="connsiteY1" fmla="*/ 272585 h 290064"/>
                <a:gd name="connsiteX2" fmla="*/ 51800 w 784249"/>
                <a:gd name="connsiteY2" fmla="*/ 289730 h 290064"/>
                <a:gd name="connsiteX3" fmla="*/ 78825 w 784249"/>
                <a:gd name="connsiteY3" fmla="*/ 255835 h 290064"/>
                <a:gd name="connsiteX4" fmla="*/ 118466 w 784249"/>
                <a:gd name="connsiteY4" fmla="*/ 202820 h 290064"/>
                <a:gd name="connsiteX5" fmla="*/ 177776 w 784249"/>
                <a:gd name="connsiteY5" fmla="*/ 152776 h 290064"/>
                <a:gd name="connsiteX6" fmla="*/ 250171 w 784249"/>
                <a:gd name="connsiteY6" fmla="*/ 107570 h 290064"/>
                <a:gd name="connsiteX7" fmla="*/ 330639 w 784249"/>
                <a:gd name="connsiteY7" fmla="*/ 79359 h 290064"/>
                <a:gd name="connsiteX8" fmla="*/ 394922 w 784249"/>
                <a:gd name="connsiteY8" fmla="*/ 71585 h 290064"/>
                <a:gd name="connsiteX9" fmla="*/ 469523 w 784249"/>
                <a:gd name="connsiteY9" fmla="*/ 74848 h 290064"/>
                <a:gd name="connsiteX10" fmla="*/ 533297 w 784249"/>
                <a:gd name="connsiteY10" fmla="*/ 94647 h 290064"/>
                <a:gd name="connsiteX11" fmla="*/ 580180 w 784249"/>
                <a:gd name="connsiteY11" fmla="*/ 118689 h 290064"/>
                <a:gd name="connsiteX12" fmla="*/ 626371 w 784249"/>
                <a:gd name="connsiteY12" fmla="*/ 154326 h 290064"/>
                <a:gd name="connsiteX13" fmla="*/ 669498 w 784249"/>
                <a:gd name="connsiteY13" fmla="*/ 202207 h 290064"/>
                <a:gd name="connsiteX14" fmla="*/ 706858 w 784249"/>
                <a:gd name="connsiteY14" fmla="*/ 245762 h 290064"/>
                <a:gd name="connsiteX15" fmla="*/ 733790 w 784249"/>
                <a:gd name="connsiteY15" fmla="*/ 272585 h 290064"/>
                <a:gd name="connsiteX16" fmla="*/ 762760 w 784249"/>
                <a:gd name="connsiteY16" fmla="*/ 252142 h 290064"/>
                <a:gd name="connsiteX17" fmla="*/ 784029 w 784249"/>
                <a:gd name="connsiteY17" fmla="*/ 231087 h 290064"/>
                <a:gd name="connsiteX18" fmla="*/ 771890 w 784249"/>
                <a:gd name="connsiteY18" fmla="*/ 204005 h 290064"/>
                <a:gd name="connsiteX19" fmla="*/ 741651 w 784249"/>
                <a:gd name="connsiteY19" fmla="*/ 160344 h 290064"/>
                <a:gd name="connsiteX20" fmla="*/ 678786 w 784249"/>
                <a:gd name="connsiteY20" fmla="*/ 98510 h 290064"/>
                <a:gd name="connsiteX21" fmla="*/ 584264 w 784249"/>
                <a:gd name="connsiteY21" fmla="*/ 38120 h 290064"/>
                <a:gd name="connsiteX22" fmla="*/ 487799 w 784249"/>
                <a:gd name="connsiteY22" fmla="*/ 8615 h 290064"/>
                <a:gd name="connsiteX23" fmla="*/ 415655 w 784249"/>
                <a:gd name="connsiteY23" fmla="*/ 995 h 290064"/>
                <a:gd name="connsiteX24" fmla="*/ 356132 w 784249"/>
                <a:gd name="connsiteY24" fmla="*/ 1715 h 290064"/>
                <a:gd name="connsiteX25" fmla="*/ 264895 w 784249"/>
                <a:gd name="connsiteY25" fmla="*/ 22156 h 290064"/>
                <a:gd name="connsiteX26" fmla="*/ 188960 w 784249"/>
                <a:gd name="connsiteY26" fmla="*/ 57320 h 290064"/>
                <a:gd name="connsiteX27" fmla="*/ 129905 w 784249"/>
                <a:gd name="connsiteY27" fmla="*/ 99230 h 290064"/>
                <a:gd name="connsiteX28" fmla="*/ 93710 w 784249"/>
                <a:gd name="connsiteY28" fmla="*/ 129710 h 290064"/>
                <a:gd name="connsiteX29" fmla="*/ 61325 w 784249"/>
                <a:gd name="connsiteY29" fmla="*/ 162095 h 290064"/>
                <a:gd name="connsiteX30" fmla="*/ 27035 w 784249"/>
                <a:gd name="connsiteY30" fmla="*/ 207815 h 290064"/>
                <a:gd name="connsiteX31" fmla="*/ 0 w 784249"/>
                <a:gd name="connsiteY31" fmla="*/ 252187 h 290064"/>
                <a:gd name="connsiteX0" fmla="*/ 0 w 784249"/>
                <a:gd name="connsiteY0" fmla="*/ 252187 h 290064"/>
                <a:gd name="connsiteX1" fmla="*/ 25130 w 784249"/>
                <a:gd name="connsiteY1" fmla="*/ 272585 h 290064"/>
                <a:gd name="connsiteX2" fmla="*/ 51800 w 784249"/>
                <a:gd name="connsiteY2" fmla="*/ 289730 h 290064"/>
                <a:gd name="connsiteX3" fmla="*/ 78825 w 784249"/>
                <a:gd name="connsiteY3" fmla="*/ 255835 h 290064"/>
                <a:gd name="connsiteX4" fmla="*/ 118466 w 784249"/>
                <a:gd name="connsiteY4" fmla="*/ 202820 h 290064"/>
                <a:gd name="connsiteX5" fmla="*/ 177776 w 784249"/>
                <a:gd name="connsiteY5" fmla="*/ 152776 h 290064"/>
                <a:gd name="connsiteX6" fmla="*/ 250171 w 784249"/>
                <a:gd name="connsiteY6" fmla="*/ 107570 h 290064"/>
                <a:gd name="connsiteX7" fmla="*/ 330639 w 784249"/>
                <a:gd name="connsiteY7" fmla="*/ 79359 h 290064"/>
                <a:gd name="connsiteX8" fmla="*/ 394922 w 784249"/>
                <a:gd name="connsiteY8" fmla="*/ 71585 h 290064"/>
                <a:gd name="connsiteX9" fmla="*/ 469523 w 784249"/>
                <a:gd name="connsiteY9" fmla="*/ 74848 h 290064"/>
                <a:gd name="connsiteX10" fmla="*/ 533297 w 784249"/>
                <a:gd name="connsiteY10" fmla="*/ 94647 h 290064"/>
                <a:gd name="connsiteX11" fmla="*/ 580180 w 784249"/>
                <a:gd name="connsiteY11" fmla="*/ 118689 h 290064"/>
                <a:gd name="connsiteX12" fmla="*/ 626371 w 784249"/>
                <a:gd name="connsiteY12" fmla="*/ 154326 h 290064"/>
                <a:gd name="connsiteX13" fmla="*/ 674058 w 784249"/>
                <a:gd name="connsiteY13" fmla="*/ 201394 h 290064"/>
                <a:gd name="connsiteX14" fmla="*/ 706858 w 784249"/>
                <a:gd name="connsiteY14" fmla="*/ 245762 h 290064"/>
                <a:gd name="connsiteX15" fmla="*/ 733790 w 784249"/>
                <a:gd name="connsiteY15" fmla="*/ 272585 h 290064"/>
                <a:gd name="connsiteX16" fmla="*/ 762760 w 784249"/>
                <a:gd name="connsiteY16" fmla="*/ 252142 h 290064"/>
                <a:gd name="connsiteX17" fmla="*/ 784029 w 784249"/>
                <a:gd name="connsiteY17" fmla="*/ 231087 h 290064"/>
                <a:gd name="connsiteX18" fmla="*/ 771890 w 784249"/>
                <a:gd name="connsiteY18" fmla="*/ 204005 h 290064"/>
                <a:gd name="connsiteX19" fmla="*/ 741651 w 784249"/>
                <a:gd name="connsiteY19" fmla="*/ 160344 h 290064"/>
                <a:gd name="connsiteX20" fmla="*/ 678786 w 784249"/>
                <a:gd name="connsiteY20" fmla="*/ 98510 h 290064"/>
                <a:gd name="connsiteX21" fmla="*/ 584264 w 784249"/>
                <a:gd name="connsiteY21" fmla="*/ 38120 h 290064"/>
                <a:gd name="connsiteX22" fmla="*/ 487799 w 784249"/>
                <a:gd name="connsiteY22" fmla="*/ 8615 h 290064"/>
                <a:gd name="connsiteX23" fmla="*/ 415655 w 784249"/>
                <a:gd name="connsiteY23" fmla="*/ 995 h 290064"/>
                <a:gd name="connsiteX24" fmla="*/ 356132 w 784249"/>
                <a:gd name="connsiteY24" fmla="*/ 1715 h 290064"/>
                <a:gd name="connsiteX25" fmla="*/ 264895 w 784249"/>
                <a:gd name="connsiteY25" fmla="*/ 22156 h 290064"/>
                <a:gd name="connsiteX26" fmla="*/ 188960 w 784249"/>
                <a:gd name="connsiteY26" fmla="*/ 57320 h 290064"/>
                <a:gd name="connsiteX27" fmla="*/ 129905 w 784249"/>
                <a:gd name="connsiteY27" fmla="*/ 99230 h 290064"/>
                <a:gd name="connsiteX28" fmla="*/ 93710 w 784249"/>
                <a:gd name="connsiteY28" fmla="*/ 129710 h 290064"/>
                <a:gd name="connsiteX29" fmla="*/ 61325 w 784249"/>
                <a:gd name="connsiteY29" fmla="*/ 162095 h 290064"/>
                <a:gd name="connsiteX30" fmla="*/ 27035 w 784249"/>
                <a:gd name="connsiteY30" fmla="*/ 207815 h 290064"/>
                <a:gd name="connsiteX31" fmla="*/ 0 w 784249"/>
                <a:gd name="connsiteY31" fmla="*/ 252187 h 290064"/>
                <a:gd name="connsiteX0" fmla="*/ 0 w 784249"/>
                <a:gd name="connsiteY0" fmla="*/ 252187 h 290064"/>
                <a:gd name="connsiteX1" fmla="*/ 25130 w 784249"/>
                <a:gd name="connsiteY1" fmla="*/ 272585 h 290064"/>
                <a:gd name="connsiteX2" fmla="*/ 51800 w 784249"/>
                <a:gd name="connsiteY2" fmla="*/ 289730 h 290064"/>
                <a:gd name="connsiteX3" fmla="*/ 78825 w 784249"/>
                <a:gd name="connsiteY3" fmla="*/ 255835 h 290064"/>
                <a:gd name="connsiteX4" fmla="*/ 118466 w 784249"/>
                <a:gd name="connsiteY4" fmla="*/ 202820 h 290064"/>
                <a:gd name="connsiteX5" fmla="*/ 177776 w 784249"/>
                <a:gd name="connsiteY5" fmla="*/ 152776 h 290064"/>
                <a:gd name="connsiteX6" fmla="*/ 250171 w 784249"/>
                <a:gd name="connsiteY6" fmla="*/ 107570 h 290064"/>
                <a:gd name="connsiteX7" fmla="*/ 330639 w 784249"/>
                <a:gd name="connsiteY7" fmla="*/ 79359 h 290064"/>
                <a:gd name="connsiteX8" fmla="*/ 394922 w 784249"/>
                <a:gd name="connsiteY8" fmla="*/ 71585 h 290064"/>
                <a:gd name="connsiteX9" fmla="*/ 469523 w 784249"/>
                <a:gd name="connsiteY9" fmla="*/ 74848 h 290064"/>
                <a:gd name="connsiteX10" fmla="*/ 533297 w 784249"/>
                <a:gd name="connsiteY10" fmla="*/ 94647 h 290064"/>
                <a:gd name="connsiteX11" fmla="*/ 580180 w 784249"/>
                <a:gd name="connsiteY11" fmla="*/ 118689 h 290064"/>
                <a:gd name="connsiteX12" fmla="*/ 626371 w 784249"/>
                <a:gd name="connsiteY12" fmla="*/ 154326 h 290064"/>
                <a:gd name="connsiteX13" fmla="*/ 674058 w 784249"/>
                <a:gd name="connsiteY13" fmla="*/ 201394 h 290064"/>
                <a:gd name="connsiteX14" fmla="*/ 708378 w 784249"/>
                <a:gd name="connsiteY14" fmla="*/ 237630 h 290064"/>
                <a:gd name="connsiteX15" fmla="*/ 733790 w 784249"/>
                <a:gd name="connsiteY15" fmla="*/ 272585 h 290064"/>
                <a:gd name="connsiteX16" fmla="*/ 762760 w 784249"/>
                <a:gd name="connsiteY16" fmla="*/ 252142 h 290064"/>
                <a:gd name="connsiteX17" fmla="*/ 784029 w 784249"/>
                <a:gd name="connsiteY17" fmla="*/ 231087 h 290064"/>
                <a:gd name="connsiteX18" fmla="*/ 771890 w 784249"/>
                <a:gd name="connsiteY18" fmla="*/ 204005 h 290064"/>
                <a:gd name="connsiteX19" fmla="*/ 741651 w 784249"/>
                <a:gd name="connsiteY19" fmla="*/ 160344 h 290064"/>
                <a:gd name="connsiteX20" fmla="*/ 678786 w 784249"/>
                <a:gd name="connsiteY20" fmla="*/ 98510 h 290064"/>
                <a:gd name="connsiteX21" fmla="*/ 584264 w 784249"/>
                <a:gd name="connsiteY21" fmla="*/ 38120 h 290064"/>
                <a:gd name="connsiteX22" fmla="*/ 487799 w 784249"/>
                <a:gd name="connsiteY22" fmla="*/ 8615 h 290064"/>
                <a:gd name="connsiteX23" fmla="*/ 415655 w 784249"/>
                <a:gd name="connsiteY23" fmla="*/ 995 h 290064"/>
                <a:gd name="connsiteX24" fmla="*/ 356132 w 784249"/>
                <a:gd name="connsiteY24" fmla="*/ 1715 h 290064"/>
                <a:gd name="connsiteX25" fmla="*/ 264895 w 784249"/>
                <a:gd name="connsiteY25" fmla="*/ 22156 h 290064"/>
                <a:gd name="connsiteX26" fmla="*/ 188960 w 784249"/>
                <a:gd name="connsiteY26" fmla="*/ 57320 h 290064"/>
                <a:gd name="connsiteX27" fmla="*/ 129905 w 784249"/>
                <a:gd name="connsiteY27" fmla="*/ 99230 h 290064"/>
                <a:gd name="connsiteX28" fmla="*/ 93710 w 784249"/>
                <a:gd name="connsiteY28" fmla="*/ 129710 h 290064"/>
                <a:gd name="connsiteX29" fmla="*/ 61325 w 784249"/>
                <a:gd name="connsiteY29" fmla="*/ 162095 h 290064"/>
                <a:gd name="connsiteX30" fmla="*/ 27035 w 784249"/>
                <a:gd name="connsiteY30" fmla="*/ 207815 h 290064"/>
                <a:gd name="connsiteX31" fmla="*/ 0 w 784249"/>
                <a:gd name="connsiteY31" fmla="*/ 252187 h 29006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784249" h="290064">
                  <a:moveTo>
                    <a:pt x="0" y="252187"/>
                  </a:moveTo>
                  <a:cubicBezTo>
                    <a:pt x="2223" y="258220"/>
                    <a:pt x="17510" y="266870"/>
                    <a:pt x="25130" y="272585"/>
                  </a:cubicBezTo>
                  <a:cubicBezTo>
                    <a:pt x="31798" y="277030"/>
                    <a:pt x="42851" y="292522"/>
                    <a:pt x="51800" y="289730"/>
                  </a:cubicBezTo>
                  <a:cubicBezTo>
                    <a:pt x="60749" y="286938"/>
                    <a:pt x="76285" y="260598"/>
                    <a:pt x="78825" y="255835"/>
                  </a:cubicBezTo>
                  <a:cubicBezTo>
                    <a:pt x="89936" y="241350"/>
                    <a:pt x="101974" y="219997"/>
                    <a:pt x="118466" y="202820"/>
                  </a:cubicBezTo>
                  <a:cubicBezTo>
                    <a:pt x="134958" y="185644"/>
                    <a:pt x="155825" y="168651"/>
                    <a:pt x="177776" y="152776"/>
                  </a:cubicBezTo>
                  <a:cubicBezTo>
                    <a:pt x="199727" y="136901"/>
                    <a:pt x="224694" y="119806"/>
                    <a:pt x="250171" y="107570"/>
                  </a:cubicBezTo>
                  <a:cubicBezTo>
                    <a:pt x="275648" y="95334"/>
                    <a:pt x="306514" y="85356"/>
                    <a:pt x="330639" y="79359"/>
                  </a:cubicBezTo>
                  <a:cubicBezTo>
                    <a:pt x="354764" y="73362"/>
                    <a:pt x="371775" y="72337"/>
                    <a:pt x="394922" y="71585"/>
                  </a:cubicBezTo>
                  <a:cubicBezTo>
                    <a:pt x="418069" y="70833"/>
                    <a:pt x="441340" y="72464"/>
                    <a:pt x="469523" y="74848"/>
                  </a:cubicBezTo>
                  <a:cubicBezTo>
                    <a:pt x="495322" y="77465"/>
                    <a:pt x="514854" y="87340"/>
                    <a:pt x="533297" y="94647"/>
                  </a:cubicBezTo>
                  <a:cubicBezTo>
                    <a:pt x="551740" y="101954"/>
                    <a:pt x="564668" y="108743"/>
                    <a:pt x="580180" y="118689"/>
                  </a:cubicBezTo>
                  <a:cubicBezTo>
                    <a:pt x="595692" y="128635"/>
                    <a:pt x="610725" y="140542"/>
                    <a:pt x="626371" y="154326"/>
                  </a:cubicBezTo>
                  <a:cubicBezTo>
                    <a:pt x="642017" y="168110"/>
                    <a:pt x="660390" y="187510"/>
                    <a:pt x="674058" y="201394"/>
                  </a:cubicBezTo>
                  <a:cubicBezTo>
                    <a:pt x="687726" y="215278"/>
                    <a:pt x="698296" y="227256"/>
                    <a:pt x="708378" y="237630"/>
                  </a:cubicBezTo>
                  <a:cubicBezTo>
                    <a:pt x="718460" y="248004"/>
                    <a:pt x="724726" y="270166"/>
                    <a:pt x="733790" y="272585"/>
                  </a:cubicBezTo>
                  <a:cubicBezTo>
                    <a:pt x="742854" y="275004"/>
                    <a:pt x="754387" y="259058"/>
                    <a:pt x="762760" y="252142"/>
                  </a:cubicBezTo>
                  <a:cubicBezTo>
                    <a:pt x="771133" y="245226"/>
                    <a:pt x="782507" y="239110"/>
                    <a:pt x="784029" y="231087"/>
                  </a:cubicBezTo>
                  <a:cubicBezTo>
                    <a:pt x="785551" y="223064"/>
                    <a:pt x="778953" y="215795"/>
                    <a:pt x="771890" y="204005"/>
                  </a:cubicBezTo>
                  <a:cubicBezTo>
                    <a:pt x="764827" y="192215"/>
                    <a:pt x="757168" y="177926"/>
                    <a:pt x="741651" y="160344"/>
                  </a:cubicBezTo>
                  <a:cubicBezTo>
                    <a:pt x="726134" y="142762"/>
                    <a:pt x="705017" y="118881"/>
                    <a:pt x="678786" y="98510"/>
                  </a:cubicBezTo>
                  <a:cubicBezTo>
                    <a:pt x="652555" y="78139"/>
                    <a:pt x="616095" y="53102"/>
                    <a:pt x="584264" y="38120"/>
                  </a:cubicBezTo>
                  <a:cubicBezTo>
                    <a:pt x="552433" y="23138"/>
                    <a:pt x="515900" y="14802"/>
                    <a:pt x="487799" y="8615"/>
                  </a:cubicBezTo>
                  <a:cubicBezTo>
                    <a:pt x="459698" y="2428"/>
                    <a:pt x="434387" y="2900"/>
                    <a:pt x="415655" y="995"/>
                  </a:cubicBezTo>
                  <a:cubicBezTo>
                    <a:pt x="395814" y="1235"/>
                    <a:pt x="381258" y="-1812"/>
                    <a:pt x="356132" y="1715"/>
                  </a:cubicBezTo>
                  <a:cubicBezTo>
                    <a:pt x="331006" y="5242"/>
                    <a:pt x="292757" y="12889"/>
                    <a:pt x="264895" y="22156"/>
                  </a:cubicBezTo>
                  <a:cubicBezTo>
                    <a:pt x="237033" y="31424"/>
                    <a:pt x="206105" y="45890"/>
                    <a:pt x="188960" y="57320"/>
                  </a:cubicBezTo>
                  <a:cubicBezTo>
                    <a:pt x="171815" y="68750"/>
                    <a:pt x="145780" y="87165"/>
                    <a:pt x="129905" y="99230"/>
                  </a:cubicBezTo>
                  <a:cubicBezTo>
                    <a:pt x="114030" y="111295"/>
                    <a:pt x="105140" y="119233"/>
                    <a:pt x="93710" y="129710"/>
                  </a:cubicBezTo>
                  <a:cubicBezTo>
                    <a:pt x="82280" y="140187"/>
                    <a:pt x="72438" y="149078"/>
                    <a:pt x="61325" y="162095"/>
                  </a:cubicBezTo>
                  <a:cubicBezTo>
                    <a:pt x="50213" y="175113"/>
                    <a:pt x="37256" y="192800"/>
                    <a:pt x="27035" y="207815"/>
                  </a:cubicBezTo>
                  <a:cubicBezTo>
                    <a:pt x="16814" y="222830"/>
                    <a:pt x="318" y="241392"/>
                    <a:pt x="0" y="252187"/>
                  </a:cubicBez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Flowchart: Connector 1">
            <a:extLst>
              <a:ext uri="{FF2B5EF4-FFF2-40B4-BE49-F238E27FC236}">
                <a16:creationId xmlns:a16="http://schemas.microsoft.com/office/drawing/2014/main" id="{C4178009-EADF-423D-8098-907AE19971CD}"/>
              </a:ext>
            </a:extLst>
          </p:cNvPr>
          <p:cNvSpPr/>
          <p:nvPr/>
        </p:nvSpPr>
        <p:spPr>
          <a:xfrm>
            <a:off x="1139764" y="1233650"/>
            <a:ext cx="45719" cy="45719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Flowchart: Connector 2">
            <a:extLst>
              <a:ext uri="{FF2B5EF4-FFF2-40B4-BE49-F238E27FC236}">
                <a16:creationId xmlns:a16="http://schemas.microsoft.com/office/drawing/2014/main" id="{6E7B2526-9577-440D-BA89-550CE4959E7D}"/>
              </a:ext>
            </a:extLst>
          </p:cNvPr>
          <p:cNvSpPr/>
          <p:nvPr/>
        </p:nvSpPr>
        <p:spPr>
          <a:xfrm>
            <a:off x="1139500" y="1361355"/>
            <a:ext cx="45719" cy="45719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Flowchart: Connector 3">
            <a:extLst>
              <a:ext uri="{FF2B5EF4-FFF2-40B4-BE49-F238E27FC236}">
                <a16:creationId xmlns:a16="http://schemas.microsoft.com/office/drawing/2014/main" id="{340417FC-1E1E-4274-AB6B-4D8AD6E1B8F7}"/>
              </a:ext>
            </a:extLst>
          </p:cNvPr>
          <p:cNvSpPr/>
          <p:nvPr/>
        </p:nvSpPr>
        <p:spPr>
          <a:xfrm>
            <a:off x="1162498" y="2391979"/>
            <a:ext cx="45719" cy="45719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Flowchart: Connector 4">
            <a:extLst>
              <a:ext uri="{FF2B5EF4-FFF2-40B4-BE49-F238E27FC236}">
                <a16:creationId xmlns:a16="http://schemas.microsoft.com/office/drawing/2014/main" id="{1FD731F7-8EBC-4F6B-9A04-360EFA52A3BA}"/>
              </a:ext>
            </a:extLst>
          </p:cNvPr>
          <p:cNvSpPr/>
          <p:nvPr/>
        </p:nvSpPr>
        <p:spPr>
          <a:xfrm>
            <a:off x="1162498" y="3596183"/>
            <a:ext cx="45719" cy="45719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54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295</Words>
  <Application>Microsoft Office PowerPoint</Application>
  <PresentationFormat>A4 Paper (210x297 mm)</PresentationFormat>
  <Paragraphs>1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17</cp:revision>
  <dcterms:created xsi:type="dcterms:W3CDTF">2022-05-10T05:11:22Z</dcterms:created>
  <dcterms:modified xsi:type="dcterms:W3CDTF">2022-05-11T09:28:42Z</dcterms:modified>
</cp:coreProperties>
</file>